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3"/>
  </p:notesMasterIdLst>
  <p:sldIdLst>
    <p:sldId id="799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2DAA9E"/>
    <a:srgbClr val="F5B7BF"/>
    <a:srgbClr val="ED8390"/>
    <a:srgbClr val="7DDFD6"/>
    <a:srgbClr val="D4F4F1"/>
    <a:srgbClr val="FFCC99"/>
    <a:srgbClr val="FF9933"/>
    <a:srgbClr val="E3F2D9"/>
    <a:srgbClr val="ACD78E"/>
    <a:srgbClr val="D0E7F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43" autoAdjust="0"/>
    <p:restoredTop sz="93521" autoAdjust="0"/>
  </p:normalViewPr>
  <p:slideViewPr>
    <p:cSldViewPr snapToGrid="0">
      <p:cViewPr>
        <p:scale>
          <a:sx n="50" d="100"/>
          <a:sy n="50" d="100"/>
        </p:scale>
        <p:origin x="1284" y="2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EE6F573-7E06-4AF2-81A0-DD0AFEBFBBF9}" type="datetimeFigureOut">
              <a:rPr lang="zh-CN" altLang="en-US" smtClean="0"/>
              <a:t>2026/1/20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4E87246-070C-4DD1-B41D-1B06226838C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6483667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altLang="zh-CN" sz="1200" b="0" i="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4E87246-070C-4DD1-B41D-1B06226838C0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2761762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26207438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>
            <a:alpha val="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 bg1="lt1" tx1="dk1" bg2="lt2" tx2="dk2" accent1="accent1" accent2="accent2" accent3="accent3" accent4="accent4" accent5="accent5" accent6="accent6" hlink="hlink" folHlink="folHlink"/>
  <p:sldLayoutIdLst>
    <p:sldLayoutId id="2147483655" r:id="rId1"/>
    <p:sldLayoutId id="2147483660" r:id="rId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microsoft.com/office/2007/relationships/hdphoto" Target="../media/hdphoto2.wdp"/><Relationship Id="rId5" Type="http://schemas.openxmlformats.org/officeDocument/2006/relationships/image" Target="../media/image2.png"/><Relationship Id="rId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8D1F968-A3D6-74CD-B8A1-89D81BE07FB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1" name="组合 20">
            <a:extLst>
              <a:ext uri="{FF2B5EF4-FFF2-40B4-BE49-F238E27FC236}">
                <a16:creationId xmlns:a16="http://schemas.microsoft.com/office/drawing/2014/main" id="{072ED3A6-D44D-3F67-073E-209E33EEBE9F}"/>
              </a:ext>
            </a:extLst>
          </p:cNvPr>
          <p:cNvGrpSpPr/>
          <p:nvPr/>
        </p:nvGrpSpPr>
        <p:grpSpPr>
          <a:xfrm>
            <a:off x="2295727" y="311285"/>
            <a:ext cx="7030757" cy="6411988"/>
            <a:chOff x="1057788" y="-474238"/>
            <a:chExt cx="9130023" cy="8326500"/>
          </a:xfrm>
        </p:grpSpPr>
        <p:grpSp>
          <p:nvGrpSpPr>
            <p:cNvPr id="6" name="组合 5">
              <a:extLst>
                <a:ext uri="{FF2B5EF4-FFF2-40B4-BE49-F238E27FC236}">
                  <a16:creationId xmlns:a16="http://schemas.microsoft.com/office/drawing/2014/main" id="{D89D331F-853D-DC6F-2B7E-0024F28AD338}"/>
                </a:ext>
              </a:extLst>
            </p:cNvPr>
            <p:cNvGrpSpPr/>
            <p:nvPr/>
          </p:nvGrpSpPr>
          <p:grpSpPr>
            <a:xfrm>
              <a:off x="1057788" y="-474238"/>
              <a:ext cx="9130023" cy="3432977"/>
              <a:chOff x="1057788" y="131691"/>
              <a:chExt cx="9130023" cy="3432977"/>
            </a:xfrm>
          </p:grpSpPr>
          <p:pic>
            <p:nvPicPr>
              <p:cNvPr id="7" name="图片 6">
                <a:extLst>
                  <a:ext uri="{FF2B5EF4-FFF2-40B4-BE49-F238E27FC236}">
                    <a16:creationId xmlns:a16="http://schemas.microsoft.com/office/drawing/2014/main" id="{1954CF94-83F4-0AC7-7F13-BADF3287D1E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brightnessContrast contrast="20000"/>
                        </a14:imgEffect>
                      </a14:imgLayer>
                    </a14:imgProps>
                  </a:ext>
                </a:extLst>
              </a:blip>
              <a:srcRect r="32640"/>
              <a:stretch>
                <a:fillRect/>
              </a:stretch>
            </p:blipFill>
            <p:spPr>
              <a:xfrm>
                <a:off x="5793646" y="131691"/>
                <a:ext cx="4394165" cy="3432977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pic>
            <p:nvPicPr>
              <p:cNvPr id="12" name="图片 11">
                <a:extLst>
                  <a:ext uri="{FF2B5EF4-FFF2-40B4-BE49-F238E27FC236}">
                    <a16:creationId xmlns:a16="http://schemas.microsoft.com/office/drawing/2014/main" id="{58F44607-B344-E330-2F53-48187D949E3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>
                <a:extLst>
                  <a:ext uri="{BEBA8EAE-BF5A-486C-A8C5-ECC9F3942E4B}">
                    <a14:imgProps xmlns:a14="http://schemas.microsoft.com/office/drawing/2010/main">
                      <a14:imgLayer r:embed="rId6">
                        <a14:imgEffect>
                          <a14:brightnessContrast contrast="20000"/>
                        </a14:imgEffect>
                      </a14:imgLayer>
                    </a14:imgProps>
                  </a:ext>
                </a:extLst>
              </a:blip>
              <a:srcRect l="5066" r="39729" b="19232"/>
              <a:stretch>
                <a:fillRect/>
              </a:stretch>
            </p:blipFill>
            <p:spPr>
              <a:xfrm>
                <a:off x="1057788" y="131691"/>
                <a:ext cx="4394165" cy="3432977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sp>
            <p:nvSpPr>
              <p:cNvPr id="13" name="文本框 12">
                <a:extLst>
                  <a:ext uri="{FF2B5EF4-FFF2-40B4-BE49-F238E27FC236}">
                    <a16:creationId xmlns:a16="http://schemas.microsoft.com/office/drawing/2014/main" id="{4AC1450B-7FF3-1273-D941-E3743CCF7D63}"/>
                  </a:ext>
                </a:extLst>
              </p:cNvPr>
              <p:cNvSpPr txBox="1"/>
              <p:nvPr/>
            </p:nvSpPr>
            <p:spPr>
              <a:xfrm>
                <a:off x="1058097" y="137606"/>
                <a:ext cx="408478" cy="43964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endParaRPr lang="zh-CN" altLang="en-US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" name="文本框 15">
                <a:extLst>
                  <a:ext uri="{FF2B5EF4-FFF2-40B4-BE49-F238E27FC236}">
                    <a16:creationId xmlns:a16="http://schemas.microsoft.com/office/drawing/2014/main" id="{0F48EC72-1B20-F5AF-7D0B-87943169BDE2}"/>
                  </a:ext>
                </a:extLst>
              </p:cNvPr>
              <p:cNvSpPr txBox="1"/>
              <p:nvPr/>
            </p:nvSpPr>
            <p:spPr>
              <a:xfrm>
                <a:off x="5792252" y="139079"/>
                <a:ext cx="408478" cy="43964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endParaRPr lang="zh-CN" altLang="en-US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898" name="矩形 897">
              <a:extLst>
                <a:ext uri="{FF2B5EF4-FFF2-40B4-BE49-F238E27FC236}">
                  <a16:creationId xmlns:a16="http://schemas.microsoft.com/office/drawing/2014/main" id="{2A6C9932-4CD7-A127-2863-CDD5F787135A}"/>
                </a:ext>
              </a:extLst>
            </p:cNvPr>
            <p:cNvSpPr/>
            <p:nvPr/>
          </p:nvSpPr>
          <p:spPr>
            <a:xfrm>
              <a:off x="1641670" y="3283436"/>
              <a:ext cx="7739564" cy="4568826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  <a:ln>
              <a:noFill/>
            </a:ln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400" dirty="0"/>
            </a:p>
          </p:txBody>
        </p:sp>
        <p:sp>
          <p:nvSpPr>
            <p:cNvPr id="899" name="Freeform 581">
              <a:extLst>
                <a:ext uri="{FF2B5EF4-FFF2-40B4-BE49-F238E27FC236}">
                  <a16:creationId xmlns:a16="http://schemas.microsoft.com/office/drawing/2014/main" id="{FCEC540F-3294-6A49-1E8C-10DB84DE2B2E}"/>
                </a:ext>
              </a:extLst>
            </p:cNvPr>
            <p:cNvSpPr/>
            <p:nvPr/>
          </p:nvSpPr>
          <p:spPr>
            <a:xfrm rot="20430576">
              <a:off x="3747965" y="3683308"/>
              <a:ext cx="4334387" cy="3724675"/>
            </a:xfrm>
            <a:custGeom>
              <a:avLst/>
              <a:gdLst>
                <a:gd name="connsiteX0" fmla="*/ 9175 w 9387"/>
                <a:gd name="connsiteY0" fmla="*/ 1694 h 9552"/>
                <a:gd name="connsiteX1" fmla="*/ 5994 w 9387"/>
                <a:gd name="connsiteY1" fmla="*/ 49 h 9552"/>
                <a:gd name="connsiteX2" fmla="*/ 5165 w 9387"/>
                <a:gd name="connsiteY2" fmla="*/ 647 h 9552"/>
                <a:gd name="connsiteX3" fmla="*/ 3791 w 9387"/>
                <a:gd name="connsiteY3" fmla="*/ 690 h 9552"/>
                <a:gd name="connsiteX4" fmla="*/ 1168 w 9387"/>
                <a:gd name="connsiteY4" fmla="*/ 1672 h 9552"/>
                <a:gd name="connsiteX5" fmla="*/ 388 w 9387"/>
                <a:gd name="connsiteY5" fmla="*/ 7527 h 9552"/>
                <a:gd name="connsiteX6" fmla="*/ 1477 w 9387"/>
                <a:gd name="connsiteY6" fmla="*/ 8959 h 9552"/>
                <a:gd name="connsiteX7" fmla="*/ 3098 w 9387"/>
                <a:gd name="connsiteY7" fmla="*/ 7805 h 9552"/>
                <a:gd name="connsiteX8" fmla="*/ 3952 w 9387"/>
                <a:gd name="connsiteY8" fmla="*/ 7418 h 9552"/>
                <a:gd name="connsiteX9" fmla="*/ 5190 w 9387"/>
                <a:gd name="connsiteY9" fmla="*/ 7655 h 9552"/>
                <a:gd name="connsiteX10" fmla="*/ 5388 w 9387"/>
                <a:gd name="connsiteY10" fmla="*/ 8596 h 9552"/>
                <a:gd name="connsiteX11" fmla="*/ 5635 w 9387"/>
                <a:gd name="connsiteY11" fmla="*/ 9258 h 9552"/>
                <a:gd name="connsiteX12" fmla="*/ 7269 w 9387"/>
                <a:gd name="connsiteY12" fmla="*/ 9365 h 9552"/>
                <a:gd name="connsiteX13" fmla="*/ 7343 w 9387"/>
                <a:gd name="connsiteY13" fmla="*/ 9343 h 9552"/>
                <a:gd name="connsiteX14" fmla="*/ 9101 w 9387"/>
                <a:gd name="connsiteY14" fmla="*/ 6331 h 9552"/>
                <a:gd name="connsiteX15" fmla="*/ 9212 w 9387"/>
                <a:gd name="connsiteY15" fmla="*/ 5134 h 9552"/>
                <a:gd name="connsiteX16" fmla="*/ 9175 w 9387"/>
                <a:gd name="connsiteY16" fmla="*/ 1694 h 9552"/>
                <a:gd name="connsiteX0" fmla="*/ 9774 w 10000"/>
                <a:gd name="connsiteY0" fmla="*/ 1773 h 10000"/>
                <a:gd name="connsiteX1" fmla="*/ 6385 w 10000"/>
                <a:gd name="connsiteY1" fmla="*/ 51 h 10000"/>
                <a:gd name="connsiteX2" fmla="*/ 5502 w 10000"/>
                <a:gd name="connsiteY2" fmla="*/ 677 h 10000"/>
                <a:gd name="connsiteX3" fmla="*/ 4039 w 10000"/>
                <a:gd name="connsiteY3" fmla="*/ 722 h 10000"/>
                <a:gd name="connsiteX4" fmla="*/ 1244 w 10000"/>
                <a:gd name="connsiteY4" fmla="*/ 1750 h 10000"/>
                <a:gd name="connsiteX5" fmla="*/ 413 w 10000"/>
                <a:gd name="connsiteY5" fmla="*/ 7880 h 10000"/>
                <a:gd name="connsiteX6" fmla="*/ 1573 w 10000"/>
                <a:gd name="connsiteY6" fmla="*/ 9379 h 10000"/>
                <a:gd name="connsiteX7" fmla="*/ 3512 w 10000"/>
                <a:gd name="connsiteY7" fmla="*/ 8735 h 10000"/>
                <a:gd name="connsiteX8" fmla="*/ 4210 w 10000"/>
                <a:gd name="connsiteY8" fmla="*/ 7766 h 10000"/>
                <a:gd name="connsiteX9" fmla="*/ 5529 w 10000"/>
                <a:gd name="connsiteY9" fmla="*/ 8014 h 10000"/>
                <a:gd name="connsiteX10" fmla="*/ 5740 w 10000"/>
                <a:gd name="connsiteY10" fmla="*/ 8999 h 10000"/>
                <a:gd name="connsiteX11" fmla="*/ 6003 w 10000"/>
                <a:gd name="connsiteY11" fmla="*/ 9692 h 10000"/>
                <a:gd name="connsiteX12" fmla="*/ 7744 w 10000"/>
                <a:gd name="connsiteY12" fmla="*/ 9804 h 10000"/>
                <a:gd name="connsiteX13" fmla="*/ 7823 w 10000"/>
                <a:gd name="connsiteY13" fmla="*/ 9781 h 10000"/>
                <a:gd name="connsiteX14" fmla="*/ 9695 w 10000"/>
                <a:gd name="connsiteY14" fmla="*/ 6628 h 10000"/>
                <a:gd name="connsiteX15" fmla="*/ 9814 w 10000"/>
                <a:gd name="connsiteY15" fmla="*/ 5375 h 10000"/>
                <a:gd name="connsiteX16" fmla="*/ 9774 w 10000"/>
                <a:gd name="connsiteY16" fmla="*/ 1773 h 10000"/>
                <a:gd name="connsiteX0" fmla="*/ 9774 w 10000"/>
                <a:gd name="connsiteY0" fmla="*/ 1773 h 10000"/>
                <a:gd name="connsiteX1" fmla="*/ 6385 w 10000"/>
                <a:gd name="connsiteY1" fmla="*/ 51 h 10000"/>
                <a:gd name="connsiteX2" fmla="*/ 5502 w 10000"/>
                <a:gd name="connsiteY2" fmla="*/ 677 h 10000"/>
                <a:gd name="connsiteX3" fmla="*/ 4039 w 10000"/>
                <a:gd name="connsiteY3" fmla="*/ 722 h 10000"/>
                <a:gd name="connsiteX4" fmla="*/ 1244 w 10000"/>
                <a:gd name="connsiteY4" fmla="*/ 1750 h 10000"/>
                <a:gd name="connsiteX5" fmla="*/ 413 w 10000"/>
                <a:gd name="connsiteY5" fmla="*/ 7880 h 10000"/>
                <a:gd name="connsiteX6" fmla="*/ 1573 w 10000"/>
                <a:gd name="connsiteY6" fmla="*/ 9379 h 10000"/>
                <a:gd name="connsiteX7" fmla="*/ 3512 w 10000"/>
                <a:gd name="connsiteY7" fmla="*/ 8735 h 10000"/>
                <a:gd name="connsiteX8" fmla="*/ 4356 w 10000"/>
                <a:gd name="connsiteY8" fmla="*/ 8041 h 10000"/>
                <a:gd name="connsiteX9" fmla="*/ 5529 w 10000"/>
                <a:gd name="connsiteY9" fmla="*/ 8014 h 10000"/>
                <a:gd name="connsiteX10" fmla="*/ 5740 w 10000"/>
                <a:gd name="connsiteY10" fmla="*/ 8999 h 10000"/>
                <a:gd name="connsiteX11" fmla="*/ 6003 w 10000"/>
                <a:gd name="connsiteY11" fmla="*/ 9692 h 10000"/>
                <a:gd name="connsiteX12" fmla="*/ 7744 w 10000"/>
                <a:gd name="connsiteY12" fmla="*/ 9804 h 10000"/>
                <a:gd name="connsiteX13" fmla="*/ 7823 w 10000"/>
                <a:gd name="connsiteY13" fmla="*/ 9781 h 10000"/>
                <a:gd name="connsiteX14" fmla="*/ 9695 w 10000"/>
                <a:gd name="connsiteY14" fmla="*/ 6628 h 10000"/>
                <a:gd name="connsiteX15" fmla="*/ 9814 w 10000"/>
                <a:gd name="connsiteY15" fmla="*/ 5375 h 10000"/>
                <a:gd name="connsiteX16" fmla="*/ 9774 w 10000"/>
                <a:gd name="connsiteY16" fmla="*/ 1773 h 10000"/>
                <a:gd name="connsiteX0" fmla="*/ 9774 w 10000"/>
                <a:gd name="connsiteY0" fmla="*/ 1773 h 10000"/>
                <a:gd name="connsiteX1" fmla="*/ 6385 w 10000"/>
                <a:gd name="connsiteY1" fmla="*/ 51 h 10000"/>
                <a:gd name="connsiteX2" fmla="*/ 5502 w 10000"/>
                <a:gd name="connsiteY2" fmla="*/ 677 h 10000"/>
                <a:gd name="connsiteX3" fmla="*/ 4039 w 10000"/>
                <a:gd name="connsiteY3" fmla="*/ 722 h 10000"/>
                <a:gd name="connsiteX4" fmla="*/ 1244 w 10000"/>
                <a:gd name="connsiteY4" fmla="*/ 1750 h 10000"/>
                <a:gd name="connsiteX5" fmla="*/ 413 w 10000"/>
                <a:gd name="connsiteY5" fmla="*/ 7880 h 10000"/>
                <a:gd name="connsiteX6" fmla="*/ 1573 w 10000"/>
                <a:gd name="connsiteY6" fmla="*/ 9379 h 10000"/>
                <a:gd name="connsiteX7" fmla="*/ 3512 w 10000"/>
                <a:gd name="connsiteY7" fmla="*/ 8735 h 10000"/>
                <a:gd name="connsiteX8" fmla="*/ 4452 w 10000"/>
                <a:gd name="connsiteY8" fmla="*/ 8297 h 10000"/>
                <a:gd name="connsiteX9" fmla="*/ 5529 w 10000"/>
                <a:gd name="connsiteY9" fmla="*/ 8014 h 10000"/>
                <a:gd name="connsiteX10" fmla="*/ 5740 w 10000"/>
                <a:gd name="connsiteY10" fmla="*/ 8999 h 10000"/>
                <a:gd name="connsiteX11" fmla="*/ 6003 w 10000"/>
                <a:gd name="connsiteY11" fmla="*/ 9692 h 10000"/>
                <a:gd name="connsiteX12" fmla="*/ 7744 w 10000"/>
                <a:gd name="connsiteY12" fmla="*/ 9804 h 10000"/>
                <a:gd name="connsiteX13" fmla="*/ 7823 w 10000"/>
                <a:gd name="connsiteY13" fmla="*/ 9781 h 10000"/>
                <a:gd name="connsiteX14" fmla="*/ 9695 w 10000"/>
                <a:gd name="connsiteY14" fmla="*/ 6628 h 10000"/>
                <a:gd name="connsiteX15" fmla="*/ 9814 w 10000"/>
                <a:gd name="connsiteY15" fmla="*/ 5375 h 10000"/>
                <a:gd name="connsiteX16" fmla="*/ 9774 w 10000"/>
                <a:gd name="connsiteY16" fmla="*/ 1773 h 10000"/>
                <a:gd name="connsiteX0" fmla="*/ 9774 w 10000"/>
                <a:gd name="connsiteY0" fmla="*/ 1773 h 10000"/>
                <a:gd name="connsiteX1" fmla="*/ 6385 w 10000"/>
                <a:gd name="connsiteY1" fmla="*/ 51 h 10000"/>
                <a:gd name="connsiteX2" fmla="*/ 5502 w 10000"/>
                <a:gd name="connsiteY2" fmla="*/ 677 h 10000"/>
                <a:gd name="connsiteX3" fmla="*/ 4039 w 10000"/>
                <a:gd name="connsiteY3" fmla="*/ 722 h 10000"/>
                <a:gd name="connsiteX4" fmla="*/ 1244 w 10000"/>
                <a:gd name="connsiteY4" fmla="*/ 1750 h 10000"/>
                <a:gd name="connsiteX5" fmla="*/ 413 w 10000"/>
                <a:gd name="connsiteY5" fmla="*/ 7880 h 10000"/>
                <a:gd name="connsiteX6" fmla="*/ 1573 w 10000"/>
                <a:gd name="connsiteY6" fmla="*/ 9379 h 10000"/>
                <a:gd name="connsiteX7" fmla="*/ 3574 w 10000"/>
                <a:gd name="connsiteY7" fmla="*/ 8901 h 10000"/>
                <a:gd name="connsiteX8" fmla="*/ 4452 w 10000"/>
                <a:gd name="connsiteY8" fmla="*/ 8297 h 10000"/>
                <a:gd name="connsiteX9" fmla="*/ 5529 w 10000"/>
                <a:gd name="connsiteY9" fmla="*/ 8014 h 10000"/>
                <a:gd name="connsiteX10" fmla="*/ 5740 w 10000"/>
                <a:gd name="connsiteY10" fmla="*/ 8999 h 10000"/>
                <a:gd name="connsiteX11" fmla="*/ 6003 w 10000"/>
                <a:gd name="connsiteY11" fmla="*/ 9692 h 10000"/>
                <a:gd name="connsiteX12" fmla="*/ 7744 w 10000"/>
                <a:gd name="connsiteY12" fmla="*/ 9804 h 10000"/>
                <a:gd name="connsiteX13" fmla="*/ 7823 w 10000"/>
                <a:gd name="connsiteY13" fmla="*/ 9781 h 10000"/>
                <a:gd name="connsiteX14" fmla="*/ 9695 w 10000"/>
                <a:gd name="connsiteY14" fmla="*/ 6628 h 10000"/>
                <a:gd name="connsiteX15" fmla="*/ 9814 w 10000"/>
                <a:gd name="connsiteY15" fmla="*/ 5375 h 10000"/>
                <a:gd name="connsiteX16" fmla="*/ 9774 w 10000"/>
                <a:gd name="connsiteY16" fmla="*/ 1773 h 10000"/>
                <a:gd name="connsiteX0" fmla="*/ 9774 w 10000"/>
                <a:gd name="connsiteY0" fmla="*/ 1773 h 10000"/>
                <a:gd name="connsiteX1" fmla="*/ 6385 w 10000"/>
                <a:gd name="connsiteY1" fmla="*/ 51 h 10000"/>
                <a:gd name="connsiteX2" fmla="*/ 5502 w 10000"/>
                <a:gd name="connsiteY2" fmla="*/ 677 h 10000"/>
                <a:gd name="connsiteX3" fmla="*/ 4039 w 10000"/>
                <a:gd name="connsiteY3" fmla="*/ 722 h 10000"/>
                <a:gd name="connsiteX4" fmla="*/ 1244 w 10000"/>
                <a:gd name="connsiteY4" fmla="*/ 1750 h 10000"/>
                <a:gd name="connsiteX5" fmla="*/ 413 w 10000"/>
                <a:gd name="connsiteY5" fmla="*/ 7880 h 10000"/>
                <a:gd name="connsiteX6" fmla="*/ 1573 w 10000"/>
                <a:gd name="connsiteY6" fmla="*/ 9379 h 10000"/>
                <a:gd name="connsiteX7" fmla="*/ 3574 w 10000"/>
                <a:gd name="connsiteY7" fmla="*/ 8901 h 10000"/>
                <a:gd name="connsiteX8" fmla="*/ 4492 w 10000"/>
                <a:gd name="connsiteY8" fmla="*/ 8526 h 10000"/>
                <a:gd name="connsiteX9" fmla="*/ 5529 w 10000"/>
                <a:gd name="connsiteY9" fmla="*/ 8014 h 10000"/>
                <a:gd name="connsiteX10" fmla="*/ 5740 w 10000"/>
                <a:gd name="connsiteY10" fmla="*/ 8999 h 10000"/>
                <a:gd name="connsiteX11" fmla="*/ 6003 w 10000"/>
                <a:gd name="connsiteY11" fmla="*/ 9692 h 10000"/>
                <a:gd name="connsiteX12" fmla="*/ 7744 w 10000"/>
                <a:gd name="connsiteY12" fmla="*/ 9804 h 10000"/>
                <a:gd name="connsiteX13" fmla="*/ 7823 w 10000"/>
                <a:gd name="connsiteY13" fmla="*/ 9781 h 10000"/>
                <a:gd name="connsiteX14" fmla="*/ 9695 w 10000"/>
                <a:gd name="connsiteY14" fmla="*/ 6628 h 10000"/>
                <a:gd name="connsiteX15" fmla="*/ 9814 w 10000"/>
                <a:gd name="connsiteY15" fmla="*/ 5375 h 10000"/>
                <a:gd name="connsiteX16" fmla="*/ 9774 w 10000"/>
                <a:gd name="connsiteY16" fmla="*/ 1773 h 10000"/>
                <a:gd name="connsiteX0" fmla="*/ 9774 w 10000"/>
                <a:gd name="connsiteY0" fmla="*/ 1773 h 10000"/>
                <a:gd name="connsiteX1" fmla="*/ 6385 w 10000"/>
                <a:gd name="connsiteY1" fmla="*/ 51 h 10000"/>
                <a:gd name="connsiteX2" fmla="*/ 5502 w 10000"/>
                <a:gd name="connsiteY2" fmla="*/ 677 h 10000"/>
                <a:gd name="connsiteX3" fmla="*/ 4039 w 10000"/>
                <a:gd name="connsiteY3" fmla="*/ 722 h 10000"/>
                <a:gd name="connsiteX4" fmla="*/ 1244 w 10000"/>
                <a:gd name="connsiteY4" fmla="*/ 1750 h 10000"/>
                <a:gd name="connsiteX5" fmla="*/ 413 w 10000"/>
                <a:gd name="connsiteY5" fmla="*/ 7880 h 10000"/>
                <a:gd name="connsiteX6" fmla="*/ 1573 w 10000"/>
                <a:gd name="connsiteY6" fmla="*/ 9379 h 10000"/>
                <a:gd name="connsiteX7" fmla="*/ 3574 w 10000"/>
                <a:gd name="connsiteY7" fmla="*/ 8901 h 10000"/>
                <a:gd name="connsiteX8" fmla="*/ 4492 w 10000"/>
                <a:gd name="connsiteY8" fmla="*/ 8526 h 10000"/>
                <a:gd name="connsiteX9" fmla="*/ 5529 w 10000"/>
                <a:gd name="connsiteY9" fmla="*/ 8014 h 10000"/>
                <a:gd name="connsiteX10" fmla="*/ 5740 w 10000"/>
                <a:gd name="connsiteY10" fmla="*/ 8999 h 10000"/>
                <a:gd name="connsiteX11" fmla="*/ 6003 w 10000"/>
                <a:gd name="connsiteY11" fmla="*/ 9692 h 10000"/>
                <a:gd name="connsiteX12" fmla="*/ 7744 w 10000"/>
                <a:gd name="connsiteY12" fmla="*/ 9804 h 10000"/>
                <a:gd name="connsiteX13" fmla="*/ 7823 w 10000"/>
                <a:gd name="connsiteY13" fmla="*/ 9781 h 10000"/>
                <a:gd name="connsiteX14" fmla="*/ 9695 w 10000"/>
                <a:gd name="connsiteY14" fmla="*/ 6628 h 10000"/>
                <a:gd name="connsiteX15" fmla="*/ 9814 w 10000"/>
                <a:gd name="connsiteY15" fmla="*/ 5375 h 10000"/>
                <a:gd name="connsiteX16" fmla="*/ 9774 w 10000"/>
                <a:gd name="connsiteY16" fmla="*/ 1773 h 10000"/>
                <a:gd name="connsiteX0" fmla="*/ 9774 w 10000"/>
                <a:gd name="connsiteY0" fmla="*/ 1773 h 10000"/>
                <a:gd name="connsiteX1" fmla="*/ 6385 w 10000"/>
                <a:gd name="connsiteY1" fmla="*/ 51 h 10000"/>
                <a:gd name="connsiteX2" fmla="*/ 5502 w 10000"/>
                <a:gd name="connsiteY2" fmla="*/ 677 h 10000"/>
                <a:gd name="connsiteX3" fmla="*/ 4039 w 10000"/>
                <a:gd name="connsiteY3" fmla="*/ 722 h 10000"/>
                <a:gd name="connsiteX4" fmla="*/ 1244 w 10000"/>
                <a:gd name="connsiteY4" fmla="*/ 1750 h 10000"/>
                <a:gd name="connsiteX5" fmla="*/ 413 w 10000"/>
                <a:gd name="connsiteY5" fmla="*/ 7880 h 10000"/>
                <a:gd name="connsiteX6" fmla="*/ 1573 w 10000"/>
                <a:gd name="connsiteY6" fmla="*/ 9379 h 10000"/>
                <a:gd name="connsiteX7" fmla="*/ 3574 w 10000"/>
                <a:gd name="connsiteY7" fmla="*/ 8901 h 10000"/>
                <a:gd name="connsiteX8" fmla="*/ 4492 w 10000"/>
                <a:gd name="connsiteY8" fmla="*/ 8526 h 10000"/>
                <a:gd name="connsiteX9" fmla="*/ 5529 w 10000"/>
                <a:gd name="connsiteY9" fmla="*/ 8014 h 10000"/>
                <a:gd name="connsiteX10" fmla="*/ 5740 w 10000"/>
                <a:gd name="connsiteY10" fmla="*/ 8999 h 10000"/>
                <a:gd name="connsiteX11" fmla="*/ 6003 w 10000"/>
                <a:gd name="connsiteY11" fmla="*/ 9692 h 10000"/>
                <a:gd name="connsiteX12" fmla="*/ 7744 w 10000"/>
                <a:gd name="connsiteY12" fmla="*/ 9804 h 10000"/>
                <a:gd name="connsiteX13" fmla="*/ 7823 w 10000"/>
                <a:gd name="connsiteY13" fmla="*/ 9781 h 10000"/>
                <a:gd name="connsiteX14" fmla="*/ 9695 w 10000"/>
                <a:gd name="connsiteY14" fmla="*/ 6628 h 10000"/>
                <a:gd name="connsiteX15" fmla="*/ 9814 w 10000"/>
                <a:gd name="connsiteY15" fmla="*/ 5375 h 10000"/>
                <a:gd name="connsiteX16" fmla="*/ 9774 w 10000"/>
                <a:gd name="connsiteY16" fmla="*/ 1773 h 10000"/>
                <a:gd name="connsiteX0" fmla="*/ 9774 w 10000"/>
                <a:gd name="connsiteY0" fmla="*/ 1773 h 10000"/>
                <a:gd name="connsiteX1" fmla="*/ 6385 w 10000"/>
                <a:gd name="connsiteY1" fmla="*/ 51 h 10000"/>
                <a:gd name="connsiteX2" fmla="*/ 5502 w 10000"/>
                <a:gd name="connsiteY2" fmla="*/ 677 h 10000"/>
                <a:gd name="connsiteX3" fmla="*/ 4039 w 10000"/>
                <a:gd name="connsiteY3" fmla="*/ 722 h 10000"/>
                <a:gd name="connsiteX4" fmla="*/ 1244 w 10000"/>
                <a:gd name="connsiteY4" fmla="*/ 1750 h 10000"/>
                <a:gd name="connsiteX5" fmla="*/ 413 w 10000"/>
                <a:gd name="connsiteY5" fmla="*/ 7880 h 10000"/>
                <a:gd name="connsiteX6" fmla="*/ 1573 w 10000"/>
                <a:gd name="connsiteY6" fmla="*/ 9379 h 10000"/>
                <a:gd name="connsiteX7" fmla="*/ 3574 w 10000"/>
                <a:gd name="connsiteY7" fmla="*/ 8901 h 10000"/>
                <a:gd name="connsiteX8" fmla="*/ 4492 w 10000"/>
                <a:gd name="connsiteY8" fmla="*/ 8526 h 10000"/>
                <a:gd name="connsiteX9" fmla="*/ 5529 w 10000"/>
                <a:gd name="connsiteY9" fmla="*/ 8014 h 10000"/>
                <a:gd name="connsiteX10" fmla="*/ 5740 w 10000"/>
                <a:gd name="connsiteY10" fmla="*/ 8999 h 10000"/>
                <a:gd name="connsiteX11" fmla="*/ 6003 w 10000"/>
                <a:gd name="connsiteY11" fmla="*/ 9692 h 10000"/>
                <a:gd name="connsiteX12" fmla="*/ 7744 w 10000"/>
                <a:gd name="connsiteY12" fmla="*/ 9804 h 10000"/>
                <a:gd name="connsiteX13" fmla="*/ 7823 w 10000"/>
                <a:gd name="connsiteY13" fmla="*/ 9781 h 10000"/>
                <a:gd name="connsiteX14" fmla="*/ 9695 w 10000"/>
                <a:gd name="connsiteY14" fmla="*/ 6628 h 10000"/>
                <a:gd name="connsiteX15" fmla="*/ 9814 w 10000"/>
                <a:gd name="connsiteY15" fmla="*/ 5375 h 10000"/>
                <a:gd name="connsiteX16" fmla="*/ 9774 w 10000"/>
                <a:gd name="connsiteY16" fmla="*/ 1773 h 10000"/>
                <a:gd name="connsiteX0" fmla="*/ 9774 w 10000"/>
                <a:gd name="connsiteY0" fmla="*/ 1773 h 10000"/>
                <a:gd name="connsiteX1" fmla="*/ 6385 w 10000"/>
                <a:gd name="connsiteY1" fmla="*/ 51 h 10000"/>
                <a:gd name="connsiteX2" fmla="*/ 5502 w 10000"/>
                <a:gd name="connsiteY2" fmla="*/ 677 h 10000"/>
                <a:gd name="connsiteX3" fmla="*/ 4039 w 10000"/>
                <a:gd name="connsiteY3" fmla="*/ 722 h 10000"/>
                <a:gd name="connsiteX4" fmla="*/ 1244 w 10000"/>
                <a:gd name="connsiteY4" fmla="*/ 1750 h 10000"/>
                <a:gd name="connsiteX5" fmla="*/ 413 w 10000"/>
                <a:gd name="connsiteY5" fmla="*/ 7880 h 10000"/>
                <a:gd name="connsiteX6" fmla="*/ 1573 w 10000"/>
                <a:gd name="connsiteY6" fmla="*/ 9379 h 10000"/>
                <a:gd name="connsiteX7" fmla="*/ 3589 w 10000"/>
                <a:gd name="connsiteY7" fmla="*/ 9002 h 10000"/>
                <a:gd name="connsiteX8" fmla="*/ 4492 w 10000"/>
                <a:gd name="connsiteY8" fmla="*/ 8526 h 10000"/>
                <a:gd name="connsiteX9" fmla="*/ 5529 w 10000"/>
                <a:gd name="connsiteY9" fmla="*/ 8014 h 10000"/>
                <a:gd name="connsiteX10" fmla="*/ 5740 w 10000"/>
                <a:gd name="connsiteY10" fmla="*/ 8999 h 10000"/>
                <a:gd name="connsiteX11" fmla="*/ 6003 w 10000"/>
                <a:gd name="connsiteY11" fmla="*/ 9692 h 10000"/>
                <a:gd name="connsiteX12" fmla="*/ 7744 w 10000"/>
                <a:gd name="connsiteY12" fmla="*/ 9804 h 10000"/>
                <a:gd name="connsiteX13" fmla="*/ 7823 w 10000"/>
                <a:gd name="connsiteY13" fmla="*/ 9781 h 10000"/>
                <a:gd name="connsiteX14" fmla="*/ 9695 w 10000"/>
                <a:gd name="connsiteY14" fmla="*/ 6628 h 10000"/>
                <a:gd name="connsiteX15" fmla="*/ 9814 w 10000"/>
                <a:gd name="connsiteY15" fmla="*/ 5375 h 10000"/>
                <a:gd name="connsiteX16" fmla="*/ 9774 w 10000"/>
                <a:gd name="connsiteY16" fmla="*/ 1773 h 10000"/>
                <a:gd name="connsiteX0" fmla="*/ 9774 w 10000"/>
                <a:gd name="connsiteY0" fmla="*/ 1773 h 10000"/>
                <a:gd name="connsiteX1" fmla="*/ 6385 w 10000"/>
                <a:gd name="connsiteY1" fmla="*/ 51 h 10000"/>
                <a:gd name="connsiteX2" fmla="*/ 5502 w 10000"/>
                <a:gd name="connsiteY2" fmla="*/ 677 h 10000"/>
                <a:gd name="connsiteX3" fmla="*/ 4039 w 10000"/>
                <a:gd name="connsiteY3" fmla="*/ 722 h 10000"/>
                <a:gd name="connsiteX4" fmla="*/ 1244 w 10000"/>
                <a:gd name="connsiteY4" fmla="*/ 1750 h 10000"/>
                <a:gd name="connsiteX5" fmla="*/ 413 w 10000"/>
                <a:gd name="connsiteY5" fmla="*/ 7880 h 10000"/>
                <a:gd name="connsiteX6" fmla="*/ 1573 w 10000"/>
                <a:gd name="connsiteY6" fmla="*/ 9379 h 10000"/>
                <a:gd name="connsiteX7" fmla="*/ 3589 w 10000"/>
                <a:gd name="connsiteY7" fmla="*/ 9002 h 10000"/>
                <a:gd name="connsiteX8" fmla="*/ 4492 w 10000"/>
                <a:gd name="connsiteY8" fmla="*/ 8526 h 10000"/>
                <a:gd name="connsiteX9" fmla="*/ 5379 w 10000"/>
                <a:gd name="connsiteY9" fmla="*/ 7981 h 10000"/>
                <a:gd name="connsiteX10" fmla="*/ 5740 w 10000"/>
                <a:gd name="connsiteY10" fmla="*/ 8999 h 10000"/>
                <a:gd name="connsiteX11" fmla="*/ 6003 w 10000"/>
                <a:gd name="connsiteY11" fmla="*/ 9692 h 10000"/>
                <a:gd name="connsiteX12" fmla="*/ 7744 w 10000"/>
                <a:gd name="connsiteY12" fmla="*/ 9804 h 10000"/>
                <a:gd name="connsiteX13" fmla="*/ 7823 w 10000"/>
                <a:gd name="connsiteY13" fmla="*/ 9781 h 10000"/>
                <a:gd name="connsiteX14" fmla="*/ 9695 w 10000"/>
                <a:gd name="connsiteY14" fmla="*/ 6628 h 10000"/>
                <a:gd name="connsiteX15" fmla="*/ 9814 w 10000"/>
                <a:gd name="connsiteY15" fmla="*/ 5375 h 10000"/>
                <a:gd name="connsiteX16" fmla="*/ 9774 w 10000"/>
                <a:gd name="connsiteY16" fmla="*/ 1773 h 10000"/>
                <a:gd name="connsiteX0" fmla="*/ 9774 w 10000"/>
                <a:gd name="connsiteY0" fmla="*/ 1773 h 10000"/>
                <a:gd name="connsiteX1" fmla="*/ 6385 w 10000"/>
                <a:gd name="connsiteY1" fmla="*/ 51 h 10000"/>
                <a:gd name="connsiteX2" fmla="*/ 5502 w 10000"/>
                <a:gd name="connsiteY2" fmla="*/ 677 h 10000"/>
                <a:gd name="connsiteX3" fmla="*/ 4039 w 10000"/>
                <a:gd name="connsiteY3" fmla="*/ 722 h 10000"/>
                <a:gd name="connsiteX4" fmla="*/ 1244 w 10000"/>
                <a:gd name="connsiteY4" fmla="*/ 1750 h 10000"/>
                <a:gd name="connsiteX5" fmla="*/ 413 w 10000"/>
                <a:gd name="connsiteY5" fmla="*/ 7880 h 10000"/>
                <a:gd name="connsiteX6" fmla="*/ 1573 w 10000"/>
                <a:gd name="connsiteY6" fmla="*/ 9379 h 10000"/>
                <a:gd name="connsiteX7" fmla="*/ 3589 w 10000"/>
                <a:gd name="connsiteY7" fmla="*/ 9002 h 10000"/>
                <a:gd name="connsiteX8" fmla="*/ 4492 w 10000"/>
                <a:gd name="connsiteY8" fmla="*/ 8526 h 10000"/>
                <a:gd name="connsiteX9" fmla="*/ 5379 w 10000"/>
                <a:gd name="connsiteY9" fmla="*/ 7981 h 10000"/>
                <a:gd name="connsiteX10" fmla="*/ 5740 w 10000"/>
                <a:gd name="connsiteY10" fmla="*/ 8999 h 10000"/>
                <a:gd name="connsiteX11" fmla="*/ 6003 w 10000"/>
                <a:gd name="connsiteY11" fmla="*/ 9692 h 10000"/>
                <a:gd name="connsiteX12" fmla="*/ 7744 w 10000"/>
                <a:gd name="connsiteY12" fmla="*/ 9804 h 10000"/>
                <a:gd name="connsiteX13" fmla="*/ 7823 w 10000"/>
                <a:gd name="connsiteY13" fmla="*/ 9781 h 10000"/>
                <a:gd name="connsiteX14" fmla="*/ 9695 w 10000"/>
                <a:gd name="connsiteY14" fmla="*/ 6628 h 10000"/>
                <a:gd name="connsiteX15" fmla="*/ 9814 w 10000"/>
                <a:gd name="connsiteY15" fmla="*/ 5375 h 10000"/>
                <a:gd name="connsiteX16" fmla="*/ 9774 w 10000"/>
                <a:gd name="connsiteY16" fmla="*/ 1773 h 10000"/>
                <a:gd name="connsiteX0" fmla="*/ 9774 w 10000"/>
                <a:gd name="connsiteY0" fmla="*/ 1773 h 10000"/>
                <a:gd name="connsiteX1" fmla="*/ 6385 w 10000"/>
                <a:gd name="connsiteY1" fmla="*/ 51 h 10000"/>
                <a:gd name="connsiteX2" fmla="*/ 5502 w 10000"/>
                <a:gd name="connsiteY2" fmla="*/ 677 h 10000"/>
                <a:gd name="connsiteX3" fmla="*/ 4039 w 10000"/>
                <a:gd name="connsiteY3" fmla="*/ 722 h 10000"/>
                <a:gd name="connsiteX4" fmla="*/ 1244 w 10000"/>
                <a:gd name="connsiteY4" fmla="*/ 1750 h 10000"/>
                <a:gd name="connsiteX5" fmla="*/ 413 w 10000"/>
                <a:gd name="connsiteY5" fmla="*/ 7880 h 10000"/>
                <a:gd name="connsiteX6" fmla="*/ 1573 w 10000"/>
                <a:gd name="connsiteY6" fmla="*/ 9379 h 10000"/>
                <a:gd name="connsiteX7" fmla="*/ 3589 w 10000"/>
                <a:gd name="connsiteY7" fmla="*/ 9002 h 10000"/>
                <a:gd name="connsiteX8" fmla="*/ 4492 w 10000"/>
                <a:gd name="connsiteY8" fmla="*/ 8526 h 10000"/>
                <a:gd name="connsiteX9" fmla="*/ 5366 w 10000"/>
                <a:gd name="connsiteY9" fmla="*/ 7762 h 10000"/>
                <a:gd name="connsiteX10" fmla="*/ 5740 w 10000"/>
                <a:gd name="connsiteY10" fmla="*/ 8999 h 10000"/>
                <a:gd name="connsiteX11" fmla="*/ 6003 w 10000"/>
                <a:gd name="connsiteY11" fmla="*/ 9692 h 10000"/>
                <a:gd name="connsiteX12" fmla="*/ 7744 w 10000"/>
                <a:gd name="connsiteY12" fmla="*/ 9804 h 10000"/>
                <a:gd name="connsiteX13" fmla="*/ 7823 w 10000"/>
                <a:gd name="connsiteY13" fmla="*/ 9781 h 10000"/>
                <a:gd name="connsiteX14" fmla="*/ 9695 w 10000"/>
                <a:gd name="connsiteY14" fmla="*/ 6628 h 10000"/>
                <a:gd name="connsiteX15" fmla="*/ 9814 w 10000"/>
                <a:gd name="connsiteY15" fmla="*/ 5375 h 10000"/>
                <a:gd name="connsiteX16" fmla="*/ 9774 w 10000"/>
                <a:gd name="connsiteY16" fmla="*/ 1773 h 10000"/>
                <a:gd name="connsiteX0" fmla="*/ 9774 w 10000"/>
                <a:gd name="connsiteY0" fmla="*/ 1773 h 10000"/>
                <a:gd name="connsiteX1" fmla="*/ 6385 w 10000"/>
                <a:gd name="connsiteY1" fmla="*/ 51 h 10000"/>
                <a:gd name="connsiteX2" fmla="*/ 5502 w 10000"/>
                <a:gd name="connsiteY2" fmla="*/ 677 h 10000"/>
                <a:gd name="connsiteX3" fmla="*/ 4039 w 10000"/>
                <a:gd name="connsiteY3" fmla="*/ 722 h 10000"/>
                <a:gd name="connsiteX4" fmla="*/ 1244 w 10000"/>
                <a:gd name="connsiteY4" fmla="*/ 1750 h 10000"/>
                <a:gd name="connsiteX5" fmla="*/ 413 w 10000"/>
                <a:gd name="connsiteY5" fmla="*/ 7880 h 10000"/>
                <a:gd name="connsiteX6" fmla="*/ 1573 w 10000"/>
                <a:gd name="connsiteY6" fmla="*/ 9379 h 10000"/>
                <a:gd name="connsiteX7" fmla="*/ 3589 w 10000"/>
                <a:gd name="connsiteY7" fmla="*/ 9002 h 10000"/>
                <a:gd name="connsiteX8" fmla="*/ 4492 w 10000"/>
                <a:gd name="connsiteY8" fmla="*/ 8526 h 10000"/>
                <a:gd name="connsiteX9" fmla="*/ 5366 w 10000"/>
                <a:gd name="connsiteY9" fmla="*/ 7762 h 10000"/>
                <a:gd name="connsiteX10" fmla="*/ 5740 w 10000"/>
                <a:gd name="connsiteY10" fmla="*/ 8999 h 10000"/>
                <a:gd name="connsiteX11" fmla="*/ 6003 w 10000"/>
                <a:gd name="connsiteY11" fmla="*/ 9692 h 10000"/>
                <a:gd name="connsiteX12" fmla="*/ 7744 w 10000"/>
                <a:gd name="connsiteY12" fmla="*/ 9804 h 10000"/>
                <a:gd name="connsiteX13" fmla="*/ 7823 w 10000"/>
                <a:gd name="connsiteY13" fmla="*/ 9781 h 10000"/>
                <a:gd name="connsiteX14" fmla="*/ 9695 w 10000"/>
                <a:gd name="connsiteY14" fmla="*/ 6628 h 10000"/>
                <a:gd name="connsiteX15" fmla="*/ 9814 w 10000"/>
                <a:gd name="connsiteY15" fmla="*/ 5375 h 10000"/>
                <a:gd name="connsiteX16" fmla="*/ 9774 w 10000"/>
                <a:gd name="connsiteY16" fmla="*/ 1773 h 10000"/>
                <a:gd name="connsiteX0" fmla="*/ 9774 w 10000"/>
                <a:gd name="connsiteY0" fmla="*/ 1773 h 10000"/>
                <a:gd name="connsiteX1" fmla="*/ 6385 w 10000"/>
                <a:gd name="connsiteY1" fmla="*/ 51 h 10000"/>
                <a:gd name="connsiteX2" fmla="*/ 5502 w 10000"/>
                <a:gd name="connsiteY2" fmla="*/ 677 h 10000"/>
                <a:gd name="connsiteX3" fmla="*/ 4039 w 10000"/>
                <a:gd name="connsiteY3" fmla="*/ 722 h 10000"/>
                <a:gd name="connsiteX4" fmla="*/ 1244 w 10000"/>
                <a:gd name="connsiteY4" fmla="*/ 1750 h 10000"/>
                <a:gd name="connsiteX5" fmla="*/ 413 w 10000"/>
                <a:gd name="connsiteY5" fmla="*/ 7880 h 10000"/>
                <a:gd name="connsiteX6" fmla="*/ 1573 w 10000"/>
                <a:gd name="connsiteY6" fmla="*/ 9379 h 10000"/>
                <a:gd name="connsiteX7" fmla="*/ 3589 w 10000"/>
                <a:gd name="connsiteY7" fmla="*/ 9002 h 10000"/>
                <a:gd name="connsiteX8" fmla="*/ 4492 w 10000"/>
                <a:gd name="connsiteY8" fmla="*/ 8526 h 10000"/>
                <a:gd name="connsiteX9" fmla="*/ 5296 w 10000"/>
                <a:gd name="connsiteY9" fmla="*/ 7760 h 10000"/>
                <a:gd name="connsiteX10" fmla="*/ 5740 w 10000"/>
                <a:gd name="connsiteY10" fmla="*/ 8999 h 10000"/>
                <a:gd name="connsiteX11" fmla="*/ 6003 w 10000"/>
                <a:gd name="connsiteY11" fmla="*/ 9692 h 10000"/>
                <a:gd name="connsiteX12" fmla="*/ 7744 w 10000"/>
                <a:gd name="connsiteY12" fmla="*/ 9804 h 10000"/>
                <a:gd name="connsiteX13" fmla="*/ 7823 w 10000"/>
                <a:gd name="connsiteY13" fmla="*/ 9781 h 10000"/>
                <a:gd name="connsiteX14" fmla="*/ 9695 w 10000"/>
                <a:gd name="connsiteY14" fmla="*/ 6628 h 10000"/>
                <a:gd name="connsiteX15" fmla="*/ 9814 w 10000"/>
                <a:gd name="connsiteY15" fmla="*/ 5375 h 10000"/>
                <a:gd name="connsiteX16" fmla="*/ 9774 w 10000"/>
                <a:gd name="connsiteY16" fmla="*/ 1773 h 10000"/>
                <a:gd name="connsiteX0" fmla="*/ 9774 w 10000"/>
                <a:gd name="connsiteY0" fmla="*/ 1773 h 10000"/>
                <a:gd name="connsiteX1" fmla="*/ 6385 w 10000"/>
                <a:gd name="connsiteY1" fmla="*/ 51 h 10000"/>
                <a:gd name="connsiteX2" fmla="*/ 5502 w 10000"/>
                <a:gd name="connsiteY2" fmla="*/ 677 h 10000"/>
                <a:gd name="connsiteX3" fmla="*/ 4039 w 10000"/>
                <a:gd name="connsiteY3" fmla="*/ 722 h 10000"/>
                <a:gd name="connsiteX4" fmla="*/ 1244 w 10000"/>
                <a:gd name="connsiteY4" fmla="*/ 1750 h 10000"/>
                <a:gd name="connsiteX5" fmla="*/ 413 w 10000"/>
                <a:gd name="connsiteY5" fmla="*/ 7880 h 10000"/>
                <a:gd name="connsiteX6" fmla="*/ 1573 w 10000"/>
                <a:gd name="connsiteY6" fmla="*/ 9379 h 10000"/>
                <a:gd name="connsiteX7" fmla="*/ 3589 w 10000"/>
                <a:gd name="connsiteY7" fmla="*/ 9002 h 10000"/>
                <a:gd name="connsiteX8" fmla="*/ 4523 w 10000"/>
                <a:gd name="connsiteY8" fmla="*/ 8609 h 10000"/>
                <a:gd name="connsiteX9" fmla="*/ 5296 w 10000"/>
                <a:gd name="connsiteY9" fmla="*/ 7760 h 10000"/>
                <a:gd name="connsiteX10" fmla="*/ 5740 w 10000"/>
                <a:gd name="connsiteY10" fmla="*/ 8999 h 10000"/>
                <a:gd name="connsiteX11" fmla="*/ 6003 w 10000"/>
                <a:gd name="connsiteY11" fmla="*/ 9692 h 10000"/>
                <a:gd name="connsiteX12" fmla="*/ 7744 w 10000"/>
                <a:gd name="connsiteY12" fmla="*/ 9804 h 10000"/>
                <a:gd name="connsiteX13" fmla="*/ 7823 w 10000"/>
                <a:gd name="connsiteY13" fmla="*/ 9781 h 10000"/>
                <a:gd name="connsiteX14" fmla="*/ 9695 w 10000"/>
                <a:gd name="connsiteY14" fmla="*/ 6628 h 10000"/>
                <a:gd name="connsiteX15" fmla="*/ 9814 w 10000"/>
                <a:gd name="connsiteY15" fmla="*/ 5375 h 10000"/>
                <a:gd name="connsiteX16" fmla="*/ 9774 w 10000"/>
                <a:gd name="connsiteY16" fmla="*/ 1773 h 10000"/>
                <a:gd name="connsiteX0" fmla="*/ 9774 w 10000"/>
                <a:gd name="connsiteY0" fmla="*/ 1773 h 10000"/>
                <a:gd name="connsiteX1" fmla="*/ 6385 w 10000"/>
                <a:gd name="connsiteY1" fmla="*/ 51 h 10000"/>
                <a:gd name="connsiteX2" fmla="*/ 5502 w 10000"/>
                <a:gd name="connsiteY2" fmla="*/ 677 h 10000"/>
                <a:gd name="connsiteX3" fmla="*/ 4039 w 10000"/>
                <a:gd name="connsiteY3" fmla="*/ 722 h 10000"/>
                <a:gd name="connsiteX4" fmla="*/ 1244 w 10000"/>
                <a:gd name="connsiteY4" fmla="*/ 1750 h 10000"/>
                <a:gd name="connsiteX5" fmla="*/ 413 w 10000"/>
                <a:gd name="connsiteY5" fmla="*/ 7880 h 10000"/>
                <a:gd name="connsiteX6" fmla="*/ 1573 w 10000"/>
                <a:gd name="connsiteY6" fmla="*/ 9379 h 10000"/>
                <a:gd name="connsiteX7" fmla="*/ 3554 w 10000"/>
                <a:gd name="connsiteY7" fmla="*/ 9274 h 10000"/>
                <a:gd name="connsiteX8" fmla="*/ 4523 w 10000"/>
                <a:gd name="connsiteY8" fmla="*/ 8609 h 10000"/>
                <a:gd name="connsiteX9" fmla="*/ 5296 w 10000"/>
                <a:gd name="connsiteY9" fmla="*/ 7760 h 10000"/>
                <a:gd name="connsiteX10" fmla="*/ 5740 w 10000"/>
                <a:gd name="connsiteY10" fmla="*/ 8999 h 10000"/>
                <a:gd name="connsiteX11" fmla="*/ 6003 w 10000"/>
                <a:gd name="connsiteY11" fmla="*/ 9692 h 10000"/>
                <a:gd name="connsiteX12" fmla="*/ 7744 w 10000"/>
                <a:gd name="connsiteY12" fmla="*/ 9804 h 10000"/>
                <a:gd name="connsiteX13" fmla="*/ 7823 w 10000"/>
                <a:gd name="connsiteY13" fmla="*/ 9781 h 10000"/>
                <a:gd name="connsiteX14" fmla="*/ 9695 w 10000"/>
                <a:gd name="connsiteY14" fmla="*/ 6628 h 10000"/>
                <a:gd name="connsiteX15" fmla="*/ 9814 w 10000"/>
                <a:gd name="connsiteY15" fmla="*/ 5375 h 10000"/>
                <a:gd name="connsiteX16" fmla="*/ 9774 w 10000"/>
                <a:gd name="connsiteY16" fmla="*/ 1773 h 10000"/>
                <a:gd name="connsiteX0" fmla="*/ 9774 w 10000"/>
                <a:gd name="connsiteY0" fmla="*/ 1773 h 10000"/>
                <a:gd name="connsiteX1" fmla="*/ 6385 w 10000"/>
                <a:gd name="connsiteY1" fmla="*/ 51 h 10000"/>
                <a:gd name="connsiteX2" fmla="*/ 5502 w 10000"/>
                <a:gd name="connsiteY2" fmla="*/ 677 h 10000"/>
                <a:gd name="connsiteX3" fmla="*/ 4039 w 10000"/>
                <a:gd name="connsiteY3" fmla="*/ 722 h 10000"/>
                <a:gd name="connsiteX4" fmla="*/ 1244 w 10000"/>
                <a:gd name="connsiteY4" fmla="*/ 1750 h 10000"/>
                <a:gd name="connsiteX5" fmla="*/ 413 w 10000"/>
                <a:gd name="connsiteY5" fmla="*/ 7880 h 10000"/>
                <a:gd name="connsiteX6" fmla="*/ 1573 w 10000"/>
                <a:gd name="connsiteY6" fmla="*/ 9379 h 10000"/>
                <a:gd name="connsiteX7" fmla="*/ 3554 w 10000"/>
                <a:gd name="connsiteY7" fmla="*/ 9274 h 10000"/>
                <a:gd name="connsiteX8" fmla="*/ 4523 w 10000"/>
                <a:gd name="connsiteY8" fmla="*/ 8609 h 10000"/>
                <a:gd name="connsiteX9" fmla="*/ 5296 w 10000"/>
                <a:gd name="connsiteY9" fmla="*/ 7760 h 10000"/>
                <a:gd name="connsiteX10" fmla="*/ 5740 w 10000"/>
                <a:gd name="connsiteY10" fmla="*/ 8999 h 10000"/>
                <a:gd name="connsiteX11" fmla="*/ 6003 w 10000"/>
                <a:gd name="connsiteY11" fmla="*/ 9692 h 10000"/>
                <a:gd name="connsiteX12" fmla="*/ 7744 w 10000"/>
                <a:gd name="connsiteY12" fmla="*/ 9804 h 10000"/>
                <a:gd name="connsiteX13" fmla="*/ 7823 w 10000"/>
                <a:gd name="connsiteY13" fmla="*/ 9781 h 10000"/>
                <a:gd name="connsiteX14" fmla="*/ 9695 w 10000"/>
                <a:gd name="connsiteY14" fmla="*/ 6628 h 10000"/>
                <a:gd name="connsiteX15" fmla="*/ 9814 w 10000"/>
                <a:gd name="connsiteY15" fmla="*/ 5375 h 10000"/>
                <a:gd name="connsiteX16" fmla="*/ 9774 w 10000"/>
                <a:gd name="connsiteY16" fmla="*/ 1773 h 10000"/>
                <a:gd name="connsiteX0" fmla="*/ 9774 w 10000"/>
                <a:gd name="connsiteY0" fmla="*/ 1773 h 10000"/>
                <a:gd name="connsiteX1" fmla="*/ 6385 w 10000"/>
                <a:gd name="connsiteY1" fmla="*/ 51 h 10000"/>
                <a:gd name="connsiteX2" fmla="*/ 5502 w 10000"/>
                <a:gd name="connsiteY2" fmla="*/ 677 h 10000"/>
                <a:gd name="connsiteX3" fmla="*/ 4039 w 10000"/>
                <a:gd name="connsiteY3" fmla="*/ 722 h 10000"/>
                <a:gd name="connsiteX4" fmla="*/ 1244 w 10000"/>
                <a:gd name="connsiteY4" fmla="*/ 1750 h 10000"/>
                <a:gd name="connsiteX5" fmla="*/ 413 w 10000"/>
                <a:gd name="connsiteY5" fmla="*/ 7880 h 10000"/>
                <a:gd name="connsiteX6" fmla="*/ 1573 w 10000"/>
                <a:gd name="connsiteY6" fmla="*/ 9379 h 10000"/>
                <a:gd name="connsiteX7" fmla="*/ 3554 w 10000"/>
                <a:gd name="connsiteY7" fmla="*/ 9274 h 10000"/>
                <a:gd name="connsiteX8" fmla="*/ 4523 w 10000"/>
                <a:gd name="connsiteY8" fmla="*/ 8609 h 10000"/>
                <a:gd name="connsiteX9" fmla="*/ 5296 w 10000"/>
                <a:gd name="connsiteY9" fmla="*/ 7760 h 10000"/>
                <a:gd name="connsiteX10" fmla="*/ 6003 w 10000"/>
                <a:gd name="connsiteY10" fmla="*/ 9692 h 10000"/>
                <a:gd name="connsiteX11" fmla="*/ 7744 w 10000"/>
                <a:gd name="connsiteY11" fmla="*/ 9804 h 10000"/>
                <a:gd name="connsiteX12" fmla="*/ 7823 w 10000"/>
                <a:gd name="connsiteY12" fmla="*/ 9781 h 10000"/>
                <a:gd name="connsiteX13" fmla="*/ 9695 w 10000"/>
                <a:gd name="connsiteY13" fmla="*/ 6628 h 10000"/>
                <a:gd name="connsiteX14" fmla="*/ 9814 w 10000"/>
                <a:gd name="connsiteY14" fmla="*/ 5375 h 10000"/>
                <a:gd name="connsiteX15" fmla="*/ 9774 w 10000"/>
                <a:gd name="connsiteY15" fmla="*/ 1773 h 10000"/>
                <a:gd name="connsiteX0" fmla="*/ 9774 w 10000"/>
                <a:gd name="connsiteY0" fmla="*/ 1773 h 10000"/>
                <a:gd name="connsiteX1" fmla="*/ 6385 w 10000"/>
                <a:gd name="connsiteY1" fmla="*/ 51 h 10000"/>
                <a:gd name="connsiteX2" fmla="*/ 5502 w 10000"/>
                <a:gd name="connsiteY2" fmla="*/ 677 h 10000"/>
                <a:gd name="connsiteX3" fmla="*/ 4039 w 10000"/>
                <a:gd name="connsiteY3" fmla="*/ 722 h 10000"/>
                <a:gd name="connsiteX4" fmla="*/ 1244 w 10000"/>
                <a:gd name="connsiteY4" fmla="*/ 1750 h 10000"/>
                <a:gd name="connsiteX5" fmla="*/ 413 w 10000"/>
                <a:gd name="connsiteY5" fmla="*/ 7880 h 10000"/>
                <a:gd name="connsiteX6" fmla="*/ 1573 w 10000"/>
                <a:gd name="connsiteY6" fmla="*/ 9379 h 10000"/>
                <a:gd name="connsiteX7" fmla="*/ 3554 w 10000"/>
                <a:gd name="connsiteY7" fmla="*/ 9274 h 10000"/>
                <a:gd name="connsiteX8" fmla="*/ 4580 w 10000"/>
                <a:gd name="connsiteY8" fmla="*/ 8821 h 10000"/>
                <a:gd name="connsiteX9" fmla="*/ 5296 w 10000"/>
                <a:gd name="connsiteY9" fmla="*/ 7760 h 10000"/>
                <a:gd name="connsiteX10" fmla="*/ 6003 w 10000"/>
                <a:gd name="connsiteY10" fmla="*/ 9692 h 10000"/>
                <a:gd name="connsiteX11" fmla="*/ 7744 w 10000"/>
                <a:gd name="connsiteY11" fmla="*/ 9804 h 10000"/>
                <a:gd name="connsiteX12" fmla="*/ 7823 w 10000"/>
                <a:gd name="connsiteY12" fmla="*/ 9781 h 10000"/>
                <a:gd name="connsiteX13" fmla="*/ 9695 w 10000"/>
                <a:gd name="connsiteY13" fmla="*/ 6628 h 10000"/>
                <a:gd name="connsiteX14" fmla="*/ 9814 w 10000"/>
                <a:gd name="connsiteY14" fmla="*/ 5375 h 10000"/>
                <a:gd name="connsiteX15" fmla="*/ 9774 w 10000"/>
                <a:gd name="connsiteY15" fmla="*/ 1773 h 10000"/>
                <a:gd name="connsiteX0" fmla="*/ 9774 w 10000"/>
                <a:gd name="connsiteY0" fmla="*/ 1773 h 10000"/>
                <a:gd name="connsiteX1" fmla="*/ 6385 w 10000"/>
                <a:gd name="connsiteY1" fmla="*/ 51 h 10000"/>
                <a:gd name="connsiteX2" fmla="*/ 5502 w 10000"/>
                <a:gd name="connsiteY2" fmla="*/ 677 h 10000"/>
                <a:gd name="connsiteX3" fmla="*/ 4039 w 10000"/>
                <a:gd name="connsiteY3" fmla="*/ 722 h 10000"/>
                <a:gd name="connsiteX4" fmla="*/ 1244 w 10000"/>
                <a:gd name="connsiteY4" fmla="*/ 1750 h 10000"/>
                <a:gd name="connsiteX5" fmla="*/ 413 w 10000"/>
                <a:gd name="connsiteY5" fmla="*/ 7880 h 10000"/>
                <a:gd name="connsiteX6" fmla="*/ 1573 w 10000"/>
                <a:gd name="connsiteY6" fmla="*/ 9379 h 10000"/>
                <a:gd name="connsiteX7" fmla="*/ 3567 w 10000"/>
                <a:gd name="connsiteY7" fmla="*/ 9493 h 10000"/>
                <a:gd name="connsiteX8" fmla="*/ 4580 w 10000"/>
                <a:gd name="connsiteY8" fmla="*/ 8821 h 10000"/>
                <a:gd name="connsiteX9" fmla="*/ 5296 w 10000"/>
                <a:gd name="connsiteY9" fmla="*/ 7760 h 10000"/>
                <a:gd name="connsiteX10" fmla="*/ 6003 w 10000"/>
                <a:gd name="connsiteY10" fmla="*/ 9692 h 10000"/>
                <a:gd name="connsiteX11" fmla="*/ 7744 w 10000"/>
                <a:gd name="connsiteY11" fmla="*/ 9804 h 10000"/>
                <a:gd name="connsiteX12" fmla="*/ 7823 w 10000"/>
                <a:gd name="connsiteY12" fmla="*/ 9781 h 10000"/>
                <a:gd name="connsiteX13" fmla="*/ 9695 w 10000"/>
                <a:gd name="connsiteY13" fmla="*/ 6628 h 10000"/>
                <a:gd name="connsiteX14" fmla="*/ 9814 w 10000"/>
                <a:gd name="connsiteY14" fmla="*/ 5375 h 10000"/>
                <a:gd name="connsiteX15" fmla="*/ 9774 w 10000"/>
                <a:gd name="connsiteY15" fmla="*/ 1773 h 10000"/>
                <a:gd name="connsiteX0" fmla="*/ 9774 w 10000"/>
                <a:gd name="connsiteY0" fmla="*/ 1773 h 10000"/>
                <a:gd name="connsiteX1" fmla="*/ 6385 w 10000"/>
                <a:gd name="connsiteY1" fmla="*/ 51 h 10000"/>
                <a:gd name="connsiteX2" fmla="*/ 5502 w 10000"/>
                <a:gd name="connsiteY2" fmla="*/ 677 h 10000"/>
                <a:gd name="connsiteX3" fmla="*/ 4039 w 10000"/>
                <a:gd name="connsiteY3" fmla="*/ 722 h 10000"/>
                <a:gd name="connsiteX4" fmla="*/ 1244 w 10000"/>
                <a:gd name="connsiteY4" fmla="*/ 1750 h 10000"/>
                <a:gd name="connsiteX5" fmla="*/ 413 w 10000"/>
                <a:gd name="connsiteY5" fmla="*/ 7880 h 10000"/>
                <a:gd name="connsiteX6" fmla="*/ 1573 w 10000"/>
                <a:gd name="connsiteY6" fmla="*/ 9379 h 10000"/>
                <a:gd name="connsiteX7" fmla="*/ 3567 w 10000"/>
                <a:gd name="connsiteY7" fmla="*/ 9493 h 10000"/>
                <a:gd name="connsiteX8" fmla="*/ 4628 w 10000"/>
                <a:gd name="connsiteY8" fmla="*/ 8886 h 10000"/>
                <a:gd name="connsiteX9" fmla="*/ 5296 w 10000"/>
                <a:gd name="connsiteY9" fmla="*/ 7760 h 10000"/>
                <a:gd name="connsiteX10" fmla="*/ 6003 w 10000"/>
                <a:gd name="connsiteY10" fmla="*/ 9692 h 10000"/>
                <a:gd name="connsiteX11" fmla="*/ 7744 w 10000"/>
                <a:gd name="connsiteY11" fmla="*/ 9804 h 10000"/>
                <a:gd name="connsiteX12" fmla="*/ 7823 w 10000"/>
                <a:gd name="connsiteY12" fmla="*/ 9781 h 10000"/>
                <a:gd name="connsiteX13" fmla="*/ 9695 w 10000"/>
                <a:gd name="connsiteY13" fmla="*/ 6628 h 10000"/>
                <a:gd name="connsiteX14" fmla="*/ 9814 w 10000"/>
                <a:gd name="connsiteY14" fmla="*/ 5375 h 10000"/>
                <a:gd name="connsiteX15" fmla="*/ 9774 w 10000"/>
                <a:gd name="connsiteY15" fmla="*/ 1773 h 10000"/>
                <a:gd name="connsiteX0" fmla="*/ 9774 w 10000"/>
                <a:gd name="connsiteY0" fmla="*/ 1773 h 10000"/>
                <a:gd name="connsiteX1" fmla="*/ 6385 w 10000"/>
                <a:gd name="connsiteY1" fmla="*/ 51 h 10000"/>
                <a:gd name="connsiteX2" fmla="*/ 5502 w 10000"/>
                <a:gd name="connsiteY2" fmla="*/ 677 h 10000"/>
                <a:gd name="connsiteX3" fmla="*/ 4039 w 10000"/>
                <a:gd name="connsiteY3" fmla="*/ 722 h 10000"/>
                <a:gd name="connsiteX4" fmla="*/ 1244 w 10000"/>
                <a:gd name="connsiteY4" fmla="*/ 1750 h 10000"/>
                <a:gd name="connsiteX5" fmla="*/ 413 w 10000"/>
                <a:gd name="connsiteY5" fmla="*/ 7880 h 10000"/>
                <a:gd name="connsiteX6" fmla="*/ 1573 w 10000"/>
                <a:gd name="connsiteY6" fmla="*/ 9379 h 10000"/>
                <a:gd name="connsiteX7" fmla="*/ 3542 w 10000"/>
                <a:gd name="connsiteY7" fmla="*/ 9793 h 10000"/>
                <a:gd name="connsiteX8" fmla="*/ 4628 w 10000"/>
                <a:gd name="connsiteY8" fmla="*/ 8886 h 10000"/>
                <a:gd name="connsiteX9" fmla="*/ 5296 w 10000"/>
                <a:gd name="connsiteY9" fmla="*/ 7760 h 10000"/>
                <a:gd name="connsiteX10" fmla="*/ 6003 w 10000"/>
                <a:gd name="connsiteY10" fmla="*/ 9692 h 10000"/>
                <a:gd name="connsiteX11" fmla="*/ 7744 w 10000"/>
                <a:gd name="connsiteY11" fmla="*/ 9804 h 10000"/>
                <a:gd name="connsiteX12" fmla="*/ 7823 w 10000"/>
                <a:gd name="connsiteY12" fmla="*/ 9781 h 10000"/>
                <a:gd name="connsiteX13" fmla="*/ 9695 w 10000"/>
                <a:gd name="connsiteY13" fmla="*/ 6628 h 10000"/>
                <a:gd name="connsiteX14" fmla="*/ 9814 w 10000"/>
                <a:gd name="connsiteY14" fmla="*/ 5375 h 10000"/>
                <a:gd name="connsiteX15" fmla="*/ 9774 w 10000"/>
                <a:gd name="connsiteY15" fmla="*/ 1773 h 10000"/>
                <a:gd name="connsiteX0" fmla="*/ 9774 w 10000"/>
                <a:gd name="connsiteY0" fmla="*/ 1773 h 10000"/>
                <a:gd name="connsiteX1" fmla="*/ 6385 w 10000"/>
                <a:gd name="connsiteY1" fmla="*/ 51 h 10000"/>
                <a:gd name="connsiteX2" fmla="*/ 5502 w 10000"/>
                <a:gd name="connsiteY2" fmla="*/ 677 h 10000"/>
                <a:gd name="connsiteX3" fmla="*/ 4039 w 10000"/>
                <a:gd name="connsiteY3" fmla="*/ 722 h 10000"/>
                <a:gd name="connsiteX4" fmla="*/ 1244 w 10000"/>
                <a:gd name="connsiteY4" fmla="*/ 1750 h 10000"/>
                <a:gd name="connsiteX5" fmla="*/ 413 w 10000"/>
                <a:gd name="connsiteY5" fmla="*/ 7880 h 10000"/>
                <a:gd name="connsiteX6" fmla="*/ 1573 w 10000"/>
                <a:gd name="connsiteY6" fmla="*/ 9379 h 10000"/>
                <a:gd name="connsiteX7" fmla="*/ 3337 w 10000"/>
                <a:gd name="connsiteY7" fmla="*/ 9859 h 10000"/>
                <a:gd name="connsiteX8" fmla="*/ 4628 w 10000"/>
                <a:gd name="connsiteY8" fmla="*/ 8886 h 10000"/>
                <a:gd name="connsiteX9" fmla="*/ 5296 w 10000"/>
                <a:gd name="connsiteY9" fmla="*/ 7760 h 10000"/>
                <a:gd name="connsiteX10" fmla="*/ 6003 w 10000"/>
                <a:gd name="connsiteY10" fmla="*/ 9692 h 10000"/>
                <a:gd name="connsiteX11" fmla="*/ 7744 w 10000"/>
                <a:gd name="connsiteY11" fmla="*/ 9804 h 10000"/>
                <a:gd name="connsiteX12" fmla="*/ 7823 w 10000"/>
                <a:gd name="connsiteY12" fmla="*/ 9781 h 10000"/>
                <a:gd name="connsiteX13" fmla="*/ 9695 w 10000"/>
                <a:gd name="connsiteY13" fmla="*/ 6628 h 10000"/>
                <a:gd name="connsiteX14" fmla="*/ 9814 w 10000"/>
                <a:gd name="connsiteY14" fmla="*/ 5375 h 10000"/>
                <a:gd name="connsiteX15" fmla="*/ 9774 w 10000"/>
                <a:gd name="connsiteY15" fmla="*/ 1773 h 10000"/>
                <a:gd name="connsiteX0" fmla="*/ 9774 w 10000"/>
                <a:gd name="connsiteY0" fmla="*/ 1773 h 10000"/>
                <a:gd name="connsiteX1" fmla="*/ 6385 w 10000"/>
                <a:gd name="connsiteY1" fmla="*/ 51 h 10000"/>
                <a:gd name="connsiteX2" fmla="*/ 5502 w 10000"/>
                <a:gd name="connsiteY2" fmla="*/ 677 h 10000"/>
                <a:gd name="connsiteX3" fmla="*/ 4039 w 10000"/>
                <a:gd name="connsiteY3" fmla="*/ 722 h 10000"/>
                <a:gd name="connsiteX4" fmla="*/ 1244 w 10000"/>
                <a:gd name="connsiteY4" fmla="*/ 1750 h 10000"/>
                <a:gd name="connsiteX5" fmla="*/ 413 w 10000"/>
                <a:gd name="connsiteY5" fmla="*/ 7880 h 10000"/>
                <a:gd name="connsiteX6" fmla="*/ 1573 w 10000"/>
                <a:gd name="connsiteY6" fmla="*/ 9379 h 10000"/>
                <a:gd name="connsiteX7" fmla="*/ 3309 w 10000"/>
                <a:gd name="connsiteY7" fmla="*/ 9967 h 10000"/>
                <a:gd name="connsiteX8" fmla="*/ 4628 w 10000"/>
                <a:gd name="connsiteY8" fmla="*/ 8886 h 10000"/>
                <a:gd name="connsiteX9" fmla="*/ 5296 w 10000"/>
                <a:gd name="connsiteY9" fmla="*/ 7760 h 10000"/>
                <a:gd name="connsiteX10" fmla="*/ 6003 w 10000"/>
                <a:gd name="connsiteY10" fmla="*/ 9692 h 10000"/>
                <a:gd name="connsiteX11" fmla="*/ 7744 w 10000"/>
                <a:gd name="connsiteY11" fmla="*/ 9804 h 10000"/>
                <a:gd name="connsiteX12" fmla="*/ 7823 w 10000"/>
                <a:gd name="connsiteY12" fmla="*/ 9781 h 10000"/>
                <a:gd name="connsiteX13" fmla="*/ 9695 w 10000"/>
                <a:gd name="connsiteY13" fmla="*/ 6628 h 10000"/>
                <a:gd name="connsiteX14" fmla="*/ 9814 w 10000"/>
                <a:gd name="connsiteY14" fmla="*/ 5375 h 10000"/>
                <a:gd name="connsiteX15" fmla="*/ 9774 w 10000"/>
                <a:gd name="connsiteY15" fmla="*/ 1773 h 10000"/>
                <a:gd name="connsiteX0" fmla="*/ 9774 w 10000"/>
                <a:gd name="connsiteY0" fmla="*/ 1773 h 10000"/>
                <a:gd name="connsiteX1" fmla="*/ 6385 w 10000"/>
                <a:gd name="connsiteY1" fmla="*/ 51 h 10000"/>
                <a:gd name="connsiteX2" fmla="*/ 5502 w 10000"/>
                <a:gd name="connsiteY2" fmla="*/ 677 h 10000"/>
                <a:gd name="connsiteX3" fmla="*/ 4039 w 10000"/>
                <a:gd name="connsiteY3" fmla="*/ 722 h 10000"/>
                <a:gd name="connsiteX4" fmla="*/ 1244 w 10000"/>
                <a:gd name="connsiteY4" fmla="*/ 1750 h 10000"/>
                <a:gd name="connsiteX5" fmla="*/ 413 w 10000"/>
                <a:gd name="connsiteY5" fmla="*/ 7880 h 10000"/>
                <a:gd name="connsiteX6" fmla="*/ 1573 w 10000"/>
                <a:gd name="connsiteY6" fmla="*/ 9379 h 10000"/>
                <a:gd name="connsiteX7" fmla="*/ 3309 w 10000"/>
                <a:gd name="connsiteY7" fmla="*/ 9967 h 10000"/>
                <a:gd name="connsiteX8" fmla="*/ 4628 w 10000"/>
                <a:gd name="connsiteY8" fmla="*/ 8886 h 10000"/>
                <a:gd name="connsiteX9" fmla="*/ 5296 w 10000"/>
                <a:gd name="connsiteY9" fmla="*/ 7760 h 10000"/>
                <a:gd name="connsiteX10" fmla="*/ 6003 w 10000"/>
                <a:gd name="connsiteY10" fmla="*/ 9692 h 10000"/>
                <a:gd name="connsiteX11" fmla="*/ 7744 w 10000"/>
                <a:gd name="connsiteY11" fmla="*/ 9804 h 10000"/>
                <a:gd name="connsiteX12" fmla="*/ 7823 w 10000"/>
                <a:gd name="connsiteY12" fmla="*/ 9781 h 10000"/>
                <a:gd name="connsiteX13" fmla="*/ 9695 w 10000"/>
                <a:gd name="connsiteY13" fmla="*/ 6628 h 10000"/>
                <a:gd name="connsiteX14" fmla="*/ 9814 w 10000"/>
                <a:gd name="connsiteY14" fmla="*/ 5375 h 10000"/>
                <a:gd name="connsiteX15" fmla="*/ 9774 w 10000"/>
                <a:gd name="connsiteY15" fmla="*/ 1773 h 10000"/>
                <a:gd name="connsiteX0" fmla="*/ 9774 w 10000"/>
                <a:gd name="connsiteY0" fmla="*/ 1773 h 10000"/>
                <a:gd name="connsiteX1" fmla="*/ 6385 w 10000"/>
                <a:gd name="connsiteY1" fmla="*/ 51 h 10000"/>
                <a:gd name="connsiteX2" fmla="*/ 5502 w 10000"/>
                <a:gd name="connsiteY2" fmla="*/ 677 h 10000"/>
                <a:gd name="connsiteX3" fmla="*/ 4039 w 10000"/>
                <a:gd name="connsiteY3" fmla="*/ 722 h 10000"/>
                <a:gd name="connsiteX4" fmla="*/ 1244 w 10000"/>
                <a:gd name="connsiteY4" fmla="*/ 1750 h 10000"/>
                <a:gd name="connsiteX5" fmla="*/ 413 w 10000"/>
                <a:gd name="connsiteY5" fmla="*/ 7880 h 10000"/>
                <a:gd name="connsiteX6" fmla="*/ 1573 w 10000"/>
                <a:gd name="connsiteY6" fmla="*/ 9379 h 10000"/>
                <a:gd name="connsiteX7" fmla="*/ 3309 w 10000"/>
                <a:gd name="connsiteY7" fmla="*/ 9967 h 10000"/>
                <a:gd name="connsiteX8" fmla="*/ 4628 w 10000"/>
                <a:gd name="connsiteY8" fmla="*/ 8886 h 10000"/>
                <a:gd name="connsiteX9" fmla="*/ 5296 w 10000"/>
                <a:gd name="connsiteY9" fmla="*/ 7760 h 10000"/>
                <a:gd name="connsiteX10" fmla="*/ 6003 w 10000"/>
                <a:gd name="connsiteY10" fmla="*/ 9692 h 10000"/>
                <a:gd name="connsiteX11" fmla="*/ 7744 w 10000"/>
                <a:gd name="connsiteY11" fmla="*/ 9804 h 10000"/>
                <a:gd name="connsiteX12" fmla="*/ 7823 w 10000"/>
                <a:gd name="connsiteY12" fmla="*/ 9781 h 10000"/>
                <a:gd name="connsiteX13" fmla="*/ 9695 w 10000"/>
                <a:gd name="connsiteY13" fmla="*/ 6628 h 10000"/>
                <a:gd name="connsiteX14" fmla="*/ 9814 w 10000"/>
                <a:gd name="connsiteY14" fmla="*/ 5375 h 10000"/>
                <a:gd name="connsiteX15" fmla="*/ 9774 w 10000"/>
                <a:gd name="connsiteY15" fmla="*/ 1773 h 10000"/>
                <a:gd name="connsiteX0" fmla="*/ 9774 w 10000"/>
                <a:gd name="connsiteY0" fmla="*/ 1773 h 10000"/>
                <a:gd name="connsiteX1" fmla="*/ 6385 w 10000"/>
                <a:gd name="connsiteY1" fmla="*/ 51 h 10000"/>
                <a:gd name="connsiteX2" fmla="*/ 5502 w 10000"/>
                <a:gd name="connsiteY2" fmla="*/ 677 h 10000"/>
                <a:gd name="connsiteX3" fmla="*/ 4039 w 10000"/>
                <a:gd name="connsiteY3" fmla="*/ 722 h 10000"/>
                <a:gd name="connsiteX4" fmla="*/ 1244 w 10000"/>
                <a:gd name="connsiteY4" fmla="*/ 1750 h 10000"/>
                <a:gd name="connsiteX5" fmla="*/ 413 w 10000"/>
                <a:gd name="connsiteY5" fmla="*/ 7880 h 10000"/>
                <a:gd name="connsiteX6" fmla="*/ 1573 w 10000"/>
                <a:gd name="connsiteY6" fmla="*/ 9379 h 10000"/>
                <a:gd name="connsiteX7" fmla="*/ 3309 w 10000"/>
                <a:gd name="connsiteY7" fmla="*/ 9967 h 10000"/>
                <a:gd name="connsiteX8" fmla="*/ 4628 w 10000"/>
                <a:gd name="connsiteY8" fmla="*/ 8886 h 10000"/>
                <a:gd name="connsiteX9" fmla="*/ 5296 w 10000"/>
                <a:gd name="connsiteY9" fmla="*/ 7760 h 10000"/>
                <a:gd name="connsiteX10" fmla="*/ 6003 w 10000"/>
                <a:gd name="connsiteY10" fmla="*/ 9692 h 10000"/>
                <a:gd name="connsiteX11" fmla="*/ 7744 w 10000"/>
                <a:gd name="connsiteY11" fmla="*/ 9804 h 10000"/>
                <a:gd name="connsiteX12" fmla="*/ 7823 w 10000"/>
                <a:gd name="connsiteY12" fmla="*/ 9781 h 10000"/>
                <a:gd name="connsiteX13" fmla="*/ 9695 w 10000"/>
                <a:gd name="connsiteY13" fmla="*/ 6628 h 10000"/>
                <a:gd name="connsiteX14" fmla="*/ 9814 w 10000"/>
                <a:gd name="connsiteY14" fmla="*/ 5375 h 10000"/>
                <a:gd name="connsiteX15" fmla="*/ 9774 w 10000"/>
                <a:gd name="connsiteY15" fmla="*/ 1773 h 10000"/>
                <a:gd name="connsiteX0" fmla="*/ 9774 w 10000"/>
                <a:gd name="connsiteY0" fmla="*/ 1773 h 10000"/>
                <a:gd name="connsiteX1" fmla="*/ 6385 w 10000"/>
                <a:gd name="connsiteY1" fmla="*/ 51 h 10000"/>
                <a:gd name="connsiteX2" fmla="*/ 5502 w 10000"/>
                <a:gd name="connsiteY2" fmla="*/ 677 h 10000"/>
                <a:gd name="connsiteX3" fmla="*/ 4039 w 10000"/>
                <a:gd name="connsiteY3" fmla="*/ 722 h 10000"/>
                <a:gd name="connsiteX4" fmla="*/ 1244 w 10000"/>
                <a:gd name="connsiteY4" fmla="*/ 1750 h 10000"/>
                <a:gd name="connsiteX5" fmla="*/ 413 w 10000"/>
                <a:gd name="connsiteY5" fmla="*/ 7880 h 10000"/>
                <a:gd name="connsiteX6" fmla="*/ 1573 w 10000"/>
                <a:gd name="connsiteY6" fmla="*/ 9379 h 10000"/>
                <a:gd name="connsiteX7" fmla="*/ 3309 w 10000"/>
                <a:gd name="connsiteY7" fmla="*/ 9967 h 10000"/>
                <a:gd name="connsiteX8" fmla="*/ 4628 w 10000"/>
                <a:gd name="connsiteY8" fmla="*/ 8886 h 10000"/>
                <a:gd name="connsiteX9" fmla="*/ 5296 w 10000"/>
                <a:gd name="connsiteY9" fmla="*/ 7760 h 10000"/>
                <a:gd name="connsiteX10" fmla="*/ 6003 w 10000"/>
                <a:gd name="connsiteY10" fmla="*/ 9692 h 10000"/>
                <a:gd name="connsiteX11" fmla="*/ 7744 w 10000"/>
                <a:gd name="connsiteY11" fmla="*/ 9804 h 10000"/>
                <a:gd name="connsiteX12" fmla="*/ 7823 w 10000"/>
                <a:gd name="connsiteY12" fmla="*/ 9781 h 10000"/>
                <a:gd name="connsiteX13" fmla="*/ 9695 w 10000"/>
                <a:gd name="connsiteY13" fmla="*/ 6628 h 10000"/>
                <a:gd name="connsiteX14" fmla="*/ 9814 w 10000"/>
                <a:gd name="connsiteY14" fmla="*/ 5375 h 10000"/>
                <a:gd name="connsiteX15" fmla="*/ 9774 w 10000"/>
                <a:gd name="connsiteY15" fmla="*/ 1773 h 10000"/>
                <a:gd name="connsiteX0" fmla="*/ 9774 w 10150"/>
                <a:gd name="connsiteY0" fmla="*/ 1773 h 10000"/>
                <a:gd name="connsiteX1" fmla="*/ 6385 w 10150"/>
                <a:gd name="connsiteY1" fmla="*/ 51 h 10000"/>
                <a:gd name="connsiteX2" fmla="*/ 5502 w 10150"/>
                <a:gd name="connsiteY2" fmla="*/ 677 h 10000"/>
                <a:gd name="connsiteX3" fmla="*/ 4039 w 10150"/>
                <a:gd name="connsiteY3" fmla="*/ 722 h 10000"/>
                <a:gd name="connsiteX4" fmla="*/ 1244 w 10150"/>
                <a:gd name="connsiteY4" fmla="*/ 1750 h 10000"/>
                <a:gd name="connsiteX5" fmla="*/ 413 w 10150"/>
                <a:gd name="connsiteY5" fmla="*/ 7880 h 10000"/>
                <a:gd name="connsiteX6" fmla="*/ 1573 w 10150"/>
                <a:gd name="connsiteY6" fmla="*/ 9379 h 10000"/>
                <a:gd name="connsiteX7" fmla="*/ 3309 w 10150"/>
                <a:gd name="connsiteY7" fmla="*/ 9967 h 10000"/>
                <a:gd name="connsiteX8" fmla="*/ 4628 w 10150"/>
                <a:gd name="connsiteY8" fmla="*/ 8886 h 10000"/>
                <a:gd name="connsiteX9" fmla="*/ 5296 w 10150"/>
                <a:gd name="connsiteY9" fmla="*/ 7760 h 10000"/>
                <a:gd name="connsiteX10" fmla="*/ 6003 w 10150"/>
                <a:gd name="connsiteY10" fmla="*/ 9692 h 10000"/>
                <a:gd name="connsiteX11" fmla="*/ 7744 w 10150"/>
                <a:gd name="connsiteY11" fmla="*/ 9804 h 10000"/>
                <a:gd name="connsiteX12" fmla="*/ 7823 w 10150"/>
                <a:gd name="connsiteY12" fmla="*/ 9781 h 10000"/>
                <a:gd name="connsiteX13" fmla="*/ 9695 w 10150"/>
                <a:gd name="connsiteY13" fmla="*/ 6628 h 10000"/>
                <a:gd name="connsiteX14" fmla="*/ 10072 w 10150"/>
                <a:gd name="connsiteY14" fmla="*/ 5831 h 10000"/>
                <a:gd name="connsiteX15" fmla="*/ 9774 w 10150"/>
                <a:gd name="connsiteY15" fmla="*/ 1773 h 10000"/>
                <a:gd name="connsiteX0" fmla="*/ 9774 w 10153"/>
                <a:gd name="connsiteY0" fmla="*/ 1773 h 10000"/>
                <a:gd name="connsiteX1" fmla="*/ 6385 w 10153"/>
                <a:gd name="connsiteY1" fmla="*/ 51 h 10000"/>
                <a:gd name="connsiteX2" fmla="*/ 5502 w 10153"/>
                <a:gd name="connsiteY2" fmla="*/ 677 h 10000"/>
                <a:gd name="connsiteX3" fmla="*/ 4039 w 10153"/>
                <a:gd name="connsiteY3" fmla="*/ 722 h 10000"/>
                <a:gd name="connsiteX4" fmla="*/ 1244 w 10153"/>
                <a:gd name="connsiteY4" fmla="*/ 1750 h 10000"/>
                <a:gd name="connsiteX5" fmla="*/ 413 w 10153"/>
                <a:gd name="connsiteY5" fmla="*/ 7880 h 10000"/>
                <a:gd name="connsiteX6" fmla="*/ 1573 w 10153"/>
                <a:gd name="connsiteY6" fmla="*/ 9379 h 10000"/>
                <a:gd name="connsiteX7" fmla="*/ 3309 w 10153"/>
                <a:gd name="connsiteY7" fmla="*/ 9967 h 10000"/>
                <a:gd name="connsiteX8" fmla="*/ 4628 w 10153"/>
                <a:gd name="connsiteY8" fmla="*/ 8886 h 10000"/>
                <a:gd name="connsiteX9" fmla="*/ 5296 w 10153"/>
                <a:gd name="connsiteY9" fmla="*/ 7760 h 10000"/>
                <a:gd name="connsiteX10" fmla="*/ 6003 w 10153"/>
                <a:gd name="connsiteY10" fmla="*/ 9692 h 10000"/>
                <a:gd name="connsiteX11" fmla="*/ 7744 w 10153"/>
                <a:gd name="connsiteY11" fmla="*/ 9804 h 10000"/>
                <a:gd name="connsiteX12" fmla="*/ 7823 w 10153"/>
                <a:gd name="connsiteY12" fmla="*/ 9781 h 10000"/>
                <a:gd name="connsiteX13" fmla="*/ 10153 w 10153"/>
                <a:gd name="connsiteY13" fmla="*/ 7675 h 10000"/>
                <a:gd name="connsiteX14" fmla="*/ 10072 w 10153"/>
                <a:gd name="connsiteY14" fmla="*/ 5831 h 10000"/>
                <a:gd name="connsiteX15" fmla="*/ 9774 w 10153"/>
                <a:gd name="connsiteY15" fmla="*/ 1773 h 10000"/>
                <a:gd name="connsiteX0" fmla="*/ 9774 w 10486"/>
                <a:gd name="connsiteY0" fmla="*/ 1773 h 10000"/>
                <a:gd name="connsiteX1" fmla="*/ 6385 w 10486"/>
                <a:gd name="connsiteY1" fmla="*/ 51 h 10000"/>
                <a:gd name="connsiteX2" fmla="*/ 5502 w 10486"/>
                <a:gd name="connsiteY2" fmla="*/ 677 h 10000"/>
                <a:gd name="connsiteX3" fmla="*/ 4039 w 10486"/>
                <a:gd name="connsiteY3" fmla="*/ 722 h 10000"/>
                <a:gd name="connsiteX4" fmla="*/ 1244 w 10486"/>
                <a:gd name="connsiteY4" fmla="*/ 1750 h 10000"/>
                <a:gd name="connsiteX5" fmla="*/ 413 w 10486"/>
                <a:gd name="connsiteY5" fmla="*/ 7880 h 10000"/>
                <a:gd name="connsiteX6" fmla="*/ 1573 w 10486"/>
                <a:gd name="connsiteY6" fmla="*/ 9379 h 10000"/>
                <a:gd name="connsiteX7" fmla="*/ 3309 w 10486"/>
                <a:gd name="connsiteY7" fmla="*/ 9967 h 10000"/>
                <a:gd name="connsiteX8" fmla="*/ 4628 w 10486"/>
                <a:gd name="connsiteY8" fmla="*/ 8886 h 10000"/>
                <a:gd name="connsiteX9" fmla="*/ 5296 w 10486"/>
                <a:gd name="connsiteY9" fmla="*/ 7760 h 10000"/>
                <a:gd name="connsiteX10" fmla="*/ 6003 w 10486"/>
                <a:gd name="connsiteY10" fmla="*/ 9692 h 10000"/>
                <a:gd name="connsiteX11" fmla="*/ 7744 w 10486"/>
                <a:gd name="connsiteY11" fmla="*/ 9804 h 10000"/>
                <a:gd name="connsiteX12" fmla="*/ 7823 w 10486"/>
                <a:gd name="connsiteY12" fmla="*/ 9781 h 10000"/>
                <a:gd name="connsiteX13" fmla="*/ 10153 w 10486"/>
                <a:gd name="connsiteY13" fmla="*/ 7675 h 10000"/>
                <a:gd name="connsiteX14" fmla="*/ 10454 w 10486"/>
                <a:gd name="connsiteY14" fmla="*/ 6042 h 10000"/>
                <a:gd name="connsiteX15" fmla="*/ 9774 w 10486"/>
                <a:gd name="connsiteY15" fmla="*/ 1773 h 10000"/>
                <a:gd name="connsiteX0" fmla="*/ 9774 w 10629"/>
                <a:gd name="connsiteY0" fmla="*/ 1773 h 10000"/>
                <a:gd name="connsiteX1" fmla="*/ 6385 w 10629"/>
                <a:gd name="connsiteY1" fmla="*/ 51 h 10000"/>
                <a:gd name="connsiteX2" fmla="*/ 5502 w 10629"/>
                <a:gd name="connsiteY2" fmla="*/ 677 h 10000"/>
                <a:gd name="connsiteX3" fmla="*/ 4039 w 10629"/>
                <a:gd name="connsiteY3" fmla="*/ 722 h 10000"/>
                <a:gd name="connsiteX4" fmla="*/ 1244 w 10629"/>
                <a:gd name="connsiteY4" fmla="*/ 1750 h 10000"/>
                <a:gd name="connsiteX5" fmla="*/ 413 w 10629"/>
                <a:gd name="connsiteY5" fmla="*/ 7880 h 10000"/>
                <a:gd name="connsiteX6" fmla="*/ 1573 w 10629"/>
                <a:gd name="connsiteY6" fmla="*/ 9379 h 10000"/>
                <a:gd name="connsiteX7" fmla="*/ 3309 w 10629"/>
                <a:gd name="connsiteY7" fmla="*/ 9967 h 10000"/>
                <a:gd name="connsiteX8" fmla="*/ 4628 w 10629"/>
                <a:gd name="connsiteY8" fmla="*/ 8886 h 10000"/>
                <a:gd name="connsiteX9" fmla="*/ 5296 w 10629"/>
                <a:gd name="connsiteY9" fmla="*/ 7760 h 10000"/>
                <a:gd name="connsiteX10" fmla="*/ 6003 w 10629"/>
                <a:gd name="connsiteY10" fmla="*/ 9692 h 10000"/>
                <a:gd name="connsiteX11" fmla="*/ 7744 w 10629"/>
                <a:gd name="connsiteY11" fmla="*/ 9804 h 10000"/>
                <a:gd name="connsiteX12" fmla="*/ 7823 w 10629"/>
                <a:gd name="connsiteY12" fmla="*/ 9781 h 10000"/>
                <a:gd name="connsiteX13" fmla="*/ 10153 w 10629"/>
                <a:gd name="connsiteY13" fmla="*/ 7675 h 10000"/>
                <a:gd name="connsiteX14" fmla="*/ 10604 w 10629"/>
                <a:gd name="connsiteY14" fmla="*/ 5807 h 10000"/>
                <a:gd name="connsiteX15" fmla="*/ 9774 w 10629"/>
                <a:gd name="connsiteY15" fmla="*/ 1773 h 10000"/>
                <a:gd name="connsiteX0" fmla="*/ 9774 w 10629"/>
                <a:gd name="connsiteY0" fmla="*/ 1773 h 10000"/>
                <a:gd name="connsiteX1" fmla="*/ 6385 w 10629"/>
                <a:gd name="connsiteY1" fmla="*/ 51 h 10000"/>
                <a:gd name="connsiteX2" fmla="*/ 5502 w 10629"/>
                <a:gd name="connsiteY2" fmla="*/ 677 h 10000"/>
                <a:gd name="connsiteX3" fmla="*/ 4039 w 10629"/>
                <a:gd name="connsiteY3" fmla="*/ 722 h 10000"/>
                <a:gd name="connsiteX4" fmla="*/ 1244 w 10629"/>
                <a:gd name="connsiteY4" fmla="*/ 1750 h 10000"/>
                <a:gd name="connsiteX5" fmla="*/ 413 w 10629"/>
                <a:gd name="connsiteY5" fmla="*/ 7880 h 10000"/>
                <a:gd name="connsiteX6" fmla="*/ 1573 w 10629"/>
                <a:gd name="connsiteY6" fmla="*/ 9379 h 10000"/>
                <a:gd name="connsiteX7" fmla="*/ 3309 w 10629"/>
                <a:gd name="connsiteY7" fmla="*/ 9967 h 10000"/>
                <a:gd name="connsiteX8" fmla="*/ 4628 w 10629"/>
                <a:gd name="connsiteY8" fmla="*/ 8886 h 10000"/>
                <a:gd name="connsiteX9" fmla="*/ 5296 w 10629"/>
                <a:gd name="connsiteY9" fmla="*/ 7760 h 10000"/>
                <a:gd name="connsiteX10" fmla="*/ 6003 w 10629"/>
                <a:gd name="connsiteY10" fmla="*/ 9692 h 10000"/>
                <a:gd name="connsiteX11" fmla="*/ 7744 w 10629"/>
                <a:gd name="connsiteY11" fmla="*/ 9804 h 10000"/>
                <a:gd name="connsiteX12" fmla="*/ 7823 w 10629"/>
                <a:gd name="connsiteY12" fmla="*/ 9781 h 10000"/>
                <a:gd name="connsiteX13" fmla="*/ 10153 w 10629"/>
                <a:gd name="connsiteY13" fmla="*/ 7675 h 10000"/>
                <a:gd name="connsiteX14" fmla="*/ 10604 w 10629"/>
                <a:gd name="connsiteY14" fmla="*/ 5807 h 10000"/>
                <a:gd name="connsiteX15" fmla="*/ 9774 w 10629"/>
                <a:gd name="connsiteY15" fmla="*/ 1773 h 10000"/>
                <a:gd name="connsiteX0" fmla="*/ 9774 w 10629"/>
                <a:gd name="connsiteY0" fmla="*/ 1773 h 10000"/>
                <a:gd name="connsiteX1" fmla="*/ 6385 w 10629"/>
                <a:gd name="connsiteY1" fmla="*/ 51 h 10000"/>
                <a:gd name="connsiteX2" fmla="*/ 5502 w 10629"/>
                <a:gd name="connsiteY2" fmla="*/ 677 h 10000"/>
                <a:gd name="connsiteX3" fmla="*/ 4039 w 10629"/>
                <a:gd name="connsiteY3" fmla="*/ 722 h 10000"/>
                <a:gd name="connsiteX4" fmla="*/ 1244 w 10629"/>
                <a:gd name="connsiteY4" fmla="*/ 1750 h 10000"/>
                <a:gd name="connsiteX5" fmla="*/ 413 w 10629"/>
                <a:gd name="connsiteY5" fmla="*/ 7880 h 10000"/>
                <a:gd name="connsiteX6" fmla="*/ 1573 w 10629"/>
                <a:gd name="connsiteY6" fmla="*/ 9379 h 10000"/>
                <a:gd name="connsiteX7" fmla="*/ 3309 w 10629"/>
                <a:gd name="connsiteY7" fmla="*/ 9967 h 10000"/>
                <a:gd name="connsiteX8" fmla="*/ 4628 w 10629"/>
                <a:gd name="connsiteY8" fmla="*/ 8886 h 10000"/>
                <a:gd name="connsiteX9" fmla="*/ 5296 w 10629"/>
                <a:gd name="connsiteY9" fmla="*/ 7760 h 10000"/>
                <a:gd name="connsiteX10" fmla="*/ 6003 w 10629"/>
                <a:gd name="connsiteY10" fmla="*/ 9692 h 10000"/>
                <a:gd name="connsiteX11" fmla="*/ 7744 w 10629"/>
                <a:gd name="connsiteY11" fmla="*/ 9804 h 10000"/>
                <a:gd name="connsiteX12" fmla="*/ 7823 w 10629"/>
                <a:gd name="connsiteY12" fmla="*/ 9781 h 10000"/>
                <a:gd name="connsiteX13" fmla="*/ 10153 w 10629"/>
                <a:gd name="connsiteY13" fmla="*/ 7675 h 10000"/>
                <a:gd name="connsiteX14" fmla="*/ 10604 w 10629"/>
                <a:gd name="connsiteY14" fmla="*/ 5807 h 10000"/>
                <a:gd name="connsiteX15" fmla="*/ 9774 w 10629"/>
                <a:gd name="connsiteY15" fmla="*/ 1773 h 10000"/>
                <a:gd name="connsiteX0" fmla="*/ 9774 w 10629"/>
                <a:gd name="connsiteY0" fmla="*/ 1773 h 10000"/>
                <a:gd name="connsiteX1" fmla="*/ 6385 w 10629"/>
                <a:gd name="connsiteY1" fmla="*/ 51 h 10000"/>
                <a:gd name="connsiteX2" fmla="*/ 5502 w 10629"/>
                <a:gd name="connsiteY2" fmla="*/ 677 h 10000"/>
                <a:gd name="connsiteX3" fmla="*/ 4039 w 10629"/>
                <a:gd name="connsiteY3" fmla="*/ 722 h 10000"/>
                <a:gd name="connsiteX4" fmla="*/ 1244 w 10629"/>
                <a:gd name="connsiteY4" fmla="*/ 1750 h 10000"/>
                <a:gd name="connsiteX5" fmla="*/ 413 w 10629"/>
                <a:gd name="connsiteY5" fmla="*/ 7880 h 10000"/>
                <a:gd name="connsiteX6" fmla="*/ 1573 w 10629"/>
                <a:gd name="connsiteY6" fmla="*/ 9379 h 10000"/>
                <a:gd name="connsiteX7" fmla="*/ 3309 w 10629"/>
                <a:gd name="connsiteY7" fmla="*/ 9967 h 10000"/>
                <a:gd name="connsiteX8" fmla="*/ 4628 w 10629"/>
                <a:gd name="connsiteY8" fmla="*/ 8886 h 10000"/>
                <a:gd name="connsiteX9" fmla="*/ 5296 w 10629"/>
                <a:gd name="connsiteY9" fmla="*/ 7760 h 10000"/>
                <a:gd name="connsiteX10" fmla="*/ 6003 w 10629"/>
                <a:gd name="connsiteY10" fmla="*/ 9692 h 10000"/>
                <a:gd name="connsiteX11" fmla="*/ 7744 w 10629"/>
                <a:gd name="connsiteY11" fmla="*/ 9804 h 10000"/>
                <a:gd name="connsiteX12" fmla="*/ 7823 w 10629"/>
                <a:gd name="connsiteY12" fmla="*/ 9781 h 10000"/>
                <a:gd name="connsiteX13" fmla="*/ 10153 w 10629"/>
                <a:gd name="connsiteY13" fmla="*/ 7675 h 10000"/>
                <a:gd name="connsiteX14" fmla="*/ 10604 w 10629"/>
                <a:gd name="connsiteY14" fmla="*/ 5807 h 10000"/>
                <a:gd name="connsiteX15" fmla="*/ 9774 w 10629"/>
                <a:gd name="connsiteY15" fmla="*/ 1773 h 10000"/>
                <a:gd name="connsiteX0" fmla="*/ 9774 w 10629"/>
                <a:gd name="connsiteY0" fmla="*/ 1773 h 10000"/>
                <a:gd name="connsiteX1" fmla="*/ 6385 w 10629"/>
                <a:gd name="connsiteY1" fmla="*/ 51 h 10000"/>
                <a:gd name="connsiteX2" fmla="*/ 5502 w 10629"/>
                <a:gd name="connsiteY2" fmla="*/ 677 h 10000"/>
                <a:gd name="connsiteX3" fmla="*/ 4039 w 10629"/>
                <a:gd name="connsiteY3" fmla="*/ 722 h 10000"/>
                <a:gd name="connsiteX4" fmla="*/ 1244 w 10629"/>
                <a:gd name="connsiteY4" fmla="*/ 1750 h 10000"/>
                <a:gd name="connsiteX5" fmla="*/ 413 w 10629"/>
                <a:gd name="connsiteY5" fmla="*/ 7880 h 10000"/>
                <a:gd name="connsiteX6" fmla="*/ 1573 w 10629"/>
                <a:gd name="connsiteY6" fmla="*/ 9379 h 10000"/>
                <a:gd name="connsiteX7" fmla="*/ 3309 w 10629"/>
                <a:gd name="connsiteY7" fmla="*/ 9967 h 10000"/>
                <a:gd name="connsiteX8" fmla="*/ 4628 w 10629"/>
                <a:gd name="connsiteY8" fmla="*/ 8886 h 10000"/>
                <a:gd name="connsiteX9" fmla="*/ 5296 w 10629"/>
                <a:gd name="connsiteY9" fmla="*/ 7760 h 10000"/>
                <a:gd name="connsiteX10" fmla="*/ 6003 w 10629"/>
                <a:gd name="connsiteY10" fmla="*/ 9692 h 10000"/>
                <a:gd name="connsiteX11" fmla="*/ 7744 w 10629"/>
                <a:gd name="connsiteY11" fmla="*/ 9804 h 10000"/>
                <a:gd name="connsiteX12" fmla="*/ 7823 w 10629"/>
                <a:gd name="connsiteY12" fmla="*/ 9781 h 10000"/>
                <a:gd name="connsiteX13" fmla="*/ 10153 w 10629"/>
                <a:gd name="connsiteY13" fmla="*/ 7675 h 10000"/>
                <a:gd name="connsiteX14" fmla="*/ 10604 w 10629"/>
                <a:gd name="connsiteY14" fmla="*/ 5807 h 10000"/>
                <a:gd name="connsiteX15" fmla="*/ 9774 w 10629"/>
                <a:gd name="connsiteY15" fmla="*/ 1773 h 10000"/>
                <a:gd name="connsiteX0" fmla="*/ 9774 w 10629"/>
                <a:gd name="connsiteY0" fmla="*/ 1773 h 10000"/>
                <a:gd name="connsiteX1" fmla="*/ 6385 w 10629"/>
                <a:gd name="connsiteY1" fmla="*/ 51 h 10000"/>
                <a:gd name="connsiteX2" fmla="*/ 5502 w 10629"/>
                <a:gd name="connsiteY2" fmla="*/ 677 h 10000"/>
                <a:gd name="connsiteX3" fmla="*/ 4039 w 10629"/>
                <a:gd name="connsiteY3" fmla="*/ 722 h 10000"/>
                <a:gd name="connsiteX4" fmla="*/ 1244 w 10629"/>
                <a:gd name="connsiteY4" fmla="*/ 1750 h 10000"/>
                <a:gd name="connsiteX5" fmla="*/ 413 w 10629"/>
                <a:gd name="connsiteY5" fmla="*/ 7880 h 10000"/>
                <a:gd name="connsiteX6" fmla="*/ 1573 w 10629"/>
                <a:gd name="connsiteY6" fmla="*/ 9379 h 10000"/>
                <a:gd name="connsiteX7" fmla="*/ 3309 w 10629"/>
                <a:gd name="connsiteY7" fmla="*/ 9967 h 10000"/>
                <a:gd name="connsiteX8" fmla="*/ 4628 w 10629"/>
                <a:gd name="connsiteY8" fmla="*/ 8886 h 10000"/>
                <a:gd name="connsiteX9" fmla="*/ 5296 w 10629"/>
                <a:gd name="connsiteY9" fmla="*/ 7760 h 10000"/>
                <a:gd name="connsiteX10" fmla="*/ 6003 w 10629"/>
                <a:gd name="connsiteY10" fmla="*/ 9692 h 10000"/>
                <a:gd name="connsiteX11" fmla="*/ 7744 w 10629"/>
                <a:gd name="connsiteY11" fmla="*/ 9804 h 10000"/>
                <a:gd name="connsiteX12" fmla="*/ 7823 w 10629"/>
                <a:gd name="connsiteY12" fmla="*/ 9781 h 10000"/>
                <a:gd name="connsiteX13" fmla="*/ 10153 w 10629"/>
                <a:gd name="connsiteY13" fmla="*/ 7675 h 10000"/>
                <a:gd name="connsiteX14" fmla="*/ 10604 w 10629"/>
                <a:gd name="connsiteY14" fmla="*/ 5807 h 10000"/>
                <a:gd name="connsiteX15" fmla="*/ 9774 w 10629"/>
                <a:gd name="connsiteY15" fmla="*/ 1773 h 10000"/>
                <a:gd name="connsiteX0" fmla="*/ 9774 w 10629"/>
                <a:gd name="connsiteY0" fmla="*/ 1773 h 10000"/>
                <a:gd name="connsiteX1" fmla="*/ 6385 w 10629"/>
                <a:gd name="connsiteY1" fmla="*/ 51 h 10000"/>
                <a:gd name="connsiteX2" fmla="*/ 5502 w 10629"/>
                <a:gd name="connsiteY2" fmla="*/ 677 h 10000"/>
                <a:gd name="connsiteX3" fmla="*/ 4039 w 10629"/>
                <a:gd name="connsiteY3" fmla="*/ 722 h 10000"/>
                <a:gd name="connsiteX4" fmla="*/ 1244 w 10629"/>
                <a:gd name="connsiteY4" fmla="*/ 1750 h 10000"/>
                <a:gd name="connsiteX5" fmla="*/ 413 w 10629"/>
                <a:gd name="connsiteY5" fmla="*/ 7880 h 10000"/>
                <a:gd name="connsiteX6" fmla="*/ 1573 w 10629"/>
                <a:gd name="connsiteY6" fmla="*/ 9379 h 10000"/>
                <a:gd name="connsiteX7" fmla="*/ 3309 w 10629"/>
                <a:gd name="connsiteY7" fmla="*/ 9967 h 10000"/>
                <a:gd name="connsiteX8" fmla="*/ 4628 w 10629"/>
                <a:gd name="connsiteY8" fmla="*/ 8886 h 10000"/>
                <a:gd name="connsiteX9" fmla="*/ 5296 w 10629"/>
                <a:gd name="connsiteY9" fmla="*/ 7760 h 10000"/>
                <a:gd name="connsiteX10" fmla="*/ 6003 w 10629"/>
                <a:gd name="connsiteY10" fmla="*/ 9692 h 10000"/>
                <a:gd name="connsiteX11" fmla="*/ 7744 w 10629"/>
                <a:gd name="connsiteY11" fmla="*/ 9804 h 10000"/>
                <a:gd name="connsiteX12" fmla="*/ 7823 w 10629"/>
                <a:gd name="connsiteY12" fmla="*/ 9781 h 10000"/>
                <a:gd name="connsiteX13" fmla="*/ 10153 w 10629"/>
                <a:gd name="connsiteY13" fmla="*/ 7675 h 10000"/>
                <a:gd name="connsiteX14" fmla="*/ 10604 w 10629"/>
                <a:gd name="connsiteY14" fmla="*/ 5807 h 10000"/>
                <a:gd name="connsiteX15" fmla="*/ 9774 w 10629"/>
                <a:gd name="connsiteY15" fmla="*/ 1773 h 10000"/>
                <a:gd name="connsiteX0" fmla="*/ 9774 w 10629"/>
                <a:gd name="connsiteY0" fmla="*/ 1773 h 10000"/>
                <a:gd name="connsiteX1" fmla="*/ 6385 w 10629"/>
                <a:gd name="connsiteY1" fmla="*/ 51 h 10000"/>
                <a:gd name="connsiteX2" fmla="*/ 5502 w 10629"/>
                <a:gd name="connsiteY2" fmla="*/ 677 h 10000"/>
                <a:gd name="connsiteX3" fmla="*/ 4039 w 10629"/>
                <a:gd name="connsiteY3" fmla="*/ 722 h 10000"/>
                <a:gd name="connsiteX4" fmla="*/ 1244 w 10629"/>
                <a:gd name="connsiteY4" fmla="*/ 1750 h 10000"/>
                <a:gd name="connsiteX5" fmla="*/ 413 w 10629"/>
                <a:gd name="connsiteY5" fmla="*/ 7880 h 10000"/>
                <a:gd name="connsiteX6" fmla="*/ 1573 w 10629"/>
                <a:gd name="connsiteY6" fmla="*/ 9379 h 10000"/>
                <a:gd name="connsiteX7" fmla="*/ 3309 w 10629"/>
                <a:gd name="connsiteY7" fmla="*/ 9967 h 10000"/>
                <a:gd name="connsiteX8" fmla="*/ 4628 w 10629"/>
                <a:gd name="connsiteY8" fmla="*/ 8886 h 10000"/>
                <a:gd name="connsiteX9" fmla="*/ 5296 w 10629"/>
                <a:gd name="connsiteY9" fmla="*/ 7760 h 10000"/>
                <a:gd name="connsiteX10" fmla="*/ 6003 w 10629"/>
                <a:gd name="connsiteY10" fmla="*/ 9692 h 10000"/>
                <a:gd name="connsiteX11" fmla="*/ 7744 w 10629"/>
                <a:gd name="connsiteY11" fmla="*/ 9804 h 10000"/>
                <a:gd name="connsiteX12" fmla="*/ 7823 w 10629"/>
                <a:gd name="connsiteY12" fmla="*/ 9781 h 10000"/>
                <a:gd name="connsiteX13" fmla="*/ 10153 w 10629"/>
                <a:gd name="connsiteY13" fmla="*/ 7675 h 10000"/>
                <a:gd name="connsiteX14" fmla="*/ 10604 w 10629"/>
                <a:gd name="connsiteY14" fmla="*/ 5807 h 10000"/>
                <a:gd name="connsiteX15" fmla="*/ 9774 w 10629"/>
                <a:gd name="connsiteY15" fmla="*/ 1773 h 10000"/>
                <a:gd name="connsiteX0" fmla="*/ 9774 w 10728"/>
                <a:gd name="connsiteY0" fmla="*/ 1773 h 10000"/>
                <a:gd name="connsiteX1" fmla="*/ 6385 w 10728"/>
                <a:gd name="connsiteY1" fmla="*/ 51 h 10000"/>
                <a:gd name="connsiteX2" fmla="*/ 5502 w 10728"/>
                <a:gd name="connsiteY2" fmla="*/ 677 h 10000"/>
                <a:gd name="connsiteX3" fmla="*/ 4039 w 10728"/>
                <a:gd name="connsiteY3" fmla="*/ 722 h 10000"/>
                <a:gd name="connsiteX4" fmla="*/ 1244 w 10728"/>
                <a:gd name="connsiteY4" fmla="*/ 1750 h 10000"/>
                <a:gd name="connsiteX5" fmla="*/ 413 w 10728"/>
                <a:gd name="connsiteY5" fmla="*/ 7880 h 10000"/>
                <a:gd name="connsiteX6" fmla="*/ 1573 w 10728"/>
                <a:gd name="connsiteY6" fmla="*/ 9379 h 10000"/>
                <a:gd name="connsiteX7" fmla="*/ 3309 w 10728"/>
                <a:gd name="connsiteY7" fmla="*/ 9967 h 10000"/>
                <a:gd name="connsiteX8" fmla="*/ 4628 w 10728"/>
                <a:gd name="connsiteY8" fmla="*/ 8886 h 10000"/>
                <a:gd name="connsiteX9" fmla="*/ 5296 w 10728"/>
                <a:gd name="connsiteY9" fmla="*/ 7760 h 10000"/>
                <a:gd name="connsiteX10" fmla="*/ 6003 w 10728"/>
                <a:gd name="connsiteY10" fmla="*/ 9692 h 10000"/>
                <a:gd name="connsiteX11" fmla="*/ 7744 w 10728"/>
                <a:gd name="connsiteY11" fmla="*/ 9804 h 10000"/>
                <a:gd name="connsiteX12" fmla="*/ 7823 w 10728"/>
                <a:gd name="connsiteY12" fmla="*/ 9781 h 10000"/>
                <a:gd name="connsiteX13" fmla="*/ 10153 w 10728"/>
                <a:gd name="connsiteY13" fmla="*/ 7675 h 10000"/>
                <a:gd name="connsiteX14" fmla="*/ 10706 w 10728"/>
                <a:gd name="connsiteY14" fmla="*/ 5733 h 10000"/>
                <a:gd name="connsiteX15" fmla="*/ 9774 w 10728"/>
                <a:gd name="connsiteY15" fmla="*/ 1773 h 10000"/>
                <a:gd name="connsiteX0" fmla="*/ 9774 w 10793"/>
                <a:gd name="connsiteY0" fmla="*/ 1773 h 10000"/>
                <a:gd name="connsiteX1" fmla="*/ 6385 w 10793"/>
                <a:gd name="connsiteY1" fmla="*/ 51 h 10000"/>
                <a:gd name="connsiteX2" fmla="*/ 5502 w 10793"/>
                <a:gd name="connsiteY2" fmla="*/ 677 h 10000"/>
                <a:gd name="connsiteX3" fmla="*/ 4039 w 10793"/>
                <a:gd name="connsiteY3" fmla="*/ 722 h 10000"/>
                <a:gd name="connsiteX4" fmla="*/ 1244 w 10793"/>
                <a:gd name="connsiteY4" fmla="*/ 1750 h 10000"/>
                <a:gd name="connsiteX5" fmla="*/ 413 w 10793"/>
                <a:gd name="connsiteY5" fmla="*/ 7880 h 10000"/>
                <a:gd name="connsiteX6" fmla="*/ 1573 w 10793"/>
                <a:gd name="connsiteY6" fmla="*/ 9379 h 10000"/>
                <a:gd name="connsiteX7" fmla="*/ 3309 w 10793"/>
                <a:gd name="connsiteY7" fmla="*/ 9967 h 10000"/>
                <a:gd name="connsiteX8" fmla="*/ 4628 w 10793"/>
                <a:gd name="connsiteY8" fmla="*/ 8886 h 10000"/>
                <a:gd name="connsiteX9" fmla="*/ 5296 w 10793"/>
                <a:gd name="connsiteY9" fmla="*/ 7760 h 10000"/>
                <a:gd name="connsiteX10" fmla="*/ 6003 w 10793"/>
                <a:gd name="connsiteY10" fmla="*/ 9692 h 10000"/>
                <a:gd name="connsiteX11" fmla="*/ 7744 w 10793"/>
                <a:gd name="connsiteY11" fmla="*/ 9804 h 10000"/>
                <a:gd name="connsiteX12" fmla="*/ 7823 w 10793"/>
                <a:gd name="connsiteY12" fmla="*/ 9781 h 10000"/>
                <a:gd name="connsiteX13" fmla="*/ 10153 w 10793"/>
                <a:gd name="connsiteY13" fmla="*/ 7675 h 10000"/>
                <a:gd name="connsiteX14" fmla="*/ 10773 w 10793"/>
                <a:gd name="connsiteY14" fmla="*/ 5624 h 10000"/>
                <a:gd name="connsiteX15" fmla="*/ 9774 w 10793"/>
                <a:gd name="connsiteY15" fmla="*/ 1773 h 10000"/>
                <a:gd name="connsiteX0" fmla="*/ 9774 w 10880"/>
                <a:gd name="connsiteY0" fmla="*/ 1773 h 10000"/>
                <a:gd name="connsiteX1" fmla="*/ 6385 w 10880"/>
                <a:gd name="connsiteY1" fmla="*/ 51 h 10000"/>
                <a:gd name="connsiteX2" fmla="*/ 5502 w 10880"/>
                <a:gd name="connsiteY2" fmla="*/ 677 h 10000"/>
                <a:gd name="connsiteX3" fmla="*/ 4039 w 10880"/>
                <a:gd name="connsiteY3" fmla="*/ 722 h 10000"/>
                <a:gd name="connsiteX4" fmla="*/ 1244 w 10880"/>
                <a:gd name="connsiteY4" fmla="*/ 1750 h 10000"/>
                <a:gd name="connsiteX5" fmla="*/ 413 w 10880"/>
                <a:gd name="connsiteY5" fmla="*/ 7880 h 10000"/>
                <a:gd name="connsiteX6" fmla="*/ 1573 w 10880"/>
                <a:gd name="connsiteY6" fmla="*/ 9379 h 10000"/>
                <a:gd name="connsiteX7" fmla="*/ 3309 w 10880"/>
                <a:gd name="connsiteY7" fmla="*/ 9967 h 10000"/>
                <a:gd name="connsiteX8" fmla="*/ 4628 w 10880"/>
                <a:gd name="connsiteY8" fmla="*/ 8886 h 10000"/>
                <a:gd name="connsiteX9" fmla="*/ 5296 w 10880"/>
                <a:gd name="connsiteY9" fmla="*/ 7760 h 10000"/>
                <a:gd name="connsiteX10" fmla="*/ 6003 w 10880"/>
                <a:gd name="connsiteY10" fmla="*/ 9692 h 10000"/>
                <a:gd name="connsiteX11" fmla="*/ 7744 w 10880"/>
                <a:gd name="connsiteY11" fmla="*/ 9804 h 10000"/>
                <a:gd name="connsiteX12" fmla="*/ 7823 w 10880"/>
                <a:gd name="connsiteY12" fmla="*/ 9781 h 10000"/>
                <a:gd name="connsiteX13" fmla="*/ 10153 w 10880"/>
                <a:gd name="connsiteY13" fmla="*/ 7675 h 10000"/>
                <a:gd name="connsiteX14" fmla="*/ 10861 w 10880"/>
                <a:gd name="connsiteY14" fmla="*/ 5455 h 10000"/>
                <a:gd name="connsiteX15" fmla="*/ 9774 w 10880"/>
                <a:gd name="connsiteY15" fmla="*/ 1773 h 10000"/>
                <a:gd name="connsiteX0" fmla="*/ 9774 w 10774"/>
                <a:gd name="connsiteY0" fmla="*/ 1773 h 10000"/>
                <a:gd name="connsiteX1" fmla="*/ 6385 w 10774"/>
                <a:gd name="connsiteY1" fmla="*/ 51 h 10000"/>
                <a:gd name="connsiteX2" fmla="*/ 5502 w 10774"/>
                <a:gd name="connsiteY2" fmla="*/ 677 h 10000"/>
                <a:gd name="connsiteX3" fmla="*/ 4039 w 10774"/>
                <a:gd name="connsiteY3" fmla="*/ 722 h 10000"/>
                <a:gd name="connsiteX4" fmla="*/ 1244 w 10774"/>
                <a:gd name="connsiteY4" fmla="*/ 1750 h 10000"/>
                <a:gd name="connsiteX5" fmla="*/ 413 w 10774"/>
                <a:gd name="connsiteY5" fmla="*/ 7880 h 10000"/>
                <a:gd name="connsiteX6" fmla="*/ 1573 w 10774"/>
                <a:gd name="connsiteY6" fmla="*/ 9379 h 10000"/>
                <a:gd name="connsiteX7" fmla="*/ 3309 w 10774"/>
                <a:gd name="connsiteY7" fmla="*/ 9967 h 10000"/>
                <a:gd name="connsiteX8" fmla="*/ 4628 w 10774"/>
                <a:gd name="connsiteY8" fmla="*/ 8886 h 10000"/>
                <a:gd name="connsiteX9" fmla="*/ 5296 w 10774"/>
                <a:gd name="connsiteY9" fmla="*/ 7760 h 10000"/>
                <a:gd name="connsiteX10" fmla="*/ 6003 w 10774"/>
                <a:gd name="connsiteY10" fmla="*/ 9692 h 10000"/>
                <a:gd name="connsiteX11" fmla="*/ 7744 w 10774"/>
                <a:gd name="connsiteY11" fmla="*/ 9804 h 10000"/>
                <a:gd name="connsiteX12" fmla="*/ 7823 w 10774"/>
                <a:gd name="connsiteY12" fmla="*/ 9781 h 10000"/>
                <a:gd name="connsiteX13" fmla="*/ 10153 w 10774"/>
                <a:gd name="connsiteY13" fmla="*/ 7675 h 10000"/>
                <a:gd name="connsiteX14" fmla="*/ 10753 w 10774"/>
                <a:gd name="connsiteY14" fmla="*/ 5572 h 10000"/>
                <a:gd name="connsiteX15" fmla="*/ 9774 w 10774"/>
                <a:gd name="connsiteY15" fmla="*/ 1773 h 10000"/>
                <a:gd name="connsiteX0" fmla="*/ 9774 w 10764"/>
                <a:gd name="connsiteY0" fmla="*/ 1773 h 10000"/>
                <a:gd name="connsiteX1" fmla="*/ 6385 w 10764"/>
                <a:gd name="connsiteY1" fmla="*/ 51 h 10000"/>
                <a:gd name="connsiteX2" fmla="*/ 5502 w 10764"/>
                <a:gd name="connsiteY2" fmla="*/ 677 h 10000"/>
                <a:gd name="connsiteX3" fmla="*/ 4039 w 10764"/>
                <a:gd name="connsiteY3" fmla="*/ 722 h 10000"/>
                <a:gd name="connsiteX4" fmla="*/ 1244 w 10764"/>
                <a:gd name="connsiteY4" fmla="*/ 1750 h 10000"/>
                <a:gd name="connsiteX5" fmla="*/ 413 w 10764"/>
                <a:gd name="connsiteY5" fmla="*/ 7880 h 10000"/>
                <a:gd name="connsiteX6" fmla="*/ 1573 w 10764"/>
                <a:gd name="connsiteY6" fmla="*/ 9379 h 10000"/>
                <a:gd name="connsiteX7" fmla="*/ 3309 w 10764"/>
                <a:gd name="connsiteY7" fmla="*/ 9967 h 10000"/>
                <a:gd name="connsiteX8" fmla="*/ 4628 w 10764"/>
                <a:gd name="connsiteY8" fmla="*/ 8886 h 10000"/>
                <a:gd name="connsiteX9" fmla="*/ 5296 w 10764"/>
                <a:gd name="connsiteY9" fmla="*/ 7760 h 10000"/>
                <a:gd name="connsiteX10" fmla="*/ 6003 w 10764"/>
                <a:gd name="connsiteY10" fmla="*/ 9692 h 10000"/>
                <a:gd name="connsiteX11" fmla="*/ 7744 w 10764"/>
                <a:gd name="connsiteY11" fmla="*/ 9804 h 10000"/>
                <a:gd name="connsiteX12" fmla="*/ 7823 w 10764"/>
                <a:gd name="connsiteY12" fmla="*/ 9781 h 10000"/>
                <a:gd name="connsiteX13" fmla="*/ 10146 w 10764"/>
                <a:gd name="connsiteY13" fmla="*/ 7829 h 10000"/>
                <a:gd name="connsiteX14" fmla="*/ 10753 w 10764"/>
                <a:gd name="connsiteY14" fmla="*/ 5572 h 10000"/>
                <a:gd name="connsiteX15" fmla="*/ 9774 w 10764"/>
                <a:gd name="connsiteY15" fmla="*/ 1773 h 10000"/>
                <a:gd name="connsiteX0" fmla="*/ 9774 w 10801"/>
                <a:gd name="connsiteY0" fmla="*/ 1773 h 10000"/>
                <a:gd name="connsiteX1" fmla="*/ 6385 w 10801"/>
                <a:gd name="connsiteY1" fmla="*/ 51 h 10000"/>
                <a:gd name="connsiteX2" fmla="*/ 5502 w 10801"/>
                <a:gd name="connsiteY2" fmla="*/ 677 h 10000"/>
                <a:gd name="connsiteX3" fmla="*/ 4039 w 10801"/>
                <a:gd name="connsiteY3" fmla="*/ 722 h 10000"/>
                <a:gd name="connsiteX4" fmla="*/ 1244 w 10801"/>
                <a:gd name="connsiteY4" fmla="*/ 1750 h 10000"/>
                <a:gd name="connsiteX5" fmla="*/ 413 w 10801"/>
                <a:gd name="connsiteY5" fmla="*/ 7880 h 10000"/>
                <a:gd name="connsiteX6" fmla="*/ 1573 w 10801"/>
                <a:gd name="connsiteY6" fmla="*/ 9379 h 10000"/>
                <a:gd name="connsiteX7" fmla="*/ 3309 w 10801"/>
                <a:gd name="connsiteY7" fmla="*/ 9967 h 10000"/>
                <a:gd name="connsiteX8" fmla="*/ 4628 w 10801"/>
                <a:gd name="connsiteY8" fmla="*/ 8886 h 10000"/>
                <a:gd name="connsiteX9" fmla="*/ 5296 w 10801"/>
                <a:gd name="connsiteY9" fmla="*/ 7760 h 10000"/>
                <a:gd name="connsiteX10" fmla="*/ 6003 w 10801"/>
                <a:gd name="connsiteY10" fmla="*/ 9692 h 10000"/>
                <a:gd name="connsiteX11" fmla="*/ 7744 w 10801"/>
                <a:gd name="connsiteY11" fmla="*/ 9804 h 10000"/>
                <a:gd name="connsiteX12" fmla="*/ 7823 w 10801"/>
                <a:gd name="connsiteY12" fmla="*/ 9781 h 10000"/>
                <a:gd name="connsiteX13" fmla="*/ 10146 w 10801"/>
                <a:gd name="connsiteY13" fmla="*/ 7829 h 10000"/>
                <a:gd name="connsiteX14" fmla="*/ 10791 w 10801"/>
                <a:gd name="connsiteY14" fmla="*/ 5384 h 10000"/>
                <a:gd name="connsiteX15" fmla="*/ 9774 w 10801"/>
                <a:gd name="connsiteY15" fmla="*/ 1773 h 10000"/>
                <a:gd name="connsiteX0" fmla="*/ 9774 w 10801"/>
                <a:gd name="connsiteY0" fmla="*/ 1773 h 10000"/>
                <a:gd name="connsiteX1" fmla="*/ 6385 w 10801"/>
                <a:gd name="connsiteY1" fmla="*/ 51 h 10000"/>
                <a:gd name="connsiteX2" fmla="*/ 5502 w 10801"/>
                <a:gd name="connsiteY2" fmla="*/ 677 h 10000"/>
                <a:gd name="connsiteX3" fmla="*/ 4039 w 10801"/>
                <a:gd name="connsiteY3" fmla="*/ 722 h 10000"/>
                <a:gd name="connsiteX4" fmla="*/ 1244 w 10801"/>
                <a:gd name="connsiteY4" fmla="*/ 1750 h 10000"/>
                <a:gd name="connsiteX5" fmla="*/ 413 w 10801"/>
                <a:gd name="connsiteY5" fmla="*/ 7880 h 10000"/>
                <a:gd name="connsiteX6" fmla="*/ 1573 w 10801"/>
                <a:gd name="connsiteY6" fmla="*/ 9379 h 10000"/>
                <a:gd name="connsiteX7" fmla="*/ 3309 w 10801"/>
                <a:gd name="connsiteY7" fmla="*/ 9967 h 10000"/>
                <a:gd name="connsiteX8" fmla="*/ 4628 w 10801"/>
                <a:gd name="connsiteY8" fmla="*/ 8886 h 10000"/>
                <a:gd name="connsiteX9" fmla="*/ 5296 w 10801"/>
                <a:gd name="connsiteY9" fmla="*/ 7760 h 10000"/>
                <a:gd name="connsiteX10" fmla="*/ 6003 w 10801"/>
                <a:gd name="connsiteY10" fmla="*/ 9692 h 10000"/>
                <a:gd name="connsiteX11" fmla="*/ 7744 w 10801"/>
                <a:gd name="connsiteY11" fmla="*/ 9804 h 10000"/>
                <a:gd name="connsiteX12" fmla="*/ 7823 w 10801"/>
                <a:gd name="connsiteY12" fmla="*/ 9781 h 10000"/>
                <a:gd name="connsiteX13" fmla="*/ 10146 w 10801"/>
                <a:gd name="connsiteY13" fmla="*/ 7829 h 10000"/>
                <a:gd name="connsiteX14" fmla="*/ 10791 w 10801"/>
                <a:gd name="connsiteY14" fmla="*/ 5384 h 10000"/>
                <a:gd name="connsiteX15" fmla="*/ 9774 w 10801"/>
                <a:gd name="connsiteY15" fmla="*/ 1773 h 10000"/>
                <a:gd name="connsiteX0" fmla="*/ 9774 w 10801"/>
                <a:gd name="connsiteY0" fmla="*/ 1773 h 10000"/>
                <a:gd name="connsiteX1" fmla="*/ 6385 w 10801"/>
                <a:gd name="connsiteY1" fmla="*/ 51 h 10000"/>
                <a:gd name="connsiteX2" fmla="*/ 5477 w 10801"/>
                <a:gd name="connsiteY2" fmla="*/ 585 h 10000"/>
                <a:gd name="connsiteX3" fmla="*/ 4039 w 10801"/>
                <a:gd name="connsiteY3" fmla="*/ 722 h 10000"/>
                <a:gd name="connsiteX4" fmla="*/ 1244 w 10801"/>
                <a:gd name="connsiteY4" fmla="*/ 1750 h 10000"/>
                <a:gd name="connsiteX5" fmla="*/ 413 w 10801"/>
                <a:gd name="connsiteY5" fmla="*/ 7880 h 10000"/>
                <a:gd name="connsiteX6" fmla="*/ 1573 w 10801"/>
                <a:gd name="connsiteY6" fmla="*/ 9379 h 10000"/>
                <a:gd name="connsiteX7" fmla="*/ 3309 w 10801"/>
                <a:gd name="connsiteY7" fmla="*/ 9967 h 10000"/>
                <a:gd name="connsiteX8" fmla="*/ 4628 w 10801"/>
                <a:gd name="connsiteY8" fmla="*/ 8886 h 10000"/>
                <a:gd name="connsiteX9" fmla="*/ 5296 w 10801"/>
                <a:gd name="connsiteY9" fmla="*/ 7760 h 10000"/>
                <a:gd name="connsiteX10" fmla="*/ 6003 w 10801"/>
                <a:gd name="connsiteY10" fmla="*/ 9692 h 10000"/>
                <a:gd name="connsiteX11" fmla="*/ 7744 w 10801"/>
                <a:gd name="connsiteY11" fmla="*/ 9804 h 10000"/>
                <a:gd name="connsiteX12" fmla="*/ 7823 w 10801"/>
                <a:gd name="connsiteY12" fmla="*/ 9781 h 10000"/>
                <a:gd name="connsiteX13" fmla="*/ 10146 w 10801"/>
                <a:gd name="connsiteY13" fmla="*/ 7829 h 10000"/>
                <a:gd name="connsiteX14" fmla="*/ 10791 w 10801"/>
                <a:gd name="connsiteY14" fmla="*/ 5384 h 10000"/>
                <a:gd name="connsiteX15" fmla="*/ 9774 w 10801"/>
                <a:gd name="connsiteY15" fmla="*/ 1773 h 10000"/>
                <a:gd name="connsiteX0" fmla="*/ 9774 w 10801"/>
                <a:gd name="connsiteY0" fmla="*/ 1905 h 10132"/>
                <a:gd name="connsiteX1" fmla="*/ 6385 w 10801"/>
                <a:gd name="connsiteY1" fmla="*/ 183 h 10132"/>
                <a:gd name="connsiteX2" fmla="*/ 5477 w 10801"/>
                <a:gd name="connsiteY2" fmla="*/ 717 h 10132"/>
                <a:gd name="connsiteX3" fmla="*/ 3885 w 10801"/>
                <a:gd name="connsiteY3" fmla="*/ 99 h 10132"/>
                <a:gd name="connsiteX4" fmla="*/ 1244 w 10801"/>
                <a:gd name="connsiteY4" fmla="*/ 1882 h 10132"/>
                <a:gd name="connsiteX5" fmla="*/ 413 w 10801"/>
                <a:gd name="connsiteY5" fmla="*/ 8012 h 10132"/>
                <a:gd name="connsiteX6" fmla="*/ 1573 w 10801"/>
                <a:gd name="connsiteY6" fmla="*/ 9511 h 10132"/>
                <a:gd name="connsiteX7" fmla="*/ 3309 w 10801"/>
                <a:gd name="connsiteY7" fmla="*/ 10099 h 10132"/>
                <a:gd name="connsiteX8" fmla="*/ 4628 w 10801"/>
                <a:gd name="connsiteY8" fmla="*/ 9018 h 10132"/>
                <a:gd name="connsiteX9" fmla="*/ 5296 w 10801"/>
                <a:gd name="connsiteY9" fmla="*/ 7892 h 10132"/>
                <a:gd name="connsiteX10" fmla="*/ 6003 w 10801"/>
                <a:gd name="connsiteY10" fmla="*/ 9824 h 10132"/>
                <a:gd name="connsiteX11" fmla="*/ 7744 w 10801"/>
                <a:gd name="connsiteY11" fmla="*/ 9936 h 10132"/>
                <a:gd name="connsiteX12" fmla="*/ 7823 w 10801"/>
                <a:gd name="connsiteY12" fmla="*/ 9913 h 10132"/>
                <a:gd name="connsiteX13" fmla="*/ 10146 w 10801"/>
                <a:gd name="connsiteY13" fmla="*/ 7961 h 10132"/>
                <a:gd name="connsiteX14" fmla="*/ 10791 w 10801"/>
                <a:gd name="connsiteY14" fmla="*/ 5516 h 10132"/>
                <a:gd name="connsiteX15" fmla="*/ 9774 w 10801"/>
                <a:gd name="connsiteY15" fmla="*/ 1905 h 10132"/>
                <a:gd name="connsiteX0" fmla="*/ 9833 w 10860"/>
                <a:gd name="connsiteY0" fmla="*/ 1917 h 10144"/>
                <a:gd name="connsiteX1" fmla="*/ 6444 w 10860"/>
                <a:gd name="connsiteY1" fmla="*/ 195 h 10144"/>
                <a:gd name="connsiteX2" fmla="*/ 5536 w 10860"/>
                <a:gd name="connsiteY2" fmla="*/ 729 h 10144"/>
                <a:gd name="connsiteX3" fmla="*/ 3944 w 10860"/>
                <a:gd name="connsiteY3" fmla="*/ 111 h 10144"/>
                <a:gd name="connsiteX4" fmla="*/ 1077 w 10860"/>
                <a:gd name="connsiteY4" fmla="*/ 1708 h 10144"/>
                <a:gd name="connsiteX5" fmla="*/ 472 w 10860"/>
                <a:gd name="connsiteY5" fmla="*/ 8024 h 10144"/>
                <a:gd name="connsiteX6" fmla="*/ 1632 w 10860"/>
                <a:gd name="connsiteY6" fmla="*/ 9523 h 10144"/>
                <a:gd name="connsiteX7" fmla="*/ 3368 w 10860"/>
                <a:gd name="connsiteY7" fmla="*/ 10111 h 10144"/>
                <a:gd name="connsiteX8" fmla="*/ 4687 w 10860"/>
                <a:gd name="connsiteY8" fmla="*/ 9030 h 10144"/>
                <a:gd name="connsiteX9" fmla="*/ 5355 w 10860"/>
                <a:gd name="connsiteY9" fmla="*/ 7904 h 10144"/>
                <a:gd name="connsiteX10" fmla="*/ 6062 w 10860"/>
                <a:gd name="connsiteY10" fmla="*/ 9836 h 10144"/>
                <a:gd name="connsiteX11" fmla="*/ 7803 w 10860"/>
                <a:gd name="connsiteY11" fmla="*/ 9948 h 10144"/>
                <a:gd name="connsiteX12" fmla="*/ 7882 w 10860"/>
                <a:gd name="connsiteY12" fmla="*/ 9925 h 10144"/>
                <a:gd name="connsiteX13" fmla="*/ 10205 w 10860"/>
                <a:gd name="connsiteY13" fmla="*/ 7973 h 10144"/>
                <a:gd name="connsiteX14" fmla="*/ 10850 w 10860"/>
                <a:gd name="connsiteY14" fmla="*/ 5528 h 10144"/>
                <a:gd name="connsiteX15" fmla="*/ 9833 w 10860"/>
                <a:gd name="connsiteY15" fmla="*/ 1917 h 10144"/>
                <a:gd name="connsiteX0" fmla="*/ 9833 w 10860"/>
                <a:gd name="connsiteY0" fmla="*/ 2344 h 10571"/>
                <a:gd name="connsiteX1" fmla="*/ 6444 w 10860"/>
                <a:gd name="connsiteY1" fmla="*/ 622 h 10571"/>
                <a:gd name="connsiteX2" fmla="*/ 5536 w 10860"/>
                <a:gd name="connsiteY2" fmla="*/ 1156 h 10571"/>
                <a:gd name="connsiteX3" fmla="*/ 4055 w 10860"/>
                <a:gd name="connsiteY3" fmla="*/ 86 h 10571"/>
                <a:gd name="connsiteX4" fmla="*/ 1077 w 10860"/>
                <a:gd name="connsiteY4" fmla="*/ 2135 h 10571"/>
                <a:gd name="connsiteX5" fmla="*/ 472 w 10860"/>
                <a:gd name="connsiteY5" fmla="*/ 8451 h 10571"/>
                <a:gd name="connsiteX6" fmla="*/ 1632 w 10860"/>
                <a:gd name="connsiteY6" fmla="*/ 9950 h 10571"/>
                <a:gd name="connsiteX7" fmla="*/ 3368 w 10860"/>
                <a:gd name="connsiteY7" fmla="*/ 10538 h 10571"/>
                <a:gd name="connsiteX8" fmla="*/ 4687 w 10860"/>
                <a:gd name="connsiteY8" fmla="*/ 9457 h 10571"/>
                <a:gd name="connsiteX9" fmla="*/ 5355 w 10860"/>
                <a:gd name="connsiteY9" fmla="*/ 8331 h 10571"/>
                <a:gd name="connsiteX10" fmla="*/ 6062 w 10860"/>
                <a:gd name="connsiteY10" fmla="*/ 10263 h 10571"/>
                <a:gd name="connsiteX11" fmla="*/ 7803 w 10860"/>
                <a:gd name="connsiteY11" fmla="*/ 10375 h 10571"/>
                <a:gd name="connsiteX12" fmla="*/ 7882 w 10860"/>
                <a:gd name="connsiteY12" fmla="*/ 10352 h 10571"/>
                <a:gd name="connsiteX13" fmla="*/ 10205 w 10860"/>
                <a:gd name="connsiteY13" fmla="*/ 8400 h 10571"/>
                <a:gd name="connsiteX14" fmla="*/ 10850 w 10860"/>
                <a:gd name="connsiteY14" fmla="*/ 5955 h 10571"/>
                <a:gd name="connsiteX15" fmla="*/ 9833 w 10860"/>
                <a:gd name="connsiteY15" fmla="*/ 2344 h 10571"/>
                <a:gd name="connsiteX0" fmla="*/ 9833 w 10860"/>
                <a:gd name="connsiteY0" fmla="*/ 2447 h 10674"/>
                <a:gd name="connsiteX1" fmla="*/ 6444 w 10860"/>
                <a:gd name="connsiteY1" fmla="*/ 725 h 10674"/>
                <a:gd name="connsiteX2" fmla="*/ 5536 w 10860"/>
                <a:gd name="connsiteY2" fmla="*/ 1259 h 10674"/>
                <a:gd name="connsiteX3" fmla="*/ 4078 w 10860"/>
                <a:gd name="connsiteY3" fmla="*/ 81 h 10674"/>
                <a:gd name="connsiteX4" fmla="*/ 1077 w 10860"/>
                <a:gd name="connsiteY4" fmla="*/ 2238 h 10674"/>
                <a:gd name="connsiteX5" fmla="*/ 472 w 10860"/>
                <a:gd name="connsiteY5" fmla="*/ 8554 h 10674"/>
                <a:gd name="connsiteX6" fmla="*/ 1632 w 10860"/>
                <a:gd name="connsiteY6" fmla="*/ 10053 h 10674"/>
                <a:gd name="connsiteX7" fmla="*/ 3368 w 10860"/>
                <a:gd name="connsiteY7" fmla="*/ 10641 h 10674"/>
                <a:gd name="connsiteX8" fmla="*/ 4687 w 10860"/>
                <a:gd name="connsiteY8" fmla="*/ 9560 h 10674"/>
                <a:gd name="connsiteX9" fmla="*/ 5355 w 10860"/>
                <a:gd name="connsiteY9" fmla="*/ 8434 h 10674"/>
                <a:gd name="connsiteX10" fmla="*/ 6062 w 10860"/>
                <a:gd name="connsiteY10" fmla="*/ 10366 h 10674"/>
                <a:gd name="connsiteX11" fmla="*/ 7803 w 10860"/>
                <a:gd name="connsiteY11" fmla="*/ 10478 h 10674"/>
                <a:gd name="connsiteX12" fmla="*/ 7882 w 10860"/>
                <a:gd name="connsiteY12" fmla="*/ 10455 h 10674"/>
                <a:gd name="connsiteX13" fmla="*/ 10205 w 10860"/>
                <a:gd name="connsiteY13" fmla="*/ 8503 h 10674"/>
                <a:gd name="connsiteX14" fmla="*/ 10850 w 10860"/>
                <a:gd name="connsiteY14" fmla="*/ 6058 h 10674"/>
                <a:gd name="connsiteX15" fmla="*/ 9833 w 10860"/>
                <a:gd name="connsiteY15" fmla="*/ 2447 h 10674"/>
                <a:gd name="connsiteX0" fmla="*/ 9833 w 10860"/>
                <a:gd name="connsiteY0" fmla="*/ 2447 h 10674"/>
                <a:gd name="connsiteX1" fmla="*/ 6444 w 10860"/>
                <a:gd name="connsiteY1" fmla="*/ 725 h 10674"/>
                <a:gd name="connsiteX2" fmla="*/ 5479 w 10860"/>
                <a:gd name="connsiteY2" fmla="*/ 1162 h 10674"/>
                <a:gd name="connsiteX3" fmla="*/ 4078 w 10860"/>
                <a:gd name="connsiteY3" fmla="*/ 81 h 10674"/>
                <a:gd name="connsiteX4" fmla="*/ 1077 w 10860"/>
                <a:gd name="connsiteY4" fmla="*/ 2238 h 10674"/>
                <a:gd name="connsiteX5" fmla="*/ 472 w 10860"/>
                <a:gd name="connsiteY5" fmla="*/ 8554 h 10674"/>
                <a:gd name="connsiteX6" fmla="*/ 1632 w 10860"/>
                <a:gd name="connsiteY6" fmla="*/ 10053 h 10674"/>
                <a:gd name="connsiteX7" fmla="*/ 3368 w 10860"/>
                <a:gd name="connsiteY7" fmla="*/ 10641 h 10674"/>
                <a:gd name="connsiteX8" fmla="*/ 4687 w 10860"/>
                <a:gd name="connsiteY8" fmla="*/ 9560 h 10674"/>
                <a:gd name="connsiteX9" fmla="*/ 5355 w 10860"/>
                <a:gd name="connsiteY9" fmla="*/ 8434 h 10674"/>
                <a:gd name="connsiteX10" fmla="*/ 6062 w 10860"/>
                <a:gd name="connsiteY10" fmla="*/ 10366 h 10674"/>
                <a:gd name="connsiteX11" fmla="*/ 7803 w 10860"/>
                <a:gd name="connsiteY11" fmla="*/ 10478 h 10674"/>
                <a:gd name="connsiteX12" fmla="*/ 7882 w 10860"/>
                <a:gd name="connsiteY12" fmla="*/ 10455 h 10674"/>
                <a:gd name="connsiteX13" fmla="*/ 10205 w 10860"/>
                <a:gd name="connsiteY13" fmla="*/ 8503 h 10674"/>
                <a:gd name="connsiteX14" fmla="*/ 10850 w 10860"/>
                <a:gd name="connsiteY14" fmla="*/ 6058 h 10674"/>
                <a:gd name="connsiteX15" fmla="*/ 9833 w 10860"/>
                <a:gd name="connsiteY15" fmla="*/ 2447 h 10674"/>
                <a:gd name="connsiteX0" fmla="*/ 9833 w 10860"/>
                <a:gd name="connsiteY0" fmla="*/ 2447 h 10674"/>
                <a:gd name="connsiteX1" fmla="*/ 6444 w 10860"/>
                <a:gd name="connsiteY1" fmla="*/ 725 h 10674"/>
                <a:gd name="connsiteX2" fmla="*/ 5479 w 10860"/>
                <a:gd name="connsiteY2" fmla="*/ 1162 h 10674"/>
                <a:gd name="connsiteX3" fmla="*/ 4078 w 10860"/>
                <a:gd name="connsiteY3" fmla="*/ 81 h 10674"/>
                <a:gd name="connsiteX4" fmla="*/ 1077 w 10860"/>
                <a:gd name="connsiteY4" fmla="*/ 2238 h 10674"/>
                <a:gd name="connsiteX5" fmla="*/ 472 w 10860"/>
                <a:gd name="connsiteY5" fmla="*/ 8554 h 10674"/>
                <a:gd name="connsiteX6" fmla="*/ 1632 w 10860"/>
                <a:gd name="connsiteY6" fmla="*/ 10053 h 10674"/>
                <a:gd name="connsiteX7" fmla="*/ 3368 w 10860"/>
                <a:gd name="connsiteY7" fmla="*/ 10641 h 10674"/>
                <a:gd name="connsiteX8" fmla="*/ 4687 w 10860"/>
                <a:gd name="connsiteY8" fmla="*/ 9560 h 10674"/>
                <a:gd name="connsiteX9" fmla="*/ 5355 w 10860"/>
                <a:gd name="connsiteY9" fmla="*/ 8434 h 10674"/>
                <a:gd name="connsiteX10" fmla="*/ 6062 w 10860"/>
                <a:gd name="connsiteY10" fmla="*/ 10366 h 10674"/>
                <a:gd name="connsiteX11" fmla="*/ 7803 w 10860"/>
                <a:gd name="connsiteY11" fmla="*/ 10478 h 10674"/>
                <a:gd name="connsiteX12" fmla="*/ 7882 w 10860"/>
                <a:gd name="connsiteY12" fmla="*/ 10455 h 10674"/>
                <a:gd name="connsiteX13" fmla="*/ 10205 w 10860"/>
                <a:gd name="connsiteY13" fmla="*/ 8503 h 10674"/>
                <a:gd name="connsiteX14" fmla="*/ 10850 w 10860"/>
                <a:gd name="connsiteY14" fmla="*/ 6058 h 10674"/>
                <a:gd name="connsiteX15" fmla="*/ 9833 w 10860"/>
                <a:gd name="connsiteY15" fmla="*/ 2447 h 10674"/>
                <a:gd name="connsiteX0" fmla="*/ 9877 w 10904"/>
                <a:gd name="connsiteY0" fmla="*/ 2451 h 10678"/>
                <a:gd name="connsiteX1" fmla="*/ 6488 w 10904"/>
                <a:gd name="connsiteY1" fmla="*/ 729 h 10678"/>
                <a:gd name="connsiteX2" fmla="*/ 5523 w 10904"/>
                <a:gd name="connsiteY2" fmla="*/ 1166 h 10678"/>
                <a:gd name="connsiteX3" fmla="*/ 4122 w 10904"/>
                <a:gd name="connsiteY3" fmla="*/ 85 h 10678"/>
                <a:gd name="connsiteX4" fmla="*/ 984 w 10904"/>
                <a:gd name="connsiteY4" fmla="*/ 2157 h 10678"/>
                <a:gd name="connsiteX5" fmla="*/ 516 w 10904"/>
                <a:gd name="connsiteY5" fmla="*/ 8558 h 10678"/>
                <a:gd name="connsiteX6" fmla="*/ 1676 w 10904"/>
                <a:gd name="connsiteY6" fmla="*/ 10057 h 10678"/>
                <a:gd name="connsiteX7" fmla="*/ 3412 w 10904"/>
                <a:gd name="connsiteY7" fmla="*/ 10645 h 10678"/>
                <a:gd name="connsiteX8" fmla="*/ 4731 w 10904"/>
                <a:gd name="connsiteY8" fmla="*/ 9564 h 10678"/>
                <a:gd name="connsiteX9" fmla="*/ 5399 w 10904"/>
                <a:gd name="connsiteY9" fmla="*/ 8438 h 10678"/>
                <a:gd name="connsiteX10" fmla="*/ 6106 w 10904"/>
                <a:gd name="connsiteY10" fmla="*/ 10370 h 10678"/>
                <a:gd name="connsiteX11" fmla="*/ 7847 w 10904"/>
                <a:gd name="connsiteY11" fmla="*/ 10482 h 10678"/>
                <a:gd name="connsiteX12" fmla="*/ 7926 w 10904"/>
                <a:gd name="connsiteY12" fmla="*/ 10459 h 10678"/>
                <a:gd name="connsiteX13" fmla="*/ 10249 w 10904"/>
                <a:gd name="connsiteY13" fmla="*/ 8507 h 10678"/>
                <a:gd name="connsiteX14" fmla="*/ 10894 w 10904"/>
                <a:gd name="connsiteY14" fmla="*/ 6062 h 10678"/>
                <a:gd name="connsiteX15" fmla="*/ 9877 w 10904"/>
                <a:gd name="connsiteY15" fmla="*/ 2451 h 10678"/>
                <a:gd name="connsiteX0" fmla="*/ 9877 w 10904"/>
                <a:gd name="connsiteY0" fmla="*/ 2451 h 10678"/>
                <a:gd name="connsiteX1" fmla="*/ 6488 w 10904"/>
                <a:gd name="connsiteY1" fmla="*/ 729 h 10678"/>
                <a:gd name="connsiteX2" fmla="*/ 5523 w 10904"/>
                <a:gd name="connsiteY2" fmla="*/ 1166 h 10678"/>
                <a:gd name="connsiteX3" fmla="*/ 4122 w 10904"/>
                <a:gd name="connsiteY3" fmla="*/ 85 h 10678"/>
                <a:gd name="connsiteX4" fmla="*/ 984 w 10904"/>
                <a:gd name="connsiteY4" fmla="*/ 2157 h 10678"/>
                <a:gd name="connsiteX5" fmla="*/ 516 w 10904"/>
                <a:gd name="connsiteY5" fmla="*/ 8558 h 10678"/>
                <a:gd name="connsiteX6" fmla="*/ 1676 w 10904"/>
                <a:gd name="connsiteY6" fmla="*/ 10057 h 10678"/>
                <a:gd name="connsiteX7" fmla="*/ 3412 w 10904"/>
                <a:gd name="connsiteY7" fmla="*/ 10645 h 10678"/>
                <a:gd name="connsiteX8" fmla="*/ 4731 w 10904"/>
                <a:gd name="connsiteY8" fmla="*/ 9564 h 10678"/>
                <a:gd name="connsiteX9" fmla="*/ 5399 w 10904"/>
                <a:gd name="connsiteY9" fmla="*/ 8438 h 10678"/>
                <a:gd name="connsiteX10" fmla="*/ 6106 w 10904"/>
                <a:gd name="connsiteY10" fmla="*/ 10370 h 10678"/>
                <a:gd name="connsiteX11" fmla="*/ 7847 w 10904"/>
                <a:gd name="connsiteY11" fmla="*/ 10482 h 10678"/>
                <a:gd name="connsiteX12" fmla="*/ 7926 w 10904"/>
                <a:gd name="connsiteY12" fmla="*/ 10459 h 10678"/>
                <a:gd name="connsiteX13" fmla="*/ 10249 w 10904"/>
                <a:gd name="connsiteY13" fmla="*/ 8507 h 10678"/>
                <a:gd name="connsiteX14" fmla="*/ 10894 w 10904"/>
                <a:gd name="connsiteY14" fmla="*/ 6062 h 10678"/>
                <a:gd name="connsiteX15" fmla="*/ 9877 w 10904"/>
                <a:gd name="connsiteY15" fmla="*/ 2451 h 10678"/>
                <a:gd name="connsiteX0" fmla="*/ 9877 w 10904"/>
                <a:gd name="connsiteY0" fmla="*/ 2451 h 10678"/>
                <a:gd name="connsiteX1" fmla="*/ 6488 w 10904"/>
                <a:gd name="connsiteY1" fmla="*/ 729 h 10678"/>
                <a:gd name="connsiteX2" fmla="*/ 5446 w 10904"/>
                <a:gd name="connsiteY2" fmla="*/ 1133 h 10678"/>
                <a:gd name="connsiteX3" fmla="*/ 4122 w 10904"/>
                <a:gd name="connsiteY3" fmla="*/ 85 h 10678"/>
                <a:gd name="connsiteX4" fmla="*/ 984 w 10904"/>
                <a:gd name="connsiteY4" fmla="*/ 2157 h 10678"/>
                <a:gd name="connsiteX5" fmla="*/ 516 w 10904"/>
                <a:gd name="connsiteY5" fmla="*/ 8558 h 10678"/>
                <a:gd name="connsiteX6" fmla="*/ 1676 w 10904"/>
                <a:gd name="connsiteY6" fmla="*/ 10057 h 10678"/>
                <a:gd name="connsiteX7" fmla="*/ 3412 w 10904"/>
                <a:gd name="connsiteY7" fmla="*/ 10645 h 10678"/>
                <a:gd name="connsiteX8" fmla="*/ 4731 w 10904"/>
                <a:gd name="connsiteY8" fmla="*/ 9564 h 10678"/>
                <a:gd name="connsiteX9" fmla="*/ 5399 w 10904"/>
                <a:gd name="connsiteY9" fmla="*/ 8438 h 10678"/>
                <a:gd name="connsiteX10" fmla="*/ 6106 w 10904"/>
                <a:gd name="connsiteY10" fmla="*/ 10370 h 10678"/>
                <a:gd name="connsiteX11" fmla="*/ 7847 w 10904"/>
                <a:gd name="connsiteY11" fmla="*/ 10482 h 10678"/>
                <a:gd name="connsiteX12" fmla="*/ 7926 w 10904"/>
                <a:gd name="connsiteY12" fmla="*/ 10459 h 10678"/>
                <a:gd name="connsiteX13" fmla="*/ 10249 w 10904"/>
                <a:gd name="connsiteY13" fmla="*/ 8507 h 10678"/>
                <a:gd name="connsiteX14" fmla="*/ 10894 w 10904"/>
                <a:gd name="connsiteY14" fmla="*/ 6062 h 10678"/>
                <a:gd name="connsiteX15" fmla="*/ 9877 w 10904"/>
                <a:gd name="connsiteY15" fmla="*/ 2451 h 10678"/>
                <a:gd name="connsiteX0" fmla="*/ 9877 w 10904"/>
                <a:gd name="connsiteY0" fmla="*/ 2451 h 10678"/>
                <a:gd name="connsiteX1" fmla="*/ 6488 w 10904"/>
                <a:gd name="connsiteY1" fmla="*/ 729 h 10678"/>
                <a:gd name="connsiteX2" fmla="*/ 5628 w 10904"/>
                <a:gd name="connsiteY2" fmla="*/ 802 h 10678"/>
                <a:gd name="connsiteX3" fmla="*/ 4122 w 10904"/>
                <a:gd name="connsiteY3" fmla="*/ 85 h 10678"/>
                <a:gd name="connsiteX4" fmla="*/ 984 w 10904"/>
                <a:gd name="connsiteY4" fmla="*/ 2157 h 10678"/>
                <a:gd name="connsiteX5" fmla="*/ 516 w 10904"/>
                <a:gd name="connsiteY5" fmla="*/ 8558 h 10678"/>
                <a:gd name="connsiteX6" fmla="*/ 1676 w 10904"/>
                <a:gd name="connsiteY6" fmla="*/ 10057 h 10678"/>
                <a:gd name="connsiteX7" fmla="*/ 3412 w 10904"/>
                <a:gd name="connsiteY7" fmla="*/ 10645 h 10678"/>
                <a:gd name="connsiteX8" fmla="*/ 4731 w 10904"/>
                <a:gd name="connsiteY8" fmla="*/ 9564 h 10678"/>
                <a:gd name="connsiteX9" fmla="*/ 5399 w 10904"/>
                <a:gd name="connsiteY9" fmla="*/ 8438 h 10678"/>
                <a:gd name="connsiteX10" fmla="*/ 6106 w 10904"/>
                <a:gd name="connsiteY10" fmla="*/ 10370 h 10678"/>
                <a:gd name="connsiteX11" fmla="*/ 7847 w 10904"/>
                <a:gd name="connsiteY11" fmla="*/ 10482 h 10678"/>
                <a:gd name="connsiteX12" fmla="*/ 7926 w 10904"/>
                <a:gd name="connsiteY12" fmla="*/ 10459 h 10678"/>
                <a:gd name="connsiteX13" fmla="*/ 10249 w 10904"/>
                <a:gd name="connsiteY13" fmla="*/ 8507 h 10678"/>
                <a:gd name="connsiteX14" fmla="*/ 10894 w 10904"/>
                <a:gd name="connsiteY14" fmla="*/ 6062 h 10678"/>
                <a:gd name="connsiteX15" fmla="*/ 9877 w 10904"/>
                <a:gd name="connsiteY15" fmla="*/ 2451 h 10678"/>
                <a:gd name="connsiteX0" fmla="*/ 9877 w 10904"/>
                <a:gd name="connsiteY0" fmla="*/ 2769 h 10996"/>
                <a:gd name="connsiteX1" fmla="*/ 6488 w 10904"/>
                <a:gd name="connsiteY1" fmla="*/ 1047 h 10996"/>
                <a:gd name="connsiteX2" fmla="*/ 5628 w 10904"/>
                <a:gd name="connsiteY2" fmla="*/ 1120 h 10996"/>
                <a:gd name="connsiteX3" fmla="*/ 3986 w 10904"/>
                <a:gd name="connsiteY3" fmla="*/ 73 h 10996"/>
                <a:gd name="connsiteX4" fmla="*/ 984 w 10904"/>
                <a:gd name="connsiteY4" fmla="*/ 2475 h 10996"/>
                <a:gd name="connsiteX5" fmla="*/ 516 w 10904"/>
                <a:gd name="connsiteY5" fmla="*/ 8876 h 10996"/>
                <a:gd name="connsiteX6" fmla="*/ 1676 w 10904"/>
                <a:gd name="connsiteY6" fmla="*/ 10375 h 10996"/>
                <a:gd name="connsiteX7" fmla="*/ 3412 w 10904"/>
                <a:gd name="connsiteY7" fmla="*/ 10963 h 10996"/>
                <a:gd name="connsiteX8" fmla="*/ 4731 w 10904"/>
                <a:gd name="connsiteY8" fmla="*/ 9882 h 10996"/>
                <a:gd name="connsiteX9" fmla="*/ 5399 w 10904"/>
                <a:gd name="connsiteY9" fmla="*/ 8756 h 10996"/>
                <a:gd name="connsiteX10" fmla="*/ 6106 w 10904"/>
                <a:gd name="connsiteY10" fmla="*/ 10688 h 10996"/>
                <a:gd name="connsiteX11" fmla="*/ 7847 w 10904"/>
                <a:gd name="connsiteY11" fmla="*/ 10800 h 10996"/>
                <a:gd name="connsiteX12" fmla="*/ 7926 w 10904"/>
                <a:gd name="connsiteY12" fmla="*/ 10777 h 10996"/>
                <a:gd name="connsiteX13" fmla="*/ 10249 w 10904"/>
                <a:gd name="connsiteY13" fmla="*/ 8825 h 10996"/>
                <a:gd name="connsiteX14" fmla="*/ 10894 w 10904"/>
                <a:gd name="connsiteY14" fmla="*/ 6380 h 10996"/>
                <a:gd name="connsiteX15" fmla="*/ 9877 w 10904"/>
                <a:gd name="connsiteY15" fmla="*/ 2769 h 10996"/>
                <a:gd name="connsiteX0" fmla="*/ 9877 w 10904"/>
                <a:gd name="connsiteY0" fmla="*/ 2962 h 11189"/>
                <a:gd name="connsiteX1" fmla="*/ 6488 w 10904"/>
                <a:gd name="connsiteY1" fmla="*/ 1240 h 11189"/>
                <a:gd name="connsiteX2" fmla="*/ 5628 w 10904"/>
                <a:gd name="connsiteY2" fmla="*/ 1313 h 11189"/>
                <a:gd name="connsiteX3" fmla="*/ 4159 w 10904"/>
                <a:gd name="connsiteY3" fmla="*/ 67 h 11189"/>
                <a:gd name="connsiteX4" fmla="*/ 984 w 10904"/>
                <a:gd name="connsiteY4" fmla="*/ 2668 h 11189"/>
                <a:gd name="connsiteX5" fmla="*/ 516 w 10904"/>
                <a:gd name="connsiteY5" fmla="*/ 9069 h 11189"/>
                <a:gd name="connsiteX6" fmla="*/ 1676 w 10904"/>
                <a:gd name="connsiteY6" fmla="*/ 10568 h 11189"/>
                <a:gd name="connsiteX7" fmla="*/ 3412 w 10904"/>
                <a:gd name="connsiteY7" fmla="*/ 11156 h 11189"/>
                <a:gd name="connsiteX8" fmla="*/ 4731 w 10904"/>
                <a:gd name="connsiteY8" fmla="*/ 10075 h 11189"/>
                <a:gd name="connsiteX9" fmla="*/ 5399 w 10904"/>
                <a:gd name="connsiteY9" fmla="*/ 8949 h 11189"/>
                <a:gd name="connsiteX10" fmla="*/ 6106 w 10904"/>
                <a:gd name="connsiteY10" fmla="*/ 10881 h 11189"/>
                <a:gd name="connsiteX11" fmla="*/ 7847 w 10904"/>
                <a:gd name="connsiteY11" fmla="*/ 10993 h 11189"/>
                <a:gd name="connsiteX12" fmla="*/ 7926 w 10904"/>
                <a:gd name="connsiteY12" fmla="*/ 10970 h 11189"/>
                <a:gd name="connsiteX13" fmla="*/ 10249 w 10904"/>
                <a:gd name="connsiteY13" fmla="*/ 9018 h 11189"/>
                <a:gd name="connsiteX14" fmla="*/ 10894 w 10904"/>
                <a:gd name="connsiteY14" fmla="*/ 6573 h 11189"/>
                <a:gd name="connsiteX15" fmla="*/ 9877 w 10904"/>
                <a:gd name="connsiteY15" fmla="*/ 2962 h 11189"/>
                <a:gd name="connsiteX0" fmla="*/ 9877 w 10904"/>
                <a:gd name="connsiteY0" fmla="*/ 2962 h 11189"/>
                <a:gd name="connsiteX1" fmla="*/ 6488 w 10904"/>
                <a:gd name="connsiteY1" fmla="*/ 1240 h 11189"/>
                <a:gd name="connsiteX2" fmla="*/ 5628 w 10904"/>
                <a:gd name="connsiteY2" fmla="*/ 1313 h 11189"/>
                <a:gd name="connsiteX3" fmla="*/ 4159 w 10904"/>
                <a:gd name="connsiteY3" fmla="*/ 67 h 11189"/>
                <a:gd name="connsiteX4" fmla="*/ 984 w 10904"/>
                <a:gd name="connsiteY4" fmla="*/ 2668 h 11189"/>
                <a:gd name="connsiteX5" fmla="*/ 516 w 10904"/>
                <a:gd name="connsiteY5" fmla="*/ 9069 h 11189"/>
                <a:gd name="connsiteX6" fmla="*/ 1676 w 10904"/>
                <a:gd name="connsiteY6" fmla="*/ 10568 h 11189"/>
                <a:gd name="connsiteX7" fmla="*/ 3412 w 10904"/>
                <a:gd name="connsiteY7" fmla="*/ 11156 h 11189"/>
                <a:gd name="connsiteX8" fmla="*/ 4731 w 10904"/>
                <a:gd name="connsiteY8" fmla="*/ 10075 h 11189"/>
                <a:gd name="connsiteX9" fmla="*/ 5399 w 10904"/>
                <a:gd name="connsiteY9" fmla="*/ 8949 h 11189"/>
                <a:gd name="connsiteX10" fmla="*/ 6106 w 10904"/>
                <a:gd name="connsiteY10" fmla="*/ 10881 h 11189"/>
                <a:gd name="connsiteX11" fmla="*/ 7847 w 10904"/>
                <a:gd name="connsiteY11" fmla="*/ 10993 h 11189"/>
                <a:gd name="connsiteX12" fmla="*/ 7926 w 10904"/>
                <a:gd name="connsiteY12" fmla="*/ 10970 h 11189"/>
                <a:gd name="connsiteX13" fmla="*/ 10249 w 10904"/>
                <a:gd name="connsiteY13" fmla="*/ 9018 h 11189"/>
                <a:gd name="connsiteX14" fmla="*/ 10894 w 10904"/>
                <a:gd name="connsiteY14" fmla="*/ 6573 h 11189"/>
                <a:gd name="connsiteX15" fmla="*/ 9877 w 10904"/>
                <a:gd name="connsiteY15" fmla="*/ 2962 h 11189"/>
                <a:gd name="connsiteX0" fmla="*/ 9877 w 10904"/>
                <a:gd name="connsiteY0" fmla="*/ 2962 h 11189"/>
                <a:gd name="connsiteX1" fmla="*/ 6488 w 10904"/>
                <a:gd name="connsiteY1" fmla="*/ 1240 h 11189"/>
                <a:gd name="connsiteX2" fmla="*/ 5628 w 10904"/>
                <a:gd name="connsiteY2" fmla="*/ 1313 h 11189"/>
                <a:gd name="connsiteX3" fmla="*/ 4159 w 10904"/>
                <a:gd name="connsiteY3" fmla="*/ 67 h 11189"/>
                <a:gd name="connsiteX4" fmla="*/ 984 w 10904"/>
                <a:gd name="connsiteY4" fmla="*/ 2668 h 11189"/>
                <a:gd name="connsiteX5" fmla="*/ 516 w 10904"/>
                <a:gd name="connsiteY5" fmla="*/ 9069 h 11189"/>
                <a:gd name="connsiteX6" fmla="*/ 1676 w 10904"/>
                <a:gd name="connsiteY6" fmla="*/ 10568 h 11189"/>
                <a:gd name="connsiteX7" fmla="*/ 3412 w 10904"/>
                <a:gd name="connsiteY7" fmla="*/ 11156 h 11189"/>
                <a:gd name="connsiteX8" fmla="*/ 4731 w 10904"/>
                <a:gd name="connsiteY8" fmla="*/ 10075 h 11189"/>
                <a:gd name="connsiteX9" fmla="*/ 5399 w 10904"/>
                <a:gd name="connsiteY9" fmla="*/ 8949 h 11189"/>
                <a:gd name="connsiteX10" fmla="*/ 6106 w 10904"/>
                <a:gd name="connsiteY10" fmla="*/ 10881 h 11189"/>
                <a:gd name="connsiteX11" fmla="*/ 7847 w 10904"/>
                <a:gd name="connsiteY11" fmla="*/ 10993 h 11189"/>
                <a:gd name="connsiteX12" fmla="*/ 7926 w 10904"/>
                <a:gd name="connsiteY12" fmla="*/ 10970 h 11189"/>
                <a:gd name="connsiteX13" fmla="*/ 10249 w 10904"/>
                <a:gd name="connsiteY13" fmla="*/ 9018 h 11189"/>
                <a:gd name="connsiteX14" fmla="*/ 10894 w 10904"/>
                <a:gd name="connsiteY14" fmla="*/ 6573 h 11189"/>
                <a:gd name="connsiteX15" fmla="*/ 9877 w 10904"/>
                <a:gd name="connsiteY15" fmla="*/ 2962 h 11189"/>
                <a:gd name="connsiteX0" fmla="*/ 9877 w 10904"/>
                <a:gd name="connsiteY0" fmla="*/ 2911 h 11138"/>
                <a:gd name="connsiteX1" fmla="*/ 6488 w 10904"/>
                <a:gd name="connsiteY1" fmla="*/ 1189 h 11138"/>
                <a:gd name="connsiteX2" fmla="*/ 5628 w 10904"/>
                <a:gd name="connsiteY2" fmla="*/ 1262 h 11138"/>
                <a:gd name="connsiteX3" fmla="*/ 4159 w 10904"/>
                <a:gd name="connsiteY3" fmla="*/ 16 h 11138"/>
                <a:gd name="connsiteX4" fmla="*/ 984 w 10904"/>
                <a:gd name="connsiteY4" fmla="*/ 2617 h 11138"/>
                <a:gd name="connsiteX5" fmla="*/ 516 w 10904"/>
                <a:gd name="connsiteY5" fmla="*/ 9018 h 11138"/>
                <a:gd name="connsiteX6" fmla="*/ 1676 w 10904"/>
                <a:gd name="connsiteY6" fmla="*/ 10517 h 11138"/>
                <a:gd name="connsiteX7" fmla="*/ 3412 w 10904"/>
                <a:gd name="connsiteY7" fmla="*/ 11105 h 11138"/>
                <a:gd name="connsiteX8" fmla="*/ 4731 w 10904"/>
                <a:gd name="connsiteY8" fmla="*/ 10024 h 11138"/>
                <a:gd name="connsiteX9" fmla="*/ 5399 w 10904"/>
                <a:gd name="connsiteY9" fmla="*/ 8898 h 11138"/>
                <a:gd name="connsiteX10" fmla="*/ 6106 w 10904"/>
                <a:gd name="connsiteY10" fmla="*/ 10830 h 11138"/>
                <a:gd name="connsiteX11" fmla="*/ 7847 w 10904"/>
                <a:gd name="connsiteY11" fmla="*/ 10942 h 11138"/>
                <a:gd name="connsiteX12" fmla="*/ 7926 w 10904"/>
                <a:gd name="connsiteY12" fmla="*/ 10919 h 11138"/>
                <a:gd name="connsiteX13" fmla="*/ 10249 w 10904"/>
                <a:gd name="connsiteY13" fmla="*/ 8967 h 11138"/>
                <a:gd name="connsiteX14" fmla="*/ 10894 w 10904"/>
                <a:gd name="connsiteY14" fmla="*/ 6522 h 11138"/>
                <a:gd name="connsiteX15" fmla="*/ 9877 w 10904"/>
                <a:gd name="connsiteY15" fmla="*/ 2911 h 11138"/>
                <a:gd name="connsiteX0" fmla="*/ 9877 w 10904"/>
                <a:gd name="connsiteY0" fmla="*/ 1841 h 10068"/>
                <a:gd name="connsiteX1" fmla="*/ 6488 w 10904"/>
                <a:gd name="connsiteY1" fmla="*/ 119 h 10068"/>
                <a:gd name="connsiteX2" fmla="*/ 5628 w 10904"/>
                <a:gd name="connsiteY2" fmla="*/ 192 h 10068"/>
                <a:gd name="connsiteX3" fmla="*/ 3555 w 10904"/>
                <a:gd name="connsiteY3" fmla="*/ 531 h 10068"/>
                <a:gd name="connsiteX4" fmla="*/ 984 w 10904"/>
                <a:gd name="connsiteY4" fmla="*/ 1547 h 10068"/>
                <a:gd name="connsiteX5" fmla="*/ 516 w 10904"/>
                <a:gd name="connsiteY5" fmla="*/ 7948 h 10068"/>
                <a:gd name="connsiteX6" fmla="*/ 1676 w 10904"/>
                <a:gd name="connsiteY6" fmla="*/ 9447 h 10068"/>
                <a:gd name="connsiteX7" fmla="*/ 3412 w 10904"/>
                <a:gd name="connsiteY7" fmla="*/ 10035 h 10068"/>
                <a:gd name="connsiteX8" fmla="*/ 4731 w 10904"/>
                <a:gd name="connsiteY8" fmla="*/ 8954 h 10068"/>
                <a:gd name="connsiteX9" fmla="*/ 5399 w 10904"/>
                <a:gd name="connsiteY9" fmla="*/ 7828 h 10068"/>
                <a:gd name="connsiteX10" fmla="*/ 6106 w 10904"/>
                <a:gd name="connsiteY10" fmla="*/ 9760 h 10068"/>
                <a:gd name="connsiteX11" fmla="*/ 7847 w 10904"/>
                <a:gd name="connsiteY11" fmla="*/ 9872 h 10068"/>
                <a:gd name="connsiteX12" fmla="*/ 7926 w 10904"/>
                <a:gd name="connsiteY12" fmla="*/ 9849 h 10068"/>
                <a:gd name="connsiteX13" fmla="*/ 10249 w 10904"/>
                <a:gd name="connsiteY13" fmla="*/ 7897 h 10068"/>
                <a:gd name="connsiteX14" fmla="*/ 10894 w 10904"/>
                <a:gd name="connsiteY14" fmla="*/ 5452 h 10068"/>
                <a:gd name="connsiteX15" fmla="*/ 9877 w 10904"/>
                <a:gd name="connsiteY15" fmla="*/ 1841 h 10068"/>
                <a:gd name="connsiteX0" fmla="*/ 9877 w 10904"/>
                <a:gd name="connsiteY0" fmla="*/ 1841 h 10068"/>
                <a:gd name="connsiteX1" fmla="*/ 6488 w 10904"/>
                <a:gd name="connsiteY1" fmla="*/ 119 h 10068"/>
                <a:gd name="connsiteX2" fmla="*/ 5628 w 10904"/>
                <a:gd name="connsiteY2" fmla="*/ 192 h 10068"/>
                <a:gd name="connsiteX3" fmla="*/ 3555 w 10904"/>
                <a:gd name="connsiteY3" fmla="*/ 531 h 10068"/>
                <a:gd name="connsiteX4" fmla="*/ 984 w 10904"/>
                <a:gd name="connsiteY4" fmla="*/ 1547 h 10068"/>
                <a:gd name="connsiteX5" fmla="*/ 516 w 10904"/>
                <a:gd name="connsiteY5" fmla="*/ 7948 h 10068"/>
                <a:gd name="connsiteX6" fmla="*/ 1676 w 10904"/>
                <a:gd name="connsiteY6" fmla="*/ 9447 h 10068"/>
                <a:gd name="connsiteX7" fmla="*/ 3412 w 10904"/>
                <a:gd name="connsiteY7" fmla="*/ 10035 h 10068"/>
                <a:gd name="connsiteX8" fmla="*/ 4731 w 10904"/>
                <a:gd name="connsiteY8" fmla="*/ 8954 h 10068"/>
                <a:gd name="connsiteX9" fmla="*/ 5399 w 10904"/>
                <a:gd name="connsiteY9" fmla="*/ 7828 h 10068"/>
                <a:gd name="connsiteX10" fmla="*/ 6106 w 10904"/>
                <a:gd name="connsiteY10" fmla="*/ 9760 h 10068"/>
                <a:gd name="connsiteX11" fmla="*/ 7847 w 10904"/>
                <a:gd name="connsiteY11" fmla="*/ 9872 h 10068"/>
                <a:gd name="connsiteX12" fmla="*/ 7926 w 10904"/>
                <a:gd name="connsiteY12" fmla="*/ 9849 h 10068"/>
                <a:gd name="connsiteX13" fmla="*/ 10249 w 10904"/>
                <a:gd name="connsiteY13" fmla="*/ 7897 h 10068"/>
                <a:gd name="connsiteX14" fmla="*/ 10894 w 10904"/>
                <a:gd name="connsiteY14" fmla="*/ 5452 h 10068"/>
                <a:gd name="connsiteX15" fmla="*/ 9877 w 10904"/>
                <a:gd name="connsiteY15" fmla="*/ 1841 h 10068"/>
                <a:gd name="connsiteX0" fmla="*/ 9877 w 10904"/>
                <a:gd name="connsiteY0" fmla="*/ 1774 h 10001"/>
                <a:gd name="connsiteX1" fmla="*/ 6488 w 10904"/>
                <a:gd name="connsiteY1" fmla="*/ 52 h 10001"/>
                <a:gd name="connsiteX2" fmla="*/ 5589 w 10904"/>
                <a:gd name="connsiteY2" fmla="*/ 453 h 10001"/>
                <a:gd name="connsiteX3" fmla="*/ 3555 w 10904"/>
                <a:gd name="connsiteY3" fmla="*/ 464 h 10001"/>
                <a:gd name="connsiteX4" fmla="*/ 984 w 10904"/>
                <a:gd name="connsiteY4" fmla="*/ 1480 h 10001"/>
                <a:gd name="connsiteX5" fmla="*/ 516 w 10904"/>
                <a:gd name="connsiteY5" fmla="*/ 7881 h 10001"/>
                <a:gd name="connsiteX6" fmla="*/ 1676 w 10904"/>
                <a:gd name="connsiteY6" fmla="*/ 9380 h 10001"/>
                <a:gd name="connsiteX7" fmla="*/ 3412 w 10904"/>
                <a:gd name="connsiteY7" fmla="*/ 9968 h 10001"/>
                <a:gd name="connsiteX8" fmla="*/ 4731 w 10904"/>
                <a:gd name="connsiteY8" fmla="*/ 8887 h 10001"/>
                <a:gd name="connsiteX9" fmla="*/ 5399 w 10904"/>
                <a:gd name="connsiteY9" fmla="*/ 7761 h 10001"/>
                <a:gd name="connsiteX10" fmla="*/ 6106 w 10904"/>
                <a:gd name="connsiteY10" fmla="*/ 9693 h 10001"/>
                <a:gd name="connsiteX11" fmla="*/ 7847 w 10904"/>
                <a:gd name="connsiteY11" fmla="*/ 9805 h 10001"/>
                <a:gd name="connsiteX12" fmla="*/ 7926 w 10904"/>
                <a:gd name="connsiteY12" fmla="*/ 9782 h 10001"/>
                <a:gd name="connsiteX13" fmla="*/ 10249 w 10904"/>
                <a:gd name="connsiteY13" fmla="*/ 7830 h 10001"/>
                <a:gd name="connsiteX14" fmla="*/ 10894 w 10904"/>
                <a:gd name="connsiteY14" fmla="*/ 5385 h 10001"/>
                <a:gd name="connsiteX15" fmla="*/ 9877 w 10904"/>
                <a:gd name="connsiteY15" fmla="*/ 1774 h 10001"/>
                <a:gd name="connsiteX0" fmla="*/ 9877 w 10904"/>
                <a:gd name="connsiteY0" fmla="*/ 1746 h 9973"/>
                <a:gd name="connsiteX1" fmla="*/ 6488 w 10904"/>
                <a:gd name="connsiteY1" fmla="*/ 24 h 9973"/>
                <a:gd name="connsiteX2" fmla="*/ 5567 w 10904"/>
                <a:gd name="connsiteY2" fmla="*/ 733 h 9973"/>
                <a:gd name="connsiteX3" fmla="*/ 3555 w 10904"/>
                <a:gd name="connsiteY3" fmla="*/ 436 h 9973"/>
                <a:gd name="connsiteX4" fmla="*/ 984 w 10904"/>
                <a:gd name="connsiteY4" fmla="*/ 1452 h 9973"/>
                <a:gd name="connsiteX5" fmla="*/ 516 w 10904"/>
                <a:gd name="connsiteY5" fmla="*/ 7853 h 9973"/>
                <a:gd name="connsiteX6" fmla="*/ 1676 w 10904"/>
                <a:gd name="connsiteY6" fmla="*/ 9352 h 9973"/>
                <a:gd name="connsiteX7" fmla="*/ 3412 w 10904"/>
                <a:gd name="connsiteY7" fmla="*/ 9940 h 9973"/>
                <a:gd name="connsiteX8" fmla="*/ 4731 w 10904"/>
                <a:gd name="connsiteY8" fmla="*/ 8859 h 9973"/>
                <a:gd name="connsiteX9" fmla="*/ 5399 w 10904"/>
                <a:gd name="connsiteY9" fmla="*/ 7733 h 9973"/>
                <a:gd name="connsiteX10" fmla="*/ 6106 w 10904"/>
                <a:gd name="connsiteY10" fmla="*/ 9665 h 9973"/>
                <a:gd name="connsiteX11" fmla="*/ 7847 w 10904"/>
                <a:gd name="connsiteY11" fmla="*/ 9777 h 9973"/>
                <a:gd name="connsiteX12" fmla="*/ 7926 w 10904"/>
                <a:gd name="connsiteY12" fmla="*/ 9754 h 9973"/>
                <a:gd name="connsiteX13" fmla="*/ 10249 w 10904"/>
                <a:gd name="connsiteY13" fmla="*/ 7802 h 9973"/>
                <a:gd name="connsiteX14" fmla="*/ 10894 w 10904"/>
                <a:gd name="connsiteY14" fmla="*/ 5357 h 9973"/>
                <a:gd name="connsiteX15" fmla="*/ 9877 w 10904"/>
                <a:gd name="connsiteY15" fmla="*/ 1746 h 9973"/>
                <a:gd name="connsiteX0" fmla="*/ 9058 w 10000"/>
                <a:gd name="connsiteY0" fmla="*/ 1797 h 10046"/>
                <a:gd name="connsiteX1" fmla="*/ 5950 w 10000"/>
                <a:gd name="connsiteY1" fmla="*/ 70 h 10046"/>
                <a:gd name="connsiteX2" fmla="*/ 5031 w 10000"/>
                <a:gd name="connsiteY2" fmla="*/ 346 h 10046"/>
                <a:gd name="connsiteX3" fmla="*/ 3260 w 10000"/>
                <a:gd name="connsiteY3" fmla="*/ 483 h 10046"/>
                <a:gd name="connsiteX4" fmla="*/ 902 w 10000"/>
                <a:gd name="connsiteY4" fmla="*/ 1502 h 10046"/>
                <a:gd name="connsiteX5" fmla="*/ 473 w 10000"/>
                <a:gd name="connsiteY5" fmla="*/ 7920 h 10046"/>
                <a:gd name="connsiteX6" fmla="*/ 1537 w 10000"/>
                <a:gd name="connsiteY6" fmla="*/ 9423 h 10046"/>
                <a:gd name="connsiteX7" fmla="*/ 3129 w 10000"/>
                <a:gd name="connsiteY7" fmla="*/ 10013 h 10046"/>
                <a:gd name="connsiteX8" fmla="*/ 4339 w 10000"/>
                <a:gd name="connsiteY8" fmla="*/ 8929 h 10046"/>
                <a:gd name="connsiteX9" fmla="*/ 4951 w 10000"/>
                <a:gd name="connsiteY9" fmla="*/ 7800 h 10046"/>
                <a:gd name="connsiteX10" fmla="*/ 5600 w 10000"/>
                <a:gd name="connsiteY10" fmla="*/ 9737 h 10046"/>
                <a:gd name="connsiteX11" fmla="*/ 7196 w 10000"/>
                <a:gd name="connsiteY11" fmla="*/ 9849 h 10046"/>
                <a:gd name="connsiteX12" fmla="*/ 7269 w 10000"/>
                <a:gd name="connsiteY12" fmla="*/ 9826 h 10046"/>
                <a:gd name="connsiteX13" fmla="*/ 9399 w 10000"/>
                <a:gd name="connsiteY13" fmla="*/ 7869 h 10046"/>
                <a:gd name="connsiteX14" fmla="*/ 9991 w 10000"/>
                <a:gd name="connsiteY14" fmla="*/ 5418 h 10046"/>
                <a:gd name="connsiteX15" fmla="*/ 9058 w 10000"/>
                <a:gd name="connsiteY15" fmla="*/ 1797 h 10046"/>
                <a:gd name="connsiteX0" fmla="*/ 9058 w 10000"/>
                <a:gd name="connsiteY0" fmla="*/ 2032 h 10281"/>
                <a:gd name="connsiteX1" fmla="*/ 5950 w 10000"/>
                <a:gd name="connsiteY1" fmla="*/ 305 h 10281"/>
                <a:gd name="connsiteX2" fmla="*/ 5110 w 10000"/>
                <a:gd name="connsiteY2" fmla="*/ 35 h 10281"/>
                <a:gd name="connsiteX3" fmla="*/ 3260 w 10000"/>
                <a:gd name="connsiteY3" fmla="*/ 718 h 10281"/>
                <a:gd name="connsiteX4" fmla="*/ 902 w 10000"/>
                <a:gd name="connsiteY4" fmla="*/ 1737 h 10281"/>
                <a:gd name="connsiteX5" fmla="*/ 473 w 10000"/>
                <a:gd name="connsiteY5" fmla="*/ 8155 h 10281"/>
                <a:gd name="connsiteX6" fmla="*/ 1537 w 10000"/>
                <a:gd name="connsiteY6" fmla="*/ 9658 h 10281"/>
                <a:gd name="connsiteX7" fmla="*/ 3129 w 10000"/>
                <a:gd name="connsiteY7" fmla="*/ 10248 h 10281"/>
                <a:gd name="connsiteX8" fmla="*/ 4339 w 10000"/>
                <a:gd name="connsiteY8" fmla="*/ 9164 h 10281"/>
                <a:gd name="connsiteX9" fmla="*/ 4951 w 10000"/>
                <a:gd name="connsiteY9" fmla="*/ 8035 h 10281"/>
                <a:gd name="connsiteX10" fmla="*/ 5600 w 10000"/>
                <a:gd name="connsiteY10" fmla="*/ 9972 h 10281"/>
                <a:gd name="connsiteX11" fmla="*/ 7196 w 10000"/>
                <a:gd name="connsiteY11" fmla="*/ 10084 h 10281"/>
                <a:gd name="connsiteX12" fmla="*/ 7269 w 10000"/>
                <a:gd name="connsiteY12" fmla="*/ 10061 h 10281"/>
                <a:gd name="connsiteX13" fmla="*/ 9399 w 10000"/>
                <a:gd name="connsiteY13" fmla="*/ 8104 h 10281"/>
                <a:gd name="connsiteX14" fmla="*/ 9991 w 10000"/>
                <a:gd name="connsiteY14" fmla="*/ 5653 h 10281"/>
                <a:gd name="connsiteX15" fmla="*/ 9058 w 10000"/>
                <a:gd name="connsiteY15" fmla="*/ 2032 h 10281"/>
                <a:gd name="connsiteX0" fmla="*/ 9058 w 10000"/>
                <a:gd name="connsiteY0" fmla="*/ 2003 h 10252"/>
                <a:gd name="connsiteX1" fmla="*/ 5950 w 10000"/>
                <a:gd name="connsiteY1" fmla="*/ 276 h 10252"/>
                <a:gd name="connsiteX2" fmla="*/ 5110 w 10000"/>
                <a:gd name="connsiteY2" fmla="*/ 6 h 10252"/>
                <a:gd name="connsiteX3" fmla="*/ 3359 w 10000"/>
                <a:gd name="connsiteY3" fmla="*/ 280 h 10252"/>
                <a:gd name="connsiteX4" fmla="*/ 902 w 10000"/>
                <a:gd name="connsiteY4" fmla="*/ 1708 h 10252"/>
                <a:gd name="connsiteX5" fmla="*/ 473 w 10000"/>
                <a:gd name="connsiteY5" fmla="*/ 8126 h 10252"/>
                <a:gd name="connsiteX6" fmla="*/ 1537 w 10000"/>
                <a:gd name="connsiteY6" fmla="*/ 9629 h 10252"/>
                <a:gd name="connsiteX7" fmla="*/ 3129 w 10000"/>
                <a:gd name="connsiteY7" fmla="*/ 10219 h 10252"/>
                <a:gd name="connsiteX8" fmla="*/ 4339 w 10000"/>
                <a:gd name="connsiteY8" fmla="*/ 9135 h 10252"/>
                <a:gd name="connsiteX9" fmla="*/ 4951 w 10000"/>
                <a:gd name="connsiteY9" fmla="*/ 8006 h 10252"/>
                <a:gd name="connsiteX10" fmla="*/ 5600 w 10000"/>
                <a:gd name="connsiteY10" fmla="*/ 9943 h 10252"/>
                <a:gd name="connsiteX11" fmla="*/ 7196 w 10000"/>
                <a:gd name="connsiteY11" fmla="*/ 10055 h 10252"/>
                <a:gd name="connsiteX12" fmla="*/ 7269 w 10000"/>
                <a:gd name="connsiteY12" fmla="*/ 10032 h 10252"/>
                <a:gd name="connsiteX13" fmla="*/ 9399 w 10000"/>
                <a:gd name="connsiteY13" fmla="*/ 8075 h 10252"/>
                <a:gd name="connsiteX14" fmla="*/ 9991 w 10000"/>
                <a:gd name="connsiteY14" fmla="*/ 5624 h 10252"/>
                <a:gd name="connsiteX15" fmla="*/ 9058 w 10000"/>
                <a:gd name="connsiteY15" fmla="*/ 2003 h 10252"/>
                <a:gd name="connsiteX0" fmla="*/ 9058 w 10000"/>
                <a:gd name="connsiteY0" fmla="*/ 2017 h 10266"/>
                <a:gd name="connsiteX1" fmla="*/ 5950 w 10000"/>
                <a:gd name="connsiteY1" fmla="*/ 290 h 10266"/>
                <a:gd name="connsiteX2" fmla="*/ 5110 w 10000"/>
                <a:gd name="connsiteY2" fmla="*/ 20 h 10266"/>
                <a:gd name="connsiteX3" fmla="*/ 3345 w 10000"/>
                <a:gd name="connsiteY3" fmla="*/ 515 h 10266"/>
                <a:gd name="connsiteX4" fmla="*/ 902 w 10000"/>
                <a:gd name="connsiteY4" fmla="*/ 1722 h 10266"/>
                <a:gd name="connsiteX5" fmla="*/ 473 w 10000"/>
                <a:gd name="connsiteY5" fmla="*/ 8140 h 10266"/>
                <a:gd name="connsiteX6" fmla="*/ 1537 w 10000"/>
                <a:gd name="connsiteY6" fmla="*/ 9643 h 10266"/>
                <a:gd name="connsiteX7" fmla="*/ 3129 w 10000"/>
                <a:gd name="connsiteY7" fmla="*/ 10233 h 10266"/>
                <a:gd name="connsiteX8" fmla="*/ 4339 w 10000"/>
                <a:gd name="connsiteY8" fmla="*/ 9149 h 10266"/>
                <a:gd name="connsiteX9" fmla="*/ 4951 w 10000"/>
                <a:gd name="connsiteY9" fmla="*/ 8020 h 10266"/>
                <a:gd name="connsiteX10" fmla="*/ 5600 w 10000"/>
                <a:gd name="connsiteY10" fmla="*/ 9957 h 10266"/>
                <a:gd name="connsiteX11" fmla="*/ 7196 w 10000"/>
                <a:gd name="connsiteY11" fmla="*/ 10069 h 10266"/>
                <a:gd name="connsiteX12" fmla="*/ 7269 w 10000"/>
                <a:gd name="connsiteY12" fmla="*/ 10046 h 10266"/>
                <a:gd name="connsiteX13" fmla="*/ 9399 w 10000"/>
                <a:gd name="connsiteY13" fmla="*/ 8089 h 10266"/>
                <a:gd name="connsiteX14" fmla="*/ 9991 w 10000"/>
                <a:gd name="connsiteY14" fmla="*/ 5638 h 10266"/>
                <a:gd name="connsiteX15" fmla="*/ 9058 w 10000"/>
                <a:gd name="connsiteY15" fmla="*/ 2017 h 10266"/>
                <a:gd name="connsiteX0" fmla="*/ 9058 w 10000"/>
                <a:gd name="connsiteY0" fmla="*/ 2017 h 10266"/>
                <a:gd name="connsiteX1" fmla="*/ 5950 w 10000"/>
                <a:gd name="connsiteY1" fmla="*/ 290 h 10266"/>
                <a:gd name="connsiteX2" fmla="*/ 5110 w 10000"/>
                <a:gd name="connsiteY2" fmla="*/ 20 h 10266"/>
                <a:gd name="connsiteX3" fmla="*/ 3345 w 10000"/>
                <a:gd name="connsiteY3" fmla="*/ 515 h 10266"/>
                <a:gd name="connsiteX4" fmla="*/ 902 w 10000"/>
                <a:gd name="connsiteY4" fmla="*/ 1722 h 10266"/>
                <a:gd name="connsiteX5" fmla="*/ 473 w 10000"/>
                <a:gd name="connsiteY5" fmla="*/ 8140 h 10266"/>
                <a:gd name="connsiteX6" fmla="*/ 1537 w 10000"/>
                <a:gd name="connsiteY6" fmla="*/ 9643 h 10266"/>
                <a:gd name="connsiteX7" fmla="*/ 3129 w 10000"/>
                <a:gd name="connsiteY7" fmla="*/ 10233 h 10266"/>
                <a:gd name="connsiteX8" fmla="*/ 4339 w 10000"/>
                <a:gd name="connsiteY8" fmla="*/ 9149 h 10266"/>
                <a:gd name="connsiteX9" fmla="*/ 4951 w 10000"/>
                <a:gd name="connsiteY9" fmla="*/ 8020 h 10266"/>
                <a:gd name="connsiteX10" fmla="*/ 5600 w 10000"/>
                <a:gd name="connsiteY10" fmla="*/ 9957 h 10266"/>
                <a:gd name="connsiteX11" fmla="*/ 7196 w 10000"/>
                <a:gd name="connsiteY11" fmla="*/ 10069 h 10266"/>
                <a:gd name="connsiteX12" fmla="*/ 7269 w 10000"/>
                <a:gd name="connsiteY12" fmla="*/ 10046 h 10266"/>
                <a:gd name="connsiteX13" fmla="*/ 9399 w 10000"/>
                <a:gd name="connsiteY13" fmla="*/ 8089 h 10266"/>
                <a:gd name="connsiteX14" fmla="*/ 9991 w 10000"/>
                <a:gd name="connsiteY14" fmla="*/ 5638 h 10266"/>
                <a:gd name="connsiteX15" fmla="*/ 9058 w 10000"/>
                <a:gd name="connsiteY15" fmla="*/ 2017 h 10266"/>
                <a:gd name="connsiteX0" fmla="*/ 9058 w 10000"/>
                <a:gd name="connsiteY0" fmla="*/ 2018 h 10267"/>
                <a:gd name="connsiteX1" fmla="*/ 5950 w 10000"/>
                <a:gd name="connsiteY1" fmla="*/ 291 h 10267"/>
                <a:gd name="connsiteX2" fmla="*/ 4658 w 10000"/>
                <a:gd name="connsiteY2" fmla="*/ 20 h 10267"/>
                <a:gd name="connsiteX3" fmla="*/ 3345 w 10000"/>
                <a:gd name="connsiteY3" fmla="*/ 516 h 10267"/>
                <a:gd name="connsiteX4" fmla="*/ 902 w 10000"/>
                <a:gd name="connsiteY4" fmla="*/ 1723 h 10267"/>
                <a:gd name="connsiteX5" fmla="*/ 473 w 10000"/>
                <a:gd name="connsiteY5" fmla="*/ 8141 h 10267"/>
                <a:gd name="connsiteX6" fmla="*/ 1537 w 10000"/>
                <a:gd name="connsiteY6" fmla="*/ 9644 h 10267"/>
                <a:gd name="connsiteX7" fmla="*/ 3129 w 10000"/>
                <a:gd name="connsiteY7" fmla="*/ 10234 h 10267"/>
                <a:gd name="connsiteX8" fmla="*/ 4339 w 10000"/>
                <a:gd name="connsiteY8" fmla="*/ 9150 h 10267"/>
                <a:gd name="connsiteX9" fmla="*/ 4951 w 10000"/>
                <a:gd name="connsiteY9" fmla="*/ 8021 h 10267"/>
                <a:gd name="connsiteX10" fmla="*/ 5600 w 10000"/>
                <a:gd name="connsiteY10" fmla="*/ 9958 h 10267"/>
                <a:gd name="connsiteX11" fmla="*/ 7196 w 10000"/>
                <a:gd name="connsiteY11" fmla="*/ 10070 h 10267"/>
                <a:gd name="connsiteX12" fmla="*/ 7269 w 10000"/>
                <a:gd name="connsiteY12" fmla="*/ 10047 h 10267"/>
                <a:gd name="connsiteX13" fmla="*/ 9399 w 10000"/>
                <a:gd name="connsiteY13" fmla="*/ 8090 h 10267"/>
                <a:gd name="connsiteX14" fmla="*/ 9991 w 10000"/>
                <a:gd name="connsiteY14" fmla="*/ 5639 h 10267"/>
                <a:gd name="connsiteX15" fmla="*/ 9058 w 10000"/>
                <a:gd name="connsiteY15" fmla="*/ 2018 h 10267"/>
                <a:gd name="connsiteX0" fmla="*/ 9058 w 10000"/>
                <a:gd name="connsiteY0" fmla="*/ 1834 h 10083"/>
                <a:gd name="connsiteX1" fmla="*/ 5950 w 10000"/>
                <a:gd name="connsiteY1" fmla="*/ 107 h 10083"/>
                <a:gd name="connsiteX2" fmla="*/ 3345 w 10000"/>
                <a:gd name="connsiteY2" fmla="*/ 332 h 10083"/>
                <a:gd name="connsiteX3" fmla="*/ 902 w 10000"/>
                <a:gd name="connsiteY3" fmla="*/ 1539 h 10083"/>
                <a:gd name="connsiteX4" fmla="*/ 473 w 10000"/>
                <a:gd name="connsiteY4" fmla="*/ 7957 h 10083"/>
                <a:gd name="connsiteX5" fmla="*/ 1537 w 10000"/>
                <a:gd name="connsiteY5" fmla="*/ 9460 h 10083"/>
                <a:gd name="connsiteX6" fmla="*/ 3129 w 10000"/>
                <a:gd name="connsiteY6" fmla="*/ 10050 h 10083"/>
                <a:gd name="connsiteX7" fmla="*/ 4339 w 10000"/>
                <a:gd name="connsiteY7" fmla="*/ 8966 h 10083"/>
                <a:gd name="connsiteX8" fmla="*/ 4951 w 10000"/>
                <a:gd name="connsiteY8" fmla="*/ 7837 h 10083"/>
                <a:gd name="connsiteX9" fmla="*/ 5600 w 10000"/>
                <a:gd name="connsiteY9" fmla="*/ 9774 h 10083"/>
                <a:gd name="connsiteX10" fmla="*/ 7196 w 10000"/>
                <a:gd name="connsiteY10" fmla="*/ 9886 h 10083"/>
                <a:gd name="connsiteX11" fmla="*/ 7269 w 10000"/>
                <a:gd name="connsiteY11" fmla="*/ 9863 h 10083"/>
                <a:gd name="connsiteX12" fmla="*/ 9399 w 10000"/>
                <a:gd name="connsiteY12" fmla="*/ 7906 h 10083"/>
                <a:gd name="connsiteX13" fmla="*/ 9991 w 10000"/>
                <a:gd name="connsiteY13" fmla="*/ 5455 h 10083"/>
                <a:gd name="connsiteX14" fmla="*/ 9058 w 10000"/>
                <a:gd name="connsiteY14" fmla="*/ 1834 h 10083"/>
                <a:gd name="connsiteX0" fmla="*/ 9287 w 9992"/>
                <a:gd name="connsiteY0" fmla="*/ 1656 h 10071"/>
                <a:gd name="connsiteX1" fmla="*/ 5950 w 9992"/>
                <a:gd name="connsiteY1" fmla="*/ 95 h 10071"/>
                <a:gd name="connsiteX2" fmla="*/ 3345 w 9992"/>
                <a:gd name="connsiteY2" fmla="*/ 320 h 10071"/>
                <a:gd name="connsiteX3" fmla="*/ 902 w 9992"/>
                <a:gd name="connsiteY3" fmla="*/ 1527 h 10071"/>
                <a:gd name="connsiteX4" fmla="*/ 473 w 9992"/>
                <a:gd name="connsiteY4" fmla="*/ 7945 h 10071"/>
                <a:gd name="connsiteX5" fmla="*/ 1537 w 9992"/>
                <a:gd name="connsiteY5" fmla="*/ 9448 h 10071"/>
                <a:gd name="connsiteX6" fmla="*/ 3129 w 9992"/>
                <a:gd name="connsiteY6" fmla="*/ 10038 h 10071"/>
                <a:gd name="connsiteX7" fmla="*/ 4339 w 9992"/>
                <a:gd name="connsiteY7" fmla="*/ 8954 h 10071"/>
                <a:gd name="connsiteX8" fmla="*/ 4951 w 9992"/>
                <a:gd name="connsiteY8" fmla="*/ 7825 h 10071"/>
                <a:gd name="connsiteX9" fmla="*/ 5600 w 9992"/>
                <a:gd name="connsiteY9" fmla="*/ 9762 h 10071"/>
                <a:gd name="connsiteX10" fmla="*/ 7196 w 9992"/>
                <a:gd name="connsiteY10" fmla="*/ 9874 h 10071"/>
                <a:gd name="connsiteX11" fmla="*/ 7269 w 9992"/>
                <a:gd name="connsiteY11" fmla="*/ 9851 h 10071"/>
                <a:gd name="connsiteX12" fmla="*/ 9399 w 9992"/>
                <a:gd name="connsiteY12" fmla="*/ 7894 h 10071"/>
                <a:gd name="connsiteX13" fmla="*/ 9991 w 9992"/>
                <a:gd name="connsiteY13" fmla="*/ 5443 h 10071"/>
                <a:gd name="connsiteX14" fmla="*/ 9287 w 9992"/>
                <a:gd name="connsiteY14" fmla="*/ 1656 h 10071"/>
                <a:gd name="connsiteX0" fmla="*/ 9294 w 10000"/>
                <a:gd name="connsiteY0" fmla="*/ 1644 h 10000"/>
                <a:gd name="connsiteX1" fmla="*/ 5955 w 10000"/>
                <a:gd name="connsiteY1" fmla="*/ 94 h 10000"/>
                <a:gd name="connsiteX2" fmla="*/ 3348 w 10000"/>
                <a:gd name="connsiteY2" fmla="*/ 318 h 10000"/>
                <a:gd name="connsiteX3" fmla="*/ 903 w 10000"/>
                <a:gd name="connsiteY3" fmla="*/ 1516 h 10000"/>
                <a:gd name="connsiteX4" fmla="*/ 473 w 10000"/>
                <a:gd name="connsiteY4" fmla="*/ 7889 h 10000"/>
                <a:gd name="connsiteX5" fmla="*/ 1538 w 10000"/>
                <a:gd name="connsiteY5" fmla="*/ 9381 h 10000"/>
                <a:gd name="connsiteX6" fmla="*/ 3132 w 10000"/>
                <a:gd name="connsiteY6" fmla="*/ 9967 h 10000"/>
                <a:gd name="connsiteX7" fmla="*/ 4342 w 10000"/>
                <a:gd name="connsiteY7" fmla="*/ 8891 h 10000"/>
                <a:gd name="connsiteX8" fmla="*/ 4955 w 10000"/>
                <a:gd name="connsiteY8" fmla="*/ 7770 h 10000"/>
                <a:gd name="connsiteX9" fmla="*/ 5604 w 10000"/>
                <a:gd name="connsiteY9" fmla="*/ 9693 h 10000"/>
                <a:gd name="connsiteX10" fmla="*/ 7202 w 10000"/>
                <a:gd name="connsiteY10" fmla="*/ 9804 h 10000"/>
                <a:gd name="connsiteX11" fmla="*/ 7275 w 10000"/>
                <a:gd name="connsiteY11" fmla="*/ 9782 h 10000"/>
                <a:gd name="connsiteX12" fmla="*/ 9407 w 10000"/>
                <a:gd name="connsiteY12" fmla="*/ 7838 h 10000"/>
                <a:gd name="connsiteX13" fmla="*/ 9999 w 10000"/>
                <a:gd name="connsiteY13" fmla="*/ 5405 h 10000"/>
                <a:gd name="connsiteX14" fmla="*/ 9294 w 10000"/>
                <a:gd name="connsiteY14" fmla="*/ 1644 h 10000"/>
                <a:gd name="connsiteX0" fmla="*/ 9294 w 10000"/>
                <a:gd name="connsiteY0" fmla="*/ 1644 h 10000"/>
                <a:gd name="connsiteX1" fmla="*/ 5955 w 10000"/>
                <a:gd name="connsiteY1" fmla="*/ 94 h 10000"/>
                <a:gd name="connsiteX2" fmla="*/ 3348 w 10000"/>
                <a:gd name="connsiteY2" fmla="*/ 318 h 10000"/>
                <a:gd name="connsiteX3" fmla="*/ 903 w 10000"/>
                <a:gd name="connsiteY3" fmla="*/ 1516 h 10000"/>
                <a:gd name="connsiteX4" fmla="*/ 473 w 10000"/>
                <a:gd name="connsiteY4" fmla="*/ 7889 h 10000"/>
                <a:gd name="connsiteX5" fmla="*/ 1538 w 10000"/>
                <a:gd name="connsiteY5" fmla="*/ 9381 h 10000"/>
                <a:gd name="connsiteX6" fmla="*/ 3132 w 10000"/>
                <a:gd name="connsiteY6" fmla="*/ 9967 h 10000"/>
                <a:gd name="connsiteX7" fmla="*/ 4342 w 10000"/>
                <a:gd name="connsiteY7" fmla="*/ 8891 h 10000"/>
                <a:gd name="connsiteX8" fmla="*/ 4955 w 10000"/>
                <a:gd name="connsiteY8" fmla="*/ 7770 h 10000"/>
                <a:gd name="connsiteX9" fmla="*/ 5604 w 10000"/>
                <a:gd name="connsiteY9" fmla="*/ 9693 h 10000"/>
                <a:gd name="connsiteX10" fmla="*/ 7202 w 10000"/>
                <a:gd name="connsiteY10" fmla="*/ 9804 h 10000"/>
                <a:gd name="connsiteX11" fmla="*/ 7275 w 10000"/>
                <a:gd name="connsiteY11" fmla="*/ 9782 h 10000"/>
                <a:gd name="connsiteX12" fmla="*/ 9407 w 10000"/>
                <a:gd name="connsiteY12" fmla="*/ 7838 h 10000"/>
                <a:gd name="connsiteX13" fmla="*/ 9999 w 10000"/>
                <a:gd name="connsiteY13" fmla="*/ 5405 h 10000"/>
                <a:gd name="connsiteX14" fmla="*/ 9294 w 10000"/>
                <a:gd name="connsiteY14" fmla="*/ 1644 h 10000"/>
                <a:gd name="connsiteX0" fmla="*/ 9294 w 10000"/>
                <a:gd name="connsiteY0" fmla="*/ 1598 h 9954"/>
                <a:gd name="connsiteX1" fmla="*/ 5955 w 10000"/>
                <a:gd name="connsiteY1" fmla="*/ 48 h 9954"/>
                <a:gd name="connsiteX2" fmla="*/ 3348 w 10000"/>
                <a:gd name="connsiteY2" fmla="*/ 272 h 9954"/>
                <a:gd name="connsiteX3" fmla="*/ 903 w 10000"/>
                <a:gd name="connsiteY3" fmla="*/ 1470 h 9954"/>
                <a:gd name="connsiteX4" fmla="*/ 473 w 10000"/>
                <a:gd name="connsiteY4" fmla="*/ 7843 h 9954"/>
                <a:gd name="connsiteX5" fmla="*/ 1538 w 10000"/>
                <a:gd name="connsiteY5" fmla="*/ 9335 h 9954"/>
                <a:gd name="connsiteX6" fmla="*/ 3132 w 10000"/>
                <a:gd name="connsiteY6" fmla="*/ 9921 h 9954"/>
                <a:gd name="connsiteX7" fmla="*/ 4342 w 10000"/>
                <a:gd name="connsiteY7" fmla="*/ 8845 h 9954"/>
                <a:gd name="connsiteX8" fmla="*/ 4955 w 10000"/>
                <a:gd name="connsiteY8" fmla="*/ 7724 h 9954"/>
                <a:gd name="connsiteX9" fmla="*/ 5604 w 10000"/>
                <a:gd name="connsiteY9" fmla="*/ 9647 h 9954"/>
                <a:gd name="connsiteX10" fmla="*/ 7202 w 10000"/>
                <a:gd name="connsiteY10" fmla="*/ 9758 h 9954"/>
                <a:gd name="connsiteX11" fmla="*/ 7275 w 10000"/>
                <a:gd name="connsiteY11" fmla="*/ 9736 h 9954"/>
                <a:gd name="connsiteX12" fmla="*/ 9407 w 10000"/>
                <a:gd name="connsiteY12" fmla="*/ 7792 h 9954"/>
                <a:gd name="connsiteX13" fmla="*/ 9999 w 10000"/>
                <a:gd name="connsiteY13" fmla="*/ 5359 h 9954"/>
                <a:gd name="connsiteX14" fmla="*/ 9294 w 10000"/>
                <a:gd name="connsiteY14" fmla="*/ 1598 h 9954"/>
                <a:gd name="connsiteX0" fmla="*/ 9294 w 10000"/>
                <a:gd name="connsiteY0" fmla="*/ 1568 h 9963"/>
                <a:gd name="connsiteX1" fmla="*/ 5821 w 10000"/>
                <a:gd name="connsiteY1" fmla="*/ 58 h 9963"/>
                <a:gd name="connsiteX2" fmla="*/ 3348 w 10000"/>
                <a:gd name="connsiteY2" fmla="*/ 236 h 9963"/>
                <a:gd name="connsiteX3" fmla="*/ 903 w 10000"/>
                <a:gd name="connsiteY3" fmla="*/ 1440 h 9963"/>
                <a:gd name="connsiteX4" fmla="*/ 473 w 10000"/>
                <a:gd name="connsiteY4" fmla="*/ 7842 h 9963"/>
                <a:gd name="connsiteX5" fmla="*/ 1538 w 10000"/>
                <a:gd name="connsiteY5" fmla="*/ 9341 h 9963"/>
                <a:gd name="connsiteX6" fmla="*/ 3132 w 10000"/>
                <a:gd name="connsiteY6" fmla="*/ 9930 h 9963"/>
                <a:gd name="connsiteX7" fmla="*/ 4342 w 10000"/>
                <a:gd name="connsiteY7" fmla="*/ 8849 h 9963"/>
                <a:gd name="connsiteX8" fmla="*/ 4955 w 10000"/>
                <a:gd name="connsiteY8" fmla="*/ 7723 h 9963"/>
                <a:gd name="connsiteX9" fmla="*/ 5604 w 10000"/>
                <a:gd name="connsiteY9" fmla="*/ 9655 h 9963"/>
                <a:gd name="connsiteX10" fmla="*/ 7202 w 10000"/>
                <a:gd name="connsiteY10" fmla="*/ 9766 h 9963"/>
                <a:gd name="connsiteX11" fmla="*/ 7275 w 10000"/>
                <a:gd name="connsiteY11" fmla="*/ 9744 h 9963"/>
                <a:gd name="connsiteX12" fmla="*/ 9407 w 10000"/>
                <a:gd name="connsiteY12" fmla="*/ 7791 h 9963"/>
                <a:gd name="connsiteX13" fmla="*/ 9999 w 10000"/>
                <a:gd name="connsiteY13" fmla="*/ 5347 h 9963"/>
                <a:gd name="connsiteX14" fmla="*/ 9294 w 10000"/>
                <a:gd name="connsiteY14" fmla="*/ 1568 h 9963"/>
                <a:gd name="connsiteX0" fmla="*/ 9294 w 10000"/>
                <a:gd name="connsiteY0" fmla="*/ 1561 h 9987"/>
                <a:gd name="connsiteX1" fmla="*/ 5821 w 10000"/>
                <a:gd name="connsiteY1" fmla="*/ 45 h 9987"/>
                <a:gd name="connsiteX2" fmla="*/ 3348 w 10000"/>
                <a:gd name="connsiteY2" fmla="*/ 224 h 9987"/>
                <a:gd name="connsiteX3" fmla="*/ 903 w 10000"/>
                <a:gd name="connsiteY3" fmla="*/ 1432 h 9987"/>
                <a:gd name="connsiteX4" fmla="*/ 473 w 10000"/>
                <a:gd name="connsiteY4" fmla="*/ 7858 h 9987"/>
                <a:gd name="connsiteX5" fmla="*/ 1538 w 10000"/>
                <a:gd name="connsiteY5" fmla="*/ 9363 h 9987"/>
                <a:gd name="connsiteX6" fmla="*/ 3132 w 10000"/>
                <a:gd name="connsiteY6" fmla="*/ 9954 h 9987"/>
                <a:gd name="connsiteX7" fmla="*/ 4342 w 10000"/>
                <a:gd name="connsiteY7" fmla="*/ 8869 h 9987"/>
                <a:gd name="connsiteX8" fmla="*/ 4955 w 10000"/>
                <a:gd name="connsiteY8" fmla="*/ 7739 h 9987"/>
                <a:gd name="connsiteX9" fmla="*/ 5604 w 10000"/>
                <a:gd name="connsiteY9" fmla="*/ 9678 h 9987"/>
                <a:gd name="connsiteX10" fmla="*/ 7202 w 10000"/>
                <a:gd name="connsiteY10" fmla="*/ 9789 h 9987"/>
                <a:gd name="connsiteX11" fmla="*/ 7275 w 10000"/>
                <a:gd name="connsiteY11" fmla="*/ 9767 h 9987"/>
                <a:gd name="connsiteX12" fmla="*/ 9407 w 10000"/>
                <a:gd name="connsiteY12" fmla="*/ 7807 h 9987"/>
                <a:gd name="connsiteX13" fmla="*/ 9999 w 10000"/>
                <a:gd name="connsiteY13" fmla="*/ 5354 h 9987"/>
                <a:gd name="connsiteX14" fmla="*/ 9294 w 10000"/>
                <a:gd name="connsiteY14" fmla="*/ 1561 h 9987"/>
                <a:gd name="connsiteX0" fmla="*/ 9294 w 10000"/>
                <a:gd name="connsiteY0" fmla="*/ 1563 h 10000"/>
                <a:gd name="connsiteX1" fmla="*/ 5821 w 10000"/>
                <a:gd name="connsiteY1" fmla="*/ 45 h 10000"/>
                <a:gd name="connsiteX2" fmla="*/ 3348 w 10000"/>
                <a:gd name="connsiteY2" fmla="*/ 224 h 10000"/>
                <a:gd name="connsiteX3" fmla="*/ 903 w 10000"/>
                <a:gd name="connsiteY3" fmla="*/ 1434 h 10000"/>
                <a:gd name="connsiteX4" fmla="*/ 473 w 10000"/>
                <a:gd name="connsiteY4" fmla="*/ 7868 h 10000"/>
                <a:gd name="connsiteX5" fmla="*/ 1538 w 10000"/>
                <a:gd name="connsiteY5" fmla="*/ 9375 h 10000"/>
                <a:gd name="connsiteX6" fmla="*/ 3132 w 10000"/>
                <a:gd name="connsiteY6" fmla="*/ 9967 h 10000"/>
                <a:gd name="connsiteX7" fmla="*/ 4342 w 10000"/>
                <a:gd name="connsiteY7" fmla="*/ 8881 h 10000"/>
                <a:gd name="connsiteX8" fmla="*/ 4955 w 10000"/>
                <a:gd name="connsiteY8" fmla="*/ 7749 h 10000"/>
                <a:gd name="connsiteX9" fmla="*/ 5604 w 10000"/>
                <a:gd name="connsiteY9" fmla="*/ 9691 h 10000"/>
                <a:gd name="connsiteX10" fmla="*/ 7202 w 10000"/>
                <a:gd name="connsiteY10" fmla="*/ 9802 h 10000"/>
                <a:gd name="connsiteX11" fmla="*/ 7275 w 10000"/>
                <a:gd name="connsiteY11" fmla="*/ 9780 h 10000"/>
                <a:gd name="connsiteX12" fmla="*/ 9407 w 10000"/>
                <a:gd name="connsiteY12" fmla="*/ 7817 h 10000"/>
                <a:gd name="connsiteX13" fmla="*/ 9999 w 10000"/>
                <a:gd name="connsiteY13" fmla="*/ 5361 h 10000"/>
                <a:gd name="connsiteX14" fmla="*/ 9294 w 10000"/>
                <a:gd name="connsiteY14" fmla="*/ 1563 h 10000"/>
                <a:gd name="connsiteX0" fmla="*/ 9294 w 10000"/>
                <a:gd name="connsiteY0" fmla="*/ 1563 h 10000"/>
                <a:gd name="connsiteX1" fmla="*/ 5821 w 10000"/>
                <a:gd name="connsiteY1" fmla="*/ 45 h 10000"/>
                <a:gd name="connsiteX2" fmla="*/ 3348 w 10000"/>
                <a:gd name="connsiteY2" fmla="*/ 224 h 10000"/>
                <a:gd name="connsiteX3" fmla="*/ 903 w 10000"/>
                <a:gd name="connsiteY3" fmla="*/ 1434 h 10000"/>
                <a:gd name="connsiteX4" fmla="*/ 473 w 10000"/>
                <a:gd name="connsiteY4" fmla="*/ 7868 h 10000"/>
                <a:gd name="connsiteX5" fmla="*/ 1538 w 10000"/>
                <a:gd name="connsiteY5" fmla="*/ 9375 h 10000"/>
                <a:gd name="connsiteX6" fmla="*/ 3132 w 10000"/>
                <a:gd name="connsiteY6" fmla="*/ 9967 h 10000"/>
                <a:gd name="connsiteX7" fmla="*/ 4342 w 10000"/>
                <a:gd name="connsiteY7" fmla="*/ 8881 h 10000"/>
                <a:gd name="connsiteX8" fmla="*/ 4955 w 10000"/>
                <a:gd name="connsiteY8" fmla="*/ 7749 h 10000"/>
                <a:gd name="connsiteX9" fmla="*/ 5604 w 10000"/>
                <a:gd name="connsiteY9" fmla="*/ 9691 h 10000"/>
                <a:gd name="connsiteX10" fmla="*/ 7202 w 10000"/>
                <a:gd name="connsiteY10" fmla="*/ 9802 h 10000"/>
                <a:gd name="connsiteX11" fmla="*/ 7275 w 10000"/>
                <a:gd name="connsiteY11" fmla="*/ 9780 h 10000"/>
                <a:gd name="connsiteX12" fmla="*/ 9407 w 10000"/>
                <a:gd name="connsiteY12" fmla="*/ 7817 h 10000"/>
                <a:gd name="connsiteX13" fmla="*/ 9999 w 10000"/>
                <a:gd name="connsiteY13" fmla="*/ 5361 h 10000"/>
                <a:gd name="connsiteX14" fmla="*/ 9294 w 10000"/>
                <a:gd name="connsiteY14" fmla="*/ 1563 h 10000"/>
                <a:gd name="connsiteX0" fmla="*/ 9294 w 10000"/>
                <a:gd name="connsiteY0" fmla="*/ 1563 h 10000"/>
                <a:gd name="connsiteX1" fmla="*/ 5821 w 10000"/>
                <a:gd name="connsiteY1" fmla="*/ 45 h 10000"/>
                <a:gd name="connsiteX2" fmla="*/ 3348 w 10000"/>
                <a:gd name="connsiteY2" fmla="*/ 224 h 10000"/>
                <a:gd name="connsiteX3" fmla="*/ 903 w 10000"/>
                <a:gd name="connsiteY3" fmla="*/ 1434 h 10000"/>
                <a:gd name="connsiteX4" fmla="*/ 473 w 10000"/>
                <a:gd name="connsiteY4" fmla="*/ 7868 h 10000"/>
                <a:gd name="connsiteX5" fmla="*/ 1538 w 10000"/>
                <a:gd name="connsiteY5" fmla="*/ 9375 h 10000"/>
                <a:gd name="connsiteX6" fmla="*/ 3132 w 10000"/>
                <a:gd name="connsiteY6" fmla="*/ 9967 h 10000"/>
                <a:gd name="connsiteX7" fmla="*/ 4342 w 10000"/>
                <a:gd name="connsiteY7" fmla="*/ 8881 h 10000"/>
                <a:gd name="connsiteX8" fmla="*/ 4955 w 10000"/>
                <a:gd name="connsiteY8" fmla="*/ 7749 h 10000"/>
                <a:gd name="connsiteX9" fmla="*/ 5604 w 10000"/>
                <a:gd name="connsiteY9" fmla="*/ 9691 h 10000"/>
                <a:gd name="connsiteX10" fmla="*/ 7202 w 10000"/>
                <a:gd name="connsiteY10" fmla="*/ 9802 h 10000"/>
                <a:gd name="connsiteX11" fmla="*/ 7275 w 10000"/>
                <a:gd name="connsiteY11" fmla="*/ 9780 h 10000"/>
                <a:gd name="connsiteX12" fmla="*/ 9407 w 10000"/>
                <a:gd name="connsiteY12" fmla="*/ 7817 h 10000"/>
                <a:gd name="connsiteX13" fmla="*/ 9999 w 10000"/>
                <a:gd name="connsiteY13" fmla="*/ 5361 h 10000"/>
                <a:gd name="connsiteX14" fmla="*/ 9294 w 10000"/>
                <a:gd name="connsiteY14" fmla="*/ 1563 h 10000"/>
                <a:gd name="connsiteX0" fmla="*/ 9294 w 10000"/>
                <a:gd name="connsiteY0" fmla="*/ 1563 h 10000"/>
                <a:gd name="connsiteX1" fmla="*/ 5821 w 10000"/>
                <a:gd name="connsiteY1" fmla="*/ 45 h 10000"/>
                <a:gd name="connsiteX2" fmla="*/ 3410 w 10000"/>
                <a:gd name="connsiteY2" fmla="*/ 390 h 10000"/>
                <a:gd name="connsiteX3" fmla="*/ 903 w 10000"/>
                <a:gd name="connsiteY3" fmla="*/ 1434 h 10000"/>
                <a:gd name="connsiteX4" fmla="*/ 473 w 10000"/>
                <a:gd name="connsiteY4" fmla="*/ 7868 h 10000"/>
                <a:gd name="connsiteX5" fmla="*/ 1538 w 10000"/>
                <a:gd name="connsiteY5" fmla="*/ 9375 h 10000"/>
                <a:gd name="connsiteX6" fmla="*/ 3132 w 10000"/>
                <a:gd name="connsiteY6" fmla="*/ 9967 h 10000"/>
                <a:gd name="connsiteX7" fmla="*/ 4342 w 10000"/>
                <a:gd name="connsiteY7" fmla="*/ 8881 h 10000"/>
                <a:gd name="connsiteX8" fmla="*/ 4955 w 10000"/>
                <a:gd name="connsiteY8" fmla="*/ 7749 h 10000"/>
                <a:gd name="connsiteX9" fmla="*/ 5604 w 10000"/>
                <a:gd name="connsiteY9" fmla="*/ 9691 h 10000"/>
                <a:gd name="connsiteX10" fmla="*/ 7202 w 10000"/>
                <a:gd name="connsiteY10" fmla="*/ 9802 h 10000"/>
                <a:gd name="connsiteX11" fmla="*/ 7275 w 10000"/>
                <a:gd name="connsiteY11" fmla="*/ 9780 h 10000"/>
                <a:gd name="connsiteX12" fmla="*/ 9407 w 10000"/>
                <a:gd name="connsiteY12" fmla="*/ 7817 h 10000"/>
                <a:gd name="connsiteX13" fmla="*/ 9999 w 10000"/>
                <a:gd name="connsiteY13" fmla="*/ 5361 h 10000"/>
                <a:gd name="connsiteX14" fmla="*/ 9294 w 10000"/>
                <a:gd name="connsiteY14" fmla="*/ 1563 h 10000"/>
                <a:gd name="connsiteX0" fmla="*/ 9294 w 10000"/>
                <a:gd name="connsiteY0" fmla="*/ 1563 h 10000"/>
                <a:gd name="connsiteX1" fmla="*/ 5821 w 10000"/>
                <a:gd name="connsiteY1" fmla="*/ 45 h 10000"/>
                <a:gd name="connsiteX2" fmla="*/ 3410 w 10000"/>
                <a:gd name="connsiteY2" fmla="*/ 390 h 10000"/>
                <a:gd name="connsiteX3" fmla="*/ 903 w 10000"/>
                <a:gd name="connsiteY3" fmla="*/ 1434 h 10000"/>
                <a:gd name="connsiteX4" fmla="*/ 473 w 10000"/>
                <a:gd name="connsiteY4" fmla="*/ 7868 h 10000"/>
                <a:gd name="connsiteX5" fmla="*/ 1538 w 10000"/>
                <a:gd name="connsiteY5" fmla="*/ 9375 h 10000"/>
                <a:gd name="connsiteX6" fmla="*/ 3132 w 10000"/>
                <a:gd name="connsiteY6" fmla="*/ 9967 h 10000"/>
                <a:gd name="connsiteX7" fmla="*/ 4342 w 10000"/>
                <a:gd name="connsiteY7" fmla="*/ 8881 h 10000"/>
                <a:gd name="connsiteX8" fmla="*/ 4955 w 10000"/>
                <a:gd name="connsiteY8" fmla="*/ 7749 h 10000"/>
                <a:gd name="connsiteX9" fmla="*/ 5604 w 10000"/>
                <a:gd name="connsiteY9" fmla="*/ 9691 h 10000"/>
                <a:gd name="connsiteX10" fmla="*/ 7202 w 10000"/>
                <a:gd name="connsiteY10" fmla="*/ 9802 h 10000"/>
                <a:gd name="connsiteX11" fmla="*/ 7275 w 10000"/>
                <a:gd name="connsiteY11" fmla="*/ 9780 h 10000"/>
                <a:gd name="connsiteX12" fmla="*/ 9407 w 10000"/>
                <a:gd name="connsiteY12" fmla="*/ 7817 h 10000"/>
                <a:gd name="connsiteX13" fmla="*/ 9999 w 10000"/>
                <a:gd name="connsiteY13" fmla="*/ 5361 h 10000"/>
                <a:gd name="connsiteX14" fmla="*/ 9294 w 10000"/>
                <a:gd name="connsiteY14" fmla="*/ 1563 h 10000"/>
                <a:gd name="connsiteX0" fmla="*/ 9294 w 10000"/>
                <a:gd name="connsiteY0" fmla="*/ 1599 h 10036"/>
                <a:gd name="connsiteX1" fmla="*/ 5821 w 10000"/>
                <a:gd name="connsiteY1" fmla="*/ 81 h 10036"/>
                <a:gd name="connsiteX2" fmla="*/ 3410 w 10000"/>
                <a:gd name="connsiteY2" fmla="*/ 426 h 10036"/>
                <a:gd name="connsiteX3" fmla="*/ 903 w 10000"/>
                <a:gd name="connsiteY3" fmla="*/ 1470 h 10036"/>
                <a:gd name="connsiteX4" fmla="*/ 473 w 10000"/>
                <a:gd name="connsiteY4" fmla="*/ 7904 h 10036"/>
                <a:gd name="connsiteX5" fmla="*/ 1538 w 10000"/>
                <a:gd name="connsiteY5" fmla="*/ 9411 h 10036"/>
                <a:gd name="connsiteX6" fmla="*/ 3132 w 10000"/>
                <a:gd name="connsiteY6" fmla="*/ 10003 h 10036"/>
                <a:gd name="connsiteX7" fmla="*/ 4342 w 10000"/>
                <a:gd name="connsiteY7" fmla="*/ 8917 h 10036"/>
                <a:gd name="connsiteX8" fmla="*/ 4955 w 10000"/>
                <a:gd name="connsiteY8" fmla="*/ 7785 h 10036"/>
                <a:gd name="connsiteX9" fmla="*/ 5604 w 10000"/>
                <a:gd name="connsiteY9" fmla="*/ 9727 h 10036"/>
                <a:gd name="connsiteX10" fmla="*/ 7202 w 10000"/>
                <a:gd name="connsiteY10" fmla="*/ 9838 h 10036"/>
                <a:gd name="connsiteX11" fmla="*/ 7275 w 10000"/>
                <a:gd name="connsiteY11" fmla="*/ 9816 h 10036"/>
                <a:gd name="connsiteX12" fmla="*/ 9407 w 10000"/>
                <a:gd name="connsiteY12" fmla="*/ 7853 h 10036"/>
                <a:gd name="connsiteX13" fmla="*/ 9999 w 10000"/>
                <a:gd name="connsiteY13" fmla="*/ 5397 h 10036"/>
                <a:gd name="connsiteX14" fmla="*/ 9294 w 10000"/>
                <a:gd name="connsiteY14" fmla="*/ 1599 h 10036"/>
                <a:gd name="connsiteX0" fmla="*/ 9294 w 10000"/>
                <a:gd name="connsiteY0" fmla="*/ 1647 h 10084"/>
                <a:gd name="connsiteX1" fmla="*/ 5821 w 10000"/>
                <a:gd name="connsiteY1" fmla="*/ 129 h 10084"/>
                <a:gd name="connsiteX2" fmla="*/ 3410 w 10000"/>
                <a:gd name="connsiteY2" fmla="*/ 474 h 10084"/>
                <a:gd name="connsiteX3" fmla="*/ 903 w 10000"/>
                <a:gd name="connsiteY3" fmla="*/ 1518 h 10084"/>
                <a:gd name="connsiteX4" fmla="*/ 473 w 10000"/>
                <a:gd name="connsiteY4" fmla="*/ 7952 h 10084"/>
                <a:gd name="connsiteX5" fmla="*/ 1538 w 10000"/>
                <a:gd name="connsiteY5" fmla="*/ 9459 h 10084"/>
                <a:gd name="connsiteX6" fmla="*/ 3132 w 10000"/>
                <a:gd name="connsiteY6" fmla="*/ 10051 h 10084"/>
                <a:gd name="connsiteX7" fmla="*/ 4342 w 10000"/>
                <a:gd name="connsiteY7" fmla="*/ 8965 h 10084"/>
                <a:gd name="connsiteX8" fmla="*/ 4955 w 10000"/>
                <a:gd name="connsiteY8" fmla="*/ 7833 h 10084"/>
                <a:gd name="connsiteX9" fmla="*/ 5604 w 10000"/>
                <a:gd name="connsiteY9" fmla="*/ 9775 h 10084"/>
                <a:gd name="connsiteX10" fmla="*/ 7202 w 10000"/>
                <a:gd name="connsiteY10" fmla="*/ 9886 h 10084"/>
                <a:gd name="connsiteX11" fmla="*/ 7275 w 10000"/>
                <a:gd name="connsiteY11" fmla="*/ 9864 h 10084"/>
                <a:gd name="connsiteX12" fmla="*/ 9407 w 10000"/>
                <a:gd name="connsiteY12" fmla="*/ 7901 h 10084"/>
                <a:gd name="connsiteX13" fmla="*/ 9999 w 10000"/>
                <a:gd name="connsiteY13" fmla="*/ 5445 h 10084"/>
                <a:gd name="connsiteX14" fmla="*/ 9294 w 10000"/>
                <a:gd name="connsiteY14" fmla="*/ 1647 h 10084"/>
                <a:gd name="connsiteX0" fmla="*/ 9294 w 10000"/>
                <a:gd name="connsiteY0" fmla="*/ 1691 h 10128"/>
                <a:gd name="connsiteX1" fmla="*/ 5821 w 10000"/>
                <a:gd name="connsiteY1" fmla="*/ 173 h 10128"/>
                <a:gd name="connsiteX2" fmla="*/ 3410 w 10000"/>
                <a:gd name="connsiteY2" fmla="*/ 518 h 10128"/>
                <a:gd name="connsiteX3" fmla="*/ 903 w 10000"/>
                <a:gd name="connsiteY3" fmla="*/ 1562 h 10128"/>
                <a:gd name="connsiteX4" fmla="*/ 473 w 10000"/>
                <a:gd name="connsiteY4" fmla="*/ 7996 h 10128"/>
                <a:gd name="connsiteX5" fmla="*/ 1538 w 10000"/>
                <a:gd name="connsiteY5" fmla="*/ 9503 h 10128"/>
                <a:gd name="connsiteX6" fmla="*/ 3132 w 10000"/>
                <a:gd name="connsiteY6" fmla="*/ 10095 h 10128"/>
                <a:gd name="connsiteX7" fmla="*/ 4342 w 10000"/>
                <a:gd name="connsiteY7" fmla="*/ 9009 h 10128"/>
                <a:gd name="connsiteX8" fmla="*/ 4955 w 10000"/>
                <a:gd name="connsiteY8" fmla="*/ 7877 h 10128"/>
                <a:gd name="connsiteX9" fmla="*/ 5604 w 10000"/>
                <a:gd name="connsiteY9" fmla="*/ 9819 h 10128"/>
                <a:gd name="connsiteX10" fmla="*/ 7202 w 10000"/>
                <a:gd name="connsiteY10" fmla="*/ 9930 h 10128"/>
                <a:gd name="connsiteX11" fmla="*/ 7275 w 10000"/>
                <a:gd name="connsiteY11" fmla="*/ 9908 h 10128"/>
                <a:gd name="connsiteX12" fmla="*/ 9407 w 10000"/>
                <a:gd name="connsiteY12" fmla="*/ 7945 h 10128"/>
                <a:gd name="connsiteX13" fmla="*/ 9999 w 10000"/>
                <a:gd name="connsiteY13" fmla="*/ 5489 h 10128"/>
                <a:gd name="connsiteX14" fmla="*/ 9294 w 10000"/>
                <a:gd name="connsiteY14" fmla="*/ 1691 h 10128"/>
                <a:gd name="connsiteX0" fmla="*/ 9294 w 10000"/>
                <a:gd name="connsiteY0" fmla="*/ 1743 h 10180"/>
                <a:gd name="connsiteX1" fmla="*/ 5782 w 10000"/>
                <a:gd name="connsiteY1" fmla="*/ 152 h 10180"/>
                <a:gd name="connsiteX2" fmla="*/ 3410 w 10000"/>
                <a:gd name="connsiteY2" fmla="*/ 570 h 10180"/>
                <a:gd name="connsiteX3" fmla="*/ 903 w 10000"/>
                <a:gd name="connsiteY3" fmla="*/ 1614 h 10180"/>
                <a:gd name="connsiteX4" fmla="*/ 473 w 10000"/>
                <a:gd name="connsiteY4" fmla="*/ 8048 h 10180"/>
                <a:gd name="connsiteX5" fmla="*/ 1538 w 10000"/>
                <a:gd name="connsiteY5" fmla="*/ 9555 h 10180"/>
                <a:gd name="connsiteX6" fmla="*/ 3132 w 10000"/>
                <a:gd name="connsiteY6" fmla="*/ 10147 h 10180"/>
                <a:gd name="connsiteX7" fmla="*/ 4342 w 10000"/>
                <a:gd name="connsiteY7" fmla="*/ 9061 h 10180"/>
                <a:gd name="connsiteX8" fmla="*/ 4955 w 10000"/>
                <a:gd name="connsiteY8" fmla="*/ 7929 h 10180"/>
                <a:gd name="connsiteX9" fmla="*/ 5604 w 10000"/>
                <a:gd name="connsiteY9" fmla="*/ 9871 h 10180"/>
                <a:gd name="connsiteX10" fmla="*/ 7202 w 10000"/>
                <a:gd name="connsiteY10" fmla="*/ 9982 h 10180"/>
                <a:gd name="connsiteX11" fmla="*/ 7275 w 10000"/>
                <a:gd name="connsiteY11" fmla="*/ 9960 h 10180"/>
                <a:gd name="connsiteX12" fmla="*/ 9407 w 10000"/>
                <a:gd name="connsiteY12" fmla="*/ 7997 h 10180"/>
                <a:gd name="connsiteX13" fmla="*/ 9999 w 10000"/>
                <a:gd name="connsiteY13" fmla="*/ 5541 h 10180"/>
                <a:gd name="connsiteX14" fmla="*/ 9294 w 10000"/>
                <a:gd name="connsiteY14" fmla="*/ 1743 h 10180"/>
                <a:gd name="connsiteX0" fmla="*/ 9294 w 10000"/>
                <a:gd name="connsiteY0" fmla="*/ 1796 h 10233"/>
                <a:gd name="connsiteX1" fmla="*/ 5743 w 10000"/>
                <a:gd name="connsiteY1" fmla="*/ 132 h 10233"/>
                <a:gd name="connsiteX2" fmla="*/ 3410 w 10000"/>
                <a:gd name="connsiteY2" fmla="*/ 623 h 10233"/>
                <a:gd name="connsiteX3" fmla="*/ 903 w 10000"/>
                <a:gd name="connsiteY3" fmla="*/ 1667 h 10233"/>
                <a:gd name="connsiteX4" fmla="*/ 473 w 10000"/>
                <a:gd name="connsiteY4" fmla="*/ 8101 h 10233"/>
                <a:gd name="connsiteX5" fmla="*/ 1538 w 10000"/>
                <a:gd name="connsiteY5" fmla="*/ 9608 h 10233"/>
                <a:gd name="connsiteX6" fmla="*/ 3132 w 10000"/>
                <a:gd name="connsiteY6" fmla="*/ 10200 h 10233"/>
                <a:gd name="connsiteX7" fmla="*/ 4342 w 10000"/>
                <a:gd name="connsiteY7" fmla="*/ 9114 h 10233"/>
                <a:gd name="connsiteX8" fmla="*/ 4955 w 10000"/>
                <a:gd name="connsiteY8" fmla="*/ 7982 h 10233"/>
                <a:gd name="connsiteX9" fmla="*/ 5604 w 10000"/>
                <a:gd name="connsiteY9" fmla="*/ 9924 h 10233"/>
                <a:gd name="connsiteX10" fmla="*/ 7202 w 10000"/>
                <a:gd name="connsiteY10" fmla="*/ 10035 h 10233"/>
                <a:gd name="connsiteX11" fmla="*/ 7275 w 10000"/>
                <a:gd name="connsiteY11" fmla="*/ 10013 h 10233"/>
                <a:gd name="connsiteX12" fmla="*/ 9407 w 10000"/>
                <a:gd name="connsiteY12" fmla="*/ 8050 h 10233"/>
                <a:gd name="connsiteX13" fmla="*/ 9999 w 10000"/>
                <a:gd name="connsiteY13" fmla="*/ 5594 h 10233"/>
                <a:gd name="connsiteX14" fmla="*/ 9294 w 10000"/>
                <a:gd name="connsiteY14" fmla="*/ 1796 h 10233"/>
                <a:gd name="connsiteX0" fmla="*/ 9294 w 10000"/>
                <a:gd name="connsiteY0" fmla="*/ 1784 h 10221"/>
                <a:gd name="connsiteX1" fmla="*/ 5743 w 10000"/>
                <a:gd name="connsiteY1" fmla="*/ 120 h 10221"/>
                <a:gd name="connsiteX2" fmla="*/ 3430 w 10000"/>
                <a:gd name="connsiteY2" fmla="*/ 301 h 10221"/>
                <a:gd name="connsiteX3" fmla="*/ 903 w 10000"/>
                <a:gd name="connsiteY3" fmla="*/ 1655 h 10221"/>
                <a:gd name="connsiteX4" fmla="*/ 473 w 10000"/>
                <a:gd name="connsiteY4" fmla="*/ 8089 h 10221"/>
                <a:gd name="connsiteX5" fmla="*/ 1538 w 10000"/>
                <a:gd name="connsiteY5" fmla="*/ 9596 h 10221"/>
                <a:gd name="connsiteX6" fmla="*/ 3132 w 10000"/>
                <a:gd name="connsiteY6" fmla="*/ 10188 h 10221"/>
                <a:gd name="connsiteX7" fmla="*/ 4342 w 10000"/>
                <a:gd name="connsiteY7" fmla="*/ 9102 h 10221"/>
                <a:gd name="connsiteX8" fmla="*/ 4955 w 10000"/>
                <a:gd name="connsiteY8" fmla="*/ 7970 h 10221"/>
                <a:gd name="connsiteX9" fmla="*/ 5604 w 10000"/>
                <a:gd name="connsiteY9" fmla="*/ 9912 h 10221"/>
                <a:gd name="connsiteX10" fmla="*/ 7202 w 10000"/>
                <a:gd name="connsiteY10" fmla="*/ 10023 h 10221"/>
                <a:gd name="connsiteX11" fmla="*/ 7275 w 10000"/>
                <a:gd name="connsiteY11" fmla="*/ 10001 h 10221"/>
                <a:gd name="connsiteX12" fmla="*/ 9407 w 10000"/>
                <a:gd name="connsiteY12" fmla="*/ 8038 h 10221"/>
                <a:gd name="connsiteX13" fmla="*/ 9999 w 10000"/>
                <a:gd name="connsiteY13" fmla="*/ 5582 h 10221"/>
                <a:gd name="connsiteX14" fmla="*/ 9294 w 10000"/>
                <a:gd name="connsiteY14" fmla="*/ 1784 h 10221"/>
                <a:gd name="connsiteX0" fmla="*/ 9294 w 10000"/>
                <a:gd name="connsiteY0" fmla="*/ 1844 h 10281"/>
                <a:gd name="connsiteX1" fmla="*/ 5835 w 10000"/>
                <a:gd name="connsiteY1" fmla="*/ 104 h 10281"/>
                <a:gd name="connsiteX2" fmla="*/ 3430 w 10000"/>
                <a:gd name="connsiteY2" fmla="*/ 361 h 10281"/>
                <a:gd name="connsiteX3" fmla="*/ 903 w 10000"/>
                <a:gd name="connsiteY3" fmla="*/ 1715 h 10281"/>
                <a:gd name="connsiteX4" fmla="*/ 473 w 10000"/>
                <a:gd name="connsiteY4" fmla="*/ 8149 h 10281"/>
                <a:gd name="connsiteX5" fmla="*/ 1538 w 10000"/>
                <a:gd name="connsiteY5" fmla="*/ 9656 h 10281"/>
                <a:gd name="connsiteX6" fmla="*/ 3132 w 10000"/>
                <a:gd name="connsiteY6" fmla="*/ 10248 h 10281"/>
                <a:gd name="connsiteX7" fmla="*/ 4342 w 10000"/>
                <a:gd name="connsiteY7" fmla="*/ 9162 h 10281"/>
                <a:gd name="connsiteX8" fmla="*/ 4955 w 10000"/>
                <a:gd name="connsiteY8" fmla="*/ 8030 h 10281"/>
                <a:gd name="connsiteX9" fmla="*/ 5604 w 10000"/>
                <a:gd name="connsiteY9" fmla="*/ 9972 h 10281"/>
                <a:gd name="connsiteX10" fmla="*/ 7202 w 10000"/>
                <a:gd name="connsiteY10" fmla="*/ 10083 h 10281"/>
                <a:gd name="connsiteX11" fmla="*/ 7275 w 10000"/>
                <a:gd name="connsiteY11" fmla="*/ 10061 h 10281"/>
                <a:gd name="connsiteX12" fmla="*/ 9407 w 10000"/>
                <a:gd name="connsiteY12" fmla="*/ 8098 h 10281"/>
                <a:gd name="connsiteX13" fmla="*/ 9999 w 10000"/>
                <a:gd name="connsiteY13" fmla="*/ 5642 h 10281"/>
                <a:gd name="connsiteX14" fmla="*/ 9294 w 10000"/>
                <a:gd name="connsiteY14" fmla="*/ 1844 h 10281"/>
                <a:gd name="connsiteX0" fmla="*/ 9294 w 10000"/>
                <a:gd name="connsiteY0" fmla="*/ 1813 h 10250"/>
                <a:gd name="connsiteX1" fmla="*/ 5835 w 10000"/>
                <a:gd name="connsiteY1" fmla="*/ 73 h 10250"/>
                <a:gd name="connsiteX2" fmla="*/ 3430 w 10000"/>
                <a:gd name="connsiteY2" fmla="*/ 330 h 10250"/>
                <a:gd name="connsiteX3" fmla="*/ 903 w 10000"/>
                <a:gd name="connsiteY3" fmla="*/ 1684 h 10250"/>
                <a:gd name="connsiteX4" fmla="*/ 473 w 10000"/>
                <a:gd name="connsiteY4" fmla="*/ 8118 h 10250"/>
                <a:gd name="connsiteX5" fmla="*/ 1538 w 10000"/>
                <a:gd name="connsiteY5" fmla="*/ 9625 h 10250"/>
                <a:gd name="connsiteX6" fmla="*/ 3132 w 10000"/>
                <a:gd name="connsiteY6" fmla="*/ 10217 h 10250"/>
                <a:gd name="connsiteX7" fmla="*/ 4342 w 10000"/>
                <a:gd name="connsiteY7" fmla="*/ 9131 h 10250"/>
                <a:gd name="connsiteX8" fmla="*/ 4955 w 10000"/>
                <a:gd name="connsiteY8" fmla="*/ 7999 h 10250"/>
                <a:gd name="connsiteX9" fmla="*/ 5604 w 10000"/>
                <a:gd name="connsiteY9" fmla="*/ 9941 h 10250"/>
                <a:gd name="connsiteX10" fmla="*/ 7202 w 10000"/>
                <a:gd name="connsiteY10" fmla="*/ 10052 h 10250"/>
                <a:gd name="connsiteX11" fmla="*/ 7275 w 10000"/>
                <a:gd name="connsiteY11" fmla="*/ 10030 h 10250"/>
                <a:gd name="connsiteX12" fmla="*/ 9407 w 10000"/>
                <a:gd name="connsiteY12" fmla="*/ 8067 h 10250"/>
                <a:gd name="connsiteX13" fmla="*/ 9999 w 10000"/>
                <a:gd name="connsiteY13" fmla="*/ 5611 h 10250"/>
                <a:gd name="connsiteX14" fmla="*/ 9294 w 10000"/>
                <a:gd name="connsiteY14" fmla="*/ 1813 h 10250"/>
                <a:gd name="connsiteX0" fmla="*/ 9294 w 10000"/>
                <a:gd name="connsiteY0" fmla="*/ 1768 h 10205"/>
                <a:gd name="connsiteX1" fmla="*/ 5835 w 10000"/>
                <a:gd name="connsiteY1" fmla="*/ 28 h 10205"/>
                <a:gd name="connsiteX2" fmla="*/ 3430 w 10000"/>
                <a:gd name="connsiteY2" fmla="*/ 285 h 10205"/>
                <a:gd name="connsiteX3" fmla="*/ 903 w 10000"/>
                <a:gd name="connsiteY3" fmla="*/ 1639 h 10205"/>
                <a:gd name="connsiteX4" fmla="*/ 473 w 10000"/>
                <a:gd name="connsiteY4" fmla="*/ 8073 h 10205"/>
                <a:gd name="connsiteX5" fmla="*/ 1538 w 10000"/>
                <a:gd name="connsiteY5" fmla="*/ 9580 h 10205"/>
                <a:gd name="connsiteX6" fmla="*/ 3132 w 10000"/>
                <a:gd name="connsiteY6" fmla="*/ 10172 h 10205"/>
                <a:gd name="connsiteX7" fmla="*/ 4342 w 10000"/>
                <a:gd name="connsiteY7" fmla="*/ 9086 h 10205"/>
                <a:gd name="connsiteX8" fmla="*/ 4955 w 10000"/>
                <a:gd name="connsiteY8" fmla="*/ 7954 h 10205"/>
                <a:gd name="connsiteX9" fmla="*/ 5604 w 10000"/>
                <a:gd name="connsiteY9" fmla="*/ 9896 h 10205"/>
                <a:gd name="connsiteX10" fmla="*/ 7202 w 10000"/>
                <a:gd name="connsiteY10" fmla="*/ 10007 h 10205"/>
                <a:gd name="connsiteX11" fmla="*/ 7275 w 10000"/>
                <a:gd name="connsiteY11" fmla="*/ 9985 h 10205"/>
                <a:gd name="connsiteX12" fmla="*/ 9407 w 10000"/>
                <a:gd name="connsiteY12" fmla="*/ 8022 h 10205"/>
                <a:gd name="connsiteX13" fmla="*/ 9999 w 10000"/>
                <a:gd name="connsiteY13" fmla="*/ 5566 h 10205"/>
                <a:gd name="connsiteX14" fmla="*/ 9294 w 10000"/>
                <a:gd name="connsiteY14" fmla="*/ 1768 h 10205"/>
                <a:gd name="connsiteX0" fmla="*/ 9294 w 10000"/>
                <a:gd name="connsiteY0" fmla="*/ 1768 h 10205"/>
                <a:gd name="connsiteX1" fmla="*/ 5835 w 10000"/>
                <a:gd name="connsiteY1" fmla="*/ 28 h 10205"/>
                <a:gd name="connsiteX2" fmla="*/ 3430 w 10000"/>
                <a:gd name="connsiteY2" fmla="*/ 285 h 10205"/>
                <a:gd name="connsiteX3" fmla="*/ 903 w 10000"/>
                <a:gd name="connsiteY3" fmla="*/ 1639 h 10205"/>
                <a:gd name="connsiteX4" fmla="*/ 473 w 10000"/>
                <a:gd name="connsiteY4" fmla="*/ 8073 h 10205"/>
                <a:gd name="connsiteX5" fmla="*/ 1538 w 10000"/>
                <a:gd name="connsiteY5" fmla="*/ 9580 h 10205"/>
                <a:gd name="connsiteX6" fmla="*/ 3132 w 10000"/>
                <a:gd name="connsiteY6" fmla="*/ 10172 h 10205"/>
                <a:gd name="connsiteX7" fmla="*/ 4342 w 10000"/>
                <a:gd name="connsiteY7" fmla="*/ 9086 h 10205"/>
                <a:gd name="connsiteX8" fmla="*/ 5601 w 10000"/>
                <a:gd name="connsiteY8" fmla="*/ 8661 h 10205"/>
                <a:gd name="connsiteX9" fmla="*/ 5604 w 10000"/>
                <a:gd name="connsiteY9" fmla="*/ 9896 h 10205"/>
                <a:gd name="connsiteX10" fmla="*/ 7202 w 10000"/>
                <a:gd name="connsiteY10" fmla="*/ 10007 h 10205"/>
                <a:gd name="connsiteX11" fmla="*/ 7275 w 10000"/>
                <a:gd name="connsiteY11" fmla="*/ 9985 h 10205"/>
                <a:gd name="connsiteX12" fmla="*/ 9407 w 10000"/>
                <a:gd name="connsiteY12" fmla="*/ 8022 h 10205"/>
                <a:gd name="connsiteX13" fmla="*/ 9999 w 10000"/>
                <a:gd name="connsiteY13" fmla="*/ 5566 h 10205"/>
                <a:gd name="connsiteX14" fmla="*/ 9294 w 10000"/>
                <a:gd name="connsiteY14" fmla="*/ 1768 h 10205"/>
                <a:gd name="connsiteX0" fmla="*/ 9294 w 10000"/>
                <a:gd name="connsiteY0" fmla="*/ 1768 h 10665"/>
                <a:gd name="connsiteX1" fmla="*/ 5835 w 10000"/>
                <a:gd name="connsiteY1" fmla="*/ 28 h 10665"/>
                <a:gd name="connsiteX2" fmla="*/ 3430 w 10000"/>
                <a:gd name="connsiteY2" fmla="*/ 285 h 10665"/>
                <a:gd name="connsiteX3" fmla="*/ 903 w 10000"/>
                <a:gd name="connsiteY3" fmla="*/ 1639 h 10665"/>
                <a:gd name="connsiteX4" fmla="*/ 473 w 10000"/>
                <a:gd name="connsiteY4" fmla="*/ 8073 h 10665"/>
                <a:gd name="connsiteX5" fmla="*/ 1538 w 10000"/>
                <a:gd name="connsiteY5" fmla="*/ 9580 h 10665"/>
                <a:gd name="connsiteX6" fmla="*/ 3132 w 10000"/>
                <a:gd name="connsiteY6" fmla="*/ 10172 h 10665"/>
                <a:gd name="connsiteX7" fmla="*/ 4342 w 10000"/>
                <a:gd name="connsiteY7" fmla="*/ 9086 h 10665"/>
                <a:gd name="connsiteX8" fmla="*/ 5601 w 10000"/>
                <a:gd name="connsiteY8" fmla="*/ 8661 h 10665"/>
                <a:gd name="connsiteX9" fmla="*/ 6217 w 10000"/>
                <a:gd name="connsiteY9" fmla="*/ 10509 h 10665"/>
                <a:gd name="connsiteX10" fmla="*/ 7202 w 10000"/>
                <a:gd name="connsiteY10" fmla="*/ 10007 h 10665"/>
                <a:gd name="connsiteX11" fmla="*/ 7275 w 10000"/>
                <a:gd name="connsiteY11" fmla="*/ 9985 h 10665"/>
                <a:gd name="connsiteX12" fmla="*/ 9407 w 10000"/>
                <a:gd name="connsiteY12" fmla="*/ 8022 h 10665"/>
                <a:gd name="connsiteX13" fmla="*/ 9999 w 10000"/>
                <a:gd name="connsiteY13" fmla="*/ 5566 h 10665"/>
                <a:gd name="connsiteX14" fmla="*/ 9294 w 10000"/>
                <a:gd name="connsiteY14" fmla="*/ 1768 h 10665"/>
                <a:gd name="connsiteX0" fmla="*/ 9294 w 10000"/>
                <a:gd name="connsiteY0" fmla="*/ 1768 h 10184"/>
                <a:gd name="connsiteX1" fmla="*/ 5835 w 10000"/>
                <a:gd name="connsiteY1" fmla="*/ 28 h 10184"/>
                <a:gd name="connsiteX2" fmla="*/ 3430 w 10000"/>
                <a:gd name="connsiteY2" fmla="*/ 285 h 10184"/>
                <a:gd name="connsiteX3" fmla="*/ 903 w 10000"/>
                <a:gd name="connsiteY3" fmla="*/ 1639 h 10184"/>
                <a:gd name="connsiteX4" fmla="*/ 473 w 10000"/>
                <a:gd name="connsiteY4" fmla="*/ 8073 h 10184"/>
                <a:gd name="connsiteX5" fmla="*/ 1538 w 10000"/>
                <a:gd name="connsiteY5" fmla="*/ 9580 h 10184"/>
                <a:gd name="connsiteX6" fmla="*/ 3132 w 10000"/>
                <a:gd name="connsiteY6" fmla="*/ 10172 h 10184"/>
                <a:gd name="connsiteX7" fmla="*/ 4342 w 10000"/>
                <a:gd name="connsiteY7" fmla="*/ 9086 h 10184"/>
                <a:gd name="connsiteX8" fmla="*/ 5601 w 10000"/>
                <a:gd name="connsiteY8" fmla="*/ 8661 h 10184"/>
                <a:gd name="connsiteX9" fmla="*/ 7202 w 10000"/>
                <a:gd name="connsiteY9" fmla="*/ 10007 h 10184"/>
                <a:gd name="connsiteX10" fmla="*/ 7275 w 10000"/>
                <a:gd name="connsiteY10" fmla="*/ 9985 h 10184"/>
                <a:gd name="connsiteX11" fmla="*/ 9407 w 10000"/>
                <a:gd name="connsiteY11" fmla="*/ 8022 h 10184"/>
                <a:gd name="connsiteX12" fmla="*/ 9999 w 10000"/>
                <a:gd name="connsiteY12" fmla="*/ 5566 h 10184"/>
                <a:gd name="connsiteX13" fmla="*/ 9294 w 10000"/>
                <a:gd name="connsiteY13" fmla="*/ 1768 h 10184"/>
                <a:gd name="connsiteX0" fmla="*/ 9294 w 10000"/>
                <a:gd name="connsiteY0" fmla="*/ 1768 h 10232"/>
                <a:gd name="connsiteX1" fmla="*/ 5835 w 10000"/>
                <a:gd name="connsiteY1" fmla="*/ 28 h 10232"/>
                <a:gd name="connsiteX2" fmla="*/ 3430 w 10000"/>
                <a:gd name="connsiteY2" fmla="*/ 285 h 10232"/>
                <a:gd name="connsiteX3" fmla="*/ 903 w 10000"/>
                <a:gd name="connsiteY3" fmla="*/ 1639 h 10232"/>
                <a:gd name="connsiteX4" fmla="*/ 473 w 10000"/>
                <a:gd name="connsiteY4" fmla="*/ 8073 h 10232"/>
                <a:gd name="connsiteX5" fmla="*/ 1538 w 10000"/>
                <a:gd name="connsiteY5" fmla="*/ 9580 h 10232"/>
                <a:gd name="connsiteX6" fmla="*/ 3132 w 10000"/>
                <a:gd name="connsiteY6" fmla="*/ 10172 h 10232"/>
                <a:gd name="connsiteX7" fmla="*/ 4342 w 10000"/>
                <a:gd name="connsiteY7" fmla="*/ 9086 h 10232"/>
                <a:gd name="connsiteX8" fmla="*/ 5601 w 10000"/>
                <a:gd name="connsiteY8" fmla="*/ 8661 h 10232"/>
                <a:gd name="connsiteX9" fmla="*/ 7202 w 10000"/>
                <a:gd name="connsiteY9" fmla="*/ 10007 h 10232"/>
                <a:gd name="connsiteX10" fmla="*/ 7253 w 10000"/>
                <a:gd name="connsiteY10" fmla="*/ 10175 h 10232"/>
                <a:gd name="connsiteX11" fmla="*/ 9407 w 10000"/>
                <a:gd name="connsiteY11" fmla="*/ 8022 h 10232"/>
                <a:gd name="connsiteX12" fmla="*/ 9999 w 10000"/>
                <a:gd name="connsiteY12" fmla="*/ 5566 h 10232"/>
                <a:gd name="connsiteX13" fmla="*/ 9294 w 10000"/>
                <a:gd name="connsiteY13" fmla="*/ 1768 h 10232"/>
                <a:gd name="connsiteX0" fmla="*/ 9294 w 10000"/>
                <a:gd name="connsiteY0" fmla="*/ 1768 h 10232"/>
                <a:gd name="connsiteX1" fmla="*/ 5835 w 10000"/>
                <a:gd name="connsiteY1" fmla="*/ 28 h 10232"/>
                <a:gd name="connsiteX2" fmla="*/ 3430 w 10000"/>
                <a:gd name="connsiteY2" fmla="*/ 285 h 10232"/>
                <a:gd name="connsiteX3" fmla="*/ 903 w 10000"/>
                <a:gd name="connsiteY3" fmla="*/ 1639 h 10232"/>
                <a:gd name="connsiteX4" fmla="*/ 473 w 10000"/>
                <a:gd name="connsiteY4" fmla="*/ 8073 h 10232"/>
                <a:gd name="connsiteX5" fmla="*/ 1538 w 10000"/>
                <a:gd name="connsiteY5" fmla="*/ 9580 h 10232"/>
                <a:gd name="connsiteX6" fmla="*/ 3132 w 10000"/>
                <a:gd name="connsiteY6" fmla="*/ 10172 h 10232"/>
                <a:gd name="connsiteX7" fmla="*/ 4358 w 10000"/>
                <a:gd name="connsiteY7" fmla="*/ 9148 h 10232"/>
                <a:gd name="connsiteX8" fmla="*/ 5601 w 10000"/>
                <a:gd name="connsiteY8" fmla="*/ 8661 h 10232"/>
                <a:gd name="connsiteX9" fmla="*/ 7202 w 10000"/>
                <a:gd name="connsiteY9" fmla="*/ 10007 h 10232"/>
                <a:gd name="connsiteX10" fmla="*/ 7253 w 10000"/>
                <a:gd name="connsiteY10" fmla="*/ 10175 h 10232"/>
                <a:gd name="connsiteX11" fmla="*/ 9407 w 10000"/>
                <a:gd name="connsiteY11" fmla="*/ 8022 h 10232"/>
                <a:gd name="connsiteX12" fmla="*/ 9999 w 10000"/>
                <a:gd name="connsiteY12" fmla="*/ 5566 h 10232"/>
                <a:gd name="connsiteX13" fmla="*/ 9294 w 10000"/>
                <a:gd name="connsiteY13" fmla="*/ 1768 h 10232"/>
                <a:gd name="connsiteX0" fmla="*/ 9294 w 10000"/>
                <a:gd name="connsiteY0" fmla="*/ 1768 h 10232"/>
                <a:gd name="connsiteX1" fmla="*/ 5835 w 10000"/>
                <a:gd name="connsiteY1" fmla="*/ 28 h 10232"/>
                <a:gd name="connsiteX2" fmla="*/ 3430 w 10000"/>
                <a:gd name="connsiteY2" fmla="*/ 285 h 10232"/>
                <a:gd name="connsiteX3" fmla="*/ 903 w 10000"/>
                <a:gd name="connsiteY3" fmla="*/ 1639 h 10232"/>
                <a:gd name="connsiteX4" fmla="*/ 473 w 10000"/>
                <a:gd name="connsiteY4" fmla="*/ 8073 h 10232"/>
                <a:gd name="connsiteX5" fmla="*/ 1538 w 10000"/>
                <a:gd name="connsiteY5" fmla="*/ 9580 h 10232"/>
                <a:gd name="connsiteX6" fmla="*/ 3158 w 10000"/>
                <a:gd name="connsiteY6" fmla="*/ 10221 h 10232"/>
                <a:gd name="connsiteX7" fmla="*/ 4358 w 10000"/>
                <a:gd name="connsiteY7" fmla="*/ 9148 h 10232"/>
                <a:gd name="connsiteX8" fmla="*/ 5601 w 10000"/>
                <a:gd name="connsiteY8" fmla="*/ 8661 h 10232"/>
                <a:gd name="connsiteX9" fmla="*/ 7202 w 10000"/>
                <a:gd name="connsiteY9" fmla="*/ 10007 h 10232"/>
                <a:gd name="connsiteX10" fmla="*/ 7253 w 10000"/>
                <a:gd name="connsiteY10" fmla="*/ 10175 h 10232"/>
                <a:gd name="connsiteX11" fmla="*/ 9407 w 10000"/>
                <a:gd name="connsiteY11" fmla="*/ 8022 h 10232"/>
                <a:gd name="connsiteX12" fmla="*/ 9999 w 10000"/>
                <a:gd name="connsiteY12" fmla="*/ 5566 h 10232"/>
                <a:gd name="connsiteX13" fmla="*/ 9294 w 10000"/>
                <a:gd name="connsiteY13" fmla="*/ 1768 h 10232"/>
                <a:gd name="connsiteX0" fmla="*/ 9294 w 10000"/>
                <a:gd name="connsiteY0" fmla="*/ 1768 h 10230"/>
                <a:gd name="connsiteX1" fmla="*/ 5835 w 10000"/>
                <a:gd name="connsiteY1" fmla="*/ 28 h 10230"/>
                <a:gd name="connsiteX2" fmla="*/ 3430 w 10000"/>
                <a:gd name="connsiteY2" fmla="*/ 285 h 10230"/>
                <a:gd name="connsiteX3" fmla="*/ 903 w 10000"/>
                <a:gd name="connsiteY3" fmla="*/ 1639 h 10230"/>
                <a:gd name="connsiteX4" fmla="*/ 473 w 10000"/>
                <a:gd name="connsiteY4" fmla="*/ 8073 h 10230"/>
                <a:gd name="connsiteX5" fmla="*/ 1538 w 10000"/>
                <a:gd name="connsiteY5" fmla="*/ 9580 h 10230"/>
                <a:gd name="connsiteX6" fmla="*/ 3158 w 10000"/>
                <a:gd name="connsiteY6" fmla="*/ 10221 h 10230"/>
                <a:gd name="connsiteX7" fmla="*/ 4358 w 10000"/>
                <a:gd name="connsiteY7" fmla="*/ 9148 h 10230"/>
                <a:gd name="connsiteX8" fmla="*/ 5601 w 10000"/>
                <a:gd name="connsiteY8" fmla="*/ 8661 h 10230"/>
                <a:gd name="connsiteX9" fmla="*/ 7202 w 10000"/>
                <a:gd name="connsiteY9" fmla="*/ 10007 h 10230"/>
                <a:gd name="connsiteX10" fmla="*/ 9407 w 10000"/>
                <a:gd name="connsiteY10" fmla="*/ 8022 h 10230"/>
                <a:gd name="connsiteX11" fmla="*/ 9999 w 10000"/>
                <a:gd name="connsiteY11" fmla="*/ 5566 h 10230"/>
                <a:gd name="connsiteX12" fmla="*/ 9294 w 10000"/>
                <a:gd name="connsiteY12" fmla="*/ 1768 h 10230"/>
                <a:gd name="connsiteX0" fmla="*/ 9294 w 10000"/>
                <a:gd name="connsiteY0" fmla="*/ 1768 h 10230"/>
                <a:gd name="connsiteX1" fmla="*/ 5835 w 10000"/>
                <a:gd name="connsiteY1" fmla="*/ 28 h 10230"/>
                <a:gd name="connsiteX2" fmla="*/ 3430 w 10000"/>
                <a:gd name="connsiteY2" fmla="*/ 285 h 10230"/>
                <a:gd name="connsiteX3" fmla="*/ 903 w 10000"/>
                <a:gd name="connsiteY3" fmla="*/ 1639 h 10230"/>
                <a:gd name="connsiteX4" fmla="*/ 473 w 10000"/>
                <a:gd name="connsiteY4" fmla="*/ 8073 h 10230"/>
                <a:gd name="connsiteX5" fmla="*/ 1538 w 10000"/>
                <a:gd name="connsiteY5" fmla="*/ 9580 h 10230"/>
                <a:gd name="connsiteX6" fmla="*/ 3158 w 10000"/>
                <a:gd name="connsiteY6" fmla="*/ 10221 h 10230"/>
                <a:gd name="connsiteX7" fmla="*/ 4358 w 10000"/>
                <a:gd name="connsiteY7" fmla="*/ 9148 h 10230"/>
                <a:gd name="connsiteX8" fmla="*/ 5601 w 10000"/>
                <a:gd name="connsiteY8" fmla="*/ 8661 h 10230"/>
                <a:gd name="connsiteX9" fmla="*/ 7202 w 10000"/>
                <a:gd name="connsiteY9" fmla="*/ 10007 h 10230"/>
                <a:gd name="connsiteX10" fmla="*/ 9407 w 10000"/>
                <a:gd name="connsiteY10" fmla="*/ 8022 h 10230"/>
                <a:gd name="connsiteX11" fmla="*/ 9999 w 10000"/>
                <a:gd name="connsiteY11" fmla="*/ 5566 h 10230"/>
                <a:gd name="connsiteX12" fmla="*/ 9294 w 10000"/>
                <a:gd name="connsiteY12" fmla="*/ 1768 h 10230"/>
                <a:gd name="connsiteX0" fmla="*/ 9294 w 10000"/>
                <a:gd name="connsiteY0" fmla="*/ 1948 h 10410"/>
                <a:gd name="connsiteX1" fmla="*/ 5835 w 10000"/>
                <a:gd name="connsiteY1" fmla="*/ 208 h 10410"/>
                <a:gd name="connsiteX2" fmla="*/ 3310 w 10000"/>
                <a:gd name="connsiteY2" fmla="*/ 209 h 10410"/>
                <a:gd name="connsiteX3" fmla="*/ 903 w 10000"/>
                <a:gd name="connsiteY3" fmla="*/ 1819 h 10410"/>
                <a:gd name="connsiteX4" fmla="*/ 473 w 10000"/>
                <a:gd name="connsiteY4" fmla="*/ 8253 h 10410"/>
                <a:gd name="connsiteX5" fmla="*/ 1538 w 10000"/>
                <a:gd name="connsiteY5" fmla="*/ 9760 h 10410"/>
                <a:gd name="connsiteX6" fmla="*/ 3158 w 10000"/>
                <a:gd name="connsiteY6" fmla="*/ 10401 h 10410"/>
                <a:gd name="connsiteX7" fmla="*/ 4358 w 10000"/>
                <a:gd name="connsiteY7" fmla="*/ 9328 h 10410"/>
                <a:gd name="connsiteX8" fmla="*/ 5601 w 10000"/>
                <a:gd name="connsiteY8" fmla="*/ 8841 h 10410"/>
                <a:gd name="connsiteX9" fmla="*/ 7202 w 10000"/>
                <a:gd name="connsiteY9" fmla="*/ 10187 h 10410"/>
                <a:gd name="connsiteX10" fmla="*/ 9407 w 10000"/>
                <a:gd name="connsiteY10" fmla="*/ 8202 h 10410"/>
                <a:gd name="connsiteX11" fmla="*/ 9999 w 10000"/>
                <a:gd name="connsiteY11" fmla="*/ 5746 h 10410"/>
                <a:gd name="connsiteX12" fmla="*/ 9294 w 10000"/>
                <a:gd name="connsiteY12" fmla="*/ 1948 h 10410"/>
                <a:gd name="connsiteX0" fmla="*/ 9294 w 10000"/>
                <a:gd name="connsiteY0" fmla="*/ 2125 h 10587"/>
                <a:gd name="connsiteX1" fmla="*/ 5734 w 10000"/>
                <a:gd name="connsiteY1" fmla="*/ 132 h 10587"/>
                <a:gd name="connsiteX2" fmla="*/ 3310 w 10000"/>
                <a:gd name="connsiteY2" fmla="*/ 386 h 10587"/>
                <a:gd name="connsiteX3" fmla="*/ 903 w 10000"/>
                <a:gd name="connsiteY3" fmla="*/ 1996 h 10587"/>
                <a:gd name="connsiteX4" fmla="*/ 473 w 10000"/>
                <a:gd name="connsiteY4" fmla="*/ 8430 h 10587"/>
                <a:gd name="connsiteX5" fmla="*/ 1538 w 10000"/>
                <a:gd name="connsiteY5" fmla="*/ 9937 h 10587"/>
                <a:gd name="connsiteX6" fmla="*/ 3158 w 10000"/>
                <a:gd name="connsiteY6" fmla="*/ 10578 h 10587"/>
                <a:gd name="connsiteX7" fmla="*/ 4358 w 10000"/>
                <a:gd name="connsiteY7" fmla="*/ 9505 h 10587"/>
                <a:gd name="connsiteX8" fmla="*/ 5601 w 10000"/>
                <a:gd name="connsiteY8" fmla="*/ 9018 h 10587"/>
                <a:gd name="connsiteX9" fmla="*/ 7202 w 10000"/>
                <a:gd name="connsiteY9" fmla="*/ 10364 h 10587"/>
                <a:gd name="connsiteX10" fmla="*/ 9407 w 10000"/>
                <a:gd name="connsiteY10" fmla="*/ 8379 h 10587"/>
                <a:gd name="connsiteX11" fmla="*/ 9999 w 10000"/>
                <a:gd name="connsiteY11" fmla="*/ 5923 h 10587"/>
                <a:gd name="connsiteX12" fmla="*/ 9294 w 10000"/>
                <a:gd name="connsiteY12" fmla="*/ 2125 h 10587"/>
                <a:gd name="connsiteX0" fmla="*/ 9294 w 10000"/>
                <a:gd name="connsiteY0" fmla="*/ 1999 h 10461"/>
                <a:gd name="connsiteX1" fmla="*/ 5734 w 10000"/>
                <a:gd name="connsiteY1" fmla="*/ 6 h 10461"/>
                <a:gd name="connsiteX2" fmla="*/ 3310 w 10000"/>
                <a:gd name="connsiteY2" fmla="*/ 260 h 10461"/>
                <a:gd name="connsiteX3" fmla="*/ 903 w 10000"/>
                <a:gd name="connsiteY3" fmla="*/ 1870 h 10461"/>
                <a:gd name="connsiteX4" fmla="*/ 473 w 10000"/>
                <a:gd name="connsiteY4" fmla="*/ 8304 h 10461"/>
                <a:gd name="connsiteX5" fmla="*/ 1538 w 10000"/>
                <a:gd name="connsiteY5" fmla="*/ 9811 h 10461"/>
                <a:gd name="connsiteX6" fmla="*/ 3158 w 10000"/>
                <a:gd name="connsiteY6" fmla="*/ 10452 h 10461"/>
                <a:gd name="connsiteX7" fmla="*/ 4358 w 10000"/>
                <a:gd name="connsiteY7" fmla="*/ 9379 h 10461"/>
                <a:gd name="connsiteX8" fmla="*/ 5601 w 10000"/>
                <a:gd name="connsiteY8" fmla="*/ 8892 h 10461"/>
                <a:gd name="connsiteX9" fmla="*/ 7202 w 10000"/>
                <a:gd name="connsiteY9" fmla="*/ 10238 h 10461"/>
                <a:gd name="connsiteX10" fmla="*/ 9407 w 10000"/>
                <a:gd name="connsiteY10" fmla="*/ 8253 h 10461"/>
                <a:gd name="connsiteX11" fmla="*/ 9999 w 10000"/>
                <a:gd name="connsiteY11" fmla="*/ 5797 h 10461"/>
                <a:gd name="connsiteX12" fmla="*/ 9294 w 10000"/>
                <a:gd name="connsiteY12" fmla="*/ 1999 h 10461"/>
                <a:gd name="connsiteX0" fmla="*/ 9294 w 10000"/>
                <a:gd name="connsiteY0" fmla="*/ 2106 h 10568"/>
                <a:gd name="connsiteX1" fmla="*/ 5727 w 10000"/>
                <a:gd name="connsiteY1" fmla="*/ 0 h 10568"/>
                <a:gd name="connsiteX2" fmla="*/ 3310 w 10000"/>
                <a:gd name="connsiteY2" fmla="*/ 367 h 10568"/>
                <a:gd name="connsiteX3" fmla="*/ 903 w 10000"/>
                <a:gd name="connsiteY3" fmla="*/ 1977 h 10568"/>
                <a:gd name="connsiteX4" fmla="*/ 473 w 10000"/>
                <a:gd name="connsiteY4" fmla="*/ 8411 h 10568"/>
                <a:gd name="connsiteX5" fmla="*/ 1538 w 10000"/>
                <a:gd name="connsiteY5" fmla="*/ 9918 h 10568"/>
                <a:gd name="connsiteX6" fmla="*/ 3158 w 10000"/>
                <a:gd name="connsiteY6" fmla="*/ 10559 h 10568"/>
                <a:gd name="connsiteX7" fmla="*/ 4358 w 10000"/>
                <a:gd name="connsiteY7" fmla="*/ 9486 h 10568"/>
                <a:gd name="connsiteX8" fmla="*/ 5601 w 10000"/>
                <a:gd name="connsiteY8" fmla="*/ 8999 h 10568"/>
                <a:gd name="connsiteX9" fmla="*/ 7202 w 10000"/>
                <a:gd name="connsiteY9" fmla="*/ 10345 h 10568"/>
                <a:gd name="connsiteX10" fmla="*/ 9407 w 10000"/>
                <a:gd name="connsiteY10" fmla="*/ 8360 h 10568"/>
                <a:gd name="connsiteX11" fmla="*/ 9999 w 10000"/>
                <a:gd name="connsiteY11" fmla="*/ 5904 h 10568"/>
                <a:gd name="connsiteX12" fmla="*/ 9294 w 10000"/>
                <a:gd name="connsiteY12" fmla="*/ 2106 h 10568"/>
                <a:gd name="connsiteX0" fmla="*/ 9294 w 10000"/>
                <a:gd name="connsiteY0" fmla="*/ 2106 h 10568"/>
                <a:gd name="connsiteX1" fmla="*/ 5727 w 10000"/>
                <a:gd name="connsiteY1" fmla="*/ 0 h 10568"/>
                <a:gd name="connsiteX2" fmla="*/ 3310 w 10000"/>
                <a:gd name="connsiteY2" fmla="*/ 367 h 10568"/>
                <a:gd name="connsiteX3" fmla="*/ 903 w 10000"/>
                <a:gd name="connsiteY3" fmla="*/ 1977 h 10568"/>
                <a:gd name="connsiteX4" fmla="*/ 473 w 10000"/>
                <a:gd name="connsiteY4" fmla="*/ 8411 h 10568"/>
                <a:gd name="connsiteX5" fmla="*/ 1538 w 10000"/>
                <a:gd name="connsiteY5" fmla="*/ 9918 h 10568"/>
                <a:gd name="connsiteX6" fmla="*/ 3158 w 10000"/>
                <a:gd name="connsiteY6" fmla="*/ 10559 h 10568"/>
                <a:gd name="connsiteX7" fmla="*/ 4358 w 10000"/>
                <a:gd name="connsiteY7" fmla="*/ 9486 h 10568"/>
                <a:gd name="connsiteX8" fmla="*/ 5601 w 10000"/>
                <a:gd name="connsiteY8" fmla="*/ 8999 h 10568"/>
                <a:gd name="connsiteX9" fmla="*/ 7202 w 10000"/>
                <a:gd name="connsiteY9" fmla="*/ 10345 h 10568"/>
                <a:gd name="connsiteX10" fmla="*/ 9407 w 10000"/>
                <a:gd name="connsiteY10" fmla="*/ 8360 h 10568"/>
                <a:gd name="connsiteX11" fmla="*/ 9999 w 10000"/>
                <a:gd name="connsiteY11" fmla="*/ 5904 h 10568"/>
                <a:gd name="connsiteX12" fmla="*/ 9294 w 10000"/>
                <a:gd name="connsiteY12" fmla="*/ 2106 h 10568"/>
                <a:gd name="connsiteX0" fmla="*/ 9294 w 10000"/>
                <a:gd name="connsiteY0" fmla="*/ 2106 h 10568"/>
                <a:gd name="connsiteX1" fmla="*/ 5727 w 10000"/>
                <a:gd name="connsiteY1" fmla="*/ 0 h 10568"/>
                <a:gd name="connsiteX2" fmla="*/ 3310 w 10000"/>
                <a:gd name="connsiteY2" fmla="*/ 367 h 10568"/>
                <a:gd name="connsiteX3" fmla="*/ 903 w 10000"/>
                <a:gd name="connsiteY3" fmla="*/ 1977 h 10568"/>
                <a:gd name="connsiteX4" fmla="*/ 473 w 10000"/>
                <a:gd name="connsiteY4" fmla="*/ 8411 h 10568"/>
                <a:gd name="connsiteX5" fmla="*/ 1538 w 10000"/>
                <a:gd name="connsiteY5" fmla="*/ 9918 h 10568"/>
                <a:gd name="connsiteX6" fmla="*/ 3158 w 10000"/>
                <a:gd name="connsiteY6" fmla="*/ 10559 h 10568"/>
                <a:gd name="connsiteX7" fmla="*/ 4358 w 10000"/>
                <a:gd name="connsiteY7" fmla="*/ 9486 h 10568"/>
                <a:gd name="connsiteX8" fmla="*/ 5601 w 10000"/>
                <a:gd name="connsiteY8" fmla="*/ 8999 h 10568"/>
                <a:gd name="connsiteX9" fmla="*/ 7202 w 10000"/>
                <a:gd name="connsiteY9" fmla="*/ 10345 h 10568"/>
                <a:gd name="connsiteX10" fmla="*/ 9407 w 10000"/>
                <a:gd name="connsiteY10" fmla="*/ 8360 h 10568"/>
                <a:gd name="connsiteX11" fmla="*/ 9999 w 10000"/>
                <a:gd name="connsiteY11" fmla="*/ 5904 h 10568"/>
                <a:gd name="connsiteX12" fmla="*/ 9294 w 10000"/>
                <a:gd name="connsiteY12" fmla="*/ 2106 h 10568"/>
                <a:gd name="connsiteX0" fmla="*/ 9294 w 10000"/>
                <a:gd name="connsiteY0" fmla="*/ 2106 h 10568"/>
                <a:gd name="connsiteX1" fmla="*/ 5727 w 10000"/>
                <a:gd name="connsiteY1" fmla="*/ 0 h 10568"/>
                <a:gd name="connsiteX2" fmla="*/ 3310 w 10000"/>
                <a:gd name="connsiteY2" fmla="*/ 367 h 10568"/>
                <a:gd name="connsiteX3" fmla="*/ 903 w 10000"/>
                <a:gd name="connsiteY3" fmla="*/ 1977 h 10568"/>
                <a:gd name="connsiteX4" fmla="*/ 473 w 10000"/>
                <a:gd name="connsiteY4" fmla="*/ 8411 h 10568"/>
                <a:gd name="connsiteX5" fmla="*/ 1538 w 10000"/>
                <a:gd name="connsiteY5" fmla="*/ 9918 h 10568"/>
                <a:gd name="connsiteX6" fmla="*/ 3158 w 10000"/>
                <a:gd name="connsiteY6" fmla="*/ 10559 h 10568"/>
                <a:gd name="connsiteX7" fmla="*/ 4358 w 10000"/>
                <a:gd name="connsiteY7" fmla="*/ 9486 h 10568"/>
                <a:gd name="connsiteX8" fmla="*/ 5601 w 10000"/>
                <a:gd name="connsiteY8" fmla="*/ 8999 h 10568"/>
                <a:gd name="connsiteX9" fmla="*/ 7202 w 10000"/>
                <a:gd name="connsiteY9" fmla="*/ 10345 h 10568"/>
                <a:gd name="connsiteX10" fmla="*/ 9407 w 10000"/>
                <a:gd name="connsiteY10" fmla="*/ 8360 h 10568"/>
                <a:gd name="connsiteX11" fmla="*/ 9999 w 10000"/>
                <a:gd name="connsiteY11" fmla="*/ 5904 h 10568"/>
                <a:gd name="connsiteX12" fmla="*/ 9294 w 10000"/>
                <a:gd name="connsiteY12" fmla="*/ 2106 h 10568"/>
                <a:gd name="connsiteX0" fmla="*/ 9294 w 10000"/>
                <a:gd name="connsiteY0" fmla="*/ 2106 h 10568"/>
                <a:gd name="connsiteX1" fmla="*/ 5727 w 10000"/>
                <a:gd name="connsiteY1" fmla="*/ 0 h 10568"/>
                <a:gd name="connsiteX2" fmla="*/ 3310 w 10000"/>
                <a:gd name="connsiteY2" fmla="*/ 367 h 10568"/>
                <a:gd name="connsiteX3" fmla="*/ 903 w 10000"/>
                <a:gd name="connsiteY3" fmla="*/ 1977 h 10568"/>
                <a:gd name="connsiteX4" fmla="*/ 473 w 10000"/>
                <a:gd name="connsiteY4" fmla="*/ 8411 h 10568"/>
                <a:gd name="connsiteX5" fmla="*/ 1538 w 10000"/>
                <a:gd name="connsiteY5" fmla="*/ 9918 h 10568"/>
                <a:gd name="connsiteX6" fmla="*/ 3158 w 10000"/>
                <a:gd name="connsiteY6" fmla="*/ 10559 h 10568"/>
                <a:gd name="connsiteX7" fmla="*/ 4358 w 10000"/>
                <a:gd name="connsiteY7" fmla="*/ 9486 h 10568"/>
                <a:gd name="connsiteX8" fmla="*/ 5601 w 10000"/>
                <a:gd name="connsiteY8" fmla="*/ 8999 h 10568"/>
                <a:gd name="connsiteX9" fmla="*/ 7202 w 10000"/>
                <a:gd name="connsiteY9" fmla="*/ 10345 h 10568"/>
                <a:gd name="connsiteX10" fmla="*/ 9407 w 10000"/>
                <a:gd name="connsiteY10" fmla="*/ 8360 h 10568"/>
                <a:gd name="connsiteX11" fmla="*/ 9999 w 10000"/>
                <a:gd name="connsiteY11" fmla="*/ 5904 h 10568"/>
                <a:gd name="connsiteX12" fmla="*/ 9294 w 10000"/>
                <a:gd name="connsiteY12" fmla="*/ 2106 h 10568"/>
                <a:gd name="connsiteX0" fmla="*/ 9294 w 10000"/>
                <a:gd name="connsiteY0" fmla="*/ 2106 h 10568"/>
                <a:gd name="connsiteX1" fmla="*/ 5727 w 10000"/>
                <a:gd name="connsiteY1" fmla="*/ 0 h 10568"/>
                <a:gd name="connsiteX2" fmla="*/ 3310 w 10000"/>
                <a:gd name="connsiteY2" fmla="*/ 367 h 10568"/>
                <a:gd name="connsiteX3" fmla="*/ 903 w 10000"/>
                <a:gd name="connsiteY3" fmla="*/ 1977 h 10568"/>
                <a:gd name="connsiteX4" fmla="*/ 473 w 10000"/>
                <a:gd name="connsiteY4" fmla="*/ 8411 h 10568"/>
                <a:gd name="connsiteX5" fmla="*/ 1538 w 10000"/>
                <a:gd name="connsiteY5" fmla="*/ 9918 h 10568"/>
                <a:gd name="connsiteX6" fmla="*/ 3158 w 10000"/>
                <a:gd name="connsiteY6" fmla="*/ 10559 h 10568"/>
                <a:gd name="connsiteX7" fmla="*/ 4358 w 10000"/>
                <a:gd name="connsiteY7" fmla="*/ 9486 h 10568"/>
                <a:gd name="connsiteX8" fmla="*/ 5601 w 10000"/>
                <a:gd name="connsiteY8" fmla="*/ 8999 h 10568"/>
                <a:gd name="connsiteX9" fmla="*/ 7202 w 10000"/>
                <a:gd name="connsiteY9" fmla="*/ 10345 h 10568"/>
                <a:gd name="connsiteX10" fmla="*/ 9407 w 10000"/>
                <a:gd name="connsiteY10" fmla="*/ 8360 h 10568"/>
                <a:gd name="connsiteX11" fmla="*/ 9999 w 10000"/>
                <a:gd name="connsiteY11" fmla="*/ 5904 h 10568"/>
                <a:gd name="connsiteX12" fmla="*/ 9294 w 10000"/>
                <a:gd name="connsiteY12" fmla="*/ 2106 h 10568"/>
                <a:gd name="connsiteX0" fmla="*/ 9169 w 9875"/>
                <a:gd name="connsiteY0" fmla="*/ 2106 h 10570"/>
                <a:gd name="connsiteX1" fmla="*/ 5602 w 9875"/>
                <a:gd name="connsiteY1" fmla="*/ 0 h 10570"/>
                <a:gd name="connsiteX2" fmla="*/ 3185 w 9875"/>
                <a:gd name="connsiteY2" fmla="*/ 367 h 10570"/>
                <a:gd name="connsiteX3" fmla="*/ 778 w 9875"/>
                <a:gd name="connsiteY3" fmla="*/ 1977 h 10570"/>
                <a:gd name="connsiteX4" fmla="*/ 552 w 9875"/>
                <a:gd name="connsiteY4" fmla="*/ 7955 h 10570"/>
                <a:gd name="connsiteX5" fmla="*/ 1413 w 9875"/>
                <a:gd name="connsiteY5" fmla="*/ 9918 h 10570"/>
                <a:gd name="connsiteX6" fmla="*/ 3033 w 9875"/>
                <a:gd name="connsiteY6" fmla="*/ 10559 h 10570"/>
                <a:gd name="connsiteX7" fmla="*/ 4233 w 9875"/>
                <a:gd name="connsiteY7" fmla="*/ 9486 h 10570"/>
                <a:gd name="connsiteX8" fmla="*/ 5476 w 9875"/>
                <a:gd name="connsiteY8" fmla="*/ 8999 h 10570"/>
                <a:gd name="connsiteX9" fmla="*/ 7077 w 9875"/>
                <a:gd name="connsiteY9" fmla="*/ 10345 h 10570"/>
                <a:gd name="connsiteX10" fmla="*/ 9282 w 9875"/>
                <a:gd name="connsiteY10" fmla="*/ 8360 h 10570"/>
                <a:gd name="connsiteX11" fmla="*/ 9874 w 9875"/>
                <a:gd name="connsiteY11" fmla="*/ 5904 h 10570"/>
                <a:gd name="connsiteX12" fmla="*/ 9169 w 9875"/>
                <a:gd name="connsiteY12" fmla="*/ 2106 h 10570"/>
                <a:gd name="connsiteX0" fmla="*/ 9285 w 10000"/>
                <a:gd name="connsiteY0" fmla="*/ 1992 h 9990"/>
                <a:gd name="connsiteX1" fmla="*/ 5673 w 10000"/>
                <a:gd name="connsiteY1" fmla="*/ 0 h 9990"/>
                <a:gd name="connsiteX2" fmla="*/ 3225 w 10000"/>
                <a:gd name="connsiteY2" fmla="*/ 347 h 9990"/>
                <a:gd name="connsiteX3" fmla="*/ 788 w 10000"/>
                <a:gd name="connsiteY3" fmla="*/ 1870 h 9990"/>
                <a:gd name="connsiteX4" fmla="*/ 559 w 10000"/>
                <a:gd name="connsiteY4" fmla="*/ 7526 h 9990"/>
                <a:gd name="connsiteX5" fmla="*/ 1657 w 10000"/>
                <a:gd name="connsiteY5" fmla="*/ 9039 h 9990"/>
                <a:gd name="connsiteX6" fmla="*/ 3071 w 10000"/>
                <a:gd name="connsiteY6" fmla="*/ 9990 h 9990"/>
                <a:gd name="connsiteX7" fmla="*/ 4287 w 10000"/>
                <a:gd name="connsiteY7" fmla="*/ 8974 h 9990"/>
                <a:gd name="connsiteX8" fmla="*/ 5545 w 10000"/>
                <a:gd name="connsiteY8" fmla="*/ 8514 h 9990"/>
                <a:gd name="connsiteX9" fmla="*/ 7167 w 10000"/>
                <a:gd name="connsiteY9" fmla="*/ 9787 h 9990"/>
                <a:gd name="connsiteX10" fmla="*/ 9399 w 10000"/>
                <a:gd name="connsiteY10" fmla="*/ 7909 h 9990"/>
                <a:gd name="connsiteX11" fmla="*/ 9999 w 10000"/>
                <a:gd name="connsiteY11" fmla="*/ 5586 h 9990"/>
                <a:gd name="connsiteX12" fmla="*/ 9285 w 10000"/>
                <a:gd name="connsiteY12" fmla="*/ 1992 h 9990"/>
                <a:gd name="connsiteX0" fmla="*/ 9285 w 10000"/>
                <a:gd name="connsiteY0" fmla="*/ 1994 h 9827"/>
                <a:gd name="connsiteX1" fmla="*/ 5673 w 10000"/>
                <a:gd name="connsiteY1" fmla="*/ 0 h 9827"/>
                <a:gd name="connsiteX2" fmla="*/ 3225 w 10000"/>
                <a:gd name="connsiteY2" fmla="*/ 347 h 9827"/>
                <a:gd name="connsiteX3" fmla="*/ 788 w 10000"/>
                <a:gd name="connsiteY3" fmla="*/ 1872 h 9827"/>
                <a:gd name="connsiteX4" fmla="*/ 559 w 10000"/>
                <a:gd name="connsiteY4" fmla="*/ 7534 h 9827"/>
                <a:gd name="connsiteX5" fmla="*/ 1657 w 10000"/>
                <a:gd name="connsiteY5" fmla="*/ 9048 h 9827"/>
                <a:gd name="connsiteX6" fmla="*/ 3133 w 10000"/>
                <a:gd name="connsiteY6" fmla="*/ 9827 h 9827"/>
                <a:gd name="connsiteX7" fmla="*/ 4287 w 10000"/>
                <a:gd name="connsiteY7" fmla="*/ 8983 h 9827"/>
                <a:gd name="connsiteX8" fmla="*/ 5545 w 10000"/>
                <a:gd name="connsiteY8" fmla="*/ 8523 h 9827"/>
                <a:gd name="connsiteX9" fmla="*/ 7167 w 10000"/>
                <a:gd name="connsiteY9" fmla="*/ 9797 h 9827"/>
                <a:gd name="connsiteX10" fmla="*/ 9399 w 10000"/>
                <a:gd name="connsiteY10" fmla="*/ 7917 h 9827"/>
                <a:gd name="connsiteX11" fmla="*/ 9999 w 10000"/>
                <a:gd name="connsiteY11" fmla="*/ 5592 h 9827"/>
                <a:gd name="connsiteX12" fmla="*/ 9285 w 10000"/>
                <a:gd name="connsiteY12" fmla="*/ 1994 h 9827"/>
                <a:gd name="connsiteX0" fmla="*/ 9285 w 10000"/>
                <a:gd name="connsiteY0" fmla="*/ 2029 h 10000"/>
                <a:gd name="connsiteX1" fmla="*/ 5673 w 10000"/>
                <a:gd name="connsiteY1" fmla="*/ 0 h 10000"/>
                <a:gd name="connsiteX2" fmla="*/ 3225 w 10000"/>
                <a:gd name="connsiteY2" fmla="*/ 353 h 10000"/>
                <a:gd name="connsiteX3" fmla="*/ 788 w 10000"/>
                <a:gd name="connsiteY3" fmla="*/ 1905 h 10000"/>
                <a:gd name="connsiteX4" fmla="*/ 559 w 10000"/>
                <a:gd name="connsiteY4" fmla="*/ 7667 h 10000"/>
                <a:gd name="connsiteX5" fmla="*/ 1657 w 10000"/>
                <a:gd name="connsiteY5" fmla="*/ 9207 h 10000"/>
                <a:gd name="connsiteX6" fmla="*/ 3133 w 10000"/>
                <a:gd name="connsiteY6" fmla="*/ 10000 h 10000"/>
                <a:gd name="connsiteX7" fmla="*/ 4287 w 10000"/>
                <a:gd name="connsiteY7" fmla="*/ 9141 h 10000"/>
                <a:gd name="connsiteX8" fmla="*/ 5545 w 10000"/>
                <a:gd name="connsiteY8" fmla="*/ 8673 h 10000"/>
                <a:gd name="connsiteX9" fmla="*/ 7052 w 10000"/>
                <a:gd name="connsiteY9" fmla="*/ 9483 h 10000"/>
                <a:gd name="connsiteX10" fmla="*/ 9399 w 10000"/>
                <a:gd name="connsiteY10" fmla="*/ 8056 h 10000"/>
                <a:gd name="connsiteX11" fmla="*/ 9999 w 10000"/>
                <a:gd name="connsiteY11" fmla="*/ 5690 h 10000"/>
                <a:gd name="connsiteX12" fmla="*/ 9285 w 10000"/>
                <a:gd name="connsiteY12" fmla="*/ 2029 h 10000"/>
                <a:gd name="connsiteX0" fmla="*/ 9285 w 10000"/>
                <a:gd name="connsiteY0" fmla="*/ 2029 h 10000"/>
                <a:gd name="connsiteX1" fmla="*/ 5673 w 10000"/>
                <a:gd name="connsiteY1" fmla="*/ 0 h 10000"/>
                <a:gd name="connsiteX2" fmla="*/ 3225 w 10000"/>
                <a:gd name="connsiteY2" fmla="*/ 353 h 10000"/>
                <a:gd name="connsiteX3" fmla="*/ 788 w 10000"/>
                <a:gd name="connsiteY3" fmla="*/ 1905 h 10000"/>
                <a:gd name="connsiteX4" fmla="*/ 559 w 10000"/>
                <a:gd name="connsiteY4" fmla="*/ 7667 h 10000"/>
                <a:gd name="connsiteX5" fmla="*/ 1657 w 10000"/>
                <a:gd name="connsiteY5" fmla="*/ 9207 h 10000"/>
                <a:gd name="connsiteX6" fmla="*/ 3133 w 10000"/>
                <a:gd name="connsiteY6" fmla="*/ 10000 h 10000"/>
                <a:gd name="connsiteX7" fmla="*/ 4287 w 10000"/>
                <a:gd name="connsiteY7" fmla="*/ 9141 h 10000"/>
                <a:gd name="connsiteX8" fmla="*/ 5545 w 10000"/>
                <a:gd name="connsiteY8" fmla="*/ 8673 h 10000"/>
                <a:gd name="connsiteX9" fmla="*/ 7052 w 10000"/>
                <a:gd name="connsiteY9" fmla="*/ 9483 h 10000"/>
                <a:gd name="connsiteX10" fmla="*/ 9379 w 10000"/>
                <a:gd name="connsiteY10" fmla="*/ 7785 h 10000"/>
                <a:gd name="connsiteX11" fmla="*/ 9999 w 10000"/>
                <a:gd name="connsiteY11" fmla="*/ 5690 h 10000"/>
                <a:gd name="connsiteX12" fmla="*/ 9285 w 10000"/>
                <a:gd name="connsiteY12" fmla="*/ 2029 h 10000"/>
                <a:gd name="connsiteX0" fmla="*/ 9285 w 9999"/>
                <a:gd name="connsiteY0" fmla="*/ 2029 h 10000"/>
                <a:gd name="connsiteX1" fmla="*/ 5673 w 9999"/>
                <a:gd name="connsiteY1" fmla="*/ 0 h 10000"/>
                <a:gd name="connsiteX2" fmla="*/ 3225 w 9999"/>
                <a:gd name="connsiteY2" fmla="*/ 353 h 10000"/>
                <a:gd name="connsiteX3" fmla="*/ 788 w 9999"/>
                <a:gd name="connsiteY3" fmla="*/ 1905 h 10000"/>
                <a:gd name="connsiteX4" fmla="*/ 559 w 9999"/>
                <a:gd name="connsiteY4" fmla="*/ 7667 h 10000"/>
                <a:gd name="connsiteX5" fmla="*/ 1657 w 9999"/>
                <a:gd name="connsiteY5" fmla="*/ 9207 h 10000"/>
                <a:gd name="connsiteX6" fmla="*/ 3133 w 9999"/>
                <a:gd name="connsiteY6" fmla="*/ 10000 h 10000"/>
                <a:gd name="connsiteX7" fmla="*/ 4287 w 9999"/>
                <a:gd name="connsiteY7" fmla="*/ 9141 h 10000"/>
                <a:gd name="connsiteX8" fmla="*/ 5545 w 9999"/>
                <a:gd name="connsiteY8" fmla="*/ 8673 h 10000"/>
                <a:gd name="connsiteX9" fmla="*/ 7052 w 9999"/>
                <a:gd name="connsiteY9" fmla="*/ 9483 h 10000"/>
                <a:gd name="connsiteX10" fmla="*/ 9279 w 9999"/>
                <a:gd name="connsiteY10" fmla="*/ 7651 h 10000"/>
                <a:gd name="connsiteX11" fmla="*/ 9999 w 9999"/>
                <a:gd name="connsiteY11" fmla="*/ 5690 h 10000"/>
                <a:gd name="connsiteX12" fmla="*/ 9285 w 9999"/>
                <a:gd name="connsiteY12" fmla="*/ 2029 h 10000"/>
                <a:gd name="connsiteX0" fmla="*/ 9286 w 9862"/>
                <a:gd name="connsiteY0" fmla="*/ 2029 h 10000"/>
                <a:gd name="connsiteX1" fmla="*/ 5674 w 9862"/>
                <a:gd name="connsiteY1" fmla="*/ 0 h 10000"/>
                <a:gd name="connsiteX2" fmla="*/ 3225 w 9862"/>
                <a:gd name="connsiteY2" fmla="*/ 353 h 10000"/>
                <a:gd name="connsiteX3" fmla="*/ 788 w 9862"/>
                <a:gd name="connsiteY3" fmla="*/ 1905 h 10000"/>
                <a:gd name="connsiteX4" fmla="*/ 559 w 9862"/>
                <a:gd name="connsiteY4" fmla="*/ 7667 h 10000"/>
                <a:gd name="connsiteX5" fmla="*/ 1657 w 9862"/>
                <a:gd name="connsiteY5" fmla="*/ 9207 h 10000"/>
                <a:gd name="connsiteX6" fmla="*/ 3133 w 9862"/>
                <a:gd name="connsiteY6" fmla="*/ 10000 h 10000"/>
                <a:gd name="connsiteX7" fmla="*/ 4287 w 9862"/>
                <a:gd name="connsiteY7" fmla="*/ 9141 h 10000"/>
                <a:gd name="connsiteX8" fmla="*/ 5546 w 9862"/>
                <a:gd name="connsiteY8" fmla="*/ 8673 h 10000"/>
                <a:gd name="connsiteX9" fmla="*/ 7053 w 9862"/>
                <a:gd name="connsiteY9" fmla="*/ 9483 h 10000"/>
                <a:gd name="connsiteX10" fmla="*/ 9280 w 9862"/>
                <a:gd name="connsiteY10" fmla="*/ 7651 h 10000"/>
                <a:gd name="connsiteX11" fmla="*/ 9861 w 9862"/>
                <a:gd name="connsiteY11" fmla="*/ 5377 h 10000"/>
                <a:gd name="connsiteX12" fmla="*/ 9286 w 9862"/>
                <a:gd name="connsiteY12" fmla="*/ 2029 h 10000"/>
                <a:gd name="connsiteX0" fmla="*/ 9416 w 9999"/>
                <a:gd name="connsiteY0" fmla="*/ 2029 h 10000"/>
                <a:gd name="connsiteX1" fmla="*/ 5753 w 9999"/>
                <a:gd name="connsiteY1" fmla="*/ 0 h 10000"/>
                <a:gd name="connsiteX2" fmla="*/ 3270 w 9999"/>
                <a:gd name="connsiteY2" fmla="*/ 353 h 10000"/>
                <a:gd name="connsiteX3" fmla="*/ 799 w 9999"/>
                <a:gd name="connsiteY3" fmla="*/ 1905 h 10000"/>
                <a:gd name="connsiteX4" fmla="*/ 567 w 9999"/>
                <a:gd name="connsiteY4" fmla="*/ 7667 h 10000"/>
                <a:gd name="connsiteX5" fmla="*/ 1680 w 9999"/>
                <a:gd name="connsiteY5" fmla="*/ 9207 h 10000"/>
                <a:gd name="connsiteX6" fmla="*/ 3177 w 9999"/>
                <a:gd name="connsiteY6" fmla="*/ 10000 h 10000"/>
                <a:gd name="connsiteX7" fmla="*/ 4347 w 9999"/>
                <a:gd name="connsiteY7" fmla="*/ 9141 h 10000"/>
                <a:gd name="connsiteX8" fmla="*/ 5624 w 9999"/>
                <a:gd name="connsiteY8" fmla="*/ 8673 h 10000"/>
                <a:gd name="connsiteX9" fmla="*/ 7152 w 9999"/>
                <a:gd name="connsiteY9" fmla="*/ 9483 h 10000"/>
                <a:gd name="connsiteX10" fmla="*/ 9410 w 9999"/>
                <a:gd name="connsiteY10" fmla="*/ 7651 h 10000"/>
                <a:gd name="connsiteX11" fmla="*/ 9999 w 9999"/>
                <a:gd name="connsiteY11" fmla="*/ 5377 h 10000"/>
                <a:gd name="connsiteX12" fmla="*/ 9416 w 9999"/>
                <a:gd name="connsiteY12" fmla="*/ 2029 h 10000"/>
                <a:gd name="connsiteX0" fmla="*/ 9378 w 9961"/>
                <a:gd name="connsiteY0" fmla="*/ 2029 h 10000"/>
                <a:gd name="connsiteX1" fmla="*/ 5715 w 9961"/>
                <a:gd name="connsiteY1" fmla="*/ 0 h 10000"/>
                <a:gd name="connsiteX2" fmla="*/ 3231 w 9961"/>
                <a:gd name="connsiteY2" fmla="*/ 353 h 10000"/>
                <a:gd name="connsiteX3" fmla="*/ 760 w 9961"/>
                <a:gd name="connsiteY3" fmla="*/ 1905 h 10000"/>
                <a:gd name="connsiteX4" fmla="*/ 598 w 9961"/>
                <a:gd name="connsiteY4" fmla="*/ 7460 h 10000"/>
                <a:gd name="connsiteX5" fmla="*/ 1641 w 9961"/>
                <a:gd name="connsiteY5" fmla="*/ 9207 h 10000"/>
                <a:gd name="connsiteX6" fmla="*/ 3138 w 9961"/>
                <a:gd name="connsiteY6" fmla="*/ 10000 h 10000"/>
                <a:gd name="connsiteX7" fmla="*/ 4308 w 9961"/>
                <a:gd name="connsiteY7" fmla="*/ 9141 h 10000"/>
                <a:gd name="connsiteX8" fmla="*/ 5586 w 9961"/>
                <a:gd name="connsiteY8" fmla="*/ 8673 h 10000"/>
                <a:gd name="connsiteX9" fmla="*/ 7114 w 9961"/>
                <a:gd name="connsiteY9" fmla="*/ 9483 h 10000"/>
                <a:gd name="connsiteX10" fmla="*/ 9372 w 9961"/>
                <a:gd name="connsiteY10" fmla="*/ 7651 h 10000"/>
                <a:gd name="connsiteX11" fmla="*/ 9961 w 9961"/>
                <a:gd name="connsiteY11" fmla="*/ 5377 h 10000"/>
                <a:gd name="connsiteX12" fmla="*/ 9378 w 9961"/>
                <a:gd name="connsiteY12" fmla="*/ 2029 h 100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</a:cxnLst>
              <a:rect l="l" t="t" r="r" b="b"/>
              <a:pathLst>
                <a:path w="9961" h="10000">
                  <a:moveTo>
                    <a:pt x="9378" y="2029"/>
                  </a:moveTo>
                  <a:cubicBezTo>
                    <a:pt x="8212" y="-74"/>
                    <a:pt x="6819" y="4"/>
                    <a:pt x="5715" y="0"/>
                  </a:cubicBezTo>
                  <a:cubicBezTo>
                    <a:pt x="4610" y="-4"/>
                    <a:pt x="4203" y="100"/>
                    <a:pt x="3231" y="353"/>
                  </a:cubicBezTo>
                  <a:cubicBezTo>
                    <a:pt x="2260" y="608"/>
                    <a:pt x="1442" y="974"/>
                    <a:pt x="760" y="1905"/>
                  </a:cubicBezTo>
                  <a:cubicBezTo>
                    <a:pt x="-185" y="3164"/>
                    <a:pt x="-258" y="5012"/>
                    <a:pt x="598" y="7460"/>
                  </a:cubicBezTo>
                  <a:cubicBezTo>
                    <a:pt x="898" y="8304"/>
                    <a:pt x="1218" y="8784"/>
                    <a:pt x="1641" y="9207"/>
                  </a:cubicBezTo>
                  <a:cubicBezTo>
                    <a:pt x="2064" y="9630"/>
                    <a:pt x="2694" y="10011"/>
                    <a:pt x="3138" y="10000"/>
                  </a:cubicBezTo>
                  <a:cubicBezTo>
                    <a:pt x="3582" y="9989"/>
                    <a:pt x="3900" y="9362"/>
                    <a:pt x="4308" y="9141"/>
                  </a:cubicBezTo>
                  <a:cubicBezTo>
                    <a:pt x="4716" y="8920"/>
                    <a:pt x="5118" y="8616"/>
                    <a:pt x="5586" y="8673"/>
                  </a:cubicBezTo>
                  <a:cubicBezTo>
                    <a:pt x="6053" y="8730"/>
                    <a:pt x="6483" y="9653"/>
                    <a:pt x="7114" y="9483"/>
                  </a:cubicBezTo>
                  <a:cubicBezTo>
                    <a:pt x="7744" y="9313"/>
                    <a:pt x="8894" y="8365"/>
                    <a:pt x="9372" y="7651"/>
                  </a:cubicBezTo>
                  <a:cubicBezTo>
                    <a:pt x="9838" y="6942"/>
                    <a:pt x="9820" y="6524"/>
                    <a:pt x="9961" y="5377"/>
                  </a:cubicBezTo>
                  <a:cubicBezTo>
                    <a:pt x="9942" y="4372"/>
                    <a:pt x="9740" y="2768"/>
                    <a:pt x="9378" y="2029"/>
                  </a:cubicBezTo>
                  <a:close/>
                </a:path>
              </a:pathLst>
            </a:custGeom>
            <a:gradFill>
              <a:gsLst>
                <a:gs pos="0">
                  <a:schemeClr val="accent6">
                    <a:lumMod val="5000"/>
                    <a:lumOff val="95000"/>
                  </a:schemeClr>
                </a:gs>
                <a:gs pos="74000">
                  <a:schemeClr val="accent6">
                    <a:lumMod val="45000"/>
                    <a:lumOff val="55000"/>
                  </a:schemeClr>
                </a:gs>
                <a:gs pos="83000">
                  <a:schemeClr val="accent6">
                    <a:lumMod val="45000"/>
                    <a:lumOff val="55000"/>
                  </a:schemeClr>
                </a:gs>
                <a:gs pos="100000">
                  <a:schemeClr val="accent6">
                    <a:lumMod val="30000"/>
                    <a:lumOff val="70000"/>
                  </a:schemeClr>
                </a:gs>
              </a:gsLst>
              <a:lin ang="5400000" scaled="1"/>
            </a:gradFill>
            <a:ln w="9525">
              <a:solidFill>
                <a:schemeClr val="tx1"/>
              </a:solidFill>
            </a:ln>
            <a:effectLst>
              <a:softEdge rad="12700"/>
            </a:effectLst>
          </p:spPr>
          <p:txBody>
            <a:bodyPr/>
            <a:lstStyle/>
            <a:p>
              <a:endParaRPr lang="zh-CN" altLang="en-US" sz="1400" dirty="0"/>
            </a:p>
          </p:txBody>
        </p:sp>
        <p:grpSp>
          <p:nvGrpSpPr>
            <p:cNvPr id="900" name="组合 899">
              <a:extLst>
                <a:ext uri="{FF2B5EF4-FFF2-40B4-BE49-F238E27FC236}">
                  <a16:creationId xmlns:a16="http://schemas.microsoft.com/office/drawing/2014/main" id="{F54D5056-49A1-E01F-D412-1CE334B122CE}"/>
                </a:ext>
              </a:extLst>
            </p:cNvPr>
            <p:cNvGrpSpPr/>
            <p:nvPr/>
          </p:nvGrpSpPr>
          <p:grpSpPr>
            <a:xfrm rot="14598252">
              <a:off x="4895744" y="3893767"/>
              <a:ext cx="3176611" cy="2943241"/>
              <a:chOff x="-2901535" y="2775402"/>
              <a:chExt cx="5247539" cy="4862028"/>
            </a:xfrm>
          </p:grpSpPr>
          <p:grpSp>
            <p:nvGrpSpPr>
              <p:cNvPr id="955" name="组合 954">
                <a:extLst>
                  <a:ext uri="{FF2B5EF4-FFF2-40B4-BE49-F238E27FC236}">
                    <a16:creationId xmlns:a16="http://schemas.microsoft.com/office/drawing/2014/main" id="{F188463B-234E-7003-675B-E1A826C2FD5E}"/>
                  </a:ext>
                </a:extLst>
              </p:cNvPr>
              <p:cNvGrpSpPr/>
              <p:nvPr/>
            </p:nvGrpSpPr>
            <p:grpSpPr>
              <a:xfrm rot="255497">
                <a:off x="-2901535" y="2775402"/>
                <a:ext cx="5247539" cy="4862028"/>
                <a:chOff x="-2901535" y="3323832"/>
                <a:chExt cx="4655623" cy="4313597"/>
              </a:xfrm>
            </p:grpSpPr>
            <p:sp>
              <p:nvSpPr>
                <p:cNvPr id="957" name="Freeform 590">
                  <a:extLst>
                    <a:ext uri="{FF2B5EF4-FFF2-40B4-BE49-F238E27FC236}">
                      <a16:creationId xmlns:a16="http://schemas.microsoft.com/office/drawing/2014/main" id="{88D5F370-6DED-1BA1-F20A-B08FC328B8AD}"/>
                    </a:ext>
                  </a:extLst>
                </p:cNvPr>
                <p:cNvSpPr/>
                <p:nvPr/>
              </p:nvSpPr>
              <p:spPr>
                <a:xfrm rot="18956618">
                  <a:off x="-2901535" y="3354551"/>
                  <a:ext cx="4577861" cy="4240418"/>
                </a:xfrm>
                <a:custGeom>
                  <a:avLst/>
                  <a:gdLst/>
                  <a:ahLst/>
                  <a:cxnLst>
                    <a:cxn ang="0">
                      <a:pos x="3190" y="2956"/>
                    </a:cxn>
                    <a:cxn ang="0">
                      <a:pos x="1981" y="10159"/>
                    </a:cxn>
                    <a:cxn ang="0">
                      <a:pos x="6774" y="13440"/>
                    </a:cxn>
                    <a:cxn ang="0">
                      <a:pos x="11137" y="11607"/>
                    </a:cxn>
                    <a:cxn ang="0">
                      <a:pos x="3190" y="2956"/>
                    </a:cxn>
                  </a:cxnLst>
                  <a:rect l="0" t="0" r="0" b="0"/>
                  <a:pathLst>
                    <a:path w="312" h="289">
                      <a:moveTo>
                        <a:pt x="68" y="63"/>
                      </a:moveTo>
                      <a:cubicBezTo>
                        <a:pt x="0" y="126"/>
                        <a:pt x="21" y="176"/>
                        <a:pt x="42" y="216"/>
                      </a:cubicBezTo>
                      <a:cubicBezTo>
                        <a:pt x="63" y="257"/>
                        <a:pt x="89" y="283"/>
                        <a:pt x="144" y="286"/>
                      </a:cubicBezTo>
                      <a:cubicBezTo>
                        <a:pt x="189" y="289"/>
                        <a:pt x="203" y="289"/>
                        <a:pt x="237" y="247"/>
                      </a:cubicBezTo>
                      <a:cubicBezTo>
                        <a:pt x="312" y="160"/>
                        <a:pt x="137" y="0"/>
                        <a:pt x="68" y="63"/>
                      </a:cubicBezTo>
                      <a:close/>
                    </a:path>
                  </a:pathLst>
                </a:custGeom>
                <a:noFill/>
                <a:ln w="160338" cap="flat" cmpd="sng">
                  <a:solidFill>
                    <a:srgbClr val="D6838D">
                      <a:alpha val="100000"/>
                    </a:srgbClr>
                  </a:solidFill>
                  <a:prstDash val="solid"/>
                  <a:miter lim="800000"/>
                  <a:headEnd type="none" w="med" len="med"/>
                  <a:tailEnd type="none" w="med" len="med"/>
                </a:ln>
              </p:spPr>
              <p:txBody>
                <a:bodyPr/>
                <a:lstStyle/>
                <a:p>
                  <a:endParaRPr lang="zh-CN" altLang="en-US" sz="1400"/>
                </a:p>
              </p:txBody>
            </p:sp>
            <p:sp>
              <p:nvSpPr>
                <p:cNvPr id="958" name="Freeform 596">
                  <a:extLst>
                    <a:ext uri="{FF2B5EF4-FFF2-40B4-BE49-F238E27FC236}">
                      <a16:creationId xmlns:a16="http://schemas.microsoft.com/office/drawing/2014/main" id="{A6A3F081-A5B1-493A-4F87-17943DB95BD3}"/>
                    </a:ext>
                  </a:extLst>
                </p:cNvPr>
                <p:cNvSpPr/>
                <p:nvPr/>
              </p:nvSpPr>
              <p:spPr>
                <a:xfrm rot="18956618">
                  <a:off x="-2845201" y="3371495"/>
                  <a:ext cx="4539236" cy="4220970"/>
                </a:xfrm>
                <a:custGeom>
                  <a:avLst/>
                  <a:gdLst/>
                  <a:ahLst/>
                  <a:cxnLst>
                    <a:cxn ang="0">
                      <a:pos x="3246" y="2956"/>
                    </a:cxn>
                    <a:cxn ang="0">
                      <a:pos x="2163" y="10393"/>
                    </a:cxn>
                    <a:cxn ang="0">
                      <a:pos x="6962" y="13674"/>
                    </a:cxn>
                    <a:cxn ang="0">
                      <a:pos x="11341" y="11837"/>
                    </a:cxn>
                    <a:cxn ang="0">
                      <a:pos x="3246" y="2956"/>
                    </a:cxn>
                  </a:cxnLst>
                  <a:rect l="0" t="0" r="0" b="0"/>
                  <a:pathLst>
                    <a:path w="316" h="294">
                      <a:moveTo>
                        <a:pt x="69" y="63"/>
                      </a:moveTo>
                      <a:cubicBezTo>
                        <a:pt x="0" y="126"/>
                        <a:pt x="25" y="181"/>
                        <a:pt x="46" y="221"/>
                      </a:cubicBezTo>
                      <a:cubicBezTo>
                        <a:pt x="67" y="262"/>
                        <a:pt x="93" y="288"/>
                        <a:pt x="148" y="291"/>
                      </a:cubicBezTo>
                      <a:cubicBezTo>
                        <a:pt x="193" y="294"/>
                        <a:pt x="207" y="294"/>
                        <a:pt x="241" y="252"/>
                      </a:cubicBezTo>
                      <a:cubicBezTo>
                        <a:pt x="316" y="165"/>
                        <a:pt x="137" y="0"/>
                        <a:pt x="69" y="63"/>
                      </a:cubicBezTo>
                      <a:close/>
                    </a:path>
                  </a:pathLst>
                </a:custGeom>
                <a:solidFill>
                  <a:srgbClr val="EBF8FB">
                    <a:alpha val="100000"/>
                  </a:srgbClr>
                </a:solidFill>
                <a:ln w="9525">
                  <a:noFill/>
                </a:ln>
              </p:spPr>
              <p:txBody>
                <a:bodyPr/>
                <a:lstStyle/>
                <a:p>
                  <a:endParaRPr lang="zh-CN" altLang="en-US" sz="1400" dirty="0"/>
                </a:p>
              </p:txBody>
            </p:sp>
            <p:sp>
              <p:nvSpPr>
                <p:cNvPr id="959" name="Freeform 727">
                  <a:extLst>
                    <a:ext uri="{FF2B5EF4-FFF2-40B4-BE49-F238E27FC236}">
                      <a16:creationId xmlns:a16="http://schemas.microsoft.com/office/drawing/2014/main" id="{ACF2BF8C-52C3-6A13-ED8B-83625239726E}"/>
                    </a:ext>
                  </a:extLst>
                </p:cNvPr>
                <p:cNvSpPr/>
                <p:nvPr/>
              </p:nvSpPr>
              <p:spPr>
                <a:xfrm rot="18956618">
                  <a:off x="-2884759" y="3323832"/>
                  <a:ext cx="4638847" cy="4313597"/>
                </a:xfrm>
                <a:custGeom>
                  <a:avLst/>
                  <a:gdLst/>
                  <a:ahLst/>
                  <a:cxnLst>
                    <a:cxn ang="0">
                      <a:pos x="3246" y="2956"/>
                    </a:cxn>
                    <a:cxn ang="0">
                      <a:pos x="2163" y="10393"/>
                    </a:cxn>
                    <a:cxn ang="0">
                      <a:pos x="6962" y="13674"/>
                    </a:cxn>
                    <a:cxn ang="0">
                      <a:pos x="11341" y="11837"/>
                    </a:cxn>
                    <a:cxn ang="0">
                      <a:pos x="3246" y="2956"/>
                    </a:cxn>
                  </a:cxnLst>
                  <a:rect l="0" t="0" r="0" b="0"/>
                  <a:pathLst>
                    <a:path w="316" h="294">
                      <a:moveTo>
                        <a:pt x="69" y="63"/>
                      </a:moveTo>
                      <a:cubicBezTo>
                        <a:pt x="0" y="126"/>
                        <a:pt x="25" y="181"/>
                        <a:pt x="46" y="221"/>
                      </a:cubicBezTo>
                      <a:cubicBezTo>
                        <a:pt x="67" y="262"/>
                        <a:pt x="93" y="288"/>
                        <a:pt x="148" y="291"/>
                      </a:cubicBezTo>
                      <a:cubicBezTo>
                        <a:pt x="193" y="294"/>
                        <a:pt x="207" y="294"/>
                        <a:pt x="241" y="252"/>
                      </a:cubicBezTo>
                      <a:cubicBezTo>
                        <a:pt x="316" y="165"/>
                        <a:pt x="137" y="0"/>
                        <a:pt x="69" y="63"/>
                      </a:cubicBezTo>
                      <a:close/>
                    </a:path>
                  </a:pathLst>
                </a:custGeom>
                <a:noFill/>
                <a:ln w="11113" cap="rnd" cmpd="sng">
                  <a:solidFill>
                    <a:srgbClr val="333333">
                      <a:alpha val="100000"/>
                    </a:srgbClr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txBody>
                <a:bodyPr/>
                <a:lstStyle/>
                <a:p>
                  <a:endParaRPr lang="zh-CN" altLang="en-US" sz="1400" dirty="0"/>
                </a:p>
              </p:txBody>
            </p:sp>
          </p:grpSp>
          <p:sp>
            <p:nvSpPr>
              <p:cNvPr id="956" name="任意多边形: 形状 955">
                <a:extLst>
                  <a:ext uri="{FF2B5EF4-FFF2-40B4-BE49-F238E27FC236}">
                    <a16:creationId xmlns:a16="http://schemas.microsoft.com/office/drawing/2014/main" id="{0EE5696B-B2DB-AE8A-4F01-32B9CC5F1D7C}"/>
                  </a:ext>
                </a:extLst>
              </p:cNvPr>
              <p:cNvSpPr/>
              <p:nvPr/>
            </p:nvSpPr>
            <p:spPr>
              <a:xfrm rot="10748370">
                <a:off x="-2201819" y="4394867"/>
                <a:ext cx="4008349" cy="2188150"/>
              </a:xfrm>
              <a:custGeom>
                <a:avLst/>
                <a:gdLst>
                  <a:gd name="connsiteX0" fmla="*/ 6659 w 2422600"/>
                  <a:gd name="connsiteY0" fmla="*/ 449064 h 1333159"/>
                  <a:gd name="connsiteX1" fmla="*/ 767054 w 2422600"/>
                  <a:gd name="connsiteY1" fmla="*/ 458689 h 1333159"/>
                  <a:gd name="connsiteX2" fmla="*/ 882557 w 2422600"/>
                  <a:gd name="connsiteY2" fmla="*/ 1209460 h 1333159"/>
                  <a:gd name="connsiteX3" fmla="*/ 1594827 w 2422600"/>
                  <a:gd name="connsiteY3" fmla="*/ 1257586 h 1333159"/>
                  <a:gd name="connsiteX4" fmla="*/ 1729581 w 2422600"/>
                  <a:gd name="connsiteY4" fmla="*/ 458689 h 1333159"/>
                  <a:gd name="connsiteX5" fmla="*/ 2422600 w 2422600"/>
                  <a:gd name="connsiteY5" fmla="*/ 410563 h 1333159"/>
                  <a:gd name="connsiteX6" fmla="*/ 1835459 w 2422600"/>
                  <a:gd name="connsiteY6" fmla="*/ 208432 h 1333159"/>
                  <a:gd name="connsiteX7" fmla="*/ 1257943 w 2422600"/>
                  <a:gd name="connsiteY7" fmla="*/ 6302 h 1333159"/>
                  <a:gd name="connsiteX8" fmla="*/ 6659 w 2422600"/>
                  <a:gd name="connsiteY8" fmla="*/ 449064 h 1333159"/>
                  <a:gd name="connsiteX0" fmla="*/ 6659 w 2422600"/>
                  <a:gd name="connsiteY0" fmla="*/ 444949 h 1329044"/>
                  <a:gd name="connsiteX1" fmla="*/ 767054 w 2422600"/>
                  <a:gd name="connsiteY1" fmla="*/ 454574 h 1329044"/>
                  <a:gd name="connsiteX2" fmla="*/ 882557 w 2422600"/>
                  <a:gd name="connsiteY2" fmla="*/ 1205345 h 1329044"/>
                  <a:gd name="connsiteX3" fmla="*/ 1594827 w 2422600"/>
                  <a:gd name="connsiteY3" fmla="*/ 1253471 h 1329044"/>
                  <a:gd name="connsiteX4" fmla="*/ 1729581 w 2422600"/>
                  <a:gd name="connsiteY4" fmla="*/ 454574 h 1329044"/>
                  <a:gd name="connsiteX5" fmla="*/ 2422600 w 2422600"/>
                  <a:gd name="connsiteY5" fmla="*/ 406448 h 1329044"/>
                  <a:gd name="connsiteX6" fmla="*/ 1835459 w 2422600"/>
                  <a:gd name="connsiteY6" fmla="*/ 204317 h 1329044"/>
                  <a:gd name="connsiteX7" fmla="*/ 1257943 w 2422600"/>
                  <a:gd name="connsiteY7" fmla="*/ 2187 h 1329044"/>
                  <a:gd name="connsiteX8" fmla="*/ 6659 w 2422600"/>
                  <a:gd name="connsiteY8" fmla="*/ 444949 h 1329044"/>
                  <a:gd name="connsiteX0" fmla="*/ 6659 w 2422600"/>
                  <a:gd name="connsiteY0" fmla="*/ 444949 h 1329044"/>
                  <a:gd name="connsiteX1" fmla="*/ 767054 w 2422600"/>
                  <a:gd name="connsiteY1" fmla="*/ 454574 h 1329044"/>
                  <a:gd name="connsiteX2" fmla="*/ 882557 w 2422600"/>
                  <a:gd name="connsiteY2" fmla="*/ 1205345 h 1329044"/>
                  <a:gd name="connsiteX3" fmla="*/ 1594827 w 2422600"/>
                  <a:gd name="connsiteY3" fmla="*/ 1253471 h 1329044"/>
                  <a:gd name="connsiteX4" fmla="*/ 1729581 w 2422600"/>
                  <a:gd name="connsiteY4" fmla="*/ 454574 h 1329044"/>
                  <a:gd name="connsiteX5" fmla="*/ 2422600 w 2422600"/>
                  <a:gd name="connsiteY5" fmla="*/ 406448 h 1329044"/>
                  <a:gd name="connsiteX6" fmla="*/ 1257943 w 2422600"/>
                  <a:gd name="connsiteY6" fmla="*/ 2187 h 1329044"/>
                  <a:gd name="connsiteX7" fmla="*/ 6659 w 2422600"/>
                  <a:gd name="connsiteY7" fmla="*/ 444949 h 1329044"/>
                  <a:gd name="connsiteX0" fmla="*/ 6659 w 2422600"/>
                  <a:gd name="connsiteY0" fmla="*/ 449828 h 1333923"/>
                  <a:gd name="connsiteX1" fmla="*/ 767054 w 2422600"/>
                  <a:gd name="connsiteY1" fmla="*/ 459453 h 1333923"/>
                  <a:gd name="connsiteX2" fmla="*/ 882557 w 2422600"/>
                  <a:gd name="connsiteY2" fmla="*/ 1210224 h 1333923"/>
                  <a:gd name="connsiteX3" fmla="*/ 1594827 w 2422600"/>
                  <a:gd name="connsiteY3" fmla="*/ 1258350 h 1333923"/>
                  <a:gd name="connsiteX4" fmla="*/ 1729581 w 2422600"/>
                  <a:gd name="connsiteY4" fmla="*/ 459453 h 1333923"/>
                  <a:gd name="connsiteX5" fmla="*/ 2422600 w 2422600"/>
                  <a:gd name="connsiteY5" fmla="*/ 411327 h 1333923"/>
                  <a:gd name="connsiteX6" fmla="*/ 1257943 w 2422600"/>
                  <a:gd name="connsiteY6" fmla="*/ 7066 h 1333923"/>
                  <a:gd name="connsiteX7" fmla="*/ 6659 w 2422600"/>
                  <a:gd name="connsiteY7" fmla="*/ 449828 h 1333923"/>
                  <a:gd name="connsiteX0" fmla="*/ 6659 w 2422600"/>
                  <a:gd name="connsiteY0" fmla="*/ 443457 h 1327552"/>
                  <a:gd name="connsiteX1" fmla="*/ 767054 w 2422600"/>
                  <a:gd name="connsiteY1" fmla="*/ 453082 h 1327552"/>
                  <a:gd name="connsiteX2" fmla="*/ 882557 w 2422600"/>
                  <a:gd name="connsiteY2" fmla="*/ 1203853 h 1327552"/>
                  <a:gd name="connsiteX3" fmla="*/ 1594827 w 2422600"/>
                  <a:gd name="connsiteY3" fmla="*/ 1251979 h 1327552"/>
                  <a:gd name="connsiteX4" fmla="*/ 1729581 w 2422600"/>
                  <a:gd name="connsiteY4" fmla="*/ 453082 h 1327552"/>
                  <a:gd name="connsiteX5" fmla="*/ 2422600 w 2422600"/>
                  <a:gd name="connsiteY5" fmla="*/ 404956 h 1327552"/>
                  <a:gd name="connsiteX6" fmla="*/ 1257943 w 2422600"/>
                  <a:gd name="connsiteY6" fmla="*/ 695 h 1327552"/>
                  <a:gd name="connsiteX7" fmla="*/ 6659 w 2422600"/>
                  <a:gd name="connsiteY7" fmla="*/ 443457 h 1327552"/>
                  <a:gd name="connsiteX0" fmla="*/ 6772 w 2422713"/>
                  <a:gd name="connsiteY0" fmla="*/ 443457 h 1331964"/>
                  <a:gd name="connsiteX1" fmla="*/ 767167 w 2422713"/>
                  <a:gd name="connsiteY1" fmla="*/ 453082 h 1331964"/>
                  <a:gd name="connsiteX2" fmla="*/ 959672 w 2422713"/>
                  <a:gd name="connsiteY2" fmla="*/ 1213478 h 1331964"/>
                  <a:gd name="connsiteX3" fmla="*/ 1594940 w 2422713"/>
                  <a:gd name="connsiteY3" fmla="*/ 1251979 h 1331964"/>
                  <a:gd name="connsiteX4" fmla="*/ 1729694 w 2422713"/>
                  <a:gd name="connsiteY4" fmla="*/ 453082 h 1331964"/>
                  <a:gd name="connsiteX5" fmla="*/ 2422713 w 2422713"/>
                  <a:gd name="connsiteY5" fmla="*/ 404956 h 1331964"/>
                  <a:gd name="connsiteX6" fmla="*/ 1258056 w 2422713"/>
                  <a:gd name="connsiteY6" fmla="*/ 695 h 1331964"/>
                  <a:gd name="connsiteX7" fmla="*/ 6772 w 2422713"/>
                  <a:gd name="connsiteY7" fmla="*/ 443457 h 1331964"/>
                  <a:gd name="connsiteX0" fmla="*/ 6933 w 2422874"/>
                  <a:gd name="connsiteY0" fmla="*/ 443457 h 1351841"/>
                  <a:gd name="connsiteX1" fmla="*/ 767328 w 2422874"/>
                  <a:gd name="connsiteY1" fmla="*/ 453082 h 1351841"/>
                  <a:gd name="connsiteX2" fmla="*/ 1065711 w 2422874"/>
                  <a:gd name="connsiteY2" fmla="*/ 1251979 h 1351841"/>
                  <a:gd name="connsiteX3" fmla="*/ 1595101 w 2422874"/>
                  <a:gd name="connsiteY3" fmla="*/ 1251979 h 1351841"/>
                  <a:gd name="connsiteX4" fmla="*/ 1729855 w 2422874"/>
                  <a:gd name="connsiteY4" fmla="*/ 453082 h 1351841"/>
                  <a:gd name="connsiteX5" fmla="*/ 2422874 w 2422874"/>
                  <a:gd name="connsiteY5" fmla="*/ 404956 h 1351841"/>
                  <a:gd name="connsiteX6" fmla="*/ 1258217 w 2422874"/>
                  <a:gd name="connsiteY6" fmla="*/ 695 h 1351841"/>
                  <a:gd name="connsiteX7" fmla="*/ 6933 w 2422874"/>
                  <a:gd name="connsiteY7" fmla="*/ 443457 h 1351841"/>
                  <a:gd name="connsiteX0" fmla="*/ 6933 w 2422874"/>
                  <a:gd name="connsiteY0" fmla="*/ 443457 h 1351840"/>
                  <a:gd name="connsiteX1" fmla="*/ 767328 w 2422874"/>
                  <a:gd name="connsiteY1" fmla="*/ 453082 h 1351840"/>
                  <a:gd name="connsiteX2" fmla="*/ 1065711 w 2422874"/>
                  <a:gd name="connsiteY2" fmla="*/ 1251979 h 1351840"/>
                  <a:gd name="connsiteX3" fmla="*/ 1546975 w 2422874"/>
                  <a:gd name="connsiteY3" fmla="*/ 1251979 h 1351840"/>
                  <a:gd name="connsiteX4" fmla="*/ 1729855 w 2422874"/>
                  <a:gd name="connsiteY4" fmla="*/ 453082 h 1351840"/>
                  <a:gd name="connsiteX5" fmla="*/ 2422874 w 2422874"/>
                  <a:gd name="connsiteY5" fmla="*/ 404956 h 1351840"/>
                  <a:gd name="connsiteX6" fmla="*/ 1258217 w 2422874"/>
                  <a:gd name="connsiteY6" fmla="*/ 695 h 1351840"/>
                  <a:gd name="connsiteX7" fmla="*/ 6933 w 2422874"/>
                  <a:gd name="connsiteY7" fmla="*/ 443457 h 1351840"/>
                  <a:gd name="connsiteX0" fmla="*/ 6933 w 2422874"/>
                  <a:gd name="connsiteY0" fmla="*/ 443457 h 1351240"/>
                  <a:gd name="connsiteX1" fmla="*/ 767328 w 2422874"/>
                  <a:gd name="connsiteY1" fmla="*/ 453082 h 1351240"/>
                  <a:gd name="connsiteX2" fmla="*/ 1065711 w 2422874"/>
                  <a:gd name="connsiteY2" fmla="*/ 1251979 h 1351240"/>
                  <a:gd name="connsiteX3" fmla="*/ 1546975 w 2422874"/>
                  <a:gd name="connsiteY3" fmla="*/ 1251979 h 1351240"/>
                  <a:gd name="connsiteX4" fmla="*/ 1604727 w 2422874"/>
                  <a:gd name="connsiteY4" fmla="*/ 462708 h 1351240"/>
                  <a:gd name="connsiteX5" fmla="*/ 2422874 w 2422874"/>
                  <a:gd name="connsiteY5" fmla="*/ 404956 h 1351240"/>
                  <a:gd name="connsiteX6" fmla="*/ 1258217 w 2422874"/>
                  <a:gd name="connsiteY6" fmla="*/ 695 h 1351240"/>
                  <a:gd name="connsiteX7" fmla="*/ 6933 w 2422874"/>
                  <a:gd name="connsiteY7" fmla="*/ 443457 h 1351240"/>
                  <a:gd name="connsiteX0" fmla="*/ 2314 w 2418255"/>
                  <a:gd name="connsiteY0" fmla="*/ 443467 h 1348851"/>
                  <a:gd name="connsiteX1" fmla="*/ 945589 w 2418255"/>
                  <a:gd name="connsiteY1" fmla="*/ 491593 h 1348851"/>
                  <a:gd name="connsiteX2" fmla="*/ 1061092 w 2418255"/>
                  <a:gd name="connsiteY2" fmla="*/ 1251989 h 1348851"/>
                  <a:gd name="connsiteX3" fmla="*/ 1542356 w 2418255"/>
                  <a:gd name="connsiteY3" fmla="*/ 1251989 h 1348851"/>
                  <a:gd name="connsiteX4" fmla="*/ 1600108 w 2418255"/>
                  <a:gd name="connsiteY4" fmla="*/ 462718 h 1348851"/>
                  <a:gd name="connsiteX5" fmla="*/ 2418255 w 2418255"/>
                  <a:gd name="connsiteY5" fmla="*/ 404966 h 1348851"/>
                  <a:gd name="connsiteX6" fmla="*/ 1253598 w 2418255"/>
                  <a:gd name="connsiteY6" fmla="*/ 705 h 1348851"/>
                  <a:gd name="connsiteX7" fmla="*/ 2314 w 2418255"/>
                  <a:gd name="connsiteY7" fmla="*/ 443467 h 1348851"/>
                  <a:gd name="connsiteX0" fmla="*/ 2361 w 2418302"/>
                  <a:gd name="connsiteY0" fmla="*/ 443467 h 1372022"/>
                  <a:gd name="connsiteX1" fmla="*/ 945636 w 2418302"/>
                  <a:gd name="connsiteY1" fmla="*/ 491593 h 1372022"/>
                  <a:gd name="connsiteX2" fmla="*/ 1167017 w 2418302"/>
                  <a:gd name="connsiteY2" fmla="*/ 1290490 h 1372022"/>
                  <a:gd name="connsiteX3" fmla="*/ 1542403 w 2418302"/>
                  <a:gd name="connsiteY3" fmla="*/ 1251989 h 1372022"/>
                  <a:gd name="connsiteX4" fmla="*/ 1600155 w 2418302"/>
                  <a:gd name="connsiteY4" fmla="*/ 462718 h 1372022"/>
                  <a:gd name="connsiteX5" fmla="*/ 2418302 w 2418302"/>
                  <a:gd name="connsiteY5" fmla="*/ 404966 h 1372022"/>
                  <a:gd name="connsiteX6" fmla="*/ 1253645 w 2418302"/>
                  <a:gd name="connsiteY6" fmla="*/ 705 h 1372022"/>
                  <a:gd name="connsiteX7" fmla="*/ 2361 w 2418302"/>
                  <a:gd name="connsiteY7" fmla="*/ 443467 h 1372022"/>
                  <a:gd name="connsiteX0" fmla="*/ 2361 w 2418302"/>
                  <a:gd name="connsiteY0" fmla="*/ 443467 h 1372022"/>
                  <a:gd name="connsiteX1" fmla="*/ 945636 w 2418302"/>
                  <a:gd name="connsiteY1" fmla="*/ 491593 h 1372022"/>
                  <a:gd name="connsiteX2" fmla="*/ 1167017 w 2418302"/>
                  <a:gd name="connsiteY2" fmla="*/ 1290490 h 1372022"/>
                  <a:gd name="connsiteX3" fmla="*/ 1455775 w 2418302"/>
                  <a:gd name="connsiteY3" fmla="*/ 1251989 h 1372022"/>
                  <a:gd name="connsiteX4" fmla="*/ 1600155 w 2418302"/>
                  <a:gd name="connsiteY4" fmla="*/ 462718 h 1372022"/>
                  <a:gd name="connsiteX5" fmla="*/ 2418302 w 2418302"/>
                  <a:gd name="connsiteY5" fmla="*/ 404966 h 1372022"/>
                  <a:gd name="connsiteX6" fmla="*/ 1253645 w 2418302"/>
                  <a:gd name="connsiteY6" fmla="*/ 705 h 1372022"/>
                  <a:gd name="connsiteX7" fmla="*/ 2361 w 2418302"/>
                  <a:gd name="connsiteY7" fmla="*/ 443467 h 1372022"/>
                  <a:gd name="connsiteX0" fmla="*/ 2398 w 2418339"/>
                  <a:gd name="connsiteY0" fmla="*/ 443467 h 1378336"/>
                  <a:gd name="connsiteX1" fmla="*/ 945673 w 2418339"/>
                  <a:gd name="connsiteY1" fmla="*/ 491593 h 1378336"/>
                  <a:gd name="connsiteX2" fmla="*/ 1244056 w 2418339"/>
                  <a:gd name="connsiteY2" fmla="*/ 1300115 h 1378336"/>
                  <a:gd name="connsiteX3" fmla="*/ 1455812 w 2418339"/>
                  <a:gd name="connsiteY3" fmla="*/ 1251989 h 1378336"/>
                  <a:gd name="connsiteX4" fmla="*/ 1600192 w 2418339"/>
                  <a:gd name="connsiteY4" fmla="*/ 462718 h 1378336"/>
                  <a:gd name="connsiteX5" fmla="*/ 2418339 w 2418339"/>
                  <a:gd name="connsiteY5" fmla="*/ 404966 h 1378336"/>
                  <a:gd name="connsiteX6" fmla="*/ 1253682 w 2418339"/>
                  <a:gd name="connsiteY6" fmla="*/ 705 h 1378336"/>
                  <a:gd name="connsiteX7" fmla="*/ 2398 w 2418339"/>
                  <a:gd name="connsiteY7" fmla="*/ 443467 h 1378336"/>
                  <a:gd name="connsiteX0" fmla="*/ 2398 w 2418339"/>
                  <a:gd name="connsiteY0" fmla="*/ 443467 h 1366129"/>
                  <a:gd name="connsiteX1" fmla="*/ 945673 w 2418339"/>
                  <a:gd name="connsiteY1" fmla="*/ 491593 h 1366129"/>
                  <a:gd name="connsiteX2" fmla="*/ 1244056 w 2418339"/>
                  <a:gd name="connsiteY2" fmla="*/ 1300115 h 1366129"/>
                  <a:gd name="connsiteX3" fmla="*/ 1417311 w 2418339"/>
                  <a:gd name="connsiteY3" fmla="*/ 1223113 h 1366129"/>
                  <a:gd name="connsiteX4" fmla="*/ 1600192 w 2418339"/>
                  <a:gd name="connsiteY4" fmla="*/ 462718 h 1366129"/>
                  <a:gd name="connsiteX5" fmla="*/ 2418339 w 2418339"/>
                  <a:gd name="connsiteY5" fmla="*/ 404966 h 1366129"/>
                  <a:gd name="connsiteX6" fmla="*/ 1253682 w 2418339"/>
                  <a:gd name="connsiteY6" fmla="*/ 705 h 1366129"/>
                  <a:gd name="connsiteX7" fmla="*/ 2398 w 2418339"/>
                  <a:gd name="connsiteY7" fmla="*/ 443467 h 1366129"/>
                  <a:gd name="connsiteX0" fmla="*/ 2398 w 2418339"/>
                  <a:gd name="connsiteY0" fmla="*/ 443467 h 1378336"/>
                  <a:gd name="connsiteX1" fmla="*/ 945673 w 2418339"/>
                  <a:gd name="connsiteY1" fmla="*/ 491593 h 1378336"/>
                  <a:gd name="connsiteX2" fmla="*/ 1244056 w 2418339"/>
                  <a:gd name="connsiteY2" fmla="*/ 1300115 h 1378336"/>
                  <a:gd name="connsiteX3" fmla="*/ 1417311 w 2418339"/>
                  <a:gd name="connsiteY3" fmla="*/ 1251989 h 1378336"/>
                  <a:gd name="connsiteX4" fmla="*/ 1600192 w 2418339"/>
                  <a:gd name="connsiteY4" fmla="*/ 462718 h 1378336"/>
                  <a:gd name="connsiteX5" fmla="*/ 2418339 w 2418339"/>
                  <a:gd name="connsiteY5" fmla="*/ 404966 h 1378336"/>
                  <a:gd name="connsiteX6" fmla="*/ 1253682 w 2418339"/>
                  <a:gd name="connsiteY6" fmla="*/ 705 h 1378336"/>
                  <a:gd name="connsiteX7" fmla="*/ 2398 w 2418339"/>
                  <a:gd name="connsiteY7" fmla="*/ 443467 h 1378336"/>
                  <a:gd name="connsiteX0" fmla="*/ 3256 w 2419197"/>
                  <a:gd name="connsiteY0" fmla="*/ 443467 h 1378336"/>
                  <a:gd name="connsiteX1" fmla="*/ 946531 w 2419197"/>
                  <a:gd name="connsiteY1" fmla="*/ 491593 h 1378336"/>
                  <a:gd name="connsiteX2" fmla="*/ 1244914 w 2419197"/>
                  <a:gd name="connsiteY2" fmla="*/ 1300115 h 1378336"/>
                  <a:gd name="connsiteX3" fmla="*/ 1418169 w 2419197"/>
                  <a:gd name="connsiteY3" fmla="*/ 1251989 h 1378336"/>
                  <a:gd name="connsiteX4" fmla="*/ 1601050 w 2419197"/>
                  <a:gd name="connsiteY4" fmla="*/ 462718 h 1378336"/>
                  <a:gd name="connsiteX5" fmla="*/ 2419197 w 2419197"/>
                  <a:gd name="connsiteY5" fmla="*/ 404966 h 1378336"/>
                  <a:gd name="connsiteX6" fmla="*/ 1254540 w 2419197"/>
                  <a:gd name="connsiteY6" fmla="*/ 705 h 1378336"/>
                  <a:gd name="connsiteX7" fmla="*/ 3256 w 2419197"/>
                  <a:gd name="connsiteY7" fmla="*/ 443467 h 1378336"/>
                  <a:gd name="connsiteX0" fmla="*/ 2938 w 2418879"/>
                  <a:gd name="connsiteY0" fmla="*/ 443467 h 1378336"/>
                  <a:gd name="connsiteX1" fmla="*/ 946213 w 2418879"/>
                  <a:gd name="connsiteY1" fmla="*/ 491593 h 1378336"/>
                  <a:gd name="connsiteX2" fmla="*/ 1244596 w 2418879"/>
                  <a:gd name="connsiteY2" fmla="*/ 1300115 h 1378336"/>
                  <a:gd name="connsiteX3" fmla="*/ 1417851 w 2418879"/>
                  <a:gd name="connsiteY3" fmla="*/ 1251989 h 1378336"/>
                  <a:gd name="connsiteX4" fmla="*/ 1600732 w 2418879"/>
                  <a:gd name="connsiteY4" fmla="*/ 462718 h 1378336"/>
                  <a:gd name="connsiteX5" fmla="*/ 2418879 w 2418879"/>
                  <a:gd name="connsiteY5" fmla="*/ 404966 h 1378336"/>
                  <a:gd name="connsiteX6" fmla="*/ 1254222 w 2418879"/>
                  <a:gd name="connsiteY6" fmla="*/ 705 h 1378336"/>
                  <a:gd name="connsiteX7" fmla="*/ 2938 w 2418879"/>
                  <a:gd name="connsiteY7" fmla="*/ 443467 h 1378336"/>
                  <a:gd name="connsiteX0" fmla="*/ 2938 w 2418879"/>
                  <a:gd name="connsiteY0" fmla="*/ 443467 h 1378336"/>
                  <a:gd name="connsiteX1" fmla="*/ 946213 w 2418879"/>
                  <a:gd name="connsiteY1" fmla="*/ 491593 h 1378336"/>
                  <a:gd name="connsiteX2" fmla="*/ 1244596 w 2418879"/>
                  <a:gd name="connsiteY2" fmla="*/ 1300115 h 1378336"/>
                  <a:gd name="connsiteX3" fmla="*/ 1417851 w 2418879"/>
                  <a:gd name="connsiteY3" fmla="*/ 1251989 h 1378336"/>
                  <a:gd name="connsiteX4" fmla="*/ 1600732 w 2418879"/>
                  <a:gd name="connsiteY4" fmla="*/ 462718 h 1378336"/>
                  <a:gd name="connsiteX5" fmla="*/ 2418879 w 2418879"/>
                  <a:gd name="connsiteY5" fmla="*/ 404966 h 1378336"/>
                  <a:gd name="connsiteX6" fmla="*/ 1254222 w 2418879"/>
                  <a:gd name="connsiteY6" fmla="*/ 705 h 1378336"/>
                  <a:gd name="connsiteX7" fmla="*/ 2938 w 2418879"/>
                  <a:gd name="connsiteY7" fmla="*/ 443467 h 1378336"/>
                  <a:gd name="connsiteX0" fmla="*/ 2938 w 2418879"/>
                  <a:gd name="connsiteY0" fmla="*/ 443467 h 1384803"/>
                  <a:gd name="connsiteX1" fmla="*/ 946213 w 2418879"/>
                  <a:gd name="connsiteY1" fmla="*/ 491593 h 1384803"/>
                  <a:gd name="connsiteX2" fmla="*/ 1244596 w 2418879"/>
                  <a:gd name="connsiteY2" fmla="*/ 1300115 h 1384803"/>
                  <a:gd name="connsiteX3" fmla="*/ 1417851 w 2418879"/>
                  <a:gd name="connsiteY3" fmla="*/ 1251989 h 1384803"/>
                  <a:gd name="connsiteX4" fmla="*/ 1600732 w 2418879"/>
                  <a:gd name="connsiteY4" fmla="*/ 462718 h 1384803"/>
                  <a:gd name="connsiteX5" fmla="*/ 2418879 w 2418879"/>
                  <a:gd name="connsiteY5" fmla="*/ 404966 h 1384803"/>
                  <a:gd name="connsiteX6" fmla="*/ 1254222 w 2418879"/>
                  <a:gd name="connsiteY6" fmla="*/ 705 h 1384803"/>
                  <a:gd name="connsiteX7" fmla="*/ 2938 w 2418879"/>
                  <a:gd name="connsiteY7" fmla="*/ 443467 h 1384803"/>
                  <a:gd name="connsiteX0" fmla="*/ 2938 w 2418879"/>
                  <a:gd name="connsiteY0" fmla="*/ 443467 h 1406657"/>
                  <a:gd name="connsiteX1" fmla="*/ 946213 w 2418879"/>
                  <a:gd name="connsiteY1" fmla="*/ 491593 h 1406657"/>
                  <a:gd name="connsiteX2" fmla="*/ 1244596 w 2418879"/>
                  <a:gd name="connsiteY2" fmla="*/ 1300115 h 1406657"/>
                  <a:gd name="connsiteX3" fmla="*/ 1417851 w 2418879"/>
                  <a:gd name="connsiteY3" fmla="*/ 1251989 h 1406657"/>
                  <a:gd name="connsiteX4" fmla="*/ 1600732 w 2418879"/>
                  <a:gd name="connsiteY4" fmla="*/ 462718 h 1406657"/>
                  <a:gd name="connsiteX5" fmla="*/ 2418879 w 2418879"/>
                  <a:gd name="connsiteY5" fmla="*/ 404966 h 1406657"/>
                  <a:gd name="connsiteX6" fmla="*/ 1254222 w 2418879"/>
                  <a:gd name="connsiteY6" fmla="*/ 705 h 1406657"/>
                  <a:gd name="connsiteX7" fmla="*/ 2938 w 2418879"/>
                  <a:gd name="connsiteY7" fmla="*/ 443467 h 1406657"/>
                  <a:gd name="connsiteX0" fmla="*/ 2938 w 2418879"/>
                  <a:gd name="connsiteY0" fmla="*/ 443467 h 1411078"/>
                  <a:gd name="connsiteX1" fmla="*/ 946213 w 2418879"/>
                  <a:gd name="connsiteY1" fmla="*/ 491593 h 1411078"/>
                  <a:gd name="connsiteX2" fmla="*/ 1244596 w 2418879"/>
                  <a:gd name="connsiteY2" fmla="*/ 1300115 h 1411078"/>
                  <a:gd name="connsiteX3" fmla="*/ 1417851 w 2418879"/>
                  <a:gd name="connsiteY3" fmla="*/ 1251989 h 1411078"/>
                  <a:gd name="connsiteX4" fmla="*/ 1600732 w 2418879"/>
                  <a:gd name="connsiteY4" fmla="*/ 462718 h 1411078"/>
                  <a:gd name="connsiteX5" fmla="*/ 2418879 w 2418879"/>
                  <a:gd name="connsiteY5" fmla="*/ 404966 h 1411078"/>
                  <a:gd name="connsiteX6" fmla="*/ 1254222 w 2418879"/>
                  <a:gd name="connsiteY6" fmla="*/ 705 h 1411078"/>
                  <a:gd name="connsiteX7" fmla="*/ 2938 w 2418879"/>
                  <a:gd name="connsiteY7" fmla="*/ 443467 h 1411078"/>
                  <a:gd name="connsiteX0" fmla="*/ 2938 w 2418879"/>
                  <a:gd name="connsiteY0" fmla="*/ 443467 h 1397072"/>
                  <a:gd name="connsiteX1" fmla="*/ 946213 w 2418879"/>
                  <a:gd name="connsiteY1" fmla="*/ 491593 h 1397072"/>
                  <a:gd name="connsiteX2" fmla="*/ 1244596 w 2418879"/>
                  <a:gd name="connsiteY2" fmla="*/ 1300115 h 1397072"/>
                  <a:gd name="connsiteX3" fmla="*/ 1417851 w 2418879"/>
                  <a:gd name="connsiteY3" fmla="*/ 1251989 h 1397072"/>
                  <a:gd name="connsiteX4" fmla="*/ 1600732 w 2418879"/>
                  <a:gd name="connsiteY4" fmla="*/ 462718 h 1397072"/>
                  <a:gd name="connsiteX5" fmla="*/ 2418879 w 2418879"/>
                  <a:gd name="connsiteY5" fmla="*/ 404966 h 1397072"/>
                  <a:gd name="connsiteX6" fmla="*/ 1254222 w 2418879"/>
                  <a:gd name="connsiteY6" fmla="*/ 705 h 1397072"/>
                  <a:gd name="connsiteX7" fmla="*/ 2938 w 2418879"/>
                  <a:gd name="connsiteY7" fmla="*/ 443467 h 1397072"/>
                  <a:gd name="connsiteX0" fmla="*/ 2938 w 2418879"/>
                  <a:gd name="connsiteY0" fmla="*/ 443467 h 1368019"/>
                  <a:gd name="connsiteX1" fmla="*/ 946213 w 2418879"/>
                  <a:gd name="connsiteY1" fmla="*/ 491593 h 1368019"/>
                  <a:gd name="connsiteX2" fmla="*/ 1244596 w 2418879"/>
                  <a:gd name="connsiteY2" fmla="*/ 1300115 h 1368019"/>
                  <a:gd name="connsiteX3" fmla="*/ 1417851 w 2418879"/>
                  <a:gd name="connsiteY3" fmla="*/ 1251989 h 1368019"/>
                  <a:gd name="connsiteX4" fmla="*/ 1600732 w 2418879"/>
                  <a:gd name="connsiteY4" fmla="*/ 462718 h 1368019"/>
                  <a:gd name="connsiteX5" fmla="*/ 2418879 w 2418879"/>
                  <a:gd name="connsiteY5" fmla="*/ 404966 h 1368019"/>
                  <a:gd name="connsiteX6" fmla="*/ 1254222 w 2418879"/>
                  <a:gd name="connsiteY6" fmla="*/ 705 h 1368019"/>
                  <a:gd name="connsiteX7" fmla="*/ 2938 w 2418879"/>
                  <a:gd name="connsiteY7" fmla="*/ 443467 h 1368019"/>
                  <a:gd name="connsiteX0" fmla="*/ 2938 w 2418879"/>
                  <a:gd name="connsiteY0" fmla="*/ 443467 h 1368019"/>
                  <a:gd name="connsiteX1" fmla="*/ 946213 w 2418879"/>
                  <a:gd name="connsiteY1" fmla="*/ 491593 h 1368019"/>
                  <a:gd name="connsiteX2" fmla="*/ 1244596 w 2418879"/>
                  <a:gd name="connsiteY2" fmla="*/ 1300115 h 1368019"/>
                  <a:gd name="connsiteX3" fmla="*/ 1417851 w 2418879"/>
                  <a:gd name="connsiteY3" fmla="*/ 1251989 h 1368019"/>
                  <a:gd name="connsiteX4" fmla="*/ 1600732 w 2418879"/>
                  <a:gd name="connsiteY4" fmla="*/ 462718 h 1368019"/>
                  <a:gd name="connsiteX5" fmla="*/ 2418879 w 2418879"/>
                  <a:gd name="connsiteY5" fmla="*/ 404966 h 1368019"/>
                  <a:gd name="connsiteX6" fmla="*/ 1254222 w 2418879"/>
                  <a:gd name="connsiteY6" fmla="*/ 705 h 1368019"/>
                  <a:gd name="connsiteX7" fmla="*/ 2938 w 2418879"/>
                  <a:gd name="connsiteY7" fmla="*/ 443467 h 1368019"/>
                  <a:gd name="connsiteX0" fmla="*/ 2938 w 2418879"/>
                  <a:gd name="connsiteY0" fmla="*/ 443467 h 1368019"/>
                  <a:gd name="connsiteX1" fmla="*/ 946213 w 2418879"/>
                  <a:gd name="connsiteY1" fmla="*/ 491593 h 1368019"/>
                  <a:gd name="connsiteX2" fmla="*/ 1244596 w 2418879"/>
                  <a:gd name="connsiteY2" fmla="*/ 1300115 h 1368019"/>
                  <a:gd name="connsiteX3" fmla="*/ 1417851 w 2418879"/>
                  <a:gd name="connsiteY3" fmla="*/ 1251989 h 1368019"/>
                  <a:gd name="connsiteX4" fmla="*/ 1600732 w 2418879"/>
                  <a:gd name="connsiteY4" fmla="*/ 462718 h 1368019"/>
                  <a:gd name="connsiteX5" fmla="*/ 2418879 w 2418879"/>
                  <a:gd name="connsiteY5" fmla="*/ 404966 h 1368019"/>
                  <a:gd name="connsiteX6" fmla="*/ 1254222 w 2418879"/>
                  <a:gd name="connsiteY6" fmla="*/ 705 h 1368019"/>
                  <a:gd name="connsiteX7" fmla="*/ 2938 w 2418879"/>
                  <a:gd name="connsiteY7" fmla="*/ 443467 h 1368019"/>
                  <a:gd name="connsiteX0" fmla="*/ 3113 w 2419054"/>
                  <a:gd name="connsiteY0" fmla="*/ 443467 h 1368019"/>
                  <a:gd name="connsiteX1" fmla="*/ 946388 w 2419054"/>
                  <a:gd name="connsiteY1" fmla="*/ 491593 h 1368019"/>
                  <a:gd name="connsiteX2" fmla="*/ 1244771 w 2419054"/>
                  <a:gd name="connsiteY2" fmla="*/ 1300115 h 1368019"/>
                  <a:gd name="connsiteX3" fmla="*/ 1418026 w 2419054"/>
                  <a:gd name="connsiteY3" fmla="*/ 1251989 h 1368019"/>
                  <a:gd name="connsiteX4" fmla="*/ 1600907 w 2419054"/>
                  <a:gd name="connsiteY4" fmla="*/ 462718 h 1368019"/>
                  <a:gd name="connsiteX5" fmla="*/ 2419054 w 2419054"/>
                  <a:gd name="connsiteY5" fmla="*/ 404966 h 1368019"/>
                  <a:gd name="connsiteX6" fmla="*/ 1254397 w 2419054"/>
                  <a:gd name="connsiteY6" fmla="*/ 705 h 1368019"/>
                  <a:gd name="connsiteX7" fmla="*/ 3113 w 2419054"/>
                  <a:gd name="connsiteY7" fmla="*/ 443467 h 1368019"/>
                  <a:gd name="connsiteX0" fmla="*/ 3382 w 2419323"/>
                  <a:gd name="connsiteY0" fmla="*/ 443467 h 1368019"/>
                  <a:gd name="connsiteX1" fmla="*/ 946657 w 2419323"/>
                  <a:gd name="connsiteY1" fmla="*/ 491593 h 1368019"/>
                  <a:gd name="connsiteX2" fmla="*/ 1245040 w 2419323"/>
                  <a:gd name="connsiteY2" fmla="*/ 1300115 h 1368019"/>
                  <a:gd name="connsiteX3" fmla="*/ 1418295 w 2419323"/>
                  <a:gd name="connsiteY3" fmla="*/ 1251989 h 1368019"/>
                  <a:gd name="connsiteX4" fmla="*/ 1601176 w 2419323"/>
                  <a:gd name="connsiteY4" fmla="*/ 462718 h 1368019"/>
                  <a:gd name="connsiteX5" fmla="*/ 2419323 w 2419323"/>
                  <a:gd name="connsiteY5" fmla="*/ 404966 h 1368019"/>
                  <a:gd name="connsiteX6" fmla="*/ 1254666 w 2419323"/>
                  <a:gd name="connsiteY6" fmla="*/ 705 h 1368019"/>
                  <a:gd name="connsiteX7" fmla="*/ 3382 w 2419323"/>
                  <a:gd name="connsiteY7" fmla="*/ 443467 h 1368019"/>
                  <a:gd name="connsiteX0" fmla="*/ 2901 w 2418842"/>
                  <a:gd name="connsiteY0" fmla="*/ 443467 h 1368019"/>
                  <a:gd name="connsiteX1" fmla="*/ 946176 w 2418842"/>
                  <a:gd name="connsiteY1" fmla="*/ 491593 h 1368019"/>
                  <a:gd name="connsiteX2" fmla="*/ 1244559 w 2418842"/>
                  <a:gd name="connsiteY2" fmla="*/ 1300115 h 1368019"/>
                  <a:gd name="connsiteX3" fmla="*/ 1417814 w 2418842"/>
                  <a:gd name="connsiteY3" fmla="*/ 1251989 h 1368019"/>
                  <a:gd name="connsiteX4" fmla="*/ 1600695 w 2418842"/>
                  <a:gd name="connsiteY4" fmla="*/ 462718 h 1368019"/>
                  <a:gd name="connsiteX5" fmla="*/ 2418842 w 2418842"/>
                  <a:gd name="connsiteY5" fmla="*/ 404966 h 1368019"/>
                  <a:gd name="connsiteX6" fmla="*/ 1254185 w 2418842"/>
                  <a:gd name="connsiteY6" fmla="*/ 705 h 1368019"/>
                  <a:gd name="connsiteX7" fmla="*/ 2901 w 2418842"/>
                  <a:gd name="connsiteY7" fmla="*/ 443467 h 1368019"/>
                  <a:gd name="connsiteX0" fmla="*/ 3479 w 2419420"/>
                  <a:gd name="connsiteY0" fmla="*/ 443467 h 1368019"/>
                  <a:gd name="connsiteX1" fmla="*/ 946754 w 2419420"/>
                  <a:gd name="connsiteY1" fmla="*/ 491593 h 1368019"/>
                  <a:gd name="connsiteX2" fmla="*/ 1245137 w 2419420"/>
                  <a:gd name="connsiteY2" fmla="*/ 1300115 h 1368019"/>
                  <a:gd name="connsiteX3" fmla="*/ 1418392 w 2419420"/>
                  <a:gd name="connsiteY3" fmla="*/ 1251989 h 1368019"/>
                  <a:gd name="connsiteX4" fmla="*/ 1601273 w 2419420"/>
                  <a:gd name="connsiteY4" fmla="*/ 462718 h 1368019"/>
                  <a:gd name="connsiteX5" fmla="*/ 2419420 w 2419420"/>
                  <a:gd name="connsiteY5" fmla="*/ 404966 h 1368019"/>
                  <a:gd name="connsiteX6" fmla="*/ 1254763 w 2419420"/>
                  <a:gd name="connsiteY6" fmla="*/ 705 h 1368019"/>
                  <a:gd name="connsiteX7" fmla="*/ 3479 w 2419420"/>
                  <a:gd name="connsiteY7" fmla="*/ 443467 h 1368019"/>
                  <a:gd name="connsiteX0" fmla="*/ 3036 w 2418977"/>
                  <a:gd name="connsiteY0" fmla="*/ 443467 h 1368019"/>
                  <a:gd name="connsiteX1" fmla="*/ 946311 w 2418977"/>
                  <a:gd name="connsiteY1" fmla="*/ 491593 h 1368019"/>
                  <a:gd name="connsiteX2" fmla="*/ 1244694 w 2418977"/>
                  <a:gd name="connsiteY2" fmla="*/ 1300115 h 1368019"/>
                  <a:gd name="connsiteX3" fmla="*/ 1417949 w 2418977"/>
                  <a:gd name="connsiteY3" fmla="*/ 1251989 h 1368019"/>
                  <a:gd name="connsiteX4" fmla="*/ 1600830 w 2418977"/>
                  <a:gd name="connsiteY4" fmla="*/ 462718 h 1368019"/>
                  <a:gd name="connsiteX5" fmla="*/ 2418977 w 2418977"/>
                  <a:gd name="connsiteY5" fmla="*/ 404966 h 1368019"/>
                  <a:gd name="connsiteX6" fmla="*/ 1254320 w 2418977"/>
                  <a:gd name="connsiteY6" fmla="*/ 705 h 1368019"/>
                  <a:gd name="connsiteX7" fmla="*/ 3036 w 2418977"/>
                  <a:gd name="connsiteY7" fmla="*/ 443467 h 1368019"/>
                  <a:gd name="connsiteX0" fmla="*/ 3036 w 2418977"/>
                  <a:gd name="connsiteY0" fmla="*/ 443467 h 1368019"/>
                  <a:gd name="connsiteX1" fmla="*/ 946311 w 2418977"/>
                  <a:gd name="connsiteY1" fmla="*/ 491593 h 1368019"/>
                  <a:gd name="connsiteX2" fmla="*/ 1244694 w 2418977"/>
                  <a:gd name="connsiteY2" fmla="*/ 1300115 h 1368019"/>
                  <a:gd name="connsiteX3" fmla="*/ 1417949 w 2418977"/>
                  <a:gd name="connsiteY3" fmla="*/ 1251989 h 1368019"/>
                  <a:gd name="connsiteX4" fmla="*/ 1600830 w 2418977"/>
                  <a:gd name="connsiteY4" fmla="*/ 462718 h 1368019"/>
                  <a:gd name="connsiteX5" fmla="*/ 2418977 w 2418977"/>
                  <a:gd name="connsiteY5" fmla="*/ 404966 h 1368019"/>
                  <a:gd name="connsiteX6" fmla="*/ 1254320 w 2418977"/>
                  <a:gd name="connsiteY6" fmla="*/ 705 h 1368019"/>
                  <a:gd name="connsiteX7" fmla="*/ 3036 w 2418977"/>
                  <a:gd name="connsiteY7" fmla="*/ 443467 h 1368019"/>
                  <a:gd name="connsiteX0" fmla="*/ 3224 w 2419165"/>
                  <a:gd name="connsiteY0" fmla="*/ 443467 h 1368019"/>
                  <a:gd name="connsiteX1" fmla="*/ 946499 w 2419165"/>
                  <a:gd name="connsiteY1" fmla="*/ 491593 h 1368019"/>
                  <a:gd name="connsiteX2" fmla="*/ 1244882 w 2419165"/>
                  <a:gd name="connsiteY2" fmla="*/ 1300115 h 1368019"/>
                  <a:gd name="connsiteX3" fmla="*/ 1418137 w 2419165"/>
                  <a:gd name="connsiteY3" fmla="*/ 1251989 h 1368019"/>
                  <a:gd name="connsiteX4" fmla="*/ 1601018 w 2419165"/>
                  <a:gd name="connsiteY4" fmla="*/ 462718 h 1368019"/>
                  <a:gd name="connsiteX5" fmla="*/ 2419165 w 2419165"/>
                  <a:gd name="connsiteY5" fmla="*/ 404966 h 1368019"/>
                  <a:gd name="connsiteX6" fmla="*/ 1254508 w 2419165"/>
                  <a:gd name="connsiteY6" fmla="*/ 705 h 1368019"/>
                  <a:gd name="connsiteX7" fmla="*/ 3224 w 2419165"/>
                  <a:gd name="connsiteY7" fmla="*/ 443467 h 1368019"/>
                  <a:gd name="connsiteX0" fmla="*/ 3623 w 2419564"/>
                  <a:gd name="connsiteY0" fmla="*/ 443467 h 1368019"/>
                  <a:gd name="connsiteX1" fmla="*/ 946898 w 2419564"/>
                  <a:gd name="connsiteY1" fmla="*/ 491593 h 1368019"/>
                  <a:gd name="connsiteX2" fmla="*/ 1245281 w 2419564"/>
                  <a:gd name="connsiteY2" fmla="*/ 1300115 h 1368019"/>
                  <a:gd name="connsiteX3" fmla="*/ 1418536 w 2419564"/>
                  <a:gd name="connsiteY3" fmla="*/ 1251989 h 1368019"/>
                  <a:gd name="connsiteX4" fmla="*/ 1601417 w 2419564"/>
                  <a:gd name="connsiteY4" fmla="*/ 462718 h 1368019"/>
                  <a:gd name="connsiteX5" fmla="*/ 2419564 w 2419564"/>
                  <a:gd name="connsiteY5" fmla="*/ 404966 h 1368019"/>
                  <a:gd name="connsiteX6" fmla="*/ 1254907 w 2419564"/>
                  <a:gd name="connsiteY6" fmla="*/ 705 h 1368019"/>
                  <a:gd name="connsiteX7" fmla="*/ 3623 w 2419564"/>
                  <a:gd name="connsiteY7" fmla="*/ 443467 h 1368019"/>
                  <a:gd name="connsiteX0" fmla="*/ 3645 w 2419586"/>
                  <a:gd name="connsiteY0" fmla="*/ 443467 h 1368019"/>
                  <a:gd name="connsiteX1" fmla="*/ 946920 w 2419586"/>
                  <a:gd name="connsiteY1" fmla="*/ 491593 h 1368019"/>
                  <a:gd name="connsiteX2" fmla="*/ 1245303 w 2419586"/>
                  <a:gd name="connsiteY2" fmla="*/ 1300115 h 1368019"/>
                  <a:gd name="connsiteX3" fmla="*/ 1418558 w 2419586"/>
                  <a:gd name="connsiteY3" fmla="*/ 1251989 h 1368019"/>
                  <a:gd name="connsiteX4" fmla="*/ 1601439 w 2419586"/>
                  <a:gd name="connsiteY4" fmla="*/ 462718 h 1368019"/>
                  <a:gd name="connsiteX5" fmla="*/ 2419586 w 2419586"/>
                  <a:gd name="connsiteY5" fmla="*/ 404966 h 1368019"/>
                  <a:gd name="connsiteX6" fmla="*/ 1254929 w 2419586"/>
                  <a:gd name="connsiteY6" fmla="*/ 705 h 1368019"/>
                  <a:gd name="connsiteX7" fmla="*/ 3645 w 2419586"/>
                  <a:gd name="connsiteY7" fmla="*/ 443467 h 1368019"/>
                  <a:gd name="connsiteX0" fmla="*/ 3645 w 2419586"/>
                  <a:gd name="connsiteY0" fmla="*/ 443467 h 1368019"/>
                  <a:gd name="connsiteX1" fmla="*/ 946920 w 2419586"/>
                  <a:gd name="connsiteY1" fmla="*/ 491593 h 1368019"/>
                  <a:gd name="connsiteX2" fmla="*/ 1245303 w 2419586"/>
                  <a:gd name="connsiteY2" fmla="*/ 1300115 h 1368019"/>
                  <a:gd name="connsiteX3" fmla="*/ 1418558 w 2419586"/>
                  <a:gd name="connsiteY3" fmla="*/ 1251989 h 1368019"/>
                  <a:gd name="connsiteX4" fmla="*/ 1601439 w 2419586"/>
                  <a:gd name="connsiteY4" fmla="*/ 462718 h 1368019"/>
                  <a:gd name="connsiteX5" fmla="*/ 2419586 w 2419586"/>
                  <a:gd name="connsiteY5" fmla="*/ 404966 h 1368019"/>
                  <a:gd name="connsiteX6" fmla="*/ 1254929 w 2419586"/>
                  <a:gd name="connsiteY6" fmla="*/ 705 h 1368019"/>
                  <a:gd name="connsiteX7" fmla="*/ 3645 w 2419586"/>
                  <a:gd name="connsiteY7" fmla="*/ 443467 h 1368019"/>
                  <a:gd name="connsiteX0" fmla="*/ 5674 w 2421615"/>
                  <a:gd name="connsiteY0" fmla="*/ 75571 h 1000123"/>
                  <a:gd name="connsiteX1" fmla="*/ 948949 w 2421615"/>
                  <a:gd name="connsiteY1" fmla="*/ 123697 h 1000123"/>
                  <a:gd name="connsiteX2" fmla="*/ 1247332 w 2421615"/>
                  <a:gd name="connsiteY2" fmla="*/ 932219 h 1000123"/>
                  <a:gd name="connsiteX3" fmla="*/ 1420587 w 2421615"/>
                  <a:gd name="connsiteY3" fmla="*/ 884093 h 1000123"/>
                  <a:gd name="connsiteX4" fmla="*/ 1603468 w 2421615"/>
                  <a:gd name="connsiteY4" fmla="*/ 94822 h 1000123"/>
                  <a:gd name="connsiteX5" fmla="*/ 2421615 w 2421615"/>
                  <a:gd name="connsiteY5" fmla="*/ 37070 h 1000123"/>
                  <a:gd name="connsiteX6" fmla="*/ 1342209 w 2421615"/>
                  <a:gd name="connsiteY6" fmla="*/ 160502 h 1000123"/>
                  <a:gd name="connsiteX7" fmla="*/ 5674 w 2421615"/>
                  <a:gd name="connsiteY7" fmla="*/ 75571 h 1000123"/>
                  <a:gd name="connsiteX0" fmla="*/ 4743 w 2420684"/>
                  <a:gd name="connsiteY0" fmla="*/ 94793 h 1019345"/>
                  <a:gd name="connsiteX1" fmla="*/ 948018 w 2420684"/>
                  <a:gd name="connsiteY1" fmla="*/ 142919 h 1019345"/>
                  <a:gd name="connsiteX2" fmla="*/ 1246401 w 2420684"/>
                  <a:gd name="connsiteY2" fmla="*/ 951441 h 1019345"/>
                  <a:gd name="connsiteX3" fmla="*/ 1419656 w 2420684"/>
                  <a:gd name="connsiteY3" fmla="*/ 903315 h 1019345"/>
                  <a:gd name="connsiteX4" fmla="*/ 1602537 w 2420684"/>
                  <a:gd name="connsiteY4" fmla="*/ 114044 h 1019345"/>
                  <a:gd name="connsiteX5" fmla="*/ 2420684 w 2420684"/>
                  <a:gd name="connsiteY5" fmla="*/ 56292 h 1019345"/>
                  <a:gd name="connsiteX6" fmla="*/ 1303954 w 2420684"/>
                  <a:gd name="connsiteY6" fmla="*/ 54316 h 1019345"/>
                  <a:gd name="connsiteX7" fmla="*/ 4743 w 2420684"/>
                  <a:gd name="connsiteY7" fmla="*/ 94793 h 1019345"/>
                  <a:gd name="connsiteX0" fmla="*/ 3542 w 2419483"/>
                  <a:gd name="connsiteY0" fmla="*/ 168693 h 1093245"/>
                  <a:gd name="connsiteX1" fmla="*/ 946817 w 2419483"/>
                  <a:gd name="connsiteY1" fmla="*/ 216819 h 1093245"/>
                  <a:gd name="connsiteX2" fmla="*/ 1245200 w 2419483"/>
                  <a:gd name="connsiteY2" fmla="*/ 1025341 h 1093245"/>
                  <a:gd name="connsiteX3" fmla="*/ 1418455 w 2419483"/>
                  <a:gd name="connsiteY3" fmla="*/ 977215 h 1093245"/>
                  <a:gd name="connsiteX4" fmla="*/ 1601336 w 2419483"/>
                  <a:gd name="connsiteY4" fmla="*/ 187944 h 1093245"/>
                  <a:gd name="connsiteX5" fmla="*/ 2419483 w 2419483"/>
                  <a:gd name="connsiteY5" fmla="*/ 130192 h 1093245"/>
                  <a:gd name="connsiteX6" fmla="*/ 1249981 w 2419483"/>
                  <a:gd name="connsiteY6" fmla="*/ 1694 h 1093245"/>
                  <a:gd name="connsiteX7" fmla="*/ 3542 w 2419483"/>
                  <a:gd name="connsiteY7" fmla="*/ 168693 h 1093245"/>
                  <a:gd name="connsiteX0" fmla="*/ 3638 w 2419579"/>
                  <a:gd name="connsiteY0" fmla="*/ 229325 h 1153877"/>
                  <a:gd name="connsiteX1" fmla="*/ 946913 w 2419579"/>
                  <a:gd name="connsiteY1" fmla="*/ 277451 h 1153877"/>
                  <a:gd name="connsiteX2" fmla="*/ 1245296 w 2419579"/>
                  <a:gd name="connsiteY2" fmla="*/ 1085973 h 1153877"/>
                  <a:gd name="connsiteX3" fmla="*/ 1418551 w 2419579"/>
                  <a:gd name="connsiteY3" fmla="*/ 1037847 h 1153877"/>
                  <a:gd name="connsiteX4" fmla="*/ 1601432 w 2419579"/>
                  <a:gd name="connsiteY4" fmla="*/ 248576 h 1153877"/>
                  <a:gd name="connsiteX5" fmla="*/ 2419579 w 2419579"/>
                  <a:gd name="connsiteY5" fmla="*/ 190824 h 1153877"/>
                  <a:gd name="connsiteX6" fmla="*/ 1254587 w 2419579"/>
                  <a:gd name="connsiteY6" fmla="*/ 1293 h 1153877"/>
                  <a:gd name="connsiteX7" fmla="*/ 3638 w 2419579"/>
                  <a:gd name="connsiteY7" fmla="*/ 229325 h 1153877"/>
                  <a:gd name="connsiteX0" fmla="*/ 3638 w 2419579"/>
                  <a:gd name="connsiteY0" fmla="*/ 229325 h 1160783"/>
                  <a:gd name="connsiteX1" fmla="*/ 946913 w 2419579"/>
                  <a:gd name="connsiteY1" fmla="*/ 277451 h 1160783"/>
                  <a:gd name="connsiteX2" fmla="*/ 1245296 w 2419579"/>
                  <a:gd name="connsiteY2" fmla="*/ 1085973 h 1160783"/>
                  <a:gd name="connsiteX3" fmla="*/ 1418551 w 2419579"/>
                  <a:gd name="connsiteY3" fmla="*/ 1037847 h 1160783"/>
                  <a:gd name="connsiteX4" fmla="*/ 1472212 w 2419579"/>
                  <a:gd name="connsiteY4" fmla="*/ 315958 h 1160783"/>
                  <a:gd name="connsiteX5" fmla="*/ 2419579 w 2419579"/>
                  <a:gd name="connsiteY5" fmla="*/ 190824 h 1160783"/>
                  <a:gd name="connsiteX6" fmla="*/ 1254587 w 2419579"/>
                  <a:gd name="connsiteY6" fmla="*/ 1293 h 1160783"/>
                  <a:gd name="connsiteX7" fmla="*/ 3638 w 2419579"/>
                  <a:gd name="connsiteY7" fmla="*/ 229325 h 1160783"/>
                  <a:gd name="connsiteX0" fmla="*/ 3638 w 2419579"/>
                  <a:gd name="connsiteY0" fmla="*/ 229325 h 1160783"/>
                  <a:gd name="connsiteX1" fmla="*/ 946913 w 2419579"/>
                  <a:gd name="connsiteY1" fmla="*/ 277451 h 1160783"/>
                  <a:gd name="connsiteX2" fmla="*/ 1245296 w 2419579"/>
                  <a:gd name="connsiteY2" fmla="*/ 1085973 h 1160783"/>
                  <a:gd name="connsiteX3" fmla="*/ 1418551 w 2419579"/>
                  <a:gd name="connsiteY3" fmla="*/ 1037847 h 1160783"/>
                  <a:gd name="connsiteX4" fmla="*/ 1472212 w 2419579"/>
                  <a:gd name="connsiteY4" fmla="*/ 315958 h 1160783"/>
                  <a:gd name="connsiteX5" fmla="*/ 2419579 w 2419579"/>
                  <a:gd name="connsiteY5" fmla="*/ 190824 h 1160783"/>
                  <a:gd name="connsiteX6" fmla="*/ 1254587 w 2419579"/>
                  <a:gd name="connsiteY6" fmla="*/ 1293 h 1160783"/>
                  <a:gd name="connsiteX7" fmla="*/ 3638 w 2419579"/>
                  <a:gd name="connsiteY7" fmla="*/ 229325 h 1160783"/>
                  <a:gd name="connsiteX0" fmla="*/ 3638 w 2419579"/>
                  <a:gd name="connsiteY0" fmla="*/ 229325 h 1161872"/>
                  <a:gd name="connsiteX1" fmla="*/ 946913 w 2419579"/>
                  <a:gd name="connsiteY1" fmla="*/ 277451 h 1161872"/>
                  <a:gd name="connsiteX2" fmla="*/ 1245296 w 2419579"/>
                  <a:gd name="connsiteY2" fmla="*/ 1085973 h 1161872"/>
                  <a:gd name="connsiteX3" fmla="*/ 1418551 w 2419579"/>
                  <a:gd name="connsiteY3" fmla="*/ 1037847 h 1161872"/>
                  <a:gd name="connsiteX4" fmla="*/ 1411919 w 2419579"/>
                  <a:gd name="connsiteY4" fmla="*/ 294142 h 1161872"/>
                  <a:gd name="connsiteX5" fmla="*/ 2419579 w 2419579"/>
                  <a:gd name="connsiteY5" fmla="*/ 190824 h 1161872"/>
                  <a:gd name="connsiteX6" fmla="*/ 1254587 w 2419579"/>
                  <a:gd name="connsiteY6" fmla="*/ 1293 h 1161872"/>
                  <a:gd name="connsiteX7" fmla="*/ 3638 w 2419579"/>
                  <a:gd name="connsiteY7" fmla="*/ 229325 h 1161872"/>
                  <a:gd name="connsiteX0" fmla="*/ 3638 w 2419579"/>
                  <a:gd name="connsiteY0" fmla="*/ 229325 h 1161873"/>
                  <a:gd name="connsiteX1" fmla="*/ 946913 w 2419579"/>
                  <a:gd name="connsiteY1" fmla="*/ 277451 h 1161873"/>
                  <a:gd name="connsiteX2" fmla="*/ 1245296 w 2419579"/>
                  <a:gd name="connsiteY2" fmla="*/ 1085973 h 1161873"/>
                  <a:gd name="connsiteX3" fmla="*/ 1418551 w 2419579"/>
                  <a:gd name="connsiteY3" fmla="*/ 1037847 h 1161873"/>
                  <a:gd name="connsiteX4" fmla="*/ 1411919 w 2419579"/>
                  <a:gd name="connsiteY4" fmla="*/ 294142 h 1161873"/>
                  <a:gd name="connsiteX5" fmla="*/ 2419579 w 2419579"/>
                  <a:gd name="connsiteY5" fmla="*/ 190824 h 1161873"/>
                  <a:gd name="connsiteX6" fmla="*/ 1254587 w 2419579"/>
                  <a:gd name="connsiteY6" fmla="*/ 1293 h 1161873"/>
                  <a:gd name="connsiteX7" fmla="*/ 3638 w 2419579"/>
                  <a:gd name="connsiteY7" fmla="*/ 229325 h 1161873"/>
                  <a:gd name="connsiteX0" fmla="*/ 3638 w 2419579"/>
                  <a:gd name="connsiteY0" fmla="*/ 229325 h 1161873"/>
                  <a:gd name="connsiteX1" fmla="*/ 946913 w 2419579"/>
                  <a:gd name="connsiteY1" fmla="*/ 277451 h 1161873"/>
                  <a:gd name="connsiteX2" fmla="*/ 1245296 w 2419579"/>
                  <a:gd name="connsiteY2" fmla="*/ 1085973 h 1161873"/>
                  <a:gd name="connsiteX3" fmla="*/ 1418551 w 2419579"/>
                  <a:gd name="connsiteY3" fmla="*/ 1037847 h 1161873"/>
                  <a:gd name="connsiteX4" fmla="*/ 1411919 w 2419579"/>
                  <a:gd name="connsiteY4" fmla="*/ 294142 h 1161873"/>
                  <a:gd name="connsiteX5" fmla="*/ 2419579 w 2419579"/>
                  <a:gd name="connsiteY5" fmla="*/ 190824 h 1161873"/>
                  <a:gd name="connsiteX6" fmla="*/ 1254587 w 2419579"/>
                  <a:gd name="connsiteY6" fmla="*/ 1293 h 1161873"/>
                  <a:gd name="connsiteX7" fmla="*/ 3638 w 2419579"/>
                  <a:gd name="connsiteY7" fmla="*/ 229325 h 1161873"/>
                  <a:gd name="connsiteX0" fmla="*/ 3030 w 2418971"/>
                  <a:gd name="connsiteY0" fmla="*/ 229325 h 1161873"/>
                  <a:gd name="connsiteX1" fmla="*/ 946305 w 2418971"/>
                  <a:gd name="connsiteY1" fmla="*/ 277451 h 1161873"/>
                  <a:gd name="connsiteX2" fmla="*/ 1244688 w 2418971"/>
                  <a:gd name="connsiteY2" fmla="*/ 1085973 h 1161873"/>
                  <a:gd name="connsiteX3" fmla="*/ 1417943 w 2418971"/>
                  <a:gd name="connsiteY3" fmla="*/ 1037847 h 1161873"/>
                  <a:gd name="connsiteX4" fmla="*/ 1411311 w 2418971"/>
                  <a:gd name="connsiteY4" fmla="*/ 294142 h 1161873"/>
                  <a:gd name="connsiteX5" fmla="*/ 2418971 w 2418971"/>
                  <a:gd name="connsiteY5" fmla="*/ 190824 h 1161873"/>
                  <a:gd name="connsiteX6" fmla="*/ 1253979 w 2418971"/>
                  <a:gd name="connsiteY6" fmla="*/ 1293 h 1161873"/>
                  <a:gd name="connsiteX7" fmla="*/ 3030 w 2418971"/>
                  <a:gd name="connsiteY7" fmla="*/ 229325 h 1161873"/>
                  <a:gd name="connsiteX0" fmla="*/ 3068 w 2419009"/>
                  <a:gd name="connsiteY0" fmla="*/ 229325 h 1161873"/>
                  <a:gd name="connsiteX1" fmla="*/ 946343 w 2419009"/>
                  <a:gd name="connsiteY1" fmla="*/ 277451 h 1161873"/>
                  <a:gd name="connsiteX2" fmla="*/ 1244726 w 2419009"/>
                  <a:gd name="connsiteY2" fmla="*/ 1085973 h 1161873"/>
                  <a:gd name="connsiteX3" fmla="*/ 1417981 w 2419009"/>
                  <a:gd name="connsiteY3" fmla="*/ 1037847 h 1161873"/>
                  <a:gd name="connsiteX4" fmla="*/ 1411349 w 2419009"/>
                  <a:gd name="connsiteY4" fmla="*/ 294142 h 1161873"/>
                  <a:gd name="connsiteX5" fmla="*/ 2419009 w 2419009"/>
                  <a:gd name="connsiteY5" fmla="*/ 190824 h 1161873"/>
                  <a:gd name="connsiteX6" fmla="*/ 1254017 w 2419009"/>
                  <a:gd name="connsiteY6" fmla="*/ 1293 h 1161873"/>
                  <a:gd name="connsiteX7" fmla="*/ 3068 w 2419009"/>
                  <a:gd name="connsiteY7" fmla="*/ 229325 h 1161873"/>
                  <a:gd name="connsiteX0" fmla="*/ 3068 w 2419009"/>
                  <a:gd name="connsiteY0" fmla="*/ 229325 h 1157303"/>
                  <a:gd name="connsiteX1" fmla="*/ 946343 w 2419009"/>
                  <a:gd name="connsiteY1" fmla="*/ 277451 h 1157303"/>
                  <a:gd name="connsiteX2" fmla="*/ 1244726 w 2419009"/>
                  <a:gd name="connsiteY2" fmla="*/ 1085973 h 1157303"/>
                  <a:gd name="connsiteX3" fmla="*/ 1392233 w 2419009"/>
                  <a:gd name="connsiteY3" fmla="*/ 1027257 h 1157303"/>
                  <a:gd name="connsiteX4" fmla="*/ 1411349 w 2419009"/>
                  <a:gd name="connsiteY4" fmla="*/ 294142 h 1157303"/>
                  <a:gd name="connsiteX5" fmla="*/ 2419009 w 2419009"/>
                  <a:gd name="connsiteY5" fmla="*/ 190824 h 1157303"/>
                  <a:gd name="connsiteX6" fmla="*/ 1254017 w 2419009"/>
                  <a:gd name="connsiteY6" fmla="*/ 1293 h 1157303"/>
                  <a:gd name="connsiteX7" fmla="*/ 3068 w 2419009"/>
                  <a:gd name="connsiteY7" fmla="*/ 229325 h 1157303"/>
                  <a:gd name="connsiteX0" fmla="*/ 3068 w 2419009"/>
                  <a:gd name="connsiteY0" fmla="*/ 229325 h 1172153"/>
                  <a:gd name="connsiteX1" fmla="*/ 946343 w 2419009"/>
                  <a:gd name="connsiteY1" fmla="*/ 277451 h 1172153"/>
                  <a:gd name="connsiteX2" fmla="*/ 1244726 w 2419009"/>
                  <a:gd name="connsiteY2" fmla="*/ 1085973 h 1172153"/>
                  <a:gd name="connsiteX3" fmla="*/ 1392233 w 2419009"/>
                  <a:gd name="connsiteY3" fmla="*/ 1027257 h 1172153"/>
                  <a:gd name="connsiteX4" fmla="*/ 1411349 w 2419009"/>
                  <a:gd name="connsiteY4" fmla="*/ 294142 h 1172153"/>
                  <a:gd name="connsiteX5" fmla="*/ 2419009 w 2419009"/>
                  <a:gd name="connsiteY5" fmla="*/ 190824 h 1172153"/>
                  <a:gd name="connsiteX6" fmla="*/ 1254017 w 2419009"/>
                  <a:gd name="connsiteY6" fmla="*/ 1293 h 1172153"/>
                  <a:gd name="connsiteX7" fmla="*/ 3068 w 2419009"/>
                  <a:gd name="connsiteY7" fmla="*/ 229325 h 1172153"/>
                  <a:gd name="connsiteX0" fmla="*/ 3068 w 2419009"/>
                  <a:gd name="connsiteY0" fmla="*/ 229325 h 1180161"/>
                  <a:gd name="connsiteX1" fmla="*/ 946343 w 2419009"/>
                  <a:gd name="connsiteY1" fmla="*/ 277451 h 1180161"/>
                  <a:gd name="connsiteX2" fmla="*/ 1244726 w 2419009"/>
                  <a:gd name="connsiteY2" fmla="*/ 1085973 h 1180161"/>
                  <a:gd name="connsiteX3" fmla="*/ 1392233 w 2419009"/>
                  <a:gd name="connsiteY3" fmla="*/ 1027257 h 1180161"/>
                  <a:gd name="connsiteX4" fmla="*/ 1411349 w 2419009"/>
                  <a:gd name="connsiteY4" fmla="*/ 294142 h 1180161"/>
                  <a:gd name="connsiteX5" fmla="*/ 2419009 w 2419009"/>
                  <a:gd name="connsiteY5" fmla="*/ 190824 h 1180161"/>
                  <a:gd name="connsiteX6" fmla="*/ 1254017 w 2419009"/>
                  <a:gd name="connsiteY6" fmla="*/ 1293 h 1180161"/>
                  <a:gd name="connsiteX7" fmla="*/ 3068 w 2419009"/>
                  <a:gd name="connsiteY7" fmla="*/ 229325 h 1180161"/>
                  <a:gd name="connsiteX0" fmla="*/ 3068 w 2419009"/>
                  <a:gd name="connsiteY0" fmla="*/ 229325 h 1180161"/>
                  <a:gd name="connsiteX1" fmla="*/ 946343 w 2419009"/>
                  <a:gd name="connsiteY1" fmla="*/ 277451 h 1180161"/>
                  <a:gd name="connsiteX2" fmla="*/ 1244726 w 2419009"/>
                  <a:gd name="connsiteY2" fmla="*/ 1085973 h 1180161"/>
                  <a:gd name="connsiteX3" fmla="*/ 1392233 w 2419009"/>
                  <a:gd name="connsiteY3" fmla="*/ 1027257 h 1180161"/>
                  <a:gd name="connsiteX4" fmla="*/ 1411349 w 2419009"/>
                  <a:gd name="connsiteY4" fmla="*/ 294142 h 1180161"/>
                  <a:gd name="connsiteX5" fmla="*/ 2419009 w 2419009"/>
                  <a:gd name="connsiteY5" fmla="*/ 190824 h 1180161"/>
                  <a:gd name="connsiteX6" fmla="*/ 1254017 w 2419009"/>
                  <a:gd name="connsiteY6" fmla="*/ 1293 h 1180161"/>
                  <a:gd name="connsiteX7" fmla="*/ 3068 w 2419009"/>
                  <a:gd name="connsiteY7" fmla="*/ 229325 h 1180161"/>
                  <a:gd name="connsiteX0" fmla="*/ 3068 w 2419009"/>
                  <a:gd name="connsiteY0" fmla="*/ 229325 h 1180161"/>
                  <a:gd name="connsiteX1" fmla="*/ 946343 w 2419009"/>
                  <a:gd name="connsiteY1" fmla="*/ 277451 h 1180161"/>
                  <a:gd name="connsiteX2" fmla="*/ 1244726 w 2419009"/>
                  <a:gd name="connsiteY2" fmla="*/ 1085973 h 1180161"/>
                  <a:gd name="connsiteX3" fmla="*/ 1392233 w 2419009"/>
                  <a:gd name="connsiteY3" fmla="*/ 1027257 h 1180161"/>
                  <a:gd name="connsiteX4" fmla="*/ 1411349 w 2419009"/>
                  <a:gd name="connsiteY4" fmla="*/ 294142 h 1180161"/>
                  <a:gd name="connsiteX5" fmla="*/ 2419009 w 2419009"/>
                  <a:gd name="connsiteY5" fmla="*/ 190824 h 1180161"/>
                  <a:gd name="connsiteX6" fmla="*/ 1254017 w 2419009"/>
                  <a:gd name="connsiteY6" fmla="*/ 1293 h 1180161"/>
                  <a:gd name="connsiteX7" fmla="*/ 3068 w 2419009"/>
                  <a:gd name="connsiteY7" fmla="*/ 229325 h 1180161"/>
                  <a:gd name="connsiteX0" fmla="*/ 3068 w 2419009"/>
                  <a:gd name="connsiteY0" fmla="*/ 229325 h 1161518"/>
                  <a:gd name="connsiteX1" fmla="*/ 946343 w 2419009"/>
                  <a:gd name="connsiteY1" fmla="*/ 277451 h 1161518"/>
                  <a:gd name="connsiteX2" fmla="*/ 1244726 w 2419009"/>
                  <a:gd name="connsiteY2" fmla="*/ 1085973 h 1161518"/>
                  <a:gd name="connsiteX3" fmla="*/ 1392233 w 2419009"/>
                  <a:gd name="connsiteY3" fmla="*/ 1027257 h 1161518"/>
                  <a:gd name="connsiteX4" fmla="*/ 1411349 w 2419009"/>
                  <a:gd name="connsiteY4" fmla="*/ 294142 h 1161518"/>
                  <a:gd name="connsiteX5" fmla="*/ 2419009 w 2419009"/>
                  <a:gd name="connsiteY5" fmla="*/ 190824 h 1161518"/>
                  <a:gd name="connsiteX6" fmla="*/ 1254017 w 2419009"/>
                  <a:gd name="connsiteY6" fmla="*/ 1293 h 1161518"/>
                  <a:gd name="connsiteX7" fmla="*/ 3068 w 2419009"/>
                  <a:gd name="connsiteY7" fmla="*/ 229325 h 1161518"/>
                  <a:gd name="connsiteX0" fmla="*/ 3068 w 2419009"/>
                  <a:gd name="connsiteY0" fmla="*/ 229325 h 1188160"/>
                  <a:gd name="connsiteX1" fmla="*/ 946343 w 2419009"/>
                  <a:gd name="connsiteY1" fmla="*/ 277451 h 1188160"/>
                  <a:gd name="connsiteX2" fmla="*/ 1244726 w 2419009"/>
                  <a:gd name="connsiteY2" fmla="*/ 1085973 h 1188160"/>
                  <a:gd name="connsiteX3" fmla="*/ 1392233 w 2419009"/>
                  <a:gd name="connsiteY3" fmla="*/ 1027257 h 1188160"/>
                  <a:gd name="connsiteX4" fmla="*/ 1411349 w 2419009"/>
                  <a:gd name="connsiteY4" fmla="*/ 294142 h 1188160"/>
                  <a:gd name="connsiteX5" fmla="*/ 2419009 w 2419009"/>
                  <a:gd name="connsiteY5" fmla="*/ 190824 h 1188160"/>
                  <a:gd name="connsiteX6" fmla="*/ 1254017 w 2419009"/>
                  <a:gd name="connsiteY6" fmla="*/ 1293 h 1188160"/>
                  <a:gd name="connsiteX7" fmla="*/ 3068 w 2419009"/>
                  <a:gd name="connsiteY7" fmla="*/ 229325 h 1188160"/>
                  <a:gd name="connsiteX0" fmla="*/ 3068 w 2419009"/>
                  <a:gd name="connsiteY0" fmla="*/ 229325 h 1165421"/>
                  <a:gd name="connsiteX1" fmla="*/ 946343 w 2419009"/>
                  <a:gd name="connsiteY1" fmla="*/ 277451 h 1165421"/>
                  <a:gd name="connsiteX2" fmla="*/ 1244726 w 2419009"/>
                  <a:gd name="connsiteY2" fmla="*/ 1085973 h 1165421"/>
                  <a:gd name="connsiteX3" fmla="*/ 1392233 w 2419009"/>
                  <a:gd name="connsiteY3" fmla="*/ 1027257 h 1165421"/>
                  <a:gd name="connsiteX4" fmla="*/ 1411349 w 2419009"/>
                  <a:gd name="connsiteY4" fmla="*/ 294142 h 1165421"/>
                  <a:gd name="connsiteX5" fmla="*/ 2419009 w 2419009"/>
                  <a:gd name="connsiteY5" fmla="*/ 190824 h 1165421"/>
                  <a:gd name="connsiteX6" fmla="*/ 1254017 w 2419009"/>
                  <a:gd name="connsiteY6" fmla="*/ 1293 h 1165421"/>
                  <a:gd name="connsiteX7" fmla="*/ 3068 w 2419009"/>
                  <a:gd name="connsiteY7" fmla="*/ 229325 h 1165421"/>
                  <a:gd name="connsiteX0" fmla="*/ 2926 w 2418867"/>
                  <a:gd name="connsiteY0" fmla="*/ 229361 h 1163249"/>
                  <a:gd name="connsiteX1" fmla="*/ 952431 w 2418867"/>
                  <a:gd name="connsiteY1" fmla="*/ 312876 h 1163249"/>
                  <a:gd name="connsiteX2" fmla="*/ 1244584 w 2418867"/>
                  <a:gd name="connsiteY2" fmla="*/ 1086009 h 1163249"/>
                  <a:gd name="connsiteX3" fmla="*/ 1392091 w 2418867"/>
                  <a:gd name="connsiteY3" fmla="*/ 1027293 h 1163249"/>
                  <a:gd name="connsiteX4" fmla="*/ 1411207 w 2418867"/>
                  <a:gd name="connsiteY4" fmla="*/ 294178 h 1163249"/>
                  <a:gd name="connsiteX5" fmla="*/ 2418867 w 2418867"/>
                  <a:gd name="connsiteY5" fmla="*/ 190860 h 1163249"/>
                  <a:gd name="connsiteX6" fmla="*/ 1253875 w 2418867"/>
                  <a:gd name="connsiteY6" fmla="*/ 1329 h 1163249"/>
                  <a:gd name="connsiteX7" fmla="*/ 2926 w 2418867"/>
                  <a:gd name="connsiteY7" fmla="*/ 229361 h 1163249"/>
                  <a:gd name="connsiteX0" fmla="*/ 2926 w 2418867"/>
                  <a:gd name="connsiteY0" fmla="*/ 229361 h 1163250"/>
                  <a:gd name="connsiteX1" fmla="*/ 952431 w 2418867"/>
                  <a:gd name="connsiteY1" fmla="*/ 312876 h 1163250"/>
                  <a:gd name="connsiteX2" fmla="*/ 1244584 w 2418867"/>
                  <a:gd name="connsiteY2" fmla="*/ 1086009 h 1163250"/>
                  <a:gd name="connsiteX3" fmla="*/ 1392091 w 2418867"/>
                  <a:gd name="connsiteY3" fmla="*/ 1027293 h 1163250"/>
                  <a:gd name="connsiteX4" fmla="*/ 1411207 w 2418867"/>
                  <a:gd name="connsiteY4" fmla="*/ 294178 h 1163250"/>
                  <a:gd name="connsiteX5" fmla="*/ 2418867 w 2418867"/>
                  <a:gd name="connsiteY5" fmla="*/ 190860 h 1163250"/>
                  <a:gd name="connsiteX6" fmla="*/ 1253875 w 2418867"/>
                  <a:gd name="connsiteY6" fmla="*/ 1329 h 1163250"/>
                  <a:gd name="connsiteX7" fmla="*/ 2926 w 2418867"/>
                  <a:gd name="connsiteY7" fmla="*/ 229361 h 1163250"/>
                  <a:gd name="connsiteX0" fmla="*/ 2926 w 2418867"/>
                  <a:gd name="connsiteY0" fmla="*/ 229361 h 1146622"/>
                  <a:gd name="connsiteX1" fmla="*/ 952431 w 2418867"/>
                  <a:gd name="connsiteY1" fmla="*/ 312876 h 1146622"/>
                  <a:gd name="connsiteX2" fmla="*/ 1244584 w 2418867"/>
                  <a:gd name="connsiteY2" fmla="*/ 1086009 h 1146622"/>
                  <a:gd name="connsiteX3" fmla="*/ 1392091 w 2418867"/>
                  <a:gd name="connsiteY3" fmla="*/ 1027293 h 1146622"/>
                  <a:gd name="connsiteX4" fmla="*/ 1411207 w 2418867"/>
                  <a:gd name="connsiteY4" fmla="*/ 294178 h 1146622"/>
                  <a:gd name="connsiteX5" fmla="*/ 2418867 w 2418867"/>
                  <a:gd name="connsiteY5" fmla="*/ 190860 h 1146622"/>
                  <a:gd name="connsiteX6" fmla="*/ 1253875 w 2418867"/>
                  <a:gd name="connsiteY6" fmla="*/ 1329 h 1146622"/>
                  <a:gd name="connsiteX7" fmla="*/ 2926 w 2418867"/>
                  <a:gd name="connsiteY7" fmla="*/ 229361 h 1146622"/>
                  <a:gd name="connsiteX0" fmla="*/ 2926 w 2418867"/>
                  <a:gd name="connsiteY0" fmla="*/ 229361 h 1146622"/>
                  <a:gd name="connsiteX1" fmla="*/ 952431 w 2418867"/>
                  <a:gd name="connsiteY1" fmla="*/ 312876 h 1146622"/>
                  <a:gd name="connsiteX2" fmla="*/ 1244584 w 2418867"/>
                  <a:gd name="connsiteY2" fmla="*/ 1086009 h 1146622"/>
                  <a:gd name="connsiteX3" fmla="*/ 1392091 w 2418867"/>
                  <a:gd name="connsiteY3" fmla="*/ 1027293 h 1146622"/>
                  <a:gd name="connsiteX4" fmla="*/ 1411207 w 2418867"/>
                  <a:gd name="connsiteY4" fmla="*/ 294178 h 1146622"/>
                  <a:gd name="connsiteX5" fmla="*/ 2418867 w 2418867"/>
                  <a:gd name="connsiteY5" fmla="*/ 190860 h 1146622"/>
                  <a:gd name="connsiteX6" fmla="*/ 1253875 w 2418867"/>
                  <a:gd name="connsiteY6" fmla="*/ 1329 h 1146622"/>
                  <a:gd name="connsiteX7" fmla="*/ 2926 w 2418867"/>
                  <a:gd name="connsiteY7" fmla="*/ 229361 h 1146622"/>
                  <a:gd name="connsiteX0" fmla="*/ 2926 w 2418867"/>
                  <a:gd name="connsiteY0" fmla="*/ 229361 h 1151342"/>
                  <a:gd name="connsiteX1" fmla="*/ 952431 w 2418867"/>
                  <a:gd name="connsiteY1" fmla="*/ 312876 h 1151342"/>
                  <a:gd name="connsiteX2" fmla="*/ 1244584 w 2418867"/>
                  <a:gd name="connsiteY2" fmla="*/ 1086009 h 1151342"/>
                  <a:gd name="connsiteX3" fmla="*/ 1351118 w 2418867"/>
                  <a:gd name="connsiteY3" fmla="*/ 1037580 h 1151342"/>
                  <a:gd name="connsiteX4" fmla="*/ 1411207 w 2418867"/>
                  <a:gd name="connsiteY4" fmla="*/ 294178 h 1151342"/>
                  <a:gd name="connsiteX5" fmla="*/ 2418867 w 2418867"/>
                  <a:gd name="connsiteY5" fmla="*/ 190860 h 1151342"/>
                  <a:gd name="connsiteX6" fmla="*/ 1253875 w 2418867"/>
                  <a:gd name="connsiteY6" fmla="*/ 1329 h 1151342"/>
                  <a:gd name="connsiteX7" fmla="*/ 2926 w 2418867"/>
                  <a:gd name="connsiteY7" fmla="*/ 229361 h 1151342"/>
                  <a:gd name="connsiteX0" fmla="*/ 2926 w 2418867"/>
                  <a:gd name="connsiteY0" fmla="*/ 229361 h 1137016"/>
                  <a:gd name="connsiteX1" fmla="*/ 952431 w 2418867"/>
                  <a:gd name="connsiteY1" fmla="*/ 312876 h 1137016"/>
                  <a:gd name="connsiteX2" fmla="*/ 1244584 w 2418867"/>
                  <a:gd name="connsiteY2" fmla="*/ 1086009 h 1137016"/>
                  <a:gd name="connsiteX3" fmla="*/ 1351118 w 2418867"/>
                  <a:gd name="connsiteY3" fmla="*/ 1037580 h 1137016"/>
                  <a:gd name="connsiteX4" fmla="*/ 1411207 w 2418867"/>
                  <a:gd name="connsiteY4" fmla="*/ 294178 h 1137016"/>
                  <a:gd name="connsiteX5" fmla="*/ 2418867 w 2418867"/>
                  <a:gd name="connsiteY5" fmla="*/ 190860 h 1137016"/>
                  <a:gd name="connsiteX6" fmla="*/ 1253875 w 2418867"/>
                  <a:gd name="connsiteY6" fmla="*/ 1329 h 1137016"/>
                  <a:gd name="connsiteX7" fmla="*/ 2926 w 2418867"/>
                  <a:gd name="connsiteY7" fmla="*/ 229361 h 1137016"/>
                  <a:gd name="connsiteX0" fmla="*/ 2926 w 2418867"/>
                  <a:gd name="connsiteY0" fmla="*/ 229361 h 1130839"/>
                  <a:gd name="connsiteX1" fmla="*/ 952431 w 2418867"/>
                  <a:gd name="connsiteY1" fmla="*/ 312876 h 1130839"/>
                  <a:gd name="connsiteX2" fmla="*/ 1244584 w 2418867"/>
                  <a:gd name="connsiteY2" fmla="*/ 1086009 h 1130839"/>
                  <a:gd name="connsiteX3" fmla="*/ 1351118 w 2418867"/>
                  <a:gd name="connsiteY3" fmla="*/ 1037580 h 1130839"/>
                  <a:gd name="connsiteX4" fmla="*/ 1411207 w 2418867"/>
                  <a:gd name="connsiteY4" fmla="*/ 294178 h 1130839"/>
                  <a:gd name="connsiteX5" fmla="*/ 2418867 w 2418867"/>
                  <a:gd name="connsiteY5" fmla="*/ 190860 h 1130839"/>
                  <a:gd name="connsiteX6" fmla="*/ 1253875 w 2418867"/>
                  <a:gd name="connsiteY6" fmla="*/ 1329 h 1130839"/>
                  <a:gd name="connsiteX7" fmla="*/ 2926 w 2418867"/>
                  <a:gd name="connsiteY7" fmla="*/ 229361 h 1130839"/>
                  <a:gd name="connsiteX0" fmla="*/ 2100 w 2418041"/>
                  <a:gd name="connsiteY0" fmla="*/ 285057 h 1186535"/>
                  <a:gd name="connsiteX1" fmla="*/ 951605 w 2418041"/>
                  <a:gd name="connsiteY1" fmla="*/ 368572 h 1186535"/>
                  <a:gd name="connsiteX2" fmla="*/ 1243758 w 2418041"/>
                  <a:gd name="connsiteY2" fmla="*/ 1141705 h 1186535"/>
                  <a:gd name="connsiteX3" fmla="*/ 1350292 w 2418041"/>
                  <a:gd name="connsiteY3" fmla="*/ 1093276 h 1186535"/>
                  <a:gd name="connsiteX4" fmla="*/ 1410381 w 2418041"/>
                  <a:gd name="connsiteY4" fmla="*/ 349874 h 1186535"/>
                  <a:gd name="connsiteX5" fmla="*/ 2418041 w 2418041"/>
                  <a:gd name="connsiteY5" fmla="*/ 246556 h 1186535"/>
                  <a:gd name="connsiteX6" fmla="*/ 1204120 w 2418041"/>
                  <a:gd name="connsiteY6" fmla="*/ 1088 h 1186535"/>
                  <a:gd name="connsiteX7" fmla="*/ 2100 w 2418041"/>
                  <a:gd name="connsiteY7" fmla="*/ 285057 h 1186535"/>
                  <a:gd name="connsiteX0" fmla="*/ 2240 w 2418181"/>
                  <a:gd name="connsiteY0" fmla="*/ 285057 h 1186535"/>
                  <a:gd name="connsiteX1" fmla="*/ 951745 w 2418181"/>
                  <a:gd name="connsiteY1" fmla="*/ 368572 h 1186535"/>
                  <a:gd name="connsiteX2" fmla="*/ 1243898 w 2418181"/>
                  <a:gd name="connsiteY2" fmla="*/ 1141705 h 1186535"/>
                  <a:gd name="connsiteX3" fmla="*/ 1350432 w 2418181"/>
                  <a:gd name="connsiteY3" fmla="*/ 1093276 h 1186535"/>
                  <a:gd name="connsiteX4" fmla="*/ 1410521 w 2418181"/>
                  <a:gd name="connsiteY4" fmla="*/ 349874 h 1186535"/>
                  <a:gd name="connsiteX5" fmla="*/ 2418181 w 2418181"/>
                  <a:gd name="connsiteY5" fmla="*/ 246556 h 1186535"/>
                  <a:gd name="connsiteX6" fmla="*/ 1204260 w 2418181"/>
                  <a:gd name="connsiteY6" fmla="*/ 1088 h 1186535"/>
                  <a:gd name="connsiteX7" fmla="*/ 2240 w 2418181"/>
                  <a:gd name="connsiteY7" fmla="*/ 285057 h 1186535"/>
                  <a:gd name="connsiteX0" fmla="*/ 2248 w 2418189"/>
                  <a:gd name="connsiteY0" fmla="*/ 285057 h 1186535"/>
                  <a:gd name="connsiteX1" fmla="*/ 951753 w 2418189"/>
                  <a:gd name="connsiteY1" fmla="*/ 368572 h 1186535"/>
                  <a:gd name="connsiteX2" fmla="*/ 1243906 w 2418189"/>
                  <a:gd name="connsiteY2" fmla="*/ 1141705 h 1186535"/>
                  <a:gd name="connsiteX3" fmla="*/ 1350440 w 2418189"/>
                  <a:gd name="connsiteY3" fmla="*/ 1093276 h 1186535"/>
                  <a:gd name="connsiteX4" fmla="*/ 1410529 w 2418189"/>
                  <a:gd name="connsiteY4" fmla="*/ 349874 h 1186535"/>
                  <a:gd name="connsiteX5" fmla="*/ 2418189 w 2418189"/>
                  <a:gd name="connsiteY5" fmla="*/ 246556 h 1186535"/>
                  <a:gd name="connsiteX6" fmla="*/ 1204268 w 2418189"/>
                  <a:gd name="connsiteY6" fmla="*/ 1088 h 1186535"/>
                  <a:gd name="connsiteX7" fmla="*/ 2248 w 2418189"/>
                  <a:gd name="connsiteY7" fmla="*/ 285057 h 1186535"/>
                  <a:gd name="connsiteX0" fmla="*/ 2014 w 2417955"/>
                  <a:gd name="connsiteY0" fmla="*/ 285057 h 1186535"/>
                  <a:gd name="connsiteX1" fmla="*/ 951519 w 2417955"/>
                  <a:gd name="connsiteY1" fmla="*/ 368572 h 1186535"/>
                  <a:gd name="connsiteX2" fmla="*/ 1243672 w 2417955"/>
                  <a:gd name="connsiteY2" fmla="*/ 1141705 h 1186535"/>
                  <a:gd name="connsiteX3" fmla="*/ 1350206 w 2417955"/>
                  <a:gd name="connsiteY3" fmla="*/ 1093276 h 1186535"/>
                  <a:gd name="connsiteX4" fmla="*/ 1410295 w 2417955"/>
                  <a:gd name="connsiteY4" fmla="*/ 349874 h 1186535"/>
                  <a:gd name="connsiteX5" fmla="*/ 2417955 w 2417955"/>
                  <a:gd name="connsiteY5" fmla="*/ 246556 h 1186535"/>
                  <a:gd name="connsiteX6" fmla="*/ 1204034 w 2417955"/>
                  <a:gd name="connsiteY6" fmla="*/ 1088 h 1186535"/>
                  <a:gd name="connsiteX7" fmla="*/ 2014 w 2417955"/>
                  <a:gd name="connsiteY7" fmla="*/ 285057 h 1186535"/>
                  <a:gd name="connsiteX0" fmla="*/ 2016 w 2417957"/>
                  <a:gd name="connsiteY0" fmla="*/ 285057 h 1186535"/>
                  <a:gd name="connsiteX1" fmla="*/ 951521 w 2417957"/>
                  <a:gd name="connsiteY1" fmla="*/ 368572 h 1186535"/>
                  <a:gd name="connsiteX2" fmla="*/ 1243674 w 2417957"/>
                  <a:gd name="connsiteY2" fmla="*/ 1141705 h 1186535"/>
                  <a:gd name="connsiteX3" fmla="*/ 1350208 w 2417957"/>
                  <a:gd name="connsiteY3" fmla="*/ 1093276 h 1186535"/>
                  <a:gd name="connsiteX4" fmla="*/ 1410297 w 2417957"/>
                  <a:gd name="connsiteY4" fmla="*/ 349874 h 1186535"/>
                  <a:gd name="connsiteX5" fmla="*/ 2417957 w 2417957"/>
                  <a:gd name="connsiteY5" fmla="*/ 246556 h 1186535"/>
                  <a:gd name="connsiteX6" fmla="*/ 1204036 w 2417957"/>
                  <a:gd name="connsiteY6" fmla="*/ 1088 h 1186535"/>
                  <a:gd name="connsiteX7" fmla="*/ 2016 w 2417957"/>
                  <a:gd name="connsiteY7" fmla="*/ 285057 h 1186535"/>
                  <a:gd name="connsiteX0" fmla="*/ 2016 w 2417957"/>
                  <a:gd name="connsiteY0" fmla="*/ 285057 h 1186535"/>
                  <a:gd name="connsiteX1" fmla="*/ 951521 w 2417957"/>
                  <a:gd name="connsiteY1" fmla="*/ 368572 h 1186535"/>
                  <a:gd name="connsiteX2" fmla="*/ 1243674 w 2417957"/>
                  <a:gd name="connsiteY2" fmla="*/ 1141705 h 1186535"/>
                  <a:gd name="connsiteX3" fmla="*/ 1350208 w 2417957"/>
                  <a:gd name="connsiteY3" fmla="*/ 1093276 h 1186535"/>
                  <a:gd name="connsiteX4" fmla="*/ 1410297 w 2417957"/>
                  <a:gd name="connsiteY4" fmla="*/ 349874 h 1186535"/>
                  <a:gd name="connsiteX5" fmla="*/ 2417957 w 2417957"/>
                  <a:gd name="connsiteY5" fmla="*/ 246556 h 1186535"/>
                  <a:gd name="connsiteX6" fmla="*/ 1204036 w 2417957"/>
                  <a:gd name="connsiteY6" fmla="*/ 1088 h 1186535"/>
                  <a:gd name="connsiteX7" fmla="*/ 2016 w 2417957"/>
                  <a:gd name="connsiteY7" fmla="*/ 285057 h 1186535"/>
                  <a:gd name="connsiteX0" fmla="*/ 2016 w 2417957"/>
                  <a:gd name="connsiteY0" fmla="*/ 285057 h 1186535"/>
                  <a:gd name="connsiteX1" fmla="*/ 951521 w 2417957"/>
                  <a:gd name="connsiteY1" fmla="*/ 368572 h 1186535"/>
                  <a:gd name="connsiteX2" fmla="*/ 1243674 w 2417957"/>
                  <a:gd name="connsiteY2" fmla="*/ 1141705 h 1186535"/>
                  <a:gd name="connsiteX3" fmla="*/ 1350208 w 2417957"/>
                  <a:gd name="connsiteY3" fmla="*/ 1093276 h 1186535"/>
                  <a:gd name="connsiteX4" fmla="*/ 1410297 w 2417957"/>
                  <a:gd name="connsiteY4" fmla="*/ 349874 h 1186535"/>
                  <a:gd name="connsiteX5" fmla="*/ 2417957 w 2417957"/>
                  <a:gd name="connsiteY5" fmla="*/ 246556 h 1186535"/>
                  <a:gd name="connsiteX6" fmla="*/ 1204036 w 2417957"/>
                  <a:gd name="connsiteY6" fmla="*/ 1088 h 1186535"/>
                  <a:gd name="connsiteX7" fmla="*/ 2016 w 2417957"/>
                  <a:gd name="connsiteY7" fmla="*/ 285057 h 1186535"/>
                  <a:gd name="connsiteX0" fmla="*/ 2016 w 2417957"/>
                  <a:gd name="connsiteY0" fmla="*/ 285057 h 1186535"/>
                  <a:gd name="connsiteX1" fmla="*/ 951521 w 2417957"/>
                  <a:gd name="connsiteY1" fmla="*/ 368572 h 1186535"/>
                  <a:gd name="connsiteX2" fmla="*/ 1243674 w 2417957"/>
                  <a:gd name="connsiteY2" fmla="*/ 1141705 h 1186535"/>
                  <a:gd name="connsiteX3" fmla="*/ 1350208 w 2417957"/>
                  <a:gd name="connsiteY3" fmla="*/ 1093276 h 1186535"/>
                  <a:gd name="connsiteX4" fmla="*/ 1410297 w 2417957"/>
                  <a:gd name="connsiteY4" fmla="*/ 349874 h 1186535"/>
                  <a:gd name="connsiteX5" fmla="*/ 2417957 w 2417957"/>
                  <a:gd name="connsiteY5" fmla="*/ 246556 h 1186535"/>
                  <a:gd name="connsiteX6" fmla="*/ 1204036 w 2417957"/>
                  <a:gd name="connsiteY6" fmla="*/ 1088 h 1186535"/>
                  <a:gd name="connsiteX7" fmla="*/ 2016 w 2417957"/>
                  <a:gd name="connsiteY7" fmla="*/ 285057 h 1186535"/>
                  <a:gd name="connsiteX0" fmla="*/ 2016 w 2417957"/>
                  <a:gd name="connsiteY0" fmla="*/ 285057 h 1186535"/>
                  <a:gd name="connsiteX1" fmla="*/ 951521 w 2417957"/>
                  <a:gd name="connsiteY1" fmla="*/ 368572 h 1186535"/>
                  <a:gd name="connsiteX2" fmla="*/ 1243674 w 2417957"/>
                  <a:gd name="connsiteY2" fmla="*/ 1141705 h 1186535"/>
                  <a:gd name="connsiteX3" fmla="*/ 1350208 w 2417957"/>
                  <a:gd name="connsiteY3" fmla="*/ 1093276 h 1186535"/>
                  <a:gd name="connsiteX4" fmla="*/ 1410297 w 2417957"/>
                  <a:gd name="connsiteY4" fmla="*/ 349874 h 1186535"/>
                  <a:gd name="connsiteX5" fmla="*/ 2417957 w 2417957"/>
                  <a:gd name="connsiteY5" fmla="*/ 246556 h 1186535"/>
                  <a:gd name="connsiteX6" fmla="*/ 1204036 w 2417957"/>
                  <a:gd name="connsiteY6" fmla="*/ 1088 h 1186535"/>
                  <a:gd name="connsiteX7" fmla="*/ 2016 w 2417957"/>
                  <a:gd name="connsiteY7" fmla="*/ 285057 h 1186535"/>
                  <a:gd name="connsiteX0" fmla="*/ 2016 w 2417957"/>
                  <a:gd name="connsiteY0" fmla="*/ 285057 h 1186535"/>
                  <a:gd name="connsiteX1" fmla="*/ 951521 w 2417957"/>
                  <a:gd name="connsiteY1" fmla="*/ 368572 h 1186535"/>
                  <a:gd name="connsiteX2" fmla="*/ 1243674 w 2417957"/>
                  <a:gd name="connsiteY2" fmla="*/ 1141705 h 1186535"/>
                  <a:gd name="connsiteX3" fmla="*/ 1350208 w 2417957"/>
                  <a:gd name="connsiteY3" fmla="*/ 1093276 h 1186535"/>
                  <a:gd name="connsiteX4" fmla="*/ 1410297 w 2417957"/>
                  <a:gd name="connsiteY4" fmla="*/ 349874 h 1186535"/>
                  <a:gd name="connsiteX5" fmla="*/ 2417957 w 2417957"/>
                  <a:gd name="connsiteY5" fmla="*/ 246556 h 1186535"/>
                  <a:gd name="connsiteX6" fmla="*/ 1204036 w 2417957"/>
                  <a:gd name="connsiteY6" fmla="*/ 1088 h 1186535"/>
                  <a:gd name="connsiteX7" fmla="*/ 2016 w 2417957"/>
                  <a:gd name="connsiteY7" fmla="*/ 285057 h 1186535"/>
                  <a:gd name="connsiteX0" fmla="*/ 2016 w 2417957"/>
                  <a:gd name="connsiteY0" fmla="*/ 285057 h 1186535"/>
                  <a:gd name="connsiteX1" fmla="*/ 951521 w 2417957"/>
                  <a:gd name="connsiteY1" fmla="*/ 368572 h 1186535"/>
                  <a:gd name="connsiteX2" fmla="*/ 1243674 w 2417957"/>
                  <a:gd name="connsiteY2" fmla="*/ 1141705 h 1186535"/>
                  <a:gd name="connsiteX3" fmla="*/ 1350208 w 2417957"/>
                  <a:gd name="connsiteY3" fmla="*/ 1093276 h 1186535"/>
                  <a:gd name="connsiteX4" fmla="*/ 1410297 w 2417957"/>
                  <a:gd name="connsiteY4" fmla="*/ 349874 h 1186535"/>
                  <a:gd name="connsiteX5" fmla="*/ 2417957 w 2417957"/>
                  <a:gd name="connsiteY5" fmla="*/ 246556 h 1186535"/>
                  <a:gd name="connsiteX6" fmla="*/ 1204036 w 2417957"/>
                  <a:gd name="connsiteY6" fmla="*/ 1088 h 1186535"/>
                  <a:gd name="connsiteX7" fmla="*/ 2016 w 2417957"/>
                  <a:gd name="connsiteY7" fmla="*/ 285057 h 1186535"/>
                  <a:gd name="connsiteX0" fmla="*/ 2016 w 2417957"/>
                  <a:gd name="connsiteY0" fmla="*/ 285057 h 1197257"/>
                  <a:gd name="connsiteX1" fmla="*/ 951521 w 2417957"/>
                  <a:gd name="connsiteY1" fmla="*/ 368572 h 1197257"/>
                  <a:gd name="connsiteX2" fmla="*/ 1243674 w 2417957"/>
                  <a:gd name="connsiteY2" fmla="*/ 1141705 h 1197257"/>
                  <a:gd name="connsiteX3" fmla="*/ 1350208 w 2417957"/>
                  <a:gd name="connsiteY3" fmla="*/ 1093276 h 1197257"/>
                  <a:gd name="connsiteX4" fmla="*/ 1468797 w 2417957"/>
                  <a:gd name="connsiteY4" fmla="*/ 350744 h 1197257"/>
                  <a:gd name="connsiteX5" fmla="*/ 2417957 w 2417957"/>
                  <a:gd name="connsiteY5" fmla="*/ 246556 h 1197257"/>
                  <a:gd name="connsiteX6" fmla="*/ 1204036 w 2417957"/>
                  <a:gd name="connsiteY6" fmla="*/ 1088 h 1197257"/>
                  <a:gd name="connsiteX7" fmla="*/ 2016 w 2417957"/>
                  <a:gd name="connsiteY7" fmla="*/ 285057 h 1197257"/>
                  <a:gd name="connsiteX0" fmla="*/ 2016 w 2417957"/>
                  <a:gd name="connsiteY0" fmla="*/ 285057 h 1195636"/>
                  <a:gd name="connsiteX1" fmla="*/ 951521 w 2417957"/>
                  <a:gd name="connsiteY1" fmla="*/ 368572 h 1195636"/>
                  <a:gd name="connsiteX2" fmla="*/ 1243674 w 2417957"/>
                  <a:gd name="connsiteY2" fmla="*/ 1141705 h 1195636"/>
                  <a:gd name="connsiteX3" fmla="*/ 1350208 w 2417957"/>
                  <a:gd name="connsiteY3" fmla="*/ 1093276 h 1195636"/>
                  <a:gd name="connsiteX4" fmla="*/ 1517107 w 2417957"/>
                  <a:gd name="connsiteY4" fmla="*/ 380358 h 1195636"/>
                  <a:gd name="connsiteX5" fmla="*/ 2417957 w 2417957"/>
                  <a:gd name="connsiteY5" fmla="*/ 246556 h 1195636"/>
                  <a:gd name="connsiteX6" fmla="*/ 1204036 w 2417957"/>
                  <a:gd name="connsiteY6" fmla="*/ 1088 h 1195636"/>
                  <a:gd name="connsiteX7" fmla="*/ 2016 w 2417957"/>
                  <a:gd name="connsiteY7" fmla="*/ 285057 h 1195636"/>
                  <a:gd name="connsiteX0" fmla="*/ 2016 w 2417957"/>
                  <a:gd name="connsiteY0" fmla="*/ 285057 h 1196127"/>
                  <a:gd name="connsiteX1" fmla="*/ 951521 w 2417957"/>
                  <a:gd name="connsiteY1" fmla="*/ 368572 h 1196127"/>
                  <a:gd name="connsiteX2" fmla="*/ 1243674 w 2417957"/>
                  <a:gd name="connsiteY2" fmla="*/ 1141705 h 1196127"/>
                  <a:gd name="connsiteX3" fmla="*/ 1350208 w 2417957"/>
                  <a:gd name="connsiteY3" fmla="*/ 1093276 h 1196127"/>
                  <a:gd name="connsiteX4" fmla="*/ 1556253 w 2417957"/>
                  <a:gd name="connsiteY4" fmla="*/ 371306 h 1196127"/>
                  <a:gd name="connsiteX5" fmla="*/ 2417957 w 2417957"/>
                  <a:gd name="connsiteY5" fmla="*/ 246556 h 1196127"/>
                  <a:gd name="connsiteX6" fmla="*/ 1204036 w 2417957"/>
                  <a:gd name="connsiteY6" fmla="*/ 1088 h 1196127"/>
                  <a:gd name="connsiteX7" fmla="*/ 2016 w 2417957"/>
                  <a:gd name="connsiteY7" fmla="*/ 285057 h 1196127"/>
                  <a:gd name="connsiteX0" fmla="*/ 2415 w 2418356"/>
                  <a:gd name="connsiteY0" fmla="*/ 285120 h 1196190"/>
                  <a:gd name="connsiteX1" fmla="*/ 931102 w 2418356"/>
                  <a:gd name="connsiteY1" fmla="*/ 455021 h 1196190"/>
                  <a:gd name="connsiteX2" fmla="*/ 1244073 w 2418356"/>
                  <a:gd name="connsiteY2" fmla="*/ 1141768 h 1196190"/>
                  <a:gd name="connsiteX3" fmla="*/ 1350607 w 2418356"/>
                  <a:gd name="connsiteY3" fmla="*/ 1093339 h 1196190"/>
                  <a:gd name="connsiteX4" fmla="*/ 1556652 w 2418356"/>
                  <a:gd name="connsiteY4" fmla="*/ 371369 h 1196190"/>
                  <a:gd name="connsiteX5" fmla="*/ 2418356 w 2418356"/>
                  <a:gd name="connsiteY5" fmla="*/ 246619 h 1196190"/>
                  <a:gd name="connsiteX6" fmla="*/ 1204435 w 2418356"/>
                  <a:gd name="connsiteY6" fmla="*/ 1151 h 1196190"/>
                  <a:gd name="connsiteX7" fmla="*/ 2415 w 2418356"/>
                  <a:gd name="connsiteY7" fmla="*/ 285120 h 1196190"/>
                  <a:gd name="connsiteX0" fmla="*/ 1699 w 2417640"/>
                  <a:gd name="connsiteY0" fmla="*/ 285107 h 1196177"/>
                  <a:gd name="connsiteX1" fmla="*/ 969679 w 2417640"/>
                  <a:gd name="connsiteY1" fmla="*/ 436325 h 1196177"/>
                  <a:gd name="connsiteX2" fmla="*/ 1243357 w 2417640"/>
                  <a:gd name="connsiteY2" fmla="*/ 1141755 h 1196177"/>
                  <a:gd name="connsiteX3" fmla="*/ 1349891 w 2417640"/>
                  <a:gd name="connsiteY3" fmla="*/ 1093326 h 1196177"/>
                  <a:gd name="connsiteX4" fmla="*/ 1555936 w 2417640"/>
                  <a:gd name="connsiteY4" fmla="*/ 371356 h 1196177"/>
                  <a:gd name="connsiteX5" fmla="*/ 2417640 w 2417640"/>
                  <a:gd name="connsiteY5" fmla="*/ 246606 h 1196177"/>
                  <a:gd name="connsiteX6" fmla="*/ 1203719 w 2417640"/>
                  <a:gd name="connsiteY6" fmla="*/ 1138 h 1196177"/>
                  <a:gd name="connsiteX7" fmla="*/ 1699 w 2417640"/>
                  <a:gd name="connsiteY7" fmla="*/ 285107 h 1196177"/>
                  <a:gd name="connsiteX0" fmla="*/ 1699 w 2417640"/>
                  <a:gd name="connsiteY0" fmla="*/ 285105 h 1194086"/>
                  <a:gd name="connsiteX1" fmla="*/ 969679 w 2417640"/>
                  <a:gd name="connsiteY1" fmla="*/ 436323 h 1194086"/>
                  <a:gd name="connsiteX2" fmla="*/ 1243357 w 2417640"/>
                  <a:gd name="connsiteY2" fmla="*/ 1141753 h 1194086"/>
                  <a:gd name="connsiteX3" fmla="*/ 1349891 w 2417640"/>
                  <a:gd name="connsiteY3" fmla="*/ 1093324 h 1194086"/>
                  <a:gd name="connsiteX4" fmla="*/ 1574851 w 2417640"/>
                  <a:gd name="connsiteY4" fmla="*/ 410164 h 1194086"/>
                  <a:gd name="connsiteX5" fmla="*/ 2417640 w 2417640"/>
                  <a:gd name="connsiteY5" fmla="*/ 246604 h 1194086"/>
                  <a:gd name="connsiteX6" fmla="*/ 1203719 w 2417640"/>
                  <a:gd name="connsiteY6" fmla="*/ 1136 h 1194086"/>
                  <a:gd name="connsiteX7" fmla="*/ 1699 w 2417640"/>
                  <a:gd name="connsiteY7" fmla="*/ 285105 h 1194086"/>
                  <a:gd name="connsiteX0" fmla="*/ 1695 w 2417636"/>
                  <a:gd name="connsiteY0" fmla="*/ 285105 h 1194086"/>
                  <a:gd name="connsiteX1" fmla="*/ 969675 w 2417636"/>
                  <a:gd name="connsiteY1" fmla="*/ 436323 h 1194086"/>
                  <a:gd name="connsiteX2" fmla="*/ 1243353 w 2417636"/>
                  <a:gd name="connsiteY2" fmla="*/ 1141753 h 1194086"/>
                  <a:gd name="connsiteX3" fmla="*/ 1349887 w 2417636"/>
                  <a:gd name="connsiteY3" fmla="*/ 1093324 h 1194086"/>
                  <a:gd name="connsiteX4" fmla="*/ 1574847 w 2417636"/>
                  <a:gd name="connsiteY4" fmla="*/ 410164 h 1194086"/>
                  <a:gd name="connsiteX5" fmla="*/ 2417636 w 2417636"/>
                  <a:gd name="connsiteY5" fmla="*/ 246604 h 1194086"/>
                  <a:gd name="connsiteX6" fmla="*/ 1203715 w 2417636"/>
                  <a:gd name="connsiteY6" fmla="*/ 1136 h 1194086"/>
                  <a:gd name="connsiteX7" fmla="*/ 1695 w 2417636"/>
                  <a:gd name="connsiteY7" fmla="*/ 285105 h 1194086"/>
                  <a:gd name="connsiteX0" fmla="*/ 1799 w 2417740"/>
                  <a:gd name="connsiteY0" fmla="*/ 285105 h 1194086"/>
                  <a:gd name="connsiteX1" fmla="*/ 969779 w 2417740"/>
                  <a:gd name="connsiteY1" fmla="*/ 436323 h 1194086"/>
                  <a:gd name="connsiteX2" fmla="*/ 1243457 w 2417740"/>
                  <a:gd name="connsiteY2" fmla="*/ 1141753 h 1194086"/>
                  <a:gd name="connsiteX3" fmla="*/ 1349991 w 2417740"/>
                  <a:gd name="connsiteY3" fmla="*/ 1093324 h 1194086"/>
                  <a:gd name="connsiteX4" fmla="*/ 1574951 w 2417740"/>
                  <a:gd name="connsiteY4" fmla="*/ 410164 h 1194086"/>
                  <a:gd name="connsiteX5" fmla="*/ 2417740 w 2417740"/>
                  <a:gd name="connsiteY5" fmla="*/ 246604 h 1194086"/>
                  <a:gd name="connsiteX6" fmla="*/ 1203819 w 2417740"/>
                  <a:gd name="connsiteY6" fmla="*/ 1136 h 1194086"/>
                  <a:gd name="connsiteX7" fmla="*/ 1799 w 2417740"/>
                  <a:gd name="connsiteY7" fmla="*/ 285105 h 1194086"/>
                  <a:gd name="connsiteX0" fmla="*/ 3004 w 2418945"/>
                  <a:gd name="connsiteY0" fmla="*/ 285105 h 1194086"/>
                  <a:gd name="connsiteX1" fmla="*/ 912484 w 2418945"/>
                  <a:gd name="connsiteY1" fmla="*/ 435454 h 1194086"/>
                  <a:gd name="connsiteX2" fmla="*/ 1244662 w 2418945"/>
                  <a:gd name="connsiteY2" fmla="*/ 1141753 h 1194086"/>
                  <a:gd name="connsiteX3" fmla="*/ 1351196 w 2418945"/>
                  <a:gd name="connsiteY3" fmla="*/ 1093324 h 1194086"/>
                  <a:gd name="connsiteX4" fmla="*/ 1576156 w 2418945"/>
                  <a:gd name="connsiteY4" fmla="*/ 410164 h 1194086"/>
                  <a:gd name="connsiteX5" fmla="*/ 2418945 w 2418945"/>
                  <a:gd name="connsiteY5" fmla="*/ 246604 h 1194086"/>
                  <a:gd name="connsiteX6" fmla="*/ 1205024 w 2418945"/>
                  <a:gd name="connsiteY6" fmla="*/ 1136 h 1194086"/>
                  <a:gd name="connsiteX7" fmla="*/ 3004 w 2418945"/>
                  <a:gd name="connsiteY7" fmla="*/ 285105 h 1194086"/>
                  <a:gd name="connsiteX0" fmla="*/ 3004 w 2418945"/>
                  <a:gd name="connsiteY0" fmla="*/ 285105 h 1194086"/>
                  <a:gd name="connsiteX1" fmla="*/ 912484 w 2418945"/>
                  <a:gd name="connsiteY1" fmla="*/ 435454 h 1194086"/>
                  <a:gd name="connsiteX2" fmla="*/ 1244662 w 2418945"/>
                  <a:gd name="connsiteY2" fmla="*/ 1141753 h 1194086"/>
                  <a:gd name="connsiteX3" fmla="*/ 1351196 w 2418945"/>
                  <a:gd name="connsiteY3" fmla="*/ 1093324 h 1194086"/>
                  <a:gd name="connsiteX4" fmla="*/ 1576156 w 2418945"/>
                  <a:gd name="connsiteY4" fmla="*/ 410164 h 1194086"/>
                  <a:gd name="connsiteX5" fmla="*/ 2418945 w 2418945"/>
                  <a:gd name="connsiteY5" fmla="*/ 246604 h 1194086"/>
                  <a:gd name="connsiteX6" fmla="*/ 1205024 w 2418945"/>
                  <a:gd name="connsiteY6" fmla="*/ 1136 h 1194086"/>
                  <a:gd name="connsiteX7" fmla="*/ 3004 w 2418945"/>
                  <a:gd name="connsiteY7" fmla="*/ 285105 h 1194086"/>
                  <a:gd name="connsiteX0" fmla="*/ 3004 w 2418945"/>
                  <a:gd name="connsiteY0" fmla="*/ 285105 h 1193546"/>
                  <a:gd name="connsiteX1" fmla="*/ 912484 w 2418945"/>
                  <a:gd name="connsiteY1" fmla="*/ 435454 h 1193546"/>
                  <a:gd name="connsiteX2" fmla="*/ 1244662 w 2418945"/>
                  <a:gd name="connsiteY2" fmla="*/ 1141753 h 1193546"/>
                  <a:gd name="connsiteX3" fmla="*/ 1351196 w 2418945"/>
                  <a:gd name="connsiteY3" fmla="*/ 1093324 h 1193546"/>
                  <a:gd name="connsiteX4" fmla="*/ 1615011 w 2418945"/>
                  <a:gd name="connsiteY4" fmla="*/ 420374 h 1193546"/>
                  <a:gd name="connsiteX5" fmla="*/ 2418945 w 2418945"/>
                  <a:gd name="connsiteY5" fmla="*/ 246604 h 1193546"/>
                  <a:gd name="connsiteX6" fmla="*/ 1205024 w 2418945"/>
                  <a:gd name="connsiteY6" fmla="*/ 1136 h 1193546"/>
                  <a:gd name="connsiteX7" fmla="*/ 3004 w 2418945"/>
                  <a:gd name="connsiteY7" fmla="*/ 285105 h 1193546"/>
                  <a:gd name="connsiteX0" fmla="*/ 3004 w 2418945"/>
                  <a:gd name="connsiteY0" fmla="*/ 285105 h 1193546"/>
                  <a:gd name="connsiteX1" fmla="*/ 912484 w 2418945"/>
                  <a:gd name="connsiteY1" fmla="*/ 435454 h 1193546"/>
                  <a:gd name="connsiteX2" fmla="*/ 1244662 w 2418945"/>
                  <a:gd name="connsiteY2" fmla="*/ 1141753 h 1193546"/>
                  <a:gd name="connsiteX3" fmla="*/ 1351196 w 2418945"/>
                  <a:gd name="connsiteY3" fmla="*/ 1093324 h 1193546"/>
                  <a:gd name="connsiteX4" fmla="*/ 1615011 w 2418945"/>
                  <a:gd name="connsiteY4" fmla="*/ 420374 h 1193546"/>
                  <a:gd name="connsiteX5" fmla="*/ 2418945 w 2418945"/>
                  <a:gd name="connsiteY5" fmla="*/ 246604 h 1193546"/>
                  <a:gd name="connsiteX6" fmla="*/ 1205024 w 2418945"/>
                  <a:gd name="connsiteY6" fmla="*/ 1136 h 1193546"/>
                  <a:gd name="connsiteX7" fmla="*/ 3004 w 2418945"/>
                  <a:gd name="connsiteY7" fmla="*/ 285105 h 1193546"/>
                  <a:gd name="connsiteX0" fmla="*/ 3004 w 2418945"/>
                  <a:gd name="connsiteY0" fmla="*/ 285105 h 1192020"/>
                  <a:gd name="connsiteX1" fmla="*/ 912484 w 2418945"/>
                  <a:gd name="connsiteY1" fmla="*/ 435454 h 1192020"/>
                  <a:gd name="connsiteX2" fmla="*/ 1244662 w 2418945"/>
                  <a:gd name="connsiteY2" fmla="*/ 1141753 h 1192020"/>
                  <a:gd name="connsiteX3" fmla="*/ 1351196 w 2418945"/>
                  <a:gd name="connsiteY3" fmla="*/ 1093324 h 1192020"/>
                  <a:gd name="connsiteX4" fmla="*/ 1643822 w 2418945"/>
                  <a:gd name="connsiteY4" fmla="*/ 449703 h 1192020"/>
                  <a:gd name="connsiteX5" fmla="*/ 2418945 w 2418945"/>
                  <a:gd name="connsiteY5" fmla="*/ 246604 h 1192020"/>
                  <a:gd name="connsiteX6" fmla="*/ 1205024 w 2418945"/>
                  <a:gd name="connsiteY6" fmla="*/ 1136 h 1192020"/>
                  <a:gd name="connsiteX7" fmla="*/ 3004 w 2418945"/>
                  <a:gd name="connsiteY7" fmla="*/ 285105 h 1192020"/>
                  <a:gd name="connsiteX0" fmla="*/ 3004 w 2418945"/>
                  <a:gd name="connsiteY0" fmla="*/ 285105 h 1192018"/>
                  <a:gd name="connsiteX1" fmla="*/ 912484 w 2418945"/>
                  <a:gd name="connsiteY1" fmla="*/ 435454 h 1192018"/>
                  <a:gd name="connsiteX2" fmla="*/ 1244662 w 2418945"/>
                  <a:gd name="connsiteY2" fmla="*/ 1141753 h 1192018"/>
                  <a:gd name="connsiteX3" fmla="*/ 1351196 w 2418945"/>
                  <a:gd name="connsiteY3" fmla="*/ 1093324 h 1192018"/>
                  <a:gd name="connsiteX4" fmla="*/ 1643822 w 2418945"/>
                  <a:gd name="connsiteY4" fmla="*/ 449703 h 1192018"/>
                  <a:gd name="connsiteX5" fmla="*/ 2418945 w 2418945"/>
                  <a:gd name="connsiteY5" fmla="*/ 246604 h 1192018"/>
                  <a:gd name="connsiteX6" fmla="*/ 1205024 w 2418945"/>
                  <a:gd name="connsiteY6" fmla="*/ 1136 h 1192018"/>
                  <a:gd name="connsiteX7" fmla="*/ 3004 w 2418945"/>
                  <a:gd name="connsiteY7" fmla="*/ 285105 h 1192018"/>
                  <a:gd name="connsiteX0" fmla="*/ 3004 w 2418945"/>
                  <a:gd name="connsiteY0" fmla="*/ 285105 h 1205218"/>
                  <a:gd name="connsiteX1" fmla="*/ 912484 w 2418945"/>
                  <a:gd name="connsiteY1" fmla="*/ 435454 h 1205218"/>
                  <a:gd name="connsiteX2" fmla="*/ 1244662 w 2418945"/>
                  <a:gd name="connsiteY2" fmla="*/ 1141753 h 1205218"/>
                  <a:gd name="connsiteX3" fmla="*/ 1419008 w 2418945"/>
                  <a:gd name="connsiteY3" fmla="*/ 1123227 h 1205218"/>
                  <a:gd name="connsiteX4" fmla="*/ 1643822 w 2418945"/>
                  <a:gd name="connsiteY4" fmla="*/ 449703 h 1205218"/>
                  <a:gd name="connsiteX5" fmla="*/ 2418945 w 2418945"/>
                  <a:gd name="connsiteY5" fmla="*/ 246604 h 1205218"/>
                  <a:gd name="connsiteX6" fmla="*/ 1205024 w 2418945"/>
                  <a:gd name="connsiteY6" fmla="*/ 1136 h 1205218"/>
                  <a:gd name="connsiteX7" fmla="*/ 3004 w 2418945"/>
                  <a:gd name="connsiteY7" fmla="*/ 285105 h 1205218"/>
                  <a:gd name="connsiteX0" fmla="*/ 3004 w 2418945"/>
                  <a:gd name="connsiteY0" fmla="*/ 285105 h 1207761"/>
                  <a:gd name="connsiteX1" fmla="*/ 912484 w 2418945"/>
                  <a:gd name="connsiteY1" fmla="*/ 435454 h 1207761"/>
                  <a:gd name="connsiteX2" fmla="*/ 1244662 w 2418945"/>
                  <a:gd name="connsiteY2" fmla="*/ 1141753 h 1207761"/>
                  <a:gd name="connsiteX3" fmla="*/ 1419008 w 2418945"/>
                  <a:gd name="connsiteY3" fmla="*/ 1123227 h 1207761"/>
                  <a:gd name="connsiteX4" fmla="*/ 1517656 w 2418945"/>
                  <a:gd name="connsiteY4" fmla="*/ 409299 h 1207761"/>
                  <a:gd name="connsiteX5" fmla="*/ 2418945 w 2418945"/>
                  <a:gd name="connsiteY5" fmla="*/ 246604 h 1207761"/>
                  <a:gd name="connsiteX6" fmla="*/ 1205024 w 2418945"/>
                  <a:gd name="connsiteY6" fmla="*/ 1136 h 1207761"/>
                  <a:gd name="connsiteX7" fmla="*/ 3004 w 2418945"/>
                  <a:gd name="connsiteY7" fmla="*/ 285105 h 1207761"/>
                  <a:gd name="connsiteX0" fmla="*/ 3004 w 2418945"/>
                  <a:gd name="connsiteY0" fmla="*/ 285105 h 1207761"/>
                  <a:gd name="connsiteX1" fmla="*/ 912484 w 2418945"/>
                  <a:gd name="connsiteY1" fmla="*/ 435454 h 1207761"/>
                  <a:gd name="connsiteX2" fmla="*/ 1244662 w 2418945"/>
                  <a:gd name="connsiteY2" fmla="*/ 1141753 h 1207761"/>
                  <a:gd name="connsiteX3" fmla="*/ 1419008 w 2418945"/>
                  <a:gd name="connsiteY3" fmla="*/ 1123227 h 1207761"/>
                  <a:gd name="connsiteX4" fmla="*/ 1517656 w 2418945"/>
                  <a:gd name="connsiteY4" fmla="*/ 409299 h 1207761"/>
                  <a:gd name="connsiteX5" fmla="*/ 2418945 w 2418945"/>
                  <a:gd name="connsiteY5" fmla="*/ 246604 h 1207761"/>
                  <a:gd name="connsiteX6" fmla="*/ 1205024 w 2418945"/>
                  <a:gd name="connsiteY6" fmla="*/ 1136 h 1207761"/>
                  <a:gd name="connsiteX7" fmla="*/ 3004 w 2418945"/>
                  <a:gd name="connsiteY7" fmla="*/ 285105 h 1207761"/>
                  <a:gd name="connsiteX0" fmla="*/ 3004 w 2418945"/>
                  <a:gd name="connsiteY0" fmla="*/ 285105 h 1207124"/>
                  <a:gd name="connsiteX1" fmla="*/ 912484 w 2418945"/>
                  <a:gd name="connsiteY1" fmla="*/ 435454 h 1207124"/>
                  <a:gd name="connsiteX2" fmla="*/ 1244662 w 2418945"/>
                  <a:gd name="connsiteY2" fmla="*/ 1141753 h 1207124"/>
                  <a:gd name="connsiteX3" fmla="*/ 1419008 w 2418945"/>
                  <a:gd name="connsiteY3" fmla="*/ 1123227 h 1207124"/>
                  <a:gd name="connsiteX4" fmla="*/ 1546761 w 2418945"/>
                  <a:gd name="connsiteY4" fmla="*/ 419365 h 1207124"/>
                  <a:gd name="connsiteX5" fmla="*/ 2418945 w 2418945"/>
                  <a:gd name="connsiteY5" fmla="*/ 246604 h 1207124"/>
                  <a:gd name="connsiteX6" fmla="*/ 1205024 w 2418945"/>
                  <a:gd name="connsiteY6" fmla="*/ 1136 h 1207124"/>
                  <a:gd name="connsiteX7" fmla="*/ 3004 w 2418945"/>
                  <a:gd name="connsiteY7" fmla="*/ 285105 h 1207124"/>
                  <a:gd name="connsiteX0" fmla="*/ 3004 w 2418945"/>
                  <a:gd name="connsiteY0" fmla="*/ 285105 h 1207124"/>
                  <a:gd name="connsiteX1" fmla="*/ 912484 w 2418945"/>
                  <a:gd name="connsiteY1" fmla="*/ 435454 h 1207124"/>
                  <a:gd name="connsiteX2" fmla="*/ 1244662 w 2418945"/>
                  <a:gd name="connsiteY2" fmla="*/ 1141753 h 1207124"/>
                  <a:gd name="connsiteX3" fmla="*/ 1419008 w 2418945"/>
                  <a:gd name="connsiteY3" fmla="*/ 1123227 h 1207124"/>
                  <a:gd name="connsiteX4" fmla="*/ 1546761 w 2418945"/>
                  <a:gd name="connsiteY4" fmla="*/ 419365 h 1207124"/>
                  <a:gd name="connsiteX5" fmla="*/ 2418945 w 2418945"/>
                  <a:gd name="connsiteY5" fmla="*/ 246604 h 1207124"/>
                  <a:gd name="connsiteX6" fmla="*/ 1205024 w 2418945"/>
                  <a:gd name="connsiteY6" fmla="*/ 1136 h 1207124"/>
                  <a:gd name="connsiteX7" fmla="*/ 3004 w 2418945"/>
                  <a:gd name="connsiteY7" fmla="*/ 285105 h 1207124"/>
                  <a:gd name="connsiteX0" fmla="*/ 3004 w 2418945"/>
                  <a:gd name="connsiteY0" fmla="*/ 285105 h 1207124"/>
                  <a:gd name="connsiteX1" fmla="*/ 912484 w 2418945"/>
                  <a:gd name="connsiteY1" fmla="*/ 435454 h 1207124"/>
                  <a:gd name="connsiteX2" fmla="*/ 1244662 w 2418945"/>
                  <a:gd name="connsiteY2" fmla="*/ 1141753 h 1207124"/>
                  <a:gd name="connsiteX3" fmla="*/ 1419008 w 2418945"/>
                  <a:gd name="connsiteY3" fmla="*/ 1123227 h 1207124"/>
                  <a:gd name="connsiteX4" fmla="*/ 1546761 w 2418945"/>
                  <a:gd name="connsiteY4" fmla="*/ 419365 h 1207124"/>
                  <a:gd name="connsiteX5" fmla="*/ 2418945 w 2418945"/>
                  <a:gd name="connsiteY5" fmla="*/ 246604 h 1207124"/>
                  <a:gd name="connsiteX6" fmla="*/ 1205024 w 2418945"/>
                  <a:gd name="connsiteY6" fmla="*/ 1136 h 1207124"/>
                  <a:gd name="connsiteX7" fmla="*/ 3004 w 2418945"/>
                  <a:gd name="connsiteY7" fmla="*/ 285105 h 1207124"/>
                  <a:gd name="connsiteX0" fmla="*/ 3004 w 2418945"/>
                  <a:gd name="connsiteY0" fmla="*/ 285105 h 1207124"/>
                  <a:gd name="connsiteX1" fmla="*/ 912484 w 2418945"/>
                  <a:gd name="connsiteY1" fmla="*/ 435454 h 1207124"/>
                  <a:gd name="connsiteX2" fmla="*/ 1244662 w 2418945"/>
                  <a:gd name="connsiteY2" fmla="*/ 1141753 h 1207124"/>
                  <a:gd name="connsiteX3" fmla="*/ 1419008 w 2418945"/>
                  <a:gd name="connsiteY3" fmla="*/ 1123227 h 1207124"/>
                  <a:gd name="connsiteX4" fmla="*/ 1546761 w 2418945"/>
                  <a:gd name="connsiteY4" fmla="*/ 419365 h 1207124"/>
                  <a:gd name="connsiteX5" fmla="*/ 2418945 w 2418945"/>
                  <a:gd name="connsiteY5" fmla="*/ 246604 h 1207124"/>
                  <a:gd name="connsiteX6" fmla="*/ 1205024 w 2418945"/>
                  <a:gd name="connsiteY6" fmla="*/ 1136 h 1207124"/>
                  <a:gd name="connsiteX7" fmla="*/ 3004 w 2418945"/>
                  <a:gd name="connsiteY7" fmla="*/ 285105 h 1207124"/>
                  <a:gd name="connsiteX0" fmla="*/ 3004 w 2418945"/>
                  <a:gd name="connsiteY0" fmla="*/ 285105 h 1207124"/>
                  <a:gd name="connsiteX1" fmla="*/ 912484 w 2418945"/>
                  <a:gd name="connsiteY1" fmla="*/ 435454 h 1207124"/>
                  <a:gd name="connsiteX2" fmla="*/ 1244662 w 2418945"/>
                  <a:gd name="connsiteY2" fmla="*/ 1141753 h 1207124"/>
                  <a:gd name="connsiteX3" fmla="*/ 1419008 w 2418945"/>
                  <a:gd name="connsiteY3" fmla="*/ 1123227 h 1207124"/>
                  <a:gd name="connsiteX4" fmla="*/ 1546761 w 2418945"/>
                  <a:gd name="connsiteY4" fmla="*/ 419365 h 1207124"/>
                  <a:gd name="connsiteX5" fmla="*/ 2418945 w 2418945"/>
                  <a:gd name="connsiteY5" fmla="*/ 246604 h 1207124"/>
                  <a:gd name="connsiteX6" fmla="*/ 1205024 w 2418945"/>
                  <a:gd name="connsiteY6" fmla="*/ 1136 h 1207124"/>
                  <a:gd name="connsiteX7" fmla="*/ 3004 w 2418945"/>
                  <a:gd name="connsiteY7" fmla="*/ 285105 h 1207124"/>
                  <a:gd name="connsiteX0" fmla="*/ 3004 w 2418945"/>
                  <a:gd name="connsiteY0" fmla="*/ 285105 h 1206479"/>
                  <a:gd name="connsiteX1" fmla="*/ 912484 w 2418945"/>
                  <a:gd name="connsiteY1" fmla="*/ 435454 h 1206479"/>
                  <a:gd name="connsiteX2" fmla="*/ 1244662 w 2418945"/>
                  <a:gd name="connsiteY2" fmla="*/ 1141753 h 1206479"/>
                  <a:gd name="connsiteX3" fmla="*/ 1419008 w 2418945"/>
                  <a:gd name="connsiteY3" fmla="*/ 1123227 h 1206479"/>
                  <a:gd name="connsiteX4" fmla="*/ 1585618 w 2418945"/>
                  <a:gd name="connsiteY4" fmla="*/ 429572 h 1206479"/>
                  <a:gd name="connsiteX5" fmla="*/ 2418945 w 2418945"/>
                  <a:gd name="connsiteY5" fmla="*/ 246604 h 1206479"/>
                  <a:gd name="connsiteX6" fmla="*/ 1205024 w 2418945"/>
                  <a:gd name="connsiteY6" fmla="*/ 1136 h 1206479"/>
                  <a:gd name="connsiteX7" fmla="*/ 3004 w 2418945"/>
                  <a:gd name="connsiteY7" fmla="*/ 285105 h 1206479"/>
                  <a:gd name="connsiteX0" fmla="*/ 3004 w 2418945"/>
                  <a:gd name="connsiteY0" fmla="*/ 285105 h 1206481"/>
                  <a:gd name="connsiteX1" fmla="*/ 912484 w 2418945"/>
                  <a:gd name="connsiteY1" fmla="*/ 435454 h 1206481"/>
                  <a:gd name="connsiteX2" fmla="*/ 1244662 w 2418945"/>
                  <a:gd name="connsiteY2" fmla="*/ 1141753 h 1206481"/>
                  <a:gd name="connsiteX3" fmla="*/ 1419008 w 2418945"/>
                  <a:gd name="connsiteY3" fmla="*/ 1123227 h 1206481"/>
                  <a:gd name="connsiteX4" fmla="*/ 1585618 w 2418945"/>
                  <a:gd name="connsiteY4" fmla="*/ 429572 h 1206481"/>
                  <a:gd name="connsiteX5" fmla="*/ 2418945 w 2418945"/>
                  <a:gd name="connsiteY5" fmla="*/ 246604 h 1206481"/>
                  <a:gd name="connsiteX6" fmla="*/ 1205024 w 2418945"/>
                  <a:gd name="connsiteY6" fmla="*/ 1136 h 1206481"/>
                  <a:gd name="connsiteX7" fmla="*/ 3004 w 2418945"/>
                  <a:gd name="connsiteY7" fmla="*/ 285105 h 1206481"/>
                  <a:gd name="connsiteX0" fmla="*/ 3142 w 2419083"/>
                  <a:gd name="connsiteY0" fmla="*/ 369355 h 1290730"/>
                  <a:gd name="connsiteX1" fmla="*/ 912622 w 2419083"/>
                  <a:gd name="connsiteY1" fmla="*/ 519704 h 1290730"/>
                  <a:gd name="connsiteX2" fmla="*/ 1244800 w 2419083"/>
                  <a:gd name="connsiteY2" fmla="*/ 1226003 h 1290730"/>
                  <a:gd name="connsiteX3" fmla="*/ 1419146 w 2419083"/>
                  <a:gd name="connsiteY3" fmla="*/ 1207477 h 1290730"/>
                  <a:gd name="connsiteX4" fmla="*/ 1585756 w 2419083"/>
                  <a:gd name="connsiteY4" fmla="*/ 513822 h 1290730"/>
                  <a:gd name="connsiteX5" fmla="*/ 2419083 w 2419083"/>
                  <a:gd name="connsiteY5" fmla="*/ 330854 h 1290730"/>
                  <a:gd name="connsiteX6" fmla="*/ 1212348 w 2419083"/>
                  <a:gd name="connsiteY6" fmla="*/ 882 h 1290730"/>
                  <a:gd name="connsiteX7" fmla="*/ 3142 w 2419083"/>
                  <a:gd name="connsiteY7" fmla="*/ 369355 h 1290730"/>
                  <a:gd name="connsiteX0" fmla="*/ 3866 w 2419807"/>
                  <a:gd name="connsiteY0" fmla="*/ 383386 h 1304761"/>
                  <a:gd name="connsiteX1" fmla="*/ 913346 w 2419807"/>
                  <a:gd name="connsiteY1" fmla="*/ 533735 h 1304761"/>
                  <a:gd name="connsiteX2" fmla="*/ 1245524 w 2419807"/>
                  <a:gd name="connsiteY2" fmla="*/ 1240034 h 1304761"/>
                  <a:gd name="connsiteX3" fmla="*/ 1419870 w 2419807"/>
                  <a:gd name="connsiteY3" fmla="*/ 1221508 h 1304761"/>
                  <a:gd name="connsiteX4" fmla="*/ 1586480 w 2419807"/>
                  <a:gd name="connsiteY4" fmla="*/ 527853 h 1304761"/>
                  <a:gd name="connsiteX5" fmla="*/ 2419807 w 2419807"/>
                  <a:gd name="connsiteY5" fmla="*/ 344885 h 1304761"/>
                  <a:gd name="connsiteX6" fmla="*/ 1248730 w 2419807"/>
                  <a:gd name="connsiteY6" fmla="*/ 850 h 1304761"/>
                  <a:gd name="connsiteX7" fmla="*/ 3866 w 2419807"/>
                  <a:gd name="connsiteY7" fmla="*/ 383386 h 130476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</a:cxnLst>
                <a:rect l="l" t="t" r="r" b="b"/>
                <a:pathLst>
                  <a:path w="2419807" h="1304761">
                    <a:moveTo>
                      <a:pt x="3866" y="383386"/>
                    </a:moveTo>
                    <a:cubicBezTo>
                      <a:pt x="-52031" y="472200"/>
                      <a:pt x="510185" y="844527"/>
                      <a:pt x="913346" y="533735"/>
                    </a:cubicBezTo>
                    <a:cubicBezTo>
                      <a:pt x="1316507" y="222943"/>
                      <a:pt x="1206411" y="1202872"/>
                      <a:pt x="1245524" y="1240034"/>
                    </a:cubicBezTo>
                    <a:cubicBezTo>
                      <a:pt x="1308383" y="1318632"/>
                      <a:pt x="1363044" y="1340205"/>
                      <a:pt x="1419870" y="1221508"/>
                    </a:cubicBezTo>
                    <a:cubicBezTo>
                      <a:pt x="1476696" y="1102811"/>
                      <a:pt x="1308533" y="296635"/>
                      <a:pt x="1586480" y="527853"/>
                    </a:cubicBezTo>
                    <a:cubicBezTo>
                      <a:pt x="1864427" y="759071"/>
                      <a:pt x="2276554" y="845338"/>
                      <a:pt x="2419807" y="344885"/>
                    </a:cubicBezTo>
                    <a:cubicBezTo>
                      <a:pt x="2031588" y="210131"/>
                      <a:pt x="1694700" y="20100"/>
                      <a:pt x="1248730" y="850"/>
                    </a:cubicBezTo>
                    <a:cubicBezTo>
                      <a:pt x="802760" y="-18400"/>
                      <a:pt x="59763" y="294572"/>
                      <a:pt x="3866" y="383386"/>
                    </a:cubicBezTo>
                    <a:close/>
                  </a:path>
                </a:pathLst>
              </a:custGeom>
              <a:gradFill flip="none" rotWithShape="1">
                <a:gsLst>
                  <a:gs pos="6000">
                    <a:srgbClr val="DB6458"/>
                  </a:gs>
                  <a:gs pos="89000">
                    <a:schemeClr val="accent2">
                      <a:lumMod val="60000"/>
                      <a:lumOff val="40000"/>
                    </a:schemeClr>
                  </a:gs>
                </a:gsLst>
                <a:path path="circle">
                  <a:fillToRect l="100000" t="100000"/>
                </a:path>
                <a:tileRect r="-100000" b="-100000"/>
              </a:gradFill>
              <a:ln w="12700" cap="rnd" cmpd="sng">
                <a:solidFill>
                  <a:srgbClr val="996F83"/>
                </a:solidFill>
                <a:prstDash val="solid"/>
                <a:round/>
                <a:headEnd type="none" w="med" len="med"/>
                <a:tailEnd type="none" w="med" len="med"/>
              </a:ln>
              <a:effectLst>
                <a:innerShdw blurRad="393700" dist="63500" dir="18000000">
                  <a:prstClr val="black">
                    <a:alpha val="50000"/>
                  </a:prstClr>
                </a:innerShdw>
              </a:effectLst>
            </p:spPr>
            <p:txBody>
              <a:bodyPr/>
              <a:lstStyle/>
              <a:p>
                <a:endParaRPr lang="zh-CN" altLang="en-US" sz="1400" dirty="0"/>
              </a:p>
            </p:txBody>
          </p:sp>
        </p:grpSp>
        <p:sp>
          <p:nvSpPr>
            <p:cNvPr id="902" name="任意多边形: 形状 901">
              <a:extLst>
                <a:ext uri="{FF2B5EF4-FFF2-40B4-BE49-F238E27FC236}">
                  <a16:creationId xmlns:a16="http://schemas.microsoft.com/office/drawing/2014/main" id="{0570D944-1D1E-C64F-6ECB-FAF8202EE031}"/>
                </a:ext>
              </a:extLst>
            </p:cNvPr>
            <p:cNvSpPr/>
            <p:nvPr/>
          </p:nvSpPr>
          <p:spPr>
            <a:xfrm rot="14942746">
              <a:off x="3481326" y="5133999"/>
              <a:ext cx="2864132" cy="1773872"/>
            </a:xfrm>
            <a:custGeom>
              <a:avLst/>
              <a:gdLst>
                <a:gd name="connsiteX0" fmla="*/ 21522 w 5713605"/>
                <a:gd name="connsiteY0" fmla="*/ 2598786 h 3469679"/>
                <a:gd name="connsiteX1" fmla="*/ 110732 w 5713605"/>
                <a:gd name="connsiteY1" fmla="*/ 2119283 h 3469679"/>
                <a:gd name="connsiteX2" fmla="*/ 645990 w 5713605"/>
                <a:gd name="connsiteY2" fmla="*/ 1617478 h 3469679"/>
                <a:gd name="connsiteX3" fmla="*/ 1482332 w 5713605"/>
                <a:gd name="connsiteY3" fmla="*/ 1171430 h 3469679"/>
                <a:gd name="connsiteX4" fmla="*/ 2285219 w 5713605"/>
                <a:gd name="connsiteY4" fmla="*/ 502356 h 3469679"/>
                <a:gd name="connsiteX5" fmla="*/ 2976595 w 5713605"/>
                <a:gd name="connsiteY5" fmla="*/ 145517 h 3469679"/>
                <a:gd name="connsiteX6" fmla="*/ 4091717 w 5713605"/>
                <a:gd name="connsiteY6" fmla="*/ 551 h 3469679"/>
                <a:gd name="connsiteX7" fmla="*/ 4783093 w 5713605"/>
                <a:gd name="connsiteY7" fmla="*/ 190122 h 3469679"/>
                <a:gd name="connsiteX8" fmla="*/ 5173385 w 5713605"/>
                <a:gd name="connsiteY8" fmla="*/ 613869 h 3469679"/>
                <a:gd name="connsiteX9" fmla="*/ 5630585 w 5713605"/>
                <a:gd name="connsiteY9" fmla="*/ 1539420 h 3469679"/>
                <a:gd name="connsiteX10" fmla="*/ 5697493 w 5713605"/>
                <a:gd name="connsiteY10" fmla="*/ 2375761 h 3469679"/>
                <a:gd name="connsiteX11" fmla="*/ 5441014 w 5713605"/>
                <a:gd name="connsiteY11" fmla="*/ 3044834 h 3469679"/>
                <a:gd name="connsiteX12" fmla="*/ 4838849 w 5713605"/>
                <a:gd name="connsiteY12" fmla="*/ 3368220 h 3469679"/>
                <a:gd name="connsiteX13" fmla="*/ 2764722 w 5713605"/>
                <a:gd name="connsiteY13" fmla="*/ 3468581 h 3469679"/>
                <a:gd name="connsiteX14" fmla="*/ 1604995 w 5713605"/>
                <a:gd name="connsiteY14" fmla="*/ 3412825 h 3469679"/>
                <a:gd name="connsiteX15" fmla="*/ 1058585 w 5713605"/>
                <a:gd name="connsiteY15" fmla="*/ 3279010 h 3469679"/>
                <a:gd name="connsiteX16" fmla="*/ 389512 w 5713605"/>
                <a:gd name="connsiteY16" fmla="*/ 3100590 h 3469679"/>
                <a:gd name="connsiteX17" fmla="*/ 32673 w 5713605"/>
                <a:gd name="connsiteY17" fmla="*/ 2710298 h 3469679"/>
                <a:gd name="connsiteX18" fmla="*/ 21522 w 5713605"/>
                <a:gd name="connsiteY18" fmla="*/ 2598786 h 3469679"/>
                <a:gd name="connsiteX0" fmla="*/ 23133 w 5704065"/>
                <a:gd name="connsiteY0" fmla="*/ 2710298 h 3469679"/>
                <a:gd name="connsiteX1" fmla="*/ 101192 w 5704065"/>
                <a:gd name="connsiteY1" fmla="*/ 2119283 h 3469679"/>
                <a:gd name="connsiteX2" fmla="*/ 636450 w 5704065"/>
                <a:gd name="connsiteY2" fmla="*/ 1617478 h 3469679"/>
                <a:gd name="connsiteX3" fmla="*/ 1472792 w 5704065"/>
                <a:gd name="connsiteY3" fmla="*/ 1171430 h 3469679"/>
                <a:gd name="connsiteX4" fmla="*/ 2275679 w 5704065"/>
                <a:gd name="connsiteY4" fmla="*/ 502356 h 3469679"/>
                <a:gd name="connsiteX5" fmla="*/ 2967055 w 5704065"/>
                <a:gd name="connsiteY5" fmla="*/ 145517 h 3469679"/>
                <a:gd name="connsiteX6" fmla="*/ 4082177 w 5704065"/>
                <a:gd name="connsiteY6" fmla="*/ 551 h 3469679"/>
                <a:gd name="connsiteX7" fmla="*/ 4773553 w 5704065"/>
                <a:gd name="connsiteY7" fmla="*/ 190122 h 3469679"/>
                <a:gd name="connsiteX8" fmla="*/ 5163845 w 5704065"/>
                <a:gd name="connsiteY8" fmla="*/ 613869 h 3469679"/>
                <a:gd name="connsiteX9" fmla="*/ 5621045 w 5704065"/>
                <a:gd name="connsiteY9" fmla="*/ 1539420 h 3469679"/>
                <a:gd name="connsiteX10" fmla="*/ 5687953 w 5704065"/>
                <a:gd name="connsiteY10" fmla="*/ 2375761 h 3469679"/>
                <a:gd name="connsiteX11" fmla="*/ 5431474 w 5704065"/>
                <a:gd name="connsiteY11" fmla="*/ 3044834 h 3469679"/>
                <a:gd name="connsiteX12" fmla="*/ 4829309 w 5704065"/>
                <a:gd name="connsiteY12" fmla="*/ 3368220 h 3469679"/>
                <a:gd name="connsiteX13" fmla="*/ 2755182 w 5704065"/>
                <a:gd name="connsiteY13" fmla="*/ 3468581 h 3469679"/>
                <a:gd name="connsiteX14" fmla="*/ 1595455 w 5704065"/>
                <a:gd name="connsiteY14" fmla="*/ 3412825 h 3469679"/>
                <a:gd name="connsiteX15" fmla="*/ 1049045 w 5704065"/>
                <a:gd name="connsiteY15" fmla="*/ 3279010 h 3469679"/>
                <a:gd name="connsiteX16" fmla="*/ 379972 w 5704065"/>
                <a:gd name="connsiteY16" fmla="*/ 3100590 h 3469679"/>
                <a:gd name="connsiteX17" fmla="*/ 23133 w 5704065"/>
                <a:gd name="connsiteY17" fmla="*/ 2710298 h 3469679"/>
                <a:gd name="connsiteX0" fmla="*/ 23133 w 5704065"/>
                <a:gd name="connsiteY0" fmla="*/ 2710298 h 3476747"/>
                <a:gd name="connsiteX1" fmla="*/ 101192 w 5704065"/>
                <a:gd name="connsiteY1" fmla="*/ 2119283 h 3476747"/>
                <a:gd name="connsiteX2" fmla="*/ 636450 w 5704065"/>
                <a:gd name="connsiteY2" fmla="*/ 1617478 h 3476747"/>
                <a:gd name="connsiteX3" fmla="*/ 1472792 w 5704065"/>
                <a:gd name="connsiteY3" fmla="*/ 1171430 h 3476747"/>
                <a:gd name="connsiteX4" fmla="*/ 2275679 w 5704065"/>
                <a:gd name="connsiteY4" fmla="*/ 502356 h 3476747"/>
                <a:gd name="connsiteX5" fmla="*/ 2967055 w 5704065"/>
                <a:gd name="connsiteY5" fmla="*/ 145517 h 3476747"/>
                <a:gd name="connsiteX6" fmla="*/ 4082177 w 5704065"/>
                <a:gd name="connsiteY6" fmla="*/ 551 h 3476747"/>
                <a:gd name="connsiteX7" fmla="*/ 4773553 w 5704065"/>
                <a:gd name="connsiteY7" fmla="*/ 190122 h 3476747"/>
                <a:gd name="connsiteX8" fmla="*/ 5163845 w 5704065"/>
                <a:gd name="connsiteY8" fmla="*/ 613869 h 3476747"/>
                <a:gd name="connsiteX9" fmla="*/ 5621045 w 5704065"/>
                <a:gd name="connsiteY9" fmla="*/ 1539420 h 3476747"/>
                <a:gd name="connsiteX10" fmla="*/ 5687953 w 5704065"/>
                <a:gd name="connsiteY10" fmla="*/ 2375761 h 3476747"/>
                <a:gd name="connsiteX11" fmla="*/ 5431474 w 5704065"/>
                <a:gd name="connsiteY11" fmla="*/ 3044834 h 3476747"/>
                <a:gd name="connsiteX12" fmla="*/ 4963245 w 5704065"/>
                <a:gd name="connsiteY12" fmla="*/ 3242017 h 3476747"/>
                <a:gd name="connsiteX13" fmla="*/ 2755182 w 5704065"/>
                <a:gd name="connsiteY13" fmla="*/ 3468581 h 3476747"/>
                <a:gd name="connsiteX14" fmla="*/ 1595455 w 5704065"/>
                <a:gd name="connsiteY14" fmla="*/ 3412825 h 3476747"/>
                <a:gd name="connsiteX15" fmla="*/ 1049045 w 5704065"/>
                <a:gd name="connsiteY15" fmla="*/ 3279010 h 3476747"/>
                <a:gd name="connsiteX16" fmla="*/ 379972 w 5704065"/>
                <a:gd name="connsiteY16" fmla="*/ 3100590 h 3476747"/>
                <a:gd name="connsiteX17" fmla="*/ 23133 w 5704065"/>
                <a:gd name="connsiteY17" fmla="*/ 2710298 h 3476747"/>
                <a:gd name="connsiteX0" fmla="*/ 23133 w 5711265"/>
                <a:gd name="connsiteY0" fmla="*/ 2710298 h 3476747"/>
                <a:gd name="connsiteX1" fmla="*/ 101192 w 5711265"/>
                <a:gd name="connsiteY1" fmla="*/ 2119283 h 3476747"/>
                <a:gd name="connsiteX2" fmla="*/ 636450 w 5711265"/>
                <a:gd name="connsiteY2" fmla="*/ 1617478 h 3476747"/>
                <a:gd name="connsiteX3" fmla="*/ 1472792 w 5711265"/>
                <a:gd name="connsiteY3" fmla="*/ 1171430 h 3476747"/>
                <a:gd name="connsiteX4" fmla="*/ 2275679 w 5711265"/>
                <a:gd name="connsiteY4" fmla="*/ 502356 h 3476747"/>
                <a:gd name="connsiteX5" fmla="*/ 2967055 w 5711265"/>
                <a:gd name="connsiteY5" fmla="*/ 145517 h 3476747"/>
                <a:gd name="connsiteX6" fmla="*/ 4082177 w 5711265"/>
                <a:gd name="connsiteY6" fmla="*/ 551 h 3476747"/>
                <a:gd name="connsiteX7" fmla="*/ 4773553 w 5711265"/>
                <a:gd name="connsiteY7" fmla="*/ 190122 h 3476747"/>
                <a:gd name="connsiteX8" fmla="*/ 5163845 w 5711265"/>
                <a:gd name="connsiteY8" fmla="*/ 613869 h 3476747"/>
                <a:gd name="connsiteX9" fmla="*/ 5621045 w 5711265"/>
                <a:gd name="connsiteY9" fmla="*/ 1539420 h 3476747"/>
                <a:gd name="connsiteX10" fmla="*/ 5687953 w 5711265"/>
                <a:gd name="connsiteY10" fmla="*/ 2375761 h 3476747"/>
                <a:gd name="connsiteX11" fmla="*/ 5334265 w 5711265"/>
                <a:gd name="connsiteY11" fmla="*/ 2989546 h 3476747"/>
                <a:gd name="connsiteX12" fmla="*/ 4963245 w 5711265"/>
                <a:gd name="connsiteY12" fmla="*/ 3242017 h 3476747"/>
                <a:gd name="connsiteX13" fmla="*/ 2755182 w 5711265"/>
                <a:gd name="connsiteY13" fmla="*/ 3468581 h 3476747"/>
                <a:gd name="connsiteX14" fmla="*/ 1595455 w 5711265"/>
                <a:gd name="connsiteY14" fmla="*/ 3412825 h 3476747"/>
                <a:gd name="connsiteX15" fmla="*/ 1049045 w 5711265"/>
                <a:gd name="connsiteY15" fmla="*/ 3279010 h 3476747"/>
                <a:gd name="connsiteX16" fmla="*/ 379972 w 5711265"/>
                <a:gd name="connsiteY16" fmla="*/ 3100590 h 3476747"/>
                <a:gd name="connsiteX17" fmla="*/ 23133 w 5711265"/>
                <a:gd name="connsiteY17" fmla="*/ 2710298 h 3476747"/>
                <a:gd name="connsiteX0" fmla="*/ 23133 w 5660398"/>
                <a:gd name="connsiteY0" fmla="*/ 2710298 h 3476747"/>
                <a:gd name="connsiteX1" fmla="*/ 101192 w 5660398"/>
                <a:gd name="connsiteY1" fmla="*/ 2119283 h 3476747"/>
                <a:gd name="connsiteX2" fmla="*/ 636450 w 5660398"/>
                <a:gd name="connsiteY2" fmla="*/ 1617478 h 3476747"/>
                <a:gd name="connsiteX3" fmla="*/ 1472792 w 5660398"/>
                <a:gd name="connsiteY3" fmla="*/ 1171430 h 3476747"/>
                <a:gd name="connsiteX4" fmla="*/ 2275679 w 5660398"/>
                <a:gd name="connsiteY4" fmla="*/ 502356 h 3476747"/>
                <a:gd name="connsiteX5" fmla="*/ 2967055 w 5660398"/>
                <a:gd name="connsiteY5" fmla="*/ 145517 h 3476747"/>
                <a:gd name="connsiteX6" fmla="*/ 4082177 w 5660398"/>
                <a:gd name="connsiteY6" fmla="*/ 551 h 3476747"/>
                <a:gd name="connsiteX7" fmla="*/ 4773553 w 5660398"/>
                <a:gd name="connsiteY7" fmla="*/ 190122 h 3476747"/>
                <a:gd name="connsiteX8" fmla="*/ 5163845 w 5660398"/>
                <a:gd name="connsiteY8" fmla="*/ 613869 h 3476747"/>
                <a:gd name="connsiteX9" fmla="*/ 5621045 w 5660398"/>
                <a:gd name="connsiteY9" fmla="*/ 1539420 h 3476747"/>
                <a:gd name="connsiteX10" fmla="*/ 5603673 w 5660398"/>
                <a:gd name="connsiteY10" fmla="*/ 2394322 h 3476747"/>
                <a:gd name="connsiteX11" fmla="*/ 5334265 w 5660398"/>
                <a:gd name="connsiteY11" fmla="*/ 2989546 h 3476747"/>
                <a:gd name="connsiteX12" fmla="*/ 4963245 w 5660398"/>
                <a:gd name="connsiteY12" fmla="*/ 3242017 h 3476747"/>
                <a:gd name="connsiteX13" fmla="*/ 2755182 w 5660398"/>
                <a:gd name="connsiteY13" fmla="*/ 3468581 h 3476747"/>
                <a:gd name="connsiteX14" fmla="*/ 1595455 w 5660398"/>
                <a:gd name="connsiteY14" fmla="*/ 3412825 h 3476747"/>
                <a:gd name="connsiteX15" fmla="*/ 1049045 w 5660398"/>
                <a:gd name="connsiteY15" fmla="*/ 3279010 h 3476747"/>
                <a:gd name="connsiteX16" fmla="*/ 379972 w 5660398"/>
                <a:gd name="connsiteY16" fmla="*/ 3100590 h 3476747"/>
                <a:gd name="connsiteX17" fmla="*/ 23133 w 5660398"/>
                <a:gd name="connsiteY17" fmla="*/ 2710298 h 3476747"/>
                <a:gd name="connsiteX0" fmla="*/ 23133 w 5660398"/>
                <a:gd name="connsiteY0" fmla="*/ 2710298 h 3479795"/>
                <a:gd name="connsiteX1" fmla="*/ 101192 w 5660398"/>
                <a:gd name="connsiteY1" fmla="*/ 2119283 h 3479795"/>
                <a:gd name="connsiteX2" fmla="*/ 636450 w 5660398"/>
                <a:gd name="connsiteY2" fmla="*/ 1617478 h 3479795"/>
                <a:gd name="connsiteX3" fmla="*/ 1472792 w 5660398"/>
                <a:gd name="connsiteY3" fmla="*/ 1171430 h 3479795"/>
                <a:gd name="connsiteX4" fmla="*/ 2275679 w 5660398"/>
                <a:gd name="connsiteY4" fmla="*/ 502356 h 3479795"/>
                <a:gd name="connsiteX5" fmla="*/ 2967055 w 5660398"/>
                <a:gd name="connsiteY5" fmla="*/ 145517 h 3479795"/>
                <a:gd name="connsiteX6" fmla="*/ 4082177 w 5660398"/>
                <a:gd name="connsiteY6" fmla="*/ 551 h 3479795"/>
                <a:gd name="connsiteX7" fmla="*/ 4773553 w 5660398"/>
                <a:gd name="connsiteY7" fmla="*/ 190122 h 3479795"/>
                <a:gd name="connsiteX8" fmla="*/ 5163845 w 5660398"/>
                <a:gd name="connsiteY8" fmla="*/ 613869 h 3479795"/>
                <a:gd name="connsiteX9" fmla="*/ 5621045 w 5660398"/>
                <a:gd name="connsiteY9" fmla="*/ 1539420 h 3479795"/>
                <a:gd name="connsiteX10" fmla="*/ 5603673 w 5660398"/>
                <a:gd name="connsiteY10" fmla="*/ 2394322 h 3479795"/>
                <a:gd name="connsiteX11" fmla="*/ 5334265 w 5660398"/>
                <a:gd name="connsiteY11" fmla="*/ 2989546 h 3479795"/>
                <a:gd name="connsiteX12" fmla="*/ 4924653 w 5660398"/>
                <a:gd name="connsiteY12" fmla="*/ 3195496 h 3479795"/>
                <a:gd name="connsiteX13" fmla="*/ 2755182 w 5660398"/>
                <a:gd name="connsiteY13" fmla="*/ 3468581 h 3479795"/>
                <a:gd name="connsiteX14" fmla="*/ 1595455 w 5660398"/>
                <a:gd name="connsiteY14" fmla="*/ 3412825 h 3479795"/>
                <a:gd name="connsiteX15" fmla="*/ 1049045 w 5660398"/>
                <a:gd name="connsiteY15" fmla="*/ 3279010 h 3479795"/>
                <a:gd name="connsiteX16" fmla="*/ 379972 w 5660398"/>
                <a:gd name="connsiteY16" fmla="*/ 3100590 h 3479795"/>
                <a:gd name="connsiteX17" fmla="*/ 23133 w 5660398"/>
                <a:gd name="connsiteY17" fmla="*/ 2710298 h 3479795"/>
                <a:gd name="connsiteX0" fmla="*/ 23133 w 5660958"/>
                <a:gd name="connsiteY0" fmla="*/ 2710298 h 3479795"/>
                <a:gd name="connsiteX1" fmla="*/ 101192 w 5660958"/>
                <a:gd name="connsiteY1" fmla="*/ 2119283 h 3479795"/>
                <a:gd name="connsiteX2" fmla="*/ 636450 w 5660958"/>
                <a:gd name="connsiteY2" fmla="*/ 1617478 h 3479795"/>
                <a:gd name="connsiteX3" fmla="*/ 1472792 w 5660958"/>
                <a:gd name="connsiteY3" fmla="*/ 1171430 h 3479795"/>
                <a:gd name="connsiteX4" fmla="*/ 2275679 w 5660958"/>
                <a:gd name="connsiteY4" fmla="*/ 502356 h 3479795"/>
                <a:gd name="connsiteX5" fmla="*/ 2967055 w 5660958"/>
                <a:gd name="connsiteY5" fmla="*/ 145517 h 3479795"/>
                <a:gd name="connsiteX6" fmla="*/ 4082177 w 5660958"/>
                <a:gd name="connsiteY6" fmla="*/ 551 h 3479795"/>
                <a:gd name="connsiteX7" fmla="*/ 4773553 w 5660958"/>
                <a:gd name="connsiteY7" fmla="*/ 190122 h 3479795"/>
                <a:gd name="connsiteX8" fmla="*/ 5163845 w 5660958"/>
                <a:gd name="connsiteY8" fmla="*/ 613869 h 3479795"/>
                <a:gd name="connsiteX9" fmla="*/ 5621045 w 5660958"/>
                <a:gd name="connsiteY9" fmla="*/ 1539420 h 3479795"/>
                <a:gd name="connsiteX10" fmla="*/ 5603673 w 5660958"/>
                <a:gd name="connsiteY10" fmla="*/ 2394322 h 3479795"/>
                <a:gd name="connsiteX11" fmla="*/ 5322169 w 5660958"/>
                <a:gd name="connsiteY11" fmla="*/ 2942191 h 3479795"/>
                <a:gd name="connsiteX12" fmla="*/ 4924653 w 5660958"/>
                <a:gd name="connsiteY12" fmla="*/ 3195496 h 3479795"/>
                <a:gd name="connsiteX13" fmla="*/ 2755182 w 5660958"/>
                <a:gd name="connsiteY13" fmla="*/ 3468581 h 3479795"/>
                <a:gd name="connsiteX14" fmla="*/ 1595455 w 5660958"/>
                <a:gd name="connsiteY14" fmla="*/ 3412825 h 3479795"/>
                <a:gd name="connsiteX15" fmla="*/ 1049045 w 5660958"/>
                <a:gd name="connsiteY15" fmla="*/ 3279010 h 3479795"/>
                <a:gd name="connsiteX16" fmla="*/ 379972 w 5660958"/>
                <a:gd name="connsiteY16" fmla="*/ 3100590 h 3479795"/>
                <a:gd name="connsiteX17" fmla="*/ 23133 w 5660958"/>
                <a:gd name="connsiteY17" fmla="*/ 2710298 h 3479795"/>
                <a:gd name="connsiteX0" fmla="*/ 23133 w 5683403"/>
                <a:gd name="connsiteY0" fmla="*/ 2710298 h 3479795"/>
                <a:gd name="connsiteX1" fmla="*/ 101192 w 5683403"/>
                <a:gd name="connsiteY1" fmla="*/ 2119283 h 3479795"/>
                <a:gd name="connsiteX2" fmla="*/ 636450 w 5683403"/>
                <a:gd name="connsiteY2" fmla="*/ 1617478 h 3479795"/>
                <a:gd name="connsiteX3" fmla="*/ 1472792 w 5683403"/>
                <a:gd name="connsiteY3" fmla="*/ 1171430 h 3479795"/>
                <a:gd name="connsiteX4" fmla="*/ 2275679 w 5683403"/>
                <a:gd name="connsiteY4" fmla="*/ 502356 h 3479795"/>
                <a:gd name="connsiteX5" fmla="*/ 2967055 w 5683403"/>
                <a:gd name="connsiteY5" fmla="*/ 145517 h 3479795"/>
                <a:gd name="connsiteX6" fmla="*/ 4082177 w 5683403"/>
                <a:gd name="connsiteY6" fmla="*/ 551 h 3479795"/>
                <a:gd name="connsiteX7" fmla="*/ 4773553 w 5683403"/>
                <a:gd name="connsiteY7" fmla="*/ 190122 h 3479795"/>
                <a:gd name="connsiteX8" fmla="*/ 5163845 w 5683403"/>
                <a:gd name="connsiteY8" fmla="*/ 613869 h 3479795"/>
                <a:gd name="connsiteX9" fmla="*/ 5621045 w 5683403"/>
                <a:gd name="connsiteY9" fmla="*/ 1539420 h 3479795"/>
                <a:gd name="connsiteX10" fmla="*/ 5603673 w 5683403"/>
                <a:gd name="connsiteY10" fmla="*/ 2394322 h 3479795"/>
                <a:gd name="connsiteX11" fmla="*/ 4924653 w 5683403"/>
                <a:gd name="connsiteY11" fmla="*/ 3195496 h 3479795"/>
                <a:gd name="connsiteX12" fmla="*/ 2755182 w 5683403"/>
                <a:gd name="connsiteY12" fmla="*/ 3468581 h 3479795"/>
                <a:gd name="connsiteX13" fmla="*/ 1595455 w 5683403"/>
                <a:gd name="connsiteY13" fmla="*/ 3412825 h 3479795"/>
                <a:gd name="connsiteX14" fmla="*/ 1049045 w 5683403"/>
                <a:gd name="connsiteY14" fmla="*/ 3279010 h 3479795"/>
                <a:gd name="connsiteX15" fmla="*/ 379972 w 5683403"/>
                <a:gd name="connsiteY15" fmla="*/ 3100590 h 3479795"/>
                <a:gd name="connsiteX16" fmla="*/ 23133 w 5683403"/>
                <a:gd name="connsiteY16" fmla="*/ 2710298 h 347979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</a:cxnLst>
              <a:rect l="l" t="t" r="r" b="b"/>
              <a:pathLst>
                <a:path w="5683403" h="3479795">
                  <a:moveTo>
                    <a:pt x="23133" y="2710298"/>
                  </a:moveTo>
                  <a:cubicBezTo>
                    <a:pt x="-23330" y="2546747"/>
                    <a:pt x="-1027" y="2301420"/>
                    <a:pt x="101192" y="2119283"/>
                  </a:cubicBezTo>
                  <a:cubicBezTo>
                    <a:pt x="203412" y="1937146"/>
                    <a:pt x="407850" y="1775453"/>
                    <a:pt x="636450" y="1617478"/>
                  </a:cubicBezTo>
                  <a:cubicBezTo>
                    <a:pt x="865050" y="1459503"/>
                    <a:pt x="1199587" y="1357284"/>
                    <a:pt x="1472792" y="1171430"/>
                  </a:cubicBezTo>
                  <a:cubicBezTo>
                    <a:pt x="1745997" y="985576"/>
                    <a:pt x="2026635" y="673341"/>
                    <a:pt x="2275679" y="502356"/>
                  </a:cubicBezTo>
                  <a:cubicBezTo>
                    <a:pt x="2524723" y="331371"/>
                    <a:pt x="2665972" y="229151"/>
                    <a:pt x="2967055" y="145517"/>
                  </a:cubicBezTo>
                  <a:cubicBezTo>
                    <a:pt x="3268138" y="61883"/>
                    <a:pt x="3781094" y="-6883"/>
                    <a:pt x="4082177" y="551"/>
                  </a:cubicBezTo>
                  <a:cubicBezTo>
                    <a:pt x="4383260" y="7985"/>
                    <a:pt x="4593275" y="87902"/>
                    <a:pt x="4773553" y="190122"/>
                  </a:cubicBezTo>
                  <a:cubicBezTo>
                    <a:pt x="4953831" y="292342"/>
                    <a:pt x="5022596" y="388986"/>
                    <a:pt x="5163845" y="613869"/>
                  </a:cubicBezTo>
                  <a:cubicBezTo>
                    <a:pt x="5305094" y="838752"/>
                    <a:pt x="5547740" y="1242678"/>
                    <a:pt x="5621045" y="1539420"/>
                  </a:cubicBezTo>
                  <a:cubicBezTo>
                    <a:pt x="5694350" y="1836162"/>
                    <a:pt x="5719738" y="2118309"/>
                    <a:pt x="5603673" y="2394322"/>
                  </a:cubicBezTo>
                  <a:cubicBezTo>
                    <a:pt x="5487608" y="2670335"/>
                    <a:pt x="5399401" y="3016453"/>
                    <a:pt x="4924653" y="3195496"/>
                  </a:cubicBezTo>
                  <a:cubicBezTo>
                    <a:pt x="4449905" y="3374539"/>
                    <a:pt x="3310048" y="3432360"/>
                    <a:pt x="2755182" y="3468581"/>
                  </a:cubicBezTo>
                  <a:cubicBezTo>
                    <a:pt x="2200316" y="3504802"/>
                    <a:pt x="1879811" y="3444420"/>
                    <a:pt x="1595455" y="3412825"/>
                  </a:cubicBezTo>
                  <a:cubicBezTo>
                    <a:pt x="1311099" y="3381230"/>
                    <a:pt x="1251626" y="3331049"/>
                    <a:pt x="1049045" y="3279010"/>
                  </a:cubicBezTo>
                  <a:cubicBezTo>
                    <a:pt x="846464" y="3226971"/>
                    <a:pt x="550957" y="3195375"/>
                    <a:pt x="379972" y="3100590"/>
                  </a:cubicBezTo>
                  <a:cubicBezTo>
                    <a:pt x="208987" y="3005805"/>
                    <a:pt x="69596" y="2873849"/>
                    <a:pt x="23133" y="2710298"/>
                  </a:cubicBezTo>
                  <a:close/>
                </a:path>
              </a:pathLst>
            </a:custGeom>
            <a:noFill/>
            <a:ln w="101600">
              <a:solidFill>
                <a:srgbClr val="D6838D"/>
              </a:solidFill>
            </a:ln>
            <a:effectLst>
              <a:innerShdw blurRad="127000" dir="4200000">
                <a:prstClr val="black"/>
              </a:innerShdw>
            </a:effectLst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400" dirty="0"/>
            </a:p>
          </p:txBody>
        </p:sp>
        <p:sp>
          <p:nvSpPr>
            <p:cNvPr id="903" name="Freeform 654">
              <a:extLst>
                <a:ext uri="{FF2B5EF4-FFF2-40B4-BE49-F238E27FC236}">
                  <a16:creationId xmlns:a16="http://schemas.microsoft.com/office/drawing/2014/main" id="{BFD87BC4-C85E-2615-D517-CFBA986BFE16}"/>
                </a:ext>
              </a:extLst>
            </p:cNvPr>
            <p:cNvSpPr/>
            <p:nvPr/>
          </p:nvSpPr>
          <p:spPr>
            <a:xfrm rot="20730920">
              <a:off x="5336880" y="4600255"/>
              <a:ext cx="148321" cy="215044"/>
            </a:xfrm>
            <a:custGeom>
              <a:avLst/>
              <a:gdLst/>
              <a:ahLst/>
              <a:cxnLst>
                <a:cxn ang="0">
                  <a:pos x="2045" y="3006"/>
                </a:cxn>
                <a:cxn ang="0">
                  <a:pos x="905" y="469"/>
                </a:cxn>
                <a:cxn ang="0">
                  <a:pos x="2045" y="3006"/>
                </a:cxn>
              </a:cxnLst>
              <a:rect l="0" t="0" r="0" b="0"/>
              <a:pathLst>
                <a:path w="71" h="74">
                  <a:moveTo>
                    <a:pt x="43" y="64"/>
                  </a:moveTo>
                  <a:cubicBezTo>
                    <a:pt x="13" y="74"/>
                    <a:pt x="0" y="17"/>
                    <a:pt x="19" y="10"/>
                  </a:cubicBezTo>
                  <a:cubicBezTo>
                    <a:pt x="43" y="0"/>
                    <a:pt x="71" y="54"/>
                    <a:pt x="43" y="64"/>
                  </a:cubicBezTo>
                  <a:close/>
                </a:path>
              </a:pathLst>
            </a:custGeom>
            <a:solidFill>
              <a:srgbClr val="FFFF00"/>
            </a:solidFill>
            <a:ln w="28575">
              <a:solidFill>
                <a:srgbClr val="FF0000"/>
              </a:solidFill>
            </a:ln>
          </p:spPr>
          <p:txBody>
            <a:bodyPr/>
            <a:lstStyle/>
            <a:p>
              <a:endParaRPr lang="zh-CN" altLang="en-US" sz="1400" dirty="0"/>
            </a:p>
          </p:txBody>
        </p:sp>
        <p:sp>
          <p:nvSpPr>
            <p:cNvPr id="906" name="Freeform 654">
              <a:extLst>
                <a:ext uri="{FF2B5EF4-FFF2-40B4-BE49-F238E27FC236}">
                  <a16:creationId xmlns:a16="http://schemas.microsoft.com/office/drawing/2014/main" id="{0744A969-9909-BFE1-1128-90EF15FB5EC3}"/>
                </a:ext>
              </a:extLst>
            </p:cNvPr>
            <p:cNvSpPr/>
            <p:nvPr/>
          </p:nvSpPr>
          <p:spPr>
            <a:xfrm rot="9629799">
              <a:off x="4996147" y="4318005"/>
              <a:ext cx="224131" cy="232853"/>
            </a:xfrm>
            <a:custGeom>
              <a:avLst/>
              <a:gdLst/>
              <a:ahLst/>
              <a:cxnLst>
                <a:cxn ang="0">
                  <a:pos x="2045" y="3006"/>
                </a:cxn>
                <a:cxn ang="0">
                  <a:pos x="905" y="469"/>
                </a:cxn>
                <a:cxn ang="0">
                  <a:pos x="2045" y="3006"/>
                </a:cxn>
              </a:cxnLst>
              <a:rect l="0" t="0" r="0" b="0"/>
              <a:pathLst>
                <a:path w="71" h="74">
                  <a:moveTo>
                    <a:pt x="43" y="64"/>
                  </a:moveTo>
                  <a:cubicBezTo>
                    <a:pt x="13" y="74"/>
                    <a:pt x="0" y="17"/>
                    <a:pt x="19" y="10"/>
                  </a:cubicBezTo>
                  <a:cubicBezTo>
                    <a:pt x="43" y="0"/>
                    <a:pt x="71" y="54"/>
                    <a:pt x="43" y="64"/>
                  </a:cubicBezTo>
                  <a:close/>
                </a:path>
              </a:pathLst>
            </a:custGeom>
            <a:gradFill flip="none" rotWithShape="1">
              <a:gsLst>
                <a:gs pos="0">
                  <a:schemeClr val="accent2">
                    <a:lumMod val="20000"/>
                    <a:lumOff val="80000"/>
                  </a:schemeClr>
                </a:gs>
                <a:gs pos="100000">
                  <a:srgbClr val="C00000"/>
                </a:gs>
              </a:gsLst>
              <a:path path="circle">
                <a:fillToRect l="50000" t="-80000" r="50000" b="180000"/>
              </a:path>
              <a:tileRect/>
            </a:gradFill>
            <a:ln w="28575">
              <a:solidFill>
                <a:srgbClr val="C00000"/>
              </a:solidFill>
            </a:ln>
          </p:spPr>
          <p:txBody>
            <a:bodyPr/>
            <a:lstStyle/>
            <a:p>
              <a:endParaRPr lang="zh-CN" altLang="en-US" sz="1400"/>
            </a:p>
          </p:txBody>
        </p:sp>
        <p:sp>
          <p:nvSpPr>
            <p:cNvPr id="907" name="任意多边形: 形状 906">
              <a:extLst>
                <a:ext uri="{FF2B5EF4-FFF2-40B4-BE49-F238E27FC236}">
                  <a16:creationId xmlns:a16="http://schemas.microsoft.com/office/drawing/2014/main" id="{3E1B47E6-0D45-F533-370E-1B3E9AD15AEC}"/>
                </a:ext>
              </a:extLst>
            </p:cNvPr>
            <p:cNvSpPr/>
            <p:nvPr/>
          </p:nvSpPr>
          <p:spPr>
            <a:xfrm rot="14942746">
              <a:off x="3523431" y="5157526"/>
              <a:ext cx="2793546" cy="1710412"/>
            </a:xfrm>
            <a:custGeom>
              <a:avLst/>
              <a:gdLst>
                <a:gd name="connsiteX0" fmla="*/ 21522 w 5713605"/>
                <a:gd name="connsiteY0" fmla="*/ 2598786 h 3469679"/>
                <a:gd name="connsiteX1" fmla="*/ 110732 w 5713605"/>
                <a:gd name="connsiteY1" fmla="*/ 2119283 h 3469679"/>
                <a:gd name="connsiteX2" fmla="*/ 645990 w 5713605"/>
                <a:gd name="connsiteY2" fmla="*/ 1617478 h 3469679"/>
                <a:gd name="connsiteX3" fmla="*/ 1482332 w 5713605"/>
                <a:gd name="connsiteY3" fmla="*/ 1171430 h 3469679"/>
                <a:gd name="connsiteX4" fmla="*/ 2285219 w 5713605"/>
                <a:gd name="connsiteY4" fmla="*/ 502356 h 3469679"/>
                <a:gd name="connsiteX5" fmla="*/ 2976595 w 5713605"/>
                <a:gd name="connsiteY5" fmla="*/ 145517 h 3469679"/>
                <a:gd name="connsiteX6" fmla="*/ 4091717 w 5713605"/>
                <a:gd name="connsiteY6" fmla="*/ 551 h 3469679"/>
                <a:gd name="connsiteX7" fmla="*/ 4783093 w 5713605"/>
                <a:gd name="connsiteY7" fmla="*/ 190122 h 3469679"/>
                <a:gd name="connsiteX8" fmla="*/ 5173385 w 5713605"/>
                <a:gd name="connsiteY8" fmla="*/ 613869 h 3469679"/>
                <a:gd name="connsiteX9" fmla="*/ 5630585 w 5713605"/>
                <a:gd name="connsiteY9" fmla="*/ 1539420 h 3469679"/>
                <a:gd name="connsiteX10" fmla="*/ 5697493 w 5713605"/>
                <a:gd name="connsiteY10" fmla="*/ 2375761 h 3469679"/>
                <a:gd name="connsiteX11" fmla="*/ 5441014 w 5713605"/>
                <a:gd name="connsiteY11" fmla="*/ 3044834 h 3469679"/>
                <a:gd name="connsiteX12" fmla="*/ 4838849 w 5713605"/>
                <a:gd name="connsiteY12" fmla="*/ 3368220 h 3469679"/>
                <a:gd name="connsiteX13" fmla="*/ 2764722 w 5713605"/>
                <a:gd name="connsiteY13" fmla="*/ 3468581 h 3469679"/>
                <a:gd name="connsiteX14" fmla="*/ 1604995 w 5713605"/>
                <a:gd name="connsiteY14" fmla="*/ 3412825 h 3469679"/>
                <a:gd name="connsiteX15" fmla="*/ 1058585 w 5713605"/>
                <a:gd name="connsiteY15" fmla="*/ 3279010 h 3469679"/>
                <a:gd name="connsiteX16" fmla="*/ 389512 w 5713605"/>
                <a:gd name="connsiteY16" fmla="*/ 3100590 h 3469679"/>
                <a:gd name="connsiteX17" fmla="*/ 32673 w 5713605"/>
                <a:gd name="connsiteY17" fmla="*/ 2710298 h 3469679"/>
                <a:gd name="connsiteX18" fmla="*/ 21522 w 5713605"/>
                <a:gd name="connsiteY18" fmla="*/ 2598786 h 3469679"/>
                <a:gd name="connsiteX0" fmla="*/ 23133 w 5704065"/>
                <a:gd name="connsiteY0" fmla="*/ 2710298 h 3469679"/>
                <a:gd name="connsiteX1" fmla="*/ 101192 w 5704065"/>
                <a:gd name="connsiteY1" fmla="*/ 2119283 h 3469679"/>
                <a:gd name="connsiteX2" fmla="*/ 636450 w 5704065"/>
                <a:gd name="connsiteY2" fmla="*/ 1617478 h 3469679"/>
                <a:gd name="connsiteX3" fmla="*/ 1472792 w 5704065"/>
                <a:gd name="connsiteY3" fmla="*/ 1171430 h 3469679"/>
                <a:gd name="connsiteX4" fmla="*/ 2275679 w 5704065"/>
                <a:gd name="connsiteY4" fmla="*/ 502356 h 3469679"/>
                <a:gd name="connsiteX5" fmla="*/ 2967055 w 5704065"/>
                <a:gd name="connsiteY5" fmla="*/ 145517 h 3469679"/>
                <a:gd name="connsiteX6" fmla="*/ 4082177 w 5704065"/>
                <a:gd name="connsiteY6" fmla="*/ 551 h 3469679"/>
                <a:gd name="connsiteX7" fmla="*/ 4773553 w 5704065"/>
                <a:gd name="connsiteY7" fmla="*/ 190122 h 3469679"/>
                <a:gd name="connsiteX8" fmla="*/ 5163845 w 5704065"/>
                <a:gd name="connsiteY8" fmla="*/ 613869 h 3469679"/>
                <a:gd name="connsiteX9" fmla="*/ 5621045 w 5704065"/>
                <a:gd name="connsiteY9" fmla="*/ 1539420 h 3469679"/>
                <a:gd name="connsiteX10" fmla="*/ 5687953 w 5704065"/>
                <a:gd name="connsiteY10" fmla="*/ 2375761 h 3469679"/>
                <a:gd name="connsiteX11" fmla="*/ 5431474 w 5704065"/>
                <a:gd name="connsiteY11" fmla="*/ 3044834 h 3469679"/>
                <a:gd name="connsiteX12" fmla="*/ 4829309 w 5704065"/>
                <a:gd name="connsiteY12" fmla="*/ 3368220 h 3469679"/>
                <a:gd name="connsiteX13" fmla="*/ 2755182 w 5704065"/>
                <a:gd name="connsiteY13" fmla="*/ 3468581 h 3469679"/>
                <a:gd name="connsiteX14" fmla="*/ 1595455 w 5704065"/>
                <a:gd name="connsiteY14" fmla="*/ 3412825 h 3469679"/>
                <a:gd name="connsiteX15" fmla="*/ 1049045 w 5704065"/>
                <a:gd name="connsiteY15" fmla="*/ 3279010 h 3469679"/>
                <a:gd name="connsiteX16" fmla="*/ 379972 w 5704065"/>
                <a:gd name="connsiteY16" fmla="*/ 3100590 h 3469679"/>
                <a:gd name="connsiteX17" fmla="*/ 23133 w 5704065"/>
                <a:gd name="connsiteY17" fmla="*/ 2710298 h 3469679"/>
                <a:gd name="connsiteX0" fmla="*/ 23133 w 5704065"/>
                <a:gd name="connsiteY0" fmla="*/ 2710298 h 3476747"/>
                <a:gd name="connsiteX1" fmla="*/ 101192 w 5704065"/>
                <a:gd name="connsiteY1" fmla="*/ 2119283 h 3476747"/>
                <a:gd name="connsiteX2" fmla="*/ 636450 w 5704065"/>
                <a:gd name="connsiteY2" fmla="*/ 1617478 h 3476747"/>
                <a:gd name="connsiteX3" fmla="*/ 1472792 w 5704065"/>
                <a:gd name="connsiteY3" fmla="*/ 1171430 h 3476747"/>
                <a:gd name="connsiteX4" fmla="*/ 2275679 w 5704065"/>
                <a:gd name="connsiteY4" fmla="*/ 502356 h 3476747"/>
                <a:gd name="connsiteX5" fmla="*/ 2967055 w 5704065"/>
                <a:gd name="connsiteY5" fmla="*/ 145517 h 3476747"/>
                <a:gd name="connsiteX6" fmla="*/ 4082177 w 5704065"/>
                <a:gd name="connsiteY6" fmla="*/ 551 h 3476747"/>
                <a:gd name="connsiteX7" fmla="*/ 4773553 w 5704065"/>
                <a:gd name="connsiteY7" fmla="*/ 190122 h 3476747"/>
                <a:gd name="connsiteX8" fmla="*/ 5163845 w 5704065"/>
                <a:gd name="connsiteY8" fmla="*/ 613869 h 3476747"/>
                <a:gd name="connsiteX9" fmla="*/ 5621045 w 5704065"/>
                <a:gd name="connsiteY9" fmla="*/ 1539420 h 3476747"/>
                <a:gd name="connsiteX10" fmla="*/ 5687953 w 5704065"/>
                <a:gd name="connsiteY10" fmla="*/ 2375761 h 3476747"/>
                <a:gd name="connsiteX11" fmla="*/ 5431474 w 5704065"/>
                <a:gd name="connsiteY11" fmla="*/ 3044834 h 3476747"/>
                <a:gd name="connsiteX12" fmla="*/ 4963245 w 5704065"/>
                <a:gd name="connsiteY12" fmla="*/ 3242017 h 3476747"/>
                <a:gd name="connsiteX13" fmla="*/ 2755182 w 5704065"/>
                <a:gd name="connsiteY13" fmla="*/ 3468581 h 3476747"/>
                <a:gd name="connsiteX14" fmla="*/ 1595455 w 5704065"/>
                <a:gd name="connsiteY14" fmla="*/ 3412825 h 3476747"/>
                <a:gd name="connsiteX15" fmla="*/ 1049045 w 5704065"/>
                <a:gd name="connsiteY15" fmla="*/ 3279010 h 3476747"/>
                <a:gd name="connsiteX16" fmla="*/ 379972 w 5704065"/>
                <a:gd name="connsiteY16" fmla="*/ 3100590 h 3476747"/>
                <a:gd name="connsiteX17" fmla="*/ 23133 w 5704065"/>
                <a:gd name="connsiteY17" fmla="*/ 2710298 h 3476747"/>
                <a:gd name="connsiteX0" fmla="*/ 23133 w 5711265"/>
                <a:gd name="connsiteY0" fmla="*/ 2710298 h 3476747"/>
                <a:gd name="connsiteX1" fmla="*/ 101192 w 5711265"/>
                <a:gd name="connsiteY1" fmla="*/ 2119283 h 3476747"/>
                <a:gd name="connsiteX2" fmla="*/ 636450 w 5711265"/>
                <a:gd name="connsiteY2" fmla="*/ 1617478 h 3476747"/>
                <a:gd name="connsiteX3" fmla="*/ 1472792 w 5711265"/>
                <a:gd name="connsiteY3" fmla="*/ 1171430 h 3476747"/>
                <a:gd name="connsiteX4" fmla="*/ 2275679 w 5711265"/>
                <a:gd name="connsiteY4" fmla="*/ 502356 h 3476747"/>
                <a:gd name="connsiteX5" fmla="*/ 2967055 w 5711265"/>
                <a:gd name="connsiteY5" fmla="*/ 145517 h 3476747"/>
                <a:gd name="connsiteX6" fmla="*/ 4082177 w 5711265"/>
                <a:gd name="connsiteY6" fmla="*/ 551 h 3476747"/>
                <a:gd name="connsiteX7" fmla="*/ 4773553 w 5711265"/>
                <a:gd name="connsiteY7" fmla="*/ 190122 h 3476747"/>
                <a:gd name="connsiteX8" fmla="*/ 5163845 w 5711265"/>
                <a:gd name="connsiteY8" fmla="*/ 613869 h 3476747"/>
                <a:gd name="connsiteX9" fmla="*/ 5621045 w 5711265"/>
                <a:gd name="connsiteY9" fmla="*/ 1539420 h 3476747"/>
                <a:gd name="connsiteX10" fmla="*/ 5687953 w 5711265"/>
                <a:gd name="connsiteY10" fmla="*/ 2375761 h 3476747"/>
                <a:gd name="connsiteX11" fmla="*/ 5334265 w 5711265"/>
                <a:gd name="connsiteY11" fmla="*/ 2989546 h 3476747"/>
                <a:gd name="connsiteX12" fmla="*/ 4963245 w 5711265"/>
                <a:gd name="connsiteY12" fmla="*/ 3242017 h 3476747"/>
                <a:gd name="connsiteX13" fmla="*/ 2755182 w 5711265"/>
                <a:gd name="connsiteY13" fmla="*/ 3468581 h 3476747"/>
                <a:gd name="connsiteX14" fmla="*/ 1595455 w 5711265"/>
                <a:gd name="connsiteY14" fmla="*/ 3412825 h 3476747"/>
                <a:gd name="connsiteX15" fmla="*/ 1049045 w 5711265"/>
                <a:gd name="connsiteY15" fmla="*/ 3279010 h 3476747"/>
                <a:gd name="connsiteX16" fmla="*/ 379972 w 5711265"/>
                <a:gd name="connsiteY16" fmla="*/ 3100590 h 3476747"/>
                <a:gd name="connsiteX17" fmla="*/ 23133 w 5711265"/>
                <a:gd name="connsiteY17" fmla="*/ 2710298 h 3476747"/>
                <a:gd name="connsiteX0" fmla="*/ 23133 w 5660398"/>
                <a:gd name="connsiteY0" fmla="*/ 2710298 h 3476747"/>
                <a:gd name="connsiteX1" fmla="*/ 101192 w 5660398"/>
                <a:gd name="connsiteY1" fmla="*/ 2119283 h 3476747"/>
                <a:gd name="connsiteX2" fmla="*/ 636450 w 5660398"/>
                <a:gd name="connsiteY2" fmla="*/ 1617478 h 3476747"/>
                <a:gd name="connsiteX3" fmla="*/ 1472792 w 5660398"/>
                <a:gd name="connsiteY3" fmla="*/ 1171430 h 3476747"/>
                <a:gd name="connsiteX4" fmla="*/ 2275679 w 5660398"/>
                <a:gd name="connsiteY4" fmla="*/ 502356 h 3476747"/>
                <a:gd name="connsiteX5" fmla="*/ 2967055 w 5660398"/>
                <a:gd name="connsiteY5" fmla="*/ 145517 h 3476747"/>
                <a:gd name="connsiteX6" fmla="*/ 4082177 w 5660398"/>
                <a:gd name="connsiteY6" fmla="*/ 551 h 3476747"/>
                <a:gd name="connsiteX7" fmla="*/ 4773553 w 5660398"/>
                <a:gd name="connsiteY7" fmla="*/ 190122 h 3476747"/>
                <a:gd name="connsiteX8" fmla="*/ 5163845 w 5660398"/>
                <a:gd name="connsiteY8" fmla="*/ 613869 h 3476747"/>
                <a:gd name="connsiteX9" fmla="*/ 5621045 w 5660398"/>
                <a:gd name="connsiteY9" fmla="*/ 1539420 h 3476747"/>
                <a:gd name="connsiteX10" fmla="*/ 5603673 w 5660398"/>
                <a:gd name="connsiteY10" fmla="*/ 2394322 h 3476747"/>
                <a:gd name="connsiteX11" fmla="*/ 5334265 w 5660398"/>
                <a:gd name="connsiteY11" fmla="*/ 2989546 h 3476747"/>
                <a:gd name="connsiteX12" fmla="*/ 4963245 w 5660398"/>
                <a:gd name="connsiteY12" fmla="*/ 3242017 h 3476747"/>
                <a:gd name="connsiteX13" fmla="*/ 2755182 w 5660398"/>
                <a:gd name="connsiteY13" fmla="*/ 3468581 h 3476747"/>
                <a:gd name="connsiteX14" fmla="*/ 1595455 w 5660398"/>
                <a:gd name="connsiteY14" fmla="*/ 3412825 h 3476747"/>
                <a:gd name="connsiteX15" fmla="*/ 1049045 w 5660398"/>
                <a:gd name="connsiteY15" fmla="*/ 3279010 h 3476747"/>
                <a:gd name="connsiteX16" fmla="*/ 379972 w 5660398"/>
                <a:gd name="connsiteY16" fmla="*/ 3100590 h 3476747"/>
                <a:gd name="connsiteX17" fmla="*/ 23133 w 5660398"/>
                <a:gd name="connsiteY17" fmla="*/ 2710298 h 3476747"/>
                <a:gd name="connsiteX0" fmla="*/ 23133 w 5660398"/>
                <a:gd name="connsiteY0" fmla="*/ 2710298 h 3479795"/>
                <a:gd name="connsiteX1" fmla="*/ 101192 w 5660398"/>
                <a:gd name="connsiteY1" fmla="*/ 2119283 h 3479795"/>
                <a:gd name="connsiteX2" fmla="*/ 636450 w 5660398"/>
                <a:gd name="connsiteY2" fmla="*/ 1617478 h 3479795"/>
                <a:gd name="connsiteX3" fmla="*/ 1472792 w 5660398"/>
                <a:gd name="connsiteY3" fmla="*/ 1171430 h 3479795"/>
                <a:gd name="connsiteX4" fmla="*/ 2275679 w 5660398"/>
                <a:gd name="connsiteY4" fmla="*/ 502356 h 3479795"/>
                <a:gd name="connsiteX5" fmla="*/ 2967055 w 5660398"/>
                <a:gd name="connsiteY5" fmla="*/ 145517 h 3479795"/>
                <a:gd name="connsiteX6" fmla="*/ 4082177 w 5660398"/>
                <a:gd name="connsiteY6" fmla="*/ 551 h 3479795"/>
                <a:gd name="connsiteX7" fmla="*/ 4773553 w 5660398"/>
                <a:gd name="connsiteY7" fmla="*/ 190122 h 3479795"/>
                <a:gd name="connsiteX8" fmla="*/ 5163845 w 5660398"/>
                <a:gd name="connsiteY8" fmla="*/ 613869 h 3479795"/>
                <a:gd name="connsiteX9" fmla="*/ 5621045 w 5660398"/>
                <a:gd name="connsiteY9" fmla="*/ 1539420 h 3479795"/>
                <a:gd name="connsiteX10" fmla="*/ 5603673 w 5660398"/>
                <a:gd name="connsiteY10" fmla="*/ 2394322 h 3479795"/>
                <a:gd name="connsiteX11" fmla="*/ 5334265 w 5660398"/>
                <a:gd name="connsiteY11" fmla="*/ 2989546 h 3479795"/>
                <a:gd name="connsiteX12" fmla="*/ 4924653 w 5660398"/>
                <a:gd name="connsiteY12" fmla="*/ 3195496 h 3479795"/>
                <a:gd name="connsiteX13" fmla="*/ 2755182 w 5660398"/>
                <a:gd name="connsiteY13" fmla="*/ 3468581 h 3479795"/>
                <a:gd name="connsiteX14" fmla="*/ 1595455 w 5660398"/>
                <a:gd name="connsiteY14" fmla="*/ 3412825 h 3479795"/>
                <a:gd name="connsiteX15" fmla="*/ 1049045 w 5660398"/>
                <a:gd name="connsiteY15" fmla="*/ 3279010 h 3479795"/>
                <a:gd name="connsiteX16" fmla="*/ 379972 w 5660398"/>
                <a:gd name="connsiteY16" fmla="*/ 3100590 h 3479795"/>
                <a:gd name="connsiteX17" fmla="*/ 23133 w 5660398"/>
                <a:gd name="connsiteY17" fmla="*/ 2710298 h 3479795"/>
                <a:gd name="connsiteX0" fmla="*/ 23133 w 5660958"/>
                <a:gd name="connsiteY0" fmla="*/ 2710298 h 3479795"/>
                <a:gd name="connsiteX1" fmla="*/ 101192 w 5660958"/>
                <a:gd name="connsiteY1" fmla="*/ 2119283 h 3479795"/>
                <a:gd name="connsiteX2" fmla="*/ 636450 w 5660958"/>
                <a:gd name="connsiteY2" fmla="*/ 1617478 h 3479795"/>
                <a:gd name="connsiteX3" fmla="*/ 1472792 w 5660958"/>
                <a:gd name="connsiteY3" fmla="*/ 1171430 h 3479795"/>
                <a:gd name="connsiteX4" fmla="*/ 2275679 w 5660958"/>
                <a:gd name="connsiteY4" fmla="*/ 502356 h 3479795"/>
                <a:gd name="connsiteX5" fmla="*/ 2967055 w 5660958"/>
                <a:gd name="connsiteY5" fmla="*/ 145517 h 3479795"/>
                <a:gd name="connsiteX6" fmla="*/ 4082177 w 5660958"/>
                <a:gd name="connsiteY6" fmla="*/ 551 h 3479795"/>
                <a:gd name="connsiteX7" fmla="*/ 4773553 w 5660958"/>
                <a:gd name="connsiteY7" fmla="*/ 190122 h 3479795"/>
                <a:gd name="connsiteX8" fmla="*/ 5163845 w 5660958"/>
                <a:gd name="connsiteY8" fmla="*/ 613869 h 3479795"/>
                <a:gd name="connsiteX9" fmla="*/ 5621045 w 5660958"/>
                <a:gd name="connsiteY9" fmla="*/ 1539420 h 3479795"/>
                <a:gd name="connsiteX10" fmla="*/ 5603673 w 5660958"/>
                <a:gd name="connsiteY10" fmla="*/ 2394322 h 3479795"/>
                <a:gd name="connsiteX11" fmla="*/ 5322169 w 5660958"/>
                <a:gd name="connsiteY11" fmla="*/ 2942191 h 3479795"/>
                <a:gd name="connsiteX12" fmla="*/ 4924653 w 5660958"/>
                <a:gd name="connsiteY12" fmla="*/ 3195496 h 3479795"/>
                <a:gd name="connsiteX13" fmla="*/ 2755182 w 5660958"/>
                <a:gd name="connsiteY13" fmla="*/ 3468581 h 3479795"/>
                <a:gd name="connsiteX14" fmla="*/ 1595455 w 5660958"/>
                <a:gd name="connsiteY14" fmla="*/ 3412825 h 3479795"/>
                <a:gd name="connsiteX15" fmla="*/ 1049045 w 5660958"/>
                <a:gd name="connsiteY15" fmla="*/ 3279010 h 3479795"/>
                <a:gd name="connsiteX16" fmla="*/ 379972 w 5660958"/>
                <a:gd name="connsiteY16" fmla="*/ 3100590 h 3479795"/>
                <a:gd name="connsiteX17" fmla="*/ 23133 w 5660958"/>
                <a:gd name="connsiteY17" fmla="*/ 2710298 h 3479795"/>
                <a:gd name="connsiteX0" fmla="*/ 23133 w 5683403"/>
                <a:gd name="connsiteY0" fmla="*/ 2710298 h 3479795"/>
                <a:gd name="connsiteX1" fmla="*/ 101192 w 5683403"/>
                <a:gd name="connsiteY1" fmla="*/ 2119283 h 3479795"/>
                <a:gd name="connsiteX2" fmla="*/ 636450 w 5683403"/>
                <a:gd name="connsiteY2" fmla="*/ 1617478 h 3479795"/>
                <a:gd name="connsiteX3" fmla="*/ 1472792 w 5683403"/>
                <a:gd name="connsiteY3" fmla="*/ 1171430 h 3479795"/>
                <a:gd name="connsiteX4" fmla="*/ 2275679 w 5683403"/>
                <a:gd name="connsiteY4" fmla="*/ 502356 h 3479795"/>
                <a:gd name="connsiteX5" fmla="*/ 2967055 w 5683403"/>
                <a:gd name="connsiteY5" fmla="*/ 145517 h 3479795"/>
                <a:gd name="connsiteX6" fmla="*/ 4082177 w 5683403"/>
                <a:gd name="connsiteY6" fmla="*/ 551 h 3479795"/>
                <a:gd name="connsiteX7" fmla="*/ 4773553 w 5683403"/>
                <a:gd name="connsiteY7" fmla="*/ 190122 h 3479795"/>
                <a:gd name="connsiteX8" fmla="*/ 5163845 w 5683403"/>
                <a:gd name="connsiteY8" fmla="*/ 613869 h 3479795"/>
                <a:gd name="connsiteX9" fmla="*/ 5621045 w 5683403"/>
                <a:gd name="connsiteY9" fmla="*/ 1539420 h 3479795"/>
                <a:gd name="connsiteX10" fmla="*/ 5603673 w 5683403"/>
                <a:gd name="connsiteY10" fmla="*/ 2394322 h 3479795"/>
                <a:gd name="connsiteX11" fmla="*/ 4924653 w 5683403"/>
                <a:gd name="connsiteY11" fmla="*/ 3195496 h 3479795"/>
                <a:gd name="connsiteX12" fmla="*/ 2755182 w 5683403"/>
                <a:gd name="connsiteY12" fmla="*/ 3468581 h 3479795"/>
                <a:gd name="connsiteX13" fmla="*/ 1595455 w 5683403"/>
                <a:gd name="connsiteY13" fmla="*/ 3412825 h 3479795"/>
                <a:gd name="connsiteX14" fmla="*/ 1049045 w 5683403"/>
                <a:gd name="connsiteY14" fmla="*/ 3279010 h 3479795"/>
                <a:gd name="connsiteX15" fmla="*/ 379972 w 5683403"/>
                <a:gd name="connsiteY15" fmla="*/ 3100590 h 3479795"/>
                <a:gd name="connsiteX16" fmla="*/ 23133 w 5683403"/>
                <a:gd name="connsiteY16" fmla="*/ 2710298 h 347979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</a:cxnLst>
              <a:rect l="l" t="t" r="r" b="b"/>
              <a:pathLst>
                <a:path w="5683403" h="3479795">
                  <a:moveTo>
                    <a:pt x="23133" y="2710298"/>
                  </a:moveTo>
                  <a:cubicBezTo>
                    <a:pt x="-23330" y="2546747"/>
                    <a:pt x="-1027" y="2301420"/>
                    <a:pt x="101192" y="2119283"/>
                  </a:cubicBezTo>
                  <a:cubicBezTo>
                    <a:pt x="203412" y="1937146"/>
                    <a:pt x="407850" y="1775453"/>
                    <a:pt x="636450" y="1617478"/>
                  </a:cubicBezTo>
                  <a:cubicBezTo>
                    <a:pt x="865050" y="1459503"/>
                    <a:pt x="1199587" y="1357284"/>
                    <a:pt x="1472792" y="1171430"/>
                  </a:cubicBezTo>
                  <a:cubicBezTo>
                    <a:pt x="1745997" y="985576"/>
                    <a:pt x="2026635" y="673341"/>
                    <a:pt x="2275679" y="502356"/>
                  </a:cubicBezTo>
                  <a:cubicBezTo>
                    <a:pt x="2524723" y="331371"/>
                    <a:pt x="2665972" y="229151"/>
                    <a:pt x="2967055" y="145517"/>
                  </a:cubicBezTo>
                  <a:cubicBezTo>
                    <a:pt x="3268138" y="61883"/>
                    <a:pt x="3781094" y="-6883"/>
                    <a:pt x="4082177" y="551"/>
                  </a:cubicBezTo>
                  <a:cubicBezTo>
                    <a:pt x="4383260" y="7985"/>
                    <a:pt x="4593275" y="87902"/>
                    <a:pt x="4773553" y="190122"/>
                  </a:cubicBezTo>
                  <a:cubicBezTo>
                    <a:pt x="4953831" y="292342"/>
                    <a:pt x="5022596" y="388986"/>
                    <a:pt x="5163845" y="613869"/>
                  </a:cubicBezTo>
                  <a:cubicBezTo>
                    <a:pt x="5305094" y="838752"/>
                    <a:pt x="5547740" y="1242678"/>
                    <a:pt x="5621045" y="1539420"/>
                  </a:cubicBezTo>
                  <a:cubicBezTo>
                    <a:pt x="5694350" y="1836162"/>
                    <a:pt x="5719738" y="2118309"/>
                    <a:pt x="5603673" y="2394322"/>
                  </a:cubicBezTo>
                  <a:cubicBezTo>
                    <a:pt x="5487608" y="2670335"/>
                    <a:pt x="5399401" y="3016453"/>
                    <a:pt x="4924653" y="3195496"/>
                  </a:cubicBezTo>
                  <a:cubicBezTo>
                    <a:pt x="4449905" y="3374539"/>
                    <a:pt x="3310048" y="3432360"/>
                    <a:pt x="2755182" y="3468581"/>
                  </a:cubicBezTo>
                  <a:cubicBezTo>
                    <a:pt x="2200316" y="3504802"/>
                    <a:pt x="1879811" y="3444420"/>
                    <a:pt x="1595455" y="3412825"/>
                  </a:cubicBezTo>
                  <a:cubicBezTo>
                    <a:pt x="1311099" y="3381230"/>
                    <a:pt x="1251626" y="3331049"/>
                    <a:pt x="1049045" y="3279010"/>
                  </a:cubicBezTo>
                  <a:cubicBezTo>
                    <a:pt x="846464" y="3226971"/>
                    <a:pt x="550957" y="3195375"/>
                    <a:pt x="379972" y="3100590"/>
                  </a:cubicBezTo>
                  <a:cubicBezTo>
                    <a:pt x="208987" y="3005805"/>
                    <a:pt x="69596" y="2873849"/>
                    <a:pt x="23133" y="2710298"/>
                  </a:cubicBezTo>
                  <a:close/>
                </a:path>
              </a:pathLst>
            </a:custGeom>
            <a:solidFill>
              <a:srgbClr val="EBF8FB"/>
            </a:solidFill>
            <a:ln w="28575"/>
            <a:effectLst>
              <a:innerShdw blurRad="127000" dir="4200000">
                <a:prstClr val="black"/>
              </a:innerShdw>
            </a:effectLst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400" dirty="0"/>
            </a:p>
          </p:txBody>
        </p:sp>
        <p:sp>
          <p:nvSpPr>
            <p:cNvPr id="908" name="任意多边形: 形状 907">
              <a:extLst>
                <a:ext uri="{FF2B5EF4-FFF2-40B4-BE49-F238E27FC236}">
                  <a16:creationId xmlns:a16="http://schemas.microsoft.com/office/drawing/2014/main" id="{D70A36A3-8876-793B-F943-D7BCB998FEF8}"/>
                </a:ext>
              </a:extLst>
            </p:cNvPr>
            <p:cNvSpPr/>
            <p:nvPr/>
          </p:nvSpPr>
          <p:spPr>
            <a:xfrm rot="14942746">
              <a:off x="3775066" y="5309303"/>
              <a:ext cx="2240436" cy="1399777"/>
            </a:xfrm>
            <a:custGeom>
              <a:avLst/>
              <a:gdLst>
                <a:gd name="connsiteX0" fmla="*/ 15187 w 4553734"/>
                <a:gd name="connsiteY0" fmla="*/ 2524145 h 2527001"/>
                <a:gd name="connsiteX1" fmla="*/ 416631 w 4553734"/>
                <a:gd name="connsiteY1" fmla="*/ 2423784 h 2527001"/>
                <a:gd name="connsiteX2" fmla="*/ 918436 w 4553734"/>
                <a:gd name="connsiteY2" fmla="*/ 2100399 h 2527001"/>
                <a:gd name="connsiteX3" fmla="*/ 1208368 w 4553734"/>
                <a:gd name="connsiteY3" fmla="*/ 1542838 h 2527001"/>
                <a:gd name="connsiteX4" fmla="*/ 1174914 w 4553734"/>
                <a:gd name="connsiteY4" fmla="*/ 1096789 h 2527001"/>
                <a:gd name="connsiteX5" fmla="*/ 1464846 w 4553734"/>
                <a:gd name="connsiteY5" fmla="*/ 1275209 h 2527001"/>
                <a:gd name="connsiteX6" fmla="*/ 2133919 w 4553734"/>
                <a:gd name="connsiteY6" fmla="*/ 1252906 h 2527001"/>
                <a:gd name="connsiteX7" fmla="*/ 2747236 w 4553734"/>
                <a:gd name="connsiteY7" fmla="*/ 907218 h 2527001"/>
                <a:gd name="connsiteX8" fmla="*/ 3003714 w 4553734"/>
                <a:gd name="connsiteY8" fmla="*/ 349657 h 2527001"/>
                <a:gd name="connsiteX9" fmla="*/ 3037168 w 4553734"/>
                <a:gd name="connsiteY9" fmla="*/ 3969 h 2527001"/>
                <a:gd name="connsiteX10" fmla="*/ 3048319 w 4553734"/>
                <a:gd name="connsiteY10" fmla="*/ 572682 h 2527001"/>
                <a:gd name="connsiteX11" fmla="*/ 3215587 w 4553734"/>
                <a:gd name="connsiteY11" fmla="*/ 1107940 h 2527001"/>
                <a:gd name="connsiteX12" fmla="*/ 3784299 w 4553734"/>
                <a:gd name="connsiteY12" fmla="*/ 1821618 h 2527001"/>
                <a:gd name="connsiteX13" fmla="*/ 4553734 w 4553734"/>
                <a:gd name="connsiteY13" fmla="*/ 2011189 h 2527001"/>
                <a:gd name="connsiteX14" fmla="*/ 4196895 w 4553734"/>
                <a:gd name="connsiteY14" fmla="*/ 2000038 h 2527001"/>
                <a:gd name="connsiteX15" fmla="*/ 3327099 w 4553734"/>
                <a:gd name="connsiteY15" fmla="*/ 2111550 h 2527001"/>
                <a:gd name="connsiteX16" fmla="*/ 2747236 w 4553734"/>
                <a:gd name="connsiteY16" fmla="*/ 2323423 h 2527001"/>
                <a:gd name="connsiteX17" fmla="*/ 2401548 w 4553734"/>
                <a:gd name="connsiteY17" fmla="*/ 2390330 h 2527001"/>
                <a:gd name="connsiteX18" fmla="*/ 1576358 w 4553734"/>
                <a:gd name="connsiteY18" fmla="*/ 2401482 h 2527001"/>
                <a:gd name="connsiteX19" fmla="*/ 963041 w 4553734"/>
                <a:gd name="connsiteY19" fmla="*/ 2334574 h 2527001"/>
                <a:gd name="connsiteX20" fmla="*/ 15187 w 4553734"/>
                <a:gd name="connsiteY20" fmla="*/ 2524145 h 2527001"/>
                <a:gd name="connsiteX0" fmla="*/ 13708 w 4552255"/>
                <a:gd name="connsiteY0" fmla="*/ 2524145 h 2524306"/>
                <a:gd name="connsiteX1" fmla="*/ 415152 w 4552255"/>
                <a:gd name="connsiteY1" fmla="*/ 2423784 h 2524306"/>
                <a:gd name="connsiteX2" fmla="*/ 916957 w 4552255"/>
                <a:gd name="connsiteY2" fmla="*/ 2100399 h 2524306"/>
                <a:gd name="connsiteX3" fmla="*/ 1206889 w 4552255"/>
                <a:gd name="connsiteY3" fmla="*/ 1542838 h 2524306"/>
                <a:gd name="connsiteX4" fmla="*/ 1173435 w 4552255"/>
                <a:gd name="connsiteY4" fmla="*/ 1096789 h 2524306"/>
                <a:gd name="connsiteX5" fmla="*/ 1463367 w 4552255"/>
                <a:gd name="connsiteY5" fmla="*/ 1275209 h 2524306"/>
                <a:gd name="connsiteX6" fmla="*/ 2132440 w 4552255"/>
                <a:gd name="connsiteY6" fmla="*/ 1252906 h 2524306"/>
                <a:gd name="connsiteX7" fmla="*/ 2745757 w 4552255"/>
                <a:gd name="connsiteY7" fmla="*/ 907218 h 2524306"/>
                <a:gd name="connsiteX8" fmla="*/ 3002235 w 4552255"/>
                <a:gd name="connsiteY8" fmla="*/ 349657 h 2524306"/>
                <a:gd name="connsiteX9" fmla="*/ 3035689 w 4552255"/>
                <a:gd name="connsiteY9" fmla="*/ 3969 h 2524306"/>
                <a:gd name="connsiteX10" fmla="*/ 3046840 w 4552255"/>
                <a:gd name="connsiteY10" fmla="*/ 572682 h 2524306"/>
                <a:gd name="connsiteX11" fmla="*/ 3214108 w 4552255"/>
                <a:gd name="connsiteY11" fmla="*/ 1107940 h 2524306"/>
                <a:gd name="connsiteX12" fmla="*/ 3782820 w 4552255"/>
                <a:gd name="connsiteY12" fmla="*/ 1821618 h 2524306"/>
                <a:gd name="connsiteX13" fmla="*/ 4552255 w 4552255"/>
                <a:gd name="connsiteY13" fmla="*/ 2011189 h 2524306"/>
                <a:gd name="connsiteX14" fmla="*/ 4195416 w 4552255"/>
                <a:gd name="connsiteY14" fmla="*/ 2000038 h 2524306"/>
                <a:gd name="connsiteX15" fmla="*/ 3325620 w 4552255"/>
                <a:gd name="connsiteY15" fmla="*/ 2111550 h 2524306"/>
                <a:gd name="connsiteX16" fmla="*/ 2745757 w 4552255"/>
                <a:gd name="connsiteY16" fmla="*/ 2323423 h 2524306"/>
                <a:gd name="connsiteX17" fmla="*/ 2400069 w 4552255"/>
                <a:gd name="connsiteY17" fmla="*/ 2390330 h 2524306"/>
                <a:gd name="connsiteX18" fmla="*/ 1574879 w 4552255"/>
                <a:gd name="connsiteY18" fmla="*/ 2401482 h 2524306"/>
                <a:gd name="connsiteX19" fmla="*/ 928108 w 4552255"/>
                <a:gd name="connsiteY19" fmla="*/ 2446086 h 2524306"/>
                <a:gd name="connsiteX20" fmla="*/ 13708 w 4552255"/>
                <a:gd name="connsiteY20" fmla="*/ 2524145 h 2524306"/>
                <a:gd name="connsiteX0" fmla="*/ 13708 w 4552255"/>
                <a:gd name="connsiteY0" fmla="*/ 2524145 h 2524273"/>
                <a:gd name="connsiteX1" fmla="*/ 415152 w 4552255"/>
                <a:gd name="connsiteY1" fmla="*/ 2423784 h 2524273"/>
                <a:gd name="connsiteX2" fmla="*/ 916957 w 4552255"/>
                <a:gd name="connsiteY2" fmla="*/ 2100399 h 2524273"/>
                <a:gd name="connsiteX3" fmla="*/ 1206889 w 4552255"/>
                <a:gd name="connsiteY3" fmla="*/ 1542838 h 2524273"/>
                <a:gd name="connsiteX4" fmla="*/ 1173435 w 4552255"/>
                <a:gd name="connsiteY4" fmla="*/ 1096789 h 2524273"/>
                <a:gd name="connsiteX5" fmla="*/ 1463367 w 4552255"/>
                <a:gd name="connsiteY5" fmla="*/ 1275209 h 2524273"/>
                <a:gd name="connsiteX6" fmla="*/ 2132440 w 4552255"/>
                <a:gd name="connsiteY6" fmla="*/ 1252906 h 2524273"/>
                <a:gd name="connsiteX7" fmla="*/ 2745757 w 4552255"/>
                <a:gd name="connsiteY7" fmla="*/ 907218 h 2524273"/>
                <a:gd name="connsiteX8" fmla="*/ 3002235 w 4552255"/>
                <a:gd name="connsiteY8" fmla="*/ 349657 h 2524273"/>
                <a:gd name="connsiteX9" fmla="*/ 3035689 w 4552255"/>
                <a:gd name="connsiteY9" fmla="*/ 3969 h 2524273"/>
                <a:gd name="connsiteX10" fmla="*/ 3046840 w 4552255"/>
                <a:gd name="connsiteY10" fmla="*/ 572682 h 2524273"/>
                <a:gd name="connsiteX11" fmla="*/ 3214108 w 4552255"/>
                <a:gd name="connsiteY11" fmla="*/ 1107940 h 2524273"/>
                <a:gd name="connsiteX12" fmla="*/ 3782820 w 4552255"/>
                <a:gd name="connsiteY12" fmla="*/ 1821618 h 2524273"/>
                <a:gd name="connsiteX13" fmla="*/ 4552255 w 4552255"/>
                <a:gd name="connsiteY13" fmla="*/ 2011189 h 2524273"/>
                <a:gd name="connsiteX14" fmla="*/ 4195416 w 4552255"/>
                <a:gd name="connsiteY14" fmla="*/ 2000038 h 2524273"/>
                <a:gd name="connsiteX15" fmla="*/ 3325620 w 4552255"/>
                <a:gd name="connsiteY15" fmla="*/ 2111550 h 2524273"/>
                <a:gd name="connsiteX16" fmla="*/ 2745757 w 4552255"/>
                <a:gd name="connsiteY16" fmla="*/ 2323423 h 2524273"/>
                <a:gd name="connsiteX17" fmla="*/ 2400069 w 4552255"/>
                <a:gd name="connsiteY17" fmla="*/ 2390330 h 2524273"/>
                <a:gd name="connsiteX18" fmla="*/ 1574879 w 4552255"/>
                <a:gd name="connsiteY18" fmla="*/ 2501843 h 2524273"/>
                <a:gd name="connsiteX19" fmla="*/ 928108 w 4552255"/>
                <a:gd name="connsiteY19" fmla="*/ 2446086 h 2524273"/>
                <a:gd name="connsiteX20" fmla="*/ 13708 w 4552255"/>
                <a:gd name="connsiteY20" fmla="*/ 2524145 h 2524273"/>
                <a:gd name="connsiteX0" fmla="*/ 13708 w 4552255"/>
                <a:gd name="connsiteY0" fmla="*/ 2524145 h 2535296"/>
                <a:gd name="connsiteX1" fmla="*/ 415152 w 4552255"/>
                <a:gd name="connsiteY1" fmla="*/ 2423784 h 2535296"/>
                <a:gd name="connsiteX2" fmla="*/ 916957 w 4552255"/>
                <a:gd name="connsiteY2" fmla="*/ 2100399 h 2535296"/>
                <a:gd name="connsiteX3" fmla="*/ 1206889 w 4552255"/>
                <a:gd name="connsiteY3" fmla="*/ 1542838 h 2535296"/>
                <a:gd name="connsiteX4" fmla="*/ 1173435 w 4552255"/>
                <a:gd name="connsiteY4" fmla="*/ 1096789 h 2535296"/>
                <a:gd name="connsiteX5" fmla="*/ 1463367 w 4552255"/>
                <a:gd name="connsiteY5" fmla="*/ 1275209 h 2535296"/>
                <a:gd name="connsiteX6" fmla="*/ 2132440 w 4552255"/>
                <a:gd name="connsiteY6" fmla="*/ 1252906 h 2535296"/>
                <a:gd name="connsiteX7" fmla="*/ 2745757 w 4552255"/>
                <a:gd name="connsiteY7" fmla="*/ 907218 h 2535296"/>
                <a:gd name="connsiteX8" fmla="*/ 3002235 w 4552255"/>
                <a:gd name="connsiteY8" fmla="*/ 349657 h 2535296"/>
                <a:gd name="connsiteX9" fmla="*/ 3035689 w 4552255"/>
                <a:gd name="connsiteY9" fmla="*/ 3969 h 2535296"/>
                <a:gd name="connsiteX10" fmla="*/ 3046840 w 4552255"/>
                <a:gd name="connsiteY10" fmla="*/ 572682 h 2535296"/>
                <a:gd name="connsiteX11" fmla="*/ 3214108 w 4552255"/>
                <a:gd name="connsiteY11" fmla="*/ 1107940 h 2535296"/>
                <a:gd name="connsiteX12" fmla="*/ 3782820 w 4552255"/>
                <a:gd name="connsiteY12" fmla="*/ 1821618 h 2535296"/>
                <a:gd name="connsiteX13" fmla="*/ 4552255 w 4552255"/>
                <a:gd name="connsiteY13" fmla="*/ 2011189 h 2535296"/>
                <a:gd name="connsiteX14" fmla="*/ 4195416 w 4552255"/>
                <a:gd name="connsiteY14" fmla="*/ 2000038 h 2535296"/>
                <a:gd name="connsiteX15" fmla="*/ 3325620 w 4552255"/>
                <a:gd name="connsiteY15" fmla="*/ 2111550 h 2535296"/>
                <a:gd name="connsiteX16" fmla="*/ 2745757 w 4552255"/>
                <a:gd name="connsiteY16" fmla="*/ 2323423 h 2535296"/>
                <a:gd name="connsiteX17" fmla="*/ 2400069 w 4552255"/>
                <a:gd name="connsiteY17" fmla="*/ 2390330 h 2535296"/>
                <a:gd name="connsiteX18" fmla="*/ 1574879 w 4552255"/>
                <a:gd name="connsiteY18" fmla="*/ 2501843 h 2535296"/>
                <a:gd name="connsiteX19" fmla="*/ 928108 w 4552255"/>
                <a:gd name="connsiteY19" fmla="*/ 2535296 h 2535296"/>
                <a:gd name="connsiteX20" fmla="*/ 13708 w 4552255"/>
                <a:gd name="connsiteY20" fmla="*/ 2524145 h 2535296"/>
                <a:gd name="connsiteX0" fmla="*/ 13708 w 4552255"/>
                <a:gd name="connsiteY0" fmla="*/ 2524145 h 2535296"/>
                <a:gd name="connsiteX1" fmla="*/ 415152 w 4552255"/>
                <a:gd name="connsiteY1" fmla="*/ 2423784 h 2535296"/>
                <a:gd name="connsiteX2" fmla="*/ 916957 w 4552255"/>
                <a:gd name="connsiteY2" fmla="*/ 2100399 h 2535296"/>
                <a:gd name="connsiteX3" fmla="*/ 1206889 w 4552255"/>
                <a:gd name="connsiteY3" fmla="*/ 1542838 h 2535296"/>
                <a:gd name="connsiteX4" fmla="*/ 1173435 w 4552255"/>
                <a:gd name="connsiteY4" fmla="*/ 1096789 h 2535296"/>
                <a:gd name="connsiteX5" fmla="*/ 1463367 w 4552255"/>
                <a:gd name="connsiteY5" fmla="*/ 1275209 h 2535296"/>
                <a:gd name="connsiteX6" fmla="*/ 2132440 w 4552255"/>
                <a:gd name="connsiteY6" fmla="*/ 1252906 h 2535296"/>
                <a:gd name="connsiteX7" fmla="*/ 2745757 w 4552255"/>
                <a:gd name="connsiteY7" fmla="*/ 907218 h 2535296"/>
                <a:gd name="connsiteX8" fmla="*/ 3002235 w 4552255"/>
                <a:gd name="connsiteY8" fmla="*/ 349657 h 2535296"/>
                <a:gd name="connsiteX9" fmla="*/ 3035689 w 4552255"/>
                <a:gd name="connsiteY9" fmla="*/ 3969 h 2535296"/>
                <a:gd name="connsiteX10" fmla="*/ 3046840 w 4552255"/>
                <a:gd name="connsiteY10" fmla="*/ 572682 h 2535296"/>
                <a:gd name="connsiteX11" fmla="*/ 3214108 w 4552255"/>
                <a:gd name="connsiteY11" fmla="*/ 1107940 h 2535296"/>
                <a:gd name="connsiteX12" fmla="*/ 3782820 w 4552255"/>
                <a:gd name="connsiteY12" fmla="*/ 1821618 h 2535296"/>
                <a:gd name="connsiteX13" fmla="*/ 4552255 w 4552255"/>
                <a:gd name="connsiteY13" fmla="*/ 2011189 h 2535296"/>
                <a:gd name="connsiteX14" fmla="*/ 4195416 w 4552255"/>
                <a:gd name="connsiteY14" fmla="*/ 2000038 h 2535296"/>
                <a:gd name="connsiteX15" fmla="*/ 3325620 w 4552255"/>
                <a:gd name="connsiteY15" fmla="*/ 2111550 h 2535296"/>
                <a:gd name="connsiteX16" fmla="*/ 2745757 w 4552255"/>
                <a:gd name="connsiteY16" fmla="*/ 2323423 h 2535296"/>
                <a:gd name="connsiteX17" fmla="*/ 2444674 w 4552255"/>
                <a:gd name="connsiteY17" fmla="*/ 2524145 h 2535296"/>
                <a:gd name="connsiteX18" fmla="*/ 1574879 w 4552255"/>
                <a:gd name="connsiteY18" fmla="*/ 2501843 h 2535296"/>
                <a:gd name="connsiteX19" fmla="*/ 928108 w 4552255"/>
                <a:gd name="connsiteY19" fmla="*/ 2535296 h 2535296"/>
                <a:gd name="connsiteX20" fmla="*/ 13708 w 4552255"/>
                <a:gd name="connsiteY20" fmla="*/ 2524145 h 2535296"/>
                <a:gd name="connsiteX0" fmla="*/ 13708 w 4552255"/>
                <a:gd name="connsiteY0" fmla="*/ 2524145 h 2592679"/>
                <a:gd name="connsiteX1" fmla="*/ 415152 w 4552255"/>
                <a:gd name="connsiteY1" fmla="*/ 2423784 h 2592679"/>
                <a:gd name="connsiteX2" fmla="*/ 916957 w 4552255"/>
                <a:gd name="connsiteY2" fmla="*/ 2100399 h 2592679"/>
                <a:gd name="connsiteX3" fmla="*/ 1206889 w 4552255"/>
                <a:gd name="connsiteY3" fmla="*/ 1542838 h 2592679"/>
                <a:gd name="connsiteX4" fmla="*/ 1173435 w 4552255"/>
                <a:gd name="connsiteY4" fmla="*/ 1096789 h 2592679"/>
                <a:gd name="connsiteX5" fmla="*/ 1463367 w 4552255"/>
                <a:gd name="connsiteY5" fmla="*/ 1275209 h 2592679"/>
                <a:gd name="connsiteX6" fmla="*/ 2132440 w 4552255"/>
                <a:gd name="connsiteY6" fmla="*/ 1252906 h 2592679"/>
                <a:gd name="connsiteX7" fmla="*/ 2745757 w 4552255"/>
                <a:gd name="connsiteY7" fmla="*/ 907218 h 2592679"/>
                <a:gd name="connsiteX8" fmla="*/ 3002235 w 4552255"/>
                <a:gd name="connsiteY8" fmla="*/ 349657 h 2592679"/>
                <a:gd name="connsiteX9" fmla="*/ 3035689 w 4552255"/>
                <a:gd name="connsiteY9" fmla="*/ 3969 h 2592679"/>
                <a:gd name="connsiteX10" fmla="*/ 3046840 w 4552255"/>
                <a:gd name="connsiteY10" fmla="*/ 572682 h 2592679"/>
                <a:gd name="connsiteX11" fmla="*/ 3214108 w 4552255"/>
                <a:gd name="connsiteY11" fmla="*/ 1107940 h 2592679"/>
                <a:gd name="connsiteX12" fmla="*/ 3782820 w 4552255"/>
                <a:gd name="connsiteY12" fmla="*/ 1821618 h 2592679"/>
                <a:gd name="connsiteX13" fmla="*/ 4552255 w 4552255"/>
                <a:gd name="connsiteY13" fmla="*/ 2011189 h 2592679"/>
                <a:gd name="connsiteX14" fmla="*/ 4195416 w 4552255"/>
                <a:gd name="connsiteY14" fmla="*/ 2000038 h 2592679"/>
                <a:gd name="connsiteX15" fmla="*/ 3325620 w 4552255"/>
                <a:gd name="connsiteY15" fmla="*/ 2111550 h 2592679"/>
                <a:gd name="connsiteX16" fmla="*/ 2745757 w 4552255"/>
                <a:gd name="connsiteY16" fmla="*/ 2323423 h 2592679"/>
                <a:gd name="connsiteX17" fmla="*/ 2444674 w 4552255"/>
                <a:gd name="connsiteY17" fmla="*/ 2524145 h 2592679"/>
                <a:gd name="connsiteX18" fmla="*/ 1563727 w 4552255"/>
                <a:gd name="connsiteY18" fmla="*/ 2591052 h 2592679"/>
                <a:gd name="connsiteX19" fmla="*/ 928108 w 4552255"/>
                <a:gd name="connsiteY19" fmla="*/ 2535296 h 2592679"/>
                <a:gd name="connsiteX20" fmla="*/ 13708 w 4552255"/>
                <a:gd name="connsiteY20" fmla="*/ 2524145 h 2592679"/>
                <a:gd name="connsiteX0" fmla="*/ 103148 w 4641695"/>
                <a:gd name="connsiteY0" fmla="*/ 2524145 h 2592679"/>
                <a:gd name="connsiteX1" fmla="*/ 504592 w 4641695"/>
                <a:gd name="connsiteY1" fmla="*/ 2423784 h 2592679"/>
                <a:gd name="connsiteX2" fmla="*/ 1006397 w 4641695"/>
                <a:gd name="connsiteY2" fmla="*/ 2100399 h 2592679"/>
                <a:gd name="connsiteX3" fmla="*/ 1296329 w 4641695"/>
                <a:gd name="connsiteY3" fmla="*/ 1542838 h 2592679"/>
                <a:gd name="connsiteX4" fmla="*/ 1262875 w 4641695"/>
                <a:gd name="connsiteY4" fmla="*/ 1096789 h 2592679"/>
                <a:gd name="connsiteX5" fmla="*/ 1552807 w 4641695"/>
                <a:gd name="connsiteY5" fmla="*/ 1275209 h 2592679"/>
                <a:gd name="connsiteX6" fmla="*/ 2221880 w 4641695"/>
                <a:gd name="connsiteY6" fmla="*/ 1252906 h 2592679"/>
                <a:gd name="connsiteX7" fmla="*/ 2835197 w 4641695"/>
                <a:gd name="connsiteY7" fmla="*/ 907218 h 2592679"/>
                <a:gd name="connsiteX8" fmla="*/ 3091675 w 4641695"/>
                <a:gd name="connsiteY8" fmla="*/ 349657 h 2592679"/>
                <a:gd name="connsiteX9" fmla="*/ 3125129 w 4641695"/>
                <a:gd name="connsiteY9" fmla="*/ 3969 h 2592679"/>
                <a:gd name="connsiteX10" fmla="*/ 3136280 w 4641695"/>
                <a:gd name="connsiteY10" fmla="*/ 572682 h 2592679"/>
                <a:gd name="connsiteX11" fmla="*/ 3303548 w 4641695"/>
                <a:gd name="connsiteY11" fmla="*/ 1107940 h 2592679"/>
                <a:gd name="connsiteX12" fmla="*/ 3872260 w 4641695"/>
                <a:gd name="connsiteY12" fmla="*/ 1821618 h 2592679"/>
                <a:gd name="connsiteX13" fmla="*/ 4641695 w 4641695"/>
                <a:gd name="connsiteY13" fmla="*/ 2011189 h 2592679"/>
                <a:gd name="connsiteX14" fmla="*/ 4284856 w 4641695"/>
                <a:gd name="connsiteY14" fmla="*/ 2000038 h 2592679"/>
                <a:gd name="connsiteX15" fmla="*/ 3415060 w 4641695"/>
                <a:gd name="connsiteY15" fmla="*/ 2111550 h 2592679"/>
                <a:gd name="connsiteX16" fmla="*/ 2835197 w 4641695"/>
                <a:gd name="connsiteY16" fmla="*/ 2323423 h 2592679"/>
                <a:gd name="connsiteX17" fmla="*/ 2534114 w 4641695"/>
                <a:gd name="connsiteY17" fmla="*/ 2524145 h 2592679"/>
                <a:gd name="connsiteX18" fmla="*/ 1653167 w 4641695"/>
                <a:gd name="connsiteY18" fmla="*/ 2591052 h 2592679"/>
                <a:gd name="connsiteX19" fmla="*/ 1017548 w 4641695"/>
                <a:gd name="connsiteY19" fmla="*/ 2535296 h 2592679"/>
                <a:gd name="connsiteX20" fmla="*/ 103148 w 4641695"/>
                <a:gd name="connsiteY20" fmla="*/ 2524145 h 2592679"/>
                <a:gd name="connsiteX0" fmla="*/ 12746 w 4551293"/>
                <a:gd name="connsiteY0" fmla="*/ 2524145 h 2592679"/>
                <a:gd name="connsiteX1" fmla="*/ 414190 w 4551293"/>
                <a:gd name="connsiteY1" fmla="*/ 2423784 h 2592679"/>
                <a:gd name="connsiteX2" fmla="*/ 915995 w 4551293"/>
                <a:gd name="connsiteY2" fmla="*/ 2100399 h 2592679"/>
                <a:gd name="connsiteX3" fmla="*/ 1205927 w 4551293"/>
                <a:gd name="connsiteY3" fmla="*/ 1542838 h 2592679"/>
                <a:gd name="connsiteX4" fmla="*/ 1172473 w 4551293"/>
                <a:gd name="connsiteY4" fmla="*/ 1096789 h 2592679"/>
                <a:gd name="connsiteX5" fmla="*/ 1462405 w 4551293"/>
                <a:gd name="connsiteY5" fmla="*/ 1275209 h 2592679"/>
                <a:gd name="connsiteX6" fmla="*/ 2131478 w 4551293"/>
                <a:gd name="connsiteY6" fmla="*/ 1252906 h 2592679"/>
                <a:gd name="connsiteX7" fmla="*/ 2744795 w 4551293"/>
                <a:gd name="connsiteY7" fmla="*/ 907218 h 2592679"/>
                <a:gd name="connsiteX8" fmla="*/ 3001273 w 4551293"/>
                <a:gd name="connsiteY8" fmla="*/ 349657 h 2592679"/>
                <a:gd name="connsiteX9" fmla="*/ 3034727 w 4551293"/>
                <a:gd name="connsiteY9" fmla="*/ 3969 h 2592679"/>
                <a:gd name="connsiteX10" fmla="*/ 3045878 w 4551293"/>
                <a:gd name="connsiteY10" fmla="*/ 572682 h 2592679"/>
                <a:gd name="connsiteX11" fmla="*/ 3213146 w 4551293"/>
                <a:gd name="connsiteY11" fmla="*/ 1107940 h 2592679"/>
                <a:gd name="connsiteX12" fmla="*/ 3781858 w 4551293"/>
                <a:gd name="connsiteY12" fmla="*/ 1821618 h 2592679"/>
                <a:gd name="connsiteX13" fmla="*/ 4551293 w 4551293"/>
                <a:gd name="connsiteY13" fmla="*/ 2011189 h 2592679"/>
                <a:gd name="connsiteX14" fmla="*/ 4194454 w 4551293"/>
                <a:gd name="connsiteY14" fmla="*/ 2000038 h 2592679"/>
                <a:gd name="connsiteX15" fmla="*/ 3324658 w 4551293"/>
                <a:gd name="connsiteY15" fmla="*/ 2111550 h 2592679"/>
                <a:gd name="connsiteX16" fmla="*/ 2744795 w 4551293"/>
                <a:gd name="connsiteY16" fmla="*/ 2323423 h 2592679"/>
                <a:gd name="connsiteX17" fmla="*/ 2443712 w 4551293"/>
                <a:gd name="connsiteY17" fmla="*/ 2524145 h 2592679"/>
                <a:gd name="connsiteX18" fmla="*/ 1562765 w 4551293"/>
                <a:gd name="connsiteY18" fmla="*/ 2591052 h 2592679"/>
                <a:gd name="connsiteX19" fmla="*/ 904843 w 4551293"/>
                <a:gd name="connsiteY19" fmla="*/ 2579901 h 2592679"/>
                <a:gd name="connsiteX20" fmla="*/ 12746 w 4551293"/>
                <a:gd name="connsiteY20" fmla="*/ 2524145 h 2592679"/>
                <a:gd name="connsiteX0" fmla="*/ 12746 w 4551293"/>
                <a:gd name="connsiteY0" fmla="*/ 2524145 h 2625472"/>
                <a:gd name="connsiteX1" fmla="*/ 414190 w 4551293"/>
                <a:gd name="connsiteY1" fmla="*/ 2423784 h 2625472"/>
                <a:gd name="connsiteX2" fmla="*/ 915995 w 4551293"/>
                <a:gd name="connsiteY2" fmla="*/ 2100399 h 2625472"/>
                <a:gd name="connsiteX3" fmla="*/ 1205927 w 4551293"/>
                <a:gd name="connsiteY3" fmla="*/ 1542838 h 2625472"/>
                <a:gd name="connsiteX4" fmla="*/ 1172473 w 4551293"/>
                <a:gd name="connsiteY4" fmla="*/ 1096789 h 2625472"/>
                <a:gd name="connsiteX5" fmla="*/ 1462405 w 4551293"/>
                <a:gd name="connsiteY5" fmla="*/ 1275209 h 2625472"/>
                <a:gd name="connsiteX6" fmla="*/ 2131478 w 4551293"/>
                <a:gd name="connsiteY6" fmla="*/ 1252906 h 2625472"/>
                <a:gd name="connsiteX7" fmla="*/ 2744795 w 4551293"/>
                <a:gd name="connsiteY7" fmla="*/ 907218 h 2625472"/>
                <a:gd name="connsiteX8" fmla="*/ 3001273 w 4551293"/>
                <a:gd name="connsiteY8" fmla="*/ 349657 h 2625472"/>
                <a:gd name="connsiteX9" fmla="*/ 3034727 w 4551293"/>
                <a:gd name="connsiteY9" fmla="*/ 3969 h 2625472"/>
                <a:gd name="connsiteX10" fmla="*/ 3045878 w 4551293"/>
                <a:gd name="connsiteY10" fmla="*/ 572682 h 2625472"/>
                <a:gd name="connsiteX11" fmla="*/ 3213146 w 4551293"/>
                <a:gd name="connsiteY11" fmla="*/ 1107940 h 2625472"/>
                <a:gd name="connsiteX12" fmla="*/ 3781858 w 4551293"/>
                <a:gd name="connsiteY12" fmla="*/ 1821618 h 2625472"/>
                <a:gd name="connsiteX13" fmla="*/ 4551293 w 4551293"/>
                <a:gd name="connsiteY13" fmla="*/ 2011189 h 2625472"/>
                <a:gd name="connsiteX14" fmla="*/ 4194454 w 4551293"/>
                <a:gd name="connsiteY14" fmla="*/ 2000038 h 2625472"/>
                <a:gd name="connsiteX15" fmla="*/ 3324658 w 4551293"/>
                <a:gd name="connsiteY15" fmla="*/ 2111550 h 2625472"/>
                <a:gd name="connsiteX16" fmla="*/ 2744795 w 4551293"/>
                <a:gd name="connsiteY16" fmla="*/ 2323423 h 2625472"/>
                <a:gd name="connsiteX17" fmla="*/ 2443712 w 4551293"/>
                <a:gd name="connsiteY17" fmla="*/ 2524145 h 2625472"/>
                <a:gd name="connsiteX18" fmla="*/ 1585067 w 4551293"/>
                <a:gd name="connsiteY18" fmla="*/ 2624505 h 2625472"/>
                <a:gd name="connsiteX19" fmla="*/ 904843 w 4551293"/>
                <a:gd name="connsiteY19" fmla="*/ 2579901 h 2625472"/>
                <a:gd name="connsiteX20" fmla="*/ 12746 w 4551293"/>
                <a:gd name="connsiteY20" fmla="*/ 2524145 h 2625472"/>
                <a:gd name="connsiteX0" fmla="*/ 12746 w 4551293"/>
                <a:gd name="connsiteY0" fmla="*/ 2524145 h 2626365"/>
                <a:gd name="connsiteX1" fmla="*/ 414190 w 4551293"/>
                <a:gd name="connsiteY1" fmla="*/ 2423784 h 2626365"/>
                <a:gd name="connsiteX2" fmla="*/ 915995 w 4551293"/>
                <a:gd name="connsiteY2" fmla="*/ 2100399 h 2626365"/>
                <a:gd name="connsiteX3" fmla="*/ 1205927 w 4551293"/>
                <a:gd name="connsiteY3" fmla="*/ 1542838 h 2626365"/>
                <a:gd name="connsiteX4" fmla="*/ 1172473 w 4551293"/>
                <a:gd name="connsiteY4" fmla="*/ 1096789 h 2626365"/>
                <a:gd name="connsiteX5" fmla="*/ 1462405 w 4551293"/>
                <a:gd name="connsiteY5" fmla="*/ 1275209 h 2626365"/>
                <a:gd name="connsiteX6" fmla="*/ 2131478 w 4551293"/>
                <a:gd name="connsiteY6" fmla="*/ 1252906 h 2626365"/>
                <a:gd name="connsiteX7" fmla="*/ 2744795 w 4551293"/>
                <a:gd name="connsiteY7" fmla="*/ 907218 h 2626365"/>
                <a:gd name="connsiteX8" fmla="*/ 3001273 w 4551293"/>
                <a:gd name="connsiteY8" fmla="*/ 349657 h 2626365"/>
                <a:gd name="connsiteX9" fmla="*/ 3034727 w 4551293"/>
                <a:gd name="connsiteY9" fmla="*/ 3969 h 2626365"/>
                <a:gd name="connsiteX10" fmla="*/ 3045878 w 4551293"/>
                <a:gd name="connsiteY10" fmla="*/ 572682 h 2626365"/>
                <a:gd name="connsiteX11" fmla="*/ 3213146 w 4551293"/>
                <a:gd name="connsiteY11" fmla="*/ 1107940 h 2626365"/>
                <a:gd name="connsiteX12" fmla="*/ 3781858 w 4551293"/>
                <a:gd name="connsiteY12" fmla="*/ 1821618 h 2626365"/>
                <a:gd name="connsiteX13" fmla="*/ 4551293 w 4551293"/>
                <a:gd name="connsiteY13" fmla="*/ 2011189 h 2626365"/>
                <a:gd name="connsiteX14" fmla="*/ 4194454 w 4551293"/>
                <a:gd name="connsiteY14" fmla="*/ 2000038 h 2626365"/>
                <a:gd name="connsiteX15" fmla="*/ 3324658 w 4551293"/>
                <a:gd name="connsiteY15" fmla="*/ 2111550 h 2626365"/>
                <a:gd name="connsiteX16" fmla="*/ 2744795 w 4551293"/>
                <a:gd name="connsiteY16" fmla="*/ 2323423 h 2626365"/>
                <a:gd name="connsiteX17" fmla="*/ 2376804 w 4551293"/>
                <a:gd name="connsiteY17" fmla="*/ 2557598 h 2626365"/>
                <a:gd name="connsiteX18" fmla="*/ 1585067 w 4551293"/>
                <a:gd name="connsiteY18" fmla="*/ 2624505 h 2626365"/>
                <a:gd name="connsiteX19" fmla="*/ 904843 w 4551293"/>
                <a:gd name="connsiteY19" fmla="*/ 2579901 h 2626365"/>
                <a:gd name="connsiteX20" fmla="*/ 12746 w 4551293"/>
                <a:gd name="connsiteY20" fmla="*/ 2524145 h 2626365"/>
                <a:gd name="connsiteX0" fmla="*/ 12746 w 4551293"/>
                <a:gd name="connsiteY0" fmla="*/ 2524145 h 2625947"/>
                <a:gd name="connsiteX1" fmla="*/ 414190 w 4551293"/>
                <a:gd name="connsiteY1" fmla="*/ 2423784 h 2625947"/>
                <a:gd name="connsiteX2" fmla="*/ 915995 w 4551293"/>
                <a:gd name="connsiteY2" fmla="*/ 2100399 h 2625947"/>
                <a:gd name="connsiteX3" fmla="*/ 1205927 w 4551293"/>
                <a:gd name="connsiteY3" fmla="*/ 1542838 h 2625947"/>
                <a:gd name="connsiteX4" fmla="*/ 1172473 w 4551293"/>
                <a:gd name="connsiteY4" fmla="*/ 1096789 h 2625947"/>
                <a:gd name="connsiteX5" fmla="*/ 1462405 w 4551293"/>
                <a:gd name="connsiteY5" fmla="*/ 1275209 h 2625947"/>
                <a:gd name="connsiteX6" fmla="*/ 2131478 w 4551293"/>
                <a:gd name="connsiteY6" fmla="*/ 1252906 h 2625947"/>
                <a:gd name="connsiteX7" fmla="*/ 2744795 w 4551293"/>
                <a:gd name="connsiteY7" fmla="*/ 907218 h 2625947"/>
                <a:gd name="connsiteX8" fmla="*/ 3001273 w 4551293"/>
                <a:gd name="connsiteY8" fmla="*/ 349657 h 2625947"/>
                <a:gd name="connsiteX9" fmla="*/ 3034727 w 4551293"/>
                <a:gd name="connsiteY9" fmla="*/ 3969 h 2625947"/>
                <a:gd name="connsiteX10" fmla="*/ 3045878 w 4551293"/>
                <a:gd name="connsiteY10" fmla="*/ 572682 h 2625947"/>
                <a:gd name="connsiteX11" fmla="*/ 3213146 w 4551293"/>
                <a:gd name="connsiteY11" fmla="*/ 1107940 h 2625947"/>
                <a:gd name="connsiteX12" fmla="*/ 3781858 w 4551293"/>
                <a:gd name="connsiteY12" fmla="*/ 1821618 h 2625947"/>
                <a:gd name="connsiteX13" fmla="*/ 4551293 w 4551293"/>
                <a:gd name="connsiteY13" fmla="*/ 2011189 h 2625947"/>
                <a:gd name="connsiteX14" fmla="*/ 4194454 w 4551293"/>
                <a:gd name="connsiteY14" fmla="*/ 2000038 h 2625947"/>
                <a:gd name="connsiteX15" fmla="*/ 3324658 w 4551293"/>
                <a:gd name="connsiteY15" fmla="*/ 2111550 h 2625947"/>
                <a:gd name="connsiteX16" fmla="*/ 2800551 w 4551293"/>
                <a:gd name="connsiteY16" fmla="*/ 2390330 h 2625947"/>
                <a:gd name="connsiteX17" fmla="*/ 2376804 w 4551293"/>
                <a:gd name="connsiteY17" fmla="*/ 2557598 h 2625947"/>
                <a:gd name="connsiteX18" fmla="*/ 1585067 w 4551293"/>
                <a:gd name="connsiteY18" fmla="*/ 2624505 h 2625947"/>
                <a:gd name="connsiteX19" fmla="*/ 904843 w 4551293"/>
                <a:gd name="connsiteY19" fmla="*/ 2579901 h 2625947"/>
                <a:gd name="connsiteX20" fmla="*/ 12746 w 4551293"/>
                <a:gd name="connsiteY20" fmla="*/ 2524145 h 2625947"/>
                <a:gd name="connsiteX0" fmla="*/ 12746 w 4551293"/>
                <a:gd name="connsiteY0" fmla="*/ 2524145 h 2625947"/>
                <a:gd name="connsiteX1" fmla="*/ 414190 w 4551293"/>
                <a:gd name="connsiteY1" fmla="*/ 2423784 h 2625947"/>
                <a:gd name="connsiteX2" fmla="*/ 915995 w 4551293"/>
                <a:gd name="connsiteY2" fmla="*/ 2100399 h 2625947"/>
                <a:gd name="connsiteX3" fmla="*/ 1205927 w 4551293"/>
                <a:gd name="connsiteY3" fmla="*/ 1542838 h 2625947"/>
                <a:gd name="connsiteX4" fmla="*/ 1462405 w 4551293"/>
                <a:gd name="connsiteY4" fmla="*/ 1275209 h 2625947"/>
                <a:gd name="connsiteX5" fmla="*/ 2131478 w 4551293"/>
                <a:gd name="connsiteY5" fmla="*/ 1252906 h 2625947"/>
                <a:gd name="connsiteX6" fmla="*/ 2744795 w 4551293"/>
                <a:gd name="connsiteY6" fmla="*/ 907218 h 2625947"/>
                <a:gd name="connsiteX7" fmla="*/ 3001273 w 4551293"/>
                <a:gd name="connsiteY7" fmla="*/ 349657 h 2625947"/>
                <a:gd name="connsiteX8" fmla="*/ 3034727 w 4551293"/>
                <a:gd name="connsiteY8" fmla="*/ 3969 h 2625947"/>
                <a:gd name="connsiteX9" fmla="*/ 3045878 w 4551293"/>
                <a:gd name="connsiteY9" fmla="*/ 572682 h 2625947"/>
                <a:gd name="connsiteX10" fmla="*/ 3213146 w 4551293"/>
                <a:gd name="connsiteY10" fmla="*/ 1107940 h 2625947"/>
                <a:gd name="connsiteX11" fmla="*/ 3781858 w 4551293"/>
                <a:gd name="connsiteY11" fmla="*/ 1821618 h 2625947"/>
                <a:gd name="connsiteX12" fmla="*/ 4551293 w 4551293"/>
                <a:gd name="connsiteY12" fmla="*/ 2011189 h 2625947"/>
                <a:gd name="connsiteX13" fmla="*/ 4194454 w 4551293"/>
                <a:gd name="connsiteY13" fmla="*/ 2000038 h 2625947"/>
                <a:gd name="connsiteX14" fmla="*/ 3324658 w 4551293"/>
                <a:gd name="connsiteY14" fmla="*/ 2111550 h 2625947"/>
                <a:gd name="connsiteX15" fmla="*/ 2800551 w 4551293"/>
                <a:gd name="connsiteY15" fmla="*/ 2390330 h 2625947"/>
                <a:gd name="connsiteX16" fmla="*/ 2376804 w 4551293"/>
                <a:gd name="connsiteY16" fmla="*/ 2557598 h 2625947"/>
                <a:gd name="connsiteX17" fmla="*/ 1585067 w 4551293"/>
                <a:gd name="connsiteY17" fmla="*/ 2624505 h 2625947"/>
                <a:gd name="connsiteX18" fmla="*/ 904843 w 4551293"/>
                <a:gd name="connsiteY18" fmla="*/ 2579901 h 2625947"/>
                <a:gd name="connsiteX19" fmla="*/ 12746 w 4551293"/>
                <a:gd name="connsiteY19" fmla="*/ 2524145 h 2625947"/>
                <a:gd name="connsiteX0" fmla="*/ 17521 w 4556068"/>
                <a:gd name="connsiteY0" fmla="*/ 2524145 h 2625947"/>
                <a:gd name="connsiteX1" fmla="*/ 363209 w 4556068"/>
                <a:gd name="connsiteY1" fmla="*/ 2323423 h 2625947"/>
                <a:gd name="connsiteX2" fmla="*/ 920770 w 4556068"/>
                <a:gd name="connsiteY2" fmla="*/ 2100399 h 2625947"/>
                <a:gd name="connsiteX3" fmla="*/ 1210702 w 4556068"/>
                <a:gd name="connsiteY3" fmla="*/ 1542838 h 2625947"/>
                <a:gd name="connsiteX4" fmla="*/ 1467180 w 4556068"/>
                <a:gd name="connsiteY4" fmla="*/ 1275209 h 2625947"/>
                <a:gd name="connsiteX5" fmla="*/ 2136253 w 4556068"/>
                <a:gd name="connsiteY5" fmla="*/ 1252906 h 2625947"/>
                <a:gd name="connsiteX6" fmla="*/ 2749570 w 4556068"/>
                <a:gd name="connsiteY6" fmla="*/ 907218 h 2625947"/>
                <a:gd name="connsiteX7" fmla="*/ 3006048 w 4556068"/>
                <a:gd name="connsiteY7" fmla="*/ 349657 h 2625947"/>
                <a:gd name="connsiteX8" fmla="*/ 3039502 w 4556068"/>
                <a:gd name="connsiteY8" fmla="*/ 3969 h 2625947"/>
                <a:gd name="connsiteX9" fmla="*/ 3050653 w 4556068"/>
                <a:gd name="connsiteY9" fmla="*/ 572682 h 2625947"/>
                <a:gd name="connsiteX10" fmla="*/ 3217921 w 4556068"/>
                <a:gd name="connsiteY10" fmla="*/ 1107940 h 2625947"/>
                <a:gd name="connsiteX11" fmla="*/ 3786633 w 4556068"/>
                <a:gd name="connsiteY11" fmla="*/ 1821618 h 2625947"/>
                <a:gd name="connsiteX12" fmla="*/ 4556068 w 4556068"/>
                <a:gd name="connsiteY12" fmla="*/ 2011189 h 2625947"/>
                <a:gd name="connsiteX13" fmla="*/ 4199229 w 4556068"/>
                <a:gd name="connsiteY13" fmla="*/ 2000038 h 2625947"/>
                <a:gd name="connsiteX14" fmla="*/ 3329433 w 4556068"/>
                <a:gd name="connsiteY14" fmla="*/ 2111550 h 2625947"/>
                <a:gd name="connsiteX15" fmla="*/ 2805326 w 4556068"/>
                <a:gd name="connsiteY15" fmla="*/ 2390330 h 2625947"/>
                <a:gd name="connsiteX16" fmla="*/ 2381579 w 4556068"/>
                <a:gd name="connsiteY16" fmla="*/ 2557598 h 2625947"/>
                <a:gd name="connsiteX17" fmla="*/ 1589842 w 4556068"/>
                <a:gd name="connsiteY17" fmla="*/ 2624505 h 2625947"/>
                <a:gd name="connsiteX18" fmla="*/ 909618 w 4556068"/>
                <a:gd name="connsiteY18" fmla="*/ 2579901 h 2625947"/>
                <a:gd name="connsiteX19" fmla="*/ 17521 w 4556068"/>
                <a:gd name="connsiteY19" fmla="*/ 2524145 h 2625947"/>
                <a:gd name="connsiteX0" fmla="*/ 0 w 4538547"/>
                <a:gd name="connsiteY0" fmla="*/ 2524145 h 2625947"/>
                <a:gd name="connsiteX1" fmla="*/ 903249 w 4538547"/>
                <a:gd name="connsiteY1" fmla="*/ 2100399 h 2625947"/>
                <a:gd name="connsiteX2" fmla="*/ 1193181 w 4538547"/>
                <a:gd name="connsiteY2" fmla="*/ 1542838 h 2625947"/>
                <a:gd name="connsiteX3" fmla="*/ 1449659 w 4538547"/>
                <a:gd name="connsiteY3" fmla="*/ 1275209 h 2625947"/>
                <a:gd name="connsiteX4" fmla="*/ 2118732 w 4538547"/>
                <a:gd name="connsiteY4" fmla="*/ 1252906 h 2625947"/>
                <a:gd name="connsiteX5" fmla="*/ 2732049 w 4538547"/>
                <a:gd name="connsiteY5" fmla="*/ 907218 h 2625947"/>
                <a:gd name="connsiteX6" fmla="*/ 2988527 w 4538547"/>
                <a:gd name="connsiteY6" fmla="*/ 349657 h 2625947"/>
                <a:gd name="connsiteX7" fmla="*/ 3021981 w 4538547"/>
                <a:gd name="connsiteY7" fmla="*/ 3969 h 2625947"/>
                <a:gd name="connsiteX8" fmla="*/ 3033132 w 4538547"/>
                <a:gd name="connsiteY8" fmla="*/ 572682 h 2625947"/>
                <a:gd name="connsiteX9" fmla="*/ 3200400 w 4538547"/>
                <a:gd name="connsiteY9" fmla="*/ 1107940 h 2625947"/>
                <a:gd name="connsiteX10" fmla="*/ 3769112 w 4538547"/>
                <a:gd name="connsiteY10" fmla="*/ 1821618 h 2625947"/>
                <a:gd name="connsiteX11" fmla="*/ 4538547 w 4538547"/>
                <a:gd name="connsiteY11" fmla="*/ 2011189 h 2625947"/>
                <a:gd name="connsiteX12" fmla="*/ 4181708 w 4538547"/>
                <a:gd name="connsiteY12" fmla="*/ 2000038 h 2625947"/>
                <a:gd name="connsiteX13" fmla="*/ 3311912 w 4538547"/>
                <a:gd name="connsiteY13" fmla="*/ 2111550 h 2625947"/>
                <a:gd name="connsiteX14" fmla="*/ 2787805 w 4538547"/>
                <a:gd name="connsiteY14" fmla="*/ 2390330 h 2625947"/>
                <a:gd name="connsiteX15" fmla="*/ 2364058 w 4538547"/>
                <a:gd name="connsiteY15" fmla="*/ 2557598 h 2625947"/>
                <a:gd name="connsiteX16" fmla="*/ 1572321 w 4538547"/>
                <a:gd name="connsiteY16" fmla="*/ 2624505 h 2625947"/>
                <a:gd name="connsiteX17" fmla="*/ 892097 w 4538547"/>
                <a:gd name="connsiteY17" fmla="*/ 2579901 h 2625947"/>
                <a:gd name="connsiteX18" fmla="*/ 0 w 4538547"/>
                <a:gd name="connsiteY18" fmla="*/ 2524145 h 2625947"/>
                <a:gd name="connsiteX0" fmla="*/ 0 w 4505094"/>
                <a:gd name="connsiteY0" fmla="*/ 2535297 h 2625947"/>
                <a:gd name="connsiteX1" fmla="*/ 869796 w 4505094"/>
                <a:gd name="connsiteY1" fmla="*/ 2100399 h 2625947"/>
                <a:gd name="connsiteX2" fmla="*/ 1159728 w 4505094"/>
                <a:gd name="connsiteY2" fmla="*/ 1542838 h 2625947"/>
                <a:gd name="connsiteX3" fmla="*/ 1416206 w 4505094"/>
                <a:gd name="connsiteY3" fmla="*/ 1275209 h 2625947"/>
                <a:gd name="connsiteX4" fmla="*/ 2085279 w 4505094"/>
                <a:gd name="connsiteY4" fmla="*/ 1252906 h 2625947"/>
                <a:gd name="connsiteX5" fmla="*/ 2698596 w 4505094"/>
                <a:gd name="connsiteY5" fmla="*/ 907218 h 2625947"/>
                <a:gd name="connsiteX6" fmla="*/ 2955074 w 4505094"/>
                <a:gd name="connsiteY6" fmla="*/ 349657 h 2625947"/>
                <a:gd name="connsiteX7" fmla="*/ 2988528 w 4505094"/>
                <a:gd name="connsiteY7" fmla="*/ 3969 h 2625947"/>
                <a:gd name="connsiteX8" fmla="*/ 2999679 w 4505094"/>
                <a:gd name="connsiteY8" fmla="*/ 572682 h 2625947"/>
                <a:gd name="connsiteX9" fmla="*/ 3166947 w 4505094"/>
                <a:gd name="connsiteY9" fmla="*/ 1107940 h 2625947"/>
                <a:gd name="connsiteX10" fmla="*/ 3735659 w 4505094"/>
                <a:gd name="connsiteY10" fmla="*/ 1821618 h 2625947"/>
                <a:gd name="connsiteX11" fmla="*/ 4505094 w 4505094"/>
                <a:gd name="connsiteY11" fmla="*/ 2011189 h 2625947"/>
                <a:gd name="connsiteX12" fmla="*/ 4148255 w 4505094"/>
                <a:gd name="connsiteY12" fmla="*/ 2000038 h 2625947"/>
                <a:gd name="connsiteX13" fmla="*/ 3278459 w 4505094"/>
                <a:gd name="connsiteY13" fmla="*/ 2111550 h 2625947"/>
                <a:gd name="connsiteX14" fmla="*/ 2754352 w 4505094"/>
                <a:gd name="connsiteY14" fmla="*/ 2390330 h 2625947"/>
                <a:gd name="connsiteX15" fmla="*/ 2330605 w 4505094"/>
                <a:gd name="connsiteY15" fmla="*/ 2557598 h 2625947"/>
                <a:gd name="connsiteX16" fmla="*/ 1538868 w 4505094"/>
                <a:gd name="connsiteY16" fmla="*/ 2624505 h 2625947"/>
                <a:gd name="connsiteX17" fmla="*/ 858644 w 4505094"/>
                <a:gd name="connsiteY17" fmla="*/ 2579901 h 2625947"/>
                <a:gd name="connsiteX18" fmla="*/ 0 w 4505094"/>
                <a:gd name="connsiteY18" fmla="*/ 2535297 h 2625947"/>
                <a:gd name="connsiteX0" fmla="*/ 0 w 4505094"/>
                <a:gd name="connsiteY0" fmla="*/ 2535297 h 2669904"/>
                <a:gd name="connsiteX1" fmla="*/ 869796 w 4505094"/>
                <a:gd name="connsiteY1" fmla="*/ 2100399 h 2669904"/>
                <a:gd name="connsiteX2" fmla="*/ 1159728 w 4505094"/>
                <a:gd name="connsiteY2" fmla="*/ 1542838 h 2669904"/>
                <a:gd name="connsiteX3" fmla="*/ 1416206 w 4505094"/>
                <a:gd name="connsiteY3" fmla="*/ 1275209 h 2669904"/>
                <a:gd name="connsiteX4" fmla="*/ 2085279 w 4505094"/>
                <a:gd name="connsiteY4" fmla="*/ 1252906 h 2669904"/>
                <a:gd name="connsiteX5" fmla="*/ 2698596 w 4505094"/>
                <a:gd name="connsiteY5" fmla="*/ 907218 h 2669904"/>
                <a:gd name="connsiteX6" fmla="*/ 2955074 w 4505094"/>
                <a:gd name="connsiteY6" fmla="*/ 349657 h 2669904"/>
                <a:gd name="connsiteX7" fmla="*/ 2988528 w 4505094"/>
                <a:gd name="connsiteY7" fmla="*/ 3969 h 2669904"/>
                <a:gd name="connsiteX8" fmla="*/ 2999679 w 4505094"/>
                <a:gd name="connsiteY8" fmla="*/ 572682 h 2669904"/>
                <a:gd name="connsiteX9" fmla="*/ 3166947 w 4505094"/>
                <a:gd name="connsiteY9" fmla="*/ 1107940 h 2669904"/>
                <a:gd name="connsiteX10" fmla="*/ 3735659 w 4505094"/>
                <a:gd name="connsiteY10" fmla="*/ 1821618 h 2669904"/>
                <a:gd name="connsiteX11" fmla="*/ 4505094 w 4505094"/>
                <a:gd name="connsiteY11" fmla="*/ 2011189 h 2669904"/>
                <a:gd name="connsiteX12" fmla="*/ 4148255 w 4505094"/>
                <a:gd name="connsiteY12" fmla="*/ 2000038 h 2669904"/>
                <a:gd name="connsiteX13" fmla="*/ 3278459 w 4505094"/>
                <a:gd name="connsiteY13" fmla="*/ 2111550 h 2669904"/>
                <a:gd name="connsiteX14" fmla="*/ 2754352 w 4505094"/>
                <a:gd name="connsiteY14" fmla="*/ 2390330 h 2669904"/>
                <a:gd name="connsiteX15" fmla="*/ 2330605 w 4505094"/>
                <a:gd name="connsiteY15" fmla="*/ 2557598 h 2669904"/>
                <a:gd name="connsiteX16" fmla="*/ 1572322 w 4505094"/>
                <a:gd name="connsiteY16" fmla="*/ 2669110 h 2669904"/>
                <a:gd name="connsiteX17" fmla="*/ 858644 w 4505094"/>
                <a:gd name="connsiteY17" fmla="*/ 2579901 h 2669904"/>
                <a:gd name="connsiteX18" fmla="*/ 0 w 4505094"/>
                <a:gd name="connsiteY18" fmla="*/ 2535297 h 2669904"/>
                <a:gd name="connsiteX0" fmla="*/ 0 w 4505094"/>
                <a:gd name="connsiteY0" fmla="*/ 2535297 h 2671433"/>
                <a:gd name="connsiteX1" fmla="*/ 869796 w 4505094"/>
                <a:gd name="connsiteY1" fmla="*/ 2100399 h 2671433"/>
                <a:gd name="connsiteX2" fmla="*/ 1159728 w 4505094"/>
                <a:gd name="connsiteY2" fmla="*/ 1542838 h 2671433"/>
                <a:gd name="connsiteX3" fmla="*/ 1416206 w 4505094"/>
                <a:gd name="connsiteY3" fmla="*/ 1275209 h 2671433"/>
                <a:gd name="connsiteX4" fmla="*/ 2085279 w 4505094"/>
                <a:gd name="connsiteY4" fmla="*/ 1252906 h 2671433"/>
                <a:gd name="connsiteX5" fmla="*/ 2698596 w 4505094"/>
                <a:gd name="connsiteY5" fmla="*/ 907218 h 2671433"/>
                <a:gd name="connsiteX6" fmla="*/ 2955074 w 4505094"/>
                <a:gd name="connsiteY6" fmla="*/ 349657 h 2671433"/>
                <a:gd name="connsiteX7" fmla="*/ 2988528 w 4505094"/>
                <a:gd name="connsiteY7" fmla="*/ 3969 h 2671433"/>
                <a:gd name="connsiteX8" fmla="*/ 2999679 w 4505094"/>
                <a:gd name="connsiteY8" fmla="*/ 572682 h 2671433"/>
                <a:gd name="connsiteX9" fmla="*/ 3166947 w 4505094"/>
                <a:gd name="connsiteY9" fmla="*/ 1107940 h 2671433"/>
                <a:gd name="connsiteX10" fmla="*/ 3735659 w 4505094"/>
                <a:gd name="connsiteY10" fmla="*/ 1821618 h 2671433"/>
                <a:gd name="connsiteX11" fmla="*/ 4505094 w 4505094"/>
                <a:gd name="connsiteY11" fmla="*/ 2011189 h 2671433"/>
                <a:gd name="connsiteX12" fmla="*/ 4148255 w 4505094"/>
                <a:gd name="connsiteY12" fmla="*/ 2000038 h 2671433"/>
                <a:gd name="connsiteX13" fmla="*/ 3278459 w 4505094"/>
                <a:gd name="connsiteY13" fmla="*/ 2111550 h 2671433"/>
                <a:gd name="connsiteX14" fmla="*/ 2754352 w 4505094"/>
                <a:gd name="connsiteY14" fmla="*/ 2390330 h 2671433"/>
                <a:gd name="connsiteX15" fmla="*/ 2386362 w 4505094"/>
                <a:gd name="connsiteY15" fmla="*/ 2613354 h 2671433"/>
                <a:gd name="connsiteX16" fmla="*/ 1572322 w 4505094"/>
                <a:gd name="connsiteY16" fmla="*/ 2669110 h 2671433"/>
                <a:gd name="connsiteX17" fmla="*/ 858644 w 4505094"/>
                <a:gd name="connsiteY17" fmla="*/ 2579901 h 2671433"/>
                <a:gd name="connsiteX18" fmla="*/ 0 w 4505094"/>
                <a:gd name="connsiteY18" fmla="*/ 2535297 h 2671433"/>
                <a:gd name="connsiteX0" fmla="*/ 0 w 4505094"/>
                <a:gd name="connsiteY0" fmla="*/ 2535297 h 2671433"/>
                <a:gd name="connsiteX1" fmla="*/ 869796 w 4505094"/>
                <a:gd name="connsiteY1" fmla="*/ 2100399 h 2671433"/>
                <a:gd name="connsiteX2" fmla="*/ 1159728 w 4505094"/>
                <a:gd name="connsiteY2" fmla="*/ 1542838 h 2671433"/>
                <a:gd name="connsiteX3" fmla="*/ 1416206 w 4505094"/>
                <a:gd name="connsiteY3" fmla="*/ 1275209 h 2671433"/>
                <a:gd name="connsiteX4" fmla="*/ 2085279 w 4505094"/>
                <a:gd name="connsiteY4" fmla="*/ 1252906 h 2671433"/>
                <a:gd name="connsiteX5" fmla="*/ 2698596 w 4505094"/>
                <a:gd name="connsiteY5" fmla="*/ 907218 h 2671433"/>
                <a:gd name="connsiteX6" fmla="*/ 2955074 w 4505094"/>
                <a:gd name="connsiteY6" fmla="*/ 349657 h 2671433"/>
                <a:gd name="connsiteX7" fmla="*/ 2988528 w 4505094"/>
                <a:gd name="connsiteY7" fmla="*/ 3969 h 2671433"/>
                <a:gd name="connsiteX8" fmla="*/ 2999679 w 4505094"/>
                <a:gd name="connsiteY8" fmla="*/ 572682 h 2671433"/>
                <a:gd name="connsiteX9" fmla="*/ 3166947 w 4505094"/>
                <a:gd name="connsiteY9" fmla="*/ 1107940 h 2671433"/>
                <a:gd name="connsiteX10" fmla="*/ 3735659 w 4505094"/>
                <a:gd name="connsiteY10" fmla="*/ 1821618 h 2671433"/>
                <a:gd name="connsiteX11" fmla="*/ 4505094 w 4505094"/>
                <a:gd name="connsiteY11" fmla="*/ 2011189 h 2671433"/>
                <a:gd name="connsiteX12" fmla="*/ 4148255 w 4505094"/>
                <a:gd name="connsiteY12" fmla="*/ 2000038 h 2671433"/>
                <a:gd name="connsiteX13" fmla="*/ 3278459 w 4505094"/>
                <a:gd name="connsiteY13" fmla="*/ 2111550 h 2671433"/>
                <a:gd name="connsiteX14" fmla="*/ 2754352 w 4505094"/>
                <a:gd name="connsiteY14" fmla="*/ 2390330 h 2671433"/>
                <a:gd name="connsiteX15" fmla="*/ 2386362 w 4505094"/>
                <a:gd name="connsiteY15" fmla="*/ 2613354 h 2671433"/>
                <a:gd name="connsiteX16" fmla="*/ 1572322 w 4505094"/>
                <a:gd name="connsiteY16" fmla="*/ 2669110 h 2671433"/>
                <a:gd name="connsiteX17" fmla="*/ 858644 w 4505094"/>
                <a:gd name="connsiteY17" fmla="*/ 2579901 h 2671433"/>
                <a:gd name="connsiteX18" fmla="*/ 0 w 4505094"/>
                <a:gd name="connsiteY18" fmla="*/ 2535297 h 2671433"/>
                <a:gd name="connsiteX0" fmla="*/ 0 w 4505094"/>
                <a:gd name="connsiteY0" fmla="*/ 2535297 h 2714735"/>
                <a:gd name="connsiteX1" fmla="*/ 869796 w 4505094"/>
                <a:gd name="connsiteY1" fmla="*/ 2100399 h 2714735"/>
                <a:gd name="connsiteX2" fmla="*/ 1159728 w 4505094"/>
                <a:gd name="connsiteY2" fmla="*/ 1542838 h 2714735"/>
                <a:gd name="connsiteX3" fmla="*/ 1416206 w 4505094"/>
                <a:gd name="connsiteY3" fmla="*/ 1275209 h 2714735"/>
                <a:gd name="connsiteX4" fmla="*/ 2085279 w 4505094"/>
                <a:gd name="connsiteY4" fmla="*/ 1252906 h 2714735"/>
                <a:gd name="connsiteX5" fmla="*/ 2698596 w 4505094"/>
                <a:gd name="connsiteY5" fmla="*/ 907218 h 2714735"/>
                <a:gd name="connsiteX6" fmla="*/ 2955074 w 4505094"/>
                <a:gd name="connsiteY6" fmla="*/ 349657 h 2714735"/>
                <a:gd name="connsiteX7" fmla="*/ 2988528 w 4505094"/>
                <a:gd name="connsiteY7" fmla="*/ 3969 h 2714735"/>
                <a:gd name="connsiteX8" fmla="*/ 2999679 w 4505094"/>
                <a:gd name="connsiteY8" fmla="*/ 572682 h 2714735"/>
                <a:gd name="connsiteX9" fmla="*/ 3166947 w 4505094"/>
                <a:gd name="connsiteY9" fmla="*/ 1107940 h 2714735"/>
                <a:gd name="connsiteX10" fmla="*/ 3735659 w 4505094"/>
                <a:gd name="connsiteY10" fmla="*/ 1821618 h 2714735"/>
                <a:gd name="connsiteX11" fmla="*/ 4505094 w 4505094"/>
                <a:gd name="connsiteY11" fmla="*/ 2011189 h 2714735"/>
                <a:gd name="connsiteX12" fmla="*/ 4148255 w 4505094"/>
                <a:gd name="connsiteY12" fmla="*/ 2000038 h 2714735"/>
                <a:gd name="connsiteX13" fmla="*/ 3278459 w 4505094"/>
                <a:gd name="connsiteY13" fmla="*/ 2111550 h 2714735"/>
                <a:gd name="connsiteX14" fmla="*/ 2754352 w 4505094"/>
                <a:gd name="connsiteY14" fmla="*/ 2390330 h 2714735"/>
                <a:gd name="connsiteX15" fmla="*/ 2386362 w 4505094"/>
                <a:gd name="connsiteY15" fmla="*/ 2613354 h 2714735"/>
                <a:gd name="connsiteX16" fmla="*/ 1594625 w 4505094"/>
                <a:gd name="connsiteY16" fmla="*/ 2713714 h 2714735"/>
                <a:gd name="connsiteX17" fmla="*/ 858644 w 4505094"/>
                <a:gd name="connsiteY17" fmla="*/ 2579901 h 2714735"/>
                <a:gd name="connsiteX18" fmla="*/ 0 w 4505094"/>
                <a:gd name="connsiteY18" fmla="*/ 2535297 h 2714735"/>
                <a:gd name="connsiteX0" fmla="*/ 33 w 4505127"/>
                <a:gd name="connsiteY0" fmla="*/ 2535297 h 2714735"/>
                <a:gd name="connsiteX1" fmla="*/ 869829 w 4505127"/>
                <a:gd name="connsiteY1" fmla="*/ 2100399 h 2714735"/>
                <a:gd name="connsiteX2" fmla="*/ 1159761 w 4505127"/>
                <a:gd name="connsiteY2" fmla="*/ 1542838 h 2714735"/>
                <a:gd name="connsiteX3" fmla="*/ 1416239 w 4505127"/>
                <a:gd name="connsiteY3" fmla="*/ 1275209 h 2714735"/>
                <a:gd name="connsiteX4" fmla="*/ 2085312 w 4505127"/>
                <a:gd name="connsiteY4" fmla="*/ 1252906 h 2714735"/>
                <a:gd name="connsiteX5" fmla="*/ 2698629 w 4505127"/>
                <a:gd name="connsiteY5" fmla="*/ 907218 h 2714735"/>
                <a:gd name="connsiteX6" fmla="*/ 2955107 w 4505127"/>
                <a:gd name="connsiteY6" fmla="*/ 349657 h 2714735"/>
                <a:gd name="connsiteX7" fmla="*/ 2988561 w 4505127"/>
                <a:gd name="connsiteY7" fmla="*/ 3969 h 2714735"/>
                <a:gd name="connsiteX8" fmla="*/ 2999712 w 4505127"/>
                <a:gd name="connsiteY8" fmla="*/ 572682 h 2714735"/>
                <a:gd name="connsiteX9" fmla="*/ 3166980 w 4505127"/>
                <a:gd name="connsiteY9" fmla="*/ 1107940 h 2714735"/>
                <a:gd name="connsiteX10" fmla="*/ 3735692 w 4505127"/>
                <a:gd name="connsiteY10" fmla="*/ 1821618 h 2714735"/>
                <a:gd name="connsiteX11" fmla="*/ 4505127 w 4505127"/>
                <a:gd name="connsiteY11" fmla="*/ 2011189 h 2714735"/>
                <a:gd name="connsiteX12" fmla="*/ 4148288 w 4505127"/>
                <a:gd name="connsiteY12" fmla="*/ 2000038 h 2714735"/>
                <a:gd name="connsiteX13" fmla="*/ 3278492 w 4505127"/>
                <a:gd name="connsiteY13" fmla="*/ 2111550 h 2714735"/>
                <a:gd name="connsiteX14" fmla="*/ 2754385 w 4505127"/>
                <a:gd name="connsiteY14" fmla="*/ 2390330 h 2714735"/>
                <a:gd name="connsiteX15" fmla="*/ 2386395 w 4505127"/>
                <a:gd name="connsiteY15" fmla="*/ 2613354 h 2714735"/>
                <a:gd name="connsiteX16" fmla="*/ 1594658 w 4505127"/>
                <a:gd name="connsiteY16" fmla="*/ 2713714 h 2714735"/>
                <a:gd name="connsiteX17" fmla="*/ 839221 w 4505127"/>
                <a:gd name="connsiteY17" fmla="*/ 2657722 h 2714735"/>
                <a:gd name="connsiteX18" fmla="*/ 33 w 4505127"/>
                <a:gd name="connsiteY18" fmla="*/ 2535297 h 2714735"/>
                <a:gd name="connsiteX0" fmla="*/ 33 w 4505127"/>
                <a:gd name="connsiteY0" fmla="*/ 2535297 h 2714735"/>
                <a:gd name="connsiteX1" fmla="*/ 869829 w 4505127"/>
                <a:gd name="connsiteY1" fmla="*/ 2100399 h 2714735"/>
                <a:gd name="connsiteX2" fmla="*/ 1159761 w 4505127"/>
                <a:gd name="connsiteY2" fmla="*/ 1542838 h 2714735"/>
                <a:gd name="connsiteX3" fmla="*/ 1416239 w 4505127"/>
                <a:gd name="connsiteY3" fmla="*/ 1275209 h 2714735"/>
                <a:gd name="connsiteX4" fmla="*/ 2085312 w 4505127"/>
                <a:gd name="connsiteY4" fmla="*/ 1252906 h 2714735"/>
                <a:gd name="connsiteX5" fmla="*/ 2698629 w 4505127"/>
                <a:gd name="connsiteY5" fmla="*/ 907218 h 2714735"/>
                <a:gd name="connsiteX6" fmla="*/ 2955107 w 4505127"/>
                <a:gd name="connsiteY6" fmla="*/ 349657 h 2714735"/>
                <a:gd name="connsiteX7" fmla="*/ 2988561 w 4505127"/>
                <a:gd name="connsiteY7" fmla="*/ 3969 h 2714735"/>
                <a:gd name="connsiteX8" fmla="*/ 2999712 w 4505127"/>
                <a:gd name="connsiteY8" fmla="*/ 572682 h 2714735"/>
                <a:gd name="connsiteX9" fmla="*/ 3166980 w 4505127"/>
                <a:gd name="connsiteY9" fmla="*/ 1107940 h 2714735"/>
                <a:gd name="connsiteX10" fmla="*/ 3793443 w 4505127"/>
                <a:gd name="connsiteY10" fmla="*/ 1571361 h 2714735"/>
                <a:gd name="connsiteX11" fmla="*/ 4505127 w 4505127"/>
                <a:gd name="connsiteY11" fmla="*/ 2011189 h 2714735"/>
                <a:gd name="connsiteX12" fmla="*/ 4148288 w 4505127"/>
                <a:gd name="connsiteY12" fmla="*/ 2000038 h 2714735"/>
                <a:gd name="connsiteX13" fmla="*/ 3278492 w 4505127"/>
                <a:gd name="connsiteY13" fmla="*/ 2111550 h 2714735"/>
                <a:gd name="connsiteX14" fmla="*/ 2754385 w 4505127"/>
                <a:gd name="connsiteY14" fmla="*/ 2390330 h 2714735"/>
                <a:gd name="connsiteX15" fmla="*/ 2386395 w 4505127"/>
                <a:gd name="connsiteY15" fmla="*/ 2613354 h 2714735"/>
                <a:gd name="connsiteX16" fmla="*/ 1594658 w 4505127"/>
                <a:gd name="connsiteY16" fmla="*/ 2713714 h 2714735"/>
                <a:gd name="connsiteX17" fmla="*/ 839221 w 4505127"/>
                <a:gd name="connsiteY17" fmla="*/ 2657722 h 2714735"/>
                <a:gd name="connsiteX18" fmla="*/ 33 w 4505127"/>
                <a:gd name="connsiteY18" fmla="*/ 2535297 h 2714735"/>
                <a:gd name="connsiteX0" fmla="*/ 33 w 4505127"/>
                <a:gd name="connsiteY0" fmla="*/ 2535297 h 2714735"/>
                <a:gd name="connsiteX1" fmla="*/ 869829 w 4505127"/>
                <a:gd name="connsiteY1" fmla="*/ 2100399 h 2714735"/>
                <a:gd name="connsiteX2" fmla="*/ 1159761 w 4505127"/>
                <a:gd name="connsiteY2" fmla="*/ 1542838 h 2714735"/>
                <a:gd name="connsiteX3" fmla="*/ 1416239 w 4505127"/>
                <a:gd name="connsiteY3" fmla="*/ 1275209 h 2714735"/>
                <a:gd name="connsiteX4" fmla="*/ 2085312 w 4505127"/>
                <a:gd name="connsiteY4" fmla="*/ 1252906 h 2714735"/>
                <a:gd name="connsiteX5" fmla="*/ 2698629 w 4505127"/>
                <a:gd name="connsiteY5" fmla="*/ 907218 h 2714735"/>
                <a:gd name="connsiteX6" fmla="*/ 2955107 w 4505127"/>
                <a:gd name="connsiteY6" fmla="*/ 349657 h 2714735"/>
                <a:gd name="connsiteX7" fmla="*/ 2988561 w 4505127"/>
                <a:gd name="connsiteY7" fmla="*/ 3969 h 2714735"/>
                <a:gd name="connsiteX8" fmla="*/ 2999712 w 4505127"/>
                <a:gd name="connsiteY8" fmla="*/ 572682 h 2714735"/>
                <a:gd name="connsiteX9" fmla="*/ 3166980 w 4505127"/>
                <a:gd name="connsiteY9" fmla="*/ 1107940 h 2714735"/>
                <a:gd name="connsiteX10" fmla="*/ 3793443 w 4505127"/>
                <a:gd name="connsiteY10" fmla="*/ 1571361 h 2714735"/>
                <a:gd name="connsiteX11" fmla="*/ 4505127 w 4505127"/>
                <a:gd name="connsiteY11" fmla="*/ 2011189 h 2714735"/>
                <a:gd name="connsiteX12" fmla="*/ 4148288 w 4505127"/>
                <a:gd name="connsiteY12" fmla="*/ 2000038 h 2714735"/>
                <a:gd name="connsiteX13" fmla="*/ 3278492 w 4505127"/>
                <a:gd name="connsiteY13" fmla="*/ 2111550 h 2714735"/>
                <a:gd name="connsiteX14" fmla="*/ 2754385 w 4505127"/>
                <a:gd name="connsiteY14" fmla="*/ 2390330 h 2714735"/>
                <a:gd name="connsiteX15" fmla="*/ 2386395 w 4505127"/>
                <a:gd name="connsiteY15" fmla="*/ 2613354 h 2714735"/>
                <a:gd name="connsiteX16" fmla="*/ 1594658 w 4505127"/>
                <a:gd name="connsiteY16" fmla="*/ 2713714 h 2714735"/>
                <a:gd name="connsiteX17" fmla="*/ 839221 w 4505127"/>
                <a:gd name="connsiteY17" fmla="*/ 2657722 h 2714735"/>
                <a:gd name="connsiteX18" fmla="*/ 33 w 4505127"/>
                <a:gd name="connsiteY18" fmla="*/ 2535297 h 2714735"/>
                <a:gd name="connsiteX0" fmla="*/ 33 w 4505127"/>
                <a:gd name="connsiteY0" fmla="*/ 2535297 h 2714735"/>
                <a:gd name="connsiteX1" fmla="*/ 869829 w 4505127"/>
                <a:gd name="connsiteY1" fmla="*/ 2100399 h 2714735"/>
                <a:gd name="connsiteX2" fmla="*/ 1159761 w 4505127"/>
                <a:gd name="connsiteY2" fmla="*/ 1542838 h 2714735"/>
                <a:gd name="connsiteX3" fmla="*/ 1416239 w 4505127"/>
                <a:gd name="connsiteY3" fmla="*/ 1275209 h 2714735"/>
                <a:gd name="connsiteX4" fmla="*/ 2085312 w 4505127"/>
                <a:gd name="connsiteY4" fmla="*/ 1252906 h 2714735"/>
                <a:gd name="connsiteX5" fmla="*/ 2698629 w 4505127"/>
                <a:gd name="connsiteY5" fmla="*/ 907218 h 2714735"/>
                <a:gd name="connsiteX6" fmla="*/ 2955107 w 4505127"/>
                <a:gd name="connsiteY6" fmla="*/ 349657 h 2714735"/>
                <a:gd name="connsiteX7" fmla="*/ 2988561 w 4505127"/>
                <a:gd name="connsiteY7" fmla="*/ 3969 h 2714735"/>
                <a:gd name="connsiteX8" fmla="*/ 2999712 w 4505127"/>
                <a:gd name="connsiteY8" fmla="*/ 572682 h 2714735"/>
                <a:gd name="connsiteX9" fmla="*/ 3166980 w 4505127"/>
                <a:gd name="connsiteY9" fmla="*/ 1107940 h 2714735"/>
                <a:gd name="connsiteX10" fmla="*/ 3803068 w 4505127"/>
                <a:gd name="connsiteY10" fmla="*/ 1484734 h 2714735"/>
                <a:gd name="connsiteX11" fmla="*/ 4505127 w 4505127"/>
                <a:gd name="connsiteY11" fmla="*/ 2011189 h 2714735"/>
                <a:gd name="connsiteX12" fmla="*/ 4148288 w 4505127"/>
                <a:gd name="connsiteY12" fmla="*/ 2000038 h 2714735"/>
                <a:gd name="connsiteX13" fmla="*/ 3278492 w 4505127"/>
                <a:gd name="connsiteY13" fmla="*/ 2111550 h 2714735"/>
                <a:gd name="connsiteX14" fmla="*/ 2754385 w 4505127"/>
                <a:gd name="connsiteY14" fmla="*/ 2390330 h 2714735"/>
                <a:gd name="connsiteX15" fmla="*/ 2386395 w 4505127"/>
                <a:gd name="connsiteY15" fmla="*/ 2613354 h 2714735"/>
                <a:gd name="connsiteX16" fmla="*/ 1594658 w 4505127"/>
                <a:gd name="connsiteY16" fmla="*/ 2713714 h 2714735"/>
                <a:gd name="connsiteX17" fmla="*/ 839221 w 4505127"/>
                <a:gd name="connsiteY17" fmla="*/ 2657722 h 2714735"/>
                <a:gd name="connsiteX18" fmla="*/ 33 w 4505127"/>
                <a:gd name="connsiteY18" fmla="*/ 2535297 h 2714735"/>
                <a:gd name="connsiteX0" fmla="*/ 33 w 4505127"/>
                <a:gd name="connsiteY0" fmla="*/ 2535297 h 2714735"/>
                <a:gd name="connsiteX1" fmla="*/ 869829 w 4505127"/>
                <a:gd name="connsiteY1" fmla="*/ 2100399 h 2714735"/>
                <a:gd name="connsiteX2" fmla="*/ 1159761 w 4505127"/>
                <a:gd name="connsiteY2" fmla="*/ 1542838 h 2714735"/>
                <a:gd name="connsiteX3" fmla="*/ 1416239 w 4505127"/>
                <a:gd name="connsiteY3" fmla="*/ 1275209 h 2714735"/>
                <a:gd name="connsiteX4" fmla="*/ 2085312 w 4505127"/>
                <a:gd name="connsiteY4" fmla="*/ 1252906 h 2714735"/>
                <a:gd name="connsiteX5" fmla="*/ 2698629 w 4505127"/>
                <a:gd name="connsiteY5" fmla="*/ 907218 h 2714735"/>
                <a:gd name="connsiteX6" fmla="*/ 2955107 w 4505127"/>
                <a:gd name="connsiteY6" fmla="*/ 349657 h 2714735"/>
                <a:gd name="connsiteX7" fmla="*/ 2988561 w 4505127"/>
                <a:gd name="connsiteY7" fmla="*/ 3969 h 2714735"/>
                <a:gd name="connsiteX8" fmla="*/ 2999712 w 4505127"/>
                <a:gd name="connsiteY8" fmla="*/ 572682 h 2714735"/>
                <a:gd name="connsiteX9" fmla="*/ 3166980 w 4505127"/>
                <a:gd name="connsiteY9" fmla="*/ 1107940 h 2714735"/>
                <a:gd name="connsiteX10" fmla="*/ 3918572 w 4505127"/>
                <a:gd name="connsiteY10" fmla="*/ 1426982 h 2714735"/>
                <a:gd name="connsiteX11" fmla="*/ 4505127 w 4505127"/>
                <a:gd name="connsiteY11" fmla="*/ 2011189 h 2714735"/>
                <a:gd name="connsiteX12" fmla="*/ 4148288 w 4505127"/>
                <a:gd name="connsiteY12" fmla="*/ 2000038 h 2714735"/>
                <a:gd name="connsiteX13" fmla="*/ 3278492 w 4505127"/>
                <a:gd name="connsiteY13" fmla="*/ 2111550 h 2714735"/>
                <a:gd name="connsiteX14" fmla="*/ 2754385 w 4505127"/>
                <a:gd name="connsiteY14" fmla="*/ 2390330 h 2714735"/>
                <a:gd name="connsiteX15" fmla="*/ 2386395 w 4505127"/>
                <a:gd name="connsiteY15" fmla="*/ 2613354 h 2714735"/>
                <a:gd name="connsiteX16" fmla="*/ 1594658 w 4505127"/>
                <a:gd name="connsiteY16" fmla="*/ 2713714 h 2714735"/>
                <a:gd name="connsiteX17" fmla="*/ 839221 w 4505127"/>
                <a:gd name="connsiteY17" fmla="*/ 2657722 h 2714735"/>
                <a:gd name="connsiteX18" fmla="*/ 33 w 4505127"/>
                <a:gd name="connsiteY18" fmla="*/ 2535297 h 2714735"/>
                <a:gd name="connsiteX0" fmla="*/ 33 w 4505127"/>
                <a:gd name="connsiteY0" fmla="*/ 2535297 h 2714735"/>
                <a:gd name="connsiteX1" fmla="*/ 869829 w 4505127"/>
                <a:gd name="connsiteY1" fmla="*/ 2100399 h 2714735"/>
                <a:gd name="connsiteX2" fmla="*/ 1159761 w 4505127"/>
                <a:gd name="connsiteY2" fmla="*/ 1542838 h 2714735"/>
                <a:gd name="connsiteX3" fmla="*/ 1416239 w 4505127"/>
                <a:gd name="connsiteY3" fmla="*/ 1275209 h 2714735"/>
                <a:gd name="connsiteX4" fmla="*/ 2085312 w 4505127"/>
                <a:gd name="connsiteY4" fmla="*/ 1252906 h 2714735"/>
                <a:gd name="connsiteX5" fmla="*/ 2698629 w 4505127"/>
                <a:gd name="connsiteY5" fmla="*/ 907218 h 2714735"/>
                <a:gd name="connsiteX6" fmla="*/ 2955107 w 4505127"/>
                <a:gd name="connsiteY6" fmla="*/ 349657 h 2714735"/>
                <a:gd name="connsiteX7" fmla="*/ 2988561 w 4505127"/>
                <a:gd name="connsiteY7" fmla="*/ 3969 h 2714735"/>
                <a:gd name="connsiteX8" fmla="*/ 2999712 w 4505127"/>
                <a:gd name="connsiteY8" fmla="*/ 572682 h 2714735"/>
                <a:gd name="connsiteX9" fmla="*/ 3166980 w 4505127"/>
                <a:gd name="connsiteY9" fmla="*/ 1107940 h 2714735"/>
                <a:gd name="connsiteX10" fmla="*/ 3918572 w 4505127"/>
                <a:gd name="connsiteY10" fmla="*/ 1426982 h 2714735"/>
                <a:gd name="connsiteX11" fmla="*/ 4505127 w 4505127"/>
                <a:gd name="connsiteY11" fmla="*/ 2011189 h 2714735"/>
                <a:gd name="connsiteX12" fmla="*/ 4148288 w 4505127"/>
                <a:gd name="connsiteY12" fmla="*/ 2000038 h 2714735"/>
                <a:gd name="connsiteX13" fmla="*/ 3278492 w 4505127"/>
                <a:gd name="connsiteY13" fmla="*/ 2111550 h 2714735"/>
                <a:gd name="connsiteX14" fmla="*/ 2754385 w 4505127"/>
                <a:gd name="connsiteY14" fmla="*/ 2390330 h 2714735"/>
                <a:gd name="connsiteX15" fmla="*/ 2386395 w 4505127"/>
                <a:gd name="connsiteY15" fmla="*/ 2613354 h 2714735"/>
                <a:gd name="connsiteX16" fmla="*/ 1594658 w 4505127"/>
                <a:gd name="connsiteY16" fmla="*/ 2713714 h 2714735"/>
                <a:gd name="connsiteX17" fmla="*/ 839221 w 4505127"/>
                <a:gd name="connsiteY17" fmla="*/ 2657722 h 2714735"/>
                <a:gd name="connsiteX18" fmla="*/ 33 w 4505127"/>
                <a:gd name="connsiteY18" fmla="*/ 2535297 h 2714735"/>
                <a:gd name="connsiteX0" fmla="*/ 33 w 4505127"/>
                <a:gd name="connsiteY0" fmla="*/ 2535297 h 2714735"/>
                <a:gd name="connsiteX1" fmla="*/ 869829 w 4505127"/>
                <a:gd name="connsiteY1" fmla="*/ 2100399 h 2714735"/>
                <a:gd name="connsiteX2" fmla="*/ 1159761 w 4505127"/>
                <a:gd name="connsiteY2" fmla="*/ 1542838 h 2714735"/>
                <a:gd name="connsiteX3" fmla="*/ 1416239 w 4505127"/>
                <a:gd name="connsiteY3" fmla="*/ 1275209 h 2714735"/>
                <a:gd name="connsiteX4" fmla="*/ 2085312 w 4505127"/>
                <a:gd name="connsiteY4" fmla="*/ 1252906 h 2714735"/>
                <a:gd name="connsiteX5" fmla="*/ 2698629 w 4505127"/>
                <a:gd name="connsiteY5" fmla="*/ 907218 h 2714735"/>
                <a:gd name="connsiteX6" fmla="*/ 2955107 w 4505127"/>
                <a:gd name="connsiteY6" fmla="*/ 349657 h 2714735"/>
                <a:gd name="connsiteX7" fmla="*/ 2988561 w 4505127"/>
                <a:gd name="connsiteY7" fmla="*/ 3969 h 2714735"/>
                <a:gd name="connsiteX8" fmla="*/ 2999712 w 4505127"/>
                <a:gd name="connsiteY8" fmla="*/ 572682 h 2714735"/>
                <a:gd name="connsiteX9" fmla="*/ 3166980 w 4505127"/>
                <a:gd name="connsiteY9" fmla="*/ 1107940 h 2714735"/>
                <a:gd name="connsiteX10" fmla="*/ 3918572 w 4505127"/>
                <a:gd name="connsiteY10" fmla="*/ 1426982 h 2714735"/>
                <a:gd name="connsiteX11" fmla="*/ 4505127 w 4505127"/>
                <a:gd name="connsiteY11" fmla="*/ 2011189 h 2714735"/>
                <a:gd name="connsiteX12" fmla="*/ 4148288 w 4505127"/>
                <a:gd name="connsiteY12" fmla="*/ 2000038 h 2714735"/>
                <a:gd name="connsiteX13" fmla="*/ 3278492 w 4505127"/>
                <a:gd name="connsiteY13" fmla="*/ 2111550 h 2714735"/>
                <a:gd name="connsiteX14" fmla="*/ 2754385 w 4505127"/>
                <a:gd name="connsiteY14" fmla="*/ 2390330 h 2714735"/>
                <a:gd name="connsiteX15" fmla="*/ 2386395 w 4505127"/>
                <a:gd name="connsiteY15" fmla="*/ 2613354 h 2714735"/>
                <a:gd name="connsiteX16" fmla="*/ 1594658 w 4505127"/>
                <a:gd name="connsiteY16" fmla="*/ 2713714 h 2714735"/>
                <a:gd name="connsiteX17" fmla="*/ 839221 w 4505127"/>
                <a:gd name="connsiteY17" fmla="*/ 2657722 h 2714735"/>
                <a:gd name="connsiteX18" fmla="*/ 33 w 4505127"/>
                <a:gd name="connsiteY18" fmla="*/ 2535297 h 2714735"/>
                <a:gd name="connsiteX0" fmla="*/ 12 w 4505106"/>
                <a:gd name="connsiteY0" fmla="*/ 2535297 h 2721035"/>
                <a:gd name="connsiteX1" fmla="*/ 869808 w 4505106"/>
                <a:gd name="connsiteY1" fmla="*/ 2100399 h 2721035"/>
                <a:gd name="connsiteX2" fmla="*/ 1159740 w 4505106"/>
                <a:gd name="connsiteY2" fmla="*/ 1542838 h 2721035"/>
                <a:gd name="connsiteX3" fmla="*/ 1416218 w 4505106"/>
                <a:gd name="connsiteY3" fmla="*/ 1275209 h 2721035"/>
                <a:gd name="connsiteX4" fmla="*/ 2085291 w 4505106"/>
                <a:gd name="connsiteY4" fmla="*/ 1252906 h 2721035"/>
                <a:gd name="connsiteX5" fmla="*/ 2698608 w 4505106"/>
                <a:gd name="connsiteY5" fmla="*/ 907218 h 2721035"/>
                <a:gd name="connsiteX6" fmla="*/ 2955086 w 4505106"/>
                <a:gd name="connsiteY6" fmla="*/ 349657 h 2721035"/>
                <a:gd name="connsiteX7" fmla="*/ 2988540 w 4505106"/>
                <a:gd name="connsiteY7" fmla="*/ 3969 h 2721035"/>
                <a:gd name="connsiteX8" fmla="*/ 2999691 w 4505106"/>
                <a:gd name="connsiteY8" fmla="*/ 572682 h 2721035"/>
                <a:gd name="connsiteX9" fmla="*/ 3166959 w 4505106"/>
                <a:gd name="connsiteY9" fmla="*/ 1107940 h 2721035"/>
                <a:gd name="connsiteX10" fmla="*/ 3918551 w 4505106"/>
                <a:gd name="connsiteY10" fmla="*/ 1426982 h 2721035"/>
                <a:gd name="connsiteX11" fmla="*/ 4505106 w 4505106"/>
                <a:gd name="connsiteY11" fmla="*/ 2011189 h 2721035"/>
                <a:gd name="connsiteX12" fmla="*/ 4148267 w 4505106"/>
                <a:gd name="connsiteY12" fmla="*/ 2000038 h 2721035"/>
                <a:gd name="connsiteX13" fmla="*/ 3278471 w 4505106"/>
                <a:gd name="connsiteY13" fmla="*/ 2111550 h 2721035"/>
                <a:gd name="connsiteX14" fmla="*/ 2754364 w 4505106"/>
                <a:gd name="connsiteY14" fmla="*/ 2390330 h 2721035"/>
                <a:gd name="connsiteX15" fmla="*/ 2386374 w 4505106"/>
                <a:gd name="connsiteY15" fmla="*/ 2613354 h 2721035"/>
                <a:gd name="connsiteX16" fmla="*/ 1594637 w 4505106"/>
                <a:gd name="connsiteY16" fmla="*/ 2713714 h 2721035"/>
                <a:gd name="connsiteX17" fmla="*/ 851900 w 4505106"/>
                <a:gd name="connsiteY17" fmla="*/ 2708522 h 2721035"/>
                <a:gd name="connsiteX18" fmla="*/ 12 w 4505106"/>
                <a:gd name="connsiteY18" fmla="*/ 2535297 h 2721035"/>
                <a:gd name="connsiteX0" fmla="*/ 12 w 4505106"/>
                <a:gd name="connsiteY0" fmla="*/ 2535297 h 2765129"/>
                <a:gd name="connsiteX1" fmla="*/ 869808 w 4505106"/>
                <a:gd name="connsiteY1" fmla="*/ 2100399 h 2765129"/>
                <a:gd name="connsiteX2" fmla="*/ 1159740 w 4505106"/>
                <a:gd name="connsiteY2" fmla="*/ 1542838 h 2765129"/>
                <a:gd name="connsiteX3" fmla="*/ 1416218 w 4505106"/>
                <a:gd name="connsiteY3" fmla="*/ 1275209 h 2765129"/>
                <a:gd name="connsiteX4" fmla="*/ 2085291 w 4505106"/>
                <a:gd name="connsiteY4" fmla="*/ 1252906 h 2765129"/>
                <a:gd name="connsiteX5" fmla="*/ 2698608 w 4505106"/>
                <a:gd name="connsiteY5" fmla="*/ 907218 h 2765129"/>
                <a:gd name="connsiteX6" fmla="*/ 2955086 w 4505106"/>
                <a:gd name="connsiteY6" fmla="*/ 349657 h 2765129"/>
                <a:gd name="connsiteX7" fmla="*/ 2988540 w 4505106"/>
                <a:gd name="connsiteY7" fmla="*/ 3969 h 2765129"/>
                <a:gd name="connsiteX8" fmla="*/ 2999691 w 4505106"/>
                <a:gd name="connsiteY8" fmla="*/ 572682 h 2765129"/>
                <a:gd name="connsiteX9" fmla="*/ 3166959 w 4505106"/>
                <a:gd name="connsiteY9" fmla="*/ 1107940 h 2765129"/>
                <a:gd name="connsiteX10" fmla="*/ 3918551 w 4505106"/>
                <a:gd name="connsiteY10" fmla="*/ 1426982 h 2765129"/>
                <a:gd name="connsiteX11" fmla="*/ 4505106 w 4505106"/>
                <a:gd name="connsiteY11" fmla="*/ 2011189 h 2765129"/>
                <a:gd name="connsiteX12" fmla="*/ 4148267 w 4505106"/>
                <a:gd name="connsiteY12" fmla="*/ 2000038 h 2765129"/>
                <a:gd name="connsiteX13" fmla="*/ 3278471 w 4505106"/>
                <a:gd name="connsiteY13" fmla="*/ 2111550 h 2765129"/>
                <a:gd name="connsiteX14" fmla="*/ 2754364 w 4505106"/>
                <a:gd name="connsiteY14" fmla="*/ 2390330 h 2765129"/>
                <a:gd name="connsiteX15" fmla="*/ 2386374 w 4505106"/>
                <a:gd name="connsiteY15" fmla="*/ 2613354 h 2765129"/>
                <a:gd name="connsiteX16" fmla="*/ 1588287 w 4505106"/>
                <a:gd name="connsiteY16" fmla="*/ 2764514 h 2765129"/>
                <a:gd name="connsiteX17" fmla="*/ 851900 w 4505106"/>
                <a:gd name="connsiteY17" fmla="*/ 2708522 h 2765129"/>
                <a:gd name="connsiteX18" fmla="*/ 12 w 4505106"/>
                <a:gd name="connsiteY18" fmla="*/ 2535297 h 2765129"/>
                <a:gd name="connsiteX0" fmla="*/ 12 w 4505106"/>
                <a:gd name="connsiteY0" fmla="*/ 2535297 h 2769660"/>
                <a:gd name="connsiteX1" fmla="*/ 869808 w 4505106"/>
                <a:gd name="connsiteY1" fmla="*/ 2100399 h 2769660"/>
                <a:gd name="connsiteX2" fmla="*/ 1159740 w 4505106"/>
                <a:gd name="connsiteY2" fmla="*/ 1542838 h 2769660"/>
                <a:gd name="connsiteX3" fmla="*/ 1416218 w 4505106"/>
                <a:gd name="connsiteY3" fmla="*/ 1275209 h 2769660"/>
                <a:gd name="connsiteX4" fmla="*/ 2085291 w 4505106"/>
                <a:gd name="connsiteY4" fmla="*/ 1252906 h 2769660"/>
                <a:gd name="connsiteX5" fmla="*/ 2698608 w 4505106"/>
                <a:gd name="connsiteY5" fmla="*/ 907218 h 2769660"/>
                <a:gd name="connsiteX6" fmla="*/ 2955086 w 4505106"/>
                <a:gd name="connsiteY6" fmla="*/ 349657 h 2769660"/>
                <a:gd name="connsiteX7" fmla="*/ 2988540 w 4505106"/>
                <a:gd name="connsiteY7" fmla="*/ 3969 h 2769660"/>
                <a:gd name="connsiteX8" fmla="*/ 2999691 w 4505106"/>
                <a:gd name="connsiteY8" fmla="*/ 572682 h 2769660"/>
                <a:gd name="connsiteX9" fmla="*/ 3166959 w 4505106"/>
                <a:gd name="connsiteY9" fmla="*/ 1107940 h 2769660"/>
                <a:gd name="connsiteX10" fmla="*/ 3918551 w 4505106"/>
                <a:gd name="connsiteY10" fmla="*/ 1426982 h 2769660"/>
                <a:gd name="connsiteX11" fmla="*/ 4505106 w 4505106"/>
                <a:gd name="connsiteY11" fmla="*/ 2011189 h 2769660"/>
                <a:gd name="connsiteX12" fmla="*/ 4148267 w 4505106"/>
                <a:gd name="connsiteY12" fmla="*/ 2000038 h 2769660"/>
                <a:gd name="connsiteX13" fmla="*/ 3278471 w 4505106"/>
                <a:gd name="connsiteY13" fmla="*/ 2111550 h 2769660"/>
                <a:gd name="connsiteX14" fmla="*/ 2754364 w 4505106"/>
                <a:gd name="connsiteY14" fmla="*/ 2390330 h 2769660"/>
                <a:gd name="connsiteX15" fmla="*/ 2386374 w 4505106"/>
                <a:gd name="connsiteY15" fmla="*/ 2613354 h 2769660"/>
                <a:gd name="connsiteX16" fmla="*/ 1588287 w 4505106"/>
                <a:gd name="connsiteY16" fmla="*/ 2764514 h 2769660"/>
                <a:gd name="connsiteX17" fmla="*/ 851900 w 4505106"/>
                <a:gd name="connsiteY17" fmla="*/ 2708522 h 2769660"/>
                <a:gd name="connsiteX18" fmla="*/ 12 w 4505106"/>
                <a:gd name="connsiteY18" fmla="*/ 2535297 h 2769660"/>
                <a:gd name="connsiteX0" fmla="*/ 12 w 4505121"/>
                <a:gd name="connsiteY0" fmla="*/ 2535297 h 2769660"/>
                <a:gd name="connsiteX1" fmla="*/ 869808 w 4505121"/>
                <a:gd name="connsiteY1" fmla="*/ 2100399 h 2769660"/>
                <a:gd name="connsiteX2" fmla="*/ 1159740 w 4505121"/>
                <a:gd name="connsiteY2" fmla="*/ 1542838 h 2769660"/>
                <a:gd name="connsiteX3" fmla="*/ 1416218 w 4505121"/>
                <a:gd name="connsiteY3" fmla="*/ 1275209 h 2769660"/>
                <a:gd name="connsiteX4" fmla="*/ 2085291 w 4505121"/>
                <a:gd name="connsiteY4" fmla="*/ 1252906 h 2769660"/>
                <a:gd name="connsiteX5" fmla="*/ 2698608 w 4505121"/>
                <a:gd name="connsiteY5" fmla="*/ 907218 h 2769660"/>
                <a:gd name="connsiteX6" fmla="*/ 2955086 w 4505121"/>
                <a:gd name="connsiteY6" fmla="*/ 349657 h 2769660"/>
                <a:gd name="connsiteX7" fmla="*/ 2988540 w 4505121"/>
                <a:gd name="connsiteY7" fmla="*/ 3969 h 2769660"/>
                <a:gd name="connsiteX8" fmla="*/ 2999691 w 4505121"/>
                <a:gd name="connsiteY8" fmla="*/ 572682 h 2769660"/>
                <a:gd name="connsiteX9" fmla="*/ 3166959 w 4505121"/>
                <a:gd name="connsiteY9" fmla="*/ 1107940 h 2769660"/>
                <a:gd name="connsiteX10" fmla="*/ 3918551 w 4505121"/>
                <a:gd name="connsiteY10" fmla="*/ 1426982 h 2769660"/>
                <a:gd name="connsiteX11" fmla="*/ 4112179 w 4505121"/>
                <a:gd name="connsiteY11" fmla="*/ 1623836 h 2769660"/>
                <a:gd name="connsiteX12" fmla="*/ 4505106 w 4505121"/>
                <a:gd name="connsiteY12" fmla="*/ 2011189 h 2769660"/>
                <a:gd name="connsiteX13" fmla="*/ 4148267 w 4505121"/>
                <a:gd name="connsiteY13" fmla="*/ 2000038 h 2769660"/>
                <a:gd name="connsiteX14" fmla="*/ 3278471 w 4505121"/>
                <a:gd name="connsiteY14" fmla="*/ 2111550 h 2769660"/>
                <a:gd name="connsiteX15" fmla="*/ 2754364 w 4505121"/>
                <a:gd name="connsiteY15" fmla="*/ 2390330 h 2769660"/>
                <a:gd name="connsiteX16" fmla="*/ 2386374 w 4505121"/>
                <a:gd name="connsiteY16" fmla="*/ 2613354 h 2769660"/>
                <a:gd name="connsiteX17" fmla="*/ 1588287 w 4505121"/>
                <a:gd name="connsiteY17" fmla="*/ 2764514 h 2769660"/>
                <a:gd name="connsiteX18" fmla="*/ 851900 w 4505121"/>
                <a:gd name="connsiteY18" fmla="*/ 2708522 h 2769660"/>
                <a:gd name="connsiteX19" fmla="*/ 12 w 4505121"/>
                <a:gd name="connsiteY19" fmla="*/ 2535297 h 2769660"/>
                <a:gd name="connsiteX0" fmla="*/ 12 w 4515221"/>
                <a:gd name="connsiteY0" fmla="*/ 2535297 h 2769660"/>
                <a:gd name="connsiteX1" fmla="*/ 869808 w 4515221"/>
                <a:gd name="connsiteY1" fmla="*/ 2100399 h 2769660"/>
                <a:gd name="connsiteX2" fmla="*/ 1159740 w 4515221"/>
                <a:gd name="connsiteY2" fmla="*/ 1542838 h 2769660"/>
                <a:gd name="connsiteX3" fmla="*/ 1416218 w 4515221"/>
                <a:gd name="connsiteY3" fmla="*/ 1275209 h 2769660"/>
                <a:gd name="connsiteX4" fmla="*/ 2085291 w 4515221"/>
                <a:gd name="connsiteY4" fmla="*/ 1252906 h 2769660"/>
                <a:gd name="connsiteX5" fmla="*/ 2698608 w 4515221"/>
                <a:gd name="connsiteY5" fmla="*/ 907218 h 2769660"/>
                <a:gd name="connsiteX6" fmla="*/ 2955086 w 4515221"/>
                <a:gd name="connsiteY6" fmla="*/ 349657 h 2769660"/>
                <a:gd name="connsiteX7" fmla="*/ 2988540 w 4515221"/>
                <a:gd name="connsiteY7" fmla="*/ 3969 h 2769660"/>
                <a:gd name="connsiteX8" fmla="*/ 2999691 w 4515221"/>
                <a:gd name="connsiteY8" fmla="*/ 572682 h 2769660"/>
                <a:gd name="connsiteX9" fmla="*/ 3166959 w 4515221"/>
                <a:gd name="connsiteY9" fmla="*/ 1107940 h 2769660"/>
                <a:gd name="connsiteX10" fmla="*/ 3918551 w 4515221"/>
                <a:gd name="connsiteY10" fmla="*/ 1426982 h 2769660"/>
                <a:gd name="connsiteX11" fmla="*/ 4112179 w 4515221"/>
                <a:gd name="connsiteY11" fmla="*/ 1623836 h 2769660"/>
                <a:gd name="connsiteX12" fmla="*/ 4515207 w 4515221"/>
                <a:gd name="connsiteY12" fmla="*/ 2109594 h 2769660"/>
                <a:gd name="connsiteX13" fmla="*/ 4148267 w 4515221"/>
                <a:gd name="connsiteY13" fmla="*/ 2000038 h 2769660"/>
                <a:gd name="connsiteX14" fmla="*/ 3278471 w 4515221"/>
                <a:gd name="connsiteY14" fmla="*/ 2111550 h 2769660"/>
                <a:gd name="connsiteX15" fmla="*/ 2754364 w 4515221"/>
                <a:gd name="connsiteY15" fmla="*/ 2390330 h 2769660"/>
                <a:gd name="connsiteX16" fmla="*/ 2386374 w 4515221"/>
                <a:gd name="connsiteY16" fmla="*/ 2613354 h 2769660"/>
                <a:gd name="connsiteX17" fmla="*/ 1588287 w 4515221"/>
                <a:gd name="connsiteY17" fmla="*/ 2764514 h 2769660"/>
                <a:gd name="connsiteX18" fmla="*/ 851900 w 4515221"/>
                <a:gd name="connsiteY18" fmla="*/ 2708522 h 2769660"/>
                <a:gd name="connsiteX19" fmla="*/ 12 w 4515221"/>
                <a:gd name="connsiteY19" fmla="*/ 2535297 h 2769660"/>
                <a:gd name="connsiteX0" fmla="*/ 12 w 4496119"/>
                <a:gd name="connsiteY0" fmla="*/ 2535297 h 2769660"/>
                <a:gd name="connsiteX1" fmla="*/ 869808 w 4496119"/>
                <a:gd name="connsiteY1" fmla="*/ 2100399 h 2769660"/>
                <a:gd name="connsiteX2" fmla="*/ 1159740 w 4496119"/>
                <a:gd name="connsiteY2" fmla="*/ 1542838 h 2769660"/>
                <a:gd name="connsiteX3" fmla="*/ 1416218 w 4496119"/>
                <a:gd name="connsiteY3" fmla="*/ 1275209 h 2769660"/>
                <a:gd name="connsiteX4" fmla="*/ 2085291 w 4496119"/>
                <a:gd name="connsiteY4" fmla="*/ 1252906 h 2769660"/>
                <a:gd name="connsiteX5" fmla="*/ 2698608 w 4496119"/>
                <a:gd name="connsiteY5" fmla="*/ 907218 h 2769660"/>
                <a:gd name="connsiteX6" fmla="*/ 2955086 w 4496119"/>
                <a:gd name="connsiteY6" fmla="*/ 349657 h 2769660"/>
                <a:gd name="connsiteX7" fmla="*/ 2988540 w 4496119"/>
                <a:gd name="connsiteY7" fmla="*/ 3969 h 2769660"/>
                <a:gd name="connsiteX8" fmla="*/ 2999691 w 4496119"/>
                <a:gd name="connsiteY8" fmla="*/ 572682 h 2769660"/>
                <a:gd name="connsiteX9" fmla="*/ 3166959 w 4496119"/>
                <a:gd name="connsiteY9" fmla="*/ 1107940 h 2769660"/>
                <a:gd name="connsiteX10" fmla="*/ 3918551 w 4496119"/>
                <a:gd name="connsiteY10" fmla="*/ 1426982 h 2769660"/>
                <a:gd name="connsiteX11" fmla="*/ 4112179 w 4496119"/>
                <a:gd name="connsiteY11" fmla="*/ 1623836 h 2769660"/>
                <a:gd name="connsiteX12" fmla="*/ 4496104 w 4496119"/>
                <a:gd name="connsiteY12" fmla="*/ 2238345 h 2769660"/>
                <a:gd name="connsiteX13" fmla="*/ 4148267 w 4496119"/>
                <a:gd name="connsiteY13" fmla="*/ 2000038 h 2769660"/>
                <a:gd name="connsiteX14" fmla="*/ 3278471 w 4496119"/>
                <a:gd name="connsiteY14" fmla="*/ 2111550 h 2769660"/>
                <a:gd name="connsiteX15" fmla="*/ 2754364 w 4496119"/>
                <a:gd name="connsiteY15" fmla="*/ 2390330 h 2769660"/>
                <a:gd name="connsiteX16" fmla="*/ 2386374 w 4496119"/>
                <a:gd name="connsiteY16" fmla="*/ 2613354 h 2769660"/>
                <a:gd name="connsiteX17" fmla="*/ 1588287 w 4496119"/>
                <a:gd name="connsiteY17" fmla="*/ 2764514 h 2769660"/>
                <a:gd name="connsiteX18" fmla="*/ 851900 w 4496119"/>
                <a:gd name="connsiteY18" fmla="*/ 2708522 h 2769660"/>
                <a:gd name="connsiteX19" fmla="*/ 12 w 4496119"/>
                <a:gd name="connsiteY19" fmla="*/ 2535297 h 2769660"/>
                <a:gd name="connsiteX0" fmla="*/ 12 w 4496119"/>
                <a:gd name="connsiteY0" fmla="*/ 2535297 h 2769660"/>
                <a:gd name="connsiteX1" fmla="*/ 869808 w 4496119"/>
                <a:gd name="connsiteY1" fmla="*/ 2100399 h 2769660"/>
                <a:gd name="connsiteX2" fmla="*/ 1159740 w 4496119"/>
                <a:gd name="connsiteY2" fmla="*/ 1542838 h 2769660"/>
                <a:gd name="connsiteX3" fmla="*/ 1416218 w 4496119"/>
                <a:gd name="connsiteY3" fmla="*/ 1275209 h 2769660"/>
                <a:gd name="connsiteX4" fmla="*/ 2085291 w 4496119"/>
                <a:gd name="connsiteY4" fmla="*/ 1252906 h 2769660"/>
                <a:gd name="connsiteX5" fmla="*/ 2698608 w 4496119"/>
                <a:gd name="connsiteY5" fmla="*/ 907218 h 2769660"/>
                <a:gd name="connsiteX6" fmla="*/ 2955086 w 4496119"/>
                <a:gd name="connsiteY6" fmla="*/ 349657 h 2769660"/>
                <a:gd name="connsiteX7" fmla="*/ 2988540 w 4496119"/>
                <a:gd name="connsiteY7" fmla="*/ 3969 h 2769660"/>
                <a:gd name="connsiteX8" fmla="*/ 2999691 w 4496119"/>
                <a:gd name="connsiteY8" fmla="*/ 572682 h 2769660"/>
                <a:gd name="connsiteX9" fmla="*/ 3166959 w 4496119"/>
                <a:gd name="connsiteY9" fmla="*/ 1107940 h 2769660"/>
                <a:gd name="connsiteX10" fmla="*/ 3918551 w 4496119"/>
                <a:gd name="connsiteY10" fmla="*/ 1426982 h 2769660"/>
                <a:gd name="connsiteX11" fmla="*/ 4112179 w 4496119"/>
                <a:gd name="connsiteY11" fmla="*/ 1623836 h 2769660"/>
                <a:gd name="connsiteX12" fmla="*/ 4496104 w 4496119"/>
                <a:gd name="connsiteY12" fmla="*/ 2238345 h 2769660"/>
                <a:gd name="connsiteX13" fmla="*/ 4134458 w 4496119"/>
                <a:gd name="connsiteY13" fmla="*/ 2083496 h 2769660"/>
                <a:gd name="connsiteX14" fmla="*/ 3278471 w 4496119"/>
                <a:gd name="connsiteY14" fmla="*/ 2111550 h 2769660"/>
                <a:gd name="connsiteX15" fmla="*/ 2754364 w 4496119"/>
                <a:gd name="connsiteY15" fmla="*/ 2390330 h 2769660"/>
                <a:gd name="connsiteX16" fmla="*/ 2386374 w 4496119"/>
                <a:gd name="connsiteY16" fmla="*/ 2613354 h 2769660"/>
                <a:gd name="connsiteX17" fmla="*/ 1588287 w 4496119"/>
                <a:gd name="connsiteY17" fmla="*/ 2764514 h 2769660"/>
                <a:gd name="connsiteX18" fmla="*/ 851900 w 4496119"/>
                <a:gd name="connsiteY18" fmla="*/ 2708522 h 2769660"/>
                <a:gd name="connsiteX19" fmla="*/ 12 w 4496119"/>
                <a:gd name="connsiteY19" fmla="*/ 2535297 h 2769660"/>
                <a:gd name="connsiteX0" fmla="*/ 12 w 4396092"/>
                <a:gd name="connsiteY0" fmla="*/ 2535297 h 2769660"/>
                <a:gd name="connsiteX1" fmla="*/ 869808 w 4396092"/>
                <a:gd name="connsiteY1" fmla="*/ 2100399 h 2769660"/>
                <a:gd name="connsiteX2" fmla="*/ 1159740 w 4396092"/>
                <a:gd name="connsiteY2" fmla="*/ 1542838 h 2769660"/>
                <a:gd name="connsiteX3" fmla="*/ 1416218 w 4396092"/>
                <a:gd name="connsiteY3" fmla="*/ 1275209 h 2769660"/>
                <a:gd name="connsiteX4" fmla="*/ 2085291 w 4396092"/>
                <a:gd name="connsiteY4" fmla="*/ 1252906 h 2769660"/>
                <a:gd name="connsiteX5" fmla="*/ 2698608 w 4396092"/>
                <a:gd name="connsiteY5" fmla="*/ 907218 h 2769660"/>
                <a:gd name="connsiteX6" fmla="*/ 2955086 w 4396092"/>
                <a:gd name="connsiteY6" fmla="*/ 349657 h 2769660"/>
                <a:gd name="connsiteX7" fmla="*/ 2988540 w 4396092"/>
                <a:gd name="connsiteY7" fmla="*/ 3969 h 2769660"/>
                <a:gd name="connsiteX8" fmla="*/ 2999691 w 4396092"/>
                <a:gd name="connsiteY8" fmla="*/ 572682 h 2769660"/>
                <a:gd name="connsiteX9" fmla="*/ 3166959 w 4396092"/>
                <a:gd name="connsiteY9" fmla="*/ 1107940 h 2769660"/>
                <a:gd name="connsiteX10" fmla="*/ 3918551 w 4396092"/>
                <a:gd name="connsiteY10" fmla="*/ 1426982 h 2769660"/>
                <a:gd name="connsiteX11" fmla="*/ 4112179 w 4396092"/>
                <a:gd name="connsiteY11" fmla="*/ 1623836 h 2769660"/>
                <a:gd name="connsiteX12" fmla="*/ 4396069 w 4396092"/>
                <a:gd name="connsiteY12" fmla="*/ 2377888 h 2769660"/>
                <a:gd name="connsiteX13" fmla="*/ 4134458 w 4396092"/>
                <a:gd name="connsiteY13" fmla="*/ 2083496 h 2769660"/>
                <a:gd name="connsiteX14" fmla="*/ 3278471 w 4396092"/>
                <a:gd name="connsiteY14" fmla="*/ 2111550 h 2769660"/>
                <a:gd name="connsiteX15" fmla="*/ 2754364 w 4396092"/>
                <a:gd name="connsiteY15" fmla="*/ 2390330 h 2769660"/>
                <a:gd name="connsiteX16" fmla="*/ 2386374 w 4396092"/>
                <a:gd name="connsiteY16" fmla="*/ 2613354 h 2769660"/>
                <a:gd name="connsiteX17" fmla="*/ 1588287 w 4396092"/>
                <a:gd name="connsiteY17" fmla="*/ 2764514 h 2769660"/>
                <a:gd name="connsiteX18" fmla="*/ 851900 w 4396092"/>
                <a:gd name="connsiteY18" fmla="*/ 2708522 h 2769660"/>
                <a:gd name="connsiteX19" fmla="*/ 12 w 4396092"/>
                <a:gd name="connsiteY19" fmla="*/ 2535297 h 2769660"/>
                <a:gd name="connsiteX0" fmla="*/ 12 w 4396092"/>
                <a:gd name="connsiteY0" fmla="*/ 2535297 h 2769660"/>
                <a:gd name="connsiteX1" fmla="*/ 869808 w 4396092"/>
                <a:gd name="connsiteY1" fmla="*/ 2100399 h 2769660"/>
                <a:gd name="connsiteX2" fmla="*/ 1159740 w 4396092"/>
                <a:gd name="connsiteY2" fmla="*/ 1542838 h 2769660"/>
                <a:gd name="connsiteX3" fmla="*/ 1416218 w 4396092"/>
                <a:gd name="connsiteY3" fmla="*/ 1275209 h 2769660"/>
                <a:gd name="connsiteX4" fmla="*/ 2085291 w 4396092"/>
                <a:gd name="connsiteY4" fmla="*/ 1252906 h 2769660"/>
                <a:gd name="connsiteX5" fmla="*/ 2698608 w 4396092"/>
                <a:gd name="connsiteY5" fmla="*/ 907218 h 2769660"/>
                <a:gd name="connsiteX6" fmla="*/ 2955086 w 4396092"/>
                <a:gd name="connsiteY6" fmla="*/ 349657 h 2769660"/>
                <a:gd name="connsiteX7" fmla="*/ 2988540 w 4396092"/>
                <a:gd name="connsiteY7" fmla="*/ 3969 h 2769660"/>
                <a:gd name="connsiteX8" fmla="*/ 2999691 w 4396092"/>
                <a:gd name="connsiteY8" fmla="*/ 572682 h 2769660"/>
                <a:gd name="connsiteX9" fmla="*/ 3166959 w 4396092"/>
                <a:gd name="connsiteY9" fmla="*/ 1107940 h 2769660"/>
                <a:gd name="connsiteX10" fmla="*/ 3918551 w 4396092"/>
                <a:gd name="connsiteY10" fmla="*/ 1426982 h 2769660"/>
                <a:gd name="connsiteX11" fmla="*/ 4112179 w 4396092"/>
                <a:gd name="connsiteY11" fmla="*/ 1623836 h 2769660"/>
                <a:gd name="connsiteX12" fmla="*/ 4396069 w 4396092"/>
                <a:gd name="connsiteY12" fmla="*/ 2377888 h 2769660"/>
                <a:gd name="connsiteX13" fmla="*/ 3992838 w 4396092"/>
                <a:gd name="connsiteY13" fmla="*/ 2035882 h 2769660"/>
                <a:gd name="connsiteX14" fmla="*/ 3278471 w 4396092"/>
                <a:gd name="connsiteY14" fmla="*/ 2111550 h 2769660"/>
                <a:gd name="connsiteX15" fmla="*/ 2754364 w 4396092"/>
                <a:gd name="connsiteY15" fmla="*/ 2390330 h 2769660"/>
                <a:gd name="connsiteX16" fmla="*/ 2386374 w 4396092"/>
                <a:gd name="connsiteY16" fmla="*/ 2613354 h 2769660"/>
                <a:gd name="connsiteX17" fmla="*/ 1588287 w 4396092"/>
                <a:gd name="connsiteY17" fmla="*/ 2764514 h 2769660"/>
                <a:gd name="connsiteX18" fmla="*/ 851900 w 4396092"/>
                <a:gd name="connsiteY18" fmla="*/ 2708522 h 2769660"/>
                <a:gd name="connsiteX19" fmla="*/ 12 w 4396092"/>
                <a:gd name="connsiteY19" fmla="*/ 2535297 h 2769660"/>
                <a:gd name="connsiteX0" fmla="*/ 12 w 4396092"/>
                <a:gd name="connsiteY0" fmla="*/ 2535297 h 2769660"/>
                <a:gd name="connsiteX1" fmla="*/ 869808 w 4396092"/>
                <a:gd name="connsiteY1" fmla="*/ 2100399 h 2769660"/>
                <a:gd name="connsiteX2" fmla="*/ 1159740 w 4396092"/>
                <a:gd name="connsiteY2" fmla="*/ 1542838 h 2769660"/>
                <a:gd name="connsiteX3" fmla="*/ 1416218 w 4396092"/>
                <a:gd name="connsiteY3" fmla="*/ 1275209 h 2769660"/>
                <a:gd name="connsiteX4" fmla="*/ 2085291 w 4396092"/>
                <a:gd name="connsiteY4" fmla="*/ 1252906 h 2769660"/>
                <a:gd name="connsiteX5" fmla="*/ 2698608 w 4396092"/>
                <a:gd name="connsiteY5" fmla="*/ 907218 h 2769660"/>
                <a:gd name="connsiteX6" fmla="*/ 2955086 w 4396092"/>
                <a:gd name="connsiteY6" fmla="*/ 349657 h 2769660"/>
                <a:gd name="connsiteX7" fmla="*/ 2988540 w 4396092"/>
                <a:gd name="connsiteY7" fmla="*/ 3969 h 2769660"/>
                <a:gd name="connsiteX8" fmla="*/ 2999691 w 4396092"/>
                <a:gd name="connsiteY8" fmla="*/ 572682 h 2769660"/>
                <a:gd name="connsiteX9" fmla="*/ 3166959 w 4396092"/>
                <a:gd name="connsiteY9" fmla="*/ 1107940 h 2769660"/>
                <a:gd name="connsiteX10" fmla="*/ 3918551 w 4396092"/>
                <a:gd name="connsiteY10" fmla="*/ 1426982 h 2769660"/>
                <a:gd name="connsiteX11" fmla="*/ 4112179 w 4396092"/>
                <a:gd name="connsiteY11" fmla="*/ 1623836 h 2769660"/>
                <a:gd name="connsiteX12" fmla="*/ 4396069 w 4396092"/>
                <a:gd name="connsiteY12" fmla="*/ 2377888 h 2769660"/>
                <a:gd name="connsiteX13" fmla="*/ 3827757 w 4396092"/>
                <a:gd name="connsiteY13" fmla="*/ 2050341 h 2769660"/>
                <a:gd name="connsiteX14" fmla="*/ 3278471 w 4396092"/>
                <a:gd name="connsiteY14" fmla="*/ 2111550 h 2769660"/>
                <a:gd name="connsiteX15" fmla="*/ 2754364 w 4396092"/>
                <a:gd name="connsiteY15" fmla="*/ 2390330 h 2769660"/>
                <a:gd name="connsiteX16" fmla="*/ 2386374 w 4396092"/>
                <a:gd name="connsiteY16" fmla="*/ 2613354 h 2769660"/>
                <a:gd name="connsiteX17" fmla="*/ 1588287 w 4396092"/>
                <a:gd name="connsiteY17" fmla="*/ 2764514 h 2769660"/>
                <a:gd name="connsiteX18" fmla="*/ 851900 w 4396092"/>
                <a:gd name="connsiteY18" fmla="*/ 2708522 h 2769660"/>
                <a:gd name="connsiteX19" fmla="*/ 12 w 4396092"/>
                <a:gd name="connsiteY19" fmla="*/ 2535297 h 2769660"/>
                <a:gd name="connsiteX0" fmla="*/ 12 w 4370109"/>
                <a:gd name="connsiteY0" fmla="*/ 2535297 h 2769660"/>
                <a:gd name="connsiteX1" fmla="*/ 869808 w 4370109"/>
                <a:gd name="connsiteY1" fmla="*/ 2100399 h 2769660"/>
                <a:gd name="connsiteX2" fmla="*/ 1159740 w 4370109"/>
                <a:gd name="connsiteY2" fmla="*/ 1542838 h 2769660"/>
                <a:gd name="connsiteX3" fmla="*/ 1416218 w 4370109"/>
                <a:gd name="connsiteY3" fmla="*/ 1275209 h 2769660"/>
                <a:gd name="connsiteX4" fmla="*/ 2085291 w 4370109"/>
                <a:gd name="connsiteY4" fmla="*/ 1252906 h 2769660"/>
                <a:gd name="connsiteX5" fmla="*/ 2698608 w 4370109"/>
                <a:gd name="connsiteY5" fmla="*/ 907218 h 2769660"/>
                <a:gd name="connsiteX6" fmla="*/ 2955086 w 4370109"/>
                <a:gd name="connsiteY6" fmla="*/ 349657 h 2769660"/>
                <a:gd name="connsiteX7" fmla="*/ 2988540 w 4370109"/>
                <a:gd name="connsiteY7" fmla="*/ 3969 h 2769660"/>
                <a:gd name="connsiteX8" fmla="*/ 2999691 w 4370109"/>
                <a:gd name="connsiteY8" fmla="*/ 572682 h 2769660"/>
                <a:gd name="connsiteX9" fmla="*/ 3166959 w 4370109"/>
                <a:gd name="connsiteY9" fmla="*/ 1107940 h 2769660"/>
                <a:gd name="connsiteX10" fmla="*/ 3918551 w 4370109"/>
                <a:gd name="connsiteY10" fmla="*/ 1426982 h 2769660"/>
                <a:gd name="connsiteX11" fmla="*/ 4112179 w 4370109"/>
                <a:gd name="connsiteY11" fmla="*/ 1623836 h 2769660"/>
                <a:gd name="connsiteX12" fmla="*/ 4370082 w 4370109"/>
                <a:gd name="connsiteY12" fmla="*/ 2415359 h 2769660"/>
                <a:gd name="connsiteX13" fmla="*/ 3827757 w 4370109"/>
                <a:gd name="connsiteY13" fmla="*/ 2050341 h 2769660"/>
                <a:gd name="connsiteX14" fmla="*/ 3278471 w 4370109"/>
                <a:gd name="connsiteY14" fmla="*/ 2111550 h 2769660"/>
                <a:gd name="connsiteX15" fmla="*/ 2754364 w 4370109"/>
                <a:gd name="connsiteY15" fmla="*/ 2390330 h 2769660"/>
                <a:gd name="connsiteX16" fmla="*/ 2386374 w 4370109"/>
                <a:gd name="connsiteY16" fmla="*/ 2613354 h 2769660"/>
                <a:gd name="connsiteX17" fmla="*/ 1588287 w 4370109"/>
                <a:gd name="connsiteY17" fmla="*/ 2764514 h 2769660"/>
                <a:gd name="connsiteX18" fmla="*/ 851900 w 4370109"/>
                <a:gd name="connsiteY18" fmla="*/ 2708522 h 2769660"/>
                <a:gd name="connsiteX19" fmla="*/ 12 w 4370109"/>
                <a:gd name="connsiteY19" fmla="*/ 2535297 h 2769660"/>
                <a:gd name="connsiteX0" fmla="*/ 12 w 4370109"/>
                <a:gd name="connsiteY0" fmla="*/ 2535297 h 2769660"/>
                <a:gd name="connsiteX1" fmla="*/ 869808 w 4370109"/>
                <a:gd name="connsiteY1" fmla="*/ 2100399 h 2769660"/>
                <a:gd name="connsiteX2" fmla="*/ 1159740 w 4370109"/>
                <a:gd name="connsiteY2" fmla="*/ 1542838 h 2769660"/>
                <a:gd name="connsiteX3" fmla="*/ 1416218 w 4370109"/>
                <a:gd name="connsiteY3" fmla="*/ 1275209 h 2769660"/>
                <a:gd name="connsiteX4" fmla="*/ 2085291 w 4370109"/>
                <a:gd name="connsiteY4" fmla="*/ 1252906 h 2769660"/>
                <a:gd name="connsiteX5" fmla="*/ 2698608 w 4370109"/>
                <a:gd name="connsiteY5" fmla="*/ 907218 h 2769660"/>
                <a:gd name="connsiteX6" fmla="*/ 2955086 w 4370109"/>
                <a:gd name="connsiteY6" fmla="*/ 349657 h 2769660"/>
                <a:gd name="connsiteX7" fmla="*/ 2988540 w 4370109"/>
                <a:gd name="connsiteY7" fmla="*/ 3969 h 2769660"/>
                <a:gd name="connsiteX8" fmla="*/ 2999691 w 4370109"/>
                <a:gd name="connsiteY8" fmla="*/ 572682 h 2769660"/>
                <a:gd name="connsiteX9" fmla="*/ 3166959 w 4370109"/>
                <a:gd name="connsiteY9" fmla="*/ 1107940 h 2769660"/>
                <a:gd name="connsiteX10" fmla="*/ 3918551 w 4370109"/>
                <a:gd name="connsiteY10" fmla="*/ 1426982 h 2769660"/>
                <a:gd name="connsiteX11" fmla="*/ 4112179 w 4370109"/>
                <a:gd name="connsiteY11" fmla="*/ 1623836 h 2769660"/>
                <a:gd name="connsiteX12" fmla="*/ 4370082 w 4370109"/>
                <a:gd name="connsiteY12" fmla="*/ 2415359 h 2769660"/>
                <a:gd name="connsiteX13" fmla="*/ 3620602 w 4370109"/>
                <a:gd name="connsiteY13" fmla="*/ 2066633 h 2769660"/>
                <a:gd name="connsiteX14" fmla="*/ 3278471 w 4370109"/>
                <a:gd name="connsiteY14" fmla="*/ 2111550 h 2769660"/>
                <a:gd name="connsiteX15" fmla="*/ 2754364 w 4370109"/>
                <a:gd name="connsiteY15" fmla="*/ 2390330 h 2769660"/>
                <a:gd name="connsiteX16" fmla="*/ 2386374 w 4370109"/>
                <a:gd name="connsiteY16" fmla="*/ 2613354 h 2769660"/>
                <a:gd name="connsiteX17" fmla="*/ 1588287 w 4370109"/>
                <a:gd name="connsiteY17" fmla="*/ 2764514 h 2769660"/>
                <a:gd name="connsiteX18" fmla="*/ 851900 w 4370109"/>
                <a:gd name="connsiteY18" fmla="*/ 2708522 h 2769660"/>
                <a:gd name="connsiteX19" fmla="*/ 12 w 4370109"/>
                <a:gd name="connsiteY19" fmla="*/ 2535297 h 2769660"/>
                <a:gd name="connsiteX0" fmla="*/ 12 w 4370109"/>
                <a:gd name="connsiteY0" fmla="*/ 2535297 h 2769660"/>
                <a:gd name="connsiteX1" fmla="*/ 869808 w 4370109"/>
                <a:gd name="connsiteY1" fmla="*/ 2100399 h 2769660"/>
                <a:gd name="connsiteX2" fmla="*/ 1159740 w 4370109"/>
                <a:gd name="connsiteY2" fmla="*/ 1542838 h 2769660"/>
                <a:gd name="connsiteX3" fmla="*/ 1416218 w 4370109"/>
                <a:gd name="connsiteY3" fmla="*/ 1275209 h 2769660"/>
                <a:gd name="connsiteX4" fmla="*/ 2085291 w 4370109"/>
                <a:gd name="connsiteY4" fmla="*/ 1252906 h 2769660"/>
                <a:gd name="connsiteX5" fmla="*/ 2698608 w 4370109"/>
                <a:gd name="connsiteY5" fmla="*/ 907218 h 2769660"/>
                <a:gd name="connsiteX6" fmla="*/ 2955086 w 4370109"/>
                <a:gd name="connsiteY6" fmla="*/ 349657 h 2769660"/>
                <a:gd name="connsiteX7" fmla="*/ 2988540 w 4370109"/>
                <a:gd name="connsiteY7" fmla="*/ 3969 h 2769660"/>
                <a:gd name="connsiteX8" fmla="*/ 2999691 w 4370109"/>
                <a:gd name="connsiteY8" fmla="*/ 572682 h 2769660"/>
                <a:gd name="connsiteX9" fmla="*/ 3166959 w 4370109"/>
                <a:gd name="connsiteY9" fmla="*/ 1107940 h 2769660"/>
                <a:gd name="connsiteX10" fmla="*/ 3918551 w 4370109"/>
                <a:gd name="connsiteY10" fmla="*/ 1426982 h 2769660"/>
                <a:gd name="connsiteX11" fmla="*/ 4112179 w 4370109"/>
                <a:gd name="connsiteY11" fmla="*/ 1623836 h 2769660"/>
                <a:gd name="connsiteX12" fmla="*/ 4370082 w 4370109"/>
                <a:gd name="connsiteY12" fmla="*/ 2415359 h 2769660"/>
                <a:gd name="connsiteX13" fmla="*/ 3640722 w 4370109"/>
                <a:gd name="connsiteY13" fmla="*/ 2044679 h 2769660"/>
                <a:gd name="connsiteX14" fmla="*/ 3278471 w 4370109"/>
                <a:gd name="connsiteY14" fmla="*/ 2111550 h 2769660"/>
                <a:gd name="connsiteX15" fmla="*/ 2754364 w 4370109"/>
                <a:gd name="connsiteY15" fmla="*/ 2390330 h 2769660"/>
                <a:gd name="connsiteX16" fmla="*/ 2386374 w 4370109"/>
                <a:gd name="connsiteY16" fmla="*/ 2613354 h 2769660"/>
                <a:gd name="connsiteX17" fmla="*/ 1588287 w 4370109"/>
                <a:gd name="connsiteY17" fmla="*/ 2764514 h 2769660"/>
                <a:gd name="connsiteX18" fmla="*/ 851900 w 4370109"/>
                <a:gd name="connsiteY18" fmla="*/ 2708522 h 2769660"/>
                <a:gd name="connsiteX19" fmla="*/ 12 w 4370109"/>
                <a:gd name="connsiteY19" fmla="*/ 2535297 h 2769660"/>
                <a:gd name="connsiteX0" fmla="*/ 12 w 4370109"/>
                <a:gd name="connsiteY0" fmla="*/ 2535297 h 2769660"/>
                <a:gd name="connsiteX1" fmla="*/ 869808 w 4370109"/>
                <a:gd name="connsiteY1" fmla="*/ 2100399 h 2769660"/>
                <a:gd name="connsiteX2" fmla="*/ 1159740 w 4370109"/>
                <a:gd name="connsiteY2" fmla="*/ 1542838 h 2769660"/>
                <a:gd name="connsiteX3" fmla="*/ 1416218 w 4370109"/>
                <a:gd name="connsiteY3" fmla="*/ 1275209 h 2769660"/>
                <a:gd name="connsiteX4" fmla="*/ 2085291 w 4370109"/>
                <a:gd name="connsiteY4" fmla="*/ 1252906 h 2769660"/>
                <a:gd name="connsiteX5" fmla="*/ 2698608 w 4370109"/>
                <a:gd name="connsiteY5" fmla="*/ 907218 h 2769660"/>
                <a:gd name="connsiteX6" fmla="*/ 2955086 w 4370109"/>
                <a:gd name="connsiteY6" fmla="*/ 349657 h 2769660"/>
                <a:gd name="connsiteX7" fmla="*/ 2988540 w 4370109"/>
                <a:gd name="connsiteY7" fmla="*/ 3969 h 2769660"/>
                <a:gd name="connsiteX8" fmla="*/ 2999691 w 4370109"/>
                <a:gd name="connsiteY8" fmla="*/ 572682 h 2769660"/>
                <a:gd name="connsiteX9" fmla="*/ 3166959 w 4370109"/>
                <a:gd name="connsiteY9" fmla="*/ 1107940 h 2769660"/>
                <a:gd name="connsiteX10" fmla="*/ 3918551 w 4370109"/>
                <a:gd name="connsiteY10" fmla="*/ 1426982 h 2769660"/>
                <a:gd name="connsiteX11" fmla="*/ 4112179 w 4370109"/>
                <a:gd name="connsiteY11" fmla="*/ 1623836 h 2769660"/>
                <a:gd name="connsiteX12" fmla="*/ 4370082 w 4370109"/>
                <a:gd name="connsiteY12" fmla="*/ 2415359 h 2769660"/>
                <a:gd name="connsiteX13" fmla="*/ 3640722 w 4370109"/>
                <a:gd name="connsiteY13" fmla="*/ 2044679 h 2769660"/>
                <a:gd name="connsiteX14" fmla="*/ 3278471 w 4370109"/>
                <a:gd name="connsiteY14" fmla="*/ 2111550 h 2769660"/>
                <a:gd name="connsiteX15" fmla="*/ 2754364 w 4370109"/>
                <a:gd name="connsiteY15" fmla="*/ 2390330 h 2769660"/>
                <a:gd name="connsiteX16" fmla="*/ 2386374 w 4370109"/>
                <a:gd name="connsiteY16" fmla="*/ 2613354 h 2769660"/>
                <a:gd name="connsiteX17" fmla="*/ 1588287 w 4370109"/>
                <a:gd name="connsiteY17" fmla="*/ 2764514 h 2769660"/>
                <a:gd name="connsiteX18" fmla="*/ 851900 w 4370109"/>
                <a:gd name="connsiteY18" fmla="*/ 2708522 h 2769660"/>
                <a:gd name="connsiteX19" fmla="*/ 12 w 4370109"/>
                <a:gd name="connsiteY19" fmla="*/ 2535297 h 2769660"/>
                <a:gd name="connsiteX0" fmla="*/ 12 w 4370109"/>
                <a:gd name="connsiteY0" fmla="*/ 2535297 h 2769660"/>
                <a:gd name="connsiteX1" fmla="*/ 869808 w 4370109"/>
                <a:gd name="connsiteY1" fmla="*/ 2100399 h 2769660"/>
                <a:gd name="connsiteX2" fmla="*/ 1159740 w 4370109"/>
                <a:gd name="connsiteY2" fmla="*/ 1542838 h 2769660"/>
                <a:gd name="connsiteX3" fmla="*/ 1416218 w 4370109"/>
                <a:gd name="connsiteY3" fmla="*/ 1275209 h 2769660"/>
                <a:gd name="connsiteX4" fmla="*/ 2085291 w 4370109"/>
                <a:gd name="connsiteY4" fmla="*/ 1252906 h 2769660"/>
                <a:gd name="connsiteX5" fmla="*/ 2698608 w 4370109"/>
                <a:gd name="connsiteY5" fmla="*/ 907218 h 2769660"/>
                <a:gd name="connsiteX6" fmla="*/ 2955086 w 4370109"/>
                <a:gd name="connsiteY6" fmla="*/ 349657 h 2769660"/>
                <a:gd name="connsiteX7" fmla="*/ 2988540 w 4370109"/>
                <a:gd name="connsiteY7" fmla="*/ 3969 h 2769660"/>
                <a:gd name="connsiteX8" fmla="*/ 2999691 w 4370109"/>
                <a:gd name="connsiteY8" fmla="*/ 572682 h 2769660"/>
                <a:gd name="connsiteX9" fmla="*/ 3166959 w 4370109"/>
                <a:gd name="connsiteY9" fmla="*/ 1107940 h 2769660"/>
                <a:gd name="connsiteX10" fmla="*/ 3918551 w 4370109"/>
                <a:gd name="connsiteY10" fmla="*/ 1426982 h 2769660"/>
                <a:gd name="connsiteX11" fmla="*/ 4112179 w 4370109"/>
                <a:gd name="connsiteY11" fmla="*/ 1623836 h 2769660"/>
                <a:gd name="connsiteX12" fmla="*/ 4370082 w 4370109"/>
                <a:gd name="connsiteY12" fmla="*/ 2415359 h 2769660"/>
                <a:gd name="connsiteX13" fmla="*/ 3642331 w 4370109"/>
                <a:gd name="connsiteY13" fmla="*/ 2048243 h 2769660"/>
                <a:gd name="connsiteX14" fmla="*/ 3278471 w 4370109"/>
                <a:gd name="connsiteY14" fmla="*/ 2111550 h 2769660"/>
                <a:gd name="connsiteX15" fmla="*/ 2754364 w 4370109"/>
                <a:gd name="connsiteY15" fmla="*/ 2390330 h 2769660"/>
                <a:gd name="connsiteX16" fmla="*/ 2386374 w 4370109"/>
                <a:gd name="connsiteY16" fmla="*/ 2613354 h 2769660"/>
                <a:gd name="connsiteX17" fmla="*/ 1588287 w 4370109"/>
                <a:gd name="connsiteY17" fmla="*/ 2764514 h 2769660"/>
                <a:gd name="connsiteX18" fmla="*/ 851900 w 4370109"/>
                <a:gd name="connsiteY18" fmla="*/ 2708522 h 2769660"/>
                <a:gd name="connsiteX19" fmla="*/ 12 w 4370109"/>
                <a:gd name="connsiteY19" fmla="*/ 2535297 h 2769660"/>
                <a:gd name="connsiteX0" fmla="*/ 12 w 4370109"/>
                <a:gd name="connsiteY0" fmla="*/ 2535297 h 2769660"/>
                <a:gd name="connsiteX1" fmla="*/ 869808 w 4370109"/>
                <a:gd name="connsiteY1" fmla="*/ 2100399 h 2769660"/>
                <a:gd name="connsiteX2" fmla="*/ 1159740 w 4370109"/>
                <a:gd name="connsiteY2" fmla="*/ 1542838 h 2769660"/>
                <a:gd name="connsiteX3" fmla="*/ 1416218 w 4370109"/>
                <a:gd name="connsiteY3" fmla="*/ 1275209 h 2769660"/>
                <a:gd name="connsiteX4" fmla="*/ 2085291 w 4370109"/>
                <a:gd name="connsiteY4" fmla="*/ 1252906 h 2769660"/>
                <a:gd name="connsiteX5" fmla="*/ 2698608 w 4370109"/>
                <a:gd name="connsiteY5" fmla="*/ 907218 h 2769660"/>
                <a:gd name="connsiteX6" fmla="*/ 2955086 w 4370109"/>
                <a:gd name="connsiteY6" fmla="*/ 349657 h 2769660"/>
                <a:gd name="connsiteX7" fmla="*/ 2988540 w 4370109"/>
                <a:gd name="connsiteY7" fmla="*/ 3969 h 2769660"/>
                <a:gd name="connsiteX8" fmla="*/ 2999691 w 4370109"/>
                <a:gd name="connsiteY8" fmla="*/ 572682 h 2769660"/>
                <a:gd name="connsiteX9" fmla="*/ 3166959 w 4370109"/>
                <a:gd name="connsiteY9" fmla="*/ 1107940 h 2769660"/>
                <a:gd name="connsiteX10" fmla="*/ 3918551 w 4370109"/>
                <a:gd name="connsiteY10" fmla="*/ 1426982 h 2769660"/>
                <a:gd name="connsiteX11" fmla="*/ 4112179 w 4370109"/>
                <a:gd name="connsiteY11" fmla="*/ 1623836 h 2769660"/>
                <a:gd name="connsiteX12" fmla="*/ 4370082 w 4370109"/>
                <a:gd name="connsiteY12" fmla="*/ 2415359 h 2769660"/>
                <a:gd name="connsiteX13" fmla="*/ 3646242 w 4370109"/>
                <a:gd name="connsiteY13" fmla="*/ 2037898 h 2769660"/>
                <a:gd name="connsiteX14" fmla="*/ 3278471 w 4370109"/>
                <a:gd name="connsiteY14" fmla="*/ 2111550 h 2769660"/>
                <a:gd name="connsiteX15" fmla="*/ 2754364 w 4370109"/>
                <a:gd name="connsiteY15" fmla="*/ 2390330 h 2769660"/>
                <a:gd name="connsiteX16" fmla="*/ 2386374 w 4370109"/>
                <a:gd name="connsiteY16" fmla="*/ 2613354 h 2769660"/>
                <a:gd name="connsiteX17" fmla="*/ 1588287 w 4370109"/>
                <a:gd name="connsiteY17" fmla="*/ 2764514 h 2769660"/>
                <a:gd name="connsiteX18" fmla="*/ 851900 w 4370109"/>
                <a:gd name="connsiteY18" fmla="*/ 2708522 h 2769660"/>
                <a:gd name="connsiteX19" fmla="*/ 12 w 4370109"/>
                <a:gd name="connsiteY19" fmla="*/ 2535297 h 2769660"/>
                <a:gd name="connsiteX0" fmla="*/ 12 w 4370109"/>
                <a:gd name="connsiteY0" fmla="*/ 2535297 h 2769660"/>
                <a:gd name="connsiteX1" fmla="*/ 869808 w 4370109"/>
                <a:gd name="connsiteY1" fmla="*/ 2100399 h 2769660"/>
                <a:gd name="connsiteX2" fmla="*/ 1159740 w 4370109"/>
                <a:gd name="connsiteY2" fmla="*/ 1542838 h 2769660"/>
                <a:gd name="connsiteX3" fmla="*/ 1416218 w 4370109"/>
                <a:gd name="connsiteY3" fmla="*/ 1275209 h 2769660"/>
                <a:gd name="connsiteX4" fmla="*/ 2085291 w 4370109"/>
                <a:gd name="connsiteY4" fmla="*/ 1252906 h 2769660"/>
                <a:gd name="connsiteX5" fmla="*/ 2698608 w 4370109"/>
                <a:gd name="connsiteY5" fmla="*/ 907218 h 2769660"/>
                <a:gd name="connsiteX6" fmla="*/ 2955086 w 4370109"/>
                <a:gd name="connsiteY6" fmla="*/ 349657 h 2769660"/>
                <a:gd name="connsiteX7" fmla="*/ 2988540 w 4370109"/>
                <a:gd name="connsiteY7" fmla="*/ 3969 h 2769660"/>
                <a:gd name="connsiteX8" fmla="*/ 2999691 w 4370109"/>
                <a:gd name="connsiteY8" fmla="*/ 572682 h 2769660"/>
                <a:gd name="connsiteX9" fmla="*/ 3166959 w 4370109"/>
                <a:gd name="connsiteY9" fmla="*/ 1107940 h 2769660"/>
                <a:gd name="connsiteX10" fmla="*/ 3918551 w 4370109"/>
                <a:gd name="connsiteY10" fmla="*/ 1426982 h 2769660"/>
                <a:gd name="connsiteX11" fmla="*/ 4112179 w 4370109"/>
                <a:gd name="connsiteY11" fmla="*/ 1623836 h 2769660"/>
                <a:gd name="connsiteX12" fmla="*/ 4370082 w 4370109"/>
                <a:gd name="connsiteY12" fmla="*/ 2415359 h 2769660"/>
                <a:gd name="connsiteX13" fmla="*/ 3646242 w 4370109"/>
                <a:gd name="connsiteY13" fmla="*/ 2037898 h 2769660"/>
                <a:gd name="connsiteX14" fmla="*/ 3278471 w 4370109"/>
                <a:gd name="connsiteY14" fmla="*/ 2111550 h 2769660"/>
                <a:gd name="connsiteX15" fmla="*/ 2754364 w 4370109"/>
                <a:gd name="connsiteY15" fmla="*/ 2390330 h 2769660"/>
                <a:gd name="connsiteX16" fmla="*/ 2386374 w 4370109"/>
                <a:gd name="connsiteY16" fmla="*/ 2613354 h 2769660"/>
                <a:gd name="connsiteX17" fmla="*/ 1588287 w 4370109"/>
                <a:gd name="connsiteY17" fmla="*/ 2764514 h 2769660"/>
                <a:gd name="connsiteX18" fmla="*/ 851900 w 4370109"/>
                <a:gd name="connsiteY18" fmla="*/ 2708522 h 2769660"/>
                <a:gd name="connsiteX19" fmla="*/ 12 w 4370109"/>
                <a:gd name="connsiteY19" fmla="*/ 2535297 h 2769660"/>
                <a:gd name="connsiteX0" fmla="*/ 12 w 4370109"/>
                <a:gd name="connsiteY0" fmla="*/ 2535297 h 2769660"/>
                <a:gd name="connsiteX1" fmla="*/ 869808 w 4370109"/>
                <a:gd name="connsiteY1" fmla="*/ 2100399 h 2769660"/>
                <a:gd name="connsiteX2" fmla="*/ 1159740 w 4370109"/>
                <a:gd name="connsiteY2" fmla="*/ 1542838 h 2769660"/>
                <a:gd name="connsiteX3" fmla="*/ 1416218 w 4370109"/>
                <a:gd name="connsiteY3" fmla="*/ 1275209 h 2769660"/>
                <a:gd name="connsiteX4" fmla="*/ 2085291 w 4370109"/>
                <a:gd name="connsiteY4" fmla="*/ 1252906 h 2769660"/>
                <a:gd name="connsiteX5" fmla="*/ 2698608 w 4370109"/>
                <a:gd name="connsiteY5" fmla="*/ 907218 h 2769660"/>
                <a:gd name="connsiteX6" fmla="*/ 2955086 w 4370109"/>
                <a:gd name="connsiteY6" fmla="*/ 349657 h 2769660"/>
                <a:gd name="connsiteX7" fmla="*/ 2988540 w 4370109"/>
                <a:gd name="connsiteY7" fmla="*/ 3969 h 2769660"/>
                <a:gd name="connsiteX8" fmla="*/ 2999691 w 4370109"/>
                <a:gd name="connsiteY8" fmla="*/ 572682 h 2769660"/>
                <a:gd name="connsiteX9" fmla="*/ 3166959 w 4370109"/>
                <a:gd name="connsiteY9" fmla="*/ 1107940 h 2769660"/>
                <a:gd name="connsiteX10" fmla="*/ 3918551 w 4370109"/>
                <a:gd name="connsiteY10" fmla="*/ 1426982 h 2769660"/>
                <a:gd name="connsiteX11" fmla="*/ 4112179 w 4370109"/>
                <a:gd name="connsiteY11" fmla="*/ 1623836 h 2769660"/>
                <a:gd name="connsiteX12" fmla="*/ 4370082 w 4370109"/>
                <a:gd name="connsiteY12" fmla="*/ 2415359 h 2769660"/>
                <a:gd name="connsiteX13" fmla="*/ 3598962 w 4370109"/>
                <a:gd name="connsiteY13" fmla="*/ 2100428 h 2769660"/>
                <a:gd name="connsiteX14" fmla="*/ 3278471 w 4370109"/>
                <a:gd name="connsiteY14" fmla="*/ 2111550 h 2769660"/>
                <a:gd name="connsiteX15" fmla="*/ 2754364 w 4370109"/>
                <a:gd name="connsiteY15" fmla="*/ 2390330 h 2769660"/>
                <a:gd name="connsiteX16" fmla="*/ 2386374 w 4370109"/>
                <a:gd name="connsiteY16" fmla="*/ 2613354 h 2769660"/>
                <a:gd name="connsiteX17" fmla="*/ 1588287 w 4370109"/>
                <a:gd name="connsiteY17" fmla="*/ 2764514 h 2769660"/>
                <a:gd name="connsiteX18" fmla="*/ 851900 w 4370109"/>
                <a:gd name="connsiteY18" fmla="*/ 2708522 h 2769660"/>
                <a:gd name="connsiteX19" fmla="*/ 12 w 4370109"/>
                <a:gd name="connsiteY19" fmla="*/ 2535297 h 2769660"/>
                <a:gd name="connsiteX0" fmla="*/ 12 w 4370109"/>
                <a:gd name="connsiteY0" fmla="*/ 2535297 h 2769660"/>
                <a:gd name="connsiteX1" fmla="*/ 869808 w 4370109"/>
                <a:gd name="connsiteY1" fmla="*/ 2100399 h 2769660"/>
                <a:gd name="connsiteX2" fmla="*/ 1159740 w 4370109"/>
                <a:gd name="connsiteY2" fmla="*/ 1542838 h 2769660"/>
                <a:gd name="connsiteX3" fmla="*/ 1416218 w 4370109"/>
                <a:gd name="connsiteY3" fmla="*/ 1275209 h 2769660"/>
                <a:gd name="connsiteX4" fmla="*/ 2085291 w 4370109"/>
                <a:gd name="connsiteY4" fmla="*/ 1252906 h 2769660"/>
                <a:gd name="connsiteX5" fmla="*/ 2698608 w 4370109"/>
                <a:gd name="connsiteY5" fmla="*/ 907218 h 2769660"/>
                <a:gd name="connsiteX6" fmla="*/ 2955086 w 4370109"/>
                <a:gd name="connsiteY6" fmla="*/ 349657 h 2769660"/>
                <a:gd name="connsiteX7" fmla="*/ 2988540 w 4370109"/>
                <a:gd name="connsiteY7" fmla="*/ 3969 h 2769660"/>
                <a:gd name="connsiteX8" fmla="*/ 2999691 w 4370109"/>
                <a:gd name="connsiteY8" fmla="*/ 572682 h 2769660"/>
                <a:gd name="connsiteX9" fmla="*/ 3166959 w 4370109"/>
                <a:gd name="connsiteY9" fmla="*/ 1107940 h 2769660"/>
                <a:gd name="connsiteX10" fmla="*/ 3918551 w 4370109"/>
                <a:gd name="connsiteY10" fmla="*/ 1426982 h 2769660"/>
                <a:gd name="connsiteX11" fmla="*/ 4112179 w 4370109"/>
                <a:gd name="connsiteY11" fmla="*/ 1623836 h 2769660"/>
                <a:gd name="connsiteX12" fmla="*/ 4370082 w 4370109"/>
                <a:gd name="connsiteY12" fmla="*/ 2415359 h 2769660"/>
                <a:gd name="connsiteX13" fmla="*/ 3589022 w 4370109"/>
                <a:gd name="connsiteY13" fmla="*/ 2139236 h 2769660"/>
                <a:gd name="connsiteX14" fmla="*/ 3278471 w 4370109"/>
                <a:gd name="connsiteY14" fmla="*/ 2111550 h 2769660"/>
                <a:gd name="connsiteX15" fmla="*/ 2754364 w 4370109"/>
                <a:gd name="connsiteY15" fmla="*/ 2390330 h 2769660"/>
                <a:gd name="connsiteX16" fmla="*/ 2386374 w 4370109"/>
                <a:gd name="connsiteY16" fmla="*/ 2613354 h 2769660"/>
                <a:gd name="connsiteX17" fmla="*/ 1588287 w 4370109"/>
                <a:gd name="connsiteY17" fmla="*/ 2764514 h 2769660"/>
                <a:gd name="connsiteX18" fmla="*/ 851900 w 4370109"/>
                <a:gd name="connsiteY18" fmla="*/ 2708522 h 2769660"/>
                <a:gd name="connsiteX19" fmla="*/ 12 w 4370109"/>
                <a:gd name="connsiteY19" fmla="*/ 2535297 h 2769660"/>
                <a:gd name="connsiteX0" fmla="*/ 12 w 4370109"/>
                <a:gd name="connsiteY0" fmla="*/ 2535297 h 2769660"/>
                <a:gd name="connsiteX1" fmla="*/ 869808 w 4370109"/>
                <a:gd name="connsiteY1" fmla="*/ 2100399 h 2769660"/>
                <a:gd name="connsiteX2" fmla="*/ 1159740 w 4370109"/>
                <a:gd name="connsiteY2" fmla="*/ 1542838 h 2769660"/>
                <a:gd name="connsiteX3" fmla="*/ 1416218 w 4370109"/>
                <a:gd name="connsiteY3" fmla="*/ 1275209 h 2769660"/>
                <a:gd name="connsiteX4" fmla="*/ 2085291 w 4370109"/>
                <a:gd name="connsiteY4" fmla="*/ 1252906 h 2769660"/>
                <a:gd name="connsiteX5" fmla="*/ 2698608 w 4370109"/>
                <a:gd name="connsiteY5" fmla="*/ 907218 h 2769660"/>
                <a:gd name="connsiteX6" fmla="*/ 2955086 w 4370109"/>
                <a:gd name="connsiteY6" fmla="*/ 349657 h 2769660"/>
                <a:gd name="connsiteX7" fmla="*/ 2988540 w 4370109"/>
                <a:gd name="connsiteY7" fmla="*/ 3969 h 2769660"/>
                <a:gd name="connsiteX8" fmla="*/ 2999691 w 4370109"/>
                <a:gd name="connsiteY8" fmla="*/ 572682 h 2769660"/>
                <a:gd name="connsiteX9" fmla="*/ 3166959 w 4370109"/>
                <a:gd name="connsiteY9" fmla="*/ 1107940 h 2769660"/>
                <a:gd name="connsiteX10" fmla="*/ 3918551 w 4370109"/>
                <a:gd name="connsiteY10" fmla="*/ 1426982 h 2769660"/>
                <a:gd name="connsiteX11" fmla="*/ 4112179 w 4370109"/>
                <a:gd name="connsiteY11" fmla="*/ 1623836 h 2769660"/>
                <a:gd name="connsiteX12" fmla="*/ 4370082 w 4370109"/>
                <a:gd name="connsiteY12" fmla="*/ 2415359 h 2769660"/>
                <a:gd name="connsiteX13" fmla="*/ 3589022 w 4370109"/>
                <a:gd name="connsiteY13" fmla="*/ 2139236 h 2769660"/>
                <a:gd name="connsiteX14" fmla="*/ 3307341 w 4370109"/>
                <a:gd name="connsiteY14" fmla="*/ 2160296 h 2769660"/>
                <a:gd name="connsiteX15" fmla="*/ 2754364 w 4370109"/>
                <a:gd name="connsiteY15" fmla="*/ 2390330 h 2769660"/>
                <a:gd name="connsiteX16" fmla="*/ 2386374 w 4370109"/>
                <a:gd name="connsiteY16" fmla="*/ 2613354 h 2769660"/>
                <a:gd name="connsiteX17" fmla="*/ 1588287 w 4370109"/>
                <a:gd name="connsiteY17" fmla="*/ 2764514 h 2769660"/>
                <a:gd name="connsiteX18" fmla="*/ 851900 w 4370109"/>
                <a:gd name="connsiteY18" fmla="*/ 2708522 h 2769660"/>
                <a:gd name="connsiteX19" fmla="*/ 12 w 4370109"/>
                <a:gd name="connsiteY19" fmla="*/ 2535297 h 2769660"/>
                <a:gd name="connsiteX0" fmla="*/ 12 w 4364213"/>
                <a:gd name="connsiteY0" fmla="*/ 2535297 h 2769660"/>
                <a:gd name="connsiteX1" fmla="*/ 869808 w 4364213"/>
                <a:gd name="connsiteY1" fmla="*/ 2100399 h 2769660"/>
                <a:gd name="connsiteX2" fmla="*/ 1159740 w 4364213"/>
                <a:gd name="connsiteY2" fmla="*/ 1542838 h 2769660"/>
                <a:gd name="connsiteX3" fmla="*/ 1416218 w 4364213"/>
                <a:gd name="connsiteY3" fmla="*/ 1275209 h 2769660"/>
                <a:gd name="connsiteX4" fmla="*/ 2085291 w 4364213"/>
                <a:gd name="connsiteY4" fmla="*/ 1252906 h 2769660"/>
                <a:gd name="connsiteX5" fmla="*/ 2698608 w 4364213"/>
                <a:gd name="connsiteY5" fmla="*/ 907218 h 2769660"/>
                <a:gd name="connsiteX6" fmla="*/ 2955086 w 4364213"/>
                <a:gd name="connsiteY6" fmla="*/ 349657 h 2769660"/>
                <a:gd name="connsiteX7" fmla="*/ 2988540 w 4364213"/>
                <a:gd name="connsiteY7" fmla="*/ 3969 h 2769660"/>
                <a:gd name="connsiteX8" fmla="*/ 2999691 w 4364213"/>
                <a:gd name="connsiteY8" fmla="*/ 572682 h 2769660"/>
                <a:gd name="connsiteX9" fmla="*/ 3166959 w 4364213"/>
                <a:gd name="connsiteY9" fmla="*/ 1107940 h 2769660"/>
                <a:gd name="connsiteX10" fmla="*/ 3918551 w 4364213"/>
                <a:gd name="connsiteY10" fmla="*/ 1426982 h 2769660"/>
                <a:gd name="connsiteX11" fmla="*/ 4112179 w 4364213"/>
                <a:gd name="connsiteY11" fmla="*/ 1623836 h 2769660"/>
                <a:gd name="connsiteX12" fmla="*/ 4364185 w 4364213"/>
                <a:gd name="connsiteY12" fmla="*/ 2493530 h 2769660"/>
                <a:gd name="connsiteX13" fmla="*/ 3589022 w 4364213"/>
                <a:gd name="connsiteY13" fmla="*/ 2139236 h 2769660"/>
                <a:gd name="connsiteX14" fmla="*/ 3307341 w 4364213"/>
                <a:gd name="connsiteY14" fmla="*/ 2160296 h 2769660"/>
                <a:gd name="connsiteX15" fmla="*/ 2754364 w 4364213"/>
                <a:gd name="connsiteY15" fmla="*/ 2390330 h 2769660"/>
                <a:gd name="connsiteX16" fmla="*/ 2386374 w 4364213"/>
                <a:gd name="connsiteY16" fmla="*/ 2613354 h 2769660"/>
                <a:gd name="connsiteX17" fmla="*/ 1588287 w 4364213"/>
                <a:gd name="connsiteY17" fmla="*/ 2764514 h 2769660"/>
                <a:gd name="connsiteX18" fmla="*/ 851900 w 4364213"/>
                <a:gd name="connsiteY18" fmla="*/ 2708522 h 2769660"/>
                <a:gd name="connsiteX19" fmla="*/ 12 w 4364213"/>
                <a:gd name="connsiteY19" fmla="*/ 2535297 h 2769660"/>
                <a:gd name="connsiteX0" fmla="*/ 12 w 4364213"/>
                <a:gd name="connsiteY0" fmla="*/ 2618141 h 2852504"/>
                <a:gd name="connsiteX1" fmla="*/ 869808 w 4364213"/>
                <a:gd name="connsiteY1" fmla="*/ 2183243 h 2852504"/>
                <a:gd name="connsiteX2" fmla="*/ 1159740 w 4364213"/>
                <a:gd name="connsiteY2" fmla="*/ 1625682 h 2852504"/>
                <a:gd name="connsiteX3" fmla="*/ 1416218 w 4364213"/>
                <a:gd name="connsiteY3" fmla="*/ 1358053 h 2852504"/>
                <a:gd name="connsiteX4" fmla="*/ 2085291 w 4364213"/>
                <a:gd name="connsiteY4" fmla="*/ 1335750 h 2852504"/>
                <a:gd name="connsiteX5" fmla="*/ 2698608 w 4364213"/>
                <a:gd name="connsiteY5" fmla="*/ 990062 h 2852504"/>
                <a:gd name="connsiteX6" fmla="*/ 2955086 w 4364213"/>
                <a:gd name="connsiteY6" fmla="*/ 432501 h 2852504"/>
                <a:gd name="connsiteX7" fmla="*/ 2978911 w 4364213"/>
                <a:gd name="connsiteY7" fmla="*/ 3137 h 2852504"/>
                <a:gd name="connsiteX8" fmla="*/ 2999691 w 4364213"/>
                <a:gd name="connsiteY8" fmla="*/ 655526 h 2852504"/>
                <a:gd name="connsiteX9" fmla="*/ 3166959 w 4364213"/>
                <a:gd name="connsiteY9" fmla="*/ 1190784 h 2852504"/>
                <a:gd name="connsiteX10" fmla="*/ 3918551 w 4364213"/>
                <a:gd name="connsiteY10" fmla="*/ 1509826 h 2852504"/>
                <a:gd name="connsiteX11" fmla="*/ 4112179 w 4364213"/>
                <a:gd name="connsiteY11" fmla="*/ 1706680 h 2852504"/>
                <a:gd name="connsiteX12" fmla="*/ 4364185 w 4364213"/>
                <a:gd name="connsiteY12" fmla="*/ 2576374 h 2852504"/>
                <a:gd name="connsiteX13" fmla="*/ 3589022 w 4364213"/>
                <a:gd name="connsiteY13" fmla="*/ 2222080 h 2852504"/>
                <a:gd name="connsiteX14" fmla="*/ 3307341 w 4364213"/>
                <a:gd name="connsiteY14" fmla="*/ 2243140 h 2852504"/>
                <a:gd name="connsiteX15" fmla="*/ 2754364 w 4364213"/>
                <a:gd name="connsiteY15" fmla="*/ 2473174 h 2852504"/>
                <a:gd name="connsiteX16" fmla="*/ 2386374 w 4364213"/>
                <a:gd name="connsiteY16" fmla="*/ 2696198 h 2852504"/>
                <a:gd name="connsiteX17" fmla="*/ 1588287 w 4364213"/>
                <a:gd name="connsiteY17" fmla="*/ 2847358 h 2852504"/>
                <a:gd name="connsiteX18" fmla="*/ 851900 w 4364213"/>
                <a:gd name="connsiteY18" fmla="*/ 2791366 h 2852504"/>
                <a:gd name="connsiteX19" fmla="*/ 12 w 4364213"/>
                <a:gd name="connsiteY19" fmla="*/ 2618141 h 2852504"/>
                <a:gd name="connsiteX0" fmla="*/ 12 w 4364213"/>
                <a:gd name="connsiteY0" fmla="*/ 2618177 h 2852540"/>
                <a:gd name="connsiteX1" fmla="*/ 869808 w 4364213"/>
                <a:gd name="connsiteY1" fmla="*/ 2183279 h 2852540"/>
                <a:gd name="connsiteX2" fmla="*/ 1159740 w 4364213"/>
                <a:gd name="connsiteY2" fmla="*/ 1625718 h 2852540"/>
                <a:gd name="connsiteX3" fmla="*/ 1416218 w 4364213"/>
                <a:gd name="connsiteY3" fmla="*/ 1358089 h 2852540"/>
                <a:gd name="connsiteX4" fmla="*/ 2085291 w 4364213"/>
                <a:gd name="connsiteY4" fmla="*/ 1335786 h 2852540"/>
                <a:gd name="connsiteX5" fmla="*/ 2698608 w 4364213"/>
                <a:gd name="connsiteY5" fmla="*/ 990098 h 2852540"/>
                <a:gd name="connsiteX6" fmla="*/ 2913064 w 4364213"/>
                <a:gd name="connsiteY6" fmla="*/ 431524 h 2852540"/>
                <a:gd name="connsiteX7" fmla="*/ 2978911 w 4364213"/>
                <a:gd name="connsiteY7" fmla="*/ 3173 h 2852540"/>
                <a:gd name="connsiteX8" fmla="*/ 2999691 w 4364213"/>
                <a:gd name="connsiteY8" fmla="*/ 655562 h 2852540"/>
                <a:gd name="connsiteX9" fmla="*/ 3166959 w 4364213"/>
                <a:gd name="connsiteY9" fmla="*/ 1190820 h 2852540"/>
                <a:gd name="connsiteX10" fmla="*/ 3918551 w 4364213"/>
                <a:gd name="connsiteY10" fmla="*/ 1509862 h 2852540"/>
                <a:gd name="connsiteX11" fmla="*/ 4112179 w 4364213"/>
                <a:gd name="connsiteY11" fmla="*/ 1706716 h 2852540"/>
                <a:gd name="connsiteX12" fmla="*/ 4364185 w 4364213"/>
                <a:gd name="connsiteY12" fmla="*/ 2576410 h 2852540"/>
                <a:gd name="connsiteX13" fmla="*/ 3589022 w 4364213"/>
                <a:gd name="connsiteY13" fmla="*/ 2222116 h 2852540"/>
                <a:gd name="connsiteX14" fmla="*/ 3307341 w 4364213"/>
                <a:gd name="connsiteY14" fmla="*/ 2243176 h 2852540"/>
                <a:gd name="connsiteX15" fmla="*/ 2754364 w 4364213"/>
                <a:gd name="connsiteY15" fmla="*/ 2473210 h 2852540"/>
                <a:gd name="connsiteX16" fmla="*/ 2386374 w 4364213"/>
                <a:gd name="connsiteY16" fmla="*/ 2696234 h 2852540"/>
                <a:gd name="connsiteX17" fmla="*/ 1588287 w 4364213"/>
                <a:gd name="connsiteY17" fmla="*/ 2847394 h 2852540"/>
                <a:gd name="connsiteX18" fmla="*/ 851900 w 4364213"/>
                <a:gd name="connsiteY18" fmla="*/ 2791402 h 2852540"/>
                <a:gd name="connsiteX19" fmla="*/ 12 w 4364213"/>
                <a:gd name="connsiteY19" fmla="*/ 2618177 h 2852540"/>
                <a:gd name="connsiteX0" fmla="*/ 12 w 4364213"/>
                <a:gd name="connsiteY0" fmla="*/ 2617757 h 2852120"/>
                <a:gd name="connsiteX1" fmla="*/ 869808 w 4364213"/>
                <a:gd name="connsiteY1" fmla="*/ 2182859 h 2852120"/>
                <a:gd name="connsiteX2" fmla="*/ 1159740 w 4364213"/>
                <a:gd name="connsiteY2" fmla="*/ 1625298 h 2852120"/>
                <a:gd name="connsiteX3" fmla="*/ 1416218 w 4364213"/>
                <a:gd name="connsiteY3" fmla="*/ 1357669 h 2852120"/>
                <a:gd name="connsiteX4" fmla="*/ 2085291 w 4364213"/>
                <a:gd name="connsiteY4" fmla="*/ 1335366 h 2852120"/>
                <a:gd name="connsiteX5" fmla="*/ 2698608 w 4364213"/>
                <a:gd name="connsiteY5" fmla="*/ 989678 h 2852120"/>
                <a:gd name="connsiteX6" fmla="*/ 2913064 w 4364213"/>
                <a:gd name="connsiteY6" fmla="*/ 431104 h 2852120"/>
                <a:gd name="connsiteX7" fmla="*/ 2978911 w 4364213"/>
                <a:gd name="connsiteY7" fmla="*/ 2753 h 2852120"/>
                <a:gd name="connsiteX8" fmla="*/ 3020153 w 4364213"/>
                <a:gd name="connsiteY8" fmla="*/ 638168 h 2852120"/>
                <a:gd name="connsiteX9" fmla="*/ 3166959 w 4364213"/>
                <a:gd name="connsiteY9" fmla="*/ 1190400 h 2852120"/>
                <a:gd name="connsiteX10" fmla="*/ 3918551 w 4364213"/>
                <a:gd name="connsiteY10" fmla="*/ 1509442 h 2852120"/>
                <a:gd name="connsiteX11" fmla="*/ 4112179 w 4364213"/>
                <a:gd name="connsiteY11" fmla="*/ 1706296 h 2852120"/>
                <a:gd name="connsiteX12" fmla="*/ 4364185 w 4364213"/>
                <a:gd name="connsiteY12" fmla="*/ 2575990 h 2852120"/>
                <a:gd name="connsiteX13" fmla="*/ 3589022 w 4364213"/>
                <a:gd name="connsiteY13" fmla="*/ 2221696 h 2852120"/>
                <a:gd name="connsiteX14" fmla="*/ 3307341 w 4364213"/>
                <a:gd name="connsiteY14" fmla="*/ 2242756 h 2852120"/>
                <a:gd name="connsiteX15" fmla="*/ 2754364 w 4364213"/>
                <a:gd name="connsiteY15" fmla="*/ 2472790 h 2852120"/>
                <a:gd name="connsiteX16" fmla="*/ 2386374 w 4364213"/>
                <a:gd name="connsiteY16" fmla="*/ 2695814 h 2852120"/>
                <a:gd name="connsiteX17" fmla="*/ 1588287 w 4364213"/>
                <a:gd name="connsiteY17" fmla="*/ 2846974 h 2852120"/>
                <a:gd name="connsiteX18" fmla="*/ 851900 w 4364213"/>
                <a:gd name="connsiteY18" fmla="*/ 2790982 h 2852120"/>
                <a:gd name="connsiteX19" fmla="*/ 12 w 4364213"/>
                <a:gd name="connsiteY19" fmla="*/ 2617757 h 2852120"/>
                <a:gd name="connsiteX0" fmla="*/ 12 w 4364213"/>
                <a:gd name="connsiteY0" fmla="*/ 2617630 h 2851993"/>
                <a:gd name="connsiteX1" fmla="*/ 869808 w 4364213"/>
                <a:gd name="connsiteY1" fmla="*/ 2182732 h 2851993"/>
                <a:gd name="connsiteX2" fmla="*/ 1159740 w 4364213"/>
                <a:gd name="connsiteY2" fmla="*/ 1625171 h 2851993"/>
                <a:gd name="connsiteX3" fmla="*/ 1416218 w 4364213"/>
                <a:gd name="connsiteY3" fmla="*/ 1357542 h 2851993"/>
                <a:gd name="connsiteX4" fmla="*/ 2085291 w 4364213"/>
                <a:gd name="connsiteY4" fmla="*/ 1335239 h 2851993"/>
                <a:gd name="connsiteX5" fmla="*/ 2698608 w 4364213"/>
                <a:gd name="connsiteY5" fmla="*/ 989551 h 2851993"/>
                <a:gd name="connsiteX6" fmla="*/ 2861867 w 4364213"/>
                <a:gd name="connsiteY6" fmla="*/ 434920 h 2851993"/>
                <a:gd name="connsiteX7" fmla="*/ 2978911 w 4364213"/>
                <a:gd name="connsiteY7" fmla="*/ 2626 h 2851993"/>
                <a:gd name="connsiteX8" fmla="*/ 3020153 w 4364213"/>
                <a:gd name="connsiteY8" fmla="*/ 638041 h 2851993"/>
                <a:gd name="connsiteX9" fmla="*/ 3166959 w 4364213"/>
                <a:gd name="connsiteY9" fmla="*/ 1190273 h 2851993"/>
                <a:gd name="connsiteX10" fmla="*/ 3918551 w 4364213"/>
                <a:gd name="connsiteY10" fmla="*/ 1509315 h 2851993"/>
                <a:gd name="connsiteX11" fmla="*/ 4112179 w 4364213"/>
                <a:gd name="connsiteY11" fmla="*/ 1706169 h 2851993"/>
                <a:gd name="connsiteX12" fmla="*/ 4364185 w 4364213"/>
                <a:gd name="connsiteY12" fmla="*/ 2575863 h 2851993"/>
                <a:gd name="connsiteX13" fmla="*/ 3589022 w 4364213"/>
                <a:gd name="connsiteY13" fmla="*/ 2221569 h 2851993"/>
                <a:gd name="connsiteX14" fmla="*/ 3307341 w 4364213"/>
                <a:gd name="connsiteY14" fmla="*/ 2242629 h 2851993"/>
                <a:gd name="connsiteX15" fmla="*/ 2754364 w 4364213"/>
                <a:gd name="connsiteY15" fmla="*/ 2472663 h 2851993"/>
                <a:gd name="connsiteX16" fmla="*/ 2386374 w 4364213"/>
                <a:gd name="connsiteY16" fmla="*/ 2695687 h 2851993"/>
                <a:gd name="connsiteX17" fmla="*/ 1588287 w 4364213"/>
                <a:gd name="connsiteY17" fmla="*/ 2846847 h 2851993"/>
                <a:gd name="connsiteX18" fmla="*/ 851900 w 4364213"/>
                <a:gd name="connsiteY18" fmla="*/ 2790855 h 2851993"/>
                <a:gd name="connsiteX19" fmla="*/ 12 w 4364213"/>
                <a:gd name="connsiteY19" fmla="*/ 2617630 h 2851993"/>
                <a:gd name="connsiteX0" fmla="*/ 12 w 4364213"/>
                <a:gd name="connsiteY0" fmla="*/ 2617554 h 2851917"/>
                <a:gd name="connsiteX1" fmla="*/ 869808 w 4364213"/>
                <a:gd name="connsiteY1" fmla="*/ 2182656 h 2851917"/>
                <a:gd name="connsiteX2" fmla="*/ 1159740 w 4364213"/>
                <a:gd name="connsiteY2" fmla="*/ 1625095 h 2851917"/>
                <a:gd name="connsiteX3" fmla="*/ 1416218 w 4364213"/>
                <a:gd name="connsiteY3" fmla="*/ 1357466 h 2851917"/>
                <a:gd name="connsiteX4" fmla="*/ 2085291 w 4364213"/>
                <a:gd name="connsiteY4" fmla="*/ 1335163 h 2851917"/>
                <a:gd name="connsiteX5" fmla="*/ 2624386 w 4364213"/>
                <a:gd name="connsiteY5" fmla="*/ 928823 h 2851917"/>
                <a:gd name="connsiteX6" fmla="*/ 2861867 w 4364213"/>
                <a:gd name="connsiteY6" fmla="*/ 434844 h 2851917"/>
                <a:gd name="connsiteX7" fmla="*/ 2978911 w 4364213"/>
                <a:gd name="connsiteY7" fmla="*/ 2550 h 2851917"/>
                <a:gd name="connsiteX8" fmla="*/ 3020153 w 4364213"/>
                <a:gd name="connsiteY8" fmla="*/ 637965 h 2851917"/>
                <a:gd name="connsiteX9" fmla="*/ 3166959 w 4364213"/>
                <a:gd name="connsiteY9" fmla="*/ 1190197 h 2851917"/>
                <a:gd name="connsiteX10" fmla="*/ 3918551 w 4364213"/>
                <a:gd name="connsiteY10" fmla="*/ 1509239 h 2851917"/>
                <a:gd name="connsiteX11" fmla="*/ 4112179 w 4364213"/>
                <a:gd name="connsiteY11" fmla="*/ 1706093 h 2851917"/>
                <a:gd name="connsiteX12" fmla="*/ 4364185 w 4364213"/>
                <a:gd name="connsiteY12" fmla="*/ 2575787 h 2851917"/>
                <a:gd name="connsiteX13" fmla="*/ 3589022 w 4364213"/>
                <a:gd name="connsiteY13" fmla="*/ 2221493 h 2851917"/>
                <a:gd name="connsiteX14" fmla="*/ 3307341 w 4364213"/>
                <a:gd name="connsiteY14" fmla="*/ 2242553 h 2851917"/>
                <a:gd name="connsiteX15" fmla="*/ 2754364 w 4364213"/>
                <a:gd name="connsiteY15" fmla="*/ 2472587 h 2851917"/>
                <a:gd name="connsiteX16" fmla="*/ 2386374 w 4364213"/>
                <a:gd name="connsiteY16" fmla="*/ 2695611 h 2851917"/>
                <a:gd name="connsiteX17" fmla="*/ 1588287 w 4364213"/>
                <a:gd name="connsiteY17" fmla="*/ 2846771 h 2851917"/>
                <a:gd name="connsiteX18" fmla="*/ 851900 w 4364213"/>
                <a:gd name="connsiteY18" fmla="*/ 2790779 h 2851917"/>
                <a:gd name="connsiteX19" fmla="*/ 12 w 4364213"/>
                <a:gd name="connsiteY19" fmla="*/ 2617554 h 2851917"/>
                <a:gd name="connsiteX0" fmla="*/ 12 w 4364213"/>
                <a:gd name="connsiteY0" fmla="*/ 2617554 h 2851917"/>
                <a:gd name="connsiteX1" fmla="*/ 869808 w 4364213"/>
                <a:gd name="connsiteY1" fmla="*/ 2182656 h 2851917"/>
                <a:gd name="connsiteX2" fmla="*/ 1159740 w 4364213"/>
                <a:gd name="connsiteY2" fmla="*/ 1625095 h 2851917"/>
                <a:gd name="connsiteX3" fmla="*/ 1416218 w 4364213"/>
                <a:gd name="connsiteY3" fmla="*/ 1357466 h 2851917"/>
                <a:gd name="connsiteX4" fmla="*/ 2085204 w 4364213"/>
                <a:gd name="connsiteY4" fmla="*/ 1258186 h 2851917"/>
                <a:gd name="connsiteX5" fmla="*/ 2624386 w 4364213"/>
                <a:gd name="connsiteY5" fmla="*/ 928823 h 2851917"/>
                <a:gd name="connsiteX6" fmla="*/ 2861867 w 4364213"/>
                <a:gd name="connsiteY6" fmla="*/ 434844 h 2851917"/>
                <a:gd name="connsiteX7" fmla="*/ 2978911 w 4364213"/>
                <a:gd name="connsiteY7" fmla="*/ 2550 h 2851917"/>
                <a:gd name="connsiteX8" fmla="*/ 3020153 w 4364213"/>
                <a:gd name="connsiteY8" fmla="*/ 637965 h 2851917"/>
                <a:gd name="connsiteX9" fmla="*/ 3166959 w 4364213"/>
                <a:gd name="connsiteY9" fmla="*/ 1190197 h 2851917"/>
                <a:gd name="connsiteX10" fmla="*/ 3918551 w 4364213"/>
                <a:gd name="connsiteY10" fmla="*/ 1509239 h 2851917"/>
                <a:gd name="connsiteX11" fmla="*/ 4112179 w 4364213"/>
                <a:gd name="connsiteY11" fmla="*/ 1706093 h 2851917"/>
                <a:gd name="connsiteX12" fmla="*/ 4364185 w 4364213"/>
                <a:gd name="connsiteY12" fmla="*/ 2575787 h 2851917"/>
                <a:gd name="connsiteX13" fmla="*/ 3589022 w 4364213"/>
                <a:gd name="connsiteY13" fmla="*/ 2221493 h 2851917"/>
                <a:gd name="connsiteX14" fmla="*/ 3307341 w 4364213"/>
                <a:gd name="connsiteY14" fmla="*/ 2242553 h 2851917"/>
                <a:gd name="connsiteX15" fmla="*/ 2754364 w 4364213"/>
                <a:gd name="connsiteY15" fmla="*/ 2472587 h 2851917"/>
                <a:gd name="connsiteX16" fmla="*/ 2386374 w 4364213"/>
                <a:gd name="connsiteY16" fmla="*/ 2695611 h 2851917"/>
                <a:gd name="connsiteX17" fmla="*/ 1588287 w 4364213"/>
                <a:gd name="connsiteY17" fmla="*/ 2846771 h 2851917"/>
                <a:gd name="connsiteX18" fmla="*/ 851900 w 4364213"/>
                <a:gd name="connsiteY18" fmla="*/ 2790779 h 2851917"/>
                <a:gd name="connsiteX19" fmla="*/ 12 w 4364213"/>
                <a:gd name="connsiteY19" fmla="*/ 2617554 h 2851917"/>
                <a:gd name="connsiteX0" fmla="*/ 12 w 4364213"/>
                <a:gd name="connsiteY0" fmla="*/ 2617500 h 2851863"/>
                <a:gd name="connsiteX1" fmla="*/ 869808 w 4364213"/>
                <a:gd name="connsiteY1" fmla="*/ 2182602 h 2851863"/>
                <a:gd name="connsiteX2" fmla="*/ 1159740 w 4364213"/>
                <a:gd name="connsiteY2" fmla="*/ 1625041 h 2851863"/>
                <a:gd name="connsiteX3" fmla="*/ 1416218 w 4364213"/>
                <a:gd name="connsiteY3" fmla="*/ 1357412 h 2851863"/>
                <a:gd name="connsiteX4" fmla="*/ 2085204 w 4364213"/>
                <a:gd name="connsiteY4" fmla="*/ 1258132 h 2851863"/>
                <a:gd name="connsiteX5" fmla="*/ 2576310 w 4364213"/>
                <a:gd name="connsiteY5" fmla="*/ 883624 h 2851863"/>
                <a:gd name="connsiteX6" fmla="*/ 2861867 w 4364213"/>
                <a:gd name="connsiteY6" fmla="*/ 434790 h 2851863"/>
                <a:gd name="connsiteX7" fmla="*/ 2978911 w 4364213"/>
                <a:gd name="connsiteY7" fmla="*/ 2496 h 2851863"/>
                <a:gd name="connsiteX8" fmla="*/ 3020153 w 4364213"/>
                <a:gd name="connsiteY8" fmla="*/ 637911 h 2851863"/>
                <a:gd name="connsiteX9" fmla="*/ 3166959 w 4364213"/>
                <a:gd name="connsiteY9" fmla="*/ 1190143 h 2851863"/>
                <a:gd name="connsiteX10" fmla="*/ 3918551 w 4364213"/>
                <a:gd name="connsiteY10" fmla="*/ 1509185 h 2851863"/>
                <a:gd name="connsiteX11" fmla="*/ 4112179 w 4364213"/>
                <a:gd name="connsiteY11" fmla="*/ 1706039 h 2851863"/>
                <a:gd name="connsiteX12" fmla="*/ 4364185 w 4364213"/>
                <a:gd name="connsiteY12" fmla="*/ 2575733 h 2851863"/>
                <a:gd name="connsiteX13" fmla="*/ 3589022 w 4364213"/>
                <a:gd name="connsiteY13" fmla="*/ 2221439 h 2851863"/>
                <a:gd name="connsiteX14" fmla="*/ 3307341 w 4364213"/>
                <a:gd name="connsiteY14" fmla="*/ 2242499 h 2851863"/>
                <a:gd name="connsiteX15" fmla="*/ 2754364 w 4364213"/>
                <a:gd name="connsiteY15" fmla="*/ 2472533 h 2851863"/>
                <a:gd name="connsiteX16" fmla="*/ 2386374 w 4364213"/>
                <a:gd name="connsiteY16" fmla="*/ 2695557 h 2851863"/>
                <a:gd name="connsiteX17" fmla="*/ 1588287 w 4364213"/>
                <a:gd name="connsiteY17" fmla="*/ 2846717 h 2851863"/>
                <a:gd name="connsiteX18" fmla="*/ 851900 w 4364213"/>
                <a:gd name="connsiteY18" fmla="*/ 2790725 h 2851863"/>
                <a:gd name="connsiteX19" fmla="*/ 12 w 4364213"/>
                <a:gd name="connsiteY19" fmla="*/ 2617500 h 2851863"/>
                <a:gd name="connsiteX0" fmla="*/ 12 w 4364213"/>
                <a:gd name="connsiteY0" fmla="*/ 2617500 h 2851863"/>
                <a:gd name="connsiteX1" fmla="*/ 869808 w 4364213"/>
                <a:gd name="connsiteY1" fmla="*/ 2182602 h 2851863"/>
                <a:gd name="connsiteX2" fmla="*/ 1159740 w 4364213"/>
                <a:gd name="connsiteY2" fmla="*/ 1625041 h 2851863"/>
                <a:gd name="connsiteX3" fmla="*/ 1416218 w 4364213"/>
                <a:gd name="connsiteY3" fmla="*/ 1357412 h 2851863"/>
                <a:gd name="connsiteX4" fmla="*/ 2085204 w 4364213"/>
                <a:gd name="connsiteY4" fmla="*/ 1258132 h 2851863"/>
                <a:gd name="connsiteX5" fmla="*/ 2576310 w 4364213"/>
                <a:gd name="connsiteY5" fmla="*/ 883624 h 2851863"/>
                <a:gd name="connsiteX6" fmla="*/ 2861867 w 4364213"/>
                <a:gd name="connsiteY6" fmla="*/ 434790 h 2851863"/>
                <a:gd name="connsiteX7" fmla="*/ 2978911 w 4364213"/>
                <a:gd name="connsiteY7" fmla="*/ 2496 h 2851863"/>
                <a:gd name="connsiteX8" fmla="*/ 3020153 w 4364213"/>
                <a:gd name="connsiteY8" fmla="*/ 637911 h 2851863"/>
                <a:gd name="connsiteX9" fmla="*/ 3193753 w 4364213"/>
                <a:gd name="connsiteY9" fmla="*/ 1151976 h 2851863"/>
                <a:gd name="connsiteX10" fmla="*/ 3918551 w 4364213"/>
                <a:gd name="connsiteY10" fmla="*/ 1509185 h 2851863"/>
                <a:gd name="connsiteX11" fmla="*/ 4112179 w 4364213"/>
                <a:gd name="connsiteY11" fmla="*/ 1706039 h 2851863"/>
                <a:gd name="connsiteX12" fmla="*/ 4364185 w 4364213"/>
                <a:gd name="connsiteY12" fmla="*/ 2575733 h 2851863"/>
                <a:gd name="connsiteX13" fmla="*/ 3589022 w 4364213"/>
                <a:gd name="connsiteY13" fmla="*/ 2221439 h 2851863"/>
                <a:gd name="connsiteX14" fmla="*/ 3307341 w 4364213"/>
                <a:gd name="connsiteY14" fmla="*/ 2242499 h 2851863"/>
                <a:gd name="connsiteX15" fmla="*/ 2754364 w 4364213"/>
                <a:gd name="connsiteY15" fmla="*/ 2472533 h 2851863"/>
                <a:gd name="connsiteX16" fmla="*/ 2386374 w 4364213"/>
                <a:gd name="connsiteY16" fmla="*/ 2695557 h 2851863"/>
                <a:gd name="connsiteX17" fmla="*/ 1588287 w 4364213"/>
                <a:gd name="connsiteY17" fmla="*/ 2846717 h 2851863"/>
                <a:gd name="connsiteX18" fmla="*/ 851900 w 4364213"/>
                <a:gd name="connsiteY18" fmla="*/ 2790725 h 2851863"/>
                <a:gd name="connsiteX19" fmla="*/ 12 w 4364213"/>
                <a:gd name="connsiteY19" fmla="*/ 2617500 h 2851863"/>
                <a:gd name="connsiteX0" fmla="*/ 301 w 4364502"/>
                <a:gd name="connsiteY0" fmla="*/ 2617500 h 2851863"/>
                <a:gd name="connsiteX1" fmla="*/ 870097 w 4364502"/>
                <a:gd name="connsiteY1" fmla="*/ 2182602 h 2851863"/>
                <a:gd name="connsiteX2" fmla="*/ 1160029 w 4364502"/>
                <a:gd name="connsiteY2" fmla="*/ 1625041 h 2851863"/>
                <a:gd name="connsiteX3" fmla="*/ 1416507 w 4364502"/>
                <a:gd name="connsiteY3" fmla="*/ 1357412 h 2851863"/>
                <a:gd name="connsiteX4" fmla="*/ 2085493 w 4364502"/>
                <a:gd name="connsiteY4" fmla="*/ 1258132 h 2851863"/>
                <a:gd name="connsiteX5" fmla="*/ 2576599 w 4364502"/>
                <a:gd name="connsiteY5" fmla="*/ 883624 h 2851863"/>
                <a:gd name="connsiteX6" fmla="*/ 2862156 w 4364502"/>
                <a:gd name="connsiteY6" fmla="*/ 434790 h 2851863"/>
                <a:gd name="connsiteX7" fmla="*/ 2979200 w 4364502"/>
                <a:gd name="connsiteY7" fmla="*/ 2496 h 2851863"/>
                <a:gd name="connsiteX8" fmla="*/ 3020442 w 4364502"/>
                <a:gd name="connsiteY8" fmla="*/ 637911 h 2851863"/>
                <a:gd name="connsiteX9" fmla="*/ 3194042 w 4364502"/>
                <a:gd name="connsiteY9" fmla="*/ 1151976 h 2851863"/>
                <a:gd name="connsiteX10" fmla="*/ 3918840 w 4364502"/>
                <a:gd name="connsiteY10" fmla="*/ 1509185 h 2851863"/>
                <a:gd name="connsiteX11" fmla="*/ 4112468 w 4364502"/>
                <a:gd name="connsiteY11" fmla="*/ 1706039 h 2851863"/>
                <a:gd name="connsiteX12" fmla="*/ 4364474 w 4364502"/>
                <a:gd name="connsiteY12" fmla="*/ 2575733 h 2851863"/>
                <a:gd name="connsiteX13" fmla="*/ 3589311 w 4364502"/>
                <a:gd name="connsiteY13" fmla="*/ 2221439 h 2851863"/>
                <a:gd name="connsiteX14" fmla="*/ 3307630 w 4364502"/>
                <a:gd name="connsiteY14" fmla="*/ 2242499 h 2851863"/>
                <a:gd name="connsiteX15" fmla="*/ 2754653 w 4364502"/>
                <a:gd name="connsiteY15" fmla="*/ 2472533 h 2851863"/>
                <a:gd name="connsiteX16" fmla="*/ 2386663 w 4364502"/>
                <a:gd name="connsiteY16" fmla="*/ 2695557 h 2851863"/>
                <a:gd name="connsiteX17" fmla="*/ 1588576 w 4364502"/>
                <a:gd name="connsiteY17" fmla="*/ 2846717 h 2851863"/>
                <a:gd name="connsiteX18" fmla="*/ 852189 w 4364502"/>
                <a:gd name="connsiteY18" fmla="*/ 2790725 h 2851863"/>
                <a:gd name="connsiteX19" fmla="*/ 301 w 4364502"/>
                <a:gd name="connsiteY19" fmla="*/ 2617500 h 2851863"/>
                <a:gd name="connsiteX0" fmla="*/ 301 w 4364502"/>
                <a:gd name="connsiteY0" fmla="*/ 2617500 h 2851863"/>
                <a:gd name="connsiteX1" fmla="*/ 870097 w 4364502"/>
                <a:gd name="connsiteY1" fmla="*/ 2182602 h 2851863"/>
                <a:gd name="connsiteX2" fmla="*/ 1160029 w 4364502"/>
                <a:gd name="connsiteY2" fmla="*/ 1625041 h 2851863"/>
                <a:gd name="connsiteX3" fmla="*/ 1416507 w 4364502"/>
                <a:gd name="connsiteY3" fmla="*/ 1357412 h 2851863"/>
                <a:gd name="connsiteX4" fmla="*/ 2085493 w 4364502"/>
                <a:gd name="connsiteY4" fmla="*/ 1258132 h 2851863"/>
                <a:gd name="connsiteX5" fmla="*/ 2576599 w 4364502"/>
                <a:gd name="connsiteY5" fmla="*/ 883624 h 2851863"/>
                <a:gd name="connsiteX6" fmla="*/ 2862156 w 4364502"/>
                <a:gd name="connsiteY6" fmla="*/ 434790 h 2851863"/>
                <a:gd name="connsiteX7" fmla="*/ 2979200 w 4364502"/>
                <a:gd name="connsiteY7" fmla="*/ 2496 h 2851863"/>
                <a:gd name="connsiteX8" fmla="*/ 3020442 w 4364502"/>
                <a:gd name="connsiteY8" fmla="*/ 637911 h 2851863"/>
                <a:gd name="connsiteX9" fmla="*/ 3194042 w 4364502"/>
                <a:gd name="connsiteY9" fmla="*/ 1151976 h 2851863"/>
                <a:gd name="connsiteX10" fmla="*/ 3918840 w 4364502"/>
                <a:gd name="connsiteY10" fmla="*/ 1509185 h 2851863"/>
                <a:gd name="connsiteX11" fmla="*/ 4112468 w 4364502"/>
                <a:gd name="connsiteY11" fmla="*/ 1706039 h 2851863"/>
                <a:gd name="connsiteX12" fmla="*/ 4364474 w 4364502"/>
                <a:gd name="connsiteY12" fmla="*/ 2575733 h 2851863"/>
                <a:gd name="connsiteX13" fmla="*/ 3589311 w 4364502"/>
                <a:gd name="connsiteY13" fmla="*/ 2221439 h 2851863"/>
                <a:gd name="connsiteX14" fmla="*/ 3307630 w 4364502"/>
                <a:gd name="connsiteY14" fmla="*/ 2242499 h 2851863"/>
                <a:gd name="connsiteX15" fmla="*/ 2754653 w 4364502"/>
                <a:gd name="connsiteY15" fmla="*/ 2472533 h 2851863"/>
                <a:gd name="connsiteX16" fmla="*/ 2386663 w 4364502"/>
                <a:gd name="connsiteY16" fmla="*/ 2695557 h 2851863"/>
                <a:gd name="connsiteX17" fmla="*/ 1588576 w 4364502"/>
                <a:gd name="connsiteY17" fmla="*/ 2846717 h 2851863"/>
                <a:gd name="connsiteX18" fmla="*/ 852189 w 4364502"/>
                <a:gd name="connsiteY18" fmla="*/ 2790725 h 2851863"/>
                <a:gd name="connsiteX19" fmla="*/ 301 w 4364502"/>
                <a:gd name="connsiteY19" fmla="*/ 2617500 h 2851863"/>
                <a:gd name="connsiteX0" fmla="*/ 301 w 4364502"/>
                <a:gd name="connsiteY0" fmla="*/ 2617500 h 2857127"/>
                <a:gd name="connsiteX1" fmla="*/ 870097 w 4364502"/>
                <a:gd name="connsiteY1" fmla="*/ 2182602 h 2857127"/>
                <a:gd name="connsiteX2" fmla="*/ 1160029 w 4364502"/>
                <a:gd name="connsiteY2" fmla="*/ 1625041 h 2857127"/>
                <a:gd name="connsiteX3" fmla="*/ 1416507 w 4364502"/>
                <a:gd name="connsiteY3" fmla="*/ 1357412 h 2857127"/>
                <a:gd name="connsiteX4" fmla="*/ 2085493 w 4364502"/>
                <a:gd name="connsiteY4" fmla="*/ 1258132 h 2857127"/>
                <a:gd name="connsiteX5" fmla="*/ 2576599 w 4364502"/>
                <a:gd name="connsiteY5" fmla="*/ 883624 h 2857127"/>
                <a:gd name="connsiteX6" fmla="*/ 2862156 w 4364502"/>
                <a:gd name="connsiteY6" fmla="*/ 434790 h 2857127"/>
                <a:gd name="connsiteX7" fmla="*/ 2979200 w 4364502"/>
                <a:gd name="connsiteY7" fmla="*/ 2496 h 2857127"/>
                <a:gd name="connsiteX8" fmla="*/ 3020442 w 4364502"/>
                <a:gd name="connsiteY8" fmla="*/ 637911 h 2857127"/>
                <a:gd name="connsiteX9" fmla="*/ 3194042 w 4364502"/>
                <a:gd name="connsiteY9" fmla="*/ 1151976 h 2857127"/>
                <a:gd name="connsiteX10" fmla="*/ 3918840 w 4364502"/>
                <a:gd name="connsiteY10" fmla="*/ 1509185 h 2857127"/>
                <a:gd name="connsiteX11" fmla="*/ 4112468 w 4364502"/>
                <a:gd name="connsiteY11" fmla="*/ 1706039 h 2857127"/>
                <a:gd name="connsiteX12" fmla="*/ 4364474 w 4364502"/>
                <a:gd name="connsiteY12" fmla="*/ 2575733 h 2857127"/>
                <a:gd name="connsiteX13" fmla="*/ 3589311 w 4364502"/>
                <a:gd name="connsiteY13" fmla="*/ 2221439 h 2857127"/>
                <a:gd name="connsiteX14" fmla="*/ 3307630 w 4364502"/>
                <a:gd name="connsiteY14" fmla="*/ 2242499 h 2857127"/>
                <a:gd name="connsiteX15" fmla="*/ 2754653 w 4364502"/>
                <a:gd name="connsiteY15" fmla="*/ 2472533 h 2857127"/>
                <a:gd name="connsiteX16" fmla="*/ 2672008 w 4364502"/>
                <a:gd name="connsiteY16" fmla="*/ 2719246 h 2857127"/>
                <a:gd name="connsiteX17" fmla="*/ 1588576 w 4364502"/>
                <a:gd name="connsiteY17" fmla="*/ 2846717 h 2857127"/>
                <a:gd name="connsiteX18" fmla="*/ 852189 w 4364502"/>
                <a:gd name="connsiteY18" fmla="*/ 2790725 h 2857127"/>
                <a:gd name="connsiteX19" fmla="*/ 301 w 4364502"/>
                <a:gd name="connsiteY19" fmla="*/ 2617500 h 2857127"/>
                <a:gd name="connsiteX0" fmla="*/ 301 w 4364502"/>
                <a:gd name="connsiteY0" fmla="*/ 2617500 h 2847818"/>
                <a:gd name="connsiteX1" fmla="*/ 870097 w 4364502"/>
                <a:gd name="connsiteY1" fmla="*/ 2182602 h 2847818"/>
                <a:gd name="connsiteX2" fmla="*/ 1160029 w 4364502"/>
                <a:gd name="connsiteY2" fmla="*/ 1625041 h 2847818"/>
                <a:gd name="connsiteX3" fmla="*/ 1416507 w 4364502"/>
                <a:gd name="connsiteY3" fmla="*/ 1357412 h 2847818"/>
                <a:gd name="connsiteX4" fmla="*/ 2085493 w 4364502"/>
                <a:gd name="connsiteY4" fmla="*/ 1258132 h 2847818"/>
                <a:gd name="connsiteX5" fmla="*/ 2576599 w 4364502"/>
                <a:gd name="connsiteY5" fmla="*/ 883624 h 2847818"/>
                <a:gd name="connsiteX6" fmla="*/ 2862156 w 4364502"/>
                <a:gd name="connsiteY6" fmla="*/ 434790 h 2847818"/>
                <a:gd name="connsiteX7" fmla="*/ 2979200 w 4364502"/>
                <a:gd name="connsiteY7" fmla="*/ 2496 h 2847818"/>
                <a:gd name="connsiteX8" fmla="*/ 3020442 w 4364502"/>
                <a:gd name="connsiteY8" fmla="*/ 637911 h 2847818"/>
                <a:gd name="connsiteX9" fmla="*/ 3194042 w 4364502"/>
                <a:gd name="connsiteY9" fmla="*/ 1151976 h 2847818"/>
                <a:gd name="connsiteX10" fmla="*/ 3918840 w 4364502"/>
                <a:gd name="connsiteY10" fmla="*/ 1509185 h 2847818"/>
                <a:gd name="connsiteX11" fmla="*/ 4112468 w 4364502"/>
                <a:gd name="connsiteY11" fmla="*/ 1706039 h 2847818"/>
                <a:gd name="connsiteX12" fmla="*/ 4364474 w 4364502"/>
                <a:gd name="connsiteY12" fmla="*/ 2575733 h 2847818"/>
                <a:gd name="connsiteX13" fmla="*/ 3589311 w 4364502"/>
                <a:gd name="connsiteY13" fmla="*/ 2221439 h 2847818"/>
                <a:gd name="connsiteX14" fmla="*/ 3307630 w 4364502"/>
                <a:gd name="connsiteY14" fmla="*/ 2242499 h 2847818"/>
                <a:gd name="connsiteX15" fmla="*/ 3079000 w 4364502"/>
                <a:gd name="connsiteY15" fmla="*/ 2327035 h 2847818"/>
                <a:gd name="connsiteX16" fmla="*/ 2672008 w 4364502"/>
                <a:gd name="connsiteY16" fmla="*/ 2719246 h 2847818"/>
                <a:gd name="connsiteX17" fmla="*/ 1588576 w 4364502"/>
                <a:gd name="connsiteY17" fmla="*/ 2846717 h 2847818"/>
                <a:gd name="connsiteX18" fmla="*/ 852189 w 4364502"/>
                <a:gd name="connsiteY18" fmla="*/ 2790725 h 2847818"/>
                <a:gd name="connsiteX19" fmla="*/ 301 w 4364502"/>
                <a:gd name="connsiteY19" fmla="*/ 2617500 h 2847818"/>
                <a:gd name="connsiteX0" fmla="*/ 301 w 4364502"/>
                <a:gd name="connsiteY0" fmla="*/ 2617500 h 2847817"/>
                <a:gd name="connsiteX1" fmla="*/ 870097 w 4364502"/>
                <a:gd name="connsiteY1" fmla="*/ 2182602 h 2847817"/>
                <a:gd name="connsiteX2" fmla="*/ 1160029 w 4364502"/>
                <a:gd name="connsiteY2" fmla="*/ 1625041 h 2847817"/>
                <a:gd name="connsiteX3" fmla="*/ 1416507 w 4364502"/>
                <a:gd name="connsiteY3" fmla="*/ 1357412 h 2847817"/>
                <a:gd name="connsiteX4" fmla="*/ 2085493 w 4364502"/>
                <a:gd name="connsiteY4" fmla="*/ 1258132 h 2847817"/>
                <a:gd name="connsiteX5" fmla="*/ 2576599 w 4364502"/>
                <a:gd name="connsiteY5" fmla="*/ 883624 h 2847817"/>
                <a:gd name="connsiteX6" fmla="*/ 2862156 w 4364502"/>
                <a:gd name="connsiteY6" fmla="*/ 434790 h 2847817"/>
                <a:gd name="connsiteX7" fmla="*/ 2979200 w 4364502"/>
                <a:gd name="connsiteY7" fmla="*/ 2496 h 2847817"/>
                <a:gd name="connsiteX8" fmla="*/ 3020442 w 4364502"/>
                <a:gd name="connsiteY8" fmla="*/ 637911 h 2847817"/>
                <a:gd name="connsiteX9" fmla="*/ 3194042 w 4364502"/>
                <a:gd name="connsiteY9" fmla="*/ 1151976 h 2847817"/>
                <a:gd name="connsiteX10" fmla="*/ 3918840 w 4364502"/>
                <a:gd name="connsiteY10" fmla="*/ 1509185 h 2847817"/>
                <a:gd name="connsiteX11" fmla="*/ 4112468 w 4364502"/>
                <a:gd name="connsiteY11" fmla="*/ 1706039 h 2847817"/>
                <a:gd name="connsiteX12" fmla="*/ 4364474 w 4364502"/>
                <a:gd name="connsiteY12" fmla="*/ 2575733 h 2847817"/>
                <a:gd name="connsiteX13" fmla="*/ 3589311 w 4364502"/>
                <a:gd name="connsiteY13" fmla="*/ 2221439 h 2847817"/>
                <a:gd name="connsiteX14" fmla="*/ 3302677 w 4364502"/>
                <a:gd name="connsiteY14" fmla="*/ 2233324 h 2847817"/>
                <a:gd name="connsiteX15" fmla="*/ 3079000 w 4364502"/>
                <a:gd name="connsiteY15" fmla="*/ 2327035 h 2847817"/>
                <a:gd name="connsiteX16" fmla="*/ 2672008 w 4364502"/>
                <a:gd name="connsiteY16" fmla="*/ 2719246 h 2847817"/>
                <a:gd name="connsiteX17" fmla="*/ 1588576 w 4364502"/>
                <a:gd name="connsiteY17" fmla="*/ 2846717 h 2847817"/>
                <a:gd name="connsiteX18" fmla="*/ 852189 w 4364502"/>
                <a:gd name="connsiteY18" fmla="*/ 2790725 h 2847817"/>
                <a:gd name="connsiteX19" fmla="*/ 301 w 4364502"/>
                <a:gd name="connsiteY19" fmla="*/ 2617500 h 2847817"/>
                <a:gd name="connsiteX0" fmla="*/ 247 w 4547214"/>
                <a:gd name="connsiteY0" fmla="*/ 2591753 h 2847817"/>
                <a:gd name="connsiteX1" fmla="*/ 1052809 w 4547214"/>
                <a:gd name="connsiteY1" fmla="*/ 2182602 h 2847817"/>
                <a:gd name="connsiteX2" fmla="*/ 1342741 w 4547214"/>
                <a:gd name="connsiteY2" fmla="*/ 1625041 h 2847817"/>
                <a:gd name="connsiteX3" fmla="*/ 1599219 w 4547214"/>
                <a:gd name="connsiteY3" fmla="*/ 1357412 h 2847817"/>
                <a:gd name="connsiteX4" fmla="*/ 2268205 w 4547214"/>
                <a:gd name="connsiteY4" fmla="*/ 1258132 h 2847817"/>
                <a:gd name="connsiteX5" fmla="*/ 2759311 w 4547214"/>
                <a:gd name="connsiteY5" fmla="*/ 883624 h 2847817"/>
                <a:gd name="connsiteX6" fmla="*/ 3044868 w 4547214"/>
                <a:gd name="connsiteY6" fmla="*/ 434790 h 2847817"/>
                <a:gd name="connsiteX7" fmla="*/ 3161912 w 4547214"/>
                <a:gd name="connsiteY7" fmla="*/ 2496 h 2847817"/>
                <a:gd name="connsiteX8" fmla="*/ 3203154 w 4547214"/>
                <a:gd name="connsiteY8" fmla="*/ 637911 h 2847817"/>
                <a:gd name="connsiteX9" fmla="*/ 3376754 w 4547214"/>
                <a:gd name="connsiteY9" fmla="*/ 1151976 h 2847817"/>
                <a:gd name="connsiteX10" fmla="*/ 4101552 w 4547214"/>
                <a:gd name="connsiteY10" fmla="*/ 1509185 h 2847817"/>
                <a:gd name="connsiteX11" fmla="*/ 4295180 w 4547214"/>
                <a:gd name="connsiteY11" fmla="*/ 1706039 h 2847817"/>
                <a:gd name="connsiteX12" fmla="*/ 4547186 w 4547214"/>
                <a:gd name="connsiteY12" fmla="*/ 2575733 h 2847817"/>
                <a:gd name="connsiteX13" fmla="*/ 3772023 w 4547214"/>
                <a:gd name="connsiteY13" fmla="*/ 2221439 h 2847817"/>
                <a:gd name="connsiteX14" fmla="*/ 3485389 w 4547214"/>
                <a:gd name="connsiteY14" fmla="*/ 2233324 h 2847817"/>
                <a:gd name="connsiteX15" fmla="*/ 3261712 w 4547214"/>
                <a:gd name="connsiteY15" fmla="*/ 2327035 h 2847817"/>
                <a:gd name="connsiteX16" fmla="*/ 2854720 w 4547214"/>
                <a:gd name="connsiteY16" fmla="*/ 2719246 h 2847817"/>
                <a:gd name="connsiteX17" fmla="*/ 1771288 w 4547214"/>
                <a:gd name="connsiteY17" fmla="*/ 2846717 h 2847817"/>
                <a:gd name="connsiteX18" fmla="*/ 1034901 w 4547214"/>
                <a:gd name="connsiteY18" fmla="*/ 2790725 h 2847817"/>
                <a:gd name="connsiteX19" fmla="*/ 247 w 4547214"/>
                <a:gd name="connsiteY19" fmla="*/ 2591753 h 2847817"/>
                <a:gd name="connsiteX0" fmla="*/ 61 w 4547028"/>
                <a:gd name="connsiteY0" fmla="*/ 2591753 h 2847817"/>
                <a:gd name="connsiteX1" fmla="*/ 987392 w 4547028"/>
                <a:gd name="connsiteY1" fmla="*/ 2111170 h 2847817"/>
                <a:gd name="connsiteX2" fmla="*/ 1342555 w 4547028"/>
                <a:gd name="connsiteY2" fmla="*/ 1625041 h 2847817"/>
                <a:gd name="connsiteX3" fmla="*/ 1599033 w 4547028"/>
                <a:gd name="connsiteY3" fmla="*/ 1357412 h 2847817"/>
                <a:gd name="connsiteX4" fmla="*/ 2268019 w 4547028"/>
                <a:gd name="connsiteY4" fmla="*/ 1258132 h 2847817"/>
                <a:gd name="connsiteX5" fmla="*/ 2759125 w 4547028"/>
                <a:gd name="connsiteY5" fmla="*/ 883624 h 2847817"/>
                <a:gd name="connsiteX6" fmla="*/ 3044682 w 4547028"/>
                <a:gd name="connsiteY6" fmla="*/ 434790 h 2847817"/>
                <a:gd name="connsiteX7" fmla="*/ 3161726 w 4547028"/>
                <a:gd name="connsiteY7" fmla="*/ 2496 h 2847817"/>
                <a:gd name="connsiteX8" fmla="*/ 3202968 w 4547028"/>
                <a:gd name="connsiteY8" fmla="*/ 637911 h 2847817"/>
                <a:gd name="connsiteX9" fmla="*/ 3376568 w 4547028"/>
                <a:gd name="connsiteY9" fmla="*/ 1151976 h 2847817"/>
                <a:gd name="connsiteX10" fmla="*/ 4101366 w 4547028"/>
                <a:gd name="connsiteY10" fmla="*/ 1509185 h 2847817"/>
                <a:gd name="connsiteX11" fmla="*/ 4294994 w 4547028"/>
                <a:gd name="connsiteY11" fmla="*/ 1706039 h 2847817"/>
                <a:gd name="connsiteX12" fmla="*/ 4547000 w 4547028"/>
                <a:gd name="connsiteY12" fmla="*/ 2575733 h 2847817"/>
                <a:gd name="connsiteX13" fmla="*/ 3771837 w 4547028"/>
                <a:gd name="connsiteY13" fmla="*/ 2221439 h 2847817"/>
                <a:gd name="connsiteX14" fmla="*/ 3485203 w 4547028"/>
                <a:gd name="connsiteY14" fmla="*/ 2233324 h 2847817"/>
                <a:gd name="connsiteX15" fmla="*/ 3261526 w 4547028"/>
                <a:gd name="connsiteY15" fmla="*/ 2327035 h 2847817"/>
                <a:gd name="connsiteX16" fmla="*/ 2854534 w 4547028"/>
                <a:gd name="connsiteY16" fmla="*/ 2719246 h 2847817"/>
                <a:gd name="connsiteX17" fmla="*/ 1771102 w 4547028"/>
                <a:gd name="connsiteY17" fmla="*/ 2846717 h 2847817"/>
                <a:gd name="connsiteX18" fmla="*/ 1034715 w 4547028"/>
                <a:gd name="connsiteY18" fmla="*/ 2790725 h 2847817"/>
                <a:gd name="connsiteX19" fmla="*/ 61 w 4547028"/>
                <a:gd name="connsiteY19" fmla="*/ 2591753 h 2847817"/>
                <a:gd name="connsiteX0" fmla="*/ 2241 w 4549208"/>
                <a:gd name="connsiteY0" fmla="*/ 2591753 h 2847817"/>
                <a:gd name="connsiteX1" fmla="*/ 989572 w 4549208"/>
                <a:gd name="connsiteY1" fmla="*/ 2111170 h 2847817"/>
                <a:gd name="connsiteX2" fmla="*/ 1344735 w 4549208"/>
                <a:gd name="connsiteY2" fmla="*/ 1625041 h 2847817"/>
                <a:gd name="connsiteX3" fmla="*/ 1601213 w 4549208"/>
                <a:gd name="connsiteY3" fmla="*/ 1357412 h 2847817"/>
                <a:gd name="connsiteX4" fmla="*/ 2270199 w 4549208"/>
                <a:gd name="connsiteY4" fmla="*/ 1258132 h 2847817"/>
                <a:gd name="connsiteX5" fmla="*/ 2761305 w 4549208"/>
                <a:gd name="connsiteY5" fmla="*/ 883624 h 2847817"/>
                <a:gd name="connsiteX6" fmla="*/ 3046862 w 4549208"/>
                <a:gd name="connsiteY6" fmla="*/ 434790 h 2847817"/>
                <a:gd name="connsiteX7" fmla="*/ 3163906 w 4549208"/>
                <a:gd name="connsiteY7" fmla="*/ 2496 h 2847817"/>
                <a:gd name="connsiteX8" fmla="*/ 3205148 w 4549208"/>
                <a:gd name="connsiteY8" fmla="*/ 637911 h 2847817"/>
                <a:gd name="connsiteX9" fmla="*/ 3378748 w 4549208"/>
                <a:gd name="connsiteY9" fmla="*/ 1151976 h 2847817"/>
                <a:gd name="connsiteX10" fmla="*/ 4103546 w 4549208"/>
                <a:gd name="connsiteY10" fmla="*/ 1509185 h 2847817"/>
                <a:gd name="connsiteX11" fmla="*/ 4297174 w 4549208"/>
                <a:gd name="connsiteY11" fmla="*/ 1706039 h 2847817"/>
                <a:gd name="connsiteX12" fmla="*/ 4549180 w 4549208"/>
                <a:gd name="connsiteY12" fmla="*/ 2575733 h 2847817"/>
                <a:gd name="connsiteX13" fmla="*/ 3774017 w 4549208"/>
                <a:gd name="connsiteY13" fmla="*/ 2221439 h 2847817"/>
                <a:gd name="connsiteX14" fmla="*/ 3487383 w 4549208"/>
                <a:gd name="connsiteY14" fmla="*/ 2233324 h 2847817"/>
                <a:gd name="connsiteX15" fmla="*/ 3263706 w 4549208"/>
                <a:gd name="connsiteY15" fmla="*/ 2327035 h 2847817"/>
                <a:gd name="connsiteX16" fmla="*/ 2856714 w 4549208"/>
                <a:gd name="connsiteY16" fmla="*/ 2719246 h 2847817"/>
                <a:gd name="connsiteX17" fmla="*/ 1773282 w 4549208"/>
                <a:gd name="connsiteY17" fmla="*/ 2846717 h 2847817"/>
                <a:gd name="connsiteX18" fmla="*/ 1036895 w 4549208"/>
                <a:gd name="connsiteY18" fmla="*/ 2790725 h 2847817"/>
                <a:gd name="connsiteX19" fmla="*/ 2241 w 4549208"/>
                <a:gd name="connsiteY19" fmla="*/ 2591753 h 2847817"/>
                <a:gd name="connsiteX0" fmla="*/ 2217 w 4560330"/>
                <a:gd name="connsiteY0" fmla="*/ 2571107 h 2847817"/>
                <a:gd name="connsiteX1" fmla="*/ 1000694 w 4560330"/>
                <a:gd name="connsiteY1" fmla="*/ 2111170 h 2847817"/>
                <a:gd name="connsiteX2" fmla="*/ 1355857 w 4560330"/>
                <a:gd name="connsiteY2" fmla="*/ 1625041 h 2847817"/>
                <a:gd name="connsiteX3" fmla="*/ 1612335 w 4560330"/>
                <a:gd name="connsiteY3" fmla="*/ 1357412 h 2847817"/>
                <a:gd name="connsiteX4" fmla="*/ 2281321 w 4560330"/>
                <a:gd name="connsiteY4" fmla="*/ 1258132 h 2847817"/>
                <a:gd name="connsiteX5" fmla="*/ 2772427 w 4560330"/>
                <a:gd name="connsiteY5" fmla="*/ 883624 h 2847817"/>
                <a:gd name="connsiteX6" fmla="*/ 3057984 w 4560330"/>
                <a:gd name="connsiteY6" fmla="*/ 434790 h 2847817"/>
                <a:gd name="connsiteX7" fmla="*/ 3175028 w 4560330"/>
                <a:gd name="connsiteY7" fmla="*/ 2496 h 2847817"/>
                <a:gd name="connsiteX8" fmla="*/ 3216270 w 4560330"/>
                <a:gd name="connsiteY8" fmla="*/ 637911 h 2847817"/>
                <a:gd name="connsiteX9" fmla="*/ 3389870 w 4560330"/>
                <a:gd name="connsiteY9" fmla="*/ 1151976 h 2847817"/>
                <a:gd name="connsiteX10" fmla="*/ 4114668 w 4560330"/>
                <a:gd name="connsiteY10" fmla="*/ 1509185 h 2847817"/>
                <a:gd name="connsiteX11" fmla="*/ 4308296 w 4560330"/>
                <a:gd name="connsiteY11" fmla="*/ 1706039 h 2847817"/>
                <a:gd name="connsiteX12" fmla="*/ 4560302 w 4560330"/>
                <a:gd name="connsiteY12" fmla="*/ 2575733 h 2847817"/>
                <a:gd name="connsiteX13" fmla="*/ 3785139 w 4560330"/>
                <a:gd name="connsiteY13" fmla="*/ 2221439 h 2847817"/>
                <a:gd name="connsiteX14" fmla="*/ 3498505 w 4560330"/>
                <a:gd name="connsiteY14" fmla="*/ 2233324 h 2847817"/>
                <a:gd name="connsiteX15" fmla="*/ 3274828 w 4560330"/>
                <a:gd name="connsiteY15" fmla="*/ 2327035 h 2847817"/>
                <a:gd name="connsiteX16" fmla="*/ 2867836 w 4560330"/>
                <a:gd name="connsiteY16" fmla="*/ 2719246 h 2847817"/>
                <a:gd name="connsiteX17" fmla="*/ 1784404 w 4560330"/>
                <a:gd name="connsiteY17" fmla="*/ 2846717 h 2847817"/>
                <a:gd name="connsiteX18" fmla="*/ 1048017 w 4560330"/>
                <a:gd name="connsiteY18" fmla="*/ 2790725 h 2847817"/>
                <a:gd name="connsiteX19" fmla="*/ 2217 w 4560330"/>
                <a:gd name="connsiteY19" fmla="*/ 2571107 h 2847817"/>
                <a:gd name="connsiteX0" fmla="*/ 456 w 4558569"/>
                <a:gd name="connsiteY0" fmla="*/ 2571107 h 2847817"/>
                <a:gd name="connsiteX1" fmla="*/ 919940 w 4558569"/>
                <a:gd name="connsiteY1" fmla="*/ 2047172 h 2847817"/>
                <a:gd name="connsiteX2" fmla="*/ 1354096 w 4558569"/>
                <a:gd name="connsiteY2" fmla="*/ 1625041 h 2847817"/>
                <a:gd name="connsiteX3" fmla="*/ 1610574 w 4558569"/>
                <a:gd name="connsiteY3" fmla="*/ 1357412 h 2847817"/>
                <a:gd name="connsiteX4" fmla="*/ 2279560 w 4558569"/>
                <a:gd name="connsiteY4" fmla="*/ 1258132 h 2847817"/>
                <a:gd name="connsiteX5" fmla="*/ 2770666 w 4558569"/>
                <a:gd name="connsiteY5" fmla="*/ 883624 h 2847817"/>
                <a:gd name="connsiteX6" fmla="*/ 3056223 w 4558569"/>
                <a:gd name="connsiteY6" fmla="*/ 434790 h 2847817"/>
                <a:gd name="connsiteX7" fmla="*/ 3173267 w 4558569"/>
                <a:gd name="connsiteY7" fmla="*/ 2496 h 2847817"/>
                <a:gd name="connsiteX8" fmla="*/ 3214509 w 4558569"/>
                <a:gd name="connsiteY8" fmla="*/ 637911 h 2847817"/>
                <a:gd name="connsiteX9" fmla="*/ 3388109 w 4558569"/>
                <a:gd name="connsiteY9" fmla="*/ 1151976 h 2847817"/>
                <a:gd name="connsiteX10" fmla="*/ 4112907 w 4558569"/>
                <a:gd name="connsiteY10" fmla="*/ 1509185 h 2847817"/>
                <a:gd name="connsiteX11" fmla="*/ 4306535 w 4558569"/>
                <a:gd name="connsiteY11" fmla="*/ 1706039 h 2847817"/>
                <a:gd name="connsiteX12" fmla="*/ 4558541 w 4558569"/>
                <a:gd name="connsiteY12" fmla="*/ 2575733 h 2847817"/>
                <a:gd name="connsiteX13" fmla="*/ 3783378 w 4558569"/>
                <a:gd name="connsiteY13" fmla="*/ 2221439 h 2847817"/>
                <a:gd name="connsiteX14" fmla="*/ 3496744 w 4558569"/>
                <a:gd name="connsiteY14" fmla="*/ 2233324 h 2847817"/>
                <a:gd name="connsiteX15" fmla="*/ 3273067 w 4558569"/>
                <a:gd name="connsiteY15" fmla="*/ 2327035 h 2847817"/>
                <a:gd name="connsiteX16" fmla="*/ 2866075 w 4558569"/>
                <a:gd name="connsiteY16" fmla="*/ 2719246 h 2847817"/>
                <a:gd name="connsiteX17" fmla="*/ 1782643 w 4558569"/>
                <a:gd name="connsiteY17" fmla="*/ 2846717 h 2847817"/>
                <a:gd name="connsiteX18" fmla="*/ 1046256 w 4558569"/>
                <a:gd name="connsiteY18" fmla="*/ 2790725 h 2847817"/>
                <a:gd name="connsiteX19" fmla="*/ 456 w 4558569"/>
                <a:gd name="connsiteY19" fmla="*/ 2571107 h 2847817"/>
                <a:gd name="connsiteX0" fmla="*/ 450 w 4558563"/>
                <a:gd name="connsiteY0" fmla="*/ 2571107 h 2847817"/>
                <a:gd name="connsiteX1" fmla="*/ 919934 w 4558563"/>
                <a:gd name="connsiteY1" fmla="*/ 2047172 h 2847817"/>
                <a:gd name="connsiteX2" fmla="*/ 1292838 w 4558563"/>
                <a:gd name="connsiteY2" fmla="*/ 1791428 h 2847817"/>
                <a:gd name="connsiteX3" fmla="*/ 1610568 w 4558563"/>
                <a:gd name="connsiteY3" fmla="*/ 1357412 h 2847817"/>
                <a:gd name="connsiteX4" fmla="*/ 2279554 w 4558563"/>
                <a:gd name="connsiteY4" fmla="*/ 1258132 h 2847817"/>
                <a:gd name="connsiteX5" fmla="*/ 2770660 w 4558563"/>
                <a:gd name="connsiteY5" fmla="*/ 883624 h 2847817"/>
                <a:gd name="connsiteX6" fmla="*/ 3056217 w 4558563"/>
                <a:gd name="connsiteY6" fmla="*/ 434790 h 2847817"/>
                <a:gd name="connsiteX7" fmla="*/ 3173261 w 4558563"/>
                <a:gd name="connsiteY7" fmla="*/ 2496 h 2847817"/>
                <a:gd name="connsiteX8" fmla="*/ 3214503 w 4558563"/>
                <a:gd name="connsiteY8" fmla="*/ 637911 h 2847817"/>
                <a:gd name="connsiteX9" fmla="*/ 3388103 w 4558563"/>
                <a:gd name="connsiteY9" fmla="*/ 1151976 h 2847817"/>
                <a:gd name="connsiteX10" fmla="*/ 4112901 w 4558563"/>
                <a:gd name="connsiteY10" fmla="*/ 1509185 h 2847817"/>
                <a:gd name="connsiteX11" fmla="*/ 4306529 w 4558563"/>
                <a:gd name="connsiteY11" fmla="*/ 1706039 h 2847817"/>
                <a:gd name="connsiteX12" fmla="*/ 4558535 w 4558563"/>
                <a:gd name="connsiteY12" fmla="*/ 2575733 h 2847817"/>
                <a:gd name="connsiteX13" fmla="*/ 3783372 w 4558563"/>
                <a:gd name="connsiteY13" fmla="*/ 2221439 h 2847817"/>
                <a:gd name="connsiteX14" fmla="*/ 3496738 w 4558563"/>
                <a:gd name="connsiteY14" fmla="*/ 2233324 h 2847817"/>
                <a:gd name="connsiteX15" fmla="*/ 3273061 w 4558563"/>
                <a:gd name="connsiteY15" fmla="*/ 2327035 h 2847817"/>
                <a:gd name="connsiteX16" fmla="*/ 2866069 w 4558563"/>
                <a:gd name="connsiteY16" fmla="*/ 2719246 h 2847817"/>
                <a:gd name="connsiteX17" fmla="*/ 1782637 w 4558563"/>
                <a:gd name="connsiteY17" fmla="*/ 2846717 h 2847817"/>
                <a:gd name="connsiteX18" fmla="*/ 1046250 w 4558563"/>
                <a:gd name="connsiteY18" fmla="*/ 2790725 h 2847817"/>
                <a:gd name="connsiteX19" fmla="*/ 450 w 4558563"/>
                <a:gd name="connsiteY19" fmla="*/ 2571107 h 2847817"/>
                <a:gd name="connsiteX0" fmla="*/ 450 w 4558563"/>
                <a:gd name="connsiteY0" fmla="*/ 2571107 h 2847817"/>
                <a:gd name="connsiteX1" fmla="*/ 919934 w 4558563"/>
                <a:gd name="connsiteY1" fmla="*/ 2047172 h 2847817"/>
                <a:gd name="connsiteX2" fmla="*/ 1292838 w 4558563"/>
                <a:gd name="connsiteY2" fmla="*/ 1791428 h 2847817"/>
                <a:gd name="connsiteX3" fmla="*/ 1610568 w 4558563"/>
                <a:gd name="connsiteY3" fmla="*/ 1357412 h 2847817"/>
                <a:gd name="connsiteX4" fmla="*/ 2279554 w 4558563"/>
                <a:gd name="connsiteY4" fmla="*/ 1258132 h 2847817"/>
                <a:gd name="connsiteX5" fmla="*/ 2770660 w 4558563"/>
                <a:gd name="connsiteY5" fmla="*/ 883624 h 2847817"/>
                <a:gd name="connsiteX6" fmla="*/ 3056217 w 4558563"/>
                <a:gd name="connsiteY6" fmla="*/ 434790 h 2847817"/>
                <a:gd name="connsiteX7" fmla="*/ 3173261 w 4558563"/>
                <a:gd name="connsiteY7" fmla="*/ 2496 h 2847817"/>
                <a:gd name="connsiteX8" fmla="*/ 3214503 w 4558563"/>
                <a:gd name="connsiteY8" fmla="*/ 637911 h 2847817"/>
                <a:gd name="connsiteX9" fmla="*/ 3388103 w 4558563"/>
                <a:gd name="connsiteY9" fmla="*/ 1151976 h 2847817"/>
                <a:gd name="connsiteX10" fmla="*/ 4112901 w 4558563"/>
                <a:gd name="connsiteY10" fmla="*/ 1509185 h 2847817"/>
                <a:gd name="connsiteX11" fmla="*/ 4306529 w 4558563"/>
                <a:gd name="connsiteY11" fmla="*/ 1706039 h 2847817"/>
                <a:gd name="connsiteX12" fmla="*/ 4558535 w 4558563"/>
                <a:gd name="connsiteY12" fmla="*/ 2575733 h 2847817"/>
                <a:gd name="connsiteX13" fmla="*/ 3783372 w 4558563"/>
                <a:gd name="connsiteY13" fmla="*/ 2221439 h 2847817"/>
                <a:gd name="connsiteX14" fmla="*/ 3496738 w 4558563"/>
                <a:gd name="connsiteY14" fmla="*/ 2233324 h 2847817"/>
                <a:gd name="connsiteX15" fmla="*/ 3273061 w 4558563"/>
                <a:gd name="connsiteY15" fmla="*/ 2327035 h 2847817"/>
                <a:gd name="connsiteX16" fmla="*/ 2866069 w 4558563"/>
                <a:gd name="connsiteY16" fmla="*/ 2719246 h 2847817"/>
                <a:gd name="connsiteX17" fmla="*/ 1782637 w 4558563"/>
                <a:gd name="connsiteY17" fmla="*/ 2846717 h 2847817"/>
                <a:gd name="connsiteX18" fmla="*/ 1046250 w 4558563"/>
                <a:gd name="connsiteY18" fmla="*/ 2790725 h 2847817"/>
                <a:gd name="connsiteX19" fmla="*/ 450 w 4558563"/>
                <a:gd name="connsiteY19" fmla="*/ 2571107 h 2847817"/>
                <a:gd name="connsiteX0" fmla="*/ 448 w 4558561"/>
                <a:gd name="connsiteY0" fmla="*/ 2571107 h 2847817"/>
                <a:gd name="connsiteX1" fmla="*/ 919932 w 4558561"/>
                <a:gd name="connsiteY1" fmla="*/ 2047172 h 2847817"/>
                <a:gd name="connsiteX2" fmla="*/ 1277608 w 4558561"/>
                <a:gd name="connsiteY2" fmla="*/ 1752250 h 2847817"/>
                <a:gd name="connsiteX3" fmla="*/ 1610566 w 4558561"/>
                <a:gd name="connsiteY3" fmla="*/ 1357412 h 2847817"/>
                <a:gd name="connsiteX4" fmla="*/ 2279552 w 4558561"/>
                <a:gd name="connsiteY4" fmla="*/ 1258132 h 2847817"/>
                <a:gd name="connsiteX5" fmla="*/ 2770658 w 4558561"/>
                <a:gd name="connsiteY5" fmla="*/ 883624 h 2847817"/>
                <a:gd name="connsiteX6" fmla="*/ 3056215 w 4558561"/>
                <a:gd name="connsiteY6" fmla="*/ 434790 h 2847817"/>
                <a:gd name="connsiteX7" fmla="*/ 3173259 w 4558561"/>
                <a:gd name="connsiteY7" fmla="*/ 2496 h 2847817"/>
                <a:gd name="connsiteX8" fmla="*/ 3214501 w 4558561"/>
                <a:gd name="connsiteY8" fmla="*/ 637911 h 2847817"/>
                <a:gd name="connsiteX9" fmla="*/ 3388101 w 4558561"/>
                <a:gd name="connsiteY9" fmla="*/ 1151976 h 2847817"/>
                <a:gd name="connsiteX10" fmla="*/ 4112899 w 4558561"/>
                <a:gd name="connsiteY10" fmla="*/ 1509185 h 2847817"/>
                <a:gd name="connsiteX11" fmla="*/ 4306527 w 4558561"/>
                <a:gd name="connsiteY11" fmla="*/ 1706039 h 2847817"/>
                <a:gd name="connsiteX12" fmla="*/ 4558533 w 4558561"/>
                <a:gd name="connsiteY12" fmla="*/ 2575733 h 2847817"/>
                <a:gd name="connsiteX13" fmla="*/ 3783370 w 4558561"/>
                <a:gd name="connsiteY13" fmla="*/ 2221439 h 2847817"/>
                <a:gd name="connsiteX14" fmla="*/ 3496736 w 4558561"/>
                <a:gd name="connsiteY14" fmla="*/ 2233324 h 2847817"/>
                <a:gd name="connsiteX15" fmla="*/ 3273059 w 4558561"/>
                <a:gd name="connsiteY15" fmla="*/ 2327035 h 2847817"/>
                <a:gd name="connsiteX16" fmla="*/ 2866067 w 4558561"/>
                <a:gd name="connsiteY16" fmla="*/ 2719246 h 2847817"/>
                <a:gd name="connsiteX17" fmla="*/ 1782635 w 4558561"/>
                <a:gd name="connsiteY17" fmla="*/ 2846717 h 2847817"/>
                <a:gd name="connsiteX18" fmla="*/ 1046248 w 4558561"/>
                <a:gd name="connsiteY18" fmla="*/ 2790725 h 2847817"/>
                <a:gd name="connsiteX19" fmla="*/ 448 w 4558561"/>
                <a:gd name="connsiteY19" fmla="*/ 2571107 h 2847817"/>
                <a:gd name="connsiteX0" fmla="*/ 448 w 4558561"/>
                <a:gd name="connsiteY0" fmla="*/ 2571107 h 2847817"/>
                <a:gd name="connsiteX1" fmla="*/ 919932 w 4558561"/>
                <a:gd name="connsiteY1" fmla="*/ 2047172 h 2847817"/>
                <a:gd name="connsiteX2" fmla="*/ 1277608 w 4558561"/>
                <a:gd name="connsiteY2" fmla="*/ 1752250 h 2847817"/>
                <a:gd name="connsiteX3" fmla="*/ 1610566 w 4558561"/>
                <a:gd name="connsiteY3" fmla="*/ 1357412 h 2847817"/>
                <a:gd name="connsiteX4" fmla="*/ 2279552 w 4558561"/>
                <a:gd name="connsiteY4" fmla="*/ 1258132 h 2847817"/>
                <a:gd name="connsiteX5" fmla="*/ 2770658 w 4558561"/>
                <a:gd name="connsiteY5" fmla="*/ 883624 h 2847817"/>
                <a:gd name="connsiteX6" fmla="*/ 3056215 w 4558561"/>
                <a:gd name="connsiteY6" fmla="*/ 434790 h 2847817"/>
                <a:gd name="connsiteX7" fmla="*/ 3173259 w 4558561"/>
                <a:gd name="connsiteY7" fmla="*/ 2496 h 2847817"/>
                <a:gd name="connsiteX8" fmla="*/ 3214501 w 4558561"/>
                <a:gd name="connsiteY8" fmla="*/ 637911 h 2847817"/>
                <a:gd name="connsiteX9" fmla="*/ 3388101 w 4558561"/>
                <a:gd name="connsiteY9" fmla="*/ 1151976 h 2847817"/>
                <a:gd name="connsiteX10" fmla="*/ 4112899 w 4558561"/>
                <a:gd name="connsiteY10" fmla="*/ 1509185 h 2847817"/>
                <a:gd name="connsiteX11" fmla="*/ 4306527 w 4558561"/>
                <a:gd name="connsiteY11" fmla="*/ 1706039 h 2847817"/>
                <a:gd name="connsiteX12" fmla="*/ 4558533 w 4558561"/>
                <a:gd name="connsiteY12" fmla="*/ 2575733 h 2847817"/>
                <a:gd name="connsiteX13" fmla="*/ 3783370 w 4558561"/>
                <a:gd name="connsiteY13" fmla="*/ 2221439 h 2847817"/>
                <a:gd name="connsiteX14" fmla="*/ 3496736 w 4558561"/>
                <a:gd name="connsiteY14" fmla="*/ 2233324 h 2847817"/>
                <a:gd name="connsiteX15" fmla="*/ 3273059 w 4558561"/>
                <a:gd name="connsiteY15" fmla="*/ 2327035 h 2847817"/>
                <a:gd name="connsiteX16" fmla="*/ 2866067 w 4558561"/>
                <a:gd name="connsiteY16" fmla="*/ 2719246 h 2847817"/>
                <a:gd name="connsiteX17" fmla="*/ 1782635 w 4558561"/>
                <a:gd name="connsiteY17" fmla="*/ 2846717 h 2847817"/>
                <a:gd name="connsiteX18" fmla="*/ 1046248 w 4558561"/>
                <a:gd name="connsiteY18" fmla="*/ 2790725 h 2847817"/>
                <a:gd name="connsiteX19" fmla="*/ 448 w 4558561"/>
                <a:gd name="connsiteY19" fmla="*/ 2571107 h 2847817"/>
                <a:gd name="connsiteX0" fmla="*/ 448 w 4558561"/>
                <a:gd name="connsiteY0" fmla="*/ 2571107 h 2847817"/>
                <a:gd name="connsiteX1" fmla="*/ 919932 w 4558561"/>
                <a:gd name="connsiteY1" fmla="*/ 2047172 h 2847817"/>
                <a:gd name="connsiteX2" fmla="*/ 1286277 w 4558561"/>
                <a:gd name="connsiteY2" fmla="*/ 1768306 h 2847817"/>
                <a:gd name="connsiteX3" fmla="*/ 1610566 w 4558561"/>
                <a:gd name="connsiteY3" fmla="*/ 1357412 h 2847817"/>
                <a:gd name="connsiteX4" fmla="*/ 2279552 w 4558561"/>
                <a:gd name="connsiteY4" fmla="*/ 1258132 h 2847817"/>
                <a:gd name="connsiteX5" fmla="*/ 2770658 w 4558561"/>
                <a:gd name="connsiteY5" fmla="*/ 883624 h 2847817"/>
                <a:gd name="connsiteX6" fmla="*/ 3056215 w 4558561"/>
                <a:gd name="connsiteY6" fmla="*/ 434790 h 2847817"/>
                <a:gd name="connsiteX7" fmla="*/ 3173259 w 4558561"/>
                <a:gd name="connsiteY7" fmla="*/ 2496 h 2847817"/>
                <a:gd name="connsiteX8" fmla="*/ 3214501 w 4558561"/>
                <a:gd name="connsiteY8" fmla="*/ 637911 h 2847817"/>
                <a:gd name="connsiteX9" fmla="*/ 3388101 w 4558561"/>
                <a:gd name="connsiteY9" fmla="*/ 1151976 h 2847817"/>
                <a:gd name="connsiteX10" fmla="*/ 4112899 w 4558561"/>
                <a:gd name="connsiteY10" fmla="*/ 1509185 h 2847817"/>
                <a:gd name="connsiteX11" fmla="*/ 4306527 w 4558561"/>
                <a:gd name="connsiteY11" fmla="*/ 1706039 h 2847817"/>
                <a:gd name="connsiteX12" fmla="*/ 4558533 w 4558561"/>
                <a:gd name="connsiteY12" fmla="*/ 2575733 h 2847817"/>
                <a:gd name="connsiteX13" fmla="*/ 3783370 w 4558561"/>
                <a:gd name="connsiteY13" fmla="*/ 2221439 h 2847817"/>
                <a:gd name="connsiteX14" fmla="*/ 3496736 w 4558561"/>
                <a:gd name="connsiteY14" fmla="*/ 2233324 h 2847817"/>
                <a:gd name="connsiteX15" fmla="*/ 3273059 w 4558561"/>
                <a:gd name="connsiteY15" fmla="*/ 2327035 h 2847817"/>
                <a:gd name="connsiteX16" fmla="*/ 2866067 w 4558561"/>
                <a:gd name="connsiteY16" fmla="*/ 2719246 h 2847817"/>
                <a:gd name="connsiteX17" fmla="*/ 1782635 w 4558561"/>
                <a:gd name="connsiteY17" fmla="*/ 2846717 h 2847817"/>
                <a:gd name="connsiteX18" fmla="*/ 1046248 w 4558561"/>
                <a:gd name="connsiteY18" fmla="*/ 2790725 h 2847817"/>
                <a:gd name="connsiteX19" fmla="*/ 448 w 4558561"/>
                <a:gd name="connsiteY19" fmla="*/ 2571107 h 2847817"/>
                <a:gd name="connsiteX0" fmla="*/ 449 w 4558562"/>
                <a:gd name="connsiteY0" fmla="*/ 2571107 h 2847817"/>
                <a:gd name="connsiteX1" fmla="*/ 919933 w 4558562"/>
                <a:gd name="connsiteY1" fmla="*/ 2047172 h 2847817"/>
                <a:gd name="connsiteX2" fmla="*/ 1298663 w 4558562"/>
                <a:gd name="connsiteY2" fmla="*/ 1791243 h 2847817"/>
                <a:gd name="connsiteX3" fmla="*/ 1610567 w 4558562"/>
                <a:gd name="connsiteY3" fmla="*/ 1357412 h 2847817"/>
                <a:gd name="connsiteX4" fmla="*/ 2279553 w 4558562"/>
                <a:gd name="connsiteY4" fmla="*/ 1258132 h 2847817"/>
                <a:gd name="connsiteX5" fmla="*/ 2770659 w 4558562"/>
                <a:gd name="connsiteY5" fmla="*/ 883624 h 2847817"/>
                <a:gd name="connsiteX6" fmla="*/ 3056216 w 4558562"/>
                <a:gd name="connsiteY6" fmla="*/ 434790 h 2847817"/>
                <a:gd name="connsiteX7" fmla="*/ 3173260 w 4558562"/>
                <a:gd name="connsiteY7" fmla="*/ 2496 h 2847817"/>
                <a:gd name="connsiteX8" fmla="*/ 3214502 w 4558562"/>
                <a:gd name="connsiteY8" fmla="*/ 637911 h 2847817"/>
                <a:gd name="connsiteX9" fmla="*/ 3388102 w 4558562"/>
                <a:gd name="connsiteY9" fmla="*/ 1151976 h 2847817"/>
                <a:gd name="connsiteX10" fmla="*/ 4112900 w 4558562"/>
                <a:gd name="connsiteY10" fmla="*/ 1509185 h 2847817"/>
                <a:gd name="connsiteX11" fmla="*/ 4306528 w 4558562"/>
                <a:gd name="connsiteY11" fmla="*/ 1706039 h 2847817"/>
                <a:gd name="connsiteX12" fmla="*/ 4558534 w 4558562"/>
                <a:gd name="connsiteY12" fmla="*/ 2575733 h 2847817"/>
                <a:gd name="connsiteX13" fmla="*/ 3783371 w 4558562"/>
                <a:gd name="connsiteY13" fmla="*/ 2221439 h 2847817"/>
                <a:gd name="connsiteX14" fmla="*/ 3496737 w 4558562"/>
                <a:gd name="connsiteY14" fmla="*/ 2233324 h 2847817"/>
                <a:gd name="connsiteX15" fmla="*/ 3273060 w 4558562"/>
                <a:gd name="connsiteY15" fmla="*/ 2327035 h 2847817"/>
                <a:gd name="connsiteX16" fmla="*/ 2866068 w 4558562"/>
                <a:gd name="connsiteY16" fmla="*/ 2719246 h 2847817"/>
                <a:gd name="connsiteX17" fmla="*/ 1782636 w 4558562"/>
                <a:gd name="connsiteY17" fmla="*/ 2846717 h 2847817"/>
                <a:gd name="connsiteX18" fmla="*/ 1046249 w 4558562"/>
                <a:gd name="connsiteY18" fmla="*/ 2790725 h 2847817"/>
                <a:gd name="connsiteX19" fmla="*/ 449 w 4558562"/>
                <a:gd name="connsiteY19" fmla="*/ 2571107 h 2847817"/>
                <a:gd name="connsiteX0" fmla="*/ 449 w 4558562"/>
                <a:gd name="connsiteY0" fmla="*/ 2571107 h 2847817"/>
                <a:gd name="connsiteX1" fmla="*/ 919933 w 4558562"/>
                <a:gd name="connsiteY1" fmla="*/ 2047172 h 2847817"/>
                <a:gd name="connsiteX2" fmla="*/ 1298663 w 4558562"/>
                <a:gd name="connsiteY2" fmla="*/ 1791243 h 2847817"/>
                <a:gd name="connsiteX3" fmla="*/ 1610567 w 4558562"/>
                <a:gd name="connsiteY3" fmla="*/ 1357412 h 2847817"/>
                <a:gd name="connsiteX4" fmla="*/ 2279553 w 4558562"/>
                <a:gd name="connsiteY4" fmla="*/ 1258132 h 2847817"/>
                <a:gd name="connsiteX5" fmla="*/ 2770659 w 4558562"/>
                <a:gd name="connsiteY5" fmla="*/ 883624 h 2847817"/>
                <a:gd name="connsiteX6" fmla="*/ 3056216 w 4558562"/>
                <a:gd name="connsiteY6" fmla="*/ 434790 h 2847817"/>
                <a:gd name="connsiteX7" fmla="*/ 3173260 w 4558562"/>
                <a:gd name="connsiteY7" fmla="*/ 2496 h 2847817"/>
                <a:gd name="connsiteX8" fmla="*/ 3214502 w 4558562"/>
                <a:gd name="connsiteY8" fmla="*/ 637911 h 2847817"/>
                <a:gd name="connsiteX9" fmla="*/ 3388102 w 4558562"/>
                <a:gd name="connsiteY9" fmla="*/ 1151976 h 2847817"/>
                <a:gd name="connsiteX10" fmla="*/ 4112900 w 4558562"/>
                <a:gd name="connsiteY10" fmla="*/ 1509185 h 2847817"/>
                <a:gd name="connsiteX11" fmla="*/ 4306528 w 4558562"/>
                <a:gd name="connsiteY11" fmla="*/ 1706039 h 2847817"/>
                <a:gd name="connsiteX12" fmla="*/ 4558534 w 4558562"/>
                <a:gd name="connsiteY12" fmla="*/ 2575733 h 2847817"/>
                <a:gd name="connsiteX13" fmla="*/ 3783371 w 4558562"/>
                <a:gd name="connsiteY13" fmla="*/ 2221439 h 2847817"/>
                <a:gd name="connsiteX14" fmla="*/ 3496737 w 4558562"/>
                <a:gd name="connsiteY14" fmla="*/ 2233324 h 2847817"/>
                <a:gd name="connsiteX15" fmla="*/ 3273060 w 4558562"/>
                <a:gd name="connsiteY15" fmla="*/ 2327035 h 2847817"/>
                <a:gd name="connsiteX16" fmla="*/ 2866068 w 4558562"/>
                <a:gd name="connsiteY16" fmla="*/ 2719246 h 2847817"/>
                <a:gd name="connsiteX17" fmla="*/ 1782636 w 4558562"/>
                <a:gd name="connsiteY17" fmla="*/ 2846717 h 2847817"/>
                <a:gd name="connsiteX18" fmla="*/ 1046249 w 4558562"/>
                <a:gd name="connsiteY18" fmla="*/ 2790725 h 2847817"/>
                <a:gd name="connsiteX19" fmla="*/ 449 w 4558562"/>
                <a:gd name="connsiteY19" fmla="*/ 2571107 h 2847817"/>
                <a:gd name="connsiteX0" fmla="*/ 449 w 4558562"/>
                <a:gd name="connsiteY0" fmla="*/ 2571107 h 2847817"/>
                <a:gd name="connsiteX1" fmla="*/ 919933 w 4558562"/>
                <a:gd name="connsiteY1" fmla="*/ 2047172 h 2847817"/>
                <a:gd name="connsiteX2" fmla="*/ 1289855 w 4558562"/>
                <a:gd name="connsiteY2" fmla="*/ 1807850 h 2847817"/>
                <a:gd name="connsiteX3" fmla="*/ 1610567 w 4558562"/>
                <a:gd name="connsiteY3" fmla="*/ 1357412 h 2847817"/>
                <a:gd name="connsiteX4" fmla="*/ 2279553 w 4558562"/>
                <a:gd name="connsiteY4" fmla="*/ 1258132 h 2847817"/>
                <a:gd name="connsiteX5" fmla="*/ 2770659 w 4558562"/>
                <a:gd name="connsiteY5" fmla="*/ 883624 h 2847817"/>
                <a:gd name="connsiteX6" fmla="*/ 3056216 w 4558562"/>
                <a:gd name="connsiteY6" fmla="*/ 434790 h 2847817"/>
                <a:gd name="connsiteX7" fmla="*/ 3173260 w 4558562"/>
                <a:gd name="connsiteY7" fmla="*/ 2496 h 2847817"/>
                <a:gd name="connsiteX8" fmla="*/ 3214502 w 4558562"/>
                <a:gd name="connsiteY8" fmla="*/ 637911 h 2847817"/>
                <a:gd name="connsiteX9" fmla="*/ 3388102 w 4558562"/>
                <a:gd name="connsiteY9" fmla="*/ 1151976 h 2847817"/>
                <a:gd name="connsiteX10" fmla="*/ 4112900 w 4558562"/>
                <a:gd name="connsiteY10" fmla="*/ 1509185 h 2847817"/>
                <a:gd name="connsiteX11" fmla="*/ 4306528 w 4558562"/>
                <a:gd name="connsiteY11" fmla="*/ 1706039 h 2847817"/>
                <a:gd name="connsiteX12" fmla="*/ 4558534 w 4558562"/>
                <a:gd name="connsiteY12" fmla="*/ 2575733 h 2847817"/>
                <a:gd name="connsiteX13" fmla="*/ 3783371 w 4558562"/>
                <a:gd name="connsiteY13" fmla="*/ 2221439 h 2847817"/>
                <a:gd name="connsiteX14" fmla="*/ 3496737 w 4558562"/>
                <a:gd name="connsiteY14" fmla="*/ 2233324 h 2847817"/>
                <a:gd name="connsiteX15" fmla="*/ 3273060 w 4558562"/>
                <a:gd name="connsiteY15" fmla="*/ 2327035 h 2847817"/>
                <a:gd name="connsiteX16" fmla="*/ 2866068 w 4558562"/>
                <a:gd name="connsiteY16" fmla="*/ 2719246 h 2847817"/>
                <a:gd name="connsiteX17" fmla="*/ 1782636 w 4558562"/>
                <a:gd name="connsiteY17" fmla="*/ 2846717 h 2847817"/>
                <a:gd name="connsiteX18" fmla="*/ 1046249 w 4558562"/>
                <a:gd name="connsiteY18" fmla="*/ 2790725 h 2847817"/>
                <a:gd name="connsiteX19" fmla="*/ 449 w 4558562"/>
                <a:gd name="connsiteY19" fmla="*/ 2571107 h 2847817"/>
                <a:gd name="connsiteX0" fmla="*/ 449 w 4558562"/>
                <a:gd name="connsiteY0" fmla="*/ 2571107 h 2847817"/>
                <a:gd name="connsiteX1" fmla="*/ 919933 w 4558562"/>
                <a:gd name="connsiteY1" fmla="*/ 2047172 h 2847817"/>
                <a:gd name="connsiteX2" fmla="*/ 1289855 w 4558562"/>
                <a:gd name="connsiteY2" fmla="*/ 1807850 h 2847817"/>
                <a:gd name="connsiteX3" fmla="*/ 1610567 w 4558562"/>
                <a:gd name="connsiteY3" fmla="*/ 1357412 h 2847817"/>
                <a:gd name="connsiteX4" fmla="*/ 2279553 w 4558562"/>
                <a:gd name="connsiteY4" fmla="*/ 1258132 h 2847817"/>
                <a:gd name="connsiteX5" fmla="*/ 2770659 w 4558562"/>
                <a:gd name="connsiteY5" fmla="*/ 883624 h 2847817"/>
                <a:gd name="connsiteX6" fmla="*/ 3056216 w 4558562"/>
                <a:gd name="connsiteY6" fmla="*/ 434790 h 2847817"/>
                <a:gd name="connsiteX7" fmla="*/ 3173260 w 4558562"/>
                <a:gd name="connsiteY7" fmla="*/ 2496 h 2847817"/>
                <a:gd name="connsiteX8" fmla="*/ 3214502 w 4558562"/>
                <a:gd name="connsiteY8" fmla="*/ 637911 h 2847817"/>
                <a:gd name="connsiteX9" fmla="*/ 3388102 w 4558562"/>
                <a:gd name="connsiteY9" fmla="*/ 1151976 h 2847817"/>
                <a:gd name="connsiteX10" fmla="*/ 4112900 w 4558562"/>
                <a:gd name="connsiteY10" fmla="*/ 1509185 h 2847817"/>
                <a:gd name="connsiteX11" fmla="*/ 4306528 w 4558562"/>
                <a:gd name="connsiteY11" fmla="*/ 1706039 h 2847817"/>
                <a:gd name="connsiteX12" fmla="*/ 4558534 w 4558562"/>
                <a:gd name="connsiteY12" fmla="*/ 2575733 h 2847817"/>
                <a:gd name="connsiteX13" fmla="*/ 3783371 w 4558562"/>
                <a:gd name="connsiteY13" fmla="*/ 2221439 h 2847817"/>
                <a:gd name="connsiteX14" fmla="*/ 3496737 w 4558562"/>
                <a:gd name="connsiteY14" fmla="*/ 2233324 h 2847817"/>
                <a:gd name="connsiteX15" fmla="*/ 3273060 w 4558562"/>
                <a:gd name="connsiteY15" fmla="*/ 2327035 h 2847817"/>
                <a:gd name="connsiteX16" fmla="*/ 2866068 w 4558562"/>
                <a:gd name="connsiteY16" fmla="*/ 2719246 h 2847817"/>
                <a:gd name="connsiteX17" fmla="*/ 1782636 w 4558562"/>
                <a:gd name="connsiteY17" fmla="*/ 2846717 h 2847817"/>
                <a:gd name="connsiteX18" fmla="*/ 1046249 w 4558562"/>
                <a:gd name="connsiteY18" fmla="*/ 2790725 h 2847817"/>
                <a:gd name="connsiteX19" fmla="*/ 449 w 4558562"/>
                <a:gd name="connsiteY19" fmla="*/ 2571107 h 2847817"/>
                <a:gd name="connsiteX0" fmla="*/ 449 w 4558562"/>
                <a:gd name="connsiteY0" fmla="*/ 2571107 h 2847817"/>
                <a:gd name="connsiteX1" fmla="*/ 919933 w 4558562"/>
                <a:gd name="connsiteY1" fmla="*/ 2047172 h 2847817"/>
                <a:gd name="connsiteX2" fmla="*/ 1289855 w 4558562"/>
                <a:gd name="connsiteY2" fmla="*/ 1807850 h 2847817"/>
                <a:gd name="connsiteX3" fmla="*/ 1610567 w 4558562"/>
                <a:gd name="connsiteY3" fmla="*/ 1357412 h 2847817"/>
                <a:gd name="connsiteX4" fmla="*/ 2279553 w 4558562"/>
                <a:gd name="connsiteY4" fmla="*/ 1258132 h 2847817"/>
                <a:gd name="connsiteX5" fmla="*/ 2770659 w 4558562"/>
                <a:gd name="connsiteY5" fmla="*/ 883624 h 2847817"/>
                <a:gd name="connsiteX6" fmla="*/ 3056216 w 4558562"/>
                <a:gd name="connsiteY6" fmla="*/ 434790 h 2847817"/>
                <a:gd name="connsiteX7" fmla="*/ 3173260 w 4558562"/>
                <a:gd name="connsiteY7" fmla="*/ 2496 h 2847817"/>
                <a:gd name="connsiteX8" fmla="*/ 3214502 w 4558562"/>
                <a:gd name="connsiteY8" fmla="*/ 637911 h 2847817"/>
                <a:gd name="connsiteX9" fmla="*/ 3388102 w 4558562"/>
                <a:gd name="connsiteY9" fmla="*/ 1151976 h 2847817"/>
                <a:gd name="connsiteX10" fmla="*/ 4112900 w 4558562"/>
                <a:gd name="connsiteY10" fmla="*/ 1509185 h 2847817"/>
                <a:gd name="connsiteX11" fmla="*/ 4306528 w 4558562"/>
                <a:gd name="connsiteY11" fmla="*/ 1706039 h 2847817"/>
                <a:gd name="connsiteX12" fmla="*/ 4558534 w 4558562"/>
                <a:gd name="connsiteY12" fmla="*/ 2575733 h 2847817"/>
                <a:gd name="connsiteX13" fmla="*/ 3783371 w 4558562"/>
                <a:gd name="connsiteY13" fmla="*/ 2221439 h 2847817"/>
                <a:gd name="connsiteX14" fmla="*/ 3496737 w 4558562"/>
                <a:gd name="connsiteY14" fmla="*/ 2233324 h 2847817"/>
                <a:gd name="connsiteX15" fmla="*/ 3273060 w 4558562"/>
                <a:gd name="connsiteY15" fmla="*/ 2327035 h 2847817"/>
                <a:gd name="connsiteX16" fmla="*/ 2866068 w 4558562"/>
                <a:gd name="connsiteY16" fmla="*/ 2719246 h 2847817"/>
                <a:gd name="connsiteX17" fmla="*/ 1782636 w 4558562"/>
                <a:gd name="connsiteY17" fmla="*/ 2846717 h 2847817"/>
                <a:gd name="connsiteX18" fmla="*/ 1046249 w 4558562"/>
                <a:gd name="connsiteY18" fmla="*/ 2790725 h 2847817"/>
                <a:gd name="connsiteX19" fmla="*/ 449 w 4558562"/>
                <a:gd name="connsiteY19" fmla="*/ 2571107 h 2847817"/>
                <a:gd name="connsiteX0" fmla="*/ 469 w 4558582"/>
                <a:gd name="connsiteY0" fmla="*/ 2571107 h 2847817"/>
                <a:gd name="connsiteX1" fmla="*/ 919953 w 4558582"/>
                <a:gd name="connsiteY1" fmla="*/ 2047172 h 2847817"/>
                <a:gd name="connsiteX2" fmla="*/ 1289875 w 4558582"/>
                <a:gd name="connsiteY2" fmla="*/ 1807850 h 2847817"/>
                <a:gd name="connsiteX3" fmla="*/ 1610587 w 4558582"/>
                <a:gd name="connsiteY3" fmla="*/ 1357412 h 2847817"/>
                <a:gd name="connsiteX4" fmla="*/ 2279573 w 4558582"/>
                <a:gd name="connsiteY4" fmla="*/ 1258132 h 2847817"/>
                <a:gd name="connsiteX5" fmla="*/ 2770679 w 4558582"/>
                <a:gd name="connsiteY5" fmla="*/ 883624 h 2847817"/>
                <a:gd name="connsiteX6" fmla="*/ 3056236 w 4558582"/>
                <a:gd name="connsiteY6" fmla="*/ 434790 h 2847817"/>
                <a:gd name="connsiteX7" fmla="*/ 3173280 w 4558582"/>
                <a:gd name="connsiteY7" fmla="*/ 2496 h 2847817"/>
                <a:gd name="connsiteX8" fmla="*/ 3214522 w 4558582"/>
                <a:gd name="connsiteY8" fmla="*/ 637911 h 2847817"/>
                <a:gd name="connsiteX9" fmla="*/ 3388122 w 4558582"/>
                <a:gd name="connsiteY9" fmla="*/ 1151976 h 2847817"/>
                <a:gd name="connsiteX10" fmla="*/ 4112920 w 4558582"/>
                <a:gd name="connsiteY10" fmla="*/ 1509185 h 2847817"/>
                <a:gd name="connsiteX11" fmla="*/ 4306548 w 4558582"/>
                <a:gd name="connsiteY11" fmla="*/ 1706039 h 2847817"/>
                <a:gd name="connsiteX12" fmla="*/ 4558554 w 4558582"/>
                <a:gd name="connsiteY12" fmla="*/ 2575733 h 2847817"/>
                <a:gd name="connsiteX13" fmla="*/ 3783391 w 4558582"/>
                <a:gd name="connsiteY13" fmla="*/ 2221439 h 2847817"/>
                <a:gd name="connsiteX14" fmla="*/ 3496757 w 4558582"/>
                <a:gd name="connsiteY14" fmla="*/ 2233324 h 2847817"/>
                <a:gd name="connsiteX15" fmla="*/ 3273080 w 4558582"/>
                <a:gd name="connsiteY15" fmla="*/ 2327035 h 2847817"/>
                <a:gd name="connsiteX16" fmla="*/ 2866088 w 4558582"/>
                <a:gd name="connsiteY16" fmla="*/ 2719246 h 2847817"/>
                <a:gd name="connsiteX17" fmla="*/ 1782656 w 4558582"/>
                <a:gd name="connsiteY17" fmla="*/ 2846717 h 2847817"/>
                <a:gd name="connsiteX18" fmla="*/ 1046269 w 4558582"/>
                <a:gd name="connsiteY18" fmla="*/ 2790725 h 2847817"/>
                <a:gd name="connsiteX19" fmla="*/ 469 w 4558582"/>
                <a:gd name="connsiteY19" fmla="*/ 2571107 h 2847817"/>
                <a:gd name="connsiteX0" fmla="*/ 492 w 4558605"/>
                <a:gd name="connsiteY0" fmla="*/ 2571107 h 2847817"/>
                <a:gd name="connsiteX1" fmla="*/ 919976 w 4558605"/>
                <a:gd name="connsiteY1" fmla="*/ 2047172 h 2847817"/>
                <a:gd name="connsiteX2" fmla="*/ 1289898 w 4558605"/>
                <a:gd name="connsiteY2" fmla="*/ 1807850 h 2847817"/>
                <a:gd name="connsiteX3" fmla="*/ 1610610 w 4558605"/>
                <a:gd name="connsiteY3" fmla="*/ 1357412 h 2847817"/>
                <a:gd name="connsiteX4" fmla="*/ 2279596 w 4558605"/>
                <a:gd name="connsiteY4" fmla="*/ 1258132 h 2847817"/>
                <a:gd name="connsiteX5" fmla="*/ 2770702 w 4558605"/>
                <a:gd name="connsiteY5" fmla="*/ 883624 h 2847817"/>
                <a:gd name="connsiteX6" fmla="*/ 3056259 w 4558605"/>
                <a:gd name="connsiteY6" fmla="*/ 434790 h 2847817"/>
                <a:gd name="connsiteX7" fmla="*/ 3173303 w 4558605"/>
                <a:gd name="connsiteY7" fmla="*/ 2496 h 2847817"/>
                <a:gd name="connsiteX8" fmla="*/ 3214545 w 4558605"/>
                <a:gd name="connsiteY8" fmla="*/ 637911 h 2847817"/>
                <a:gd name="connsiteX9" fmla="*/ 3388145 w 4558605"/>
                <a:gd name="connsiteY9" fmla="*/ 1151976 h 2847817"/>
                <a:gd name="connsiteX10" fmla="*/ 4112943 w 4558605"/>
                <a:gd name="connsiteY10" fmla="*/ 1509185 h 2847817"/>
                <a:gd name="connsiteX11" fmla="*/ 4306571 w 4558605"/>
                <a:gd name="connsiteY11" fmla="*/ 1706039 h 2847817"/>
                <a:gd name="connsiteX12" fmla="*/ 4558577 w 4558605"/>
                <a:gd name="connsiteY12" fmla="*/ 2575733 h 2847817"/>
                <a:gd name="connsiteX13" fmla="*/ 3783414 w 4558605"/>
                <a:gd name="connsiteY13" fmla="*/ 2221439 h 2847817"/>
                <a:gd name="connsiteX14" fmla="*/ 3496780 w 4558605"/>
                <a:gd name="connsiteY14" fmla="*/ 2233324 h 2847817"/>
                <a:gd name="connsiteX15" fmla="*/ 3273103 w 4558605"/>
                <a:gd name="connsiteY15" fmla="*/ 2327035 h 2847817"/>
                <a:gd name="connsiteX16" fmla="*/ 2866111 w 4558605"/>
                <a:gd name="connsiteY16" fmla="*/ 2719246 h 2847817"/>
                <a:gd name="connsiteX17" fmla="*/ 1782679 w 4558605"/>
                <a:gd name="connsiteY17" fmla="*/ 2846717 h 2847817"/>
                <a:gd name="connsiteX18" fmla="*/ 1046292 w 4558605"/>
                <a:gd name="connsiteY18" fmla="*/ 2790725 h 2847817"/>
                <a:gd name="connsiteX19" fmla="*/ 492 w 4558605"/>
                <a:gd name="connsiteY19" fmla="*/ 2571107 h 2847817"/>
                <a:gd name="connsiteX0" fmla="*/ 453 w 4558566"/>
                <a:gd name="connsiteY0" fmla="*/ 2571107 h 2847817"/>
                <a:gd name="connsiteX1" fmla="*/ 919937 w 4558566"/>
                <a:gd name="connsiteY1" fmla="*/ 2047172 h 2847817"/>
                <a:gd name="connsiteX2" fmla="*/ 1324542 w 4558566"/>
                <a:gd name="connsiteY2" fmla="*/ 1798012 h 2847817"/>
                <a:gd name="connsiteX3" fmla="*/ 1610571 w 4558566"/>
                <a:gd name="connsiteY3" fmla="*/ 1357412 h 2847817"/>
                <a:gd name="connsiteX4" fmla="*/ 2279557 w 4558566"/>
                <a:gd name="connsiteY4" fmla="*/ 1258132 h 2847817"/>
                <a:gd name="connsiteX5" fmla="*/ 2770663 w 4558566"/>
                <a:gd name="connsiteY5" fmla="*/ 883624 h 2847817"/>
                <a:gd name="connsiteX6" fmla="*/ 3056220 w 4558566"/>
                <a:gd name="connsiteY6" fmla="*/ 434790 h 2847817"/>
                <a:gd name="connsiteX7" fmla="*/ 3173264 w 4558566"/>
                <a:gd name="connsiteY7" fmla="*/ 2496 h 2847817"/>
                <a:gd name="connsiteX8" fmla="*/ 3214506 w 4558566"/>
                <a:gd name="connsiteY8" fmla="*/ 637911 h 2847817"/>
                <a:gd name="connsiteX9" fmla="*/ 3388106 w 4558566"/>
                <a:gd name="connsiteY9" fmla="*/ 1151976 h 2847817"/>
                <a:gd name="connsiteX10" fmla="*/ 4112904 w 4558566"/>
                <a:gd name="connsiteY10" fmla="*/ 1509185 h 2847817"/>
                <a:gd name="connsiteX11" fmla="*/ 4306532 w 4558566"/>
                <a:gd name="connsiteY11" fmla="*/ 1706039 h 2847817"/>
                <a:gd name="connsiteX12" fmla="*/ 4558538 w 4558566"/>
                <a:gd name="connsiteY12" fmla="*/ 2575733 h 2847817"/>
                <a:gd name="connsiteX13" fmla="*/ 3783375 w 4558566"/>
                <a:gd name="connsiteY13" fmla="*/ 2221439 h 2847817"/>
                <a:gd name="connsiteX14" fmla="*/ 3496741 w 4558566"/>
                <a:gd name="connsiteY14" fmla="*/ 2233324 h 2847817"/>
                <a:gd name="connsiteX15" fmla="*/ 3273064 w 4558566"/>
                <a:gd name="connsiteY15" fmla="*/ 2327035 h 2847817"/>
                <a:gd name="connsiteX16" fmla="*/ 2866072 w 4558566"/>
                <a:gd name="connsiteY16" fmla="*/ 2719246 h 2847817"/>
                <a:gd name="connsiteX17" fmla="*/ 1782640 w 4558566"/>
                <a:gd name="connsiteY17" fmla="*/ 2846717 h 2847817"/>
                <a:gd name="connsiteX18" fmla="*/ 1046253 w 4558566"/>
                <a:gd name="connsiteY18" fmla="*/ 2790725 h 2847817"/>
                <a:gd name="connsiteX19" fmla="*/ 453 w 4558566"/>
                <a:gd name="connsiteY19" fmla="*/ 2571107 h 2847817"/>
                <a:gd name="connsiteX0" fmla="*/ 453 w 4558566"/>
                <a:gd name="connsiteY0" fmla="*/ 2571107 h 2847817"/>
                <a:gd name="connsiteX1" fmla="*/ 919937 w 4558566"/>
                <a:gd name="connsiteY1" fmla="*/ 2047172 h 2847817"/>
                <a:gd name="connsiteX2" fmla="*/ 1324542 w 4558566"/>
                <a:gd name="connsiteY2" fmla="*/ 1798012 h 2847817"/>
                <a:gd name="connsiteX3" fmla="*/ 1610571 w 4558566"/>
                <a:gd name="connsiteY3" fmla="*/ 1357412 h 2847817"/>
                <a:gd name="connsiteX4" fmla="*/ 2279557 w 4558566"/>
                <a:gd name="connsiteY4" fmla="*/ 1258132 h 2847817"/>
                <a:gd name="connsiteX5" fmla="*/ 2770663 w 4558566"/>
                <a:gd name="connsiteY5" fmla="*/ 883624 h 2847817"/>
                <a:gd name="connsiteX6" fmla="*/ 3056220 w 4558566"/>
                <a:gd name="connsiteY6" fmla="*/ 434790 h 2847817"/>
                <a:gd name="connsiteX7" fmla="*/ 3173264 w 4558566"/>
                <a:gd name="connsiteY7" fmla="*/ 2496 h 2847817"/>
                <a:gd name="connsiteX8" fmla="*/ 3214506 w 4558566"/>
                <a:gd name="connsiteY8" fmla="*/ 637911 h 2847817"/>
                <a:gd name="connsiteX9" fmla="*/ 3388106 w 4558566"/>
                <a:gd name="connsiteY9" fmla="*/ 1151976 h 2847817"/>
                <a:gd name="connsiteX10" fmla="*/ 4112904 w 4558566"/>
                <a:gd name="connsiteY10" fmla="*/ 1509185 h 2847817"/>
                <a:gd name="connsiteX11" fmla="*/ 4306532 w 4558566"/>
                <a:gd name="connsiteY11" fmla="*/ 1706039 h 2847817"/>
                <a:gd name="connsiteX12" fmla="*/ 4558538 w 4558566"/>
                <a:gd name="connsiteY12" fmla="*/ 2575733 h 2847817"/>
                <a:gd name="connsiteX13" fmla="*/ 3783375 w 4558566"/>
                <a:gd name="connsiteY13" fmla="*/ 2221439 h 2847817"/>
                <a:gd name="connsiteX14" fmla="*/ 3496741 w 4558566"/>
                <a:gd name="connsiteY14" fmla="*/ 2233324 h 2847817"/>
                <a:gd name="connsiteX15" fmla="*/ 3273064 w 4558566"/>
                <a:gd name="connsiteY15" fmla="*/ 2327035 h 2847817"/>
                <a:gd name="connsiteX16" fmla="*/ 2866072 w 4558566"/>
                <a:gd name="connsiteY16" fmla="*/ 2719246 h 2847817"/>
                <a:gd name="connsiteX17" fmla="*/ 1782640 w 4558566"/>
                <a:gd name="connsiteY17" fmla="*/ 2846717 h 2847817"/>
                <a:gd name="connsiteX18" fmla="*/ 1046253 w 4558566"/>
                <a:gd name="connsiteY18" fmla="*/ 2790725 h 2847817"/>
                <a:gd name="connsiteX19" fmla="*/ 453 w 4558566"/>
                <a:gd name="connsiteY19" fmla="*/ 2571107 h 2847817"/>
                <a:gd name="connsiteX0" fmla="*/ 452 w 4558565"/>
                <a:gd name="connsiteY0" fmla="*/ 2571107 h 2847817"/>
                <a:gd name="connsiteX1" fmla="*/ 919936 w 4558565"/>
                <a:gd name="connsiteY1" fmla="*/ 2047172 h 2847817"/>
                <a:gd name="connsiteX2" fmla="*/ 1318485 w 4558565"/>
                <a:gd name="connsiteY2" fmla="*/ 1827945 h 2847817"/>
                <a:gd name="connsiteX3" fmla="*/ 1610570 w 4558565"/>
                <a:gd name="connsiteY3" fmla="*/ 1357412 h 2847817"/>
                <a:gd name="connsiteX4" fmla="*/ 2279556 w 4558565"/>
                <a:gd name="connsiteY4" fmla="*/ 1258132 h 2847817"/>
                <a:gd name="connsiteX5" fmla="*/ 2770662 w 4558565"/>
                <a:gd name="connsiteY5" fmla="*/ 883624 h 2847817"/>
                <a:gd name="connsiteX6" fmla="*/ 3056219 w 4558565"/>
                <a:gd name="connsiteY6" fmla="*/ 434790 h 2847817"/>
                <a:gd name="connsiteX7" fmla="*/ 3173263 w 4558565"/>
                <a:gd name="connsiteY7" fmla="*/ 2496 h 2847817"/>
                <a:gd name="connsiteX8" fmla="*/ 3214505 w 4558565"/>
                <a:gd name="connsiteY8" fmla="*/ 637911 h 2847817"/>
                <a:gd name="connsiteX9" fmla="*/ 3388105 w 4558565"/>
                <a:gd name="connsiteY9" fmla="*/ 1151976 h 2847817"/>
                <a:gd name="connsiteX10" fmla="*/ 4112903 w 4558565"/>
                <a:gd name="connsiteY10" fmla="*/ 1509185 h 2847817"/>
                <a:gd name="connsiteX11" fmla="*/ 4306531 w 4558565"/>
                <a:gd name="connsiteY11" fmla="*/ 1706039 h 2847817"/>
                <a:gd name="connsiteX12" fmla="*/ 4558537 w 4558565"/>
                <a:gd name="connsiteY12" fmla="*/ 2575733 h 2847817"/>
                <a:gd name="connsiteX13" fmla="*/ 3783374 w 4558565"/>
                <a:gd name="connsiteY13" fmla="*/ 2221439 h 2847817"/>
                <a:gd name="connsiteX14" fmla="*/ 3496740 w 4558565"/>
                <a:gd name="connsiteY14" fmla="*/ 2233324 h 2847817"/>
                <a:gd name="connsiteX15" fmla="*/ 3273063 w 4558565"/>
                <a:gd name="connsiteY15" fmla="*/ 2327035 h 2847817"/>
                <a:gd name="connsiteX16" fmla="*/ 2866071 w 4558565"/>
                <a:gd name="connsiteY16" fmla="*/ 2719246 h 2847817"/>
                <a:gd name="connsiteX17" fmla="*/ 1782639 w 4558565"/>
                <a:gd name="connsiteY17" fmla="*/ 2846717 h 2847817"/>
                <a:gd name="connsiteX18" fmla="*/ 1046252 w 4558565"/>
                <a:gd name="connsiteY18" fmla="*/ 2790725 h 2847817"/>
                <a:gd name="connsiteX19" fmla="*/ 452 w 4558565"/>
                <a:gd name="connsiteY19" fmla="*/ 2571107 h 2847817"/>
                <a:gd name="connsiteX0" fmla="*/ 452 w 4558565"/>
                <a:gd name="connsiteY0" fmla="*/ 2571107 h 2847817"/>
                <a:gd name="connsiteX1" fmla="*/ 919936 w 4558565"/>
                <a:gd name="connsiteY1" fmla="*/ 2047172 h 2847817"/>
                <a:gd name="connsiteX2" fmla="*/ 1324713 w 4558565"/>
                <a:gd name="connsiteY2" fmla="*/ 1831248 h 2847817"/>
                <a:gd name="connsiteX3" fmla="*/ 1610570 w 4558565"/>
                <a:gd name="connsiteY3" fmla="*/ 1357412 h 2847817"/>
                <a:gd name="connsiteX4" fmla="*/ 2279556 w 4558565"/>
                <a:gd name="connsiteY4" fmla="*/ 1258132 h 2847817"/>
                <a:gd name="connsiteX5" fmla="*/ 2770662 w 4558565"/>
                <a:gd name="connsiteY5" fmla="*/ 883624 h 2847817"/>
                <a:gd name="connsiteX6" fmla="*/ 3056219 w 4558565"/>
                <a:gd name="connsiteY6" fmla="*/ 434790 h 2847817"/>
                <a:gd name="connsiteX7" fmla="*/ 3173263 w 4558565"/>
                <a:gd name="connsiteY7" fmla="*/ 2496 h 2847817"/>
                <a:gd name="connsiteX8" fmla="*/ 3214505 w 4558565"/>
                <a:gd name="connsiteY8" fmla="*/ 637911 h 2847817"/>
                <a:gd name="connsiteX9" fmla="*/ 3388105 w 4558565"/>
                <a:gd name="connsiteY9" fmla="*/ 1151976 h 2847817"/>
                <a:gd name="connsiteX10" fmla="*/ 4112903 w 4558565"/>
                <a:gd name="connsiteY10" fmla="*/ 1509185 h 2847817"/>
                <a:gd name="connsiteX11" fmla="*/ 4306531 w 4558565"/>
                <a:gd name="connsiteY11" fmla="*/ 1706039 h 2847817"/>
                <a:gd name="connsiteX12" fmla="*/ 4558537 w 4558565"/>
                <a:gd name="connsiteY12" fmla="*/ 2575733 h 2847817"/>
                <a:gd name="connsiteX13" fmla="*/ 3783374 w 4558565"/>
                <a:gd name="connsiteY13" fmla="*/ 2221439 h 2847817"/>
                <a:gd name="connsiteX14" fmla="*/ 3496740 w 4558565"/>
                <a:gd name="connsiteY14" fmla="*/ 2233324 h 2847817"/>
                <a:gd name="connsiteX15" fmla="*/ 3273063 w 4558565"/>
                <a:gd name="connsiteY15" fmla="*/ 2327035 h 2847817"/>
                <a:gd name="connsiteX16" fmla="*/ 2866071 w 4558565"/>
                <a:gd name="connsiteY16" fmla="*/ 2719246 h 2847817"/>
                <a:gd name="connsiteX17" fmla="*/ 1782639 w 4558565"/>
                <a:gd name="connsiteY17" fmla="*/ 2846717 h 2847817"/>
                <a:gd name="connsiteX18" fmla="*/ 1046252 w 4558565"/>
                <a:gd name="connsiteY18" fmla="*/ 2790725 h 2847817"/>
                <a:gd name="connsiteX19" fmla="*/ 452 w 4558565"/>
                <a:gd name="connsiteY19" fmla="*/ 2571107 h 2847817"/>
                <a:gd name="connsiteX0" fmla="*/ 454 w 4558567"/>
                <a:gd name="connsiteY0" fmla="*/ 2571107 h 2847817"/>
                <a:gd name="connsiteX1" fmla="*/ 919938 w 4558567"/>
                <a:gd name="connsiteY1" fmla="*/ 2047172 h 2847817"/>
                <a:gd name="connsiteX2" fmla="*/ 1341403 w 4558567"/>
                <a:gd name="connsiteY2" fmla="*/ 1833346 h 2847817"/>
                <a:gd name="connsiteX3" fmla="*/ 1610572 w 4558567"/>
                <a:gd name="connsiteY3" fmla="*/ 1357412 h 2847817"/>
                <a:gd name="connsiteX4" fmla="*/ 2279558 w 4558567"/>
                <a:gd name="connsiteY4" fmla="*/ 1258132 h 2847817"/>
                <a:gd name="connsiteX5" fmla="*/ 2770664 w 4558567"/>
                <a:gd name="connsiteY5" fmla="*/ 883624 h 2847817"/>
                <a:gd name="connsiteX6" fmla="*/ 3056221 w 4558567"/>
                <a:gd name="connsiteY6" fmla="*/ 434790 h 2847817"/>
                <a:gd name="connsiteX7" fmla="*/ 3173265 w 4558567"/>
                <a:gd name="connsiteY7" fmla="*/ 2496 h 2847817"/>
                <a:gd name="connsiteX8" fmla="*/ 3214507 w 4558567"/>
                <a:gd name="connsiteY8" fmla="*/ 637911 h 2847817"/>
                <a:gd name="connsiteX9" fmla="*/ 3388107 w 4558567"/>
                <a:gd name="connsiteY9" fmla="*/ 1151976 h 2847817"/>
                <a:gd name="connsiteX10" fmla="*/ 4112905 w 4558567"/>
                <a:gd name="connsiteY10" fmla="*/ 1509185 h 2847817"/>
                <a:gd name="connsiteX11" fmla="*/ 4306533 w 4558567"/>
                <a:gd name="connsiteY11" fmla="*/ 1706039 h 2847817"/>
                <a:gd name="connsiteX12" fmla="*/ 4558539 w 4558567"/>
                <a:gd name="connsiteY12" fmla="*/ 2575733 h 2847817"/>
                <a:gd name="connsiteX13" fmla="*/ 3783376 w 4558567"/>
                <a:gd name="connsiteY13" fmla="*/ 2221439 h 2847817"/>
                <a:gd name="connsiteX14" fmla="*/ 3496742 w 4558567"/>
                <a:gd name="connsiteY14" fmla="*/ 2233324 h 2847817"/>
                <a:gd name="connsiteX15" fmla="*/ 3273065 w 4558567"/>
                <a:gd name="connsiteY15" fmla="*/ 2327035 h 2847817"/>
                <a:gd name="connsiteX16" fmla="*/ 2866073 w 4558567"/>
                <a:gd name="connsiteY16" fmla="*/ 2719246 h 2847817"/>
                <a:gd name="connsiteX17" fmla="*/ 1782641 w 4558567"/>
                <a:gd name="connsiteY17" fmla="*/ 2846717 h 2847817"/>
                <a:gd name="connsiteX18" fmla="*/ 1046254 w 4558567"/>
                <a:gd name="connsiteY18" fmla="*/ 2790725 h 2847817"/>
                <a:gd name="connsiteX19" fmla="*/ 454 w 4558567"/>
                <a:gd name="connsiteY19" fmla="*/ 2571107 h 2847817"/>
                <a:gd name="connsiteX0" fmla="*/ 454 w 4558567"/>
                <a:gd name="connsiteY0" fmla="*/ 2571107 h 2847817"/>
                <a:gd name="connsiteX1" fmla="*/ 919938 w 4558567"/>
                <a:gd name="connsiteY1" fmla="*/ 2047172 h 2847817"/>
                <a:gd name="connsiteX2" fmla="*/ 1347493 w 4558567"/>
                <a:gd name="connsiteY2" fmla="*/ 1832280 h 2847817"/>
                <a:gd name="connsiteX3" fmla="*/ 1610572 w 4558567"/>
                <a:gd name="connsiteY3" fmla="*/ 1357412 h 2847817"/>
                <a:gd name="connsiteX4" fmla="*/ 2279558 w 4558567"/>
                <a:gd name="connsiteY4" fmla="*/ 1258132 h 2847817"/>
                <a:gd name="connsiteX5" fmla="*/ 2770664 w 4558567"/>
                <a:gd name="connsiteY5" fmla="*/ 883624 h 2847817"/>
                <a:gd name="connsiteX6" fmla="*/ 3056221 w 4558567"/>
                <a:gd name="connsiteY6" fmla="*/ 434790 h 2847817"/>
                <a:gd name="connsiteX7" fmla="*/ 3173265 w 4558567"/>
                <a:gd name="connsiteY7" fmla="*/ 2496 h 2847817"/>
                <a:gd name="connsiteX8" fmla="*/ 3214507 w 4558567"/>
                <a:gd name="connsiteY8" fmla="*/ 637911 h 2847817"/>
                <a:gd name="connsiteX9" fmla="*/ 3388107 w 4558567"/>
                <a:gd name="connsiteY9" fmla="*/ 1151976 h 2847817"/>
                <a:gd name="connsiteX10" fmla="*/ 4112905 w 4558567"/>
                <a:gd name="connsiteY10" fmla="*/ 1509185 h 2847817"/>
                <a:gd name="connsiteX11" fmla="*/ 4306533 w 4558567"/>
                <a:gd name="connsiteY11" fmla="*/ 1706039 h 2847817"/>
                <a:gd name="connsiteX12" fmla="*/ 4558539 w 4558567"/>
                <a:gd name="connsiteY12" fmla="*/ 2575733 h 2847817"/>
                <a:gd name="connsiteX13" fmla="*/ 3783376 w 4558567"/>
                <a:gd name="connsiteY13" fmla="*/ 2221439 h 2847817"/>
                <a:gd name="connsiteX14" fmla="*/ 3496742 w 4558567"/>
                <a:gd name="connsiteY14" fmla="*/ 2233324 h 2847817"/>
                <a:gd name="connsiteX15" fmla="*/ 3273065 w 4558567"/>
                <a:gd name="connsiteY15" fmla="*/ 2327035 h 2847817"/>
                <a:gd name="connsiteX16" fmla="*/ 2866073 w 4558567"/>
                <a:gd name="connsiteY16" fmla="*/ 2719246 h 2847817"/>
                <a:gd name="connsiteX17" fmla="*/ 1782641 w 4558567"/>
                <a:gd name="connsiteY17" fmla="*/ 2846717 h 2847817"/>
                <a:gd name="connsiteX18" fmla="*/ 1046254 w 4558567"/>
                <a:gd name="connsiteY18" fmla="*/ 2790725 h 2847817"/>
                <a:gd name="connsiteX19" fmla="*/ 454 w 4558567"/>
                <a:gd name="connsiteY19" fmla="*/ 2571107 h 2847817"/>
                <a:gd name="connsiteX0" fmla="*/ 454 w 4558567"/>
                <a:gd name="connsiteY0" fmla="*/ 2571107 h 2847817"/>
                <a:gd name="connsiteX1" fmla="*/ 919938 w 4558567"/>
                <a:gd name="connsiteY1" fmla="*/ 2047172 h 2847817"/>
                <a:gd name="connsiteX2" fmla="*/ 1347493 w 4558567"/>
                <a:gd name="connsiteY2" fmla="*/ 1832280 h 2847817"/>
                <a:gd name="connsiteX3" fmla="*/ 1603553 w 4558567"/>
                <a:gd name="connsiteY3" fmla="*/ 1356759 h 2847817"/>
                <a:gd name="connsiteX4" fmla="*/ 2279558 w 4558567"/>
                <a:gd name="connsiteY4" fmla="*/ 1258132 h 2847817"/>
                <a:gd name="connsiteX5" fmla="*/ 2770664 w 4558567"/>
                <a:gd name="connsiteY5" fmla="*/ 883624 h 2847817"/>
                <a:gd name="connsiteX6" fmla="*/ 3056221 w 4558567"/>
                <a:gd name="connsiteY6" fmla="*/ 434790 h 2847817"/>
                <a:gd name="connsiteX7" fmla="*/ 3173265 w 4558567"/>
                <a:gd name="connsiteY7" fmla="*/ 2496 h 2847817"/>
                <a:gd name="connsiteX8" fmla="*/ 3214507 w 4558567"/>
                <a:gd name="connsiteY8" fmla="*/ 637911 h 2847817"/>
                <a:gd name="connsiteX9" fmla="*/ 3388107 w 4558567"/>
                <a:gd name="connsiteY9" fmla="*/ 1151976 h 2847817"/>
                <a:gd name="connsiteX10" fmla="*/ 4112905 w 4558567"/>
                <a:gd name="connsiteY10" fmla="*/ 1509185 h 2847817"/>
                <a:gd name="connsiteX11" fmla="*/ 4306533 w 4558567"/>
                <a:gd name="connsiteY11" fmla="*/ 1706039 h 2847817"/>
                <a:gd name="connsiteX12" fmla="*/ 4558539 w 4558567"/>
                <a:gd name="connsiteY12" fmla="*/ 2575733 h 2847817"/>
                <a:gd name="connsiteX13" fmla="*/ 3783376 w 4558567"/>
                <a:gd name="connsiteY13" fmla="*/ 2221439 h 2847817"/>
                <a:gd name="connsiteX14" fmla="*/ 3496742 w 4558567"/>
                <a:gd name="connsiteY14" fmla="*/ 2233324 h 2847817"/>
                <a:gd name="connsiteX15" fmla="*/ 3273065 w 4558567"/>
                <a:gd name="connsiteY15" fmla="*/ 2327035 h 2847817"/>
                <a:gd name="connsiteX16" fmla="*/ 2866073 w 4558567"/>
                <a:gd name="connsiteY16" fmla="*/ 2719246 h 2847817"/>
                <a:gd name="connsiteX17" fmla="*/ 1782641 w 4558567"/>
                <a:gd name="connsiteY17" fmla="*/ 2846717 h 2847817"/>
                <a:gd name="connsiteX18" fmla="*/ 1046254 w 4558567"/>
                <a:gd name="connsiteY18" fmla="*/ 2790725 h 2847817"/>
                <a:gd name="connsiteX19" fmla="*/ 454 w 4558567"/>
                <a:gd name="connsiteY19" fmla="*/ 2571107 h 2847817"/>
                <a:gd name="connsiteX0" fmla="*/ 330 w 4558443"/>
                <a:gd name="connsiteY0" fmla="*/ 2571107 h 2847817"/>
                <a:gd name="connsiteX1" fmla="*/ 937648 w 4558443"/>
                <a:gd name="connsiteY1" fmla="*/ 2080203 h 2847817"/>
                <a:gd name="connsiteX2" fmla="*/ 1347369 w 4558443"/>
                <a:gd name="connsiteY2" fmla="*/ 1832280 h 2847817"/>
                <a:gd name="connsiteX3" fmla="*/ 1603429 w 4558443"/>
                <a:gd name="connsiteY3" fmla="*/ 1356759 h 2847817"/>
                <a:gd name="connsiteX4" fmla="*/ 2279434 w 4558443"/>
                <a:gd name="connsiteY4" fmla="*/ 1258132 h 2847817"/>
                <a:gd name="connsiteX5" fmla="*/ 2770540 w 4558443"/>
                <a:gd name="connsiteY5" fmla="*/ 883624 h 2847817"/>
                <a:gd name="connsiteX6" fmla="*/ 3056097 w 4558443"/>
                <a:gd name="connsiteY6" fmla="*/ 434790 h 2847817"/>
                <a:gd name="connsiteX7" fmla="*/ 3173141 w 4558443"/>
                <a:gd name="connsiteY7" fmla="*/ 2496 h 2847817"/>
                <a:gd name="connsiteX8" fmla="*/ 3214383 w 4558443"/>
                <a:gd name="connsiteY8" fmla="*/ 637911 h 2847817"/>
                <a:gd name="connsiteX9" fmla="*/ 3387983 w 4558443"/>
                <a:gd name="connsiteY9" fmla="*/ 1151976 h 2847817"/>
                <a:gd name="connsiteX10" fmla="*/ 4112781 w 4558443"/>
                <a:gd name="connsiteY10" fmla="*/ 1509185 h 2847817"/>
                <a:gd name="connsiteX11" fmla="*/ 4306409 w 4558443"/>
                <a:gd name="connsiteY11" fmla="*/ 1706039 h 2847817"/>
                <a:gd name="connsiteX12" fmla="*/ 4558415 w 4558443"/>
                <a:gd name="connsiteY12" fmla="*/ 2575733 h 2847817"/>
                <a:gd name="connsiteX13" fmla="*/ 3783252 w 4558443"/>
                <a:gd name="connsiteY13" fmla="*/ 2221439 h 2847817"/>
                <a:gd name="connsiteX14" fmla="*/ 3496618 w 4558443"/>
                <a:gd name="connsiteY14" fmla="*/ 2233324 h 2847817"/>
                <a:gd name="connsiteX15" fmla="*/ 3272941 w 4558443"/>
                <a:gd name="connsiteY15" fmla="*/ 2327035 h 2847817"/>
                <a:gd name="connsiteX16" fmla="*/ 2865949 w 4558443"/>
                <a:gd name="connsiteY16" fmla="*/ 2719246 h 2847817"/>
                <a:gd name="connsiteX17" fmla="*/ 1782517 w 4558443"/>
                <a:gd name="connsiteY17" fmla="*/ 2846717 h 2847817"/>
                <a:gd name="connsiteX18" fmla="*/ 1046130 w 4558443"/>
                <a:gd name="connsiteY18" fmla="*/ 2790725 h 2847817"/>
                <a:gd name="connsiteX19" fmla="*/ 330 w 4558443"/>
                <a:gd name="connsiteY19" fmla="*/ 2571107 h 2847817"/>
                <a:gd name="connsiteX0" fmla="*/ 403 w 4558516"/>
                <a:gd name="connsiteY0" fmla="*/ 2571107 h 2847817"/>
                <a:gd name="connsiteX1" fmla="*/ 937721 w 4558516"/>
                <a:gd name="connsiteY1" fmla="*/ 2080203 h 2847817"/>
                <a:gd name="connsiteX2" fmla="*/ 1347442 w 4558516"/>
                <a:gd name="connsiteY2" fmla="*/ 1832280 h 2847817"/>
                <a:gd name="connsiteX3" fmla="*/ 1603502 w 4558516"/>
                <a:gd name="connsiteY3" fmla="*/ 1356759 h 2847817"/>
                <a:gd name="connsiteX4" fmla="*/ 2279507 w 4558516"/>
                <a:gd name="connsiteY4" fmla="*/ 1258132 h 2847817"/>
                <a:gd name="connsiteX5" fmla="*/ 2770613 w 4558516"/>
                <a:gd name="connsiteY5" fmla="*/ 883624 h 2847817"/>
                <a:gd name="connsiteX6" fmla="*/ 3056170 w 4558516"/>
                <a:gd name="connsiteY6" fmla="*/ 434790 h 2847817"/>
                <a:gd name="connsiteX7" fmla="*/ 3173214 w 4558516"/>
                <a:gd name="connsiteY7" fmla="*/ 2496 h 2847817"/>
                <a:gd name="connsiteX8" fmla="*/ 3214456 w 4558516"/>
                <a:gd name="connsiteY8" fmla="*/ 637911 h 2847817"/>
                <a:gd name="connsiteX9" fmla="*/ 3388056 w 4558516"/>
                <a:gd name="connsiteY9" fmla="*/ 1151976 h 2847817"/>
                <a:gd name="connsiteX10" fmla="*/ 4112854 w 4558516"/>
                <a:gd name="connsiteY10" fmla="*/ 1509185 h 2847817"/>
                <a:gd name="connsiteX11" fmla="*/ 4306482 w 4558516"/>
                <a:gd name="connsiteY11" fmla="*/ 1706039 h 2847817"/>
                <a:gd name="connsiteX12" fmla="*/ 4558488 w 4558516"/>
                <a:gd name="connsiteY12" fmla="*/ 2575733 h 2847817"/>
                <a:gd name="connsiteX13" fmla="*/ 3783325 w 4558516"/>
                <a:gd name="connsiteY13" fmla="*/ 2221439 h 2847817"/>
                <a:gd name="connsiteX14" fmla="*/ 3496691 w 4558516"/>
                <a:gd name="connsiteY14" fmla="*/ 2233324 h 2847817"/>
                <a:gd name="connsiteX15" fmla="*/ 3273014 w 4558516"/>
                <a:gd name="connsiteY15" fmla="*/ 2327035 h 2847817"/>
                <a:gd name="connsiteX16" fmla="*/ 2866022 w 4558516"/>
                <a:gd name="connsiteY16" fmla="*/ 2719246 h 2847817"/>
                <a:gd name="connsiteX17" fmla="*/ 1782590 w 4558516"/>
                <a:gd name="connsiteY17" fmla="*/ 2846717 h 2847817"/>
                <a:gd name="connsiteX18" fmla="*/ 1046203 w 4558516"/>
                <a:gd name="connsiteY18" fmla="*/ 2790725 h 2847817"/>
                <a:gd name="connsiteX19" fmla="*/ 403 w 4558516"/>
                <a:gd name="connsiteY19" fmla="*/ 2571107 h 2847817"/>
                <a:gd name="connsiteX0" fmla="*/ 165 w 4558278"/>
                <a:gd name="connsiteY0" fmla="*/ 2571107 h 2847817"/>
                <a:gd name="connsiteX1" fmla="*/ 975246 w 4558278"/>
                <a:gd name="connsiteY1" fmla="*/ 2123806 h 2847817"/>
                <a:gd name="connsiteX2" fmla="*/ 1347204 w 4558278"/>
                <a:gd name="connsiteY2" fmla="*/ 1832280 h 2847817"/>
                <a:gd name="connsiteX3" fmla="*/ 1603264 w 4558278"/>
                <a:gd name="connsiteY3" fmla="*/ 1356759 h 2847817"/>
                <a:gd name="connsiteX4" fmla="*/ 2279269 w 4558278"/>
                <a:gd name="connsiteY4" fmla="*/ 1258132 h 2847817"/>
                <a:gd name="connsiteX5" fmla="*/ 2770375 w 4558278"/>
                <a:gd name="connsiteY5" fmla="*/ 883624 h 2847817"/>
                <a:gd name="connsiteX6" fmla="*/ 3055932 w 4558278"/>
                <a:gd name="connsiteY6" fmla="*/ 434790 h 2847817"/>
                <a:gd name="connsiteX7" fmla="*/ 3172976 w 4558278"/>
                <a:gd name="connsiteY7" fmla="*/ 2496 h 2847817"/>
                <a:gd name="connsiteX8" fmla="*/ 3214218 w 4558278"/>
                <a:gd name="connsiteY8" fmla="*/ 637911 h 2847817"/>
                <a:gd name="connsiteX9" fmla="*/ 3387818 w 4558278"/>
                <a:gd name="connsiteY9" fmla="*/ 1151976 h 2847817"/>
                <a:gd name="connsiteX10" fmla="*/ 4112616 w 4558278"/>
                <a:gd name="connsiteY10" fmla="*/ 1509185 h 2847817"/>
                <a:gd name="connsiteX11" fmla="*/ 4306244 w 4558278"/>
                <a:gd name="connsiteY11" fmla="*/ 1706039 h 2847817"/>
                <a:gd name="connsiteX12" fmla="*/ 4558250 w 4558278"/>
                <a:gd name="connsiteY12" fmla="*/ 2575733 h 2847817"/>
                <a:gd name="connsiteX13" fmla="*/ 3783087 w 4558278"/>
                <a:gd name="connsiteY13" fmla="*/ 2221439 h 2847817"/>
                <a:gd name="connsiteX14" fmla="*/ 3496453 w 4558278"/>
                <a:gd name="connsiteY14" fmla="*/ 2233324 h 2847817"/>
                <a:gd name="connsiteX15" fmla="*/ 3272776 w 4558278"/>
                <a:gd name="connsiteY15" fmla="*/ 2327035 h 2847817"/>
                <a:gd name="connsiteX16" fmla="*/ 2865784 w 4558278"/>
                <a:gd name="connsiteY16" fmla="*/ 2719246 h 2847817"/>
                <a:gd name="connsiteX17" fmla="*/ 1782352 w 4558278"/>
                <a:gd name="connsiteY17" fmla="*/ 2846717 h 2847817"/>
                <a:gd name="connsiteX18" fmla="*/ 1045965 w 4558278"/>
                <a:gd name="connsiteY18" fmla="*/ 2790725 h 2847817"/>
                <a:gd name="connsiteX19" fmla="*/ 165 w 4558278"/>
                <a:gd name="connsiteY19" fmla="*/ 2571107 h 2847817"/>
                <a:gd name="connsiteX0" fmla="*/ 325 w 4558438"/>
                <a:gd name="connsiteY0" fmla="*/ 2571107 h 2847817"/>
                <a:gd name="connsiteX1" fmla="*/ 948124 w 4558438"/>
                <a:gd name="connsiteY1" fmla="*/ 2118542 h 2847817"/>
                <a:gd name="connsiteX2" fmla="*/ 1347364 w 4558438"/>
                <a:gd name="connsiteY2" fmla="*/ 1832280 h 2847817"/>
                <a:gd name="connsiteX3" fmla="*/ 1603424 w 4558438"/>
                <a:gd name="connsiteY3" fmla="*/ 1356759 h 2847817"/>
                <a:gd name="connsiteX4" fmla="*/ 2279429 w 4558438"/>
                <a:gd name="connsiteY4" fmla="*/ 1258132 h 2847817"/>
                <a:gd name="connsiteX5" fmla="*/ 2770535 w 4558438"/>
                <a:gd name="connsiteY5" fmla="*/ 883624 h 2847817"/>
                <a:gd name="connsiteX6" fmla="*/ 3056092 w 4558438"/>
                <a:gd name="connsiteY6" fmla="*/ 434790 h 2847817"/>
                <a:gd name="connsiteX7" fmla="*/ 3173136 w 4558438"/>
                <a:gd name="connsiteY7" fmla="*/ 2496 h 2847817"/>
                <a:gd name="connsiteX8" fmla="*/ 3214378 w 4558438"/>
                <a:gd name="connsiteY8" fmla="*/ 637911 h 2847817"/>
                <a:gd name="connsiteX9" fmla="*/ 3387978 w 4558438"/>
                <a:gd name="connsiteY9" fmla="*/ 1151976 h 2847817"/>
                <a:gd name="connsiteX10" fmla="*/ 4112776 w 4558438"/>
                <a:gd name="connsiteY10" fmla="*/ 1509185 h 2847817"/>
                <a:gd name="connsiteX11" fmla="*/ 4306404 w 4558438"/>
                <a:gd name="connsiteY11" fmla="*/ 1706039 h 2847817"/>
                <a:gd name="connsiteX12" fmla="*/ 4558410 w 4558438"/>
                <a:gd name="connsiteY12" fmla="*/ 2575733 h 2847817"/>
                <a:gd name="connsiteX13" fmla="*/ 3783247 w 4558438"/>
                <a:gd name="connsiteY13" fmla="*/ 2221439 h 2847817"/>
                <a:gd name="connsiteX14" fmla="*/ 3496613 w 4558438"/>
                <a:gd name="connsiteY14" fmla="*/ 2233324 h 2847817"/>
                <a:gd name="connsiteX15" fmla="*/ 3272936 w 4558438"/>
                <a:gd name="connsiteY15" fmla="*/ 2327035 h 2847817"/>
                <a:gd name="connsiteX16" fmla="*/ 2865944 w 4558438"/>
                <a:gd name="connsiteY16" fmla="*/ 2719246 h 2847817"/>
                <a:gd name="connsiteX17" fmla="*/ 1782512 w 4558438"/>
                <a:gd name="connsiteY17" fmla="*/ 2846717 h 2847817"/>
                <a:gd name="connsiteX18" fmla="*/ 1046125 w 4558438"/>
                <a:gd name="connsiteY18" fmla="*/ 2790725 h 2847817"/>
                <a:gd name="connsiteX19" fmla="*/ 325 w 4558438"/>
                <a:gd name="connsiteY19" fmla="*/ 2571107 h 2847817"/>
                <a:gd name="connsiteX0" fmla="*/ 319 w 4558432"/>
                <a:gd name="connsiteY0" fmla="*/ 2571107 h 2847817"/>
                <a:gd name="connsiteX1" fmla="*/ 949184 w 4558432"/>
                <a:gd name="connsiteY1" fmla="*/ 2124633 h 2847817"/>
                <a:gd name="connsiteX2" fmla="*/ 1347358 w 4558432"/>
                <a:gd name="connsiteY2" fmla="*/ 1832280 h 2847817"/>
                <a:gd name="connsiteX3" fmla="*/ 1603418 w 4558432"/>
                <a:gd name="connsiteY3" fmla="*/ 1356759 h 2847817"/>
                <a:gd name="connsiteX4" fmla="*/ 2279423 w 4558432"/>
                <a:gd name="connsiteY4" fmla="*/ 1258132 h 2847817"/>
                <a:gd name="connsiteX5" fmla="*/ 2770529 w 4558432"/>
                <a:gd name="connsiteY5" fmla="*/ 883624 h 2847817"/>
                <a:gd name="connsiteX6" fmla="*/ 3056086 w 4558432"/>
                <a:gd name="connsiteY6" fmla="*/ 434790 h 2847817"/>
                <a:gd name="connsiteX7" fmla="*/ 3173130 w 4558432"/>
                <a:gd name="connsiteY7" fmla="*/ 2496 h 2847817"/>
                <a:gd name="connsiteX8" fmla="*/ 3214372 w 4558432"/>
                <a:gd name="connsiteY8" fmla="*/ 637911 h 2847817"/>
                <a:gd name="connsiteX9" fmla="*/ 3387972 w 4558432"/>
                <a:gd name="connsiteY9" fmla="*/ 1151976 h 2847817"/>
                <a:gd name="connsiteX10" fmla="*/ 4112770 w 4558432"/>
                <a:gd name="connsiteY10" fmla="*/ 1509185 h 2847817"/>
                <a:gd name="connsiteX11" fmla="*/ 4306398 w 4558432"/>
                <a:gd name="connsiteY11" fmla="*/ 1706039 h 2847817"/>
                <a:gd name="connsiteX12" fmla="*/ 4558404 w 4558432"/>
                <a:gd name="connsiteY12" fmla="*/ 2575733 h 2847817"/>
                <a:gd name="connsiteX13" fmla="*/ 3783241 w 4558432"/>
                <a:gd name="connsiteY13" fmla="*/ 2221439 h 2847817"/>
                <a:gd name="connsiteX14" fmla="*/ 3496607 w 4558432"/>
                <a:gd name="connsiteY14" fmla="*/ 2233324 h 2847817"/>
                <a:gd name="connsiteX15" fmla="*/ 3272930 w 4558432"/>
                <a:gd name="connsiteY15" fmla="*/ 2327035 h 2847817"/>
                <a:gd name="connsiteX16" fmla="*/ 2865938 w 4558432"/>
                <a:gd name="connsiteY16" fmla="*/ 2719246 h 2847817"/>
                <a:gd name="connsiteX17" fmla="*/ 1782506 w 4558432"/>
                <a:gd name="connsiteY17" fmla="*/ 2846717 h 2847817"/>
                <a:gd name="connsiteX18" fmla="*/ 1046119 w 4558432"/>
                <a:gd name="connsiteY18" fmla="*/ 2790725 h 2847817"/>
                <a:gd name="connsiteX19" fmla="*/ 319 w 4558432"/>
                <a:gd name="connsiteY19" fmla="*/ 2571107 h 2847817"/>
                <a:gd name="connsiteX0" fmla="*/ 319 w 4558432"/>
                <a:gd name="connsiteY0" fmla="*/ 2571107 h 2847817"/>
                <a:gd name="connsiteX1" fmla="*/ 949184 w 4558432"/>
                <a:gd name="connsiteY1" fmla="*/ 2124633 h 2847817"/>
                <a:gd name="connsiteX2" fmla="*/ 1347358 w 4558432"/>
                <a:gd name="connsiteY2" fmla="*/ 1832280 h 2847817"/>
                <a:gd name="connsiteX3" fmla="*/ 1603418 w 4558432"/>
                <a:gd name="connsiteY3" fmla="*/ 1356759 h 2847817"/>
                <a:gd name="connsiteX4" fmla="*/ 2279423 w 4558432"/>
                <a:gd name="connsiteY4" fmla="*/ 1258132 h 2847817"/>
                <a:gd name="connsiteX5" fmla="*/ 2770529 w 4558432"/>
                <a:gd name="connsiteY5" fmla="*/ 883624 h 2847817"/>
                <a:gd name="connsiteX6" fmla="*/ 3056086 w 4558432"/>
                <a:gd name="connsiteY6" fmla="*/ 434790 h 2847817"/>
                <a:gd name="connsiteX7" fmla="*/ 3173130 w 4558432"/>
                <a:gd name="connsiteY7" fmla="*/ 2496 h 2847817"/>
                <a:gd name="connsiteX8" fmla="*/ 3214372 w 4558432"/>
                <a:gd name="connsiteY8" fmla="*/ 637911 h 2847817"/>
                <a:gd name="connsiteX9" fmla="*/ 3387972 w 4558432"/>
                <a:gd name="connsiteY9" fmla="*/ 1151976 h 2847817"/>
                <a:gd name="connsiteX10" fmla="*/ 4112770 w 4558432"/>
                <a:gd name="connsiteY10" fmla="*/ 1509185 h 2847817"/>
                <a:gd name="connsiteX11" fmla="*/ 4306398 w 4558432"/>
                <a:gd name="connsiteY11" fmla="*/ 1706039 h 2847817"/>
                <a:gd name="connsiteX12" fmla="*/ 4558404 w 4558432"/>
                <a:gd name="connsiteY12" fmla="*/ 2575733 h 2847817"/>
                <a:gd name="connsiteX13" fmla="*/ 3783241 w 4558432"/>
                <a:gd name="connsiteY13" fmla="*/ 2221439 h 2847817"/>
                <a:gd name="connsiteX14" fmla="*/ 3496607 w 4558432"/>
                <a:gd name="connsiteY14" fmla="*/ 2233324 h 2847817"/>
                <a:gd name="connsiteX15" fmla="*/ 3272930 w 4558432"/>
                <a:gd name="connsiteY15" fmla="*/ 2327035 h 2847817"/>
                <a:gd name="connsiteX16" fmla="*/ 2865938 w 4558432"/>
                <a:gd name="connsiteY16" fmla="*/ 2719246 h 2847817"/>
                <a:gd name="connsiteX17" fmla="*/ 1782506 w 4558432"/>
                <a:gd name="connsiteY17" fmla="*/ 2846717 h 2847817"/>
                <a:gd name="connsiteX18" fmla="*/ 1046119 w 4558432"/>
                <a:gd name="connsiteY18" fmla="*/ 2790725 h 2847817"/>
                <a:gd name="connsiteX19" fmla="*/ 319 w 4558432"/>
                <a:gd name="connsiteY19" fmla="*/ 2571107 h 2847817"/>
                <a:gd name="connsiteX0" fmla="*/ 317 w 4558430"/>
                <a:gd name="connsiteY0" fmla="*/ 2571107 h 2847817"/>
                <a:gd name="connsiteX1" fmla="*/ 949182 w 4558430"/>
                <a:gd name="connsiteY1" fmla="*/ 2124633 h 2847817"/>
                <a:gd name="connsiteX2" fmla="*/ 1347356 w 4558430"/>
                <a:gd name="connsiteY2" fmla="*/ 1832280 h 2847817"/>
                <a:gd name="connsiteX3" fmla="*/ 1603416 w 4558430"/>
                <a:gd name="connsiteY3" fmla="*/ 1356759 h 2847817"/>
                <a:gd name="connsiteX4" fmla="*/ 2279421 w 4558430"/>
                <a:gd name="connsiteY4" fmla="*/ 1258132 h 2847817"/>
                <a:gd name="connsiteX5" fmla="*/ 2770527 w 4558430"/>
                <a:gd name="connsiteY5" fmla="*/ 883624 h 2847817"/>
                <a:gd name="connsiteX6" fmla="*/ 3056084 w 4558430"/>
                <a:gd name="connsiteY6" fmla="*/ 434790 h 2847817"/>
                <a:gd name="connsiteX7" fmla="*/ 3173128 w 4558430"/>
                <a:gd name="connsiteY7" fmla="*/ 2496 h 2847817"/>
                <a:gd name="connsiteX8" fmla="*/ 3214370 w 4558430"/>
                <a:gd name="connsiteY8" fmla="*/ 637911 h 2847817"/>
                <a:gd name="connsiteX9" fmla="*/ 3387970 w 4558430"/>
                <a:gd name="connsiteY9" fmla="*/ 1151976 h 2847817"/>
                <a:gd name="connsiteX10" fmla="*/ 4112768 w 4558430"/>
                <a:gd name="connsiteY10" fmla="*/ 1509185 h 2847817"/>
                <a:gd name="connsiteX11" fmla="*/ 4306396 w 4558430"/>
                <a:gd name="connsiteY11" fmla="*/ 1706039 h 2847817"/>
                <a:gd name="connsiteX12" fmla="*/ 4558402 w 4558430"/>
                <a:gd name="connsiteY12" fmla="*/ 2575733 h 2847817"/>
                <a:gd name="connsiteX13" fmla="*/ 3783239 w 4558430"/>
                <a:gd name="connsiteY13" fmla="*/ 2221439 h 2847817"/>
                <a:gd name="connsiteX14" fmla="*/ 3496605 w 4558430"/>
                <a:gd name="connsiteY14" fmla="*/ 2233324 h 2847817"/>
                <a:gd name="connsiteX15" fmla="*/ 3272928 w 4558430"/>
                <a:gd name="connsiteY15" fmla="*/ 2327035 h 2847817"/>
                <a:gd name="connsiteX16" fmla="*/ 2865936 w 4558430"/>
                <a:gd name="connsiteY16" fmla="*/ 2719246 h 2847817"/>
                <a:gd name="connsiteX17" fmla="*/ 1782504 w 4558430"/>
                <a:gd name="connsiteY17" fmla="*/ 2846717 h 2847817"/>
                <a:gd name="connsiteX18" fmla="*/ 1046117 w 4558430"/>
                <a:gd name="connsiteY18" fmla="*/ 2790725 h 2847817"/>
                <a:gd name="connsiteX19" fmla="*/ 317 w 4558430"/>
                <a:gd name="connsiteY19" fmla="*/ 2571107 h 2847817"/>
                <a:gd name="connsiteX0" fmla="*/ 318 w 4558431"/>
                <a:gd name="connsiteY0" fmla="*/ 2571107 h 2847817"/>
                <a:gd name="connsiteX1" fmla="*/ 949183 w 4558431"/>
                <a:gd name="connsiteY1" fmla="*/ 2124633 h 2847817"/>
                <a:gd name="connsiteX2" fmla="*/ 1347357 w 4558431"/>
                <a:gd name="connsiteY2" fmla="*/ 1832280 h 2847817"/>
                <a:gd name="connsiteX3" fmla="*/ 1603417 w 4558431"/>
                <a:gd name="connsiteY3" fmla="*/ 1356759 h 2847817"/>
                <a:gd name="connsiteX4" fmla="*/ 2279422 w 4558431"/>
                <a:gd name="connsiteY4" fmla="*/ 1258132 h 2847817"/>
                <a:gd name="connsiteX5" fmla="*/ 2770528 w 4558431"/>
                <a:gd name="connsiteY5" fmla="*/ 883624 h 2847817"/>
                <a:gd name="connsiteX6" fmla="*/ 3056085 w 4558431"/>
                <a:gd name="connsiteY6" fmla="*/ 434790 h 2847817"/>
                <a:gd name="connsiteX7" fmla="*/ 3173129 w 4558431"/>
                <a:gd name="connsiteY7" fmla="*/ 2496 h 2847817"/>
                <a:gd name="connsiteX8" fmla="*/ 3214371 w 4558431"/>
                <a:gd name="connsiteY8" fmla="*/ 637911 h 2847817"/>
                <a:gd name="connsiteX9" fmla="*/ 3387971 w 4558431"/>
                <a:gd name="connsiteY9" fmla="*/ 1151976 h 2847817"/>
                <a:gd name="connsiteX10" fmla="*/ 4112769 w 4558431"/>
                <a:gd name="connsiteY10" fmla="*/ 1509185 h 2847817"/>
                <a:gd name="connsiteX11" fmla="*/ 4306397 w 4558431"/>
                <a:gd name="connsiteY11" fmla="*/ 1706039 h 2847817"/>
                <a:gd name="connsiteX12" fmla="*/ 4558403 w 4558431"/>
                <a:gd name="connsiteY12" fmla="*/ 2575733 h 2847817"/>
                <a:gd name="connsiteX13" fmla="*/ 3783240 w 4558431"/>
                <a:gd name="connsiteY13" fmla="*/ 2221439 h 2847817"/>
                <a:gd name="connsiteX14" fmla="*/ 3496606 w 4558431"/>
                <a:gd name="connsiteY14" fmla="*/ 2233324 h 2847817"/>
                <a:gd name="connsiteX15" fmla="*/ 3272929 w 4558431"/>
                <a:gd name="connsiteY15" fmla="*/ 2327035 h 2847817"/>
                <a:gd name="connsiteX16" fmla="*/ 2865937 w 4558431"/>
                <a:gd name="connsiteY16" fmla="*/ 2719246 h 2847817"/>
                <a:gd name="connsiteX17" fmla="*/ 1782505 w 4558431"/>
                <a:gd name="connsiteY17" fmla="*/ 2846717 h 2847817"/>
                <a:gd name="connsiteX18" fmla="*/ 1046118 w 4558431"/>
                <a:gd name="connsiteY18" fmla="*/ 2790725 h 2847817"/>
                <a:gd name="connsiteX19" fmla="*/ 318 w 4558431"/>
                <a:gd name="connsiteY19" fmla="*/ 2571107 h 2847817"/>
                <a:gd name="connsiteX0" fmla="*/ 344 w 4558457"/>
                <a:gd name="connsiteY0" fmla="*/ 2571107 h 2847817"/>
                <a:gd name="connsiteX1" fmla="*/ 949209 w 4558457"/>
                <a:gd name="connsiteY1" fmla="*/ 2124633 h 2847817"/>
                <a:gd name="connsiteX2" fmla="*/ 1347383 w 4558457"/>
                <a:gd name="connsiteY2" fmla="*/ 1832280 h 2847817"/>
                <a:gd name="connsiteX3" fmla="*/ 1603443 w 4558457"/>
                <a:gd name="connsiteY3" fmla="*/ 1356759 h 2847817"/>
                <a:gd name="connsiteX4" fmla="*/ 2279448 w 4558457"/>
                <a:gd name="connsiteY4" fmla="*/ 1258132 h 2847817"/>
                <a:gd name="connsiteX5" fmla="*/ 2770554 w 4558457"/>
                <a:gd name="connsiteY5" fmla="*/ 883624 h 2847817"/>
                <a:gd name="connsiteX6" fmla="*/ 3056111 w 4558457"/>
                <a:gd name="connsiteY6" fmla="*/ 434790 h 2847817"/>
                <a:gd name="connsiteX7" fmla="*/ 3173155 w 4558457"/>
                <a:gd name="connsiteY7" fmla="*/ 2496 h 2847817"/>
                <a:gd name="connsiteX8" fmla="*/ 3214397 w 4558457"/>
                <a:gd name="connsiteY8" fmla="*/ 637911 h 2847817"/>
                <a:gd name="connsiteX9" fmla="*/ 3387997 w 4558457"/>
                <a:gd name="connsiteY9" fmla="*/ 1151976 h 2847817"/>
                <a:gd name="connsiteX10" fmla="*/ 4112795 w 4558457"/>
                <a:gd name="connsiteY10" fmla="*/ 1509185 h 2847817"/>
                <a:gd name="connsiteX11" fmla="*/ 4306423 w 4558457"/>
                <a:gd name="connsiteY11" fmla="*/ 1706039 h 2847817"/>
                <a:gd name="connsiteX12" fmla="*/ 4558429 w 4558457"/>
                <a:gd name="connsiteY12" fmla="*/ 2575733 h 2847817"/>
                <a:gd name="connsiteX13" fmla="*/ 3783266 w 4558457"/>
                <a:gd name="connsiteY13" fmla="*/ 2221439 h 2847817"/>
                <a:gd name="connsiteX14" fmla="*/ 3496632 w 4558457"/>
                <a:gd name="connsiteY14" fmla="*/ 2233324 h 2847817"/>
                <a:gd name="connsiteX15" fmla="*/ 3272955 w 4558457"/>
                <a:gd name="connsiteY15" fmla="*/ 2327035 h 2847817"/>
                <a:gd name="connsiteX16" fmla="*/ 2865963 w 4558457"/>
                <a:gd name="connsiteY16" fmla="*/ 2719246 h 2847817"/>
                <a:gd name="connsiteX17" fmla="*/ 1782531 w 4558457"/>
                <a:gd name="connsiteY17" fmla="*/ 2846717 h 2847817"/>
                <a:gd name="connsiteX18" fmla="*/ 1046144 w 4558457"/>
                <a:gd name="connsiteY18" fmla="*/ 2790725 h 2847817"/>
                <a:gd name="connsiteX19" fmla="*/ 344 w 4558457"/>
                <a:gd name="connsiteY19" fmla="*/ 2571107 h 2847817"/>
                <a:gd name="connsiteX0" fmla="*/ 361 w 4558474"/>
                <a:gd name="connsiteY0" fmla="*/ 2571107 h 2847817"/>
                <a:gd name="connsiteX1" fmla="*/ 949226 w 4558474"/>
                <a:gd name="connsiteY1" fmla="*/ 2124633 h 2847817"/>
                <a:gd name="connsiteX2" fmla="*/ 1347400 w 4558474"/>
                <a:gd name="connsiteY2" fmla="*/ 1832280 h 2847817"/>
                <a:gd name="connsiteX3" fmla="*/ 1603460 w 4558474"/>
                <a:gd name="connsiteY3" fmla="*/ 1356759 h 2847817"/>
                <a:gd name="connsiteX4" fmla="*/ 2279465 w 4558474"/>
                <a:gd name="connsiteY4" fmla="*/ 1258132 h 2847817"/>
                <a:gd name="connsiteX5" fmla="*/ 2770571 w 4558474"/>
                <a:gd name="connsiteY5" fmla="*/ 883624 h 2847817"/>
                <a:gd name="connsiteX6" fmla="*/ 3056128 w 4558474"/>
                <a:gd name="connsiteY6" fmla="*/ 434790 h 2847817"/>
                <a:gd name="connsiteX7" fmla="*/ 3173172 w 4558474"/>
                <a:gd name="connsiteY7" fmla="*/ 2496 h 2847817"/>
                <a:gd name="connsiteX8" fmla="*/ 3214414 w 4558474"/>
                <a:gd name="connsiteY8" fmla="*/ 637911 h 2847817"/>
                <a:gd name="connsiteX9" fmla="*/ 3388014 w 4558474"/>
                <a:gd name="connsiteY9" fmla="*/ 1151976 h 2847817"/>
                <a:gd name="connsiteX10" fmla="*/ 4112812 w 4558474"/>
                <a:gd name="connsiteY10" fmla="*/ 1509185 h 2847817"/>
                <a:gd name="connsiteX11" fmla="*/ 4306440 w 4558474"/>
                <a:gd name="connsiteY11" fmla="*/ 1706039 h 2847817"/>
                <a:gd name="connsiteX12" fmla="*/ 4558446 w 4558474"/>
                <a:gd name="connsiteY12" fmla="*/ 2575733 h 2847817"/>
                <a:gd name="connsiteX13" fmla="*/ 3783283 w 4558474"/>
                <a:gd name="connsiteY13" fmla="*/ 2221439 h 2847817"/>
                <a:gd name="connsiteX14" fmla="*/ 3496649 w 4558474"/>
                <a:gd name="connsiteY14" fmla="*/ 2233324 h 2847817"/>
                <a:gd name="connsiteX15" fmla="*/ 3272972 w 4558474"/>
                <a:gd name="connsiteY15" fmla="*/ 2327035 h 2847817"/>
                <a:gd name="connsiteX16" fmla="*/ 2865980 w 4558474"/>
                <a:gd name="connsiteY16" fmla="*/ 2719246 h 2847817"/>
                <a:gd name="connsiteX17" fmla="*/ 1782548 w 4558474"/>
                <a:gd name="connsiteY17" fmla="*/ 2846717 h 2847817"/>
                <a:gd name="connsiteX18" fmla="*/ 1046161 w 4558474"/>
                <a:gd name="connsiteY18" fmla="*/ 2790725 h 2847817"/>
                <a:gd name="connsiteX19" fmla="*/ 361 w 4558474"/>
                <a:gd name="connsiteY19" fmla="*/ 2571107 h 2847817"/>
                <a:gd name="connsiteX0" fmla="*/ 520 w 4558633"/>
                <a:gd name="connsiteY0" fmla="*/ 2571107 h 2847817"/>
                <a:gd name="connsiteX1" fmla="*/ 931402 w 4558633"/>
                <a:gd name="connsiteY1" fmla="*/ 2146192 h 2847817"/>
                <a:gd name="connsiteX2" fmla="*/ 1347559 w 4558633"/>
                <a:gd name="connsiteY2" fmla="*/ 1832280 h 2847817"/>
                <a:gd name="connsiteX3" fmla="*/ 1603619 w 4558633"/>
                <a:gd name="connsiteY3" fmla="*/ 1356759 h 2847817"/>
                <a:gd name="connsiteX4" fmla="*/ 2279624 w 4558633"/>
                <a:gd name="connsiteY4" fmla="*/ 1258132 h 2847817"/>
                <a:gd name="connsiteX5" fmla="*/ 2770730 w 4558633"/>
                <a:gd name="connsiteY5" fmla="*/ 883624 h 2847817"/>
                <a:gd name="connsiteX6" fmla="*/ 3056287 w 4558633"/>
                <a:gd name="connsiteY6" fmla="*/ 434790 h 2847817"/>
                <a:gd name="connsiteX7" fmla="*/ 3173331 w 4558633"/>
                <a:gd name="connsiteY7" fmla="*/ 2496 h 2847817"/>
                <a:gd name="connsiteX8" fmla="*/ 3214573 w 4558633"/>
                <a:gd name="connsiteY8" fmla="*/ 637911 h 2847817"/>
                <a:gd name="connsiteX9" fmla="*/ 3388173 w 4558633"/>
                <a:gd name="connsiteY9" fmla="*/ 1151976 h 2847817"/>
                <a:gd name="connsiteX10" fmla="*/ 4112971 w 4558633"/>
                <a:gd name="connsiteY10" fmla="*/ 1509185 h 2847817"/>
                <a:gd name="connsiteX11" fmla="*/ 4306599 w 4558633"/>
                <a:gd name="connsiteY11" fmla="*/ 1706039 h 2847817"/>
                <a:gd name="connsiteX12" fmla="*/ 4558605 w 4558633"/>
                <a:gd name="connsiteY12" fmla="*/ 2575733 h 2847817"/>
                <a:gd name="connsiteX13" fmla="*/ 3783442 w 4558633"/>
                <a:gd name="connsiteY13" fmla="*/ 2221439 h 2847817"/>
                <a:gd name="connsiteX14" fmla="*/ 3496808 w 4558633"/>
                <a:gd name="connsiteY14" fmla="*/ 2233324 h 2847817"/>
                <a:gd name="connsiteX15" fmla="*/ 3273131 w 4558633"/>
                <a:gd name="connsiteY15" fmla="*/ 2327035 h 2847817"/>
                <a:gd name="connsiteX16" fmla="*/ 2866139 w 4558633"/>
                <a:gd name="connsiteY16" fmla="*/ 2719246 h 2847817"/>
                <a:gd name="connsiteX17" fmla="*/ 1782707 w 4558633"/>
                <a:gd name="connsiteY17" fmla="*/ 2846717 h 2847817"/>
                <a:gd name="connsiteX18" fmla="*/ 1046320 w 4558633"/>
                <a:gd name="connsiteY18" fmla="*/ 2790725 h 2847817"/>
                <a:gd name="connsiteX19" fmla="*/ 520 w 4558633"/>
                <a:gd name="connsiteY19" fmla="*/ 2571107 h 2847817"/>
                <a:gd name="connsiteX0" fmla="*/ 520 w 4558633"/>
                <a:gd name="connsiteY0" fmla="*/ 2571107 h 2847817"/>
                <a:gd name="connsiteX1" fmla="*/ 931402 w 4558633"/>
                <a:gd name="connsiteY1" fmla="*/ 2146192 h 2847817"/>
                <a:gd name="connsiteX2" fmla="*/ 1347559 w 4558633"/>
                <a:gd name="connsiteY2" fmla="*/ 1832280 h 2847817"/>
                <a:gd name="connsiteX3" fmla="*/ 1603619 w 4558633"/>
                <a:gd name="connsiteY3" fmla="*/ 1356759 h 2847817"/>
                <a:gd name="connsiteX4" fmla="*/ 2279624 w 4558633"/>
                <a:gd name="connsiteY4" fmla="*/ 1258132 h 2847817"/>
                <a:gd name="connsiteX5" fmla="*/ 2770730 w 4558633"/>
                <a:gd name="connsiteY5" fmla="*/ 883624 h 2847817"/>
                <a:gd name="connsiteX6" fmla="*/ 3056287 w 4558633"/>
                <a:gd name="connsiteY6" fmla="*/ 434790 h 2847817"/>
                <a:gd name="connsiteX7" fmla="*/ 3173331 w 4558633"/>
                <a:gd name="connsiteY7" fmla="*/ 2496 h 2847817"/>
                <a:gd name="connsiteX8" fmla="*/ 3214573 w 4558633"/>
                <a:gd name="connsiteY8" fmla="*/ 637911 h 2847817"/>
                <a:gd name="connsiteX9" fmla="*/ 3388173 w 4558633"/>
                <a:gd name="connsiteY9" fmla="*/ 1151976 h 2847817"/>
                <a:gd name="connsiteX10" fmla="*/ 4112971 w 4558633"/>
                <a:gd name="connsiteY10" fmla="*/ 1509185 h 2847817"/>
                <a:gd name="connsiteX11" fmla="*/ 4306599 w 4558633"/>
                <a:gd name="connsiteY11" fmla="*/ 1706039 h 2847817"/>
                <a:gd name="connsiteX12" fmla="*/ 4558605 w 4558633"/>
                <a:gd name="connsiteY12" fmla="*/ 2575733 h 2847817"/>
                <a:gd name="connsiteX13" fmla="*/ 3783442 w 4558633"/>
                <a:gd name="connsiteY13" fmla="*/ 2221439 h 2847817"/>
                <a:gd name="connsiteX14" fmla="*/ 3496808 w 4558633"/>
                <a:gd name="connsiteY14" fmla="*/ 2233324 h 2847817"/>
                <a:gd name="connsiteX15" fmla="*/ 3273131 w 4558633"/>
                <a:gd name="connsiteY15" fmla="*/ 2327035 h 2847817"/>
                <a:gd name="connsiteX16" fmla="*/ 2866139 w 4558633"/>
                <a:gd name="connsiteY16" fmla="*/ 2719246 h 2847817"/>
                <a:gd name="connsiteX17" fmla="*/ 1782707 w 4558633"/>
                <a:gd name="connsiteY17" fmla="*/ 2846717 h 2847817"/>
                <a:gd name="connsiteX18" fmla="*/ 1046320 w 4558633"/>
                <a:gd name="connsiteY18" fmla="*/ 2790725 h 2847817"/>
                <a:gd name="connsiteX19" fmla="*/ 520 w 4558633"/>
                <a:gd name="connsiteY19" fmla="*/ 2571107 h 2847817"/>
                <a:gd name="connsiteX0" fmla="*/ 0 w 4558113"/>
                <a:gd name="connsiteY0" fmla="*/ 2571107 h 2847817"/>
                <a:gd name="connsiteX1" fmla="*/ 930882 w 4558113"/>
                <a:gd name="connsiteY1" fmla="*/ 2146192 h 2847817"/>
                <a:gd name="connsiteX2" fmla="*/ 1347039 w 4558113"/>
                <a:gd name="connsiteY2" fmla="*/ 1832280 h 2847817"/>
                <a:gd name="connsiteX3" fmla="*/ 1603099 w 4558113"/>
                <a:gd name="connsiteY3" fmla="*/ 1356759 h 2847817"/>
                <a:gd name="connsiteX4" fmla="*/ 2279104 w 4558113"/>
                <a:gd name="connsiteY4" fmla="*/ 1258132 h 2847817"/>
                <a:gd name="connsiteX5" fmla="*/ 2770210 w 4558113"/>
                <a:gd name="connsiteY5" fmla="*/ 883624 h 2847817"/>
                <a:gd name="connsiteX6" fmla="*/ 3055767 w 4558113"/>
                <a:gd name="connsiteY6" fmla="*/ 434790 h 2847817"/>
                <a:gd name="connsiteX7" fmla="*/ 3172811 w 4558113"/>
                <a:gd name="connsiteY7" fmla="*/ 2496 h 2847817"/>
                <a:gd name="connsiteX8" fmla="*/ 3214053 w 4558113"/>
                <a:gd name="connsiteY8" fmla="*/ 637911 h 2847817"/>
                <a:gd name="connsiteX9" fmla="*/ 3387653 w 4558113"/>
                <a:gd name="connsiteY9" fmla="*/ 1151976 h 2847817"/>
                <a:gd name="connsiteX10" fmla="*/ 4112451 w 4558113"/>
                <a:gd name="connsiteY10" fmla="*/ 1509185 h 2847817"/>
                <a:gd name="connsiteX11" fmla="*/ 4306079 w 4558113"/>
                <a:gd name="connsiteY11" fmla="*/ 1706039 h 2847817"/>
                <a:gd name="connsiteX12" fmla="*/ 4558085 w 4558113"/>
                <a:gd name="connsiteY12" fmla="*/ 2575733 h 2847817"/>
                <a:gd name="connsiteX13" fmla="*/ 3782922 w 4558113"/>
                <a:gd name="connsiteY13" fmla="*/ 2221439 h 2847817"/>
                <a:gd name="connsiteX14" fmla="*/ 3496288 w 4558113"/>
                <a:gd name="connsiteY14" fmla="*/ 2233324 h 2847817"/>
                <a:gd name="connsiteX15" fmla="*/ 3272611 w 4558113"/>
                <a:gd name="connsiteY15" fmla="*/ 2327035 h 2847817"/>
                <a:gd name="connsiteX16" fmla="*/ 2865619 w 4558113"/>
                <a:gd name="connsiteY16" fmla="*/ 2719246 h 2847817"/>
                <a:gd name="connsiteX17" fmla="*/ 1782187 w 4558113"/>
                <a:gd name="connsiteY17" fmla="*/ 2846717 h 2847817"/>
                <a:gd name="connsiteX18" fmla="*/ 1045800 w 4558113"/>
                <a:gd name="connsiteY18" fmla="*/ 2790725 h 2847817"/>
                <a:gd name="connsiteX19" fmla="*/ 0 w 4558113"/>
                <a:gd name="connsiteY19" fmla="*/ 2571107 h 2847817"/>
                <a:gd name="connsiteX0" fmla="*/ 0 w 4558113"/>
                <a:gd name="connsiteY0" fmla="*/ 2571107 h 2847817"/>
                <a:gd name="connsiteX1" fmla="*/ 850780 w 4558113"/>
                <a:gd name="connsiteY1" fmla="*/ 2195366 h 2847817"/>
                <a:gd name="connsiteX2" fmla="*/ 1347039 w 4558113"/>
                <a:gd name="connsiteY2" fmla="*/ 1832280 h 2847817"/>
                <a:gd name="connsiteX3" fmla="*/ 1603099 w 4558113"/>
                <a:gd name="connsiteY3" fmla="*/ 1356759 h 2847817"/>
                <a:gd name="connsiteX4" fmla="*/ 2279104 w 4558113"/>
                <a:gd name="connsiteY4" fmla="*/ 1258132 h 2847817"/>
                <a:gd name="connsiteX5" fmla="*/ 2770210 w 4558113"/>
                <a:gd name="connsiteY5" fmla="*/ 883624 h 2847817"/>
                <a:gd name="connsiteX6" fmla="*/ 3055767 w 4558113"/>
                <a:gd name="connsiteY6" fmla="*/ 434790 h 2847817"/>
                <a:gd name="connsiteX7" fmla="*/ 3172811 w 4558113"/>
                <a:gd name="connsiteY7" fmla="*/ 2496 h 2847817"/>
                <a:gd name="connsiteX8" fmla="*/ 3214053 w 4558113"/>
                <a:gd name="connsiteY8" fmla="*/ 637911 h 2847817"/>
                <a:gd name="connsiteX9" fmla="*/ 3387653 w 4558113"/>
                <a:gd name="connsiteY9" fmla="*/ 1151976 h 2847817"/>
                <a:gd name="connsiteX10" fmla="*/ 4112451 w 4558113"/>
                <a:gd name="connsiteY10" fmla="*/ 1509185 h 2847817"/>
                <a:gd name="connsiteX11" fmla="*/ 4306079 w 4558113"/>
                <a:gd name="connsiteY11" fmla="*/ 1706039 h 2847817"/>
                <a:gd name="connsiteX12" fmla="*/ 4558085 w 4558113"/>
                <a:gd name="connsiteY12" fmla="*/ 2575733 h 2847817"/>
                <a:gd name="connsiteX13" fmla="*/ 3782922 w 4558113"/>
                <a:gd name="connsiteY13" fmla="*/ 2221439 h 2847817"/>
                <a:gd name="connsiteX14" fmla="*/ 3496288 w 4558113"/>
                <a:gd name="connsiteY14" fmla="*/ 2233324 h 2847817"/>
                <a:gd name="connsiteX15" fmla="*/ 3272611 w 4558113"/>
                <a:gd name="connsiteY15" fmla="*/ 2327035 h 2847817"/>
                <a:gd name="connsiteX16" fmla="*/ 2865619 w 4558113"/>
                <a:gd name="connsiteY16" fmla="*/ 2719246 h 2847817"/>
                <a:gd name="connsiteX17" fmla="*/ 1782187 w 4558113"/>
                <a:gd name="connsiteY17" fmla="*/ 2846717 h 2847817"/>
                <a:gd name="connsiteX18" fmla="*/ 1045800 w 4558113"/>
                <a:gd name="connsiteY18" fmla="*/ 2790725 h 2847817"/>
                <a:gd name="connsiteX19" fmla="*/ 0 w 4558113"/>
                <a:gd name="connsiteY19" fmla="*/ 2571107 h 2847817"/>
                <a:gd name="connsiteX0" fmla="*/ 0 w 4558113"/>
                <a:gd name="connsiteY0" fmla="*/ 2571107 h 2847817"/>
                <a:gd name="connsiteX1" fmla="*/ 823254 w 4558113"/>
                <a:gd name="connsiteY1" fmla="*/ 2210228 h 2847817"/>
                <a:gd name="connsiteX2" fmla="*/ 1347039 w 4558113"/>
                <a:gd name="connsiteY2" fmla="*/ 1832280 h 2847817"/>
                <a:gd name="connsiteX3" fmla="*/ 1603099 w 4558113"/>
                <a:gd name="connsiteY3" fmla="*/ 1356759 h 2847817"/>
                <a:gd name="connsiteX4" fmla="*/ 2279104 w 4558113"/>
                <a:gd name="connsiteY4" fmla="*/ 1258132 h 2847817"/>
                <a:gd name="connsiteX5" fmla="*/ 2770210 w 4558113"/>
                <a:gd name="connsiteY5" fmla="*/ 883624 h 2847817"/>
                <a:gd name="connsiteX6" fmla="*/ 3055767 w 4558113"/>
                <a:gd name="connsiteY6" fmla="*/ 434790 h 2847817"/>
                <a:gd name="connsiteX7" fmla="*/ 3172811 w 4558113"/>
                <a:gd name="connsiteY7" fmla="*/ 2496 h 2847817"/>
                <a:gd name="connsiteX8" fmla="*/ 3214053 w 4558113"/>
                <a:gd name="connsiteY8" fmla="*/ 637911 h 2847817"/>
                <a:gd name="connsiteX9" fmla="*/ 3387653 w 4558113"/>
                <a:gd name="connsiteY9" fmla="*/ 1151976 h 2847817"/>
                <a:gd name="connsiteX10" fmla="*/ 4112451 w 4558113"/>
                <a:gd name="connsiteY10" fmla="*/ 1509185 h 2847817"/>
                <a:gd name="connsiteX11" fmla="*/ 4306079 w 4558113"/>
                <a:gd name="connsiteY11" fmla="*/ 1706039 h 2847817"/>
                <a:gd name="connsiteX12" fmla="*/ 4558085 w 4558113"/>
                <a:gd name="connsiteY12" fmla="*/ 2575733 h 2847817"/>
                <a:gd name="connsiteX13" fmla="*/ 3782922 w 4558113"/>
                <a:gd name="connsiteY13" fmla="*/ 2221439 h 2847817"/>
                <a:gd name="connsiteX14" fmla="*/ 3496288 w 4558113"/>
                <a:gd name="connsiteY14" fmla="*/ 2233324 h 2847817"/>
                <a:gd name="connsiteX15" fmla="*/ 3272611 w 4558113"/>
                <a:gd name="connsiteY15" fmla="*/ 2327035 h 2847817"/>
                <a:gd name="connsiteX16" fmla="*/ 2865619 w 4558113"/>
                <a:gd name="connsiteY16" fmla="*/ 2719246 h 2847817"/>
                <a:gd name="connsiteX17" fmla="*/ 1782187 w 4558113"/>
                <a:gd name="connsiteY17" fmla="*/ 2846717 h 2847817"/>
                <a:gd name="connsiteX18" fmla="*/ 1045800 w 4558113"/>
                <a:gd name="connsiteY18" fmla="*/ 2790725 h 2847817"/>
                <a:gd name="connsiteX19" fmla="*/ 0 w 4558113"/>
                <a:gd name="connsiteY19" fmla="*/ 2571107 h 2847817"/>
                <a:gd name="connsiteX0" fmla="*/ 0 w 4558113"/>
                <a:gd name="connsiteY0" fmla="*/ 2571107 h 2847817"/>
                <a:gd name="connsiteX1" fmla="*/ 823254 w 4558113"/>
                <a:gd name="connsiteY1" fmla="*/ 2210228 h 2847817"/>
                <a:gd name="connsiteX2" fmla="*/ 1347039 w 4558113"/>
                <a:gd name="connsiteY2" fmla="*/ 1832280 h 2847817"/>
                <a:gd name="connsiteX3" fmla="*/ 1603099 w 4558113"/>
                <a:gd name="connsiteY3" fmla="*/ 1356759 h 2847817"/>
                <a:gd name="connsiteX4" fmla="*/ 2279104 w 4558113"/>
                <a:gd name="connsiteY4" fmla="*/ 1258132 h 2847817"/>
                <a:gd name="connsiteX5" fmla="*/ 2770210 w 4558113"/>
                <a:gd name="connsiteY5" fmla="*/ 883624 h 2847817"/>
                <a:gd name="connsiteX6" fmla="*/ 3055767 w 4558113"/>
                <a:gd name="connsiteY6" fmla="*/ 434790 h 2847817"/>
                <a:gd name="connsiteX7" fmla="*/ 3172811 w 4558113"/>
                <a:gd name="connsiteY7" fmla="*/ 2496 h 2847817"/>
                <a:gd name="connsiteX8" fmla="*/ 3214053 w 4558113"/>
                <a:gd name="connsiteY8" fmla="*/ 637911 h 2847817"/>
                <a:gd name="connsiteX9" fmla="*/ 3387653 w 4558113"/>
                <a:gd name="connsiteY9" fmla="*/ 1151976 h 2847817"/>
                <a:gd name="connsiteX10" fmla="*/ 4112451 w 4558113"/>
                <a:gd name="connsiteY10" fmla="*/ 1509185 h 2847817"/>
                <a:gd name="connsiteX11" fmla="*/ 4306079 w 4558113"/>
                <a:gd name="connsiteY11" fmla="*/ 1706039 h 2847817"/>
                <a:gd name="connsiteX12" fmla="*/ 4558085 w 4558113"/>
                <a:gd name="connsiteY12" fmla="*/ 2575733 h 2847817"/>
                <a:gd name="connsiteX13" fmla="*/ 3782922 w 4558113"/>
                <a:gd name="connsiteY13" fmla="*/ 2221439 h 2847817"/>
                <a:gd name="connsiteX14" fmla="*/ 3496288 w 4558113"/>
                <a:gd name="connsiteY14" fmla="*/ 2233324 h 2847817"/>
                <a:gd name="connsiteX15" fmla="*/ 3272611 w 4558113"/>
                <a:gd name="connsiteY15" fmla="*/ 2327035 h 2847817"/>
                <a:gd name="connsiteX16" fmla="*/ 2865619 w 4558113"/>
                <a:gd name="connsiteY16" fmla="*/ 2719246 h 2847817"/>
                <a:gd name="connsiteX17" fmla="*/ 1782187 w 4558113"/>
                <a:gd name="connsiteY17" fmla="*/ 2846717 h 2847817"/>
                <a:gd name="connsiteX18" fmla="*/ 1045800 w 4558113"/>
                <a:gd name="connsiteY18" fmla="*/ 2790725 h 2847817"/>
                <a:gd name="connsiteX19" fmla="*/ 0 w 4558113"/>
                <a:gd name="connsiteY19" fmla="*/ 2571107 h 2847817"/>
                <a:gd name="connsiteX0" fmla="*/ 0 w 4558113"/>
                <a:gd name="connsiteY0" fmla="*/ 2571107 h 2847817"/>
                <a:gd name="connsiteX1" fmla="*/ 823254 w 4558113"/>
                <a:gd name="connsiteY1" fmla="*/ 2210228 h 2847817"/>
                <a:gd name="connsiteX2" fmla="*/ 1347039 w 4558113"/>
                <a:gd name="connsiteY2" fmla="*/ 1832280 h 2847817"/>
                <a:gd name="connsiteX3" fmla="*/ 1603099 w 4558113"/>
                <a:gd name="connsiteY3" fmla="*/ 1356759 h 2847817"/>
                <a:gd name="connsiteX4" fmla="*/ 2279104 w 4558113"/>
                <a:gd name="connsiteY4" fmla="*/ 1258132 h 2847817"/>
                <a:gd name="connsiteX5" fmla="*/ 2770210 w 4558113"/>
                <a:gd name="connsiteY5" fmla="*/ 883624 h 2847817"/>
                <a:gd name="connsiteX6" fmla="*/ 3055767 w 4558113"/>
                <a:gd name="connsiteY6" fmla="*/ 434790 h 2847817"/>
                <a:gd name="connsiteX7" fmla="*/ 3172811 w 4558113"/>
                <a:gd name="connsiteY7" fmla="*/ 2496 h 2847817"/>
                <a:gd name="connsiteX8" fmla="*/ 3214053 w 4558113"/>
                <a:gd name="connsiteY8" fmla="*/ 637911 h 2847817"/>
                <a:gd name="connsiteX9" fmla="*/ 3387653 w 4558113"/>
                <a:gd name="connsiteY9" fmla="*/ 1151976 h 2847817"/>
                <a:gd name="connsiteX10" fmla="*/ 4112451 w 4558113"/>
                <a:gd name="connsiteY10" fmla="*/ 1509185 h 2847817"/>
                <a:gd name="connsiteX11" fmla="*/ 4306079 w 4558113"/>
                <a:gd name="connsiteY11" fmla="*/ 1706039 h 2847817"/>
                <a:gd name="connsiteX12" fmla="*/ 4558085 w 4558113"/>
                <a:gd name="connsiteY12" fmla="*/ 2575733 h 2847817"/>
                <a:gd name="connsiteX13" fmla="*/ 3782922 w 4558113"/>
                <a:gd name="connsiteY13" fmla="*/ 2221439 h 2847817"/>
                <a:gd name="connsiteX14" fmla="*/ 3496288 w 4558113"/>
                <a:gd name="connsiteY14" fmla="*/ 2233324 h 2847817"/>
                <a:gd name="connsiteX15" fmla="*/ 3272611 w 4558113"/>
                <a:gd name="connsiteY15" fmla="*/ 2327035 h 2847817"/>
                <a:gd name="connsiteX16" fmla="*/ 2865619 w 4558113"/>
                <a:gd name="connsiteY16" fmla="*/ 2719246 h 2847817"/>
                <a:gd name="connsiteX17" fmla="*/ 1782187 w 4558113"/>
                <a:gd name="connsiteY17" fmla="*/ 2846717 h 2847817"/>
                <a:gd name="connsiteX18" fmla="*/ 1045800 w 4558113"/>
                <a:gd name="connsiteY18" fmla="*/ 2790725 h 2847817"/>
                <a:gd name="connsiteX19" fmla="*/ 0 w 4558113"/>
                <a:gd name="connsiteY19" fmla="*/ 2571107 h 2847817"/>
                <a:gd name="connsiteX0" fmla="*/ 0 w 4558113"/>
                <a:gd name="connsiteY0" fmla="*/ 2571107 h 2847817"/>
                <a:gd name="connsiteX1" fmla="*/ 823254 w 4558113"/>
                <a:gd name="connsiteY1" fmla="*/ 2210228 h 2847817"/>
                <a:gd name="connsiteX2" fmla="*/ 1347039 w 4558113"/>
                <a:gd name="connsiteY2" fmla="*/ 1832280 h 2847817"/>
                <a:gd name="connsiteX3" fmla="*/ 1603099 w 4558113"/>
                <a:gd name="connsiteY3" fmla="*/ 1356759 h 2847817"/>
                <a:gd name="connsiteX4" fmla="*/ 2279104 w 4558113"/>
                <a:gd name="connsiteY4" fmla="*/ 1258132 h 2847817"/>
                <a:gd name="connsiteX5" fmla="*/ 2770210 w 4558113"/>
                <a:gd name="connsiteY5" fmla="*/ 883624 h 2847817"/>
                <a:gd name="connsiteX6" fmla="*/ 3055767 w 4558113"/>
                <a:gd name="connsiteY6" fmla="*/ 434790 h 2847817"/>
                <a:gd name="connsiteX7" fmla="*/ 3172811 w 4558113"/>
                <a:gd name="connsiteY7" fmla="*/ 2496 h 2847817"/>
                <a:gd name="connsiteX8" fmla="*/ 3214053 w 4558113"/>
                <a:gd name="connsiteY8" fmla="*/ 637911 h 2847817"/>
                <a:gd name="connsiteX9" fmla="*/ 3387653 w 4558113"/>
                <a:gd name="connsiteY9" fmla="*/ 1151976 h 2847817"/>
                <a:gd name="connsiteX10" fmla="*/ 4112451 w 4558113"/>
                <a:gd name="connsiteY10" fmla="*/ 1509185 h 2847817"/>
                <a:gd name="connsiteX11" fmla="*/ 4306079 w 4558113"/>
                <a:gd name="connsiteY11" fmla="*/ 1706039 h 2847817"/>
                <a:gd name="connsiteX12" fmla="*/ 4558085 w 4558113"/>
                <a:gd name="connsiteY12" fmla="*/ 2575733 h 2847817"/>
                <a:gd name="connsiteX13" fmla="*/ 3782922 w 4558113"/>
                <a:gd name="connsiteY13" fmla="*/ 2221439 h 2847817"/>
                <a:gd name="connsiteX14" fmla="*/ 3496288 w 4558113"/>
                <a:gd name="connsiteY14" fmla="*/ 2233324 h 2847817"/>
                <a:gd name="connsiteX15" fmla="*/ 3272611 w 4558113"/>
                <a:gd name="connsiteY15" fmla="*/ 2327035 h 2847817"/>
                <a:gd name="connsiteX16" fmla="*/ 2865619 w 4558113"/>
                <a:gd name="connsiteY16" fmla="*/ 2719246 h 2847817"/>
                <a:gd name="connsiteX17" fmla="*/ 1782187 w 4558113"/>
                <a:gd name="connsiteY17" fmla="*/ 2846717 h 2847817"/>
                <a:gd name="connsiteX18" fmla="*/ 1045800 w 4558113"/>
                <a:gd name="connsiteY18" fmla="*/ 2790725 h 2847817"/>
                <a:gd name="connsiteX19" fmla="*/ 0 w 4558113"/>
                <a:gd name="connsiteY19" fmla="*/ 2571107 h 2847817"/>
                <a:gd name="connsiteX0" fmla="*/ 0 w 4558113"/>
                <a:gd name="connsiteY0" fmla="*/ 2571107 h 2847817"/>
                <a:gd name="connsiteX1" fmla="*/ 823254 w 4558113"/>
                <a:gd name="connsiteY1" fmla="*/ 2210228 h 2847817"/>
                <a:gd name="connsiteX2" fmla="*/ 1347039 w 4558113"/>
                <a:gd name="connsiteY2" fmla="*/ 1832280 h 2847817"/>
                <a:gd name="connsiteX3" fmla="*/ 1603099 w 4558113"/>
                <a:gd name="connsiteY3" fmla="*/ 1356759 h 2847817"/>
                <a:gd name="connsiteX4" fmla="*/ 2279104 w 4558113"/>
                <a:gd name="connsiteY4" fmla="*/ 1258132 h 2847817"/>
                <a:gd name="connsiteX5" fmla="*/ 2770210 w 4558113"/>
                <a:gd name="connsiteY5" fmla="*/ 883624 h 2847817"/>
                <a:gd name="connsiteX6" fmla="*/ 3055767 w 4558113"/>
                <a:gd name="connsiteY6" fmla="*/ 434790 h 2847817"/>
                <a:gd name="connsiteX7" fmla="*/ 3172811 w 4558113"/>
                <a:gd name="connsiteY7" fmla="*/ 2496 h 2847817"/>
                <a:gd name="connsiteX8" fmla="*/ 3214053 w 4558113"/>
                <a:gd name="connsiteY8" fmla="*/ 637911 h 2847817"/>
                <a:gd name="connsiteX9" fmla="*/ 3387653 w 4558113"/>
                <a:gd name="connsiteY9" fmla="*/ 1151976 h 2847817"/>
                <a:gd name="connsiteX10" fmla="*/ 4112451 w 4558113"/>
                <a:gd name="connsiteY10" fmla="*/ 1509185 h 2847817"/>
                <a:gd name="connsiteX11" fmla="*/ 4306079 w 4558113"/>
                <a:gd name="connsiteY11" fmla="*/ 1706039 h 2847817"/>
                <a:gd name="connsiteX12" fmla="*/ 4558085 w 4558113"/>
                <a:gd name="connsiteY12" fmla="*/ 2575733 h 2847817"/>
                <a:gd name="connsiteX13" fmla="*/ 3782922 w 4558113"/>
                <a:gd name="connsiteY13" fmla="*/ 2221439 h 2847817"/>
                <a:gd name="connsiteX14" fmla="*/ 3496288 w 4558113"/>
                <a:gd name="connsiteY14" fmla="*/ 2233324 h 2847817"/>
                <a:gd name="connsiteX15" fmla="*/ 3272611 w 4558113"/>
                <a:gd name="connsiteY15" fmla="*/ 2327035 h 2847817"/>
                <a:gd name="connsiteX16" fmla="*/ 2865619 w 4558113"/>
                <a:gd name="connsiteY16" fmla="*/ 2719246 h 2847817"/>
                <a:gd name="connsiteX17" fmla="*/ 1782187 w 4558113"/>
                <a:gd name="connsiteY17" fmla="*/ 2846717 h 2847817"/>
                <a:gd name="connsiteX18" fmla="*/ 1045800 w 4558113"/>
                <a:gd name="connsiteY18" fmla="*/ 2790725 h 2847817"/>
                <a:gd name="connsiteX19" fmla="*/ 0 w 4558113"/>
                <a:gd name="connsiteY19" fmla="*/ 2571107 h 2847817"/>
                <a:gd name="connsiteX0" fmla="*/ 0 w 4558113"/>
                <a:gd name="connsiteY0" fmla="*/ 2571107 h 2847817"/>
                <a:gd name="connsiteX1" fmla="*/ 823254 w 4558113"/>
                <a:gd name="connsiteY1" fmla="*/ 2210228 h 2847817"/>
                <a:gd name="connsiteX2" fmla="*/ 1347039 w 4558113"/>
                <a:gd name="connsiteY2" fmla="*/ 1832280 h 2847817"/>
                <a:gd name="connsiteX3" fmla="*/ 1603099 w 4558113"/>
                <a:gd name="connsiteY3" fmla="*/ 1356759 h 2847817"/>
                <a:gd name="connsiteX4" fmla="*/ 2279104 w 4558113"/>
                <a:gd name="connsiteY4" fmla="*/ 1258132 h 2847817"/>
                <a:gd name="connsiteX5" fmla="*/ 2770210 w 4558113"/>
                <a:gd name="connsiteY5" fmla="*/ 883624 h 2847817"/>
                <a:gd name="connsiteX6" fmla="*/ 3055767 w 4558113"/>
                <a:gd name="connsiteY6" fmla="*/ 434790 h 2847817"/>
                <a:gd name="connsiteX7" fmla="*/ 3172811 w 4558113"/>
                <a:gd name="connsiteY7" fmla="*/ 2496 h 2847817"/>
                <a:gd name="connsiteX8" fmla="*/ 3214053 w 4558113"/>
                <a:gd name="connsiteY8" fmla="*/ 637911 h 2847817"/>
                <a:gd name="connsiteX9" fmla="*/ 3387653 w 4558113"/>
                <a:gd name="connsiteY9" fmla="*/ 1151976 h 2847817"/>
                <a:gd name="connsiteX10" fmla="*/ 4112451 w 4558113"/>
                <a:gd name="connsiteY10" fmla="*/ 1509185 h 2847817"/>
                <a:gd name="connsiteX11" fmla="*/ 4306079 w 4558113"/>
                <a:gd name="connsiteY11" fmla="*/ 1706039 h 2847817"/>
                <a:gd name="connsiteX12" fmla="*/ 4558085 w 4558113"/>
                <a:gd name="connsiteY12" fmla="*/ 2575733 h 2847817"/>
                <a:gd name="connsiteX13" fmla="*/ 3782922 w 4558113"/>
                <a:gd name="connsiteY13" fmla="*/ 2221439 h 2847817"/>
                <a:gd name="connsiteX14" fmla="*/ 3496288 w 4558113"/>
                <a:gd name="connsiteY14" fmla="*/ 2233324 h 2847817"/>
                <a:gd name="connsiteX15" fmla="*/ 3272611 w 4558113"/>
                <a:gd name="connsiteY15" fmla="*/ 2327035 h 2847817"/>
                <a:gd name="connsiteX16" fmla="*/ 2865619 w 4558113"/>
                <a:gd name="connsiteY16" fmla="*/ 2719246 h 2847817"/>
                <a:gd name="connsiteX17" fmla="*/ 1782187 w 4558113"/>
                <a:gd name="connsiteY17" fmla="*/ 2846717 h 2847817"/>
                <a:gd name="connsiteX18" fmla="*/ 1045800 w 4558113"/>
                <a:gd name="connsiteY18" fmla="*/ 2790725 h 2847817"/>
                <a:gd name="connsiteX19" fmla="*/ 0 w 4558113"/>
                <a:gd name="connsiteY19" fmla="*/ 2571107 h 2847817"/>
                <a:gd name="connsiteX0" fmla="*/ 0 w 4558113"/>
                <a:gd name="connsiteY0" fmla="*/ 2571107 h 2847817"/>
                <a:gd name="connsiteX1" fmla="*/ 823254 w 4558113"/>
                <a:gd name="connsiteY1" fmla="*/ 2210228 h 2847817"/>
                <a:gd name="connsiteX2" fmla="*/ 1347039 w 4558113"/>
                <a:gd name="connsiteY2" fmla="*/ 1832280 h 2847817"/>
                <a:gd name="connsiteX3" fmla="*/ 1603099 w 4558113"/>
                <a:gd name="connsiteY3" fmla="*/ 1356759 h 2847817"/>
                <a:gd name="connsiteX4" fmla="*/ 2279104 w 4558113"/>
                <a:gd name="connsiteY4" fmla="*/ 1258132 h 2847817"/>
                <a:gd name="connsiteX5" fmla="*/ 2770210 w 4558113"/>
                <a:gd name="connsiteY5" fmla="*/ 883624 h 2847817"/>
                <a:gd name="connsiteX6" fmla="*/ 3055767 w 4558113"/>
                <a:gd name="connsiteY6" fmla="*/ 434790 h 2847817"/>
                <a:gd name="connsiteX7" fmla="*/ 3172811 w 4558113"/>
                <a:gd name="connsiteY7" fmla="*/ 2496 h 2847817"/>
                <a:gd name="connsiteX8" fmla="*/ 3214053 w 4558113"/>
                <a:gd name="connsiteY8" fmla="*/ 637911 h 2847817"/>
                <a:gd name="connsiteX9" fmla="*/ 3387653 w 4558113"/>
                <a:gd name="connsiteY9" fmla="*/ 1151976 h 2847817"/>
                <a:gd name="connsiteX10" fmla="*/ 4112451 w 4558113"/>
                <a:gd name="connsiteY10" fmla="*/ 1509185 h 2847817"/>
                <a:gd name="connsiteX11" fmla="*/ 4306079 w 4558113"/>
                <a:gd name="connsiteY11" fmla="*/ 1706039 h 2847817"/>
                <a:gd name="connsiteX12" fmla="*/ 4558085 w 4558113"/>
                <a:gd name="connsiteY12" fmla="*/ 2575733 h 2847817"/>
                <a:gd name="connsiteX13" fmla="*/ 3782922 w 4558113"/>
                <a:gd name="connsiteY13" fmla="*/ 2221439 h 2847817"/>
                <a:gd name="connsiteX14" fmla="*/ 3496288 w 4558113"/>
                <a:gd name="connsiteY14" fmla="*/ 2233324 h 2847817"/>
                <a:gd name="connsiteX15" fmla="*/ 3272611 w 4558113"/>
                <a:gd name="connsiteY15" fmla="*/ 2327035 h 2847817"/>
                <a:gd name="connsiteX16" fmla="*/ 2865619 w 4558113"/>
                <a:gd name="connsiteY16" fmla="*/ 2719246 h 2847817"/>
                <a:gd name="connsiteX17" fmla="*/ 1782187 w 4558113"/>
                <a:gd name="connsiteY17" fmla="*/ 2846717 h 2847817"/>
                <a:gd name="connsiteX18" fmla="*/ 1045800 w 4558113"/>
                <a:gd name="connsiteY18" fmla="*/ 2790725 h 2847817"/>
                <a:gd name="connsiteX19" fmla="*/ 0 w 4558113"/>
                <a:gd name="connsiteY19" fmla="*/ 2571107 h 2847817"/>
                <a:gd name="connsiteX0" fmla="*/ 0 w 4558113"/>
                <a:gd name="connsiteY0" fmla="*/ 2571107 h 2847817"/>
                <a:gd name="connsiteX1" fmla="*/ 823254 w 4558113"/>
                <a:gd name="connsiteY1" fmla="*/ 2210228 h 2847817"/>
                <a:gd name="connsiteX2" fmla="*/ 1347039 w 4558113"/>
                <a:gd name="connsiteY2" fmla="*/ 1832280 h 2847817"/>
                <a:gd name="connsiteX3" fmla="*/ 1603099 w 4558113"/>
                <a:gd name="connsiteY3" fmla="*/ 1356759 h 2847817"/>
                <a:gd name="connsiteX4" fmla="*/ 2279104 w 4558113"/>
                <a:gd name="connsiteY4" fmla="*/ 1258132 h 2847817"/>
                <a:gd name="connsiteX5" fmla="*/ 2770210 w 4558113"/>
                <a:gd name="connsiteY5" fmla="*/ 883624 h 2847817"/>
                <a:gd name="connsiteX6" fmla="*/ 3055767 w 4558113"/>
                <a:gd name="connsiteY6" fmla="*/ 434790 h 2847817"/>
                <a:gd name="connsiteX7" fmla="*/ 3172811 w 4558113"/>
                <a:gd name="connsiteY7" fmla="*/ 2496 h 2847817"/>
                <a:gd name="connsiteX8" fmla="*/ 3214053 w 4558113"/>
                <a:gd name="connsiteY8" fmla="*/ 637911 h 2847817"/>
                <a:gd name="connsiteX9" fmla="*/ 3387653 w 4558113"/>
                <a:gd name="connsiteY9" fmla="*/ 1151976 h 2847817"/>
                <a:gd name="connsiteX10" fmla="*/ 4112451 w 4558113"/>
                <a:gd name="connsiteY10" fmla="*/ 1509185 h 2847817"/>
                <a:gd name="connsiteX11" fmla="*/ 4306079 w 4558113"/>
                <a:gd name="connsiteY11" fmla="*/ 1706039 h 2847817"/>
                <a:gd name="connsiteX12" fmla="*/ 4558085 w 4558113"/>
                <a:gd name="connsiteY12" fmla="*/ 2575733 h 2847817"/>
                <a:gd name="connsiteX13" fmla="*/ 3782922 w 4558113"/>
                <a:gd name="connsiteY13" fmla="*/ 2221439 h 2847817"/>
                <a:gd name="connsiteX14" fmla="*/ 3496288 w 4558113"/>
                <a:gd name="connsiteY14" fmla="*/ 2233324 h 2847817"/>
                <a:gd name="connsiteX15" fmla="*/ 3272611 w 4558113"/>
                <a:gd name="connsiteY15" fmla="*/ 2327035 h 2847817"/>
                <a:gd name="connsiteX16" fmla="*/ 2865619 w 4558113"/>
                <a:gd name="connsiteY16" fmla="*/ 2719246 h 2847817"/>
                <a:gd name="connsiteX17" fmla="*/ 1782187 w 4558113"/>
                <a:gd name="connsiteY17" fmla="*/ 2846717 h 2847817"/>
                <a:gd name="connsiteX18" fmla="*/ 1045800 w 4558113"/>
                <a:gd name="connsiteY18" fmla="*/ 2790725 h 2847817"/>
                <a:gd name="connsiteX19" fmla="*/ 0 w 4558113"/>
                <a:gd name="connsiteY19" fmla="*/ 2571107 h 2847817"/>
                <a:gd name="connsiteX0" fmla="*/ 0 w 4558113"/>
                <a:gd name="connsiteY0" fmla="*/ 2571107 h 2847817"/>
                <a:gd name="connsiteX1" fmla="*/ 823254 w 4558113"/>
                <a:gd name="connsiteY1" fmla="*/ 2210228 h 2847817"/>
                <a:gd name="connsiteX2" fmla="*/ 1347039 w 4558113"/>
                <a:gd name="connsiteY2" fmla="*/ 1832280 h 2847817"/>
                <a:gd name="connsiteX3" fmla="*/ 1603099 w 4558113"/>
                <a:gd name="connsiteY3" fmla="*/ 1356759 h 2847817"/>
                <a:gd name="connsiteX4" fmla="*/ 2279104 w 4558113"/>
                <a:gd name="connsiteY4" fmla="*/ 1258132 h 2847817"/>
                <a:gd name="connsiteX5" fmla="*/ 2770210 w 4558113"/>
                <a:gd name="connsiteY5" fmla="*/ 883624 h 2847817"/>
                <a:gd name="connsiteX6" fmla="*/ 3055767 w 4558113"/>
                <a:gd name="connsiteY6" fmla="*/ 434790 h 2847817"/>
                <a:gd name="connsiteX7" fmla="*/ 3172811 w 4558113"/>
                <a:gd name="connsiteY7" fmla="*/ 2496 h 2847817"/>
                <a:gd name="connsiteX8" fmla="*/ 3214053 w 4558113"/>
                <a:gd name="connsiteY8" fmla="*/ 637911 h 2847817"/>
                <a:gd name="connsiteX9" fmla="*/ 3387653 w 4558113"/>
                <a:gd name="connsiteY9" fmla="*/ 1151976 h 2847817"/>
                <a:gd name="connsiteX10" fmla="*/ 4112451 w 4558113"/>
                <a:gd name="connsiteY10" fmla="*/ 1509185 h 2847817"/>
                <a:gd name="connsiteX11" fmla="*/ 4306079 w 4558113"/>
                <a:gd name="connsiteY11" fmla="*/ 1706039 h 2847817"/>
                <a:gd name="connsiteX12" fmla="*/ 4558085 w 4558113"/>
                <a:gd name="connsiteY12" fmla="*/ 2575733 h 2847817"/>
                <a:gd name="connsiteX13" fmla="*/ 3782922 w 4558113"/>
                <a:gd name="connsiteY13" fmla="*/ 2221439 h 2847817"/>
                <a:gd name="connsiteX14" fmla="*/ 3496288 w 4558113"/>
                <a:gd name="connsiteY14" fmla="*/ 2233324 h 2847817"/>
                <a:gd name="connsiteX15" fmla="*/ 3272611 w 4558113"/>
                <a:gd name="connsiteY15" fmla="*/ 2327035 h 2847817"/>
                <a:gd name="connsiteX16" fmla="*/ 2865619 w 4558113"/>
                <a:gd name="connsiteY16" fmla="*/ 2719246 h 2847817"/>
                <a:gd name="connsiteX17" fmla="*/ 1782187 w 4558113"/>
                <a:gd name="connsiteY17" fmla="*/ 2846717 h 2847817"/>
                <a:gd name="connsiteX18" fmla="*/ 1045800 w 4558113"/>
                <a:gd name="connsiteY18" fmla="*/ 2790725 h 2847817"/>
                <a:gd name="connsiteX19" fmla="*/ 0 w 4558113"/>
                <a:gd name="connsiteY19" fmla="*/ 2571107 h 2847817"/>
                <a:gd name="connsiteX0" fmla="*/ 0 w 4558113"/>
                <a:gd name="connsiteY0" fmla="*/ 2571107 h 2847817"/>
                <a:gd name="connsiteX1" fmla="*/ 820410 w 4558113"/>
                <a:gd name="connsiteY1" fmla="*/ 2193988 h 2847817"/>
                <a:gd name="connsiteX2" fmla="*/ 1347039 w 4558113"/>
                <a:gd name="connsiteY2" fmla="*/ 1832280 h 2847817"/>
                <a:gd name="connsiteX3" fmla="*/ 1603099 w 4558113"/>
                <a:gd name="connsiteY3" fmla="*/ 1356759 h 2847817"/>
                <a:gd name="connsiteX4" fmla="*/ 2279104 w 4558113"/>
                <a:gd name="connsiteY4" fmla="*/ 1258132 h 2847817"/>
                <a:gd name="connsiteX5" fmla="*/ 2770210 w 4558113"/>
                <a:gd name="connsiteY5" fmla="*/ 883624 h 2847817"/>
                <a:gd name="connsiteX6" fmla="*/ 3055767 w 4558113"/>
                <a:gd name="connsiteY6" fmla="*/ 434790 h 2847817"/>
                <a:gd name="connsiteX7" fmla="*/ 3172811 w 4558113"/>
                <a:gd name="connsiteY7" fmla="*/ 2496 h 2847817"/>
                <a:gd name="connsiteX8" fmla="*/ 3214053 w 4558113"/>
                <a:gd name="connsiteY8" fmla="*/ 637911 h 2847817"/>
                <a:gd name="connsiteX9" fmla="*/ 3387653 w 4558113"/>
                <a:gd name="connsiteY9" fmla="*/ 1151976 h 2847817"/>
                <a:gd name="connsiteX10" fmla="*/ 4112451 w 4558113"/>
                <a:gd name="connsiteY10" fmla="*/ 1509185 h 2847817"/>
                <a:gd name="connsiteX11" fmla="*/ 4306079 w 4558113"/>
                <a:gd name="connsiteY11" fmla="*/ 1706039 h 2847817"/>
                <a:gd name="connsiteX12" fmla="*/ 4558085 w 4558113"/>
                <a:gd name="connsiteY12" fmla="*/ 2575733 h 2847817"/>
                <a:gd name="connsiteX13" fmla="*/ 3782922 w 4558113"/>
                <a:gd name="connsiteY13" fmla="*/ 2221439 h 2847817"/>
                <a:gd name="connsiteX14" fmla="*/ 3496288 w 4558113"/>
                <a:gd name="connsiteY14" fmla="*/ 2233324 h 2847817"/>
                <a:gd name="connsiteX15" fmla="*/ 3272611 w 4558113"/>
                <a:gd name="connsiteY15" fmla="*/ 2327035 h 2847817"/>
                <a:gd name="connsiteX16" fmla="*/ 2865619 w 4558113"/>
                <a:gd name="connsiteY16" fmla="*/ 2719246 h 2847817"/>
                <a:gd name="connsiteX17" fmla="*/ 1782187 w 4558113"/>
                <a:gd name="connsiteY17" fmla="*/ 2846717 h 2847817"/>
                <a:gd name="connsiteX18" fmla="*/ 1045800 w 4558113"/>
                <a:gd name="connsiteY18" fmla="*/ 2790725 h 2847817"/>
                <a:gd name="connsiteX19" fmla="*/ 0 w 4558113"/>
                <a:gd name="connsiteY19" fmla="*/ 2571107 h 2847817"/>
                <a:gd name="connsiteX0" fmla="*/ 0 w 4558113"/>
                <a:gd name="connsiteY0" fmla="*/ 2571107 h 2847817"/>
                <a:gd name="connsiteX1" fmla="*/ 844083 w 4558113"/>
                <a:gd name="connsiteY1" fmla="*/ 2204908 h 2847817"/>
                <a:gd name="connsiteX2" fmla="*/ 1347039 w 4558113"/>
                <a:gd name="connsiteY2" fmla="*/ 1832280 h 2847817"/>
                <a:gd name="connsiteX3" fmla="*/ 1603099 w 4558113"/>
                <a:gd name="connsiteY3" fmla="*/ 1356759 h 2847817"/>
                <a:gd name="connsiteX4" fmla="*/ 2279104 w 4558113"/>
                <a:gd name="connsiteY4" fmla="*/ 1258132 h 2847817"/>
                <a:gd name="connsiteX5" fmla="*/ 2770210 w 4558113"/>
                <a:gd name="connsiteY5" fmla="*/ 883624 h 2847817"/>
                <a:gd name="connsiteX6" fmla="*/ 3055767 w 4558113"/>
                <a:gd name="connsiteY6" fmla="*/ 434790 h 2847817"/>
                <a:gd name="connsiteX7" fmla="*/ 3172811 w 4558113"/>
                <a:gd name="connsiteY7" fmla="*/ 2496 h 2847817"/>
                <a:gd name="connsiteX8" fmla="*/ 3214053 w 4558113"/>
                <a:gd name="connsiteY8" fmla="*/ 637911 h 2847817"/>
                <a:gd name="connsiteX9" fmla="*/ 3387653 w 4558113"/>
                <a:gd name="connsiteY9" fmla="*/ 1151976 h 2847817"/>
                <a:gd name="connsiteX10" fmla="*/ 4112451 w 4558113"/>
                <a:gd name="connsiteY10" fmla="*/ 1509185 h 2847817"/>
                <a:gd name="connsiteX11" fmla="*/ 4306079 w 4558113"/>
                <a:gd name="connsiteY11" fmla="*/ 1706039 h 2847817"/>
                <a:gd name="connsiteX12" fmla="*/ 4558085 w 4558113"/>
                <a:gd name="connsiteY12" fmla="*/ 2575733 h 2847817"/>
                <a:gd name="connsiteX13" fmla="*/ 3782922 w 4558113"/>
                <a:gd name="connsiteY13" fmla="*/ 2221439 h 2847817"/>
                <a:gd name="connsiteX14" fmla="*/ 3496288 w 4558113"/>
                <a:gd name="connsiteY14" fmla="*/ 2233324 h 2847817"/>
                <a:gd name="connsiteX15" fmla="*/ 3272611 w 4558113"/>
                <a:gd name="connsiteY15" fmla="*/ 2327035 h 2847817"/>
                <a:gd name="connsiteX16" fmla="*/ 2865619 w 4558113"/>
                <a:gd name="connsiteY16" fmla="*/ 2719246 h 2847817"/>
                <a:gd name="connsiteX17" fmla="*/ 1782187 w 4558113"/>
                <a:gd name="connsiteY17" fmla="*/ 2846717 h 2847817"/>
                <a:gd name="connsiteX18" fmla="*/ 1045800 w 4558113"/>
                <a:gd name="connsiteY18" fmla="*/ 2790725 h 2847817"/>
                <a:gd name="connsiteX19" fmla="*/ 0 w 4558113"/>
                <a:gd name="connsiteY19" fmla="*/ 2571107 h 2847817"/>
                <a:gd name="connsiteX0" fmla="*/ 0 w 4558113"/>
                <a:gd name="connsiteY0" fmla="*/ 2571107 h 2847817"/>
                <a:gd name="connsiteX1" fmla="*/ 844083 w 4558113"/>
                <a:gd name="connsiteY1" fmla="*/ 2204908 h 2847817"/>
                <a:gd name="connsiteX2" fmla="*/ 1347039 w 4558113"/>
                <a:gd name="connsiteY2" fmla="*/ 1832280 h 2847817"/>
                <a:gd name="connsiteX3" fmla="*/ 1603099 w 4558113"/>
                <a:gd name="connsiteY3" fmla="*/ 1356759 h 2847817"/>
                <a:gd name="connsiteX4" fmla="*/ 2279104 w 4558113"/>
                <a:gd name="connsiteY4" fmla="*/ 1258132 h 2847817"/>
                <a:gd name="connsiteX5" fmla="*/ 2770210 w 4558113"/>
                <a:gd name="connsiteY5" fmla="*/ 883624 h 2847817"/>
                <a:gd name="connsiteX6" fmla="*/ 3055767 w 4558113"/>
                <a:gd name="connsiteY6" fmla="*/ 434790 h 2847817"/>
                <a:gd name="connsiteX7" fmla="*/ 3172811 w 4558113"/>
                <a:gd name="connsiteY7" fmla="*/ 2496 h 2847817"/>
                <a:gd name="connsiteX8" fmla="*/ 3214053 w 4558113"/>
                <a:gd name="connsiteY8" fmla="*/ 637911 h 2847817"/>
                <a:gd name="connsiteX9" fmla="*/ 3387653 w 4558113"/>
                <a:gd name="connsiteY9" fmla="*/ 1151976 h 2847817"/>
                <a:gd name="connsiteX10" fmla="*/ 4112451 w 4558113"/>
                <a:gd name="connsiteY10" fmla="*/ 1509185 h 2847817"/>
                <a:gd name="connsiteX11" fmla="*/ 4306079 w 4558113"/>
                <a:gd name="connsiteY11" fmla="*/ 1706039 h 2847817"/>
                <a:gd name="connsiteX12" fmla="*/ 4558085 w 4558113"/>
                <a:gd name="connsiteY12" fmla="*/ 2575733 h 2847817"/>
                <a:gd name="connsiteX13" fmla="*/ 3782922 w 4558113"/>
                <a:gd name="connsiteY13" fmla="*/ 2221439 h 2847817"/>
                <a:gd name="connsiteX14" fmla="*/ 3496288 w 4558113"/>
                <a:gd name="connsiteY14" fmla="*/ 2233324 h 2847817"/>
                <a:gd name="connsiteX15" fmla="*/ 3272611 w 4558113"/>
                <a:gd name="connsiteY15" fmla="*/ 2327035 h 2847817"/>
                <a:gd name="connsiteX16" fmla="*/ 2865619 w 4558113"/>
                <a:gd name="connsiteY16" fmla="*/ 2719246 h 2847817"/>
                <a:gd name="connsiteX17" fmla="*/ 1782187 w 4558113"/>
                <a:gd name="connsiteY17" fmla="*/ 2846717 h 2847817"/>
                <a:gd name="connsiteX18" fmla="*/ 1045800 w 4558113"/>
                <a:gd name="connsiteY18" fmla="*/ 2790725 h 2847817"/>
                <a:gd name="connsiteX19" fmla="*/ 0 w 4558113"/>
                <a:gd name="connsiteY19" fmla="*/ 2571107 h 2847817"/>
                <a:gd name="connsiteX0" fmla="*/ 0 w 4558113"/>
                <a:gd name="connsiteY0" fmla="*/ 2571107 h 2847817"/>
                <a:gd name="connsiteX1" fmla="*/ 844083 w 4558113"/>
                <a:gd name="connsiteY1" fmla="*/ 2204908 h 2847817"/>
                <a:gd name="connsiteX2" fmla="*/ 1347039 w 4558113"/>
                <a:gd name="connsiteY2" fmla="*/ 1832280 h 2847817"/>
                <a:gd name="connsiteX3" fmla="*/ 1603099 w 4558113"/>
                <a:gd name="connsiteY3" fmla="*/ 1356759 h 2847817"/>
                <a:gd name="connsiteX4" fmla="*/ 2279104 w 4558113"/>
                <a:gd name="connsiteY4" fmla="*/ 1258132 h 2847817"/>
                <a:gd name="connsiteX5" fmla="*/ 2770210 w 4558113"/>
                <a:gd name="connsiteY5" fmla="*/ 883624 h 2847817"/>
                <a:gd name="connsiteX6" fmla="*/ 3055767 w 4558113"/>
                <a:gd name="connsiteY6" fmla="*/ 434790 h 2847817"/>
                <a:gd name="connsiteX7" fmla="*/ 3172811 w 4558113"/>
                <a:gd name="connsiteY7" fmla="*/ 2496 h 2847817"/>
                <a:gd name="connsiteX8" fmla="*/ 3214053 w 4558113"/>
                <a:gd name="connsiteY8" fmla="*/ 637911 h 2847817"/>
                <a:gd name="connsiteX9" fmla="*/ 3387653 w 4558113"/>
                <a:gd name="connsiteY9" fmla="*/ 1151976 h 2847817"/>
                <a:gd name="connsiteX10" fmla="*/ 4112451 w 4558113"/>
                <a:gd name="connsiteY10" fmla="*/ 1509185 h 2847817"/>
                <a:gd name="connsiteX11" fmla="*/ 4306079 w 4558113"/>
                <a:gd name="connsiteY11" fmla="*/ 1706039 h 2847817"/>
                <a:gd name="connsiteX12" fmla="*/ 4558085 w 4558113"/>
                <a:gd name="connsiteY12" fmla="*/ 2575733 h 2847817"/>
                <a:gd name="connsiteX13" fmla="*/ 3782922 w 4558113"/>
                <a:gd name="connsiteY13" fmla="*/ 2221439 h 2847817"/>
                <a:gd name="connsiteX14" fmla="*/ 3496288 w 4558113"/>
                <a:gd name="connsiteY14" fmla="*/ 2233324 h 2847817"/>
                <a:gd name="connsiteX15" fmla="*/ 3272611 w 4558113"/>
                <a:gd name="connsiteY15" fmla="*/ 2327035 h 2847817"/>
                <a:gd name="connsiteX16" fmla="*/ 2865619 w 4558113"/>
                <a:gd name="connsiteY16" fmla="*/ 2719246 h 2847817"/>
                <a:gd name="connsiteX17" fmla="*/ 1782187 w 4558113"/>
                <a:gd name="connsiteY17" fmla="*/ 2846717 h 2847817"/>
                <a:gd name="connsiteX18" fmla="*/ 1045800 w 4558113"/>
                <a:gd name="connsiteY18" fmla="*/ 2790725 h 2847817"/>
                <a:gd name="connsiteX19" fmla="*/ 0 w 4558113"/>
                <a:gd name="connsiteY19" fmla="*/ 2571107 h 284781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</a:cxnLst>
              <a:rect l="l" t="t" r="r" b="b"/>
              <a:pathLst>
                <a:path w="4558113" h="2847817">
                  <a:moveTo>
                    <a:pt x="0" y="2571107"/>
                  </a:moveTo>
                  <a:cubicBezTo>
                    <a:pt x="76266" y="2530670"/>
                    <a:pt x="520411" y="2379219"/>
                    <a:pt x="844083" y="2204908"/>
                  </a:cubicBezTo>
                  <a:cubicBezTo>
                    <a:pt x="1167755" y="2030597"/>
                    <a:pt x="1220536" y="1973638"/>
                    <a:pt x="1347039" y="1832280"/>
                  </a:cubicBezTo>
                  <a:cubicBezTo>
                    <a:pt x="1473542" y="1690922"/>
                    <a:pt x="1447755" y="1452450"/>
                    <a:pt x="1603099" y="1356759"/>
                  </a:cubicBezTo>
                  <a:cubicBezTo>
                    <a:pt x="1758443" y="1261068"/>
                    <a:pt x="2084586" y="1336988"/>
                    <a:pt x="2279104" y="1258132"/>
                  </a:cubicBezTo>
                  <a:cubicBezTo>
                    <a:pt x="2473623" y="1179276"/>
                    <a:pt x="2640766" y="1020847"/>
                    <a:pt x="2770210" y="883624"/>
                  </a:cubicBezTo>
                  <a:cubicBezTo>
                    <a:pt x="2899654" y="746401"/>
                    <a:pt x="2988667" y="581645"/>
                    <a:pt x="3055767" y="434790"/>
                  </a:cubicBezTo>
                  <a:cubicBezTo>
                    <a:pt x="3122867" y="287935"/>
                    <a:pt x="3146430" y="-31357"/>
                    <a:pt x="3172811" y="2496"/>
                  </a:cubicBezTo>
                  <a:cubicBezTo>
                    <a:pt x="3199192" y="36349"/>
                    <a:pt x="3178246" y="446331"/>
                    <a:pt x="3214053" y="637911"/>
                  </a:cubicBezTo>
                  <a:cubicBezTo>
                    <a:pt x="3249860" y="829491"/>
                    <a:pt x="3237920" y="1006764"/>
                    <a:pt x="3387653" y="1151976"/>
                  </a:cubicBezTo>
                  <a:cubicBezTo>
                    <a:pt x="3537386" y="1297188"/>
                    <a:pt x="3959380" y="1416841"/>
                    <a:pt x="4112451" y="1509185"/>
                  </a:cubicBezTo>
                  <a:cubicBezTo>
                    <a:pt x="4265522" y="1601529"/>
                    <a:pt x="4208320" y="1608671"/>
                    <a:pt x="4306079" y="1706039"/>
                  </a:cubicBezTo>
                  <a:cubicBezTo>
                    <a:pt x="4403838" y="1803407"/>
                    <a:pt x="4560537" y="2502449"/>
                    <a:pt x="4558085" y="2575733"/>
                  </a:cubicBezTo>
                  <a:cubicBezTo>
                    <a:pt x="4501986" y="2796768"/>
                    <a:pt x="3959888" y="2278507"/>
                    <a:pt x="3782922" y="2221439"/>
                  </a:cubicBezTo>
                  <a:cubicBezTo>
                    <a:pt x="3605956" y="2164371"/>
                    <a:pt x="3581340" y="2215725"/>
                    <a:pt x="3496288" y="2233324"/>
                  </a:cubicBezTo>
                  <a:cubicBezTo>
                    <a:pt x="3411236" y="2250923"/>
                    <a:pt x="3377722" y="2246048"/>
                    <a:pt x="3272611" y="2327035"/>
                  </a:cubicBezTo>
                  <a:cubicBezTo>
                    <a:pt x="3167500" y="2408022"/>
                    <a:pt x="3114023" y="2632632"/>
                    <a:pt x="2865619" y="2719246"/>
                  </a:cubicBezTo>
                  <a:cubicBezTo>
                    <a:pt x="2617215" y="2805860"/>
                    <a:pt x="2021938" y="2856010"/>
                    <a:pt x="1782187" y="2846717"/>
                  </a:cubicBezTo>
                  <a:cubicBezTo>
                    <a:pt x="1542436" y="2837424"/>
                    <a:pt x="1342831" y="2836660"/>
                    <a:pt x="1045800" y="2790725"/>
                  </a:cubicBezTo>
                  <a:cubicBezTo>
                    <a:pt x="748769" y="2744790"/>
                    <a:pt x="19153" y="2678529"/>
                    <a:pt x="0" y="2571107"/>
                  </a:cubicBezTo>
                  <a:close/>
                </a:path>
              </a:pathLst>
            </a:custGeom>
            <a:gradFill flip="none" rotWithShape="1">
              <a:gsLst>
                <a:gs pos="6000">
                  <a:srgbClr val="DB6458"/>
                </a:gs>
                <a:gs pos="89000">
                  <a:schemeClr val="accent2">
                    <a:lumMod val="60000"/>
                    <a:lumOff val="40000"/>
                  </a:schemeClr>
                </a:gs>
              </a:gsLst>
              <a:path path="circle">
                <a:fillToRect l="100000" t="100000"/>
              </a:path>
              <a:tileRect r="-100000" b="-100000"/>
            </a:gradFill>
            <a:ln w="12700" cap="rnd" cmpd="sng">
              <a:solidFill>
                <a:srgbClr val="996F83"/>
              </a:solidFill>
              <a:prstDash val="solid"/>
              <a:round/>
              <a:headEnd type="none" w="med" len="med"/>
              <a:tailEnd type="none" w="med" len="med"/>
            </a:ln>
            <a:effectLst>
              <a:innerShdw blurRad="127000" dist="12700" dir="18000000">
                <a:prstClr val="black">
                  <a:alpha val="50000"/>
                </a:prstClr>
              </a:innerShdw>
            </a:effectLst>
          </p:spPr>
          <p:txBody>
            <a:bodyPr/>
            <a:lstStyle/>
            <a:p>
              <a:endParaRPr lang="zh-CN" altLang="en-US" sz="1400" dirty="0"/>
            </a:p>
          </p:txBody>
        </p:sp>
        <p:sp>
          <p:nvSpPr>
            <p:cNvPr id="921" name="文本框 920">
              <a:extLst>
                <a:ext uri="{FF2B5EF4-FFF2-40B4-BE49-F238E27FC236}">
                  <a16:creationId xmlns:a16="http://schemas.microsoft.com/office/drawing/2014/main" id="{41D7F86B-5098-9ECF-35C2-E52E16050BB7}"/>
                </a:ext>
              </a:extLst>
            </p:cNvPr>
            <p:cNvSpPr txBox="1"/>
            <p:nvPr/>
          </p:nvSpPr>
          <p:spPr>
            <a:xfrm>
              <a:off x="1732573" y="3842797"/>
              <a:ext cx="2844371" cy="3397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Primum atrial septal defect</a:t>
              </a:r>
              <a:endParaRPr lang="zh-CN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2" name="文本框 921">
              <a:extLst>
                <a:ext uri="{FF2B5EF4-FFF2-40B4-BE49-F238E27FC236}">
                  <a16:creationId xmlns:a16="http://schemas.microsoft.com/office/drawing/2014/main" id="{8B6C2B25-E432-CA35-8570-ED240EBA6523}"/>
                </a:ext>
              </a:extLst>
            </p:cNvPr>
            <p:cNvSpPr txBox="1"/>
            <p:nvPr/>
          </p:nvSpPr>
          <p:spPr>
            <a:xfrm>
              <a:off x="7623513" y="6552993"/>
              <a:ext cx="1136162" cy="559543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100" b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r>
                <a:rPr lang="en-US" altLang="zh-CN" sz="1100" b="1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itral cleft</a:t>
              </a:r>
              <a:endParaRPr lang="zh-CN" altLang="en-US" sz="3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3" name="文本框 922">
              <a:extLst>
                <a:ext uri="{FF2B5EF4-FFF2-40B4-BE49-F238E27FC236}">
                  <a16:creationId xmlns:a16="http://schemas.microsoft.com/office/drawing/2014/main" id="{8FBEDC5E-76CF-B612-DD9C-4BE4087CD780}"/>
                </a:ext>
              </a:extLst>
            </p:cNvPr>
            <p:cNvSpPr txBox="1"/>
            <p:nvPr/>
          </p:nvSpPr>
          <p:spPr>
            <a:xfrm rot="3352987">
              <a:off x="4769975" y="5209169"/>
              <a:ext cx="1324820" cy="33972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100" b="1" dirty="0"/>
                <a:t>Small septal</a:t>
              </a:r>
              <a:endParaRPr lang="zh-CN" altLang="en-US" sz="1100" b="1" dirty="0"/>
            </a:p>
          </p:txBody>
        </p:sp>
        <p:cxnSp>
          <p:nvCxnSpPr>
            <p:cNvPr id="924" name="直接箭头连接符 923">
              <a:extLst>
                <a:ext uri="{FF2B5EF4-FFF2-40B4-BE49-F238E27FC236}">
                  <a16:creationId xmlns:a16="http://schemas.microsoft.com/office/drawing/2014/main" id="{1B224E3A-17F5-E0B9-C677-F87496178CC8}"/>
                </a:ext>
              </a:extLst>
            </p:cNvPr>
            <p:cNvCxnSpPr>
              <a:cxnSpLocks/>
            </p:cNvCxnSpPr>
            <p:nvPr/>
          </p:nvCxnSpPr>
          <p:spPr>
            <a:xfrm rot="13240802">
              <a:off x="6211105" y="6153846"/>
              <a:ext cx="1631949" cy="0"/>
            </a:xfrm>
            <a:prstGeom prst="straightConnector1">
              <a:avLst/>
            </a:prstGeom>
            <a:ln w="19050">
              <a:solidFill>
                <a:schemeClr val="tx1"/>
              </a:solidFill>
              <a:headEnd type="none" w="med" len="med"/>
              <a:tailEnd type="arrow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26" name="文本框 925">
              <a:extLst>
                <a:ext uri="{FF2B5EF4-FFF2-40B4-BE49-F238E27FC236}">
                  <a16:creationId xmlns:a16="http://schemas.microsoft.com/office/drawing/2014/main" id="{E883A151-D397-6F97-78A9-DFA560591B63}"/>
                </a:ext>
              </a:extLst>
            </p:cNvPr>
            <p:cNvSpPr txBox="1"/>
            <p:nvPr/>
          </p:nvSpPr>
          <p:spPr>
            <a:xfrm>
              <a:off x="1732573" y="4615521"/>
              <a:ext cx="2247387" cy="33972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Atrioventricular node</a:t>
              </a:r>
              <a:endParaRPr lang="zh-CN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8" name="文本框 927">
              <a:extLst>
                <a:ext uri="{FF2B5EF4-FFF2-40B4-BE49-F238E27FC236}">
                  <a16:creationId xmlns:a16="http://schemas.microsoft.com/office/drawing/2014/main" id="{ED12365D-9F35-40B0-8E23-F069FF9942A0}"/>
                </a:ext>
              </a:extLst>
            </p:cNvPr>
            <p:cNvSpPr txBox="1"/>
            <p:nvPr/>
          </p:nvSpPr>
          <p:spPr>
            <a:xfrm rot="2183334">
              <a:off x="4619638" y="6574321"/>
              <a:ext cx="1239383" cy="33972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100" b="1" dirty="0"/>
                <a:t>Anterior</a:t>
              </a:r>
              <a:endParaRPr lang="zh-CN" altLang="en-US" sz="1100" b="1" dirty="0"/>
            </a:p>
          </p:txBody>
        </p:sp>
        <p:sp>
          <p:nvSpPr>
            <p:cNvPr id="929" name="文本框 928">
              <a:extLst>
                <a:ext uri="{FF2B5EF4-FFF2-40B4-BE49-F238E27FC236}">
                  <a16:creationId xmlns:a16="http://schemas.microsoft.com/office/drawing/2014/main" id="{ABFF6ED4-F731-8A5A-3570-8CD221D85DAE}"/>
                </a:ext>
              </a:extLst>
            </p:cNvPr>
            <p:cNvSpPr txBox="1"/>
            <p:nvPr/>
          </p:nvSpPr>
          <p:spPr>
            <a:xfrm rot="19189625">
              <a:off x="3836792" y="4657142"/>
              <a:ext cx="1452276" cy="33972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100" b="1" dirty="0"/>
                <a:t>Posterior</a:t>
              </a:r>
              <a:endParaRPr lang="zh-CN" altLang="en-US" sz="1100" b="1" dirty="0"/>
            </a:p>
          </p:txBody>
        </p:sp>
        <p:sp>
          <p:nvSpPr>
            <p:cNvPr id="930" name="文本框 929">
              <a:extLst>
                <a:ext uri="{FF2B5EF4-FFF2-40B4-BE49-F238E27FC236}">
                  <a16:creationId xmlns:a16="http://schemas.microsoft.com/office/drawing/2014/main" id="{DEB62E74-C8BC-7DA9-8401-0C97E23810F5}"/>
                </a:ext>
              </a:extLst>
            </p:cNvPr>
            <p:cNvSpPr txBox="1"/>
            <p:nvPr/>
          </p:nvSpPr>
          <p:spPr>
            <a:xfrm>
              <a:off x="1732573" y="5999956"/>
              <a:ext cx="1790071" cy="33972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Tricuspid valve</a:t>
              </a:r>
              <a:endParaRPr lang="zh-CN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31" name="直接箭头连接符 930">
              <a:extLst>
                <a:ext uri="{FF2B5EF4-FFF2-40B4-BE49-F238E27FC236}">
                  <a16:creationId xmlns:a16="http://schemas.microsoft.com/office/drawing/2014/main" id="{21BBB01D-AFB3-68E1-01A4-2094E51A1A38}"/>
                </a:ext>
              </a:extLst>
            </p:cNvPr>
            <p:cNvCxnSpPr>
              <a:cxnSpLocks/>
            </p:cNvCxnSpPr>
            <p:nvPr/>
          </p:nvCxnSpPr>
          <p:spPr>
            <a:xfrm>
              <a:off x="3154759" y="6178687"/>
              <a:ext cx="1245196" cy="0"/>
            </a:xfrm>
            <a:prstGeom prst="straightConnector1">
              <a:avLst/>
            </a:prstGeom>
            <a:ln w="19050">
              <a:solidFill>
                <a:schemeClr val="tx1"/>
              </a:solidFill>
              <a:headEnd type="none" w="med" len="med"/>
              <a:tailEnd type="arrow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32" name="文本框 931">
              <a:extLst>
                <a:ext uri="{FF2B5EF4-FFF2-40B4-BE49-F238E27FC236}">
                  <a16:creationId xmlns:a16="http://schemas.microsoft.com/office/drawing/2014/main" id="{A79F02D6-D05F-E100-4F95-04D963ACD4C9}"/>
                </a:ext>
              </a:extLst>
            </p:cNvPr>
            <p:cNvSpPr txBox="1"/>
            <p:nvPr/>
          </p:nvSpPr>
          <p:spPr>
            <a:xfrm>
              <a:off x="1732573" y="5171140"/>
              <a:ext cx="1885540" cy="33972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Papillary muscle</a:t>
              </a:r>
              <a:endParaRPr lang="zh-CN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33" name="直接箭头连接符 932">
              <a:extLst>
                <a:ext uri="{FF2B5EF4-FFF2-40B4-BE49-F238E27FC236}">
                  <a16:creationId xmlns:a16="http://schemas.microsoft.com/office/drawing/2014/main" id="{A592A220-D715-A208-0ECD-A49580896B9E}"/>
                </a:ext>
              </a:extLst>
            </p:cNvPr>
            <p:cNvCxnSpPr>
              <a:cxnSpLocks/>
            </p:cNvCxnSpPr>
            <p:nvPr/>
          </p:nvCxnSpPr>
          <p:spPr>
            <a:xfrm>
              <a:off x="3331277" y="5335136"/>
              <a:ext cx="1414679" cy="6035"/>
            </a:xfrm>
            <a:prstGeom prst="straightConnector1">
              <a:avLst/>
            </a:prstGeom>
            <a:ln w="19050">
              <a:solidFill>
                <a:schemeClr val="tx1"/>
              </a:solidFill>
              <a:headEnd type="none" w="med" len="med"/>
              <a:tailEnd type="arrow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34" name="文本框 933">
              <a:extLst>
                <a:ext uri="{FF2B5EF4-FFF2-40B4-BE49-F238E27FC236}">
                  <a16:creationId xmlns:a16="http://schemas.microsoft.com/office/drawing/2014/main" id="{517F9C51-A482-847F-57BD-6B6664D6DB48}"/>
                </a:ext>
              </a:extLst>
            </p:cNvPr>
            <p:cNvSpPr txBox="1"/>
            <p:nvPr/>
          </p:nvSpPr>
          <p:spPr>
            <a:xfrm>
              <a:off x="1732573" y="4244164"/>
              <a:ext cx="1598703" cy="33972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Coronary sinus</a:t>
              </a:r>
              <a:endParaRPr lang="zh-CN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35" name="直接箭头连接符 934">
              <a:extLst>
                <a:ext uri="{FF2B5EF4-FFF2-40B4-BE49-F238E27FC236}">
                  <a16:creationId xmlns:a16="http://schemas.microsoft.com/office/drawing/2014/main" id="{378D72D1-9BB3-D13E-D06F-568B84E33DA1}"/>
                </a:ext>
              </a:extLst>
            </p:cNvPr>
            <p:cNvCxnSpPr>
              <a:cxnSpLocks/>
            </p:cNvCxnSpPr>
            <p:nvPr/>
          </p:nvCxnSpPr>
          <p:spPr>
            <a:xfrm>
              <a:off x="3250783" y="4408310"/>
              <a:ext cx="1769210" cy="0"/>
            </a:xfrm>
            <a:prstGeom prst="straightConnector1">
              <a:avLst/>
            </a:prstGeom>
            <a:ln w="19050">
              <a:solidFill>
                <a:schemeClr val="tx1"/>
              </a:solidFill>
              <a:headEnd type="none" w="med" len="med"/>
              <a:tailEnd type="arrow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36" name="文本框 935">
              <a:extLst>
                <a:ext uri="{FF2B5EF4-FFF2-40B4-BE49-F238E27FC236}">
                  <a16:creationId xmlns:a16="http://schemas.microsoft.com/office/drawing/2014/main" id="{33EC6B04-C3C5-3C91-B514-F6817F62787A}"/>
                </a:ext>
              </a:extLst>
            </p:cNvPr>
            <p:cNvSpPr txBox="1"/>
            <p:nvPr/>
          </p:nvSpPr>
          <p:spPr>
            <a:xfrm>
              <a:off x="8222377" y="5741170"/>
              <a:ext cx="1243709" cy="33972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Mitral valve</a:t>
              </a:r>
              <a:endParaRPr lang="zh-CN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37" name="文本框 936">
              <a:extLst>
                <a:ext uri="{FF2B5EF4-FFF2-40B4-BE49-F238E27FC236}">
                  <a16:creationId xmlns:a16="http://schemas.microsoft.com/office/drawing/2014/main" id="{22134EE3-7216-CFE4-B8EF-6EEDD62216D9}"/>
                </a:ext>
              </a:extLst>
            </p:cNvPr>
            <p:cNvSpPr txBox="1"/>
            <p:nvPr/>
          </p:nvSpPr>
          <p:spPr>
            <a:xfrm rot="21115992">
              <a:off x="5682902" y="4853519"/>
              <a:ext cx="1362333" cy="33972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100" b="1" dirty="0"/>
                <a:t>Anterior</a:t>
              </a:r>
              <a:endParaRPr lang="zh-CN" altLang="en-US" sz="1100" b="1" dirty="0"/>
            </a:p>
          </p:txBody>
        </p:sp>
        <p:sp>
          <p:nvSpPr>
            <p:cNvPr id="938" name="文本框 937">
              <a:extLst>
                <a:ext uri="{FF2B5EF4-FFF2-40B4-BE49-F238E27FC236}">
                  <a16:creationId xmlns:a16="http://schemas.microsoft.com/office/drawing/2014/main" id="{C7937289-C93C-D00D-B0E3-9C49B1D725CA}"/>
                </a:ext>
              </a:extLst>
            </p:cNvPr>
            <p:cNvSpPr txBox="1"/>
            <p:nvPr/>
          </p:nvSpPr>
          <p:spPr>
            <a:xfrm rot="1328052">
              <a:off x="6954064" y="4490086"/>
              <a:ext cx="1259043" cy="33972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100" b="1" dirty="0"/>
                <a:t>Posterior</a:t>
              </a:r>
              <a:endParaRPr lang="zh-CN" altLang="en-US" sz="1100" b="1" dirty="0"/>
            </a:p>
          </p:txBody>
        </p:sp>
        <p:cxnSp>
          <p:nvCxnSpPr>
            <p:cNvPr id="939" name="直接箭头连接符 938">
              <a:extLst>
                <a:ext uri="{FF2B5EF4-FFF2-40B4-BE49-F238E27FC236}">
                  <a16:creationId xmlns:a16="http://schemas.microsoft.com/office/drawing/2014/main" id="{8CAD69EF-6E1F-068D-7954-07F6171C3C6A}"/>
                </a:ext>
              </a:extLst>
            </p:cNvPr>
            <p:cNvCxnSpPr>
              <a:cxnSpLocks/>
            </p:cNvCxnSpPr>
            <p:nvPr/>
          </p:nvCxnSpPr>
          <p:spPr>
            <a:xfrm rot="13240802">
              <a:off x="7490153" y="5569792"/>
              <a:ext cx="857011" cy="0"/>
            </a:xfrm>
            <a:prstGeom prst="straightConnector1">
              <a:avLst/>
            </a:prstGeom>
            <a:ln w="19050">
              <a:solidFill>
                <a:schemeClr val="tx1"/>
              </a:solidFill>
              <a:headEnd type="none" w="med" len="med"/>
              <a:tailEnd type="arrow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40" name="直接箭头连接符 939">
              <a:extLst>
                <a:ext uri="{FF2B5EF4-FFF2-40B4-BE49-F238E27FC236}">
                  <a16:creationId xmlns:a16="http://schemas.microsoft.com/office/drawing/2014/main" id="{7F9AE0B1-7580-1819-5C21-FA2210C09072}"/>
                </a:ext>
              </a:extLst>
            </p:cNvPr>
            <p:cNvCxnSpPr>
              <a:cxnSpLocks/>
            </p:cNvCxnSpPr>
            <p:nvPr/>
          </p:nvCxnSpPr>
          <p:spPr>
            <a:xfrm>
              <a:off x="4197074" y="3997899"/>
              <a:ext cx="1209758" cy="0"/>
            </a:xfrm>
            <a:prstGeom prst="straightConnector1">
              <a:avLst/>
            </a:prstGeom>
            <a:ln w="19050">
              <a:solidFill>
                <a:schemeClr val="tx1"/>
              </a:solidFill>
              <a:headEnd type="none" w="med" len="med"/>
              <a:tailEnd type="arrow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直接箭头连接符 13">
              <a:extLst>
                <a:ext uri="{FF2B5EF4-FFF2-40B4-BE49-F238E27FC236}">
                  <a16:creationId xmlns:a16="http://schemas.microsoft.com/office/drawing/2014/main" id="{1E2396DA-C860-9C12-0269-17EA0631E1BE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714562" y="4727068"/>
              <a:ext cx="1621625" cy="52298"/>
            </a:xfrm>
            <a:prstGeom prst="straightConnector1">
              <a:avLst/>
            </a:prstGeom>
            <a:ln w="19050">
              <a:solidFill>
                <a:schemeClr val="tx1"/>
              </a:solidFill>
              <a:headEnd type="none" w="med" len="med"/>
              <a:tailEnd type="arrow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25" name="文本框 924">
              <a:extLst>
                <a:ext uri="{FF2B5EF4-FFF2-40B4-BE49-F238E27FC236}">
                  <a16:creationId xmlns:a16="http://schemas.microsoft.com/office/drawing/2014/main" id="{E82AE1D5-C745-14AD-1510-52A2E358C00B}"/>
                </a:ext>
              </a:extLst>
            </p:cNvPr>
            <p:cNvSpPr txBox="1"/>
            <p:nvPr/>
          </p:nvSpPr>
          <p:spPr>
            <a:xfrm>
              <a:off x="1658523" y="3304696"/>
              <a:ext cx="408478" cy="43964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01" name="任意多边形: 形状 900">
              <a:extLst>
                <a:ext uri="{FF2B5EF4-FFF2-40B4-BE49-F238E27FC236}">
                  <a16:creationId xmlns:a16="http://schemas.microsoft.com/office/drawing/2014/main" id="{AB41A411-3931-C4F9-555D-640652DA5D20}"/>
                </a:ext>
              </a:extLst>
            </p:cNvPr>
            <p:cNvSpPr/>
            <p:nvPr/>
          </p:nvSpPr>
          <p:spPr>
            <a:xfrm rot="1954402">
              <a:off x="4909120" y="3929589"/>
              <a:ext cx="2341210" cy="2558425"/>
            </a:xfrm>
            <a:custGeom>
              <a:avLst/>
              <a:gdLst>
                <a:gd name="connsiteX0" fmla="*/ 6903 w 1299555"/>
                <a:gd name="connsiteY0" fmla="*/ 792587 h 1539297"/>
                <a:gd name="connsiteX1" fmla="*/ 26154 w 1299555"/>
                <a:gd name="connsiteY1" fmla="*/ 378700 h 1539297"/>
                <a:gd name="connsiteX2" fmla="*/ 218659 w 1299555"/>
                <a:gd name="connsiteY2" fmla="*/ 70692 h 1539297"/>
                <a:gd name="connsiteX3" fmla="*/ 468916 w 1299555"/>
                <a:gd name="connsiteY3" fmla="*/ 3315 h 1539297"/>
                <a:gd name="connsiteX4" fmla="*/ 786549 w 1299555"/>
                <a:gd name="connsiteY4" fmla="*/ 138069 h 1539297"/>
                <a:gd name="connsiteX5" fmla="*/ 1017556 w 1299555"/>
                <a:gd name="connsiteY5" fmla="*/ 397951 h 1539297"/>
                <a:gd name="connsiteX6" fmla="*/ 1238937 w 1299555"/>
                <a:gd name="connsiteY6" fmla="*/ 840713 h 1539297"/>
                <a:gd name="connsiteX7" fmla="*/ 1296688 w 1299555"/>
                <a:gd name="connsiteY7" fmla="*/ 1235349 h 1539297"/>
                <a:gd name="connsiteX8" fmla="*/ 1267813 w 1299555"/>
                <a:gd name="connsiteY8" fmla="*/ 1485606 h 1539297"/>
                <a:gd name="connsiteX9" fmla="*/ 1075307 w 1299555"/>
                <a:gd name="connsiteY9" fmla="*/ 1533732 h 1539297"/>
                <a:gd name="connsiteX10" fmla="*/ 882802 w 1299555"/>
                <a:gd name="connsiteY10" fmla="*/ 1398978 h 1539297"/>
                <a:gd name="connsiteX11" fmla="*/ 6903 w 1299555"/>
                <a:gd name="connsiteY11" fmla="*/ 792587 h 1539297"/>
                <a:gd name="connsiteX0" fmla="*/ 6903 w 1299555"/>
                <a:gd name="connsiteY0" fmla="*/ 792587 h 1539297"/>
                <a:gd name="connsiteX1" fmla="*/ 26154 w 1299555"/>
                <a:gd name="connsiteY1" fmla="*/ 378700 h 1539297"/>
                <a:gd name="connsiteX2" fmla="*/ 218659 w 1299555"/>
                <a:gd name="connsiteY2" fmla="*/ 70692 h 1539297"/>
                <a:gd name="connsiteX3" fmla="*/ 468916 w 1299555"/>
                <a:gd name="connsiteY3" fmla="*/ 3315 h 1539297"/>
                <a:gd name="connsiteX4" fmla="*/ 786549 w 1299555"/>
                <a:gd name="connsiteY4" fmla="*/ 138069 h 1539297"/>
                <a:gd name="connsiteX5" fmla="*/ 1017556 w 1299555"/>
                <a:gd name="connsiteY5" fmla="*/ 397951 h 1539297"/>
                <a:gd name="connsiteX6" fmla="*/ 1238937 w 1299555"/>
                <a:gd name="connsiteY6" fmla="*/ 840713 h 1539297"/>
                <a:gd name="connsiteX7" fmla="*/ 1296688 w 1299555"/>
                <a:gd name="connsiteY7" fmla="*/ 1235349 h 1539297"/>
                <a:gd name="connsiteX8" fmla="*/ 1267813 w 1299555"/>
                <a:gd name="connsiteY8" fmla="*/ 1485606 h 1539297"/>
                <a:gd name="connsiteX9" fmla="*/ 1075307 w 1299555"/>
                <a:gd name="connsiteY9" fmla="*/ 1533732 h 1539297"/>
                <a:gd name="connsiteX10" fmla="*/ 599081 w 1299555"/>
                <a:gd name="connsiteY10" fmla="*/ 1239628 h 1539297"/>
                <a:gd name="connsiteX11" fmla="*/ 6903 w 1299555"/>
                <a:gd name="connsiteY11" fmla="*/ 792587 h 1539297"/>
                <a:gd name="connsiteX0" fmla="*/ 6903 w 1315454"/>
                <a:gd name="connsiteY0" fmla="*/ 792587 h 1535628"/>
                <a:gd name="connsiteX1" fmla="*/ 26154 w 1315454"/>
                <a:gd name="connsiteY1" fmla="*/ 378700 h 1535628"/>
                <a:gd name="connsiteX2" fmla="*/ 218659 w 1315454"/>
                <a:gd name="connsiteY2" fmla="*/ 70692 h 1535628"/>
                <a:gd name="connsiteX3" fmla="*/ 468916 w 1315454"/>
                <a:gd name="connsiteY3" fmla="*/ 3315 h 1535628"/>
                <a:gd name="connsiteX4" fmla="*/ 786549 w 1315454"/>
                <a:gd name="connsiteY4" fmla="*/ 138069 h 1535628"/>
                <a:gd name="connsiteX5" fmla="*/ 1017556 w 1315454"/>
                <a:gd name="connsiteY5" fmla="*/ 397951 h 1535628"/>
                <a:gd name="connsiteX6" fmla="*/ 1238937 w 1315454"/>
                <a:gd name="connsiteY6" fmla="*/ 840713 h 1535628"/>
                <a:gd name="connsiteX7" fmla="*/ 1296688 w 1315454"/>
                <a:gd name="connsiteY7" fmla="*/ 1235349 h 1535628"/>
                <a:gd name="connsiteX8" fmla="*/ 937454 w 1315454"/>
                <a:gd name="connsiteY8" fmla="*/ 1427307 h 1535628"/>
                <a:gd name="connsiteX9" fmla="*/ 1075307 w 1315454"/>
                <a:gd name="connsiteY9" fmla="*/ 1533732 h 1535628"/>
                <a:gd name="connsiteX10" fmla="*/ 599081 w 1315454"/>
                <a:gd name="connsiteY10" fmla="*/ 1239628 h 1535628"/>
                <a:gd name="connsiteX11" fmla="*/ 6903 w 1315454"/>
                <a:gd name="connsiteY11" fmla="*/ 792587 h 1535628"/>
                <a:gd name="connsiteX0" fmla="*/ 6903 w 1315454"/>
                <a:gd name="connsiteY0" fmla="*/ 792587 h 1427311"/>
                <a:gd name="connsiteX1" fmla="*/ 26154 w 1315454"/>
                <a:gd name="connsiteY1" fmla="*/ 378700 h 1427311"/>
                <a:gd name="connsiteX2" fmla="*/ 218659 w 1315454"/>
                <a:gd name="connsiteY2" fmla="*/ 70692 h 1427311"/>
                <a:gd name="connsiteX3" fmla="*/ 468916 w 1315454"/>
                <a:gd name="connsiteY3" fmla="*/ 3315 h 1427311"/>
                <a:gd name="connsiteX4" fmla="*/ 786549 w 1315454"/>
                <a:gd name="connsiteY4" fmla="*/ 138069 h 1427311"/>
                <a:gd name="connsiteX5" fmla="*/ 1017556 w 1315454"/>
                <a:gd name="connsiteY5" fmla="*/ 397951 h 1427311"/>
                <a:gd name="connsiteX6" fmla="*/ 1238937 w 1315454"/>
                <a:gd name="connsiteY6" fmla="*/ 840713 h 1427311"/>
                <a:gd name="connsiteX7" fmla="*/ 1296688 w 1315454"/>
                <a:gd name="connsiteY7" fmla="*/ 1235349 h 1427311"/>
                <a:gd name="connsiteX8" fmla="*/ 937454 w 1315454"/>
                <a:gd name="connsiteY8" fmla="*/ 1427307 h 1427311"/>
                <a:gd name="connsiteX9" fmla="*/ 599081 w 1315454"/>
                <a:gd name="connsiteY9" fmla="*/ 1239628 h 1427311"/>
                <a:gd name="connsiteX10" fmla="*/ 6903 w 1315454"/>
                <a:gd name="connsiteY10" fmla="*/ 792587 h 1427311"/>
                <a:gd name="connsiteX0" fmla="*/ 6903 w 1315454"/>
                <a:gd name="connsiteY0" fmla="*/ 792587 h 1427311"/>
                <a:gd name="connsiteX1" fmla="*/ 26154 w 1315454"/>
                <a:gd name="connsiteY1" fmla="*/ 378700 h 1427311"/>
                <a:gd name="connsiteX2" fmla="*/ 218659 w 1315454"/>
                <a:gd name="connsiteY2" fmla="*/ 70692 h 1427311"/>
                <a:gd name="connsiteX3" fmla="*/ 468916 w 1315454"/>
                <a:gd name="connsiteY3" fmla="*/ 3315 h 1427311"/>
                <a:gd name="connsiteX4" fmla="*/ 786549 w 1315454"/>
                <a:gd name="connsiteY4" fmla="*/ 138069 h 1427311"/>
                <a:gd name="connsiteX5" fmla="*/ 1017556 w 1315454"/>
                <a:gd name="connsiteY5" fmla="*/ 397951 h 1427311"/>
                <a:gd name="connsiteX6" fmla="*/ 1238937 w 1315454"/>
                <a:gd name="connsiteY6" fmla="*/ 840713 h 1427311"/>
                <a:gd name="connsiteX7" fmla="*/ 1296688 w 1315454"/>
                <a:gd name="connsiteY7" fmla="*/ 1235349 h 1427311"/>
                <a:gd name="connsiteX8" fmla="*/ 937454 w 1315454"/>
                <a:gd name="connsiteY8" fmla="*/ 1427307 h 1427311"/>
                <a:gd name="connsiteX9" fmla="*/ 599081 w 1315454"/>
                <a:gd name="connsiteY9" fmla="*/ 1239628 h 1427311"/>
                <a:gd name="connsiteX10" fmla="*/ 6903 w 1315454"/>
                <a:gd name="connsiteY10" fmla="*/ 792587 h 1427311"/>
                <a:gd name="connsiteX0" fmla="*/ 6903 w 1315454"/>
                <a:gd name="connsiteY0" fmla="*/ 792587 h 1427311"/>
                <a:gd name="connsiteX1" fmla="*/ 26154 w 1315454"/>
                <a:gd name="connsiteY1" fmla="*/ 378700 h 1427311"/>
                <a:gd name="connsiteX2" fmla="*/ 218659 w 1315454"/>
                <a:gd name="connsiteY2" fmla="*/ 70692 h 1427311"/>
                <a:gd name="connsiteX3" fmla="*/ 468916 w 1315454"/>
                <a:gd name="connsiteY3" fmla="*/ 3315 h 1427311"/>
                <a:gd name="connsiteX4" fmla="*/ 786549 w 1315454"/>
                <a:gd name="connsiteY4" fmla="*/ 138069 h 1427311"/>
                <a:gd name="connsiteX5" fmla="*/ 1017556 w 1315454"/>
                <a:gd name="connsiteY5" fmla="*/ 397951 h 1427311"/>
                <a:gd name="connsiteX6" fmla="*/ 1238937 w 1315454"/>
                <a:gd name="connsiteY6" fmla="*/ 840713 h 1427311"/>
                <a:gd name="connsiteX7" fmla="*/ 1296688 w 1315454"/>
                <a:gd name="connsiteY7" fmla="*/ 1235349 h 1427311"/>
                <a:gd name="connsiteX8" fmla="*/ 937454 w 1315454"/>
                <a:gd name="connsiteY8" fmla="*/ 1427307 h 1427311"/>
                <a:gd name="connsiteX9" fmla="*/ 599081 w 1315454"/>
                <a:gd name="connsiteY9" fmla="*/ 1239628 h 1427311"/>
                <a:gd name="connsiteX10" fmla="*/ 6903 w 1315454"/>
                <a:gd name="connsiteY10" fmla="*/ 792587 h 1427311"/>
                <a:gd name="connsiteX0" fmla="*/ 6903 w 1321609"/>
                <a:gd name="connsiteY0" fmla="*/ 792587 h 1450630"/>
                <a:gd name="connsiteX1" fmla="*/ 26154 w 1321609"/>
                <a:gd name="connsiteY1" fmla="*/ 378700 h 1450630"/>
                <a:gd name="connsiteX2" fmla="*/ 218659 w 1321609"/>
                <a:gd name="connsiteY2" fmla="*/ 70692 h 1450630"/>
                <a:gd name="connsiteX3" fmla="*/ 468916 w 1321609"/>
                <a:gd name="connsiteY3" fmla="*/ 3315 h 1450630"/>
                <a:gd name="connsiteX4" fmla="*/ 786549 w 1321609"/>
                <a:gd name="connsiteY4" fmla="*/ 138069 h 1450630"/>
                <a:gd name="connsiteX5" fmla="*/ 1017556 w 1321609"/>
                <a:gd name="connsiteY5" fmla="*/ 397951 h 1450630"/>
                <a:gd name="connsiteX6" fmla="*/ 1238937 w 1321609"/>
                <a:gd name="connsiteY6" fmla="*/ 840713 h 1450630"/>
                <a:gd name="connsiteX7" fmla="*/ 1296688 w 1321609"/>
                <a:gd name="connsiteY7" fmla="*/ 1235349 h 1450630"/>
                <a:gd name="connsiteX8" fmla="*/ 851949 w 1321609"/>
                <a:gd name="connsiteY8" fmla="*/ 1450627 h 1450630"/>
                <a:gd name="connsiteX9" fmla="*/ 599081 w 1321609"/>
                <a:gd name="connsiteY9" fmla="*/ 1239628 h 1450630"/>
                <a:gd name="connsiteX10" fmla="*/ 6903 w 1321609"/>
                <a:gd name="connsiteY10" fmla="*/ 792587 h 1450630"/>
                <a:gd name="connsiteX0" fmla="*/ 6903 w 1321609"/>
                <a:gd name="connsiteY0" fmla="*/ 792587 h 1450627"/>
                <a:gd name="connsiteX1" fmla="*/ 26154 w 1321609"/>
                <a:gd name="connsiteY1" fmla="*/ 378700 h 1450627"/>
                <a:gd name="connsiteX2" fmla="*/ 218659 w 1321609"/>
                <a:gd name="connsiteY2" fmla="*/ 70692 h 1450627"/>
                <a:gd name="connsiteX3" fmla="*/ 468916 w 1321609"/>
                <a:gd name="connsiteY3" fmla="*/ 3315 h 1450627"/>
                <a:gd name="connsiteX4" fmla="*/ 786549 w 1321609"/>
                <a:gd name="connsiteY4" fmla="*/ 138069 h 1450627"/>
                <a:gd name="connsiteX5" fmla="*/ 1017556 w 1321609"/>
                <a:gd name="connsiteY5" fmla="*/ 397951 h 1450627"/>
                <a:gd name="connsiteX6" fmla="*/ 1238937 w 1321609"/>
                <a:gd name="connsiteY6" fmla="*/ 840713 h 1450627"/>
                <a:gd name="connsiteX7" fmla="*/ 1296688 w 1321609"/>
                <a:gd name="connsiteY7" fmla="*/ 1235349 h 1450627"/>
                <a:gd name="connsiteX8" fmla="*/ 851949 w 1321609"/>
                <a:gd name="connsiteY8" fmla="*/ 1450627 h 1450627"/>
                <a:gd name="connsiteX9" fmla="*/ 599081 w 1321609"/>
                <a:gd name="connsiteY9" fmla="*/ 1239628 h 1450627"/>
                <a:gd name="connsiteX10" fmla="*/ 6903 w 1321609"/>
                <a:gd name="connsiteY10" fmla="*/ 792587 h 1450627"/>
                <a:gd name="connsiteX0" fmla="*/ 6903 w 1321609"/>
                <a:gd name="connsiteY0" fmla="*/ 792587 h 1460998"/>
                <a:gd name="connsiteX1" fmla="*/ 26154 w 1321609"/>
                <a:gd name="connsiteY1" fmla="*/ 378700 h 1460998"/>
                <a:gd name="connsiteX2" fmla="*/ 218659 w 1321609"/>
                <a:gd name="connsiteY2" fmla="*/ 70692 h 1460998"/>
                <a:gd name="connsiteX3" fmla="*/ 468916 w 1321609"/>
                <a:gd name="connsiteY3" fmla="*/ 3315 h 1460998"/>
                <a:gd name="connsiteX4" fmla="*/ 786549 w 1321609"/>
                <a:gd name="connsiteY4" fmla="*/ 138069 h 1460998"/>
                <a:gd name="connsiteX5" fmla="*/ 1017556 w 1321609"/>
                <a:gd name="connsiteY5" fmla="*/ 397951 h 1460998"/>
                <a:gd name="connsiteX6" fmla="*/ 1238937 w 1321609"/>
                <a:gd name="connsiteY6" fmla="*/ 840713 h 1460998"/>
                <a:gd name="connsiteX7" fmla="*/ 1296688 w 1321609"/>
                <a:gd name="connsiteY7" fmla="*/ 1235349 h 1460998"/>
                <a:gd name="connsiteX8" fmla="*/ 851949 w 1321609"/>
                <a:gd name="connsiteY8" fmla="*/ 1450627 h 1460998"/>
                <a:gd name="connsiteX9" fmla="*/ 599081 w 1321609"/>
                <a:gd name="connsiteY9" fmla="*/ 1239628 h 1460998"/>
                <a:gd name="connsiteX10" fmla="*/ 6903 w 1321609"/>
                <a:gd name="connsiteY10" fmla="*/ 792587 h 1460998"/>
                <a:gd name="connsiteX0" fmla="*/ 6903 w 1321609"/>
                <a:gd name="connsiteY0" fmla="*/ 887329 h 1555740"/>
                <a:gd name="connsiteX1" fmla="*/ 26154 w 1321609"/>
                <a:gd name="connsiteY1" fmla="*/ 473442 h 1555740"/>
                <a:gd name="connsiteX2" fmla="*/ 218659 w 1321609"/>
                <a:gd name="connsiteY2" fmla="*/ 165434 h 1555740"/>
                <a:gd name="connsiteX3" fmla="*/ 523328 w 1321609"/>
                <a:gd name="connsiteY3" fmla="*/ 892 h 1555740"/>
                <a:gd name="connsiteX4" fmla="*/ 786549 w 1321609"/>
                <a:gd name="connsiteY4" fmla="*/ 232811 h 1555740"/>
                <a:gd name="connsiteX5" fmla="*/ 1017556 w 1321609"/>
                <a:gd name="connsiteY5" fmla="*/ 492693 h 1555740"/>
                <a:gd name="connsiteX6" fmla="*/ 1238937 w 1321609"/>
                <a:gd name="connsiteY6" fmla="*/ 935455 h 1555740"/>
                <a:gd name="connsiteX7" fmla="*/ 1296688 w 1321609"/>
                <a:gd name="connsiteY7" fmla="*/ 1330091 h 1555740"/>
                <a:gd name="connsiteX8" fmla="*/ 851949 w 1321609"/>
                <a:gd name="connsiteY8" fmla="*/ 1545369 h 1555740"/>
                <a:gd name="connsiteX9" fmla="*/ 599081 w 1321609"/>
                <a:gd name="connsiteY9" fmla="*/ 1334370 h 1555740"/>
                <a:gd name="connsiteX10" fmla="*/ 6903 w 1321609"/>
                <a:gd name="connsiteY10" fmla="*/ 887329 h 1555740"/>
                <a:gd name="connsiteX0" fmla="*/ 6903 w 1321609"/>
                <a:gd name="connsiteY0" fmla="*/ 886573 h 1554984"/>
                <a:gd name="connsiteX1" fmla="*/ 26154 w 1321609"/>
                <a:gd name="connsiteY1" fmla="*/ 472686 h 1554984"/>
                <a:gd name="connsiteX2" fmla="*/ 218659 w 1321609"/>
                <a:gd name="connsiteY2" fmla="*/ 164678 h 1554984"/>
                <a:gd name="connsiteX3" fmla="*/ 523328 w 1321609"/>
                <a:gd name="connsiteY3" fmla="*/ 136 h 1554984"/>
                <a:gd name="connsiteX4" fmla="*/ 829301 w 1321609"/>
                <a:gd name="connsiteY4" fmla="*/ 189303 h 1554984"/>
                <a:gd name="connsiteX5" fmla="*/ 1017556 w 1321609"/>
                <a:gd name="connsiteY5" fmla="*/ 491937 h 1554984"/>
                <a:gd name="connsiteX6" fmla="*/ 1238937 w 1321609"/>
                <a:gd name="connsiteY6" fmla="*/ 934699 h 1554984"/>
                <a:gd name="connsiteX7" fmla="*/ 1296688 w 1321609"/>
                <a:gd name="connsiteY7" fmla="*/ 1329335 h 1554984"/>
                <a:gd name="connsiteX8" fmla="*/ 851949 w 1321609"/>
                <a:gd name="connsiteY8" fmla="*/ 1544613 h 1554984"/>
                <a:gd name="connsiteX9" fmla="*/ 599081 w 1321609"/>
                <a:gd name="connsiteY9" fmla="*/ 1333614 h 1554984"/>
                <a:gd name="connsiteX10" fmla="*/ 6903 w 1321609"/>
                <a:gd name="connsiteY10" fmla="*/ 886573 h 1554984"/>
                <a:gd name="connsiteX0" fmla="*/ 6903 w 1321609"/>
                <a:gd name="connsiteY0" fmla="*/ 886573 h 1554984"/>
                <a:gd name="connsiteX1" fmla="*/ 26154 w 1321609"/>
                <a:gd name="connsiteY1" fmla="*/ 472686 h 1554984"/>
                <a:gd name="connsiteX2" fmla="*/ 218659 w 1321609"/>
                <a:gd name="connsiteY2" fmla="*/ 164678 h 1554984"/>
                <a:gd name="connsiteX3" fmla="*/ 523328 w 1321609"/>
                <a:gd name="connsiteY3" fmla="*/ 136 h 1554984"/>
                <a:gd name="connsiteX4" fmla="*/ 829301 w 1321609"/>
                <a:gd name="connsiteY4" fmla="*/ 189303 h 1554984"/>
                <a:gd name="connsiteX5" fmla="*/ 1017556 w 1321609"/>
                <a:gd name="connsiteY5" fmla="*/ 491937 h 1554984"/>
                <a:gd name="connsiteX6" fmla="*/ 1238937 w 1321609"/>
                <a:gd name="connsiteY6" fmla="*/ 934699 h 1554984"/>
                <a:gd name="connsiteX7" fmla="*/ 1296688 w 1321609"/>
                <a:gd name="connsiteY7" fmla="*/ 1329335 h 1554984"/>
                <a:gd name="connsiteX8" fmla="*/ 851949 w 1321609"/>
                <a:gd name="connsiteY8" fmla="*/ 1544613 h 1554984"/>
                <a:gd name="connsiteX9" fmla="*/ 599081 w 1321609"/>
                <a:gd name="connsiteY9" fmla="*/ 1333614 h 1554984"/>
                <a:gd name="connsiteX10" fmla="*/ 6903 w 1321609"/>
                <a:gd name="connsiteY10" fmla="*/ 886573 h 1554984"/>
                <a:gd name="connsiteX0" fmla="*/ 6903 w 1320876"/>
                <a:gd name="connsiteY0" fmla="*/ 886573 h 1554984"/>
                <a:gd name="connsiteX1" fmla="*/ 26154 w 1320876"/>
                <a:gd name="connsiteY1" fmla="*/ 472686 h 1554984"/>
                <a:gd name="connsiteX2" fmla="*/ 218659 w 1320876"/>
                <a:gd name="connsiteY2" fmla="*/ 164678 h 1554984"/>
                <a:gd name="connsiteX3" fmla="*/ 523328 w 1320876"/>
                <a:gd name="connsiteY3" fmla="*/ 136 h 1554984"/>
                <a:gd name="connsiteX4" fmla="*/ 829301 w 1320876"/>
                <a:gd name="connsiteY4" fmla="*/ 189303 h 1554984"/>
                <a:gd name="connsiteX5" fmla="*/ 1044762 w 1320876"/>
                <a:gd name="connsiteY5" fmla="*/ 472504 h 1554984"/>
                <a:gd name="connsiteX6" fmla="*/ 1238937 w 1320876"/>
                <a:gd name="connsiteY6" fmla="*/ 934699 h 1554984"/>
                <a:gd name="connsiteX7" fmla="*/ 1296688 w 1320876"/>
                <a:gd name="connsiteY7" fmla="*/ 1329335 h 1554984"/>
                <a:gd name="connsiteX8" fmla="*/ 851949 w 1320876"/>
                <a:gd name="connsiteY8" fmla="*/ 1544613 h 1554984"/>
                <a:gd name="connsiteX9" fmla="*/ 599081 w 1320876"/>
                <a:gd name="connsiteY9" fmla="*/ 1333614 h 1554984"/>
                <a:gd name="connsiteX10" fmla="*/ 6903 w 1320876"/>
                <a:gd name="connsiteY10" fmla="*/ 886573 h 1554984"/>
                <a:gd name="connsiteX0" fmla="*/ 851949 w 1320876"/>
                <a:gd name="connsiteY0" fmla="*/ 1544613 h 1582707"/>
                <a:gd name="connsiteX1" fmla="*/ 599081 w 1320876"/>
                <a:gd name="connsiteY1" fmla="*/ 1333614 h 1582707"/>
                <a:gd name="connsiteX2" fmla="*/ 6903 w 1320876"/>
                <a:gd name="connsiteY2" fmla="*/ 886573 h 1582707"/>
                <a:gd name="connsiteX3" fmla="*/ 26154 w 1320876"/>
                <a:gd name="connsiteY3" fmla="*/ 472686 h 1582707"/>
                <a:gd name="connsiteX4" fmla="*/ 218659 w 1320876"/>
                <a:gd name="connsiteY4" fmla="*/ 164678 h 1582707"/>
                <a:gd name="connsiteX5" fmla="*/ 523328 w 1320876"/>
                <a:gd name="connsiteY5" fmla="*/ 136 h 1582707"/>
                <a:gd name="connsiteX6" fmla="*/ 829301 w 1320876"/>
                <a:gd name="connsiteY6" fmla="*/ 189303 h 1582707"/>
                <a:gd name="connsiteX7" fmla="*/ 1044762 w 1320876"/>
                <a:gd name="connsiteY7" fmla="*/ 472504 h 1582707"/>
                <a:gd name="connsiteX8" fmla="*/ 1238937 w 1320876"/>
                <a:gd name="connsiteY8" fmla="*/ 934699 h 1582707"/>
                <a:gd name="connsiteX9" fmla="*/ 1296688 w 1320876"/>
                <a:gd name="connsiteY9" fmla="*/ 1329335 h 1582707"/>
                <a:gd name="connsiteX10" fmla="*/ 888872 w 1320876"/>
                <a:gd name="connsiteY10" fmla="*/ 1581536 h 1582707"/>
                <a:gd name="connsiteX0" fmla="*/ 599081 w 1320876"/>
                <a:gd name="connsiteY0" fmla="*/ 1333614 h 1582707"/>
                <a:gd name="connsiteX1" fmla="*/ 6903 w 1320876"/>
                <a:gd name="connsiteY1" fmla="*/ 886573 h 1582707"/>
                <a:gd name="connsiteX2" fmla="*/ 26154 w 1320876"/>
                <a:gd name="connsiteY2" fmla="*/ 472686 h 1582707"/>
                <a:gd name="connsiteX3" fmla="*/ 218659 w 1320876"/>
                <a:gd name="connsiteY3" fmla="*/ 164678 h 1582707"/>
                <a:gd name="connsiteX4" fmla="*/ 523328 w 1320876"/>
                <a:gd name="connsiteY4" fmla="*/ 136 h 1582707"/>
                <a:gd name="connsiteX5" fmla="*/ 829301 w 1320876"/>
                <a:gd name="connsiteY5" fmla="*/ 189303 h 1582707"/>
                <a:gd name="connsiteX6" fmla="*/ 1044762 w 1320876"/>
                <a:gd name="connsiteY6" fmla="*/ 472504 h 1582707"/>
                <a:gd name="connsiteX7" fmla="*/ 1238937 w 1320876"/>
                <a:gd name="connsiteY7" fmla="*/ 934699 h 1582707"/>
                <a:gd name="connsiteX8" fmla="*/ 1296688 w 1320876"/>
                <a:gd name="connsiteY8" fmla="*/ 1329335 h 1582707"/>
                <a:gd name="connsiteX9" fmla="*/ 888872 w 1320876"/>
                <a:gd name="connsiteY9" fmla="*/ 1581536 h 1582707"/>
                <a:gd name="connsiteX0" fmla="*/ 894461 w 1320876"/>
                <a:gd name="connsiteY0" fmla="*/ 1586242 h 1586242"/>
                <a:gd name="connsiteX1" fmla="*/ 6903 w 1320876"/>
                <a:gd name="connsiteY1" fmla="*/ 886573 h 1586242"/>
                <a:gd name="connsiteX2" fmla="*/ 26154 w 1320876"/>
                <a:gd name="connsiteY2" fmla="*/ 472686 h 1586242"/>
                <a:gd name="connsiteX3" fmla="*/ 218659 w 1320876"/>
                <a:gd name="connsiteY3" fmla="*/ 164678 h 1586242"/>
                <a:gd name="connsiteX4" fmla="*/ 523328 w 1320876"/>
                <a:gd name="connsiteY4" fmla="*/ 136 h 1586242"/>
                <a:gd name="connsiteX5" fmla="*/ 829301 w 1320876"/>
                <a:gd name="connsiteY5" fmla="*/ 189303 h 1586242"/>
                <a:gd name="connsiteX6" fmla="*/ 1044762 w 1320876"/>
                <a:gd name="connsiteY6" fmla="*/ 472504 h 1586242"/>
                <a:gd name="connsiteX7" fmla="*/ 1238937 w 1320876"/>
                <a:gd name="connsiteY7" fmla="*/ 934699 h 1586242"/>
                <a:gd name="connsiteX8" fmla="*/ 1296688 w 1320876"/>
                <a:gd name="connsiteY8" fmla="*/ 1329335 h 1586242"/>
                <a:gd name="connsiteX9" fmla="*/ 888872 w 1320876"/>
                <a:gd name="connsiteY9" fmla="*/ 1581536 h 1586242"/>
                <a:gd name="connsiteX0" fmla="*/ 894461 w 1318508"/>
                <a:gd name="connsiteY0" fmla="*/ 1586242 h 1605946"/>
                <a:gd name="connsiteX1" fmla="*/ 6903 w 1318508"/>
                <a:gd name="connsiteY1" fmla="*/ 886573 h 1605946"/>
                <a:gd name="connsiteX2" fmla="*/ 26154 w 1318508"/>
                <a:gd name="connsiteY2" fmla="*/ 472686 h 1605946"/>
                <a:gd name="connsiteX3" fmla="*/ 218659 w 1318508"/>
                <a:gd name="connsiteY3" fmla="*/ 164678 h 1605946"/>
                <a:gd name="connsiteX4" fmla="*/ 523328 w 1318508"/>
                <a:gd name="connsiteY4" fmla="*/ 136 h 1605946"/>
                <a:gd name="connsiteX5" fmla="*/ 829301 w 1318508"/>
                <a:gd name="connsiteY5" fmla="*/ 189303 h 1605946"/>
                <a:gd name="connsiteX6" fmla="*/ 1044762 w 1318508"/>
                <a:gd name="connsiteY6" fmla="*/ 472504 h 1605946"/>
                <a:gd name="connsiteX7" fmla="*/ 1238937 w 1318508"/>
                <a:gd name="connsiteY7" fmla="*/ 934699 h 1605946"/>
                <a:gd name="connsiteX8" fmla="*/ 1296688 w 1318508"/>
                <a:gd name="connsiteY8" fmla="*/ 1329335 h 1605946"/>
                <a:gd name="connsiteX9" fmla="*/ 884986 w 1318508"/>
                <a:gd name="connsiteY9" fmla="*/ 1604856 h 1605946"/>
                <a:gd name="connsiteX0" fmla="*/ 894461 w 1321294"/>
                <a:gd name="connsiteY0" fmla="*/ 1586242 h 1586612"/>
                <a:gd name="connsiteX1" fmla="*/ 6903 w 1321294"/>
                <a:gd name="connsiteY1" fmla="*/ 886573 h 1586612"/>
                <a:gd name="connsiteX2" fmla="*/ 26154 w 1321294"/>
                <a:gd name="connsiteY2" fmla="*/ 472686 h 1586612"/>
                <a:gd name="connsiteX3" fmla="*/ 218659 w 1321294"/>
                <a:gd name="connsiteY3" fmla="*/ 164678 h 1586612"/>
                <a:gd name="connsiteX4" fmla="*/ 523328 w 1321294"/>
                <a:gd name="connsiteY4" fmla="*/ 136 h 1586612"/>
                <a:gd name="connsiteX5" fmla="*/ 829301 w 1321294"/>
                <a:gd name="connsiteY5" fmla="*/ 189303 h 1586612"/>
                <a:gd name="connsiteX6" fmla="*/ 1044762 w 1321294"/>
                <a:gd name="connsiteY6" fmla="*/ 472504 h 1586612"/>
                <a:gd name="connsiteX7" fmla="*/ 1238937 w 1321294"/>
                <a:gd name="connsiteY7" fmla="*/ 934699 h 1586612"/>
                <a:gd name="connsiteX8" fmla="*/ 1296688 w 1321294"/>
                <a:gd name="connsiteY8" fmla="*/ 1329335 h 1586612"/>
                <a:gd name="connsiteX9" fmla="*/ 846120 w 1321294"/>
                <a:gd name="connsiteY9" fmla="*/ 1585423 h 1586612"/>
                <a:gd name="connsiteX0" fmla="*/ 944987 w 1321294"/>
                <a:gd name="connsiteY0" fmla="*/ 1663974 h 1663974"/>
                <a:gd name="connsiteX1" fmla="*/ 6903 w 1321294"/>
                <a:gd name="connsiteY1" fmla="*/ 886573 h 1663974"/>
                <a:gd name="connsiteX2" fmla="*/ 26154 w 1321294"/>
                <a:gd name="connsiteY2" fmla="*/ 472686 h 1663974"/>
                <a:gd name="connsiteX3" fmla="*/ 218659 w 1321294"/>
                <a:gd name="connsiteY3" fmla="*/ 164678 h 1663974"/>
                <a:gd name="connsiteX4" fmla="*/ 523328 w 1321294"/>
                <a:gd name="connsiteY4" fmla="*/ 136 h 1663974"/>
                <a:gd name="connsiteX5" fmla="*/ 829301 w 1321294"/>
                <a:gd name="connsiteY5" fmla="*/ 189303 h 1663974"/>
                <a:gd name="connsiteX6" fmla="*/ 1044762 w 1321294"/>
                <a:gd name="connsiteY6" fmla="*/ 472504 h 1663974"/>
                <a:gd name="connsiteX7" fmla="*/ 1238937 w 1321294"/>
                <a:gd name="connsiteY7" fmla="*/ 934699 h 1663974"/>
                <a:gd name="connsiteX8" fmla="*/ 1296688 w 1321294"/>
                <a:gd name="connsiteY8" fmla="*/ 1329335 h 1663974"/>
                <a:gd name="connsiteX9" fmla="*/ 846120 w 1321294"/>
                <a:gd name="connsiteY9" fmla="*/ 1585423 h 1663974"/>
                <a:gd name="connsiteX0" fmla="*/ 828390 w 1321294"/>
                <a:gd name="connsiteY0" fmla="*/ 1543490 h 1586612"/>
                <a:gd name="connsiteX1" fmla="*/ 6903 w 1321294"/>
                <a:gd name="connsiteY1" fmla="*/ 886573 h 1586612"/>
                <a:gd name="connsiteX2" fmla="*/ 26154 w 1321294"/>
                <a:gd name="connsiteY2" fmla="*/ 472686 h 1586612"/>
                <a:gd name="connsiteX3" fmla="*/ 218659 w 1321294"/>
                <a:gd name="connsiteY3" fmla="*/ 164678 h 1586612"/>
                <a:gd name="connsiteX4" fmla="*/ 523328 w 1321294"/>
                <a:gd name="connsiteY4" fmla="*/ 136 h 1586612"/>
                <a:gd name="connsiteX5" fmla="*/ 829301 w 1321294"/>
                <a:gd name="connsiteY5" fmla="*/ 189303 h 1586612"/>
                <a:gd name="connsiteX6" fmla="*/ 1044762 w 1321294"/>
                <a:gd name="connsiteY6" fmla="*/ 472504 h 1586612"/>
                <a:gd name="connsiteX7" fmla="*/ 1238937 w 1321294"/>
                <a:gd name="connsiteY7" fmla="*/ 934699 h 1586612"/>
                <a:gd name="connsiteX8" fmla="*/ 1296688 w 1321294"/>
                <a:gd name="connsiteY8" fmla="*/ 1329335 h 1586612"/>
                <a:gd name="connsiteX9" fmla="*/ 846120 w 1321294"/>
                <a:gd name="connsiteY9" fmla="*/ 1585423 h 1586612"/>
                <a:gd name="connsiteX0" fmla="*/ 828390 w 1323253"/>
                <a:gd name="connsiteY0" fmla="*/ 1543490 h 1543490"/>
                <a:gd name="connsiteX1" fmla="*/ 6903 w 1323253"/>
                <a:gd name="connsiteY1" fmla="*/ 886573 h 1543490"/>
                <a:gd name="connsiteX2" fmla="*/ 26154 w 1323253"/>
                <a:gd name="connsiteY2" fmla="*/ 472686 h 1543490"/>
                <a:gd name="connsiteX3" fmla="*/ 218659 w 1323253"/>
                <a:gd name="connsiteY3" fmla="*/ 164678 h 1543490"/>
                <a:gd name="connsiteX4" fmla="*/ 523328 w 1323253"/>
                <a:gd name="connsiteY4" fmla="*/ 136 h 1543490"/>
                <a:gd name="connsiteX5" fmla="*/ 829301 w 1323253"/>
                <a:gd name="connsiteY5" fmla="*/ 189303 h 1543490"/>
                <a:gd name="connsiteX6" fmla="*/ 1044762 w 1323253"/>
                <a:gd name="connsiteY6" fmla="*/ 472504 h 1543490"/>
                <a:gd name="connsiteX7" fmla="*/ 1238937 w 1323253"/>
                <a:gd name="connsiteY7" fmla="*/ 934699 h 1543490"/>
                <a:gd name="connsiteX8" fmla="*/ 1296688 w 1323253"/>
                <a:gd name="connsiteY8" fmla="*/ 1329335 h 1543490"/>
                <a:gd name="connsiteX9" fmla="*/ 818914 w 1323253"/>
                <a:gd name="connsiteY9" fmla="*/ 1531011 h 1543490"/>
                <a:gd name="connsiteX0" fmla="*/ 828390 w 1322661"/>
                <a:gd name="connsiteY0" fmla="*/ 1543490 h 1548866"/>
                <a:gd name="connsiteX1" fmla="*/ 6903 w 1322661"/>
                <a:gd name="connsiteY1" fmla="*/ 886573 h 1548866"/>
                <a:gd name="connsiteX2" fmla="*/ 26154 w 1322661"/>
                <a:gd name="connsiteY2" fmla="*/ 472686 h 1548866"/>
                <a:gd name="connsiteX3" fmla="*/ 218659 w 1322661"/>
                <a:gd name="connsiteY3" fmla="*/ 164678 h 1548866"/>
                <a:gd name="connsiteX4" fmla="*/ 523328 w 1322661"/>
                <a:gd name="connsiteY4" fmla="*/ 136 h 1548866"/>
                <a:gd name="connsiteX5" fmla="*/ 829301 w 1322661"/>
                <a:gd name="connsiteY5" fmla="*/ 189303 h 1548866"/>
                <a:gd name="connsiteX6" fmla="*/ 1044762 w 1322661"/>
                <a:gd name="connsiteY6" fmla="*/ 472504 h 1548866"/>
                <a:gd name="connsiteX7" fmla="*/ 1238937 w 1322661"/>
                <a:gd name="connsiteY7" fmla="*/ 934699 h 1548866"/>
                <a:gd name="connsiteX8" fmla="*/ 1296688 w 1322661"/>
                <a:gd name="connsiteY8" fmla="*/ 1329335 h 1548866"/>
                <a:gd name="connsiteX9" fmla="*/ 827119 w 1322661"/>
                <a:gd name="connsiteY9" fmla="*/ 1547421 h 1548866"/>
                <a:gd name="connsiteX0" fmla="*/ 828390 w 1322219"/>
                <a:gd name="connsiteY0" fmla="*/ 1543490 h 1548866"/>
                <a:gd name="connsiteX1" fmla="*/ 6903 w 1322219"/>
                <a:gd name="connsiteY1" fmla="*/ 886573 h 1548866"/>
                <a:gd name="connsiteX2" fmla="*/ 26154 w 1322219"/>
                <a:gd name="connsiteY2" fmla="*/ 472686 h 1548866"/>
                <a:gd name="connsiteX3" fmla="*/ 218659 w 1322219"/>
                <a:gd name="connsiteY3" fmla="*/ 164678 h 1548866"/>
                <a:gd name="connsiteX4" fmla="*/ 523328 w 1322219"/>
                <a:gd name="connsiteY4" fmla="*/ 136 h 1548866"/>
                <a:gd name="connsiteX5" fmla="*/ 829301 w 1322219"/>
                <a:gd name="connsiteY5" fmla="*/ 189303 h 1548866"/>
                <a:gd name="connsiteX6" fmla="*/ 1044762 w 1322219"/>
                <a:gd name="connsiteY6" fmla="*/ 472504 h 1548866"/>
                <a:gd name="connsiteX7" fmla="*/ 1238937 w 1322219"/>
                <a:gd name="connsiteY7" fmla="*/ 934699 h 1548866"/>
                <a:gd name="connsiteX8" fmla="*/ 1296688 w 1322219"/>
                <a:gd name="connsiteY8" fmla="*/ 1329335 h 1548866"/>
                <a:gd name="connsiteX9" fmla="*/ 833273 w 1322219"/>
                <a:gd name="connsiteY9" fmla="*/ 1547421 h 1548866"/>
                <a:gd name="connsiteX0" fmla="*/ 837578 w 1331407"/>
                <a:gd name="connsiteY0" fmla="*/ 1543490 h 1548866"/>
                <a:gd name="connsiteX1" fmla="*/ 3784 w 1331407"/>
                <a:gd name="connsiteY1" fmla="*/ 876317 h 1548866"/>
                <a:gd name="connsiteX2" fmla="*/ 35342 w 1331407"/>
                <a:gd name="connsiteY2" fmla="*/ 472686 h 1548866"/>
                <a:gd name="connsiteX3" fmla="*/ 227847 w 1331407"/>
                <a:gd name="connsiteY3" fmla="*/ 164678 h 1548866"/>
                <a:gd name="connsiteX4" fmla="*/ 532516 w 1331407"/>
                <a:gd name="connsiteY4" fmla="*/ 136 h 1548866"/>
                <a:gd name="connsiteX5" fmla="*/ 838489 w 1331407"/>
                <a:gd name="connsiteY5" fmla="*/ 189303 h 1548866"/>
                <a:gd name="connsiteX6" fmla="*/ 1053950 w 1331407"/>
                <a:gd name="connsiteY6" fmla="*/ 472504 h 1548866"/>
                <a:gd name="connsiteX7" fmla="*/ 1248125 w 1331407"/>
                <a:gd name="connsiteY7" fmla="*/ 934699 h 1548866"/>
                <a:gd name="connsiteX8" fmla="*/ 1305876 w 1331407"/>
                <a:gd name="connsiteY8" fmla="*/ 1329335 h 1548866"/>
                <a:gd name="connsiteX9" fmla="*/ 842461 w 1331407"/>
                <a:gd name="connsiteY9" fmla="*/ 1547421 h 1548866"/>
                <a:gd name="connsiteX0" fmla="*/ 837578 w 1253334"/>
                <a:gd name="connsiteY0" fmla="*/ 1543490 h 1549414"/>
                <a:gd name="connsiteX1" fmla="*/ 3784 w 1253334"/>
                <a:gd name="connsiteY1" fmla="*/ 876317 h 1549414"/>
                <a:gd name="connsiteX2" fmla="*/ 35342 w 1253334"/>
                <a:gd name="connsiteY2" fmla="*/ 472686 h 1549414"/>
                <a:gd name="connsiteX3" fmla="*/ 227847 w 1253334"/>
                <a:gd name="connsiteY3" fmla="*/ 164678 h 1549414"/>
                <a:gd name="connsiteX4" fmla="*/ 532516 w 1253334"/>
                <a:gd name="connsiteY4" fmla="*/ 136 h 1549414"/>
                <a:gd name="connsiteX5" fmla="*/ 838489 w 1253334"/>
                <a:gd name="connsiteY5" fmla="*/ 189303 h 1549414"/>
                <a:gd name="connsiteX6" fmla="*/ 1053950 w 1253334"/>
                <a:gd name="connsiteY6" fmla="*/ 472504 h 1549414"/>
                <a:gd name="connsiteX7" fmla="*/ 1248125 w 1253334"/>
                <a:gd name="connsiteY7" fmla="*/ 934699 h 1549414"/>
                <a:gd name="connsiteX8" fmla="*/ 1166391 w 1253334"/>
                <a:gd name="connsiteY8" fmla="*/ 1370360 h 1549414"/>
                <a:gd name="connsiteX9" fmla="*/ 842461 w 1253334"/>
                <a:gd name="connsiteY9" fmla="*/ 1547421 h 1549414"/>
                <a:gd name="connsiteX0" fmla="*/ 837578 w 1253334"/>
                <a:gd name="connsiteY0" fmla="*/ 1543490 h 1549414"/>
                <a:gd name="connsiteX1" fmla="*/ 378141 w 1253334"/>
                <a:gd name="connsiteY1" fmla="*/ 1201568 h 1549414"/>
                <a:gd name="connsiteX2" fmla="*/ 3784 w 1253334"/>
                <a:gd name="connsiteY2" fmla="*/ 876317 h 1549414"/>
                <a:gd name="connsiteX3" fmla="*/ 35342 w 1253334"/>
                <a:gd name="connsiteY3" fmla="*/ 472686 h 1549414"/>
                <a:gd name="connsiteX4" fmla="*/ 227847 w 1253334"/>
                <a:gd name="connsiteY4" fmla="*/ 164678 h 1549414"/>
                <a:gd name="connsiteX5" fmla="*/ 532516 w 1253334"/>
                <a:gd name="connsiteY5" fmla="*/ 136 h 1549414"/>
                <a:gd name="connsiteX6" fmla="*/ 838489 w 1253334"/>
                <a:gd name="connsiteY6" fmla="*/ 189303 h 1549414"/>
                <a:gd name="connsiteX7" fmla="*/ 1053950 w 1253334"/>
                <a:gd name="connsiteY7" fmla="*/ 472504 h 1549414"/>
                <a:gd name="connsiteX8" fmla="*/ 1248125 w 1253334"/>
                <a:gd name="connsiteY8" fmla="*/ 934699 h 1549414"/>
                <a:gd name="connsiteX9" fmla="*/ 1166391 w 1253334"/>
                <a:gd name="connsiteY9" fmla="*/ 1370360 h 1549414"/>
                <a:gd name="connsiteX10" fmla="*/ 842461 w 1253334"/>
                <a:gd name="connsiteY10" fmla="*/ 1547421 h 1549414"/>
                <a:gd name="connsiteX0" fmla="*/ 864170 w 1279926"/>
                <a:gd name="connsiteY0" fmla="*/ 1543490 h 1549414"/>
                <a:gd name="connsiteX1" fmla="*/ 404733 w 1279926"/>
                <a:gd name="connsiteY1" fmla="*/ 1201568 h 1549414"/>
                <a:gd name="connsiteX2" fmla="*/ 22819 w 1279926"/>
                <a:gd name="connsiteY2" fmla="*/ 1087769 h 1549414"/>
                <a:gd name="connsiteX3" fmla="*/ 30376 w 1279926"/>
                <a:gd name="connsiteY3" fmla="*/ 876317 h 1549414"/>
                <a:gd name="connsiteX4" fmla="*/ 61934 w 1279926"/>
                <a:gd name="connsiteY4" fmla="*/ 472686 h 1549414"/>
                <a:gd name="connsiteX5" fmla="*/ 254439 w 1279926"/>
                <a:gd name="connsiteY5" fmla="*/ 164678 h 1549414"/>
                <a:gd name="connsiteX6" fmla="*/ 559108 w 1279926"/>
                <a:gd name="connsiteY6" fmla="*/ 136 h 1549414"/>
                <a:gd name="connsiteX7" fmla="*/ 865081 w 1279926"/>
                <a:gd name="connsiteY7" fmla="*/ 189303 h 1549414"/>
                <a:gd name="connsiteX8" fmla="*/ 1080542 w 1279926"/>
                <a:gd name="connsiteY8" fmla="*/ 472504 h 1549414"/>
                <a:gd name="connsiteX9" fmla="*/ 1274717 w 1279926"/>
                <a:gd name="connsiteY9" fmla="*/ 934699 h 1549414"/>
                <a:gd name="connsiteX10" fmla="*/ 1192983 w 1279926"/>
                <a:gd name="connsiteY10" fmla="*/ 1370360 h 1549414"/>
                <a:gd name="connsiteX11" fmla="*/ 869053 w 1279926"/>
                <a:gd name="connsiteY11" fmla="*/ 1547421 h 1549414"/>
                <a:gd name="connsiteX0" fmla="*/ 848575 w 1264331"/>
                <a:gd name="connsiteY0" fmla="*/ 1543490 h 1549414"/>
                <a:gd name="connsiteX1" fmla="*/ 389138 w 1264331"/>
                <a:gd name="connsiteY1" fmla="*/ 1201568 h 1549414"/>
                <a:gd name="connsiteX2" fmla="*/ 7224 w 1264331"/>
                <a:gd name="connsiteY2" fmla="*/ 1087769 h 1549414"/>
                <a:gd name="connsiteX3" fmla="*/ 14781 w 1264331"/>
                <a:gd name="connsiteY3" fmla="*/ 876317 h 1549414"/>
                <a:gd name="connsiteX4" fmla="*/ 46339 w 1264331"/>
                <a:gd name="connsiteY4" fmla="*/ 472686 h 1549414"/>
                <a:gd name="connsiteX5" fmla="*/ 238844 w 1264331"/>
                <a:gd name="connsiteY5" fmla="*/ 164678 h 1549414"/>
                <a:gd name="connsiteX6" fmla="*/ 543513 w 1264331"/>
                <a:gd name="connsiteY6" fmla="*/ 136 h 1549414"/>
                <a:gd name="connsiteX7" fmla="*/ 849486 w 1264331"/>
                <a:gd name="connsiteY7" fmla="*/ 189303 h 1549414"/>
                <a:gd name="connsiteX8" fmla="*/ 1064947 w 1264331"/>
                <a:gd name="connsiteY8" fmla="*/ 472504 h 1549414"/>
                <a:gd name="connsiteX9" fmla="*/ 1259122 w 1264331"/>
                <a:gd name="connsiteY9" fmla="*/ 934699 h 1549414"/>
                <a:gd name="connsiteX10" fmla="*/ 1177388 w 1264331"/>
                <a:gd name="connsiteY10" fmla="*/ 1370360 h 1549414"/>
                <a:gd name="connsiteX11" fmla="*/ 853458 w 1264331"/>
                <a:gd name="connsiteY11" fmla="*/ 1547421 h 1549414"/>
                <a:gd name="connsiteX0" fmla="*/ 841619 w 1257375"/>
                <a:gd name="connsiteY0" fmla="*/ 1543490 h 1549414"/>
                <a:gd name="connsiteX1" fmla="*/ 382182 w 1257375"/>
                <a:gd name="connsiteY1" fmla="*/ 1201568 h 1549414"/>
                <a:gd name="connsiteX2" fmla="*/ 268 w 1257375"/>
                <a:gd name="connsiteY2" fmla="*/ 1087769 h 1549414"/>
                <a:gd name="connsiteX3" fmla="*/ 7825 w 1257375"/>
                <a:gd name="connsiteY3" fmla="*/ 876317 h 1549414"/>
                <a:gd name="connsiteX4" fmla="*/ 39383 w 1257375"/>
                <a:gd name="connsiteY4" fmla="*/ 472686 h 1549414"/>
                <a:gd name="connsiteX5" fmla="*/ 231888 w 1257375"/>
                <a:gd name="connsiteY5" fmla="*/ 164678 h 1549414"/>
                <a:gd name="connsiteX6" fmla="*/ 536557 w 1257375"/>
                <a:gd name="connsiteY6" fmla="*/ 136 h 1549414"/>
                <a:gd name="connsiteX7" fmla="*/ 842530 w 1257375"/>
                <a:gd name="connsiteY7" fmla="*/ 189303 h 1549414"/>
                <a:gd name="connsiteX8" fmla="*/ 1057991 w 1257375"/>
                <a:gd name="connsiteY8" fmla="*/ 472504 h 1549414"/>
                <a:gd name="connsiteX9" fmla="*/ 1252166 w 1257375"/>
                <a:gd name="connsiteY9" fmla="*/ 934699 h 1549414"/>
                <a:gd name="connsiteX10" fmla="*/ 1170432 w 1257375"/>
                <a:gd name="connsiteY10" fmla="*/ 1370360 h 1549414"/>
                <a:gd name="connsiteX11" fmla="*/ 846502 w 1257375"/>
                <a:gd name="connsiteY11" fmla="*/ 1547421 h 1549414"/>
                <a:gd name="connsiteX0" fmla="*/ 838011 w 1253767"/>
                <a:gd name="connsiteY0" fmla="*/ 1543490 h 1549414"/>
                <a:gd name="connsiteX1" fmla="*/ 378574 w 1253767"/>
                <a:gd name="connsiteY1" fmla="*/ 1201568 h 1549414"/>
                <a:gd name="connsiteX2" fmla="*/ 306 w 1253767"/>
                <a:gd name="connsiteY2" fmla="*/ 1088554 h 1549414"/>
                <a:gd name="connsiteX3" fmla="*/ 4217 w 1253767"/>
                <a:gd name="connsiteY3" fmla="*/ 876317 h 1549414"/>
                <a:gd name="connsiteX4" fmla="*/ 35775 w 1253767"/>
                <a:gd name="connsiteY4" fmla="*/ 472686 h 1549414"/>
                <a:gd name="connsiteX5" fmla="*/ 228280 w 1253767"/>
                <a:gd name="connsiteY5" fmla="*/ 164678 h 1549414"/>
                <a:gd name="connsiteX6" fmla="*/ 532949 w 1253767"/>
                <a:gd name="connsiteY6" fmla="*/ 136 h 1549414"/>
                <a:gd name="connsiteX7" fmla="*/ 838922 w 1253767"/>
                <a:gd name="connsiteY7" fmla="*/ 189303 h 1549414"/>
                <a:gd name="connsiteX8" fmla="*/ 1054383 w 1253767"/>
                <a:gd name="connsiteY8" fmla="*/ 472504 h 1549414"/>
                <a:gd name="connsiteX9" fmla="*/ 1248558 w 1253767"/>
                <a:gd name="connsiteY9" fmla="*/ 934699 h 1549414"/>
                <a:gd name="connsiteX10" fmla="*/ 1166824 w 1253767"/>
                <a:gd name="connsiteY10" fmla="*/ 1370360 h 1549414"/>
                <a:gd name="connsiteX11" fmla="*/ 842894 w 1253767"/>
                <a:gd name="connsiteY11" fmla="*/ 1547421 h 1549414"/>
                <a:gd name="connsiteX0" fmla="*/ 838011 w 1253767"/>
                <a:gd name="connsiteY0" fmla="*/ 1543490 h 1549414"/>
                <a:gd name="connsiteX1" fmla="*/ 378574 w 1253767"/>
                <a:gd name="connsiteY1" fmla="*/ 1201568 h 1549414"/>
                <a:gd name="connsiteX2" fmla="*/ 306 w 1253767"/>
                <a:gd name="connsiteY2" fmla="*/ 1088554 h 1549414"/>
                <a:gd name="connsiteX3" fmla="*/ 4217 w 1253767"/>
                <a:gd name="connsiteY3" fmla="*/ 876317 h 1549414"/>
                <a:gd name="connsiteX4" fmla="*/ 35775 w 1253767"/>
                <a:gd name="connsiteY4" fmla="*/ 472686 h 1549414"/>
                <a:gd name="connsiteX5" fmla="*/ 228280 w 1253767"/>
                <a:gd name="connsiteY5" fmla="*/ 164678 h 1549414"/>
                <a:gd name="connsiteX6" fmla="*/ 532949 w 1253767"/>
                <a:gd name="connsiteY6" fmla="*/ 136 h 1549414"/>
                <a:gd name="connsiteX7" fmla="*/ 838922 w 1253767"/>
                <a:gd name="connsiteY7" fmla="*/ 189303 h 1549414"/>
                <a:gd name="connsiteX8" fmla="*/ 1054383 w 1253767"/>
                <a:gd name="connsiteY8" fmla="*/ 472504 h 1549414"/>
                <a:gd name="connsiteX9" fmla="*/ 1248558 w 1253767"/>
                <a:gd name="connsiteY9" fmla="*/ 934699 h 1549414"/>
                <a:gd name="connsiteX10" fmla="*/ 1166824 w 1253767"/>
                <a:gd name="connsiteY10" fmla="*/ 1370360 h 1549414"/>
                <a:gd name="connsiteX11" fmla="*/ 842894 w 1253767"/>
                <a:gd name="connsiteY11" fmla="*/ 1547421 h 1549414"/>
                <a:gd name="connsiteX0" fmla="*/ 838011 w 1253767"/>
                <a:gd name="connsiteY0" fmla="*/ 1543490 h 1549414"/>
                <a:gd name="connsiteX1" fmla="*/ 378574 w 1253767"/>
                <a:gd name="connsiteY1" fmla="*/ 1201568 h 1549414"/>
                <a:gd name="connsiteX2" fmla="*/ 306 w 1253767"/>
                <a:gd name="connsiteY2" fmla="*/ 1088554 h 1549414"/>
                <a:gd name="connsiteX3" fmla="*/ 4217 w 1253767"/>
                <a:gd name="connsiteY3" fmla="*/ 876317 h 1549414"/>
                <a:gd name="connsiteX4" fmla="*/ 35775 w 1253767"/>
                <a:gd name="connsiteY4" fmla="*/ 472686 h 1549414"/>
                <a:gd name="connsiteX5" fmla="*/ 228280 w 1253767"/>
                <a:gd name="connsiteY5" fmla="*/ 164678 h 1549414"/>
                <a:gd name="connsiteX6" fmla="*/ 532949 w 1253767"/>
                <a:gd name="connsiteY6" fmla="*/ 136 h 1549414"/>
                <a:gd name="connsiteX7" fmla="*/ 838922 w 1253767"/>
                <a:gd name="connsiteY7" fmla="*/ 189303 h 1549414"/>
                <a:gd name="connsiteX8" fmla="*/ 1054383 w 1253767"/>
                <a:gd name="connsiteY8" fmla="*/ 472504 h 1549414"/>
                <a:gd name="connsiteX9" fmla="*/ 1248558 w 1253767"/>
                <a:gd name="connsiteY9" fmla="*/ 934699 h 1549414"/>
                <a:gd name="connsiteX10" fmla="*/ 1166824 w 1253767"/>
                <a:gd name="connsiteY10" fmla="*/ 1370360 h 1549414"/>
                <a:gd name="connsiteX11" fmla="*/ 842894 w 1253767"/>
                <a:gd name="connsiteY11" fmla="*/ 1547421 h 1549414"/>
                <a:gd name="connsiteX0" fmla="*/ 838011 w 1253767"/>
                <a:gd name="connsiteY0" fmla="*/ 1543490 h 1549414"/>
                <a:gd name="connsiteX1" fmla="*/ 378574 w 1253767"/>
                <a:gd name="connsiteY1" fmla="*/ 1201568 h 1549414"/>
                <a:gd name="connsiteX2" fmla="*/ 306 w 1253767"/>
                <a:gd name="connsiteY2" fmla="*/ 1088554 h 1549414"/>
                <a:gd name="connsiteX3" fmla="*/ 4217 w 1253767"/>
                <a:gd name="connsiteY3" fmla="*/ 876317 h 1549414"/>
                <a:gd name="connsiteX4" fmla="*/ 35775 w 1253767"/>
                <a:gd name="connsiteY4" fmla="*/ 472686 h 1549414"/>
                <a:gd name="connsiteX5" fmla="*/ 228280 w 1253767"/>
                <a:gd name="connsiteY5" fmla="*/ 164678 h 1549414"/>
                <a:gd name="connsiteX6" fmla="*/ 532949 w 1253767"/>
                <a:gd name="connsiteY6" fmla="*/ 136 h 1549414"/>
                <a:gd name="connsiteX7" fmla="*/ 838922 w 1253767"/>
                <a:gd name="connsiteY7" fmla="*/ 189303 h 1549414"/>
                <a:gd name="connsiteX8" fmla="*/ 1054383 w 1253767"/>
                <a:gd name="connsiteY8" fmla="*/ 472504 h 1549414"/>
                <a:gd name="connsiteX9" fmla="*/ 1248558 w 1253767"/>
                <a:gd name="connsiteY9" fmla="*/ 934699 h 1549414"/>
                <a:gd name="connsiteX10" fmla="*/ 1166824 w 1253767"/>
                <a:gd name="connsiteY10" fmla="*/ 1370360 h 1549414"/>
                <a:gd name="connsiteX11" fmla="*/ 842894 w 1253767"/>
                <a:gd name="connsiteY11" fmla="*/ 1547421 h 1549414"/>
                <a:gd name="connsiteX0" fmla="*/ 839298 w 1255054"/>
                <a:gd name="connsiteY0" fmla="*/ 1543490 h 1549414"/>
                <a:gd name="connsiteX1" fmla="*/ 379861 w 1255054"/>
                <a:gd name="connsiteY1" fmla="*/ 1201568 h 1549414"/>
                <a:gd name="connsiteX2" fmla="*/ 290 w 1255054"/>
                <a:gd name="connsiteY2" fmla="*/ 1076771 h 1549414"/>
                <a:gd name="connsiteX3" fmla="*/ 5504 w 1255054"/>
                <a:gd name="connsiteY3" fmla="*/ 876317 h 1549414"/>
                <a:gd name="connsiteX4" fmla="*/ 37062 w 1255054"/>
                <a:gd name="connsiteY4" fmla="*/ 472686 h 1549414"/>
                <a:gd name="connsiteX5" fmla="*/ 229567 w 1255054"/>
                <a:gd name="connsiteY5" fmla="*/ 164678 h 1549414"/>
                <a:gd name="connsiteX6" fmla="*/ 534236 w 1255054"/>
                <a:gd name="connsiteY6" fmla="*/ 136 h 1549414"/>
                <a:gd name="connsiteX7" fmla="*/ 840209 w 1255054"/>
                <a:gd name="connsiteY7" fmla="*/ 189303 h 1549414"/>
                <a:gd name="connsiteX8" fmla="*/ 1055670 w 1255054"/>
                <a:gd name="connsiteY8" fmla="*/ 472504 h 1549414"/>
                <a:gd name="connsiteX9" fmla="*/ 1249845 w 1255054"/>
                <a:gd name="connsiteY9" fmla="*/ 934699 h 1549414"/>
                <a:gd name="connsiteX10" fmla="*/ 1168111 w 1255054"/>
                <a:gd name="connsiteY10" fmla="*/ 1370360 h 1549414"/>
                <a:gd name="connsiteX11" fmla="*/ 844181 w 1255054"/>
                <a:gd name="connsiteY11" fmla="*/ 1547421 h 1549414"/>
                <a:gd name="connsiteX0" fmla="*/ 839298 w 1255054"/>
                <a:gd name="connsiteY0" fmla="*/ 1543490 h 1549414"/>
                <a:gd name="connsiteX1" fmla="*/ 379861 w 1255054"/>
                <a:gd name="connsiteY1" fmla="*/ 1201568 h 1549414"/>
                <a:gd name="connsiteX2" fmla="*/ 290 w 1255054"/>
                <a:gd name="connsiteY2" fmla="*/ 1076771 h 1549414"/>
                <a:gd name="connsiteX3" fmla="*/ 5504 w 1255054"/>
                <a:gd name="connsiteY3" fmla="*/ 876317 h 1549414"/>
                <a:gd name="connsiteX4" fmla="*/ 37062 w 1255054"/>
                <a:gd name="connsiteY4" fmla="*/ 472686 h 1549414"/>
                <a:gd name="connsiteX5" fmla="*/ 229567 w 1255054"/>
                <a:gd name="connsiteY5" fmla="*/ 164678 h 1549414"/>
                <a:gd name="connsiteX6" fmla="*/ 534236 w 1255054"/>
                <a:gd name="connsiteY6" fmla="*/ 136 h 1549414"/>
                <a:gd name="connsiteX7" fmla="*/ 840209 w 1255054"/>
                <a:gd name="connsiteY7" fmla="*/ 189303 h 1549414"/>
                <a:gd name="connsiteX8" fmla="*/ 1055670 w 1255054"/>
                <a:gd name="connsiteY8" fmla="*/ 472504 h 1549414"/>
                <a:gd name="connsiteX9" fmla="*/ 1249845 w 1255054"/>
                <a:gd name="connsiteY9" fmla="*/ 934699 h 1549414"/>
                <a:gd name="connsiteX10" fmla="*/ 1168111 w 1255054"/>
                <a:gd name="connsiteY10" fmla="*/ 1370360 h 1549414"/>
                <a:gd name="connsiteX11" fmla="*/ 844181 w 1255054"/>
                <a:gd name="connsiteY11" fmla="*/ 1547421 h 1549414"/>
                <a:gd name="connsiteX0" fmla="*/ 839298 w 1255054"/>
                <a:gd name="connsiteY0" fmla="*/ 1543490 h 1549414"/>
                <a:gd name="connsiteX1" fmla="*/ 685038 w 1255054"/>
                <a:gd name="connsiteY1" fmla="*/ 1389084 h 1549414"/>
                <a:gd name="connsiteX2" fmla="*/ 379861 w 1255054"/>
                <a:gd name="connsiteY2" fmla="*/ 1201568 h 1549414"/>
                <a:gd name="connsiteX3" fmla="*/ 290 w 1255054"/>
                <a:gd name="connsiteY3" fmla="*/ 1076771 h 1549414"/>
                <a:gd name="connsiteX4" fmla="*/ 5504 w 1255054"/>
                <a:gd name="connsiteY4" fmla="*/ 876317 h 1549414"/>
                <a:gd name="connsiteX5" fmla="*/ 37062 w 1255054"/>
                <a:gd name="connsiteY5" fmla="*/ 472686 h 1549414"/>
                <a:gd name="connsiteX6" fmla="*/ 229567 w 1255054"/>
                <a:gd name="connsiteY6" fmla="*/ 164678 h 1549414"/>
                <a:gd name="connsiteX7" fmla="*/ 534236 w 1255054"/>
                <a:gd name="connsiteY7" fmla="*/ 136 h 1549414"/>
                <a:gd name="connsiteX8" fmla="*/ 840209 w 1255054"/>
                <a:gd name="connsiteY8" fmla="*/ 189303 h 1549414"/>
                <a:gd name="connsiteX9" fmla="*/ 1055670 w 1255054"/>
                <a:gd name="connsiteY9" fmla="*/ 472504 h 1549414"/>
                <a:gd name="connsiteX10" fmla="*/ 1249845 w 1255054"/>
                <a:gd name="connsiteY10" fmla="*/ 934699 h 1549414"/>
                <a:gd name="connsiteX11" fmla="*/ 1168111 w 1255054"/>
                <a:gd name="connsiteY11" fmla="*/ 1370360 h 1549414"/>
                <a:gd name="connsiteX12" fmla="*/ 844181 w 1255054"/>
                <a:gd name="connsiteY12" fmla="*/ 1547421 h 1549414"/>
                <a:gd name="connsiteX0" fmla="*/ 839298 w 1255054"/>
                <a:gd name="connsiteY0" fmla="*/ 1543490 h 1553726"/>
                <a:gd name="connsiteX1" fmla="*/ 728286 w 1255054"/>
                <a:gd name="connsiteY1" fmla="*/ 1544089 h 1553726"/>
                <a:gd name="connsiteX2" fmla="*/ 685038 w 1255054"/>
                <a:gd name="connsiteY2" fmla="*/ 1389084 h 1553726"/>
                <a:gd name="connsiteX3" fmla="*/ 379861 w 1255054"/>
                <a:gd name="connsiteY3" fmla="*/ 1201568 h 1553726"/>
                <a:gd name="connsiteX4" fmla="*/ 290 w 1255054"/>
                <a:gd name="connsiteY4" fmla="*/ 1076771 h 1553726"/>
                <a:gd name="connsiteX5" fmla="*/ 5504 w 1255054"/>
                <a:gd name="connsiteY5" fmla="*/ 876317 h 1553726"/>
                <a:gd name="connsiteX6" fmla="*/ 37062 w 1255054"/>
                <a:gd name="connsiteY6" fmla="*/ 472686 h 1553726"/>
                <a:gd name="connsiteX7" fmla="*/ 229567 w 1255054"/>
                <a:gd name="connsiteY7" fmla="*/ 164678 h 1553726"/>
                <a:gd name="connsiteX8" fmla="*/ 534236 w 1255054"/>
                <a:gd name="connsiteY8" fmla="*/ 136 h 1553726"/>
                <a:gd name="connsiteX9" fmla="*/ 840209 w 1255054"/>
                <a:gd name="connsiteY9" fmla="*/ 189303 h 1553726"/>
                <a:gd name="connsiteX10" fmla="*/ 1055670 w 1255054"/>
                <a:gd name="connsiteY10" fmla="*/ 472504 h 1553726"/>
                <a:gd name="connsiteX11" fmla="*/ 1249845 w 1255054"/>
                <a:gd name="connsiteY11" fmla="*/ 934699 h 1553726"/>
                <a:gd name="connsiteX12" fmla="*/ 1168111 w 1255054"/>
                <a:gd name="connsiteY12" fmla="*/ 1370360 h 1553726"/>
                <a:gd name="connsiteX13" fmla="*/ 844181 w 1255054"/>
                <a:gd name="connsiteY13" fmla="*/ 1547421 h 1553726"/>
                <a:gd name="connsiteX0" fmla="*/ 839298 w 1255054"/>
                <a:gd name="connsiteY0" fmla="*/ 1543490 h 1553726"/>
                <a:gd name="connsiteX1" fmla="*/ 728286 w 1255054"/>
                <a:gd name="connsiteY1" fmla="*/ 1544089 h 1553726"/>
                <a:gd name="connsiteX2" fmla="*/ 670716 w 1255054"/>
                <a:gd name="connsiteY2" fmla="*/ 1420506 h 1553726"/>
                <a:gd name="connsiteX3" fmla="*/ 379861 w 1255054"/>
                <a:gd name="connsiteY3" fmla="*/ 1201568 h 1553726"/>
                <a:gd name="connsiteX4" fmla="*/ 290 w 1255054"/>
                <a:gd name="connsiteY4" fmla="*/ 1076771 h 1553726"/>
                <a:gd name="connsiteX5" fmla="*/ 5504 w 1255054"/>
                <a:gd name="connsiteY5" fmla="*/ 876317 h 1553726"/>
                <a:gd name="connsiteX6" fmla="*/ 37062 w 1255054"/>
                <a:gd name="connsiteY6" fmla="*/ 472686 h 1553726"/>
                <a:gd name="connsiteX7" fmla="*/ 229567 w 1255054"/>
                <a:gd name="connsiteY7" fmla="*/ 164678 h 1553726"/>
                <a:gd name="connsiteX8" fmla="*/ 534236 w 1255054"/>
                <a:gd name="connsiteY8" fmla="*/ 136 h 1553726"/>
                <a:gd name="connsiteX9" fmla="*/ 840209 w 1255054"/>
                <a:gd name="connsiteY9" fmla="*/ 189303 h 1553726"/>
                <a:gd name="connsiteX10" fmla="*/ 1055670 w 1255054"/>
                <a:gd name="connsiteY10" fmla="*/ 472504 h 1553726"/>
                <a:gd name="connsiteX11" fmla="*/ 1249845 w 1255054"/>
                <a:gd name="connsiteY11" fmla="*/ 934699 h 1553726"/>
                <a:gd name="connsiteX12" fmla="*/ 1168111 w 1255054"/>
                <a:gd name="connsiteY12" fmla="*/ 1370360 h 1553726"/>
                <a:gd name="connsiteX13" fmla="*/ 844181 w 1255054"/>
                <a:gd name="connsiteY13" fmla="*/ 1547421 h 1553726"/>
                <a:gd name="connsiteX0" fmla="*/ 839298 w 1255054"/>
                <a:gd name="connsiteY0" fmla="*/ 1543490 h 1553726"/>
                <a:gd name="connsiteX1" fmla="*/ 728286 w 1255054"/>
                <a:gd name="connsiteY1" fmla="*/ 1544089 h 1553726"/>
                <a:gd name="connsiteX2" fmla="*/ 670716 w 1255054"/>
                <a:gd name="connsiteY2" fmla="*/ 1420506 h 1553726"/>
                <a:gd name="connsiteX3" fmla="*/ 379861 w 1255054"/>
                <a:gd name="connsiteY3" fmla="*/ 1201568 h 1553726"/>
                <a:gd name="connsiteX4" fmla="*/ 290 w 1255054"/>
                <a:gd name="connsiteY4" fmla="*/ 1076771 h 1553726"/>
                <a:gd name="connsiteX5" fmla="*/ 5504 w 1255054"/>
                <a:gd name="connsiteY5" fmla="*/ 876317 h 1553726"/>
                <a:gd name="connsiteX6" fmla="*/ 37062 w 1255054"/>
                <a:gd name="connsiteY6" fmla="*/ 472686 h 1553726"/>
                <a:gd name="connsiteX7" fmla="*/ 229567 w 1255054"/>
                <a:gd name="connsiteY7" fmla="*/ 164678 h 1553726"/>
                <a:gd name="connsiteX8" fmla="*/ 534236 w 1255054"/>
                <a:gd name="connsiteY8" fmla="*/ 136 h 1553726"/>
                <a:gd name="connsiteX9" fmla="*/ 840209 w 1255054"/>
                <a:gd name="connsiteY9" fmla="*/ 189303 h 1553726"/>
                <a:gd name="connsiteX10" fmla="*/ 1055670 w 1255054"/>
                <a:gd name="connsiteY10" fmla="*/ 472504 h 1553726"/>
                <a:gd name="connsiteX11" fmla="*/ 1249845 w 1255054"/>
                <a:gd name="connsiteY11" fmla="*/ 934699 h 1553726"/>
                <a:gd name="connsiteX12" fmla="*/ 1168111 w 1255054"/>
                <a:gd name="connsiteY12" fmla="*/ 1370360 h 1553726"/>
                <a:gd name="connsiteX13" fmla="*/ 844181 w 1255054"/>
                <a:gd name="connsiteY13" fmla="*/ 1547421 h 1553726"/>
                <a:gd name="connsiteX0" fmla="*/ 839298 w 1255054"/>
                <a:gd name="connsiteY0" fmla="*/ 1543490 h 1553726"/>
                <a:gd name="connsiteX1" fmla="*/ 728286 w 1255054"/>
                <a:gd name="connsiteY1" fmla="*/ 1544089 h 1553726"/>
                <a:gd name="connsiteX2" fmla="*/ 670716 w 1255054"/>
                <a:gd name="connsiteY2" fmla="*/ 1420506 h 1553726"/>
                <a:gd name="connsiteX3" fmla="*/ 379861 w 1255054"/>
                <a:gd name="connsiteY3" fmla="*/ 1201568 h 1553726"/>
                <a:gd name="connsiteX4" fmla="*/ 290 w 1255054"/>
                <a:gd name="connsiteY4" fmla="*/ 1076771 h 1553726"/>
                <a:gd name="connsiteX5" fmla="*/ 5504 w 1255054"/>
                <a:gd name="connsiteY5" fmla="*/ 876317 h 1553726"/>
                <a:gd name="connsiteX6" fmla="*/ 37062 w 1255054"/>
                <a:gd name="connsiteY6" fmla="*/ 472686 h 1553726"/>
                <a:gd name="connsiteX7" fmla="*/ 229567 w 1255054"/>
                <a:gd name="connsiteY7" fmla="*/ 164678 h 1553726"/>
                <a:gd name="connsiteX8" fmla="*/ 534236 w 1255054"/>
                <a:gd name="connsiteY8" fmla="*/ 136 h 1553726"/>
                <a:gd name="connsiteX9" fmla="*/ 840209 w 1255054"/>
                <a:gd name="connsiteY9" fmla="*/ 189303 h 1553726"/>
                <a:gd name="connsiteX10" fmla="*/ 1055670 w 1255054"/>
                <a:gd name="connsiteY10" fmla="*/ 472504 h 1553726"/>
                <a:gd name="connsiteX11" fmla="*/ 1249845 w 1255054"/>
                <a:gd name="connsiteY11" fmla="*/ 934699 h 1553726"/>
                <a:gd name="connsiteX12" fmla="*/ 1168111 w 1255054"/>
                <a:gd name="connsiteY12" fmla="*/ 1370360 h 1553726"/>
                <a:gd name="connsiteX13" fmla="*/ 844181 w 1255054"/>
                <a:gd name="connsiteY13" fmla="*/ 1547421 h 1553726"/>
                <a:gd name="connsiteX0" fmla="*/ 839298 w 1255054"/>
                <a:gd name="connsiteY0" fmla="*/ 1543490 h 1553726"/>
                <a:gd name="connsiteX1" fmla="*/ 728286 w 1255054"/>
                <a:gd name="connsiteY1" fmla="*/ 1544089 h 1553726"/>
                <a:gd name="connsiteX2" fmla="*/ 670716 w 1255054"/>
                <a:gd name="connsiteY2" fmla="*/ 1420506 h 1553726"/>
                <a:gd name="connsiteX3" fmla="*/ 386891 w 1255054"/>
                <a:gd name="connsiteY3" fmla="*/ 1168576 h 1553726"/>
                <a:gd name="connsiteX4" fmla="*/ 290 w 1255054"/>
                <a:gd name="connsiteY4" fmla="*/ 1076771 h 1553726"/>
                <a:gd name="connsiteX5" fmla="*/ 5504 w 1255054"/>
                <a:gd name="connsiteY5" fmla="*/ 876317 h 1553726"/>
                <a:gd name="connsiteX6" fmla="*/ 37062 w 1255054"/>
                <a:gd name="connsiteY6" fmla="*/ 472686 h 1553726"/>
                <a:gd name="connsiteX7" fmla="*/ 229567 w 1255054"/>
                <a:gd name="connsiteY7" fmla="*/ 164678 h 1553726"/>
                <a:gd name="connsiteX8" fmla="*/ 534236 w 1255054"/>
                <a:gd name="connsiteY8" fmla="*/ 136 h 1553726"/>
                <a:gd name="connsiteX9" fmla="*/ 840209 w 1255054"/>
                <a:gd name="connsiteY9" fmla="*/ 189303 h 1553726"/>
                <a:gd name="connsiteX10" fmla="*/ 1055670 w 1255054"/>
                <a:gd name="connsiteY10" fmla="*/ 472504 h 1553726"/>
                <a:gd name="connsiteX11" fmla="*/ 1249845 w 1255054"/>
                <a:gd name="connsiteY11" fmla="*/ 934699 h 1553726"/>
                <a:gd name="connsiteX12" fmla="*/ 1168111 w 1255054"/>
                <a:gd name="connsiteY12" fmla="*/ 1370360 h 1553726"/>
                <a:gd name="connsiteX13" fmla="*/ 844181 w 1255054"/>
                <a:gd name="connsiteY13" fmla="*/ 1547421 h 1553726"/>
                <a:gd name="connsiteX0" fmla="*/ 839298 w 1255054"/>
                <a:gd name="connsiteY0" fmla="*/ 1543490 h 1553726"/>
                <a:gd name="connsiteX1" fmla="*/ 728286 w 1255054"/>
                <a:gd name="connsiteY1" fmla="*/ 1544089 h 1553726"/>
                <a:gd name="connsiteX2" fmla="*/ 670716 w 1255054"/>
                <a:gd name="connsiteY2" fmla="*/ 1420506 h 1553726"/>
                <a:gd name="connsiteX3" fmla="*/ 386891 w 1255054"/>
                <a:gd name="connsiteY3" fmla="*/ 1168576 h 1553726"/>
                <a:gd name="connsiteX4" fmla="*/ 290 w 1255054"/>
                <a:gd name="connsiteY4" fmla="*/ 1076771 h 1553726"/>
                <a:gd name="connsiteX5" fmla="*/ 5504 w 1255054"/>
                <a:gd name="connsiteY5" fmla="*/ 876317 h 1553726"/>
                <a:gd name="connsiteX6" fmla="*/ 37062 w 1255054"/>
                <a:gd name="connsiteY6" fmla="*/ 472686 h 1553726"/>
                <a:gd name="connsiteX7" fmla="*/ 229567 w 1255054"/>
                <a:gd name="connsiteY7" fmla="*/ 164678 h 1553726"/>
                <a:gd name="connsiteX8" fmla="*/ 534236 w 1255054"/>
                <a:gd name="connsiteY8" fmla="*/ 136 h 1553726"/>
                <a:gd name="connsiteX9" fmla="*/ 840209 w 1255054"/>
                <a:gd name="connsiteY9" fmla="*/ 189303 h 1553726"/>
                <a:gd name="connsiteX10" fmla="*/ 1055670 w 1255054"/>
                <a:gd name="connsiteY10" fmla="*/ 472504 h 1553726"/>
                <a:gd name="connsiteX11" fmla="*/ 1249845 w 1255054"/>
                <a:gd name="connsiteY11" fmla="*/ 934699 h 1553726"/>
                <a:gd name="connsiteX12" fmla="*/ 1168111 w 1255054"/>
                <a:gd name="connsiteY12" fmla="*/ 1370360 h 1553726"/>
                <a:gd name="connsiteX13" fmla="*/ 844181 w 1255054"/>
                <a:gd name="connsiteY13" fmla="*/ 1547421 h 1553726"/>
                <a:gd name="connsiteX0" fmla="*/ 839298 w 1255054"/>
                <a:gd name="connsiteY0" fmla="*/ 1543490 h 1553726"/>
                <a:gd name="connsiteX1" fmla="*/ 728286 w 1255054"/>
                <a:gd name="connsiteY1" fmla="*/ 1544089 h 1553726"/>
                <a:gd name="connsiteX2" fmla="*/ 670716 w 1255054"/>
                <a:gd name="connsiteY2" fmla="*/ 1420506 h 1553726"/>
                <a:gd name="connsiteX3" fmla="*/ 386891 w 1255054"/>
                <a:gd name="connsiteY3" fmla="*/ 1168576 h 1553726"/>
                <a:gd name="connsiteX4" fmla="*/ 290 w 1255054"/>
                <a:gd name="connsiteY4" fmla="*/ 1076771 h 1553726"/>
                <a:gd name="connsiteX5" fmla="*/ 5504 w 1255054"/>
                <a:gd name="connsiteY5" fmla="*/ 876317 h 1553726"/>
                <a:gd name="connsiteX6" fmla="*/ 37062 w 1255054"/>
                <a:gd name="connsiteY6" fmla="*/ 472686 h 1553726"/>
                <a:gd name="connsiteX7" fmla="*/ 229567 w 1255054"/>
                <a:gd name="connsiteY7" fmla="*/ 164678 h 1553726"/>
                <a:gd name="connsiteX8" fmla="*/ 534236 w 1255054"/>
                <a:gd name="connsiteY8" fmla="*/ 136 h 1553726"/>
                <a:gd name="connsiteX9" fmla="*/ 840209 w 1255054"/>
                <a:gd name="connsiteY9" fmla="*/ 189303 h 1553726"/>
                <a:gd name="connsiteX10" fmla="*/ 1055670 w 1255054"/>
                <a:gd name="connsiteY10" fmla="*/ 472504 h 1553726"/>
                <a:gd name="connsiteX11" fmla="*/ 1249845 w 1255054"/>
                <a:gd name="connsiteY11" fmla="*/ 934699 h 1553726"/>
                <a:gd name="connsiteX12" fmla="*/ 1168111 w 1255054"/>
                <a:gd name="connsiteY12" fmla="*/ 1370360 h 1553726"/>
                <a:gd name="connsiteX13" fmla="*/ 844181 w 1255054"/>
                <a:gd name="connsiteY13" fmla="*/ 1547421 h 1553726"/>
                <a:gd name="connsiteX0" fmla="*/ 839298 w 1255054"/>
                <a:gd name="connsiteY0" fmla="*/ 1543490 h 1553726"/>
                <a:gd name="connsiteX1" fmla="*/ 728286 w 1255054"/>
                <a:gd name="connsiteY1" fmla="*/ 1544089 h 1553726"/>
                <a:gd name="connsiteX2" fmla="*/ 670716 w 1255054"/>
                <a:gd name="connsiteY2" fmla="*/ 1420506 h 1553726"/>
                <a:gd name="connsiteX3" fmla="*/ 386891 w 1255054"/>
                <a:gd name="connsiteY3" fmla="*/ 1168576 h 1553726"/>
                <a:gd name="connsiteX4" fmla="*/ 290 w 1255054"/>
                <a:gd name="connsiteY4" fmla="*/ 1076771 h 1553726"/>
                <a:gd name="connsiteX5" fmla="*/ 5504 w 1255054"/>
                <a:gd name="connsiteY5" fmla="*/ 876317 h 1553726"/>
                <a:gd name="connsiteX6" fmla="*/ 37062 w 1255054"/>
                <a:gd name="connsiteY6" fmla="*/ 472686 h 1553726"/>
                <a:gd name="connsiteX7" fmla="*/ 229567 w 1255054"/>
                <a:gd name="connsiteY7" fmla="*/ 164678 h 1553726"/>
                <a:gd name="connsiteX8" fmla="*/ 534236 w 1255054"/>
                <a:gd name="connsiteY8" fmla="*/ 136 h 1553726"/>
                <a:gd name="connsiteX9" fmla="*/ 840209 w 1255054"/>
                <a:gd name="connsiteY9" fmla="*/ 189303 h 1553726"/>
                <a:gd name="connsiteX10" fmla="*/ 1055670 w 1255054"/>
                <a:gd name="connsiteY10" fmla="*/ 472504 h 1553726"/>
                <a:gd name="connsiteX11" fmla="*/ 1249845 w 1255054"/>
                <a:gd name="connsiteY11" fmla="*/ 934699 h 1553726"/>
                <a:gd name="connsiteX12" fmla="*/ 1168111 w 1255054"/>
                <a:gd name="connsiteY12" fmla="*/ 1370360 h 1553726"/>
                <a:gd name="connsiteX13" fmla="*/ 844181 w 1255054"/>
                <a:gd name="connsiteY13" fmla="*/ 1547421 h 1553726"/>
                <a:gd name="connsiteX0" fmla="*/ 839298 w 1255054"/>
                <a:gd name="connsiteY0" fmla="*/ 1543490 h 1553726"/>
                <a:gd name="connsiteX1" fmla="*/ 728286 w 1255054"/>
                <a:gd name="connsiteY1" fmla="*/ 1544089 h 1553726"/>
                <a:gd name="connsiteX2" fmla="*/ 670716 w 1255054"/>
                <a:gd name="connsiteY2" fmla="*/ 1420506 h 1553726"/>
                <a:gd name="connsiteX3" fmla="*/ 386891 w 1255054"/>
                <a:gd name="connsiteY3" fmla="*/ 1168576 h 1553726"/>
                <a:gd name="connsiteX4" fmla="*/ 290 w 1255054"/>
                <a:gd name="connsiteY4" fmla="*/ 1076771 h 1553726"/>
                <a:gd name="connsiteX5" fmla="*/ 5504 w 1255054"/>
                <a:gd name="connsiteY5" fmla="*/ 876317 h 1553726"/>
                <a:gd name="connsiteX6" fmla="*/ 37062 w 1255054"/>
                <a:gd name="connsiteY6" fmla="*/ 472686 h 1553726"/>
                <a:gd name="connsiteX7" fmla="*/ 229567 w 1255054"/>
                <a:gd name="connsiteY7" fmla="*/ 164678 h 1553726"/>
                <a:gd name="connsiteX8" fmla="*/ 534236 w 1255054"/>
                <a:gd name="connsiteY8" fmla="*/ 136 h 1553726"/>
                <a:gd name="connsiteX9" fmla="*/ 840209 w 1255054"/>
                <a:gd name="connsiteY9" fmla="*/ 189303 h 1553726"/>
                <a:gd name="connsiteX10" fmla="*/ 1055670 w 1255054"/>
                <a:gd name="connsiteY10" fmla="*/ 472504 h 1553726"/>
                <a:gd name="connsiteX11" fmla="*/ 1249845 w 1255054"/>
                <a:gd name="connsiteY11" fmla="*/ 934699 h 1553726"/>
                <a:gd name="connsiteX12" fmla="*/ 1168111 w 1255054"/>
                <a:gd name="connsiteY12" fmla="*/ 1370360 h 1553726"/>
                <a:gd name="connsiteX13" fmla="*/ 844181 w 1255054"/>
                <a:gd name="connsiteY13" fmla="*/ 1547421 h 1553726"/>
                <a:gd name="connsiteX0" fmla="*/ 839298 w 1255054"/>
                <a:gd name="connsiteY0" fmla="*/ 1543490 h 1553726"/>
                <a:gd name="connsiteX1" fmla="*/ 728286 w 1255054"/>
                <a:gd name="connsiteY1" fmla="*/ 1544089 h 1553726"/>
                <a:gd name="connsiteX2" fmla="*/ 693375 w 1255054"/>
                <a:gd name="connsiteY2" fmla="*/ 1421551 h 1553726"/>
                <a:gd name="connsiteX3" fmla="*/ 386891 w 1255054"/>
                <a:gd name="connsiteY3" fmla="*/ 1168576 h 1553726"/>
                <a:gd name="connsiteX4" fmla="*/ 290 w 1255054"/>
                <a:gd name="connsiteY4" fmla="*/ 1076771 h 1553726"/>
                <a:gd name="connsiteX5" fmla="*/ 5504 w 1255054"/>
                <a:gd name="connsiteY5" fmla="*/ 876317 h 1553726"/>
                <a:gd name="connsiteX6" fmla="*/ 37062 w 1255054"/>
                <a:gd name="connsiteY6" fmla="*/ 472686 h 1553726"/>
                <a:gd name="connsiteX7" fmla="*/ 229567 w 1255054"/>
                <a:gd name="connsiteY7" fmla="*/ 164678 h 1553726"/>
                <a:gd name="connsiteX8" fmla="*/ 534236 w 1255054"/>
                <a:gd name="connsiteY8" fmla="*/ 136 h 1553726"/>
                <a:gd name="connsiteX9" fmla="*/ 840209 w 1255054"/>
                <a:gd name="connsiteY9" fmla="*/ 189303 h 1553726"/>
                <a:gd name="connsiteX10" fmla="*/ 1055670 w 1255054"/>
                <a:gd name="connsiteY10" fmla="*/ 472504 h 1553726"/>
                <a:gd name="connsiteX11" fmla="*/ 1249845 w 1255054"/>
                <a:gd name="connsiteY11" fmla="*/ 934699 h 1553726"/>
                <a:gd name="connsiteX12" fmla="*/ 1168111 w 1255054"/>
                <a:gd name="connsiteY12" fmla="*/ 1370360 h 1553726"/>
                <a:gd name="connsiteX13" fmla="*/ 844181 w 1255054"/>
                <a:gd name="connsiteY13" fmla="*/ 1547421 h 1553726"/>
                <a:gd name="connsiteX0" fmla="*/ 839298 w 1255054"/>
                <a:gd name="connsiteY0" fmla="*/ 1543490 h 1553726"/>
                <a:gd name="connsiteX1" fmla="*/ 728286 w 1255054"/>
                <a:gd name="connsiteY1" fmla="*/ 1544089 h 1553726"/>
                <a:gd name="connsiteX2" fmla="*/ 693375 w 1255054"/>
                <a:gd name="connsiteY2" fmla="*/ 1421551 h 1553726"/>
                <a:gd name="connsiteX3" fmla="*/ 386891 w 1255054"/>
                <a:gd name="connsiteY3" fmla="*/ 1168576 h 1553726"/>
                <a:gd name="connsiteX4" fmla="*/ 290 w 1255054"/>
                <a:gd name="connsiteY4" fmla="*/ 1076771 h 1553726"/>
                <a:gd name="connsiteX5" fmla="*/ 5504 w 1255054"/>
                <a:gd name="connsiteY5" fmla="*/ 876317 h 1553726"/>
                <a:gd name="connsiteX6" fmla="*/ 37062 w 1255054"/>
                <a:gd name="connsiteY6" fmla="*/ 472686 h 1553726"/>
                <a:gd name="connsiteX7" fmla="*/ 229567 w 1255054"/>
                <a:gd name="connsiteY7" fmla="*/ 164678 h 1553726"/>
                <a:gd name="connsiteX8" fmla="*/ 534236 w 1255054"/>
                <a:gd name="connsiteY8" fmla="*/ 136 h 1553726"/>
                <a:gd name="connsiteX9" fmla="*/ 840209 w 1255054"/>
                <a:gd name="connsiteY9" fmla="*/ 189303 h 1553726"/>
                <a:gd name="connsiteX10" fmla="*/ 1055670 w 1255054"/>
                <a:gd name="connsiteY10" fmla="*/ 472504 h 1553726"/>
                <a:gd name="connsiteX11" fmla="*/ 1249845 w 1255054"/>
                <a:gd name="connsiteY11" fmla="*/ 934699 h 1553726"/>
                <a:gd name="connsiteX12" fmla="*/ 1168111 w 1255054"/>
                <a:gd name="connsiteY12" fmla="*/ 1370360 h 1553726"/>
                <a:gd name="connsiteX13" fmla="*/ 844181 w 1255054"/>
                <a:gd name="connsiteY13" fmla="*/ 1547421 h 1553726"/>
                <a:gd name="connsiteX0" fmla="*/ 839298 w 1255054"/>
                <a:gd name="connsiteY0" fmla="*/ 1543490 h 1582454"/>
                <a:gd name="connsiteX1" fmla="*/ 683231 w 1255054"/>
                <a:gd name="connsiteY1" fmla="*/ 1576561 h 1582454"/>
                <a:gd name="connsiteX2" fmla="*/ 693375 w 1255054"/>
                <a:gd name="connsiteY2" fmla="*/ 1421551 h 1582454"/>
                <a:gd name="connsiteX3" fmla="*/ 386891 w 1255054"/>
                <a:gd name="connsiteY3" fmla="*/ 1168576 h 1582454"/>
                <a:gd name="connsiteX4" fmla="*/ 290 w 1255054"/>
                <a:gd name="connsiteY4" fmla="*/ 1076771 h 1582454"/>
                <a:gd name="connsiteX5" fmla="*/ 5504 w 1255054"/>
                <a:gd name="connsiteY5" fmla="*/ 876317 h 1582454"/>
                <a:gd name="connsiteX6" fmla="*/ 37062 w 1255054"/>
                <a:gd name="connsiteY6" fmla="*/ 472686 h 1582454"/>
                <a:gd name="connsiteX7" fmla="*/ 229567 w 1255054"/>
                <a:gd name="connsiteY7" fmla="*/ 164678 h 1582454"/>
                <a:gd name="connsiteX8" fmla="*/ 534236 w 1255054"/>
                <a:gd name="connsiteY8" fmla="*/ 136 h 1582454"/>
                <a:gd name="connsiteX9" fmla="*/ 840209 w 1255054"/>
                <a:gd name="connsiteY9" fmla="*/ 189303 h 1582454"/>
                <a:gd name="connsiteX10" fmla="*/ 1055670 w 1255054"/>
                <a:gd name="connsiteY10" fmla="*/ 472504 h 1582454"/>
                <a:gd name="connsiteX11" fmla="*/ 1249845 w 1255054"/>
                <a:gd name="connsiteY11" fmla="*/ 934699 h 1582454"/>
                <a:gd name="connsiteX12" fmla="*/ 1168111 w 1255054"/>
                <a:gd name="connsiteY12" fmla="*/ 1370360 h 1582454"/>
                <a:gd name="connsiteX13" fmla="*/ 844181 w 1255054"/>
                <a:gd name="connsiteY13" fmla="*/ 1547421 h 1582454"/>
                <a:gd name="connsiteX0" fmla="*/ 839298 w 1255054"/>
                <a:gd name="connsiteY0" fmla="*/ 1543490 h 1576561"/>
                <a:gd name="connsiteX1" fmla="*/ 683231 w 1255054"/>
                <a:gd name="connsiteY1" fmla="*/ 1576561 h 1576561"/>
                <a:gd name="connsiteX2" fmla="*/ 693375 w 1255054"/>
                <a:gd name="connsiteY2" fmla="*/ 1421551 h 1576561"/>
                <a:gd name="connsiteX3" fmla="*/ 386891 w 1255054"/>
                <a:gd name="connsiteY3" fmla="*/ 1168576 h 1576561"/>
                <a:gd name="connsiteX4" fmla="*/ 290 w 1255054"/>
                <a:gd name="connsiteY4" fmla="*/ 1076771 h 1576561"/>
                <a:gd name="connsiteX5" fmla="*/ 5504 w 1255054"/>
                <a:gd name="connsiteY5" fmla="*/ 876317 h 1576561"/>
                <a:gd name="connsiteX6" fmla="*/ 37062 w 1255054"/>
                <a:gd name="connsiteY6" fmla="*/ 472686 h 1576561"/>
                <a:gd name="connsiteX7" fmla="*/ 229567 w 1255054"/>
                <a:gd name="connsiteY7" fmla="*/ 164678 h 1576561"/>
                <a:gd name="connsiteX8" fmla="*/ 534236 w 1255054"/>
                <a:gd name="connsiteY8" fmla="*/ 136 h 1576561"/>
                <a:gd name="connsiteX9" fmla="*/ 840209 w 1255054"/>
                <a:gd name="connsiteY9" fmla="*/ 189303 h 1576561"/>
                <a:gd name="connsiteX10" fmla="*/ 1055670 w 1255054"/>
                <a:gd name="connsiteY10" fmla="*/ 472504 h 1576561"/>
                <a:gd name="connsiteX11" fmla="*/ 1249845 w 1255054"/>
                <a:gd name="connsiteY11" fmla="*/ 934699 h 1576561"/>
                <a:gd name="connsiteX12" fmla="*/ 1168111 w 1255054"/>
                <a:gd name="connsiteY12" fmla="*/ 1370360 h 1576561"/>
                <a:gd name="connsiteX13" fmla="*/ 844181 w 1255054"/>
                <a:gd name="connsiteY13" fmla="*/ 1547421 h 1576561"/>
                <a:gd name="connsiteX0" fmla="*/ 839298 w 1255054"/>
                <a:gd name="connsiteY0" fmla="*/ 1543490 h 1604578"/>
                <a:gd name="connsiteX1" fmla="*/ 688703 w 1255054"/>
                <a:gd name="connsiteY1" fmla="*/ 1604578 h 1604578"/>
                <a:gd name="connsiteX2" fmla="*/ 693375 w 1255054"/>
                <a:gd name="connsiteY2" fmla="*/ 1421551 h 1604578"/>
                <a:gd name="connsiteX3" fmla="*/ 386891 w 1255054"/>
                <a:gd name="connsiteY3" fmla="*/ 1168576 h 1604578"/>
                <a:gd name="connsiteX4" fmla="*/ 290 w 1255054"/>
                <a:gd name="connsiteY4" fmla="*/ 1076771 h 1604578"/>
                <a:gd name="connsiteX5" fmla="*/ 5504 w 1255054"/>
                <a:gd name="connsiteY5" fmla="*/ 876317 h 1604578"/>
                <a:gd name="connsiteX6" fmla="*/ 37062 w 1255054"/>
                <a:gd name="connsiteY6" fmla="*/ 472686 h 1604578"/>
                <a:gd name="connsiteX7" fmla="*/ 229567 w 1255054"/>
                <a:gd name="connsiteY7" fmla="*/ 164678 h 1604578"/>
                <a:gd name="connsiteX8" fmla="*/ 534236 w 1255054"/>
                <a:gd name="connsiteY8" fmla="*/ 136 h 1604578"/>
                <a:gd name="connsiteX9" fmla="*/ 840209 w 1255054"/>
                <a:gd name="connsiteY9" fmla="*/ 189303 h 1604578"/>
                <a:gd name="connsiteX10" fmla="*/ 1055670 w 1255054"/>
                <a:gd name="connsiteY10" fmla="*/ 472504 h 1604578"/>
                <a:gd name="connsiteX11" fmla="*/ 1249845 w 1255054"/>
                <a:gd name="connsiteY11" fmla="*/ 934699 h 1604578"/>
                <a:gd name="connsiteX12" fmla="*/ 1168111 w 1255054"/>
                <a:gd name="connsiteY12" fmla="*/ 1370360 h 1604578"/>
                <a:gd name="connsiteX13" fmla="*/ 844181 w 1255054"/>
                <a:gd name="connsiteY13" fmla="*/ 1547421 h 1604578"/>
                <a:gd name="connsiteX0" fmla="*/ 839298 w 1255054"/>
                <a:gd name="connsiteY0" fmla="*/ 1543490 h 1604578"/>
                <a:gd name="connsiteX1" fmla="*/ 688703 w 1255054"/>
                <a:gd name="connsiteY1" fmla="*/ 1604578 h 1604578"/>
                <a:gd name="connsiteX2" fmla="*/ 693375 w 1255054"/>
                <a:gd name="connsiteY2" fmla="*/ 1421551 h 1604578"/>
                <a:gd name="connsiteX3" fmla="*/ 386891 w 1255054"/>
                <a:gd name="connsiteY3" fmla="*/ 1168576 h 1604578"/>
                <a:gd name="connsiteX4" fmla="*/ 290 w 1255054"/>
                <a:gd name="connsiteY4" fmla="*/ 1076771 h 1604578"/>
                <a:gd name="connsiteX5" fmla="*/ 5504 w 1255054"/>
                <a:gd name="connsiteY5" fmla="*/ 876317 h 1604578"/>
                <a:gd name="connsiteX6" fmla="*/ 37062 w 1255054"/>
                <a:gd name="connsiteY6" fmla="*/ 472686 h 1604578"/>
                <a:gd name="connsiteX7" fmla="*/ 229567 w 1255054"/>
                <a:gd name="connsiteY7" fmla="*/ 164678 h 1604578"/>
                <a:gd name="connsiteX8" fmla="*/ 534236 w 1255054"/>
                <a:gd name="connsiteY8" fmla="*/ 136 h 1604578"/>
                <a:gd name="connsiteX9" fmla="*/ 840209 w 1255054"/>
                <a:gd name="connsiteY9" fmla="*/ 189303 h 1604578"/>
                <a:gd name="connsiteX10" fmla="*/ 1055670 w 1255054"/>
                <a:gd name="connsiteY10" fmla="*/ 472504 h 1604578"/>
                <a:gd name="connsiteX11" fmla="*/ 1249845 w 1255054"/>
                <a:gd name="connsiteY11" fmla="*/ 934699 h 1604578"/>
                <a:gd name="connsiteX12" fmla="*/ 1168111 w 1255054"/>
                <a:gd name="connsiteY12" fmla="*/ 1370360 h 1604578"/>
                <a:gd name="connsiteX13" fmla="*/ 844181 w 1255054"/>
                <a:gd name="connsiteY13" fmla="*/ 1547421 h 1604578"/>
                <a:gd name="connsiteX0" fmla="*/ 839298 w 1255054"/>
                <a:gd name="connsiteY0" fmla="*/ 1543490 h 1604578"/>
                <a:gd name="connsiteX1" fmla="*/ 688703 w 1255054"/>
                <a:gd name="connsiteY1" fmla="*/ 1604578 h 1604578"/>
                <a:gd name="connsiteX2" fmla="*/ 693375 w 1255054"/>
                <a:gd name="connsiteY2" fmla="*/ 1421551 h 1604578"/>
                <a:gd name="connsiteX3" fmla="*/ 386891 w 1255054"/>
                <a:gd name="connsiteY3" fmla="*/ 1168576 h 1604578"/>
                <a:gd name="connsiteX4" fmla="*/ 290 w 1255054"/>
                <a:gd name="connsiteY4" fmla="*/ 1076771 h 1604578"/>
                <a:gd name="connsiteX5" fmla="*/ 5504 w 1255054"/>
                <a:gd name="connsiteY5" fmla="*/ 876317 h 1604578"/>
                <a:gd name="connsiteX6" fmla="*/ 37062 w 1255054"/>
                <a:gd name="connsiteY6" fmla="*/ 472686 h 1604578"/>
                <a:gd name="connsiteX7" fmla="*/ 229567 w 1255054"/>
                <a:gd name="connsiteY7" fmla="*/ 164678 h 1604578"/>
                <a:gd name="connsiteX8" fmla="*/ 534236 w 1255054"/>
                <a:gd name="connsiteY8" fmla="*/ 136 h 1604578"/>
                <a:gd name="connsiteX9" fmla="*/ 840209 w 1255054"/>
                <a:gd name="connsiteY9" fmla="*/ 189303 h 1604578"/>
                <a:gd name="connsiteX10" fmla="*/ 1055670 w 1255054"/>
                <a:gd name="connsiteY10" fmla="*/ 472504 h 1604578"/>
                <a:gd name="connsiteX11" fmla="*/ 1249845 w 1255054"/>
                <a:gd name="connsiteY11" fmla="*/ 934699 h 1604578"/>
                <a:gd name="connsiteX12" fmla="*/ 1168111 w 1255054"/>
                <a:gd name="connsiteY12" fmla="*/ 1370360 h 1604578"/>
                <a:gd name="connsiteX13" fmla="*/ 844181 w 1255054"/>
                <a:gd name="connsiteY13" fmla="*/ 1547421 h 1604578"/>
                <a:gd name="connsiteX0" fmla="*/ 839298 w 1255054"/>
                <a:gd name="connsiteY0" fmla="*/ 1543490 h 1604578"/>
                <a:gd name="connsiteX1" fmla="*/ 688703 w 1255054"/>
                <a:gd name="connsiteY1" fmla="*/ 1604578 h 1604578"/>
                <a:gd name="connsiteX2" fmla="*/ 641808 w 1255054"/>
                <a:gd name="connsiteY2" fmla="*/ 1448787 h 1604578"/>
                <a:gd name="connsiteX3" fmla="*/ 386891 w 1255054"/>
                <a:gd name="connsiteY3" fmla="*/ 1168576 h 1604578"/>
                <a:gd name="connsiteX4" fmla="*/ 290 w 1255054"/>
                <a:gd name="connsiteY4" fmla="*/ 1076771 h 1604578"/>
                <a:gd name="connsiteX5" fmla="*/ 5504 w 1255054"/>
                <a:gd name="connsiteY5" fmla="*/ 876317 h 1604578"/>
                <a:gd name="connsiteX6" fmla="*/ 37062 w 1255054"/>
                <a:gd name="connsiteY6" fmla="*/ 472686 h 1604578"/>
                <a:gd name="connsiteX7" fmla="*/ 229567 w 1255054"/>
                <a:gd name="connsiteY7" fmla="*/ 164678 h 1604578"/>
                <a:gd name="connsiteX8" fmla="*/ 534236 w 1255054"/>
                <a:gd name="connsiteY8" fmla="*/ 136 h 1604578"/>
                <a:gd name="connsiteX9" fmla="*/ 840209 w 1255054"/>
                <a:gd name="connsiteY9" fmla="*/ 189303 h 1604578"/>
                <a:gd name="connsiteX10" fmla="*/ 1055670 w 1255054"/>
                <a:gd name="connsiteY10" fmla="*/ 472504 h 1604578"/>
                <a:gd name="connsiteX11" fmla="*/ 1249845 w 1255054"/>
                <a:gd name="connsiteY11" fmla="*/ 934699 h 1604578"/>
                <a:gd name="connsiteX12" fmla="*/ 1168111 w 1255054"/>
                <a:gd name="connsiteY12" fmla="*/ 1370360 h 1604578"/>
                <a:gd name="connsiteX13" fmla="*/ 844181 w 1255054"/>
                <a:gd name="connsiteY13" fmla="*/ 1547421 h 1604578"/>
                <a:gd name="connsiteX0" fmla="*/ 839298 w 1255054"/>
                <a:gd name="connsiteY0" fmla="*/ 1543490 h 1604578"/>
                <a:gd name="connsiteX1" fmla="*/ 688703 w 1255054"/>
                <a:gd name="connsiteY1" fmla="*/ 1604578 h 1604578"/>
                <a:gd name="connsiteX2" fmla="*/ 641808 w 1255054"/>
                <a:gd name="connsiteY2" fmla="*/ 1448787 h 1604578"/>
                <a:gd name="connsiteX3" fmla="*/ 386891 w 1255054"/>
                <a:gd name="connsiteY3" fmla="*/ 1168576 h 1604578"/>
                <a:gd name="connsiteX4" fmla="*/ 290 w 1255054"/>
                <a:gd name="connsiteY4" fmla="*/ 1076771 h 1604578"/>
                <a:gd name="connsiteX5" fmla="*/ 5504 w 1255054"/>
                <a:gd name="connsiteY5" fmla="*/ 876317 h 1604578"/>
                <a:gd name="connsiteX6" fmla="*/ 37062 w 1255054"/>
                <a:gd name="connsiteY6" fmla="*/ 472686 h 1604578"/>
                <a:gd name="connsiteX7" fmla="*/ 229567 w 1255054"/>
                <a:gd name="connsiteY7" fmla="*/ 164678 h 1604578"/>
                <a:gd name="connsiteX8" fmla="*/ 534236 w 1255054"/>
                <a:gd name="connsiteY8" fmla="*/ 136 h 1604578"/>
                <a:gd name="connsiteX9" fmla="*/ 840209 w 1255054"/>
                <a:gd name="connsiteY9" fmla="*/ 189303 h 1604578"/>
                <a:gd name="connsiteX10" fmla="*/ 1055670 w 1255054"/>
                <a:gd name="connsiteY10" fmla="*/ 472504 h 1604578"/>
                <a:gd name="connsiteX11" fmla="*/ 1249845 w 1255054"/>
                <a:gd name="connsiteY11" fmla="*/ 934699 h 1604578"/>
                <a:gd name="connsiteX12" fmla="*/ 1168111 w 1255054"/>
                <a:gd name="connsiteY12" fmla="*/ 1370360 h 1604578"/>
                <a:gd name="connsiteX13" fmla="*/ 844181 w 1255054"/>
                <a:gd name="connsiteY13" fmla="*/ 1547421 h 1604578"/>
                <a:gd name="connsiteX0" fmla="*/ 838011 w 1253767"/>
                <a:gd name="connsiteY0" fmla="*/ 1543490 h 1604578"/>
                <a:gd name="connsiteX1" fmla="*/ 687416 w 1253767"/>
                <a:gd name="connsiteY1" fmla="*/ 1604578 h 1604578"/>
                <a:gd name="connsiteX2" fmla="*/ 640521 w 1253767"/>
                <a:gd name="connsiteY2" fmla="*/ 1448787 h 1604578"/>
                <a:gd name="connsiteX3" fmla="*/ 385604 w 1253767"/>
                <a:gd name="connsiteY3" fmla="*/ 1168576 h 1604578"/>
                <a:gd name="connsiteX4" fmla="*/ 306 w 1253767"/>
                <a:gd name="connsiteY4" fmla="*/ 1088553 h 1604578"/>
                <a:gd name="connsiteX5" fmla="*/ 4217 w 1253767"/>
                <a:gd name="connsiteY5" fmla="*/ 876317 h 1604578"/>
                <a:gd name="connsiteX6" fmla="*/ 35775 w 1253767"/>
                <a:gd name="connsiteY6" fmla="*/ 472686 h 1604578"/>
                <a:gd name="connsiteX7" fmla="*/ 228280 w 1253767"/>
                <a:gd name="connsiteY7" fmla="*/ 164678 h 1604578"/>
                <a:gd name="connsiteX8" fmla="*/ 532949 w 1253767"/>
                <a:gd name="connsiteY8" fmla="*/ 136 h 1604578"/>
                <a:gd name="connsiteX9" fmla="*/ 838922 w 1253767"/>
                <a:gd name="connsiteY9" fmla="*/ 189303 h 1604578"/>
                <a:gd name="connsiteX10" fmla="*/ 1054383 w 1253767"/>
                <a:gd name="connsiteY10" fmla="*/ 472504 h 1604578"/>
                <a:gd name="connsiteX11" fmla="*/ 1248558 w 1253767"/>
                <a:gd name="connsiteY11" fmla="*/ 934699 h 1604578"/>
                <a:gd name="connsiteX12" fmla="*/ 1166824 w 1253767"/>
                <a:gd name="connsiteY12" fmla="*/ 1370360 h 1604578"/>
                <a:gd name="connsiteX13" fmla="*/ 842894 w 1253767"/>
                <a:gd name="connsiteY13" fmla="*/ 1547421 h 1604578"/>
                <a:gd name="connsiteX0" fmla="*/ 840328 w 1256084"/>
                <a:gd name="connsiteY0" fmla="*/ 1543490 h 1604578"/>
                <a:gd name="connsiteX1" fmla="*/ 689733 w 1256084"/>
                <a:gd name="connsiteY1" fmla="*/ 1604578 h 1604578"/>
                <a:gd name="connsiteX2" fmla="*/ 642838 w 1256084"/>
                <a:gd name="connsiteY2" fmla="*/ 1448787 h 1604578"/>
                <a:gd name="connsiteX3" fmla="*/ 387921 w 1256084"/>
                <a:gd name="connsiteY3" fmla="*/ 1168576 h 1604578"/>
                <a:gd name="connsiteX4" fmla="*/ 280 w 1256084"/>
                <a:gd name="connsiteY4" fmla="*/ 1099550 h 1604578"/>
                <a:gd name="connsiteX5" fmla="*/ 6534 w 1256084"/>
                <a:gd name="connsiteY5" fmla="*/ 876317 h 1604578"/>
                <a:gd name="connsiteX6" fmla="*/ 38092 w 1256084"/>
                <a:gd name="connsiteY6" fmla="*/ 472686 h 1604578"/>
                <a:gd name="connsiteX7" fmla="*/ 230597 w 1256084"/>
                <a:gd name="connsiteY7" fmla="*/ 164678 h 1604578"/>
                <a:gd name="connsiteX8" fmla="*/ 535266 w 1256084"/>
                <a:gd name="connsiteY8" fmla="*/ 136 h 1604578"/>
                <a:gd name="connsiteX9" fmla="*/ 841239 w 1256084"/>
                <a:gd name="connsiteY9" fmla="*/ 189303 h 1604578"/>
                <a:gd name="connsiteX10" fmla="*/ 1056700 w 1256084"/>
                <a:gd name="connsiteY10" fmla="*/ 472504 h 1604578"/>
                <a:gd name="connsiteX11" fmla="*/ 1250875 w 1256084"/>
                <a:gd name="connsiteY11" fmla="*/ 934699 h 1604578"/>
                <a:gd name="connsiteX12" fmla="*/ 1169141 w 1256084"/>
                <a:gd name="connsiteY12" fmla="*/ 1370360 h 1604578"/>
                <a:gd name="connsiteX13" fmla="*/ 845211 w 1256084"/>
                <a:gd name="connsiteY13" fmla="*/ 1547421 h 1604578"/>
                <a:gd name="connsiteX0" fmla="*/ 840328 w 1256084"/>
                <a:gd name="connsiteY0" fmla="*/ 1543490 h 1604578"/>
                <a:gd name="connsiteX1" fmla="*/ 689733 w 1256084"/>
                <a:gd name="connsiteY1" fmla="*/ 1604578 h 1604578"/>
                <a:gd name="connsiteX2" fmla="*/ 642838 w 1256084"/>
                <a:gd name="connsiteY2" fmla="*/ 1448787 h 1604578"/>
                <a:gd name="connsiteX3" fmla="*/ 387921 w 1256084"/>
                <a:gd name="connsiteY3" fmla="*/ 1168576 h 1604578"/>
                <a:gd name="connsiteX4" fmla="*/ 280 w 1256084"/>
                <a:gd name="connsiteY4" fmla="*/ 1099550 h 1604578"/>
                <a:gd name="connsiteX5" fmla="*/ 6534 w 1256084"/>
                <a:gd name="connsiteY5" fmla="*/ 876317 h 1604578"/>
                <a:gd name="connsiteX6" fmla="*/ 38092 w 1256084"/>
                <a:gd name="connsiteY6" fmla="*/ 472686 h 1604578"/>
                <a:gd name="connsiteX7" fmla="*/ 230597 w 1256084"/>
                <a:gd name="connsiteY7" fmla="*/ 164678 h 1604578"/>
                <a:gd name="connsiteX8" fmla="*/ 535266 w 1256084"/>
                <a:gd name="connsiteY8" fmla="*/ 136 h 1604578"/>
                <a:gd name="connsiteX9" fmla="*/ 841239 w 1256084"/>
                <a:gd name="connsiteY9" fmla="*/ 189303 h 1604578"/>
                <a:gd name="connsiteX10" fmla="*/ 1056700 w 1256084"/>
                <a:gd name="connsiteY10" fmla="*/ 472504 h 1604578"/>
                <a:gd name="connsiteX11" fmla="*/ 1250875 w 1256084"/>
                <a:gd name="connsiteY11" fmla="*/ 934699 h 1604578"/>
                <a:gd name="connsiteX12" fmla="*/ 1169141 w 1256084"/>
                <a:gd name="connsiteY12" fmla="*/ 1370360 h 1604578"/>
                <a:gd name="connsiteX13" fmla="*/ 845211 w 1256084"/>
                <a:gd name="connsiteY13" fmla="*/ 1547421 h 1604578"/>
                <a:gd name="connsiteX0" fmla="*/ 840328 w 1256084"/>
                <a:gd name="connsiteY0" fmla="*/ 1543490 h 1595741"/>
                <a:gd name="connsiteX1" fmla="*/ 688756 w 1256084"/>
                <a:gd name="connsiteY1" fmla="*/ 1595741 h 1595741"/>
                <a:gd name="connsiteX2" fmla="*/ 642838 w 1256084"/>
                <a:gd name="connsiteY2" fmla="*/ 1448787 h 1595741"/>
                <a:gd name="connsiteX3" fmla="*/ 387921 w 1256084"/>
                <a:gd name="connsiteY3" fmla="*/ 1168576 h 1595741"/>
                <a:gd name="connsiteX4" fmla="*/ 280 w 1256084"/>
                <a:gd name="connsiteY4" fmla="*/ 1099550 h 1595741"/>
                <a:gd name="connsiteX5" fmla="*/ 6534 w 1256084"/>
                <a:gd name="connsiteY5" fmla="*/ 876317 h 1595741"/>
                <a:gd name="connsiteX6" fmla="*/ 38092 w 1256084"/>
                <a:gd name="connsiteY6" fmla="*/ 472686 h 1595741"/>
                <a:gd name="connsiteX7" fmla="*/ 230597 w 1256084"/>
                <a:gd name="connsiteY7" fmla="*/ 164678 h 1595741"/>
                <a:gd name="connsiteX8" fmla="*/ 535266 w 1256084"/>
                <a:gd name="connsiteY8" fmla="*/ 136 h 1595741"/>
                <a:gd name="connsiteX9" fmla="*/ 841239 w 1256084"/>
                <a:gd name="connsiteY9" fmla="*/ 189303 h 1595741"/>
                <a:gd name="connsiteX10" fmla="*/ 1056700 w 1256084"/>
                <a:gd name="connsiteY10" fmla="*/ 472504 h 1595741"/>
                <a:gd name="connsiteX11" fmla="*/ 1250875 w 1256084"/>
                <a:gd name="connsiteY11" fmla="*/ 934699 h 1595741"/>
                <a:gd name="connsiteX12" fmla="*/ 1169141 w 1256084"/>
                <a:gd name="connsiteY12" fmla="*/ 1370360 h 1595741"/>
                <a:gd name="connsiteX13" fmla="*/ 845211 w 1256084"/>
                <a:gd name="connsiteY13" fmla="*/ 1547421 h 1595741"/>
                <a:gd name="connsiteX0" fmla="*/ 840328 w 1256084"/>
                <a:gd name="connsiteY0" fmla="*/ 1543490 h 1589556"/>
                <a:gd name="connsiteX1" fmla="*/ 680063 w 1256084"/>
                <a:gd name="connsiteY1" fmla="*/ 1589556 h 1589556"/>
                <a:gd name="connsiteX2" fmla="*/ 642838 w 1256084"/>
                <a:gd name="connsiteY2" fmla="*/ 1448787 h 1589556"/>
                <a:gd name="connsiteX3" fmla="*/ 387921 w 1256084"/>
                <a:gd name="connsiteY3" fmla="*/ 1168576 h 1589556"/>
                <a:gd name="connsiteX4" fmla="*/ 280 w 1256084"/>
                <a:gd name="connsiteY4" fmla="*/ 1099550 h 1589556"/>
                <a:gd name="connsiteX5" fmla="*/ 6534 w 1256084"/>
                <a:gd name="connsiteY5" fmla="*/ 876317 h 1589556"/>
                <a:gd name="connsiteX6" fmla="*/ 38092 w 1256084"/>
                <a:gd name="connsiteY6" fmla="*/ 472686 h 1589556"/>
                <a:gd name="connsiteX7" fmla="*/ 230597 w 1256084"/>
                <a:gd name="connsiteY7" fmla="*/ 164678 h 1589556"/>
                <a:gd name="connsiteX8" fmla="*/ 535266 w 1256084"/>
                <a:gd name="connsiteY8" fmla="*/ 136 h 1589556"/>
                <a:gd name="connsiteX9" fmla="*/ 841239 w 1256084"/>
                <a:gd name="connsiteY9" fmla="*/ 189303 h 1589556"/>
                <a:gd name="connsiteX10" fmla="*/ 1056700 w 1256084"/>
                <a:gd name="connsiteY10" fmla="*/ 472504 h 1589556"/>
                <a:gd name="connsiteX11" fmla="*/ 1250875 w 1256084"/>
                <a:gd name="connsiteY11" fmla="*/ 934699 h 1589556"/>
                <a:gd name="connsiteX12" fmla="*/ 1169141 w 1256084"/>
                <a:gd name="connsiteY12" fmla="*/ 1370360 h 1589556"/>
                <a:gd name="connsiteX13" fmla="*/ 845211 w 1256084"/>
                <a:gd name="connsiteY13" fmla="*/ 1547421 h 1589556"/>
                <a:gd name="connsiteX0" fmla="*/ 840328 w 1256084"/>
                <a:gd name="connsiteY0" fmla="*/ 1543490 h 1587298"/>
                <a:gd name="connsiteX1" fmla="*/ 676254 w 1256084"/>
                <a:gd name="connsiteY1" fmla="*/ 1587298 h 1587298"/>
                <a:gd name="connsiteX2" fmla="*/ 642838 w 1256084"/>
                <a:gd name="connsiteY2" fmla="*/ 1448787 h 1587298"/>
                <a:gd name="connsiteX3" fmla="*/ 387921 w 1256084"/>
                <a:gd name="connsiteY3" fmla="*/ 1168576 h 1587298"/>
                <a:gd name="connsiteX4" fmla="*/ 280 w 1256084"/>
                <a:gd name="connsiteY4" fmla="*/ 1099550 h 1587298"/>
                <a:gd name="connsiteX5" fmla="*/ 6534 w 1256084"/>
                <a:gd name="connsiteY5" fmla="*/ 876317 h 1587298"/>
                <a:gd name="connsiteX6" fmla="*/ 38092 w 1256084"/>
                <a:gd name="connsiteY6" fmla="*/ 472686 h 1587298"/>
                <a:gd name="connsiteX7" fmla="*/ 230597 w 1256084"/>
                <a:gd name="connsiteY7" fmla="*/ 164678 h 1587298"/>
                <a:gd name="connsiteX8" fmla="*/ 535266 w 1256084"/>
                <a:gd name="connsiteY8" fmla="*/ 136 h 1587298"/>
                <a:gd name="connsiteX9" fmla="*/ 841239 w 1256084"/>
                <a:gd name="connsiteY9" fmla="*/ 189303 h 1587298"/>
                <a:gd name="connsiteX10" fmla="*/ 1056700 w 1256084"/>
                <a:gd name="connsiteY10" fmla="*/ 472504 h 1587298"/>
                <a:gd name="connsiteX11" fmla="*/ 1250875 w 1256084"/>
                <a:gd name="connsiteY11" fmla="*/ 934699 h 1587298"/>
                <a:gd name="connsiteX12" fmla="*/ 1169141 w 1256084"/>
                <a:gd name="connsiteY12" fmla="*/ 1370360 h 1587298"/>
                <a:gd name="connsiteX13" fmla="*/ 845211 w 1256084"/>
                <a:gd name="connsiteY13" fmla="*/ 1547421 h 1587298"/>
                <a:gd name="connsiteX0" fmla="*/ 840328 w 1256084"/>
                <a:gd name="connsiteY0" fmla="*/ 1543490 h 1585040"/>
                <a:gd name="connsiteX1" fmla="*/ 672445 w 1256084"/>
                <a:gd name="connsiteY1" fmla="*/ 1585040 h 1585040"/>
                <a:gd name="connsiteX2" fmla="*/ 642838 w 1256084"/>
                <a:gd name="connsiteY2" fmla="*/ 1448787 h 1585040"/>
                <a:gd name="connsiteX3" fmla="*/ 387921 w 1256084"/>
                <a:gd name="connsiteY3" fmla="*/ 1168576 h 1585040"/>
                <a:gd name="connsiteX4" fmla="*/ 280 w 1256084"/>
                <a:gd name="connsiteY4" fmla="*/ 1099550 h 1585040"/>
                <a:gd name="connsiteX5" fmla="*/ 6534 w 1256084"/>
                <a:gd name="connsiteY5" fmla="*/ 876317 h 1585040"/>
                <a:gd name="connsiteX6" fmla="*/ 38092 w 1256084"/>
                <a:gd name="connsiteY6" fmla="*/ 472686 h 1585040"/>
                <a:gd name="connsiteX7" fmla="*/ 230597 w 1256084"/>
                <a:gd name="connsiteY7" fmla="*/ 164678 h 1585040"/>
                <a:gd name="connsiteX8" fmla="*/ 535266 w 1256084"/>
                <a:gd name="connsiteY8" fmla="*/ 136 h 1585040"/>
                <a:gd name="connsiteX9" fmla="*/ 841239 w 1256084"/>
                <a:gd name="connsiteY9" fmla="*/ 189303 h 1585040"/>
                <a:gd name="connsiteX10" fmla="*/ 1056700 w 1256084"/>
                <a:gd name="connsiteY10" fmla="*/ 472504 h 1585040"/>
                <a:gd name="connsiteX11" fmla="*/ 1250875 w 1256084"/>
                <a:gd name="connsiteY11" fmla="*/ 934699 h 1585040"/>
                <a:gd name="connsiteX12" fmla="*/ 1169141 w 1256084"/>
                <a:gd name="connsiteY12" fmla="*/ 1370360 h 1585040"/>
                <a:gd name="connsiteX13" fmla="*/ 845211 w 1256084"/>
                <a:gd name="connsiteY13" fmla="*/ 1547421 h 1585040"/>
                <a:gd name="connsiteX0" fmla="*/ 840328 w 1256084"/>
                <a:gd name="connsiteY0" fmla="*/ 1543490 h 1585040"/>
                <a:gd name="connsiteX1" fmla="*/ 672445 w 1256084"/>
                <a:gd name="connsiteY1" fmla="*/ 1585040 h 1585040"/>
                <a:gd name="connsiteX2" fmla="*/ 642838 w 1256084"/>
                <a:gd name="connsiteY2" fmla="*/ 1448787 h 1585040"/>
                <a:gd name="connsiteX3" fmla="*/ 387921 w 1256084"/>
                <a:gd name="connsiteY3" fmla="*/ 1168576 h 1585040"/>
                <a:gd name="connsiteX4" fmla="*/ 280 w 1256084"/>
                <a:gd name="connsiteY4" fmla="*/ 1099550 h 1585040"/>
                <a:gd name="connsiteX5" fmla="*/ 6534 w 1256084"/>
                <a:gd name="connsiteY5" fmla="*/ 876317 h 1585040"/>
                <a:gd name="connsiteX6" fmla="*/ 38092 w 1256084"/>
                <a:gd name="connsiteY6" fmla="*/ 472686 h 1585040"/>
                <a:gd name="connsiteX7" fmla="*/ 230597 w 1256084"/>
                <a:gd name="connsiteY7" fmla="*/ 164678 h 1585040"/>
                <a:gd name="connsiteX8" fmla="*/ 535266 w 1256084"/>
                <a:gd name="connsiteY8" fmla="*/ 136 h 1585040"/>
                <a:gd name="connsiteX9" fmla="*/ 841239 w 1256084"/>
                <a:gd name="connsiteY9" fmla="*/ 189303 h 1585040"/>
                <a:gd name="connsiteX10" fmla="*/ 1056700 w 1256084"/>
                <a:gd name="connsiteY10" fmla="*/ 472504 h 1585040"/>
                <a:gd name="connsiteX11" fmla="*/ 1250875 w 1256084"/>
                <a:gd name="connsiteY11" fmla="*/ 934699 h 1585040"/>
                <a:gd name="connsiteX12" fmla="*/ 1169141 w 1256084"/>
                <a:gd name="connsiteY12" fmla="*/ 1370360 h 1585040"/>
                <a:gd name="connsiteX13" fmla="*/ 845211 w 1256084"/>
                <a:gd name="connsiteY13" fmla="*/ 1547421 h 1585040"/>
                <a:gd name="connsiteX0" fmla="*/ 840328 w 1256084"/>
                <a:gd name="connsiteY0" fmla="*/ 1543490 h 1585040"/>
                <a:gd name="connsiteX1" fmla="*/ 672445 w 1256084"/>
                <a:gd name="connsiteY1" fmla="*/ 1585040 h 1585040"/>
                <a:gd name="connsiteX2" fmla="*/ 642838 w 1256084"/>
                <a:gd name="connsiteY2" fmla="*/ 1448787 h 1585040"/>
                <a:gd name="connsiteX3" fmla="*/ 387921 w 1256084"/>
                <a:gd name="connsiteY3" fmla="*/ 1168576 h 1585040"/>
                <a:gd name="connsiteX4" fmla="*/ 280 w 1256084"/>
                <a:gd name="connsiteY4" fmla="*/ 1099550 h 1585040"/>
                <a:gd name="connsiteX5" fmla="*/ 6534 w 1256084"/>
                <a:gd name="connsiteY5" fmla="*/ 876317 h 1585040"/>
                <a:gd name="connsiteX6" fmla="*/ 38092 w 1256084"/>
                <a:gd name="connsiteY6" fmla="*/ 472686 h 1585040"/>
                <a:gd name="connsiteX7" fmla="*/ 230597 w 1256084"/>
                <a:gd name="connsiteY7" fmla="*/ 164678 h 1585040"/>
                <a:gd name="connsiteX8" fmla="*/ 535266 w 1256084"/>
                <a:gd name="connsiteY8" fmla="*/ 136 h 1585040"/>
                <a:gd name="connsiteX9" fmla="*/ 841239 w 1256084"/>
                <a:gd name="connsiteY9" fmla="*/ 189303 h 1585040"/>
                <a:gd name="connsiteX10" fmla="*/ 1056700 w 1256084"/>
                <a:gd name="connsiteY10" fmla="*/ 472504 h 1585040"/>
                <a:gd name="connsiteX11" fmla="*/ 1250875 w 1256084"/>
                <a:gd name="connsiteY11" fmla="*/ 934699 h 1585040"/>
                <a:gd name="connsiteX12" fmla="*/ 1169141 w 1256084"/>
                <a:gd name="connsiteY12" fmla="*/ 1370360 h 1585040"/>
                <a:gd name="connsiteX13" fmla="*/ 847556 w 1256084"/>
                <a:gd name="connsiteY13" fmla="*/ 1556553 h 1585040"/>
                <a:gd name="connsiteX0" fmla="*/ 840328 w 1256084"/>
                <a:gd name="connsiteY0" fmla="*/ 1543490 h 1585040"/>
                <a:gd name="connsiteX1" fmla="*/ 672445 w 1256084"/>
                <a:gd name="connsiteY1" fmla="*/ 1585040 h 1585040"/>
                <a:gd name="connsiteX2" fmla="*/ 642838 w 1256084"/>
                <a:gd name="connsiteY2" fmla="*/ 1448787 h 1585040"/>
                <a:gd name="connsiteX3" fmla="*/ 387921 w 1256084"/>
                <a:gd name="connsiteY3" fmla="*/ 1168576 h 1585040"/>
                <a:gd name="connsiteX4" fmla="*/ 280 w 1256084"/>
                <a:gd name="connsiteY4" fmla="*/ 1099550 h 1585040"/>
                <a:gd name="connsiteX5" fmla="*/ 6534 w 1256084"/>
                <a:gd name="connsiteY5" fmla="*/ 876317 h 1585040"/>
                <a:gd name="connsiteX6" fmla="*/ 38092 w 1256084"/>
                <a:gd name="connsiteY6" fmla="*/ 472686 h 1585040"/>
                <a:gd name="connsiteX7" fmla="*/ 230597 w 1256084"/>
                <a:gd name="connsiteY7" fmla="*/ 164678 h 1585040"/>
                <a:gd name="connsiteX8" fmla="*/ 535266 w 1256084"/>
                <a:gd name="connsiteY8" fmla="*/ 136 h 1585040"/>
                <a:gd name="connsiteX9" fmla="*/ 841239 w 1256084"/>
                <a:gd name="connsiteY9" fmla="*/ 189303 h 1585040"/>
                <a:gd name="connsiteX10" fmla="*/ 1056700 w 1256084"/>
                <a:gd name="connsiteY10" fmla="*/ 472504 h 1585040"/>
                <a:gd name="connsiteX11" fmla="*/ 1250875 w 1256084"/>
                <a:gd name="connsiteY11" fmla="*/ 934699 h 1585040"/>
                <a:gd name="connsiteX12" fmla="*/ 1169141 w 1256084"/>
                <a:gd name="connsiteY12" fmla="*/ 1370360 h 1585040"/>
                <a:gd name="connsiteX13" fmla="*/ 847556 w 1256084"/>
                <a:gd name="connsiteY13" fmla="*/ 1556553 h 1585040"/>
                <a:gd name="connsiteX0" fmla="*/ 840328 w 1256084"/>
                <a:gd name="connsiteY0" fmla="*/ 1543490 h 1595252"/>
                <a:gd name="connsiteX1" fmla="*/ 673130 w 1256084"/>
                <a:gd name="connsiteY1" fmla="*/ 1595252 h 1595252"/>
                <a:gd name="connsiteX2" fmla="*/ 642838 w 1256084"/>
                <a:gd name="connsiteY2" fmla="*/ 1448787 h 1595252"/>
                <a:gd name="connsiteX3" fmla="*/ 387921 w 1256084"/>
                <a:gd name="connsiteY3" fmla="*/ 1168576 h 1595252"/>
                <a:gd name="connsiteX4" fmla="*/ 280 w 1256084"/>
                <a:gd name="connsiteY4" fmla="*/ 1099550 h 1595252"/>
                <a:gd name="connsiteX5" fmla="*/ 6534 w 1256084"/>
                <a:gd name="connsiteY5" fmla="*/ 876317 h 1595252"/>
                <a:gd name="connsiteX6" fmla="*/ 38092 w 1256084"/>
                <a:gd name="connsiteY6" fmla="*/ 472686 h 1595252"/>
                <a:gd name="connsiteX7" fmla="*/ 230597 w 1256084"/>
                <a:gd name="connsiteY7" fmla="*/ 164678 h 1595252"/>
                <a:gd name="connsiteX8" fmla="*/ 535266 w 1256084"/>
                <a:gd name="connsiteY8" fmla="*/ 136 h 1595252"/>
                <a:gd name="connsiteX9" fmla="*/ 841239 w 1256084"/>
                <a:gd name="connsiteY9" fmla="*/ 189303 h 1595252"/>
                <a:gd name="connsiteX10" fmla="*/ 1056700 w 1256084"/>
                <a:gd name="connsiteY10" fmla="*/ 472504 h 1595252"/>
                <a:gd name="connsiteX11" fmla="*/ 1250875 w 1256084"/>
                <a:gd name="connsiteY11" fmla="*/ 934699 h 1595252"/>
                <a:gd name="connsiteX12" fmla="*/ 1169141 w 1256084"/>
                <a:gd name="connsiteY12" fmla="*/ 1370360 h 1595252"/>
                <a:gd name="connsiteX13" fmla="*/ 847556 w 1256084"/>
                <a:gd name="connsiteY13" fmla="*/ 1556553 h 1595252"/>
                <a:gd name="connsiteX0" fmla="*/ 840328 w 1256084"/>
                <a:gd name="connsiteY0" fmla="*/ 1543490 h 1595252"/>
                <a:gd name="connsiteX1" fmla="*/ 673130 w 1256084"/>
                <a:gd name="connsiteY1" fmla="*/ 1595252 h 1595252"/>
                <a:gd name="connsiteX2" fmla="*/ 642838 w 1256084"/>
                <a:gd name="connsiteY2" fmla="*/ 1448787 h 1595252"/>
                <a:gd name="connsiteX3" fmla="*/ 387921 w 1256084"/>
                <a:gd name="connsiteY3" fmla="*/ 1168576 h 1595252"/>
                <a:gd name="connsiteX4" fmla="*/ 280 w 1256084"/>
                <a:gd name="connsiteY4" fmla="*/ 1099550 h 1595252"/>
                <a:gd name="connsiteX5" fmla="*/ 6534 w 1256084"/>
                <a:gd name="connsiteY5" fmla="*/ 876317 h 1595252"/>
                <a:gd name="connsiteX6" fmla="*/ 38092 w 1256084"/>
                <a:gd name="connsiteY6" fmla="*/ 472686 h 1595252"/>
                <a:gd name="connsiteX7" fmla="*/ 230597 w 1256084"/>
                <a:gd name="connsiteY7" fmla="*/ 164678 h 1595252"/>
                <a:gd name="connsiteX8" fmla="*/ 535266 w 1256084"/>
                <a:gd name="connsiteY8" fmla="*/ 136 h 1595252"/>
                <a:gd name="connsiteX9" fmla="*/ 841239 w 1256084"/>
                <a:gd name="connsiteY9" fmla="*/ 189303 h 1595252"/>
                <a:gd name="connsiteX10" fmla="*/ 1056700 w 1256084"/>
                <a:gd name="connsiteY10" fmla="*/ 472504 h 1595252"/>
                <a:gd name="connsiteX11" fmla="*/ 1250875 w 1256084"/>
                <a:gd name="connsiteY11" fmla="*/ 934699 h 1595252"/>
                <a:gd name="connsiteX12" fmla="*/ 1169141 w 1256084"/>
                <a:gd name="connsiteY12" fmla="*/ 1370360 h 1595252"/>
                <a:gd name="connsiteX13" fmla="*/ 847556 w 1256084"/>
                <a:gd name="connsiteY13" fmla="*/ 1556553 h 1595252"/>
                <a:gd name="connsiteX0" fmla="*/ 840328 w 1256084"/>
                <a:gd name="connsiteY0" fmla="*/ 1543490 h 1595252"/>
                <a:gd name="connsiteX1" fmla="*/ 673130 w 1256084"/>
                <a:gd name="connsiteY1" fmla="*/ 1595252 h 1595252"/>
                <a:gd name="connsiteX2" fmla="*/ 642838 w 1256084"/>
                <a:gd name="connsiteY2" fmla="*/ 1448787 h 1595252"/>
                <a:gd name="connsiteX3" fmla="*/ 387921 w 1256084"/>
                <a:gd name="connsiteY3" fmla="*/ 1168576 h 1595252"/>
                <a:gd name="connsiteX4" fmla="*/ 280 w 1256084"/>
                <a:gd name="connsiteY4" fmla="*/ 1099550 h 1595252"/>
                <a:gd name="connsiteX5" fmla="*/ 6534 w 1256084"/>
                <a:gd name="connsiteY5" fmla="*/ 876317 h 1595252"/>
                <a:gd name="connsiteX6" fmla="*/ 38092 w 1256084"/>
                <a:gd name="connsiteY6" fmla="*/ 472686 h 1595252"/>
                <a:gd name="connsiteX7" fmla="*/ 230597 w 1256084"/>
                <a:gd name="connsiteY7" fmla="*/ 164678 h 1595252"/>
                <a:gd name="connsiteX8" fmla="*/ 535266 w 1256084"/>
                <a:gd name="connsiteY8" fmla="*/ 136 h 1595252"/>
                <a:gd name="connsiteX9" fmla="*/ 841239 w 1256084"/>
                <a:gd name="connsiteY9" fmla="*/ 189303 h 1595252"/>
                <a:gd name="connsiteX10" fmla="*/ 1056700 w 1256084"/>
                <a:gd name="connsiteY10" fmla="*/ 472504 h 1595252"/>
                <a:gd name="connsiteX11" fmla="*/ 1250875 w 1256084"/>
                <a:gd name="connsiteY11" fmla="*/ 934699 h 1595252"/>
                <a:gd name="connsiteX12" fmla="*/ 1169141 w 1256084"/>
                <a:gd name="connsiteY12" fmla="*/ 1370360 h 1595252"/>
                <a:gd name="connsiteX13" fmla="*/ 845504 w 1256084"/>
                <a:gd name="connsiteY13" fmla="*/ 1546047 h 1595252"/>
                <a:gd name="connsiteX0" fmla="*/ 840328 w 1256084"/>
                <a:gd name="connsiteY0" fmla="*/ 1543490 h 1595252"/>
                <a:gd name="connsiteX1" fmla="*/ 673130 w 1256084"/>
                <a:gd name="connsiteY1" fmla="*/ 1595252 h 1595252"/>
                <a:gd name="connsiteX2" fmla="*/ 642838 w 1256084"/>
                <a:gd name="connsiteY2" fmla="*/ 1448787 h 1595252"/>
                <a:gd name="connsiteX3" fmla="*/ 387921 w 1256084"/>
                <a:gd name="connsiteY3" fmla="*/ 1168576 h 1595252"/>
                <a:gd name="connsiteX4" fmla="*/ 280 w 1256084"/>
                <a:gd name="connsiteY4" fmla="*/ 1099550 h 1595252"/>
                <a:gd name="connsiteX5" fmla="*/ 6534 w 1256084"/>
                <a:gd name="connsiteY5" fmla="*/ 876317 h 1595252"/>
                <a:gd name="connsiteX6" fmla="*/ 38092 w 1256084"/>
                <a:gd name="connsiteY6" fmla="*/ 472686 h 1595252"/>
                <a:gd name="connsiteX7" fmla="*/ 230597 w 1256084"/>
                <a:gd name="connsiteY7" fmla="*/ 164678 h 1595252"/>
                <a:gd name="connsiteX8" fmla="*/ 535266 w 1256084"/>
                <a:gd name="connsiteY8" fmla="*/ 136 h 1595252"/>
                <a:gd name="connsiteX9" fmla="*/ 841239 w 1256084"/>
                <a:gd name="connsiteY9" fmla="*/ 189303 h 1595252"/>
                <a:gd name="connsiteX10" fmla="*/ 1056700 w 1256084"/>
                <a:gd name="connsiteY10" fmla="*/ 472504 h 1595252"/>
                <a:gd name="connsiteX11" fmla="*/ 1250875 w 1256084"/>
                <a:gd name="connsiteY11" fmla="*/ 934699 h 1595252"/>
                <a:gd name="connsiteX12" fmla="*/ 1169141 w 1256084"/>
                <a:gd name="connsiteY12" fmla="*/ 1370360 h 1595252"/>
                <a:gd name="connsiteX13" fmla="*/ 845504 w 1256084"/>
                <a:gd name="connsiteY13" fmla="*/ 1546047 h 1595252"/>
                <a:gd name="connsiteX0" fmla="*/ 840328 w 1256084"/>
                <a:gd name="connsiteY0" fmla="*/ 1543490 h 1595252"/>
                <a:gd name="connsiteX1" fmla="*/ 673130 w 1256084"/>
                <a:gd name="connsiteY1" fmla="*/ 1595252 h 1595252"/>
                <a:gd name="connsiteX2" fmla="*/ 642838 w 1256084"/>
                <a:gd name="connsiteY2" fmla="*/ 1448787 h 1595252"/>
                <a:gd name="connsiteX3" fmla="*/ 387921 w 1256084"/>
                <a:gd name="connsiteY3" fmla="*/ 1168576 h 1595252"/>
                <a:gd name="connsiteX4" fmla="*/ 280 w 1256084"/>
                <a:gd name="connsiteY4" fmla="*/ 1099550 h 1595252"/>
                <a:gd name="connsiteX5" fmla="*/ 6534 w 1256084"/>
                <a:gd name="connsiteY5" fmla="*/ 876317 h 1595252"/>
                <a:gd name="connsiteX6" fmla="*/ 38092 w 1256084"/>
                <a:gd name="connsiteY6" fmla="*/ 472686 h 1595252"/>
                <a:gd name="connsiteX7" fmla="*/ 230597 w 1256084"/>
                <a:gd name="connsiteY7" fmla="*/ 164678 h 1595252"/>
                <a:gd name="connsiteX8" fmla="*/ 535266 w 1256084"/>
                <a:gd name="connsiteY8" fmla="*/ 136 h 1595252"/>
                <a:gd name="connsiteX9" fmla="*/ 841239 w 1256084"/>
                <a:gd name="connsiteY9" fmla="*/ 189303 h 1595252"/>
                <a:gd name="connsiteX10" fmla="*/ 1056700 w 1256084"/>
                <a:gd name="connsiteY10" fmla="*/ 472504 h 1595252"/>
                <a:gd name="connsiteX11" fmla="*/ 1250875 w 1256084"/>
                <a:gd name="connsiteY11" fmla="*/ 934699 h 1595252"/>
                <a:gd name="connsiteX12" fmla="*/ 1169141 w 1256084"/>
                <a:gd name="connsiteY12" fmla="*/ 1370360 h 1595252"/>
                <a:gd name="connsiteX13" fmla="*/ 845504 w 1256084"/>
                <a:gd name="connsiteY13" fmla="*/ 1546047 h 1595252"/>
                <a:gd name="connsiteX0" fmla="*/ 840328 w 1256084"/>
                <a:gd name="connsiteY0" fmla="*/ 1543490 h 1595252"/>
                <a:gd name="connsiteX1" fmla="*/ 673130 w 1256084"/>
                <a:gd name="connsiteY1" fmla="*/ 1595252 h 1595252"/>
                <a:gd name="connsiteX2" fmla="*/ 642838 w 1256084"/>
                <a:gd name="connsiteY2" fmla="*/ 1448787 h 1595252"/>
                <a:gd name="connsiteX3" fmla="*/ 387921 w 1256084"/>
                <a:gd name="connsiteY3" fmla="*/ 1168576 h 1595252"/>
                <a:gd name="connsiteX4" fmla="*/ 280 w 1256084"/>
                <a:gd name="connsiteY4" fmla="*/ 1099550 h 1595252"/>
                <a:gd name="connsiteX5" fmla="*/ 6534 w 1256084"/>
                <a:gd name="connsiteY5" fmla="*/ 876317 h 1595252"/>
                <a:gd name="connsiteX6" fmla="*/ 38092 w 1256084"/>
                <a:gd name="connsiteY6" fmla="*/ 472686 h 1595252"/>
                <a:gd name="connsiteX7" fmla="*/ 230597 w 1256084"/>
                <a:gd name="connsiteY7" fmla="*/ 164678 h 1595252"/>
                <a:gd name="connsiteX8" fmla="*/ 535266 w 1256084"/>
                <a:gd name="connsiteY8" fmla="*/ 136 h 1595252"/>
                <a:gd name="connsiteX9" fmla="*/ 841239 w 1256084"/>
                <a:gd name="connsiteY9" fmla="*/ 189303 h 1595252"/>
                <a:gd name="connsiteX10" fmla="*/ 1056700 w 1256084"/>
                <a:gd name="connsiteY10" fmla="*/ 472504 h 1595252"/>
                <a:gd name="connsiteX11" fmla="*/ 1250875 w 1256084"/>
                <a:gd name="connsiteY11" fmla="*/ 934699 h 1595252"/>
                <a:gd name="connsiteX12" fmla="*/ 1169141 w 1256084"/>
                <a:gd name="connsiteY12" fmla="*/ 1370360 h 1595252"/>
                <a:gd name="connsiteX13" fmla="*/ 845504 w 1256084"/>
                <a:gd name="connsiteY13" fmla="*/ 1546047 h 1595252"/>
                <a:gd name="connsiteX0" fmla="*/ 840328 w 1256084"/>
                <a:gd name="connsiteY0" fmla="*/ 1543490 h 1583665"/>
                <a:gd name="connsiteX1" fmla="*/ 672738 w 1256084"/>
                <a:gd name="connsiteY1" fmla="*/ 1583665 h 1583665"/>
                <a:gd name="connsiteX2" fmla="*/ 642838 w 1256084"/>
                <a:gd name="connsiteY2" fmla="*/ 1448787 h 1583665"/>
                <a:gd name="connsiteX3" fmla="*/ 387921 w 1256084"/>
                <a:gd name="connsiteY3" fmla="*/ 1168576 h 1583665"/>
                <a:gd name="connsiteX4" fmla="*/ 280 w 1256084"/>
                <a:gd name="connsiteY4" fmla="*/ 1099550 h 1583665"/>
                <a:gd name="connsiteX5" fmla="*/ 6534 w 1256084"/>
                <a:gd name="connsiteY5" fmla="*/ 876317 h 1583665"/>
                <a:gd name="connsiteX6" fmla="*/ 38092 w 1256084"/>
                <a:gd name="connsiteY6" fmla="*/ 472686 h 1583665"/>
                <a:gd name="connsiteX7" fmla="*/ 230597 w 1256084"/>
                <a:gd name="connsiteY7" fmla="*/ 164678 h 1583665"/>
                <a:gd name="connsiteX8" fmla="*/ 535266 w 1256084"/>
                <a:gd name="connsiteY8" fmla="*/ 136 h 1583665"/>
                <a:gd name="connsiteX9" fmla="*/ 841239 w 1256084"/>
                <a:gd name="connsiteY9" fmla="*/ 189303 h 1583665"/>
                <a:gd name="connsiteX10" fmla="*/ 1056700 w 1256084"/>
                <a:gd name="connsiteY10" fmla="*/ 472504 h 1583665"/>
                <a:gd name="connsiteX11" fmla="*/ 1250875 w 1256084"/>
                <a:gd name="connsiteY11" fmla="*/ 934699 h 1583665"/>
                <a:gd name="connsiteX12" fmla="*/ 1169141 w 1256084"/>
                <a:gd name="connsiteY12" fmla="*/ 1370360 h 1583665"/>
                <a:gd name="connsiteX13" fmla="*/ 845504 w 1256084"/>
                <a:gd name="connsiteY13" fmla="*/ 1546047 h 1583665"/>
                <a:gd name="connsiteX0" fmla="*/ 840328 w 1256084"/>
                <a:gd name="connsiteY0" fmla="*/ 1543490 h 1591325"/>
                <a:gd name="connsiteX1" fmla="*/ 668246 w 1256084"/>
                <a:gd name="connsiteY1" fmla="*/ 1591325 h 1591325"/>
                <a:gd name="connsiteX2" fmla="*/ 642838 w 1256084"/>
                <a:gd name="connsiteY2" fmla="*/ 1448787 h 1591325"/>
                <a:gd name="connsiteX3" fmla="*/ 387921 w 1256084"/>
                <a:gd name="connsiteY3" fmla="*/ 1168576 h 1591325"/>
                <a:gd name="connsiteX4" fmla="*/ 280 w 1256084"/>
                <a:gd name="connsiteY4" fmla="*/ 1099550 h 1591325"/>
                <a:gd name="connsiteX5" fmla="*/ 6534 w 1256084"/>
                <a:gd name="connsiteY5" fmla="*/ 876317 h 1591325"/>
                <a:gd name="connsiteX6" fmla="*/ 38092 w 1256084"/>
                <a:gd name="connsiteY6" fmla="*/ 472686 h 1591325"/>
                <a:gd name="connsiteX7" fmla="*/ 230597 w 1256084"/>
                <a:gd name="connsiteY7" fmla="*/ 164678 h 1591325"/>
                <a:gd name="connsiteX8" fmla="*/ 535266 w 1256084"/>
                <a:gd name="connsiteY8" fmla="*/ 136 h 1591325"/>
                <a:gd name="connsiteX9" fmla="*/ 841239 w 1256084"/>
                <a:gd name="connsiteY9" fmla="*/ 189303 h 1591325"/>
                <a:gd name="connsiteX10" fmla="*/ 1056700 w 1256084"/>
                <a:gd name="connsiteY10" fmla="*/ 472504 h 1591325"/>
                <a:gd name="connsiteX11" fmla="*/ 1250875 w 1256084"/>
                <a:gd name="connsiteY11" fmla="*/ 934699 h 1591325"/>
                <a:gd name="connsiteX12" fmla="*/ 1169141 w 1256084"/>
                <a:gd name="connsiteY12" fmla="*/ 1370360 h 1591325"/>
                <a:gd name="connsiteX13" fmla="*/ 845504 w 1256084"/>
                <a:gd name="connsiteY13" fmla="*/ 1546047 h 1591325"/>
                <a:gd name="connsiteX0" fmla="*/ 840048 w 1255804"/>
                <a:gd name="connsiteY0" fmla="*/ 1543490 h 1591325"/>
                <a:gd name="connsiteX1" fmla="*/ 667966 w 1255804"/>
                <a:gd name="connsiteY1" fmla="*/ 1591325 h 1591325"/>
                <a:gd name="connsiteX2" fmla="*/ 642558 w 1255804"/>
                <a:gd name="connsiteY2" fmla="*/ 1448787 h 1591325"/>
                <a:gd name="connsiteX3" fmla="*/ 387641 w 1255804"/>
                <a:gd name="connsiteY3" fmla="*/ 1168576 h 1591325"/>
                <a:gd name="connsiteX4" fmla="*/ 0 w 1255804"/>
                <a:gd name="connsiteY4" fmla="*/ 1099550 h 1591325"/>
                <a:gd name="connsiteX5" fmla="*/ 6254 w 1255804"/>
                <a:gd name="connsiteY5" fmla="*/ 876317 h 1591325"/>
                <a:gd name="connsiteX6" fmla="*/ 37812 w 1255804"/>
                <a:gd name="connsiteY6" fmla="*/ 472686 h 1591325"/>
                <a:gd name="connsiteX7" fmla="*/ 230317 w 1255804"/>
                <a:gd name="connsiteY7" fmla="*/ 164678 h 1591325"/>
                <a:gd name="connsiteX8" fmla="*/ 534986 w 1255804"/>
                <a:gd name="connsiteY8" fmla="*/ 136 h 1591325"/>
                <a:gd name="connsiteX9" fmla="*/ 840959 w 1255804"/>
                <a:gd name="connsiteY9" fmla="*/ 189303 h 1591325"/>
                <a:gd name="connsiteX10" fmla="*/ 1056420 w 1255804"/>
                <a:gd name="connsiteY10" fmla="*/ 472504 h 1591325"/>
                <a:gd name="connsiteX11" fmla="*/ 1250595 w 1255804"/>
                <a:gd name="connsiteY11" fmla="*/ 934699 h 1591325"/>
                <a:gd name="connsiteX12" fmla="*/ 1168861 w 1255804"/>
                <a:gd name="connsiteY12" fmla="*/ 1370360 h 1591325"/>
                <a:gd name="connsiteX13" fmla="*/ 845224 w 1255804"/>
                <a:gd name="connsiteY13" fmla="*/ 1546047 h 1591325"/>
                <a:gd name="connsiteX0" fmla="*/ 843867 w 1259623"/>
                <a:gd name="connsiteY0" fmla="*/ 1543490 h 1591325"/>
                <a:gd name="connsiteX1" fmla="*/ 671785 w 1259623"/>
                <a:gd name="connsiteY1" fmla="*/ 1591325 h 1591325"/>
                <a:gd name="connsiteX2" fmla="*/ 646377 w 1259623"/>
                <a:gd name="connsiteY2" fmla="*/ 1448787 h 1591325"/>
                <a:gd name="connsiteX3" fmla="*/ 391460 w 1259623"/>
                <a:gd name="connsiteY3" fmla="*/ 1168576 h 1591325"/>
                <a:gd name="connsiteX4" fmla="*/ 3819 w 1259623"/>
                <a:gd name="connsiteY4" fmla="*/ 1099550 h 1591325"/>
                <a:gd name="connsiteX5" fmla="*/ 10073 w 1259623"/>
                <a:gd name="connsiteY5" fmla="*/ 876317 h 1591325"/>
                <a:gd name="connsiteX6" fmla="*/ 41631 w 1259623"/>
                <a:gd name="connsiteY6" fmla="*/ 472686 h 1591325"/>
                <a:gd name="connsiteX7" fmla="*/ 234136 w 1259623"/>
                <a:gd name="connsiteY7" fmla="*/ 164678 h 1591325"/>
                <a:gd name="connsiteX8" fmla="*/ 538805 w 1259623"/>
                <a:gd name="connsiteY8" fmla="*/ 136 h 1591325"/>
                <a:gd name="connsiteX9" fmla="*/ 844778 w 1259623"/>
                <a:gd name="connsiteY9" fmla="*/ 189303 h 1591325"/>
                <a:gd name="connsiteX10" fmla="*/ 1060239 w 1259623"/>
                <a:gd name="connsiteY10" fmla="*/ 472504 h 1591325"/>
                <a:gd name="connsiteX11" fmla="*/ 1254414 w 1259623"/>
                <a:gd name="connsiteY11" fmla="*/ 934699 h 1591325"/>
                <a:gd name="connsiteX12" fmla="*/ 1172680 w 1259623"/>
                <a:gd name="connsiteY12" fmla="*/ 1370360 h 1591325"/>
                <a:gd name="connsiteX13" fmla="*/ 849043 w 1259623"/>
                <a:gd name="connsiteY13" fmla="*/ 1546047 h 1591325"/>
                <a:gd name="connsiteX0" fmla="*/ 845412 w 1261168"/>
                <a:gd name="connsiteY0" fmla="*/ 1543490 h 1591325"/>
                <a:gd name="connsiteX1" fmla="*/ 673330 w 1261168"/>
                <a:gd name="connsiteY1" fmla="*/ 1591325 h 1591325"/>
                <a:gd name="connsiteX2" fmla="*/ 647922 w 1261168"/>
                <a:gd name="connsiteY2" fmla="*/ 1448787 h 1591325"/>
                <a:gd name="connsiteX3" fmla="*/ 393005 w 1261168"/>
                <a:gd name="connsiteY3" fmla="*/ 1168576 h 1591325"/>
                <a:gd name="connsiteX4" fmla="*/ 5364 w 1261168"/>
                <a:gd name="connsiteY4" fmla="*/ 1099550 h 1591325"/>
                <a:gd name="connsiteX5" fmla="*/ 11618 w 1261168"/>
                <a:gd name="connsiteY5" fmla="*/ 876317 h 1591325"/>
                <a:gd name="connsiteX6" fmla="*/ 43176 w 1261168"/>
                <a:gd name="connsiteY6" fmla="*/ 472686 h 1591325"/>
                <a:gd name="connsiteX7" fmla="*/ 235681 w 1261168"/>
                <a:gd name="connsiteY7" fmla="*/ 164678 h 1591325"/>
                <a:gd name="connsiteX8" fmla="*/ 540350 w 1261168"/>
                <a:gd name="connsiteY8" fmla="*/ 136 h 1591325"/>
                <a:gd name="connsiteX9" fmla="*/ 846323 w 1261168"/>
                <a:gd name="connsiteY9" fmla="*/ 189303 h 1591325"/>
                <a:gd name="connsiteX10" fmla="*/ 1061784 w 1261168"/>
                <a:gd name="connsiteY10" fmla="*/ 472504 h 1591325"/>
                <a:gd name="connsiteX11" fmla="*/ 1255959 w 1261168"/>
                <a:gd name="connsiteY11" fmla="*/ 934699 h 1591325"/>
                <a:gd name="connsiteX12" fmla="*/ 1174225 w 1261168"/>
                <a:gd name="connsiteY12" fmla="*/ 1370360 h 1591325"/>
                <a:gd name="connsiteX13" fmla="*/ 850588 w 1261168"/>
                <a:gd name="connsiteY13" fmla="*/ 1546047 h 1591325"/>
                <a:gd name="connsiteX0" fmla="*/ 845412 w 1261168"/>
                <a:gd name="connsiteY0" fmla="*/ 1543490 h 1591325"/>
                <a:gd name="connsiteX1" fmla="*/ 673330 w 1261168"/>
                <a:gd name="connsiteY1" fmla="*/ 1591325 h 1591325"/>
                <a:gd name="connsiteX2" fmla="*/ 647922 w 1261168"/>
                <a:gd name="connsiteY2" fmla="*/ 1448787 h 1591325"/>
                <a:gd name="connsiteX3" fmla="*/ 393005 w 1261168"/>
                <a:gd name="connsiteY3" fmla="*/ 1168576 h 1591325"/>
                <a:gd name="connsiteX4" fmla="*/ 5364 w 1261168"/>
                <a:gd name="connsiteY4" fmla="*/ 1099550 h 1591325"/>
                <a:gd name="connsiteX5" fmla="*/ 11618 w 1261168"/>
                <a:gd name="connsiteY5" fmla="*/ 876317 h 1591325"/>
                <a:gd name="connsiteX6" fmla="*/ 43176 w 1261168"/>
                <a:gd name="connsiteY6" fmla="*/ 472686 h 1591325"/>
                <a:gd name="connsiteX7" fmla="*/ 235681 w 1261168"/>
                <a:gd name="connsiteY7" fmla="*/ 164678 h 1591325"/>
                <a:gd name="connsiteX8" fmla="*/ 540350 w 1261168"/>
                <a:gd name="connsiteY8" fmla="*/ 136 h 1591325"/>
                <a:gd name="connsiteX9" fmla="*/ 846323 w 1261168"/>
                <a:gd name="connsiteY9" fmla="*/ 189303 h 1591325"/>
                <a:gd name="connsiteX10" fmla="*/ 1061784 w 1261168"/>
                <a:gd name="connsiteY10" fmla="*/ 472504 h 1591325"/>
                <a:gd name="connsiteX11" fmla="*/ 1255959 w 1261168"/>
                <a:gd name="connsiteY11" fmla="*/ 934699 h 1591325"/>
                <a:gd name="connsiteX12" fmla="*/ 1174225 w 1261168"/>
                <a:gd name="connsiteY12" fmla="*/ 1370360 h 1591325"/>
                <a:gd name="connsiteX13" fmla="*/ 850588 w 1261168"/>
                <a:gd name="connsiteY13" fmla="*/ 1546047 h 1591325"/>
                <a:gd name="connsiteX0" fmla="*/ 845412 w 1261168"/>
                <a:gd name="connsiteY0" fmla="*/ 1543490 h 1591325"/>
                <a:gd name="connsiteX1" fmla="*/ 673330 w 1261168"/>
                <a:gd name="connsiteY1" fmla="*/ 1591325 h 1591325"/>
                <a:gd name="connsiteX2" fmla="*/ 647922 w 1261168"/>
                <a:gd name="connsiteY2" fmla="*/ 1448787 h 1591325"/>
                <a:gd name="connsiteX3" fmla="*/ 393005 w 1261168"/>
                <a:gd name="connsiteY3" fmla="*/ 1168576 h 1591325"/>
                <a:gd name="connsiteX4" fmla="*/ 5364 w 1261168"/>
                <a:gd name="connsiteY4" fmla="*/ 1099550 h 1591325"/>
                <a:gd name="connsiteX5" fmla="*/ 11618 w 1261168"/>
                <a:gd name="connsiteY5" fmla="*/ 876317 h 1591325"/>
                <a:gd name="connsiteX6" fmla="*/ 43176 w 1261168"/>
                <a:gd name="connsiteY6" fmla="*/ 472686 h 1591325"/>
                <a:gd name="connsiteX7" fmla="*/ 235681 w 1261168"/>
                <a:gd name="connsiteY7" fmla="*/ 164678 h 1591325"/>
                <a:gd name="connsiteX8" fmla="*/ 540350 w 1261168"/>
                <a:gd name="connsiteY8" fmla="*/ 136 h 1591325"/>
                <a:gd name="connsiteX9" fmla="*/ 846323 w 1261168"/>
                <a:gd name="connsiteY9" fmla="*/ 189303 h 1591325"/>
                <a:gd name="connsiteX10" fmla="*/ 1061784 w 1261168"/>
                <a:gd name="connsiteY10" fmla="*/ 472504 h 1591325"/>
                <a:gd name="connsiteX11" fmla="*/ 1255959 w 1261168"/>
                <a:gd name="connsiteY11" fmla="*/ 934699 h 1591325"/>
                <a:gd name="connsiteX12" fmla="*/ 1174225 w 1261168"/>
                <a:gd name="connsiteY12" fmla="*/ 1370360 h 1591325"/>
                <a:gd name="connsiteX13" fmla="*/ 850588 w 1261168"/>
                <a:gd name="connsiteY13" fmla="*/ 1546047 h 1591325"/>
                <a:gd name="connsiteX0" fmla="*/ 845412 w 1261168"/>
                <a:gd name="connsiteY0" fmla="*/ 1543490 h 1597707"/>
                <a:gd name="connsiteX1" fmla="*/ 676260 w 1261168"/>
                <a:gd name="connsiteY1" fmla="*/ 1597707 h 1597707"/>
                <a:gd name="connsiteX2" fmla="*/ 647922 w 1261168"/>
                <a:gd name="connsiteY2" fmla="*/ 1448787 h 1597707"/>
                <a:gd name="connsiteX3" fmla="*/ 393005 w 1261168"/>
                <a:gd name="connsiteY3" fmla="*/ 1168576 h 1597707"/>
                <a:gd name="connsiteX4" fmla="*/ 5364 w 1261168"/>
                <a:gd name="connsiteY4" fmla="*/ 1099550 h 1597707"/>
                <a:gd name="connsiteX5" fmla="*/ 11618 w 1261168"/>
                <a:gd name="connsiteY5" fmla="*/ 876317 h 1597707"/>
                <a:gd name="connsiteX6" fmla="*/ 43176 w 1261168"/>
                <a:gd name="connsiteY6" fmla="*/ 472686 h 1597707"/>
                <a:gd name="connsiteX7" fmla="*/ 235681 w 1261168"/>
                <a:gd name="connsiteY7" fmla="*/ 164678 h 1597707"/>
                <a:gd name="connsiteX8" fmla="*/ 540350 w 1261168"/>
                <a:gd name="connsiteY8" fmla="*/ 136 h 1597707"/>
                <a:gd name="connsiteX9" fmla="*/ 846323 w 1261168"/>
                <a:gd name="connsiteY9" fmla="*/ 189303 h 1597707"/>
                <a:gd name="connsiteX10" fmla="*/ 1061784 w 1261168"/>
                <a:gd name="connsiteY10" fmla="*/ 472504 h 1597707"/>
                <a:gd name="connsiteX11" fmla="*/ 1255959 w 1261168"/>
                <a:gd name="connsiteY11" fmla="*/ 934699 h 1597707"/>
                <a:gd name="connsiteX12" fmla="*/ 1174225 w 1261168"/>
                <a:gd name="connsiteY12" fmla="*/ 1370360 h 1597707"/>
                <a:gd name="connsiteX13" fmla="*/ 850588 w 1261168"/>
                <a:gd name="connsiteY13" fmla="*/ 1546047 h 1597707"/>
                <a:gd name="connsiteX0" fmla="*/ 845412 w 1261168"/>
                <a:gd name="connsiteY0" fmla="*/ 1543490 h 1597707"/>
                <a:gd name="connsiteX1" fmla="*/ 676260 w 1261168"/>
                <a:gd name="connsiteY1" fmla="*/ 1597707 h 1597707"/>
                <a:gd name="connsiteX2" fmla="*/ 647922 w 1261168"/>
                <a:gd name="connsiteY2" fmla="*/ 1448787 h 1597707"/>
                <a:gd name="connsiteX3" fmla="*/ 393005 w 1261168"/>
                <a:gd name="connsiteY3" fmla="*/ 1168576 h 1597707"/>
                <a:gd name="connsiteX4" fmla="*/ 5364 w 1261168"/>
                <a:gd name="connsiteY4" fmla="*/ 1099550 h 1597707"/>
                <a:gd name="connsiteX5" fmla="*/ 11618 w 1261168"/>
                <a:gd name="connsiteY5" fmla="*/ 876317 h 1597707"/>
                <a:gd name="connsiteX6" fmla="*/ 43176 w 1261168"/>
                <a:gd name="connsiteY6" fmla="*/ 472686 h 1597707"/>
                <a:gd name="connsiteX7" fmla="*/ 235681 w 1261168"/>
                <a:gd name="connsiteY7" fmla="*/ 164678 h 1597707"/>
                <a:gd name="connsiteX8" fmla="*/ 540350 w 1261168"/>
                <a:gd name="connsiteY8" fmla="*/ 136 h 1597707"/>
                <a:gd name="connsiteX9" fmla="*/ 846323 w 1261168"/>
                <a:gd name="connsiteY9" fmla="*/ 189303 h 1597707"/>
                <a:gd name="connsiteX10" fmla="*/ 1061784 w 1261168"/>
                <a:gd name="connsiteY10" fmla="*/ 472504 h 1597707"/>
                <a:gd name="connsiteX11" fmla="*/ 1255959 w 1261168"/>
                <a:gd name="connsiteY11" fmla="*/ 934699 h 1597707"/>
                <a:gd name="connsiteX12" fmla="*/ 1174225 w 1261168"/>
                <a:gd name="connsiteY12" fmla="*/ 1370360 h 1597707"/>
                <a:gd name="connsiteX13" fmla="*/ 850588 w 1261168"/>
                <a:gd name="connsiteY13" fmla="*/ 1546047 h 1597707"/>
                <a:gd name="connsiteX0" fmla="*/ 845412 w 1261168"/>
                <a:gd name="connsiteY0" fmla="*/ 1543490 h 1597707"/>
                <a:gd name="connsiteX1" fmla="*/ 676260 w 1261168"/>
                <a:gd name="connsiteY1" fmla="*/ 1597707 h 1597707"/>
                <a:gd name="connsiteX2" fmla="*/ 647922 w 1261168"/>
                <a:gd name="connsiteY2" fmla="*/ 1448787 h 1597707"/>
                <a:gd name="connsiteX3" fmla="*/ 393005 w 1261168"/>
                <a:gd name="connsiteY3" fmla="*/ 1168576 h 1597707"/>
                <a:gd name="connsiteX4" fmla="*/ 5364 w 1261168"/>
                <a:gd name="connsiteY4" fmla="*/ 1099550 h 1597707"/>
                <a:gd name="connsiteX5" fmla="*/ 11618 w 1261168"/>
                <a:gd name="connsiteY5" fmla="*/ 876317 h 1597707"/>
                <a:gd name="connsiteX6" fmla="*/ 43176 w 1261168"/>
                <a:gd name="connsiteY6" fmla="*/ 472686 h 1597707"/>
                <a:gd name="connsiteX7" fmla="*/ 235681 w 1261168"/>
                <a:gd name="connsiteY7" fmla="*/ 164678 h 1597707"/>
                <a:gd name="connsiteX8" fmla="*/ 540350 w 1261168"/>
                <a:gd name="connsiteY8" fmla="*/ 136 h 1597707"/>
                <a:gd name="connsiteX9" fmla="*/ 846323 w 1261168"/>
                <a:gd name="connsiteY9" fmla="*/ 189303 h 1597707"/>
                <a:gd name="connsiteX10" fmla="*/ 1061784 w 1261168"/>
                <a:gd name="connsiteY10" fmla="*/ 472504 h 1597707"/>
                <a:gd name="connsiteX11" fmla="*/ 1255959 w 1261168"/>
                <a:gd name="connsiteY11" fmla="*/ 934699 h 1597707"/>
                <a:gd name="connsiteX12" fmla="*/ 1174225 w 1261168"/>
                <a:gd name="connsiteY12" fmla="*/ 1370360 h 1597707"/>
                <a:gd name="connsiteX13" fmla="*/ 850588 w 1261168"/>
                <a:gd name="connsiteY13" fmla="*/ 1546047 h 1597707"/>
                <a:gd name="connsiteX0" fmla="*/ 845412 w 1261168"/>
                <a:gd name="connsiteY0" fmla="*/ 1543490 h 1597707"/>
                <a:gd name="connsiteX1" fmla="*/ 676260 w 1261168"/>
                <a:gd name="connsiteY1" fmla="*/ 1597707 h 1597707"/>
                <a:gd name="connsiteX2" fmla="*/ 647922 w 1261168"/>
                <a:gd name="connsiteY2" fmla="*/ 1448787 h 1597707"/>
                <a:gd name="connsiteX3" fmla="*/ 393005 w 1261168"/>
                <a:gd name="connsiteY3" fmla="*/ 1168576 h 1597707"/>
                <a:gd name="connsiteX4" fmla="*/ 5364 w 1261168"/>
                <a:gd name="connsiteY4" fmla="*/ 1099550 h 1597707"/>
                <a:gd name="connsiteX5" fmla="*/ 11618 w 1261168"/>
                <a:gd name="connsiteY5" fmla="*/ 876317 h 1597707"/>
                <a:gd name="connsiteX6" fmla="*/ 43176 w 1261168"/>
                <a:gd name="connsiteY6" fmla="*/ 472686 h 1597707"/>
                <a:gd name="connsiteX7" fmla="*/ 235681 w 1261168"/>
                <a:gd name="connsiteY7" fmla="*/ 164678 h 1597707"/>
                <a:gd name="connsiteX8" fmla="*/ 540350 w 1261168"/>
                <a:gd name="connsiteY8" fmla="*/ 136 h 1597707"/>
                <a:gd name="connsiteX9" fmla="*/ 846323 w 1261168"/>
                <a:gd name="connsiteY9" fmla="*/ 189303 h 1597707"/>
                <a:gd name="connsiteX10" fmla="*/ 1061784 w 1261168"/>
                <a:gd name="connsiteY10" fmla="*/ 472504 h 1597707"/>
                <a:gd name="connsiteX11" fmla="*/ 1255959 w 1261168"/>
                <a:gd name="connsiteY11" fmla="*/ 934699 h 1597707"/>
                <a:gd name="connsiteX12" fmla="*/ 1174225 w 1261168"/>
                <a:gd name="connsiteY12" fmla="*/ 1370360 h 1597707"/>
                <a:gd name="connsiteX13" fmla="*/ 850588 w 1261168"/>
                <a:gd name="connsiteY13" fmla="*/ 1546047 h 1597707"/>
                <a:gd name="connsiteX0" fmla="*/ 854626 w 1270382"/>
                <a:gd name="connsiteY0" fmla="*/ 1543490 h 1597707"/>
                <a:gd name="connsiteX1" fmla="*/ 685474 w 1270382"/>
                <a:gd name="connsiteY1" fmla="*/ 1597707 h 1597707"/>
                <a:gd name="connsiteX2" fmla="*/ 657136 w 1270382"/>
                <a:gd name="connsiteY2" fmla="*/ 1448787 h 1597707"/>
                <a:gd name="connsiteX3" fmla="*/ 402219 w 1270382"/>
                <a:gd name="connsiteY3" fmla="*/ 1168576 h 1597707"/>
                <a:gd name="connsiteX4" fmla="*/ 14578 w 1270382"/>
                <a:gd name="connsiteY4" fmla="*/ 1099550 h 1597707"/>
                <a:gd name="connsiteX5" fmla="*/ 20832 w 1270382"/>
                <a:gd name="connsiteY5" fmla="*/ 876317 h 1597707"/>
                <a:gd name="connsiteX6" fmla="*/ 52390 w 1270382"/>
                <a:gd name="connsiteY6" fmla="*/ 472686 h 1597707"/>
                <a:gd name="connsiteX7" fmla="*/ 244895 w 1270382"/>
                <a:gd name="connsiteY7" fmla="*/ 164678 h 1597707"/>
                <a:gd name="connsiteX8" fmla="*/ 549564 w 1270382"/>
                <a:gd name="connsiteY8" fmla="*/ 136 h 1597707"/>
                <a:gd name="connsiteX9" fmla="*/ 855537 w 1270382"/>
                <a:gd name="connsiteY9" fmla="*/ 189303 h 1597707"/>
                <a:gd name="connsiteX10" fmla="*/ 1070998 w 1270382"/>
                <a:gd name="connsiteY10" fmla="*/ 472504 h 1597707"/>
                <a:gd name="connsiteX11" fmla="*/ 1265173 w 1270382"/>
                <a:gd name="connsiteY11" fmla="*/ 934699 h 1597707"/>
                <a:gd name="connsiteX12" fmla="*/ 1183439 w 1270382"/>
                <a:gd name="connsiteY12" fmla="*/ 1370360 h 1597707"/>
                <a:gd name="connsiteX13" fmla="*/ 859802 w 1270382"/>
                <a:gd name="connsiteY13" fmla="*/ 1546047 h 1597707"/>
                <a:gd name="connsiteX0" fmla="*/ 858525 w 1274281"/>
                <a:gd name="connsiteY0" fmla="*/ 1543490 h 1597707"/>
                <a:gd name="connsiteX1" fmla="*/ 689373 w 1274281"/>
                <a:gd name="connsiteY1" fmla="*/ 1597707 h 1597707"/>
                <a:gd name="connsiteX2" fmla="*/ 661035 w 1274281"/>
                <a:gd name="connsiteY2" fmla="*/ 1448787 h 1597707"/>
                <a:gd name="connsiteX3" fmla="*/ 406118 w 1274281"/>
                <a:gd name="connsiteY3" fmla="*/ 1168576 h 1597707"/>
                <a:gd name="connsiteX4" fmla="*/ 13886 w 1274281"/>
                <a:gd name="connsiteY4" fmla="*/ 1094248 h 1597707"/>
                <a:gd name="connsiteX5" fmla="*/ 24731 w 1274281"/>
                <a:gd name="connsiteY5" fmla="*/ 876317 h 1597707"/>
                <a:gd name="connsiteX6" fmla="*/ 56289 w 1274281"/>
                <a:gd name="connsiteY6" fmla="*/ 472686 h 1597707"/>
                <a:gd name="connsiteX7" fmla="*/ 248794 w 1274281"/>
                <a:gd name="connsiteY7" fmla="*/ 164678 h 1597707"/>
                <a:gd name="connsiteX8" fmla="*/ 553463 w 1274281"/>
                <a:gd name="connsiteY8" fmla="*/ 136 h 1597707"/>
                <a:gd name="connsiteX9" fmla="*/ 859436 w 1274281"/>
                <a:gd name="connsiteY9" fmla="*/ 189303 h 1597707"/>
                <a:gd name="connsiteX10" fmla="*/ 1074897 w 1274281"/>
                <a:gd name="connsiteY10" fmla="*/ 472504 h 1597707"/>
                <a:gd name="connsiteX11" fmla="*/ 1269072 w 1274281"/>
                <a:gd name="connsiteY11" fmla="*/ 934699 h 1597707"/>
                <a:gd name="connsiteX12" fmla="*/ 1187338 w 1274281"/>
                <a:gd name="connsiteY12" fmla="*/ 1370360 h 1597707"/>
                <a:gd name="connsiteX13" fmla="*/ 863701 w 1274281"/>
                <a:gd name="connsiteY13" fmla="*/ 1546047 h 1597707"/>
                <a:gd name="connsiteX0" fmla="*/ 868660 w 1284416"/>
                <a:gd name="connsiteY0" fmla="*/ 1543490 h 1597707"/>
                <a:gd name="connsiteX1" fmla="*/ 699508 w 1284416"/>
                <a:gd name="connsiteY1" fmla="*/ 1597707 h 1597707"/>
                <a:gd name="connsiteX2" fmla="*/ 671170 w 1284416"/>
                <a:gd name="connsiteY2" fmla="*/ 1448787 h 1597707"/>
                <a:gd name="connsiteX3" fmla="*/ 416253 w 1284416"/>
                <a:gd name="connsiteY3" fmla="*/ 1168576 h 1597707"/>
                <a:gd name="connsiteX4" fmla="*/ 12399 w 1284416"/>
                <a:gd name="connsiteY4" fmla="*/ 1101810 h 1597707"/>
                <a:gd name="connsiteX5" fmla="*/ 34866 w 1284416"/>
                <a:gd name="connsiteY5" fmla="*/ 876317 h 1597707"/>
                <a:gd name="connsiteX6" fmla="*/ 66424 w 1284416"/>
                <a:gd name="connsiteY6" fmla="*/ 472686 h 1597707"/>
                <a:gd name="connsiteX7" fmla="*/ 258929 w 1284416"/>
                <a:gd name="connsiteY7" fmla="*/ 164678 h 1597707"/>
                <a:gd name="connsiteX8" fmla="*/ 563598 w 1284416"/>
                <a:gd name="connsiteY8" fmla="*/ 136 h 1597707"/>
                <a:gd name="connsiteX9" fmla="*/ 869571 w 1284416"/>
                <a:gd name="connsiteY9" fmla="*/ 189303 h 1597707"/>
                <a:gd name="connsiteX10" fmla="*/ 1085032 w 1284416"/>
                <a:gd name="connsiteY10" fmla="*/ 472504 h 1597707"/>
                <a:gd name="connsiteX11" fmla="*/ 1279207 w 1284416"/>
                <a:gd name="connsiteY11" fmla="*/ 934699 h 1597707"/>
                <a:gd name="connsiteX12" fmla="*/ 1197473 w 1284416"/>
                <a:gd name="connsiteY12" fmla="*/ 1370360 h 1597707"/>
                <a:gd name="connsiteX13" fmla="*/ 873836 w 1284416"/>
                <a:gd name="connsiteY13" fmla="*/ 1546047 h 1597707"/>
                <a:gd name="connsiteX0" fmla="*/ 868660 w 1284416"/>
                <a:gd name="connsiteY0" fmla="*/ 1543490 h 1608265"/>
                <a:gd name="connsiteX1" fmla="*/ 699508 w 1284416"/>
                <a:gd name="connsiteY1" fmla="*/ 1597707 h 1608265"/>
                <a:gd name="connsiteX2" fmla="*/ 671170 w 1284416"/>
                <a:gd name="connsiteY2" fmla="*/ 1448787 h 1608265"/>
                <a:gd name="connsiteX3" fmla="*/ 416253 w 1284416"/>
                <a:gd name="connsiteY3" fmla="*/ 1168576 h 1608265"/>
                <a:gd name="connsiteX4" fmla="*/ 12399 w 1284416"/>
                <a:gd name="connsiteY4" fmla="*/ 1101810 h 1608265"/>
                <a:gd name="connsiteX5" fmla="*/ 34866 w 1284416"/>
                <a:gd name="connsiteY5" fmla="*/ 876317 h 1608265"/>
                <a:gd name="connsiteX6" fmla="*/ 66424 w 1284416"/>
                <a:gd name="connsiteY6" fmla="*/ 472686 h 1608265"/>
                <a:gd name="connsiteX7" fmla="*/ 258929 w 1284416"/>
                <a:gd name="connsiteY7" fmla="*/ 164678 h 1608265"/>
                <a:gd name="connsiteX8" fmla="*/ 563598 w 1284416"/>
                <a:gd name="connsiteY8" fmla="*/ 136 h 1608265"/>
                <a:gd name="connsiteX9" fmla="*/ 869571 w 1284416"/>
                <a:gd name="connsiteY9" fmla="*/ 189303 h 1608265"/>
                <a:gd name="connsiteX10" fmla="*/ 1085032 w 1284416"/>
                <a:gd name="connsiteY10" fmla="*/ 472504 h 1608265"/>
                <a:gd name="connsiteX11" fmla="*/ 1279207 w 1284416"/>
                <a:gd name="connsiteY11" fmla="*/ 934699 h 1608265"/>
                <a:gd name="connsiteX12" fmla="*/ 1197473 w 1284416"/>
                <a:gd name="connsiteY12" fmla="*/ 1370360 h 1608265"/>
                <a:gd name="connsiteX13" fmla="*/ 873836 w 1284416"/>
                <a:gd name="connsiteY13" fmla="*/ 1546047 h 1608265"/>
                <a:gd name="connsiteX0" fmla="*/ 868660 w 1284416"/>
                <a:gd name="connsiteY0" fmla="*/ 1543490 h 1651167"/>
                <a:gd name="connsiteX1" fmla="*/ 697428 w 1284416"/>
                <a:gd name="connsiteY1" fmla="*/ 1643268 h 1651167"/>
                <a:gd name="connsiteX2" fmla="*/ 671170 w 1284416"/>
                <a:gd name="connsiteY2" fmla="*/ 1448787 h 1651167"/>
                <a:gd name="connsiteX3" fmla="*/ 416253 w 1284416"/>
                <a:gd name="connsiteY3" fmla="*/ 1168576 h 1651167"/>
                <a:gd name="connsiteX4" fmla="*/ 12399 w 1284416"/>
                <a:gd name="connsiteY4" fmla="*/ 1101810 h 1651167"/>
                <a:gd name="connsiteX5" fmla="*/ 34866 w 1284416"/>
                <a:gd name="connsiteY5" fmla="*/ 876317 h 1651167"/>
                <a:gd name="connsiteX6" fmla="*/ 66424 w 1284416"/>
                <a:gd name="connsiteY6" fmla="*/ 472686 h 1651167"/>
                <a:gd name="connsiteX7" fmla="*/ 258929 w 1284416"/>
                <a:gd name="connsiteY7" fmla="*/ 164678 h 1651167"/>
                <a:gd name="connsiteX8" fmla="*/ 563598 w 1284416"/>
                <a:gd name="connsiteY8" fmla="*/ 136 h 1651167"/>
                <a:gd name="connsiteX9" fmla="*/ 869571 w 1284416"/>
                <a:gd name="connsiteY9" fmla="*/ 189303 h 1651167"/>
                <a:gd name="connsiteX10" fmla="*/ 1085032 w 1284416"/>
                <a:gd name="connsiteY10" fmla="*/ 472504 h 1651167"/>
                <a:gd name="connsiteX11" fmla="*/ 1279207 w 1284416"/>
                <a:gd name="connsiteY11" fmla="*/ 934699 h 1651167"/>
                <a:gd name="connsiteX12" fmla="*/ 1197473 w 1284416"/>
                <a:gd name="connsiteY12" fmla="*/ 1370360 h 1651167"/>
                <a:gd name="connsiteX13" fmla="*/ 873836 w 1284416"/>
                <a:gd name="connsiteY13" fmla="*/ 1546047 h 1651167"/>
                <a:gd name="connsiteX0" fmla="*/ 868660 w 1284416"/>
                <a:gd name="connsiteY0" fmla="*/ 1543490 h 1656809"/>
                <a:gd name="connsiteX1" fmla="*/ 698080 w 1284416"/>
                <a:gd name="connsiteY1" fmla="*/ 1649159 h 1656809"/>
                <a:gd name="connsiteX2" fmla="*/ 671170 w 1284416"/>
                <a:gd name="connsiteY2" fmla="*/ 1448787 h 1656809"/>
                <a:gd name="connsiteX3" fmla="*/ 416253 w 1284416"/>
                <a:gd name="connsiteY3" fmla="*/ 1168576 h 1656809"/>
                <a:gd name="connsiteX4" fmla="*/ 12399 w 1284416"/>
                <a:gd name="connsiteY4" fmla="*/ 1101810 h 1656809"/>
                <a:gd name="connsiteX5" fmla="*/ 34866 w 1284416"/>
                <a:gd name="connsiteY5" fmla="*/ 876317 h 1656809"/>
                <a:gd name="connsiteX6" fmla="*/ 66424 w 1284416"/>
                <a:gd name="connsiteY6" fmla="*/ 472686 h 1656809"/>
                <a:gd name="connsiteX7" fmla="*/ 258929 w 1284416"/>
                <a:gd name="connsiteY7" fmla="*/ 164678 h 1656809"/>
                <a:gd name="connsiteX8" fmla="*/ 563598 w 1284416"/>
                <a:gd name="connsiteY8" fmla="*/ 136 h 1656809"/>
                <a:gd name="connsiteX9" fmla="*/ 869571 w 1284416"/>
                <a:gd name="connsiteY9" fmla="*/ 189303 h 1656809"/>
                <a:gd name="connsiteX10" fmla="*/ 1085032 w 1284416"/>
                <a:gd name="connsiteY10" fmla="*/ 472504 h 1656809"/>
                <a:gd name="connsiteX11" fmla="*/ 1279207 w 1284416"/>
                <a:gd name="connsiteY11" fmla="*/ 934699 h 1656809"/>
                <a:gd name="connsiteX12" fmla="*/ 1197473 w 1284416"/>
                <a:gd name="connsiteY12" fmla="*/ 1370360 h 1656809"/>
                <a:gd name="connsiteX13" fmla="*/ 873836 w 1284416"/>
                <a:gd name="connsiteY13" fmla="*/ 1546047 h 1656809"/>
                <a:gd name="connsiteX0" fmla="*/ 868660 w 1284416"/>
                <a:gd name="connsiteY0" fmla="*/ 1543490 h 1663221"/>
                <a:gd name="connsiteX1" fmla="*/ 702378 w 1284416"/>
                <a:gd name="connsiteY1" fmla="*/ 1655835 h 1663221"/>
                <a:gd name="connsiteX2" fmla="*/ 671170 w 1284416"/>
                <a:gd name="connsiteY2" fmla="*/ 1448787 h 1663221"/>
                <a:gd name="connsiteX3" fmla="*/ 416253 w 1284416"/>
                <a:gd name="connsiteY3" fmla="*/ 1168576 h 1663221"/>
                <a:gd name="connsiteX4" fmla="*/ 12399 w 1284416"/>
                <a:gd name="connsiteY4" fmla="*/ 1101810 h 1663221"/>
                <a:gd name="connsiteX5" fmla="*/ 34866 w 1284416"/>
                <a:gd name="connsiteY5" fmla="*/ 876317 h 1663221"/>
                <a:gd name="connsiteX6" fmla="*/ 66424 w 1284416"/>
                <a:gd name="connsiteY6" fmla="*/ 472686 h 1663221"/>
                <a:gd name="connsiteX7" fmla="*/ 258929 w 1284416"/>
                <a:gd name="connsiteY7" fmla="*/ 164678 h 1663221"/>
                <a:gd name="connsiteX8" fmla="*/ 563598 w 1284416"/>
                <a:gd name="connsiteY8" fmla="*/ 136 h 1663221"/>
                <a:gd name="connsiteX9" fmla="*/ 869571 w 1284416"/>
                <a:gd name="connsiteY9" fmla="*/ 189303 h 1663221"/>
                <a:gd name="connsiteX10" fmla="*/ 1085032 w 1284416"/>
                <a:gd name="connsiteY10" fmla="*/ 472504 h 1663221"/>
                <a:gd name="connsiteX11" fmla="*/ 1279207 w 1284416"/>
                <a:gd name="connsiteY11" fmla="*/ 934699 h 1663221"/>
                <a:gd name="connsiteX12" fmla="*/ 1197473 w 1284416"/>
                <a:gd name="connsiteY12" fmla="*/ 1370360 h 1663221"/>
                <a:gd name="connsiteX13" fmla="*/ 873836 w 1284416"/>
                <a:gd name="connsiteY13" fmla="*/ 1546047 h 1663221"/>
                <a:gd name="connsiteX0" fmla="*/ 868660 w 1284416"/>
                <a:gd name="connsiteY0" fmla="*/ 1543490 h 1673190"/>
                <a:gd name="connsiteX1" fmla="*/ 705895 w 1284416"/>
                <a:gd name="connsiteY1" fmla="*/ 1666178 h 1673190"/>
                <a:gd name="connsiteX2" fmla="*/ 671170 w 1284416"/>
                <a:gd name="connsiteY2" fmla="*/ 1448787 h 1673190"/>
                <a:gd name="connsiteX3" fmla="*/ 416253 w 1284416"/>
                <a:gd name="connsiteY3" fmla="*/ 1168576 h 1673190"/>
                <a:gd name="connsiteX4" fmla="*/ 12399 w 1284416"/>
                <a:gd name="connsiteY4" fmla="*/ 1101810 h 1673190"/>
                <a:gd name="connsiteX5" fmla="*/ 34866 w 1284416"/>
                <a:gd name="connsiteY5" fmla="*/ 876317 h 1673190"/>
                <a:gd name="connsiteX6" fmla="*/ 66424 w 1284416"/>
                <a:gd name="connsiteY6" fmla="*/ 472686 h 1673190"/>
                <a:gd name="connsiteX7" fmla="*/ 258929 w 1284416"/>
                <a:gd name="connsiteY7" fmla="*/ 164678 h 1673190"/>
                <a:gd name="connsiteX8" fmla="*/ 563598 w 1284416"/>
                <a:gd name="connsiteY8" fmla="*/ 136 h 1673190"/>
                <a:gd name="connsiteX9" fmla="*/ 869571 w 1284416"/>
                <a:gd name="connsiteY9" fmla="*/ 189303 h 1673190"/>
                <a:gd name="connsiteX10" fmla="*/ 1085032 w 1284416"/>
                <a:gd name="connsiteY10" fmla="*/ 472504 h 1673190"/>
                <a:gd name="connsiteX11" fmla="*/ 1279207 w 1284416"/>
                <a:gd name="connsiteY11" fmla="*/ 934699 h 1673190"/>
                <a:gd name="connsiteX12" fmla="*/ 1197473 w 1284416"/>
                <a:gd name="connsiteY12" fmla="*/ 1370360 h 1673190"/>
                <a:gd name="connsiteX13" fmla="*/ 873836 w 1284416"/>
                <a:gd name="connsiteY13" fmla="*/ 1546047 h 1673190"/>
                <a:gd name="connsiteX0" fmla="*/ 868660 w 1284416"/>
                <a:gd name="connsiteY0" fmla="*/ 1543490 h 1676991"/>
                <a:gd name="connsiteX1" fmla="*/ 705895 w 1284416"/>
                <a:gd name="connsiteY1" fmla="*/ 1666178 h 1676991"/>
                <a:gd name="connsiteX2" fmla="*/ 671170 w 1284416"/>
                <a:gd name="connsiteY2" fmla="*/ 1448787 h 1676991"/>
                <a:gd name="connsiteX3" fmla="*/ 416253 w 1284416"/>
                <a:gd name="connsiteY3" fmla="*/ 1168576 h 1676991"/>
                <a:gd name="connsiteX4" fmla="*/ 12399 w 1284416"/>
                <a:gd name="connsiteY4" fmla="*/ 1101810 h 1676991"/>
                <a:gd name="connsiteX5" fmla="*/ 34866 w 1284416"/>
                <a:gd name="connsiteY5" fmla="*/ 876317 h 1676991"/>
                <a:gd name="connsiteX6" fmla="*/ 66424 w 1284416"/>
                <a:gd name="connsiteY6" fmla="*/ 472686 h 1676991"/>
                <a:gd name="connsiteX7" fmla="*/ 258929 w 1284416"/>
                <a:gd name="connsiteY7" fmla="*/ 164678 h 1676991"/>
                <a:gd name="connsiteX8" fmla="*/ 563598 w 1284416"/>
                <a:gd name="connsiteY8" fmla="*/ 136 h 1676991"/>
                <a:gd name="connsiteX9" fmla="*/ 869571 w 1284416"/>
                <a:gd name="connsiteY9" fmla="*/ 189303 h 1676991"/>
                <a:gd name="connsiteX10" fmla="*/ 1085032 w 1284416"/>
                <a:gd name="connsiteY10" fmla="*/ 472504 h 1676991"/>
                <a:gd name="connsiteX11" fmla="*/ 1279207 w 1284416"/>
                <a:gd name="connsiteY11" fmla="*/ 934699 h 1676991"/>
                <a:gd name="connsiteX12" fmla="*/ 1197473 w 1284416"/>
                <a:gd name="connsiteY12" fmla="*/ 1370360 h 1676991"/>
                <a:gd name="connsiteX13" fmla="*/ 873836 w 1284416"/>
                <a:gd name="connsiteY13" fmla="*/ 1546047 h 1676991"/>
                <a:gd name="connsiteX0" fmla="*/ 868660 w 1284416"/>
                <a:gd name="connsiteY0" fmla="*/ 1543490 h 1670344"/>
                <a:gd name="connsiteX1" fmla="*/ 705895 w 1284416"/>
                <a:gd name="connsiteY1" fmla="*/ 1666178 h 1670344"/>
                <a:gd name="connsiteX2" fmla="*/ 671170 w 1284416"/>
                <a:gd name="connsiteY2" fmla="*/ 1448787 h 1670344"/>
                <a:gd name="connsiteX3" fmla="*/ 416253 w 1284416"/>
                <a:gd name="connsiteY3" fmla="*/ 1168576 h 1670344"/>
                <a:gd name="connsiteX4" fmla="*/ 12399 w 1284416"/>
                <a:gd name="connsiteY4" fmla="*/ 1101810 h 1670344"/>
                <a:gd name="connsiteX5" fmla="*/ 34866 w 1284416"/>
                <a:gd name="connsiteY5" fmla="*/ 876317 h 1670344"/>
                <a:gd name="connsiteX6" fmla="*/ 66424 w 1284416"/>
                <a:gd name="connsiteY6" fmla="*/ 472686 h 1670344"/>
                <a:gd name="connsiteX7" fmla="*/ 258929 w 1284416"/>
                <a:gd name="connsiteY7" fmla="*/ 164678 h 1670344"/>
                <a:gd name="connsiteX8" fmla="*/ 563598 w 1284416"/>
                <a:gd name="connsiteY8" fmla="*/ 136 h 1670344"/>
                <a:gd name="connsiteX9" fmla="*/ 869571 w 1284416"/>
                <a:gd name="connsiteY9" fmla="*/ 189303 h 1670344"/>
                <a:gd name="connsiteX10" fmla="*/ 1085032 w 1284416"/>
                <a:gd name="connsiteY10" fmla="*/ 472504 h 1670344"/>
                <a:gd name="connsiteX11" fmla="*/ 1279207 w 1284416"/>
                <a:gd name="connsiteY11" fmla="*/ 934699 h 1670344"/>
                <a:gd name="connsiteX12" fmla="*/ 1197473 w 1284416"/>
                <a:gd name="connsiteY12" fmla="*/ 1370360 h 1670344"/>
                <a:gd name="connsiteX13" fmla="*/ 873836 w 1284416"/>
                <a:gd name="connsiteY13" fmla="*/ 1546047 h 1670344"/>
                <a:gd name="connsiteX0" fmla="*/ 868660 w 1284416"/>
                <a:gd name="connsiteY0" fmla="*/ 1543490 h 1673572"/>
                <a:gd name="connsiteX1" fmla="*/ 705895 w 1284416"/>
                <a:gd name="connsiteY1" fmla="*/ 1666178 h 1673572"/>
                <a:gd name="connsiteX2" fmla="*/ 671170 w 1284416"/>
                <a:gd name="connsiteY2" fmla="*/ 1448787 h 1673572"/>
                <a:gd name="connsiteX3" fmla="*/ 416253 w 1284416"/>
                <a:gd name="connsiteY3" fmla="*/ 1168576 h 1673572"/>
                <a:gd name="connsiteX4" fmla="*/ 12399 w 1284416"/>
                <a:gd name="connsiteY4" fmla="*/ 1101810 h 1673572"/>
                <a:gd name="connsiteX5" fmla="*/ 34866 w 1284416"/>
                <a:gd name="connsiteY5" fmla="*/ 876317 h 1673572"/>
                <a:gd name="connsiteX6" fmla="*/ 66424 w 1284416"/>
                <a:gd name="connsiteY6" fmla="*/ 472686 h 1673572"/>
                <a:gd name="connsiteX7" fmla="*/ 258929 w 1284416"/>
                <a:gd name="connsiteY7" fmla="*/ 164678 h 1673572"/>
                <a:gd name="connsiteX8" fmla="*/ 563598 w 1284416"/>
                <a:gd name="connsiteY8" fmla="*/ 136 h 1673572"/>
                <a:gd name="connsiteX9" fmla="*/ 869571 w 1284416"/>
                <a:gd name="connsiteY9" fmla="*/ 189303 h 1673572"/>
                <a:gd name="connsiteX10" fmla="*/ 1085032 w 1284416"/>
                <a:gd name="connsiteY10" fmla="*/ 472504 h 1673572"/>
                <a:gd name="connsiteX11" fmla="*/ 1279207 w 1284416"/>
                <a:gd name="connsiteY11" fmla="*/ 934699 h 1673572"/>
                <a:gd name="connsiteX12" fmla="*/ 1197473 w 1284416"/>
                <a:gd name="connsiteY12" fmla="*/ 1370360 h 1673572"/>
                <a:gd name="connsiteX13" fmla="*/ 873836 w 1284416"/>
                <a:gd name="connsiteY13" fmla="*/ 1546047 h 1673572"/>
                <a:gd name="connsiteX0" fmla="*/ 868660 w 1284416"/>
                <a:gd name="connsiteY0" fmla="*/ 1543490 h 1675236"/>
                <a:gd name="connsiteX1" fmla="*/ 705895 w 1284416"/>
                <a:gd name="connsiteY1" fmla="*/ 1666178 h 1675236"/>
                <a:gd name="connsiteX2" fmla="*/ 671170 w 1284416"/>
                <a:gd name="connsiteY2" fmla="*/ 1448787 h 1675236"/>
                <a:gd name="connsiteX3" fmla="*/ 416253 w 1284416"/>
                <a:gd name="connsiteY3" fmla="*/ 1168576 h 1675236"/>
                <a:gd name="connsiteX4" fmla="*/ 12399 w 1284416"/>
                <a:gd name="connsiteY4" fmla="*/ 1101810 h 1675236"/>
                <a:gd name="connsiteX5" fmla="*/ 34866 w 1284416"/>
                <a:gd name="connsiteY5" fmla="*/ 876317 h 1675236"/>
                <a:gd name="connsiteX6" fmla="*/ 66424 w 1284416"/>
                <a:gd name="connsiteY6" fmla="*/ 472686 h 1675236"/>
                <a:gd name="connsiteX7" fmla="*/ 258929 w 1284416"/>
                <a:gd name="connsiteY7" fmla="*/ 164678 h 1675236"/>
                <a:gd name="connsiteX8" fmla="*/ 563598 w 1284416"/>
                <a:gd name="connsiteY8" fmla="*/ 136 h 1675236"/>
                <a:gd name="connsiteX9" fmla="*/ 869571 w 1284416"/>
                <a:gd name="connsiteY9" fmla="*/ 189303 h 1675236"/>
                <a:gd name="connsiteX10" fmla="*/ 1085032 w 1284416"/>
                <a:gd name="connsiteY10" fmla="*/ 472504 h 1675236"/>
                <a:gd name="connsiteX11" fmla="*/ 1279207 w 1284416"/>
                <a:gd name="connsiteY11" fmla="*/ 934699 h 1675236"/>
                <a:gd name="connsiteX12" fmla="*/ 1197473 w 1284416"/>
                <a:gd name="connsiteY12" fmla="*/ 1370360 h 1675236"/>
                <a:gd name="connsiteX13" fmla="*/ 873836 w 1284416"/>
                <a:gd name="connsiteY13" fmla="*/ 1546047 h 1675236"/>
                <a:gd name="connsiteX0" fmla="*/ 868660 w 1284416"/>
                <a:gd name="connsiteY0" fmla="*/ 1543490 h 1677345"/>
                <a:gd name="connsiteX1" fmla="*/ 705895 w 1284416"/>
                <a:gd name="connsiteY1" fmla="*/ 1666178 h 1677345"/>
                <a:gd name="connsiteX2" fmla="*/ 671170 w 1284416"/>
                <a:gd name="connsiteY2" fmla="*/ 1448787 h 1677345"/>
                <a:gd name="connsiteX3" fmla="*/ 416253 w 1284416"/>
                <a:gd name="connsiteY3" fmla="*/ 1168576 h 1677345"/>
                <a:gd name="connsiteX4" fmla="*/ 12399 w 1284416"/>
                <a:gd name="connsiteY4" fmla="*/ 1101810 h 1677345"/>
                <a:gd name="connsiteX5" fmla="*/ 34866 w 1284416"/>
                <a:gd name="connsiteY5" fmla="*/ 876317 h 1677345"/>
                <a:gd name="connsiteX6" fmla="*/ 66424 w 1284416"/>
                <a:gd name="connsiteY6" fmla="*/ 472686 h 1677345"/>
                <a:gd name="connsiteX7" fmla="*/ 258929 w 1284416"/>
                <a:gd name="connsiteY7" fmla="*/ 164678 h 1677345"/>
                <a:gd name="connsiteX8" fmla="*/ 563598 w 1284416"/>
                <a:gd name="connsiteY8" fmla="*/ 136 h 1677345"/>
                <a:gd name="connsiteX9" fmla="*/ 869571 w 1284416"/>
                <a:gd name="connsiteY9" fmla="*/ 189303 h 1677345"/>
                <a:gd name="connsiteX10" fmla="*/ 1085032 w 1284416"/>
                <a:gd name="connsiteY10" fmla="*/ 472504 h 1677345"/>
                <a:gd name="connsiteX11" fmla="*/ 1279207 w 1284416"/>
                <a:gd name="connsiteY11" fmla="*/ 934699 h 1677345"/>
                <a:gd name="connsiteX12" fmla="*/ 1197473 w 1284416"/>
                <a:gd name="connsiteY12" fmla="*/ 1370360 h 1677345"/>
                <a:gd name="connsiteX13" fmla="*/ 873836 w 1284416"/>
                <a:gd name="connsiteY13" fmla="*/ 1546047 h 1677345"/>
                <a:gd name="connsiteX0" fmla="*/ 868660 w 1284416"/>
                <a:gd name="connsiteY0" fmla="*/ 1543490 h 1681797"/>
                <a:gd name="connsiteX1" fmla="*/ 705895 w 1284416"/>
                <a:gd name="connsiteY1" fmla="*/ 1666178 h 1681797"/>
                <a:gd name="connsiteX2" fmla="*/ 671170 w 1284416"/>
                <a:gd name="connsiteY2" fmla="*/ 1448787 h 1681797"/>
                <a:gd name="connsiteX3" fmla="*/ 416253 w 1284416"/>
                <a:gd name="connsiteY3" fmla="*/ 1168576 h 1681797"/>
                <a:gd name="connsiteX4" fmla="*/ 12399 w 1284416"/>
                <a:gd name="connsiteY4" fmla="*/ 1101810 h 1681797"/>
                <a:gd name="connsiteX5" fmla="*/ 34866 w 1284416"/>
                <a:gd name="connsiteY5" fmla="*/ 876317 h 1681797"/>
                <a:gd name="connsiteX6" fmla="*/ 66424 w 1284416"/>
                <a:gd name="connsiteY6" fmla="*/ 472686 h 1681797"/>
                <a:gd name="connsiteX7" fmla="*/ 258929 w 1284416"/>
                <a:gd name="connsiteY7" fmla="*/ 164678 h 1681797"/>
                <a:gd name="connsiteX8" fmla="*/ 563598 w 1284416"/>
                <a:gd name="connsiteY8" fmla="*/ 136 h 1681797"/>
                <a:gd name="connsiteX9" fmla="*/ 869571 w 1284416"/>
                <a:gd name="connsiteY9" fmla="*/ 189303 h 1681797"/>
                <a:gd name="connsiteX10" fmla="*/ 1085032 w 1284416"/>
                <a:gd name="connsiteY10" fmla="*/ 472504 h 1681797"/>
                <a:gd name="connsiteX11" fmla="*/ 1279207 w 1284416"/>
                <a:gd name="connsiteY11" fmla="*/ 934699 h 1681797"/>
                <a:gd name="connsiteX12" fmla="*/ 1197473 w 1284416"/>
                <a:gd name="connsiteY12" fmla="*/ 1370360 h 1681797"/>
                <a:gd name="connsiteX13" fmla="*/ 873836 w 1284416"/>
                <a:gd name="connsiteY13" fmla="*/ 1546047 h 1681797"/>
                <a:gd name="connsiteX0" fmla="*/ 922010 w 1337766"/>
                <a:gd name="connsiteY0" fmla="*/ 1543490 h 1681797"/>
                <a:gd name="connsiteX1" fmla="*/ 759245 w 1337766"/>
                <a:gd name="connsiteY1" fmla="*/ 1666178 h 1681797"/>
                <a:gd name="connsiteX2" fmla="*/ 724520 w 1337766"/>
                <a:gd name="connsiteY2" fmla="*/ 1448787 h 1681797"/>
                <a:gd name="connsiteX3" fmla="*/ 469603 w 1337766"/>
                <a:gd name="connsiteY3" fmla="*/ 1168576 h 1681797"/>
                <a:gd name="connsiteX4" fmla="*/ 8116 w 1337766"/>
                <a:gd name="connsiteY4" fmla="*/ 953779 h 1681797"/>
                <a:gd name="connsiteX5" fmla="*/ 88216 w 1337766"/>
                <a:gd name="connsiteY5" fmla="*/ 876317 h 1681797"/>
                <a:gd name="connsiteX6" fmla="*/ 119774 w 1337766"/>
                <a:gd name="connsiteY6" fmla="*/ 472686 h 1681797"/>
                <a:gd name="connsiteX7" fmla="*/ 312279 w 1337766"/>
                <a:gd name="connsiteY7" fmla="*/ 164678 h 1681797"/>
                <a:gd name="connsiteX8" fmla="*/ 616948 w 1337766"/>
                <a:gd name="connsiteY8" fmla="*/ 136 h 1681797"/>
                <a:gd name="connsiteX9" fmla="*/ 922921 w 1337766"/>
                <a:gd name="connsiteY9" fmla="*/ 189303 h 1681797"/>
                <a:gd name="connsiteX10" fmla="*/ 1138382 w 1337766"/>
                <a:gd name="connsiteY10" fmla="*/ 472504 h 1681797"/>
                <a:gd name="connsiteX11" fmla="*/ 1332557 w 1337766"/>
                <a:gd name="connsiteY11" fmla="*/ 934699 h 1681797"/>
                <a:gd name="connsiteX12" fmla="*/ 1250823 w 1337766"/>
                <a:gd name="connsiteY12" fmla="*/ 1370360 h 1681797"/>
                <a:gd name="connsiteX13" fmla="*/ 927186 w 1337766"/>
                <a:gd name="connsiteY13" fmla="*/ 1546047 h 1681797"/>
                <a:gd name="connsiteX0" fmla="*/ 922010 w 1337766"/>
                <a:gd name="connsiteY0" fmla="*/ 1543490 h 1678599"/>
                <a:gd name="connsiteX1" fmla="*/ 813852 w 1337766"/>
                <a:gd name="connsiteY1" fmla="*/ 1662766 h 1678599"/>
                <a:gd name="connsiteX2" fmla="*/ 724520 w 1337766"/>
                <a:gd name="connsiteY2" fmla="*/ 1448787 h 1678599"/>
                <a:gd name="connsiteX3" fmla="*/ 469603 w 1337766"/>
                <a:gd name="connsiteY3" fmla="*/ 1168576 h 1678599"/>
                <a:gd name="connsiteX4" fmla="*/ 8116 w 1337766"/>
                <a:gd name="connsiteY4" fmla="*/ 953779 h 1678599"/>
                <a:gd name="connsiteX5" fmla="*/ 88216 w 1337766"/>
                <a:gd name="connsiteY5" fmla="*/ 876317 h 1678599"/>
                <a:gd name="connsiteX6" fmla="*/ 119774 w 1337766"/>
                <a:gd name="connsiteY6" fmla="*/ 472686 h 1678599"/>
                <a:gd name="connsiteX7" fmla="*/ 312279 w 1337766"/>
                <a:gd name="connsiteY7" fmla="*/ 164678 h 1678599"/>
                <a:gd name="connsiteX8" fmla="*/ 616948 w 1337766"/>
                <a:gd name="connsiteY8" fmla="*/ 136 h 1678599"/>
                <a:gd name="connsiteX9" fmla="*/ 922921 w 1337766"/>
                <a:gd name="connsiteY9" fmla="*/ 189303 h 1678599"/>
                <a:gd name="connsiteX10" fmla="*/ 1138382 w 1337766"/>
                <a:gd name="connsiteY10" fmla="*/ 472504 h 1678599"/>
                <a:gd name="connsiteX11" fmla="*/ 1332557 w 1337766"/>
                <a:gd name="connsiteY11" fmla="*/ 934699 h 1678599"/>
                <a:gd name="connsiteX12" fmla="*/ 1250823 w 1337766"/>
                <a:gd name="connsiteY12" fmla="*/ 1370360 h 1678599"/>
                <a:gd name="connsiteX13" fmla="*/ 927186 w 1337766"/>
                <a:gd name="connsiteY13" fmla="*/ 1546047 h 1678599"/>
                <a:gd name="connsiteX0" fmla="*/ 922010 w 1337766"/>
                <a:gd name="connsiteY0" fmla="*/ 1543490 h 1659570"/>
                <a:gd name="connsiteX1" fmla="*/ 819876 w 1337766"/>
                <a:gd name="connsiteY1" fmla="*/ 1642321 h 1659570"/>
                <a:gd name="connsiteX2" fmla="*/ 724520 w 1337766"/>
                <a:gd name="connsiteY2" fmla="*/ 1448787 h 1659570"/>
                <a:gd name="connsiteX3" fmla="*/ 469603 w 1337766"/>
                <a:gd name="connsiteY3" fmla="*/ 1168576 h 1659570"/>
                <a:gd name="connsiteX4" fmla="*/ 8116 w 1337766"/>
                <a:gd name="connsiteY4" fmla="*/ 953779 h 1659570"/>
                <a:gd name="connsiteX5" fmla="*/ 88216 w 1337766"/>
                <a:gd name="connsiteY5" fmla="*/ 876317 h 1659570"/>
                <a:gd name="connsiteX6" fmla="*/ 119774 w 1337766"/>
                <a:gd name="connsiteY6" fmla="*/ 472686 h 1659570"/>
                <a:gd name="connsiteX7" fmla="*/ 312279 w 1337766"/>
                <a:gd name="connsiteY7" fmla="*/ 164678 h 1659570"/>
                <a:gd name="connsiteX8" fmla="*/ 616948 w 1337766"/>
                <a:gd name="connsiteY8" fmla="*/ 136 h 1659570"/>
                <a:gd name="connsiteX9" fmla="*/ 922921 w 1337766"/>
                <a:gd name="connsiteY9" fmla="*/ 189303 h 1659570"/>
                <a:gd name="connsiteX10" fmla="*/ 1138382 w 1337766"/>
                <a:gd name="connsiteY10" fmla="*/ 472504 h 1659570"/>
                <a:gd name="connsiteX11" fmla="*/ 1332557 w 1337766"/>
                <a:gd name="connsiteY11" fmla="*/ 934699 h 1659570"/>
                <a:gd name="connsiteX12" fmla="*/ 1250823 w 1337766"/>
                <a:gd name="connsiteY12" fmla="*/ 1370360 h 1659570"/>
                <a:gd name="connsiteX13" fmla="*/ 927186 w 1337766"/>
                <a:gd name="connsiteY13" fmla="*/ 1546047 h 1659570"/>
                <a:gd name="connsiteX0" fmla="*/ 1058127 w 1473883"/>
                <a:gd name="connsiteY0" fmla="*/ 1543490 h 1659570"/>
                <a:gd name="connsiteX1" fmla="*/ 955993 w 1473883"/>
                <a:gd name="connsiteY1" fmla="*/ 1642321 h 1659570"/>
                <a:gd name="connsiteX2" fmla="*/ 860637 w 1473883"/>
                <a:gd name="connsiteY2" fmla="*/ 1448787 h 1659570"/>
                <a:gd name="connsiteX3" fmla="*/ 605720 w 1473883"/>
                <a:gd name="connsiteY3" fmla="*/ 1168576 h 1659570"/>
                <a:gd name="connsiteX4" fmla="*/ 144233 w 1473883"/>
                <a:gd name="connsiteY4" fmla="*/ 953779 h 1659570"/>
                <a:gd name="connsiteX5" fmla="*/ 247 w 1473883"/>
                <a:gd name="connsiteY5" fmla="*/ 767676 h 1659570"/>
                <a:gd name="connsiteX6" fmla="*/ 255891 w 1473883"/>
                <a:gd name="connsiteY6" fmla="*/ 472686 h 1659570"/>
                <a:gd name="connsiteX7" fmla="*/ 448396 w 1473883"/>
                <a:gd name="connsiteY7" fmla="*/ 164678 h 1659570"/>
                <a:gd name="connsiteX8" fmla="*/ 753065 w 1473883"/>
                <a:gd name="connsiteY8" fmla="*/ 136 h 1659570"/>
                <a:gd name="connsiteX9" fmla="*/ 1059038 w 1473883"/>
                <a:gd name="connsiteY9" fmla="*/ 189303 h 1659570"/>
                <a:gd name="connsiteX10" fmla="*/ 1274499 w 1473883"/>
                <a:gd name="connsiteY10" fmla="*/ 472504 h 1659570"/>
                <a:gd name="connsiteX11" fmla="*/ 1468674 w 1473883"/>
                <a:gd name="connsiteY11" fmla="*/ 934699 h 1659570"/>
                <a:gd name="connsiteX12" fmla="*/ 1386940 w 1473883"/>
                <a:gd name="connsiteY12" fmla="*/ 1370360 h 1659570"/>
                <a:gd name="connsiteX13" fmla="*/ 1063303 w 1473883"/>
                <a:gd name="connsiteY13" fmla="*/ 1546047 h 1659570"/>
                <a:gd name="connsiteX0" fmla="*/ 1062585 w 1478341"/>
                <a:gd name="connsiteY0" fmla="*/ 1543490 h 1659570"/>
                <a:gd name="connsiteX1" fmla="*/ 960451 w 1478341"/>
                <a:gd name="connsiteY1" fmla="*/ 1642321 h 1659570"/>
                <a:gd name="connsiteX2" fmla="*/ 865095 w 1478341"/>
                <a:gd name="connsiteY2" fmla="*/ 1448787 h 1659570"/>
                <a:gd name="connsiteX3" fmla="*/ 610178 w 1478341"/>
                <a:gd name="connsiteY3" fmla="*/ 1168576 h 1659570"/>
                <a:gd name="connsiteX4" fmla="*/ 18756 w 1478341"/>
                <a:gd name="connsiteY4" fmla="*/ 866332 h 1659570"/>
                <a:gd name="connsiteX5" fmla="*/ 4705 w 1478341"/>
                <a:gd name="connsiteY5" fmla="*/ 767676 h 1659570"/>
                <a:gd name="connsiteX6" fmla="*/ 260349 w 1478341"/>
                <a:gd name="connsiteY6" fmla="*/ 472686 h 1659570"/>
                <a:gd name="connsiteX7" fmla="*/ 452854 w 1478341"/>
                <a:gd name="connsiteY7" fmla="*/ 164678 h 1659570"/>
                <a:gd name="connsiteX8" fmla="*/ 757523 w 1478341"/>
                <a:gd name="connsiteY8" fmla="*/ 136 h 1659570"/>
                <a:gd name="connsiteX9" fmla="*/ 1063496 w 1478341"/>
                <a:gd name="connsiteY9" fmla="*/ 189303 h 1659570"/>
                <a:gd name="connsiteX10" fmla="*/ 1278957 w 1478341"/>
                <a:gd name="connsiteY10" fmla="*/ 472504 h 1659570"/>
                <a:gd name="connsiteX11" fmla="*/ 1473132 w 1478341"/>
                <a:gd name="connsiteY11" fmla="*/ 934699 h 1659570"/>
                <a:gd name="connsiteX12" fmla="*/ 1391398 w 1478341"/>
                <a:gd name="connsiteY12" fmla="*/ 1370360 h 1659570"/>
                <a:gd name="connsiteX13" fmla="*/ 1067761 w 1478341"/>
                <a:gd name="connsiteY13" fmla="*/ 1546047 h 1659570"/>
                <a:gd name="connsiteX0" fmla="*/ 1058128 w 1473884"/>
                <a:gd name="connsiteY0" fmla="*/ 1543490 h 1659570"/>
                <a:gd name="connsiteX1" fmla="*/ 955994 w 1473884"/>
                <a:gd name="connsiteY1" fmla="*/ 1642321 h 1659570"/>
                <a:gd name="connsiteX2" fmla="*/ 860638 w 1473884"/>
                <a:gd name="connsiteY2" fmla="*/ 1448787 h 1659570"/>
                <a:gd name="connsiteX3" fmla="*/ 605721 w 1473884"/>
                <a:gd name="connsiteY3" fmla="*/ 1168576 h 1659570"/>
                <a:gd name="connsiteX4" fmla="*/ 35760 w 1473884"/>
                <a:gd name="connsiteY4" fmla="*/ 813704 h 1659570"/>
                <a:gd name="connsiteX5" fmla="*/ 248 w 1473884"/>
                <a:gd name="connsiteY5" fmla="*/ 767676 h 1659570"/>
                <a:gd name="connsiteX6" fmla="*/ 255892 w 1473884"/>
                <a:gd name="connsiteY6" fmla="*/ 472686 h 1659570"/>
                <a:gd name="connsiteX7" fmla="*/ 448397 w 1473884"/>
                <a:gd name="connsiteY7" fmla="*/ 164678 h 1659570"/>
                <a:gd name="connsiteX8" fmla="*/ 753066 w 1473884"/>
                <a:gd name="connsiteY8" fmla="*/ 136 h 1659570"/>
                <a:gd name="connsiteX9" fmla="*/ 1059039 w 1473884"/>
                <a:gd name="connsiteY9" fmla="*/ 189303 h 1659570"/>
                <a:gd name="connsiteX10" fmla="*/ 1274500 w 1473884"/>
                <a:gd name="connsiteY10" fmla="*/ 472504 h 1659570"/>
                <a:gd name="connsiteX11" fmla="*/ 1468675 w 1473884"/>
                <a:gd name="connsiteY11" fmla="*/ 934699 h 1659570"/>
                <a:gd name="connsiteX12" fmla="*/ 1386941 w 1473884"/>
                <a:gd name="connsiteY12" fmla="*/ 1370360 h 1659570"/>
                <a:gd name="connsiteX13" fmla="*/ 1063304 w 1473884"/>
                <a:gd name="connsiteY13" fmla="*/ 1546047 h 1659570"/>
                <a:gd name="connsiteX0" fmla="*/ 1058128 w 1473884"/>
                <a:gd name="connsiteY0" fmla="*/ 1543490 h 1659570"/>
                <a:gd name="connsiteX1" fmla="*/ 955994 w 1473884"/>
                <a:gd name="connsiteY1" fmla="*/ 1642321 h 1659570"/>
                <a:gd name="connsiteX2" fmla="*/ 860638 w 1473884"/>
                <a:gd name="connsiteY2" fmla="*/ 1448787 h 1659570"/>
                <a:gd name="connsiteX3" fmla="*/ 605721 w 1473884"/>
                <a:gd name="connsiteY3" fmla="*/ 1168576 h 1659570"/>
                <a:gd name="connsiteX4" fmla="*/ 35760 w 1473884"/>
                <a:gd name="connsiteY4" fmla="*/ 813704 h 1659570"/>
                <a:gd name="connsiteX5" fmla="*/ 248 w 1473884"/>
                <a:gd name="connsiteY5" fmla="*/ 767676 h 1659570"/>
                <a:gd name="connsiteX6" fmla="*/ 255892 w 1473884"/>
                <a:gd name="connsiteY6" fmla="*/ 472686 h 1659570"/>
                <a:gd name="connsiteX7" fmla="*/ 448397 w 1473884"/>
                <a:gd name="connsiteY7" fmla="*/ 164678 h 1659570"/>
                <a:gd name="connsiteX8" fmla="*/ 753066 w 1473884"/>
                <a:gd name="connsiteY8" fmla="*/ 136 h 1659570"/>
                <a:gd name="connsiteX9" fmla="*/ 1059039 w 1473884"/>
                <a:gd name="connsiteY9" fmla="*/ 189303 h 1659570"/>
                <a:gd name="connsiteX10" fmla="*/ 1274500 w 1473884"/>
                <a:gd name="connsiteY10" fmla="*/ 472504 h 1659570"/>
                <a:gd name="connsiteX11" fmla="*/ 1468675 w 1473884"/>
                <a:gd name="connsiteY11" fmla="*/ 934699 h 1659570"/>
                <a:gd name="connsiteX12" fmla="*/ 1386941 w 1473884"/>
                <a:gd name="connsiteY12" fmla="*/ 1370360 h 1659570"/>
                <a:gd name="connsiteX13" fmla="*/ 1063304 w 1473884"/>
                <a:gd name="connsiteY13" fmla="*/ 1546047 h 1659570"/>
                <a:gd name="connsiteX0" fmla="*/ 1041537 w 1457293"/>
                <a:gd name="connsiteY0" fmla="*/ 1543490 h 1659570"/>
                <a:gd name="connsiteX1" fmla="*/ 939403 w 1457293"/>
                <a:gd name="connsiteY1" fmla="*/ 1642321 h 1659570"/>
                <a:gd name="connsiteX2" fmla="*/ 844047 w 1457293"/>
                <a:gd name="connsiteY2" fmla="*/ 1448787 h 1659570"/>
                <a:gd name="connsiteX3" fmla="*/ 589130 w 1457293"/>
                <a:gd name="connsiteY3" fmla="*/ 1168576 h 1659570"/>
                <a:gd name="connsiteX4" fmla="*/ 19169 w 1457293"/>
                <a:gd name="connsiteY4" fmla="*/ 813704 h 1659570"/>
                <a:gd name="connsiteX5" fmla="*/ 3614 w 1457293"/>
                <a:gd name="connsiteY5" fmla="*/ 731706 h 1659570"/>
                <a:gd name="connsiteX6" fmla="*/ 239301 w 1457293"/>
                <a:gd name="connsiteY6" fmla="*/ 472686 h 1659570"/>
                <a:gd name="connsiteX7" fmla="*/ 431806 w 1457293"/>
                <a:gd name="connsiteY7" fmla="*/ 164678 h 1659570"/>
                <a:gd name="connsiteX8" fmla="*/ 736475 w 1457293"/>
                <a:gd name="connsiteY8" fmla="*/ 136 h 1659570"/>
                <a:gd name="connsiteX9" fmla="*/ 1042448 w 1457293"/>
                <a:gd name="connsiteY9" fmla="*/ 189303 h 1659570"/>
                <a:gd name="connsiteX10" fmla="*/ 1257909 w 1457293"/>
                <a:gd name="connsiteY10" fmla="*/ 472504 h 1659570"/>
                <a:gd name="connsiteX11" fmla="*/ 1452084 w 1457293"/>
                <a:gd name="connsiteY11" fmla="*/ 934699 h 1659570"/>
                <a:gd name="connsiteX12" fmla="*/ 1370350 w 1457293"/>
                <a:gd name="connsiteY12" fmla="*/ 1370360 h 1659570"/>
                <a:gd name="connsiteX13" fmla="*/ 1046713 w 1457293"/>
                <a:gd name="connsiteY13" fmla="*/ 1546047 h 1659570"/>
                <a:gd name="connsiteX0" fmla="*/ 1041537 w 1457293"/>
                <a:gd name="connsiteY0" fmla="*/ 1543490 h 1659570"/>
                <a:gd name="connsiteX1" fmla="*/ 939403 w 1457293"/>
                <a:gd name="connsiteY1" fmla="*/ 1642321 h 1659570"/>
                <a:gd name="connsiteX2" fmla="*/ 844047 w 1457293"/>
                <a:gd name="connsiteY2" fmla="*/ 1448787 h 1659570"/>
                <a:gd name="connsiteX3" fmla="*/ 589130 w 1457293"/>
                <a:gd name="connsiteY3" fmla="*/ 1168576 h 1659570"/>
                <a:gd name="connsiteX4" fmla="*/ 19169 w 1457293"/>
                <a:gd name="connsiteY4" fmla="*/ 813704 h 1659570"/>
                <a:gd name="connsiteX5" fmla="*/ 3614 w 1457293"/>
                <a:gd name="connsiteY5" fmla="*/ 731706 h 1659570"/>
                <a:gd name="connsiteX6" fmla="*/ 239301 w 1457293"/>
                <a:gd name="connsiteY6" fmla="*/ 472686 h 1659570"/>
                <a:gd name="connsiteX7" fmla="*/ 431806 w 1457293"/>
                <a:gd name="connsiteY7" fmla="*/ 164678 h 1659570"/>
                <a:gd name="connsiteX8" fmla="*/ 736475 w 1457293"/>
                <a:gd name="connsiteY8" fmla="*/ 136 h 1659570"/>
                <a:gd name="connsiteX9" fmla="*/ 1042448 w 1457293"/>
                <a:gd name="connsiteY9" fmla="*/ 189303 h 1659570"/>
                <a:gd name="connsiteX10" fmla="*/ 1257909 w 1457293"/>
                <a:gd name="connsiteY10" fmla="*/ 472504 h 1659570"/>
                <a:gd name="connsiteX11" fmla="*/ 1452084 w 1457293"/>
                <a:gd name="connsiteY11" fmla="*/ 934699 h 1659570"/>
                <a:gd name="connsiteX12" fmla="*/ 1370350 w 1457293"/>
                <a:gd name="connsiteY12" fmla="*/ 1370360 h 1659570"/>
                <a:gd name="connsiteX13" fmla="*/ 1046713 w 1457293"/>
                <a:gd name="connsiteY13" fmla="*/ 1546047 h 1659570"/>
                <a:gd name="connsiteX0" fmla="*/ 1041537 w 1457293"/>
                <a:gd name="connsiteY0" fmla="*/ 1543480 h 1659560"/>
                <a:gd name="connsiteX1" fmla="*/ 939403 w 1457293"/>
                <a:gd name="connsiteY1" fmla="*/ 1642311 h 1659560"/>
                <a:gd name="connsiteX2" fmla="*/ 844047 w 1457293"/>
                <a:gd name="connsiteY2" fmla="*/ 1448777 h 1659560"/>
                <a:gd name="connsiteX3" fmla="*/ 589130 w 1457293"/>
                <a:gd name="connsiteY3" fmla="*/ 1168566 h 1659560"/>
                <a:gd name="connsiteX4" fmla="*/ 19169 w 1457293"/>
                <a:gd name="connsiteY4" fmla="*/ 813694 h 1659560"/>
                <a:gd name="connsiteX5" fmla="*/ 3614 w 1457293"/>
                <a:gd name="connsiteY5" fmla="*/ 731696 h 1659560"/>
                <a:gd name="connsiteX6" fmla="*/ 147406 w 1457293"/>
                <a:gd name="connsiteY6" fmla="*/ 426493 h 1659560"/>
                <a:gd name="connsiteX7" fmla="*/ 431806 w 1457293"/>
                <a:gd name="connsiteY7" fmla="*/ 164668 h 1659560"/>
                <a:gd name="connsiteX8" fmla="*/ 736475 w 1457293"/>
                <a:gd name="connsiteY8" fmla="*/ 126 h 1659560"/>
                <a:gd name="connsiteX9" fmla="*/ 1042448 w 1457293"/>
                <a:gd name="connsiteY9" fmla="*/ 189293 h 1659560"/>
                <a:gd name="connsiteX10" fmla="*/ 1257909 w 1457293"/>
                <a:gd name="connsiteY10" fmla="*/ 472494 h 1659560"/>
                <a:gd name="connsiteX11" fmla="*/ 1452084 w 1457293"/>
                <a:gd name="connsiteY11" fmla="*/ 934689 h 1659560"/>
                <a:gd name="connsiteX12" fmla="*/ 1370350 w 1457293"/>
                <a:gd name="connsiteY12" fmla="*/ 1370350 h 1659560"/>
                <a:gd name="connsiteX13" fmla="*/ 1046713 w 1457293"/>
                <a:gd name="connsiteY13" fmla="*/ 1546037 h 1659560"/>
                <a:gd name="connsiteX0" fmla="*/ 1041537 w 1457293"/>
                <a:gd name="connsiteY0" fmla="*/ 1544658 h 1660738"/>
                <a:gd name="connsiteX1" fmla="*/ 939403 w 1457293"/>
                <a:gd name="connsiteY1" fmla="*/ 1643489 h 1660738"/>
                <a:gd name="connsiteX2" fmla="*/ 844047 w 1457293"/>
                <a:gd name="connsiteY2" fmla="*/ 1449955 h 1660738"/>
                <a:gd name="connsiteX3" fmla="*/ 589130 w 1457293"/>
                <a:gd name="connsiteY3" fmla="*/ 1169744 h 1660738"/>
                <a:gd name="connsiteX4" fmla="*/ 19169 w 1457293"/>
                <a:gd name="connsiteY4" fmla="*/ 814872 h 1660738"/>
                <a:gd name="connsiteX5" fmla="*/ 3614 w 1457293"/>
                <a:gd name="connsiteY5" fmla="*/ 732874 h 1660738"/>
                <a:gd name="connsiteX6" fmla="*/ 147406 w 1457293"/>
                <a:gd name="connsiteY6" fmla="*/ 427671 h 1660738"/>
                <a:gd name="connsiteX7" fmla="*/ 381338 w 1457293"/>
                <a:gd name="connsiteY7" fmla="*/ 123446 h 1660738"/>
                <a:gd name="connsiteX8" fmla="*/ 736475 w 1457293"/>
                <a:gd name="connsiteY8" fmla="*/ 1304 h 1660738"/>
                <a:gd name="connsiteX9" fmla="*/ 1042448 w 1457293"/>
                <a:gd name="connsiteY9" fmla="*/ 190471 h 1660738"/>
                <a:gd name="connsiteX10" fmla="*/ 1257909 w 1457293"/>
                <a:gd name="connsiteY10" fmla="*/ 473672 h 1660738"/>
                <a:gd name="connsiteX11" fmla="*/ 1452084 w 1457293"/>
                <a:gd name="connsiteY11" fmla="*/ 935867 h 1660738"/>
                <a:gd name="connsiteX12" fmla="*/ 1370350 w 1457293"/>
                <a:gd name="connsiteY12" fmla="*/ 1371528 h 1660738"/>
                <a:gd name="connsiteX13" fmla="*/ 1046713 w 1457293"/>
                <a:gd name="connsiteY13" fmla="*/ 1547215 h 1660738"/>
                <a:gd name="connsiteX0" fmla="*/ 1043098 w 1458854"/>
                <a:gd name="connsiteY0" fmla="*/ 1544658 h 1660738"/>
                <a:gd name="connsiteX1" fmla="*/ 940964 w 1458854"/>
                <a:gd name="connsiteY1" fmla="*/ 1643489 h 1660738"/>
                <a:gd name="connsiteX2" fmla="*/ 845608 w 1458854"/>
                <a:gd name="connsiteY2" fmla="*/ 1449955 h 1660738"/>
                <a:gd name="connsiteX3" fmla="*/ 590691 w 1458854"/>
                <a:gd name="connsiteY3" fmla="*/ 1169744 h 1660738"/>
                <a:gd name="connsiteX4" fmla="*/ 20730 w 1458854"/>
                <a:gd name="connsiteY4" fmla="*/ 814872 h 1660738"/>
                <a:gd name="connsiteX5" fmla="*/ 148967 w 1458854"/>
                <a:gd name="connsiteY5" fmla="*/ 427671 h 1660738"/>
                <a:gd name="connsiteX6" fmla="*/ 382899 w 1458854"/>
                <a:gd name="connsiteY6" fmla="*/ 123446 h 1660738"/>
                <a:gd name="connsiteX7" fmla="*/ 738036 w 1458854"/>
                <a:gd name="connsiteY7" fmla="*/ 1304 h 1660738"/>
                <a:gd name="connsiteX8" fmla="*/ 1044009 w 1458854"/>
                <a:gd name="connsiteY8" fmla="*/ 190471 h 1660738"/>
                <a:gd name="connsiteX9" fmla="*/ 1259470 w 1458854"/>
                <a:gd name="connsiteY9" fmla="*/ 473672 h 1660738"/>
                <a:gd name="connsiteX10" fmla="*/ 1453645 w 1458854"/>
                <a:gd name="connsiteY10" fmla="*/ 935867 h 1660738"/>
                <a:gd name="connsiteX11" fmla="*/ 1371911 w 1458854"/>
                <a:gd name="connsiteY11" fmla="*/ 1371528 h 1660738"/>
                <a:gd name="connsiteX12" fmla="*/ 1048274 w 1458854"/>
                <a:gd name="connsiteY12" fmla="*/ 1547215 h 1660738"/>
                <a:gd name="connsiteX0" fmla="*/ 1043098 w 1458854"/>
                <a:gd name="connsiteY0" fmla="*/ 1544658 h 1660738"/>
                <a:gd name="connsiteX1" fmla="*/ 940964 w 1458854"/>
                <a:gd name="connsiteY1" fmla="*/ 1643489 h 1660738"/>
                <a:gd name="connsiteX2" fmla="*/ 845608 w 1458854"/>
                <a:gd name="connsiteY2" fmla="*/ 1449955 h 1660738"/>
                <a:gd name="connsiteX3" fmla="*/ 590691 w 1458854"/>
                <a:gd name="connsiteY3" fmla="*/ 1169744 h 1660738"/>
                <a:gd name="connsiteX4" fmla="*/ 20730 w 1458854"/>
                <a:gd name="connsiteY4" fmla="*/ 814872 h 1660738"/>
                <a:gd name="connsiteX5" fmla="*/ 148967 w 1458854"/>
                <a:gd name="connsiteY5" fmla="*/ 427671 h 1660738"/>
                <a:gd name="connsiteX6" fmla="*/ 382899 w 1458854"/>
                <a:gd name="connsiteY6" fmla="*/ 123446 h 1660738"/>
                <a:gd name="connsiteX7" fmla="*/ 738036 w 1458854"/>
                <a:gd name="connsiteY7" fmla="*/ 1304 h 1660738"/>
                <a:gd name="connsiteX8" fmla="*/ 1044009 w 1458854"/>
                <a:gd name="connsiteY8" fmla="*/ 190471 h 1660738"/>
                <a:gd name="connsiteX9" fmla="*/ 1259470 w 1458854"/>
                <a:gd name="connsiteY9" fmla="*/ 473672 h 1660738"/>
                <a:gd name="connsiteX10" fmla="*/ 1453645 w 1458854"/>
                <a:gd name="connsiteY10" fmla="*/ 935867 h 1660738"/>
                <a:gd name="connsiteX11" fmla="*/ 1371911 w 1458854"/>
                <a:gd name="connsiteY11" fmla="*/ 1371528 h 1660738"/>
                <a:gd name="connsiteX12" fmla="*/ 1048274 w 1458854"/>
                <a:gd name="connsiteY12" fmla="*/ 1547215 h 1660738"/>
                <a:gd name="connsiteX0" fmla="*/ 1022497 w 1438253"/>
                <a:gd name="connsiteY0" fmla="*/ 1544658 h 1660738"/>
                <a:gd name="connsiteX1" fmla="*/ 920363 w 1438253"/>
                <a:gd name="connsiteY1" fmla="*/ 1643489 h 1660738"/>
                <a:gd name="connsiteX2" fmla="*/ 825007 w 1438253"/>
                <a:gd name="connsiteY2" fmla="*/ 1449955 h 1660738"/>
                <a:gd name="connsiteX3" fmla="*/ 570090 w 1438253"/>
                <a:gd name="connsiteY3" fmla="*/ 1169744 h 1660738"/>
                <a:gd name="connsiteX4" fmla="*/ 129 w 1438253"/>
                <a:gd name="connsiteY4" fmla="*/ 814872 h 1660738"/>
                <a:gd name="connsiteX5" fmla="*/ 128366 w 1438253"/>
                <a:gd name="connsiteY5" fmla="*/ 427671 h 1660738"/>
                <a:gd name="connsiteX6" fmla="*/ 362298 w 1438253"/>
                <a:gd name="connsiteY6" fmla="*/ 123446 h 1660738"/>
                <a:gd name="connsiteX7" fmla="*/ 717435 w 1438253"/>
                <a:gd name="connsiteY7" fmla="*/ 1304 h 1660738"/>
                <a:gd name="connsiteX8" fmla="*/ 1023408 w 1438253"/>
                <a:gd name="connsiteY8" fmla="*/ 190471 h 1660738"/>
                <a:gd name="connsiteX9" fmla="*/ 1238869 w 1438253"/>
                <a:gd name="connsiteY9" fmla="*/ 473672 h 1660738"/>
                <a:gd name="connsiteX10" fmla="*/ 1433044 w 1438253"/>
                <a:gd name="connsiteY10" fmla="*/ 935867 h 1660738"/>
                <a:gd name="connsiteX11" fmla="*/ 1351310 w 1438253"/>
                <a:gd name="connsiteY11" fmla="*/ 1371528 h 1660738"/>
                <a:gd name="connsiteX12" fmla="*/ 1027673 w 1438253"/>
                <a:gd name="connsiteY12" fmla="*/ 1547215 h 1660738"/>
                <a:gd name="connsiteX0" fmla="*/ 1024359 w 1440115"/>
                <a:gd name="connsiteY0" fmla="*/ 1544658 h 1660738"/>
                <a:gd name="connsiteX1" fmla="*/ 922225 w 1440115"/>
                <a:gd name="connsiteY1" fmla="*/ 1643489 h 1660738"/>
                <a:gd name="connsiteX2" fmla="*/ 826869 w 1440115"/>
                <a:gd name="connsiteY2" fmla="*/ 1449955 h 1660738"/>
                <a:gd name="connsiteX3" fmla="*/ 571952 w 1440115"/>
                <a:gd name="connsiteY3" fmla="*/ 1169744 h 1660738"/>
                <a:gd name="connsiteX4" fmla="*/ 1991 w 1440115"/>
                <a:gd name="connsiteY4" fmla="*/ 814872 h 1660738"/>
                <a:gd name="connsiteX5" fmla="*/ 130228 w 1440115"/>
                <a:gd name="connsiteY5" fmla="*/ 427671 h 1660738"/>
                <a:gd name="connsiteX6" fmla="*/ 364160 w 1440115"/>
                <a:gd name="connsiteY6" fmla="*/ 123446 h 1660738"/>
                <a:gd name="connsiteX7" fmla="*/ 719297 w 1440115"/>
                <a:gd name="connsiteY7" fmla="*/ 1304 h 1660738"/>
                <a:gd name="connsiteX8" fmla="*/ 1025270 w 1440115"/>
                <a:gd name="connsiteY8" fmla="*/ 190471 h 1660738"/>
                <a:gd name="connsiteX9" fmla="*/ 1240731 w 1440115"/>
                <a:gd name="connsiteY9" fmla="*/ 473672 h 1660738"/>
                <a:gd name="connsiteX10" fmla="*/ 1434906 w 1440115"/>
                <a:gd name="connsiteY10" fmla="*/ 935867 h 1660738"/>
                <a:gd name="connsiteX11" fmla="*/ 1353172 w 1440115"/>
                <a:gd name="connsiteY11" fmla="*/ 1371528 h 1660738"/>
                <a:gd name="connsiteX12" fmla="*/ 1029535 w 1440115"/>
                <a:gd name="connsiteY12" fmla="*/ 1547215 h 1660738"/>
                <a:gd name="connsiteX0" fmla="*/ 1024359 w 1440115"/>
                <a:gd name="connsiteY0" fmla="*/ 1544658 h 1660738"/>
                <a:gd name="connsiteX1" fmla="*/ 922225 w 1440115"/>
                <a:gd name="connsiteY1" fmla="*/ 1643489 h 1660738"/>
                <a:gd name="connsiteX2" fmla="*/ 826869 w 1440115"/>
                <a:gd name="connsiteY2" fmla="*/ 1449955 h 1660738"/>
                <a:gd name="connsiteX3" fmla="*/ 571952 w 1440115"/>
                <a:gd name="connsiteY3" fmla="*/ 1169744 h 1660738"/>
                <a:gd name="connsiteX4" fmla="*/ 1991 w 1440115"/>
                <a:gd name="connsiteY4" fmla="*/ 814872 h 1660738"/>
                <a:gd name="connsiteX5" fmla="*/ 130228 w 1440115"/>
                <a:gd name="connsiteY5" fmla="*/ 427671 h 1660738"/>
                <a:gd name="connsiteX6" fmla="*/ 364160 w 1440115"/>
                <a:gd name="connsiteY6" fmla="*/ 123446 h 1660738"/>
                <a:gd name="connsiteX7" fmla="*/ 719297 w 1440115"/>
                <a:gd name="connsiteY7" fmla="*/ 1304 h 1660738"/>
                <a:gd name="connsiteX8" fmla="*/ 1025270 w 1440115"/>
                <a:gd name="connsiteY8" fmla="*/ 190471 h 1660738"/>
                <a:gd name="connsiteX9" fmla="*/ 1240731 w 1440115"/>
                <a:gd name="connsiteY9" fmla="*/ 473672 h 1660738"/>
                <a:gd name="connsiteX10" fmla="*/ 1434906 w 1440115"/>
                <a:gd name="connsiteY10" fmla="*/ 935867 h 1660738"/>
                <a:gd name="connsiteX11" fmla="*/ 1353172 w 1440115"/>
                <a:gd name="connsiteY11" fmla="*/ 1371528 h 1660738"/>
                <a:gd name="connsiteX12" fmla="*/ 1029535 w 1440115"/>
                <a:gd name="connsiteY12" fmla="*/ 1547215 h 1660738"/>
                <a:gd name="connsiteX13" fmla="*/ 1024359 w 1440115"/>
                <a:gd name="connsiteY13" fmla="*/ 1544658 h 1660738"/>
                <a:gd name="connsiteX0" fmla="*/ 1029535 w 1440115"/>
                <a:gd name="connsiteY0" fmla="*/ 1547215 h 1643489"/>
                <a:gd name="connsiteX1" fmla="*/ 922225 w 1440115"/>
                <a:gd name="connsiteY1" fmla="*/ 1643489 h 1643489"/>
                <a:gd name="connsiteX2" fmla="*/ 826869 w 1440115"/>
                <a:gd name="connsiteY2" fmla="*/ 1449955 h 1643489"/>
                <a:gd name="connsiteX3" fmla="*/ 571952 w 1440115"/>
                <a:gd name="connsiteY3" fmla="*/ 1169744 h 1643489"/>
                <a:gd name="connsiteX4" fmla="*/ 1991 w 1440115"/>
                <a:gd name="connsiteY4" fmla="*/ 814872 h 1643489"/>
                <a:gd name="connsiteX5" fmla="*/ 130228 w 1440115"/>
                <a:gd name="connsiteY5" fmla="*/ 427671 h 1643489"/>
                <a:gd name="connsiteX6" fmla="*/ 364160 w 1440115"/>
                <a:gd name="connsiteY6" fmla="*/ 123446 h 1643489"/>
                <a:gd name="connsiteX7" fmla="*/ 719297 w 1440115"/>
                <a:gd name="connsiteY7" fmla="*/ 1304 h 1643489"/>
                <a:gd name="connsiteX8" fmla="*/ 1025270 w 1440115"/>
                <a:gd name="connsiteY8" fmla="*/ 190471 h 1643489"/>
                <a:gd name="connsiteX9" fmla="*/ 1240731 w 1440115"/>
                <a:gd name="connsiteY9" fmla="*/ 473672 h 1643489"/>
                <a:gd name="connsiteX10" fmla="*/ 1434906 w 1440115"/>
                <a:gd name="connsiteY10" fmla="*/ 935867 h 1643489"/>
                <a:gd name="connsiteX11" fmla="*/ 1353172 w 1440115"/>
                <a:gd name="connsiteY11" fmla="*/ 1371528 h 1643489"/>
                <a:gd name="connsiteX12" fmla="*/ 1029535 w 1440115"/>
                <a:gd name="connsiteY12" fmla="*/ 1547215 h 1643489"/>
                <a:gd name="connsiteX0" fmla="*/ 1353172 w 1442060"/>
                <a:gd name="connsiteY0" fmla="*/ 1371528 h 1644419"/>
                <a:gd name="connsiteX1" fmla="*/ 922225 w 1442060"/>
                <a:gd name="connsiteY1" fmla="*/ 1643489 h 1644419"/>
                <a:gd name="connsiteX2" fmla="*/ 826869 w 1442060"/>
                <a:gd name="connsiteY2" fmla="*/ 1449955 h 1644419"/>
                <a:gd name="connsiteX3" fmla="*/ 571952 w 1442060"/>
                <a:gd name="connsiteY3" fmla="*/ 1169744 h 1644419"/>
                <a:gd name="connsiteX4" fmla="*/ 1991 w 1442060"/>
                <a:gd name="connsiteY4" fmla="*/ 814872 h 1644419"/>
                <a:gd name="connsiteX5" fmla="*/ 130228 w 1442060"/>
                <a:gd name="connsiteY5" fmla="*/ 427671 h 1644419"/>
                <a:gd name="connsiteX6" fmla="*/ 364160 w 1442060"/>
                <a:gd name="connsiteY6" fmla="*/ 123446 h 1644419"/>
                <a:gd name="connsiteX7" fmla="*/ 719297 w 1442060"/>
                <a:gd name="connsiteY7" fmla="*/ 1304 h 1644419"/>
                <a:gd name="connsiteX8" fmla="*/ 1025270 w 1442060"/>
                <a:gd name="connsiteY8" fmla="*/ 190471 h 1644419"/>
                <a:gd name="connsiteX9" fmla="*/ 1240731 w 1442060"/>
                <a:gd name="connsiteY9" fmla="*/ 473672 h 1644419"/>
                <a:gd name="connsiteX10" fmla="*/ 1434906 w 1442060"/>
                <a:gd name="connsiteY10" fmla="*/ 935867 h 1644419"/>
                <a:gd name="connsiteX11" fmla="*/ 1353172 w 1442060"/>
                <a:gd name="connsiteY11" fmla="*/ 1371528 h 1644419"/>
                <a:gd name="connsiteX0" fmla="*/ 1353172 w 1442060"/>
                <a:gd name="connsiteY0" fmla="*/ 1371528 h 1631621"/>
                <a:gd name="connsiteX1" fmla="*/ 965156 w 1442060"/>
                <a:gd name="connsiteY1" fmla="*/ 1630613 h 1631621"/>
                <a:gd name="connsiteX2" fmla="*/ 826869 w 1442060"/>
                <a:gd name="connsiteY2" fmla="*/ 1449955 h 1631621"/>
                <a:gd name="connsiteX3" fmla="*/ 571952 w 1442060"/>
                <a:gd name="connsiteY3" fmla="*/ 1169744 h 1631621"/>
                <a:gd name="connsiteX4" fmla="*/ 1991 w 1442060"/>
                <a:gd name="connsiteY4" fmla="*/ 814872 h 1631621"/>
                <a:gd name="connsiteX5" fmla="*/ 130228 w 1442060"/>
                <a:gd name="connsiteY5" fmla="*/ 427671 h 1631621"/>
                <a:gd name="connsiteX6" fmla="*/ 364160 w 1442060"/>
                <a:gd name="connsiteY6" fmla="*/ 123446 h 1631621"/>
                <a:gd name="connsiteX7" fmla="*/ 719297 w 1442060"/>
                <a:gd name="connsiteY7" fmla="*/ 1304 h 1631621"/>
                <a:gd name="connsiteX8" fmla="*/ 1025270 w 1442060"/>
                <a:gd name="connsiteY8" fmla="*/ 190471 h 1631621"/>
                <a:gd name="connsiteX9" fmla="*/ 1240731 w 1442060"/>
                <a:gd name="connsiteY9" fmla="*/ 473672 h 1631621"/>
                <a:gd name="connsiteX10" fmla="*/ 1434906 w 1442060"/>
                <a:gd name="connsiteY10" fmla="*/ 935867 h 1631621"/>
                <a:gd name="connsiteX11" fmla="*/ 1353172 w 1442060"/>
                <a:gd name="connsiteY11" fmla="*/ 1371528 h 1631621"/>
                <a:gd name="connsiteX0" fmla="*/ 1353172 w 1442060"/>
                <a:gd name="connsiteY0" fmla="*/ 1371528 h 1633876"/>
                <a:gd name="connsiteX1" fmla="*/ 990013 w 1442060"/>
                <a:gd name="connsiteY1" fmla="*/ 1632883 h 1633876"/>
                <a:gd name="connsiteX2" fmla="*/ 826869 w 1442060"/>
                <a:gd name="connsiteY2" fmla="*/ 1449955 h 1633876"/>
                <a:gd name="connsiteX3" fmla="*/ 571952 w 1442060"/>
                <a:gd name="connsiteY3" fmla="*/ 1169744 h 1633876"/>
                <a:gd name="connsiteX4" fmla="*/ 1991 w 1442060"/>
                <a:gd name="connsiteY4" fmla="*/ 814872 h 1633876"/>
                <a:gd name="connsiteX5" fmla="*/ 130228 w 1442060"/>
                <a:gd name="connsiteY5" fmla="*/ 427671 h 1633876"/>
                <a:gd name="connsiteX6" fmla="*/ 364160 w 1442060"/>
                <a:gd name="connsiteY6" fmla="*/ 123446 h 1633876"/>
                <a:gd name="connsiteX7" fmla="*/ 719297 w 1442060"/>
                <a:gd name="connsiteY7" fmla="*/ 1304 h 1633876"/>
                <a:gd name="connsiteX8" fmla="*/ 1025270 w 1442060"/>
                <a:gd name="connsiteY8" fmla="*/ 190471 h 1633876"/>
                <a:gd name="connsiteX9" fmla="*/ 1240731 w 1442060"/>
                <a:gd name="connsiteY9" fmla="*/ 473672 h 1633876"/>
                <a:gd name="connsiteX10" fmla="*/ 1434906 w 1442060"/>
                <a:gd name="connsiteY10" fmla="*/ 935867 h 1633876"/>
                <a:gd name="connsiteX11" fmla="*/ 1353172 w 1442060"/>
                <a:gd name="connsiteY11" fmla="*/ 1371528 h 1633876"/>
                <a:gd name="connsiteX0" fmla="*/ 1353172 w 1442060"/>
                <a:gd name="connsiteY0" fmla="*/ 1371528 h 1628607"/>
                <a:gd name="connsiteX1" fmla="*/ 1023907 w 1442060"/>
                <a:gd name="connsiteY1" fmla="*/ 1627579 h 1628607"/>
                <a:gd name="connsiteX2" fmla="*/ 826869 w 1442060"/>
                <a:gd name="connsiteY2" fmla="*/ 1449955 h 1628607"/>
                <a:gd name="connsiteX3" fmla="*/ 571952 w 1442060"/>
                <a:gd name="connsiteY3" fmla="*/ 1169744 h 1628607"/>
                <a:gd name="connsiteX4" fmla="*/ 1991 w 1442060"/>
                <a:gd name="connsiteY4" fmla="*/ 814872 h 1628607"/>
                <a:gd name="connsiteX5" fmla="*/ 130228 w 1442060"/>
                <a:gd name="connsiteY5" fmla="*/ 427671 h 1628607"/>
                <a:gd name="connsiteX6" fmla="*/ 364160 w 1442060"/>
                <a:gd name="connsiteY6" fmla="*/ 123446 h 1628607"/>
                <a:gd name="connsiteX7" fmla="*/ 719297 w 1442060"/>
                <a:gd name="connsiteY7" fmla="*/ 1304 h 1628607"/>
                <a:gd name="connsiteX8" fmla="*/ 1025270 w 1442060"/>
                <a:gd name="connsiteY8" fmla="*/ 190471 h 1628607"/>
                <a:gd name="connsiteX9" fmla="*/ 1240731 w 1442060"/>
                <a:gd name="connsiteY9" fmla="*/ 473672 h 1628607"/>
                <a:gd name="connsiteX10" fmla="*/ 1434906 w 1442060"/>
                <a:gd name="connsiteY10" fmla="*/ 935867 h 1628607"/>
                <a:gd name="connsiteX11" fmla="*/ 1353172 w 1442060"/>
                <a:gd name="connsiteY11" fmla="*/ 1371528 h 1628607"/>
                <a:gd name="connsiteX0" fmla="*/ 1353172 w 1442060"/>
                <a:gd name="connsiteY0" fmla="*/ 1371528 h 1628607"/>
                <a:gd name="connsiteX1" fmla="*/ 1023907 w 1442060"/>
                <a:gd name="connsiteY1" fmla="*/ 1627579 h 1628607"/>
                <a:gd name="connsiteX2" fmla="*/ 826869 w 1442060"/>
                <a:gd name="connsiteY2" fmla="*/ 1449955 h 1628607"/>
                <a:gd name="connsiteX3" fmla="*/ 571952 w 1442060"/>
                <a:gd name="connsiteY3" fmla="*/ 1169744 h 1628607"/>
                <a:gd name="connsiteX4" fmla="*/ 1991 w 1442060"/>
                <a:gd name="connsiteY4" fmla="*/ 814872 h 1628607"/>
                <a:gd name="connsiteX5" fmla="*/ 130228 w 1442060"/>
                <a:gd name="connsiteY5" fmla="*/ 427671 h 1628607"/>
                <a:gd name="connsiteX6" fmla="*/ 364160 w 1442060"/>
                <a:gd name="connsiteY6" fmla="*/ 123446 h 1628607"/>
                <a:gd name="connsiteX7" fmla="*/ 719297 w 1442060"/>
                <a:gd name="connsiteY7" fmla="*/ 1304 h 1628607"/>
                <a:gd name="connsiteX8" fmla="*/ 1025270 w 1442060"/>
                <a:gd name="connsiteY8" fmla="*/ 190471 h 1628607"/>
                <a:gd name="connsiteX9" fmla="*/ 1240731 w 1442060"/>
                <a:gd name="connsiteY9" fmla="*/ 473672 h 1628607"/>
                <a:gd name="connsiteX10" fmla="*/ 1434906 w 1442060"/>
                <a:gd name="connsiteY10" fmla="*/ 935867 h 1628607"/>
                <a:gd name="connsiteX11" fmla="*/ 1353172 w 1442060"/>
                <a:gd name="connsiteY11" fmla="*/ 1371528 h 1628607"/>
                <a:gd name="connsiteX0" fmla="*/ 1353172 w 1442060"/>
                <a:gd name="connsiteY0" fmla="*/ 1371528 h 1627579"/>
                <a:gd name="connsiteX1" fmla="*/ 1023907 w 1442060"/>
                <a:gd name="connsiteY1" fmla="*/ 1627579 h 1627579"/>
                <a:gd name="connsiteX2" fmla="*/ 826869 w 1442060"/>
                <a:gd name="connsiteY2" fmla="*/ 1449955 h 1627579"/>
                <a:gd name="connsiteX3" fmla="*/ 571952 w 1442060"/>
                <a:gd name="connsiteY3" fmla="*/ 1169744 h 1627579"/>
                <a:gd name="connsiteX4" fmla="*/ 1991 w 1442060"/>
                <a:gd name="connsiteY4" fmla="*/ 814872 h 1627579"/>
                <a:gd name="connsiteX5" fmla="*/ 130228 w 1442060"/>
                <a:gd name="connsiteY5" fmla="*/ 427671 h 1627579"/>
                <a:gd name="connsiteX6" fmla="*/ 364160 w 1442060"/>
                <a:gd name="connsiteY6" fmla="*/ 123446 h 1627579"/>
                <a:gd name="connsiteX7" fmla="*/ 719297 w 1442060"/>
                <a:gd name="connsiteY7" fmla="*/ 1304 h 1627579"/>
                <a:gd name="connsiteX8" fmla="*/ 1025270 w 1442060"/>
                <a:gd name="connsiteY8" fmla="*/ 190471 h 1627579"/>
                <a:gd name="connsiteX9" fmla="*/ 1240731 w 1442060"/>
                <a:gd name="connsiteY9" fmla="*/ 473672 h 1627579"/>
                <a:gd name="connsiteX10" fmla="*/ 1434906 w 1442060"/>
                <a:gd name="connsiteY10" fmla="*/ 935867 h 1627579"/>
                <a:gd name="connsiteX11" fmla="*/ 1353172 w 1442060"/>
                <a:gd name="connsiteY11" fmla="*/ 1371528 h 1627579"/>
                <a:gd name="connsiteX0" fmla="*/ 1353172 w 1442060"/>
                <a:gd name="connsiteY0" fmla="*/ 1371528 h 1661279"/>
                <a:gd name="connsiteX1" fmla="*/ 979095 w 1442060"/>
                <a:gd name="connsiteY1" fmla="*/ 1661279 h 1661279"/>
                <a:gd name="connsiteX2" fmla="*/ 826869 w 1442060"/>
                <a:gd name="connsiteY2" fmla="*/ 1449955 h 1661279"/>
                <a:gd name="connsiteX3" fmla="*/ 571952 w 1442060"/>
                <a:gd name="connsiteY3" fmla="*/ 1169744 h 1661279"/>
                <a:gd name="connsiteX4" fmla="*/ 1991 w 1442060"/>
                <a:gd name="connsiteY4" fmla="*/ 814872 h 1661279"/>
                <a:gd name="connsiteX5" fmla="*/ 130228 w 1442060"/>
                <a:gd name="connsiteY5" fmla="*/ 427671 h 1661279"/>
                <a:gd name="connsiteX6" fmla="*/ 364160 w 1442060"/>
                <a:gd name="connsiteY6" fmla="*/ 123446 h 1661279"/>
                <a:gd name="connsiteX7" fmla="*/ 719297 w 1442060"/>
                <a:gd name="connsiteY7" fmla="*/ 1304 h 1661279"/>
                <a:gd name="connsiteX8" fmla="*/ 1025270 w 1442060"/>
                <a:gd name="connsiteY8" fmla="*/ 190471 h 1661279"/>
                <a:gd name="connsiteX9" fmla="*/ 1240731 w 1442060"/>
                <a:gd name="connsiteY9" fmla="*/ 473672 h 1661279"/>
                <a:gd name="connsiteX10" fmla="*/ 1434906 w 1442060"/>
                <a:gd name="connsiteY10" fmla="*/ 935867 h 1661279"/>
                <a:gd name="connsiteX11" fmla="*/ 1353172 w 1442060"/>
                <a:gd name="connsiteY11" fmla="*/ 1371528 h 1661279"/>
                <a:gd name="connsiteX0" fmla="*/ 1353172 w 1442060"/>
                <a:gd name="connsiteY0" fmla="*/ 1371528 h 1651815"/>
                <a:gd name="connsiteX1" fmla="*/ 967420 w 1442060"/>
                <a:gd name="connsiteY1" fmla="*/ 1651815 h 1651815"/>
                <a:gd name="connsiteX2" fmla="*/ 826869 w 1442060"/>
                <a:gd name="connsiteY2" fmla="*/ 1449955 h 1651815"/>
                <a:gd name="connsiteX3" fmla="*/ 571952 w 1442060"/>
                <a:gd name="connsiteY3" fmla="*/ 1169744 h 1651815"/>
                <a:gd name="connsiteX4" fmla="*/ 1991 w 1442060"/>
                <a:gd name="connsiteY4" fmla="*/ 814872 h 1651815"/>
                <a:gd name="connsiteX5" fmla="*/ 130228 w 1442060"/>
                <a:gd name="connsiteY5" fmla="*/ 427671 h 1651815"/>
                <a:gd name="connsiteX6" fmla="*/ 364160 w 1442060"/>
                <a:gd name="connsiteY6" fmla="*/ 123446 h 1651815"/>
                <a:gd name="connsiteX7" fmla="*/ 719297 w 1442060"/>
                <a:gd name="connsiteY7" fmla="*/ 1304 h 1651815"/>
                <a:gd name="connsiteX8" fmla="*/ 1025270 w 1442060"/>
                <a:gd name="connsiteY8" fmla="*/ 190471 h 1651815"/>
                <a:gd name="connsiteX9" fmla="*/ 1240731 w 1442060"/>
                <a:gd name="connsiteY9" fmla="*/ 473672 h 1651815"/>
                <a:gd name="connsiteX10" fmla="*/ 1434906 w 1442060"/>
                <a:gd name="connsiteY10" fmla="*/ 935867 h 1651815"/>
                <a:gd name="connsiteX11" fmla="*/ 1353172 w 1442060"/>
                <a:gd name="connsiteY11" fmla="*/ 1371528 h 1651815"/>
                <a:gd name="connsiteX0" fmla="*/ 1353172 w 1442060"/>
                <a:gd name="connsiteY0" fmla="*/ 1371528 h 1651815"/>
                <a:gd name="connsiteX1" fmla="*/ 967420 w 1442060"/>
                <a:gd name="connsiteY1" fmla="*/ 1651815 h 1651815"/>
                <a:gd name="connsiteX2" fmla="*/ 826869 w 1442060"/>
                <a:gd name="connsiteY2" fmla="*/ 1449955 h 1651815"/>
                <a:gd name="connsiteX3" fmla="*/ 571952 w 1442060"/>
                <a:gd name="connsiteY3" fmla="*/ 1169744 h 1651815"/>
                <a:gd name="connsiteX4" fmla="*/ 1991 w 1442060"/>
                <a:gd name="connsiteY4" fmla="*/ 814872 h 1651815"/>
                <a:gd name="connsiteX5" fmla="*/ 130228 w 1442060"/>
                <a:gd name="connsiteY5" fmla="*/ 427671 h 1651815"/>
                <a:gd name="connsiteX6" fmla="*/ 364160 w 1442060"/>
                <a:gd name="connsiteY6" fmla="*/ 123446 h 1651815"/>
                <a:gd name="connsiteX7" fmla="*/ 719297 w 1442060"/>
                <a:gd name="connsiteY7" fmla="*/ 1304 h 1651815"/>
                <a:gd name="connsiteX8" fmla="*/ 1025270 w 1442060"/>
                <a:gd name="connsiteY8" fmla="*/ 190471 h 1651815"/>
                <a:gd name="connsiteX9" fmla="*/ 1240731 w 1442060"/>
                <a:gd name="connsiteY9" fmla="*/ 473672 h 1651815"/>
                <a:gd name="connsiteX10" fmla="*/ 1434906 w 1442060"/>
                <a:gd name="connsiteY10" fmla="*/ 935867 h 1651815"/>
                <a:gd name="connsiteX11" fmla="*/ 1353172 w 1442060"/>
                <a:gd name="connsiteY11" fmla="*/ 1371528 h 1651815"/>
                <a:gd name="connsiteX0" fmla="*/ 1353172 w 1442060"/>
                <a:gd name="connsiteY0" fmla="*/ 1439482 h 1719769"/>
                <a:gd name="connsiteX1" fmla="*/ 967420 w 1442060"/>
                <a:gd name="connsiteY1" fmla="*/ 1719769 h 1719769"/>
                <a:gd name="connsiteX2" fmla="*/ 826869 w 1442060"/>
                <a:gd name="connsiteY2" fmla="*/ 1517909 h 1719769"/>
                <a:gd name="connsiteX3" fmla="*/ 571952 w 1442060"/>
                <a:gd name="connsiteY3" fmla="*/ 1237698 h 1719769"/>
                <a:gd name="connsiteX4" fmla="*/ 1991 w 1442060"/>
                <a:gd name="connsiteY4" fmla="*/ 882826 h 1719769"/>
                <a:gd name="connsiteX5" fmla="*/ 130228 w 1442060"/>
                <a:gd name="connsiteY5" fmla="*/ 495625 h 1719769"/>
                <a:gd name="connsiteX6" fmla="*/ 364160 w 1442060"/>
                <a:gd name="connsiteY6" fmla="*/ 191400 h 1719769"/>
                <a:gd name="connsiteX7" fmla="*/ 704604 w 1442060"/>
                <a:gd name="connsiteY7" fmla="*/ 730 h 1719769"/>
                <a:gd name="connsiteX8" fmla="*/ 1025270 w 1442060"/>
                <a:gd name="connsiteY8" fmla="*/ 258425 h 1719769"/>
                <a:gd name="connsiteX9" fmla="*/ 1240731 w 1442060"/>
                <a:gd name="connsiteY9" fmla="*/ 541626 h 1719769"/>
                <a:gd name="connsiteX10" fmla="*/ 1434906 w 1442060"/>
                <a:gd name="connsiteY10" fmla="*/ 1003821 h 1719769"/>
                <a:gd name="connsiteX11" fmla="*/ 1353172 w 1442060"/>
                <a:gd name="connsiteY11" fmla="*/ 1439482 h 1719769"/>
                <a:gd name="connsiteX0" fmla="*/ 1353172 w 1442060"/>
                <a:gd name="connsiteY0" fmla="*/ 1506263 h 1786550"/>
                <a:gd name="connsiteX1" fmla="*/ 967420 w 1442060"/>
                <a:gd name="connsiteY1" fmla="*/ 1786550 h 1786550"/>
                <a:gd name="connsiteX2" fmla="*/ 826869 w 1442060"/>
                <a:gd name="connsiteY2" fmla="*/ 1584690 h 1786550"/>
                <a:gd name="connsiteX3" fmla="*/ 571952 w 1442060"/>
                <a:gd name="connsiteY3" fmla="*/ 1304479 h 1786550"/>
                <a:gd name="connsiteX4" fmla="*/ 1991 w 1442060"/>
                <a:gd name="connsiteY4" fmla="*/ 949607 h 1786550"/>
                <a:gd name="connsiteX5" fmla="*/ 130228 w 1442060"/>
                <a:gd name="connsiteY5" fmla="*/ 562406 h 1786550"/>
                <a:gd name="connsiteX6" fmla="*/ 364160 w 1442060"/>
                <a:gd name="connsiteY6" fmla="*/ 258181 h 1786550"/>
                <a:gd name="connsiteX7" fmla="*/ 568645 w 1442060"/>
                <a:gd name="connsiteY7" fmla="*/ 509 h 1786550"/>
                <a:gd name="connsiteX8" fmla="*/ 1025270 w 1442060"/>
                <a:gd name="connsiteY8" fmla="*/ 325206 h 1786550"/>
                <a:gd name="connsiteX9" fmla="*/ 1240731 w 1442060"/>
                <a:gd name="connsiteY9" fmla="*/ 608407 h 1786550"/>
                <a:gd name="connsiteX10" fmla="*/ 1434906 w 1442060"/>
                <a:gd name="connsiteY10" fmla="*/ 1070602 h 1786550"/>
                <a:gd name="connsiteX11" fmla="*/ 1353172 w 1442060"/>
                <a:gd name="connsiteY11" fmla="*/ 1506263 h 1786550"/>
                <a:gd name="connsiteX0" fmla="*/ 1352819 w 1441707"/>
                <a:gd name="connsiteY0" fmla="*/ 1507185 h 1787472"/>
                <a:gd name="connsiteX1" fmla="*/ 967067 w 1441707"/>
                <a:gd name="connsiteY1" fmla="*/ 1787472 h 1787472"/>
                <a:gd name="connsiteX2" fmla="*/ 826516 w 1441707"/>
                <a:gd name="connsiteY2" fmla="*/ 1585612 h 1787472"/>
                <a:gd name="connsiteX3" fmla="*/ 571599 w 1441707"/>
                <a:gd name="connsiteY3" fmla="*/ 1305401 h 1787472"/>
                <a:gd name="connsiteX4" fmla="*/ 1638 w 1441707"/>
                <a:gd name="connsiteY4" fmla="*/ 950529 h 1787472"/>
                <a:gd name="connsiteX5" fmla="*/ 129875 w 1441707"/>
                <a:gd name="connsiteY5" fmla="*/ 563328 h 1787472"/>
                <a:gd name="connsiteX6" fmla="*/ 233500 w 1441707"/>
                <a:gd name="connsiteY6" fmla="*/ 222011 h 1787472"/>
                <a:gd name="connsiteX7" fmla="*/ 568292 w 1441707"/>
                <a:gd name="connsiteY7" fmla="*/ 1431 h 1787472"/>
                <a:gd name="connsiteX8" fmla="*/ 1024917 w 1441707"/>
                <a:gd name="connsiteY8" fmla="*/ 326128 h 1787472"/>
                <a:gd name="connsiteX9" fmla="*/ 1240378 w 1441707"/>
                <a:gd name="connsiteY9" fmla="*/ 609329 h 1787472"/>
                <a:gd name="connsiteX10" fmla="*/ 1434553 w 1441707"/>
                <a:gd name="connsiteY10" fmla="*/ 1071524 h 1787472"/>
                <a:gd name="connsiteX11" fmla="*/ 1352819 w 1441707"/>
                <a:gd name="connsiteY11" fmla="*/ 1507185 h 1787472"/>
                <a:gd name="connsiteX0" fmla="*/ 1355415 w 1444303"/>
                <a:gd name="connsiteY0" fmla="*/ 1507165 h 1787452"/>
                <a:gd name="connsiteX1" fmla="*/ 969663 w 1444303"/>
                <a:gd name="connsiteY1" fmla="*/ 1787452 h 1787452"/>
                <a:gd name="connsiteX2" fmla="*/ 829112 w 1444303"/>
                <a:gd name="connsiteY2" fmla="*/ 1585592 h 1787452"/>
                <a:gd name="connsiteX3" fmla="*/ 574195 w 1444303"/>
                <a:gd name="connsiteY3" fmla="*/ 1305381 h 1787452"/>
                <a:gd name="connsiteX4" fmla="*/ 4234 w 1444303"/>
                <a:gd name="connsiteY4" fmla="*/ 950509 h 1787452"/>
                <a:gd name="connsiteX5" fmla="*/ 58656 w 1444303"/>
                <a:gd name="connsiteY5" fmla="*/ 548170 h 1787452"/>
                <a:gd name="connsiteX6" fmla="*/ 236096 w 1444303"/>
                <a:gd name="connsiteY6" fmla="*/ 221991 h 1787452"/>
                <a:gd name="connsiteX7" fmla="*/ 570888 w 1444303"/>
                <a:gd name="connsiteY7" fmla="*/ 1411 h 1787452"/>
                <a:gd name="connsiteX8" fmla="*/ 1027513 w 1444303"/>
                <a:gd name="connsiteY8" fmla="*/ 326108 h 1787452"/>
                <a:gd name="connsiteX9" fmla="*/ 1242974 w 1444303"/>
                <a:gd name="connsiteY9" fmla="*/ 609309 h 1787452"/>
                <a:gd name="connsiteX10" fmla="*/ 1437149 w 1444303"/>
                <a:gd name="connsiteY10" fmla="*/ 1071504 h 1787452"/>
                <a:gd name="connsiteX11" fmla="*/ 1355415 w 1444303"/>
                <a:gd name="connsiteY11" fmla="*/ 1507165 h 1787452"/>
                <a:gd name="connsiteX0" fmla="*/ 1355415 w 1444303"/>
                <a:gd name="connsiteY0" fmla="*/ 1513539 h 1793826"/>
                <a:gd name="connsiteX1" fmla="*/ 969663 w 1444303"/>
                <a:gd name="connsiteY1" fmla="*/ 1793826 h 1793826"/>
                <a:gd name="connsiteX2" fmla="*/ 829112 w 1444303"/>
                <a:gd name="connsiteY2" fmla="*/ 1591966 h 1793826"/>
                <a:gd name="connsiteX3" fmla="*/ 574195 w 1444303"/>
                <a:gd name="connsiteY3" fmla="*/ 1311755 h 1793826"/>
                <a:gd name="connsiteX4" fmla="*/ 4234 w 1444303"/>
                <a:gd name="connsiteY4" fmla="*/ 956883 h 1793826"/>
                <a:gd name="connsiteX5" fmla="*/ 58656 w 1444303"/>
                <a:gd name="connsiteY5" fmla="*/ 554544 h 1793826"/>
                <a:gd name="connsiteX6" fmla="*/ 236096 w 1444303"/>
                <a:gd name="connsiteY6" fmla="*/ 228365 h 1793826"/>
                <a:gd name="connsiteX7" fmla="*/ 408573 w 1444303"/>
                <a:gd name="connsiteY7" fmla="*/ 1364 h 1793826"/>
                <a:gd name="connsiteX8" fmla="*/ 1027513 w 1444303"/>
                <a:gd name="connsiteY8" fmla="*/ 332482 h 1793826"/>
                <a:gd name="connsiteX9" fmla="*/ 1242974 w 1444303"/>
                <a:gd name="connsiteY9" fmla="*/ 615683 h 1793826"/>
                <a:gd name="connsiteX10" fmla="*/ 1437149 w 1444303"/>
                <a:gd name="connsiteY10" fmla="*/ 1077878 h 1793826"/>
                <a:gd name="connsiteX11" fmla="*/ 1355415 w 1444303"/>
                <a:gd name="connsiteY11" fmla="*/ 1513539 h 1793826"/>
                <a:gd name="connsiteX0" fmla="*/ 1354600 w 1443488"/>
                <a:gd name="connsiteY0" fmla="*/ 1514645 h 1794932"/>
                <a:gd name="connsiteX1" fmla="*/ 968848 w 1443488"/>
                <a:gd name="connsiteY1" fmla="*/ 1794932 h 1794932"/>
                <a:gd name="connsiteX2" fmla="*/ 828297 w 1443488"/>
                <a:gd name="connsiteY2" fmla="*/ 1593072 h 1794932"/>
                <a:gd name="connsiteX3" fmla="*/ 573380 w 1443488"/>
                <a:gd name="connsiteY3" fmla="*/ 1312861 h 1794932"/>
                <a:gd name="connsiteX4" fmla="*/ 3419 w 1443488"/>
                <a:gd name="connsiteY4" fmla="*/ 957989 h 1794932"/>
                <a:gd name="connsiteX5" fmla="*/ 57841 w 1443488"/>
                <a:gd name="connsiteY5" fmla="*/ 555650 h 1794932"/>
                <a:gd name="connsiteX6" fmla="*/ 162594 w 1443488"/>
                <a:gd name="connsiteY6" fmla="*/ 201839 h 1794932"/>
                <a:gd name="connsiteX7" fmla="*/ 407758 w 1443488"/>
                <a:gd name="connsiteY7" fmla="*/ 2470 h 1794932"/>
                <a:gd name="connsiteX8" fmla="*/ 1026698 w 1443488"/>
                <a:gd name="connsiteY8" fmla="*/ 333588 h 1794932"/>
                <a:gd name="connsiteX9" fmla="*/ 1242159 w 1443488"/>
                <a:gd name="connsiteY9" fmla="*/ 616789 h 1794932"/>
                <a:gd name="connsiteX10" fmla="*/ 1436334 w 1443488"/>
                <a:gd name="connsiteY10" fmla="*/ 1078984 h 1794932"/>
                <a:gd name="connsiteX11" fmla="*/ 1354600 w 1443488"/>
                <a:gd name="connsiteY11" fmla="*/ 1514645 h 1794932"/>
                <a:gd name="connsiteX0" fmla="*/ 1354600 w 1443488"/>
                <a:gd name="connsiteY0" fmla="*/ 1543451 h 1823738"/>
                <a:gd name="connsiteX1" fmla="*/ 968848 w 1443488"/>
                <a:gd name="connsiteY1" fmla="*/ 1823738 h 1823738"/>
                <a:gd name="connsiteX2" fmla="*/ 828297 w 1443488"/>
                <a:gd name="connsiteY2" fmla="*/ 1621878 h 1823738"/>
                <a:gd name="connsiteX3" fmla="*/ 573380 w 1443488"/>
                <a:gd name="connsiteY3" fmla="*/ 1341667 h 1823738"/>
                <a:gd name="connsiteX4" fmla="*/ 3419 w 1443488"/>
                <a:gd name="connsiteY4" fmla="*/ 986795 h 1823738"/>
                <a:gd name="connsiteX5" fmla="*/ 57841 w 1443488"/>
                <a:gd name="connsiteY5" fmla="*/ 584456 h 1823738"/>
                <a:gd name="connsiteX6" fmla="*/ 162594 w 1443488"/>
                <a:gd name="connsiteY6" fmla="*/ 230645 h 1823738"/>
                <a:gd name="connsiteX7" fmla="*/ 410392 w 1443488"/>
                <a:gd name="connsiteY7" fmla="*/ 2122 h 1823738"/>
                <a:gd name="connsiteX8" fmla="*/ 1026698 w 1443488"/>
                <a:gd name="connsiteY8" fmla="*/ 362394 h 1823738"/>
                <a:gd name="connsiteX9" fmla="*/ 1242159 w 1443488"/>
                <a:gd name="connsiteY9" fmla="*/ 645595 h 1823738"/>
                <a:gd name="connsiteX10" fmla="*/ 1436334 w 1443488"/>
                <a:gd name="connsiteY10" fmla="*/ 1107790 h 1823738"/>
                <a:gd name="connsiteX11" fmla="*/ 1354600 w 1443488"/>
                <a:gd name="connsiteY11" fmla="*/ 1543451 h 1823738"/>
                <a:gd name="connsiteX0" fmla="*/ 1354600 w 1443488"/>
                <a:gd name="connsiteY0" fmla="*/ 1612956 h 1893243"/>
                <a:gd name="connsiteX1" fmla="*/ 968848 w 1443488"/>
                <a:gd name="connsiteY1" fmla="*/ 1893243 h 1893243"/>
                <a:gd name="connsiteX2" fmla="*/ 828297 w 1443488"/>
                <a:gd name="connsiteY2" fmla="*/ 1691383 h 1893243"/>
                <a:gd name="connsiteX3" fmla="*/ 573380 w 1443488"/>
                <a:gd name="connsiteY3" fmla="*/ 1411172 h 1893243"/>
                <a:gd name="connsiteX4" fmla="*/ 3419 w 1443488"/>
                <a:gd name="connsiteY4" fmla="*/ 1056300 h 1893243"/>
                <a:gd name="connsiteX5" fmla="*/ 57841 w 1443488"/>
                <a:gd name="connsiteY5" fmla="*/ 653961 h 1893243"/>
                <a:gd name="connsiteX6" fmla="*/ 162594 w 1443488"/>
                <a:gd name="connsiteY6" fmla="*/ 300150 h 1893243"/>
                <a:gd name="connsiteX7" fmla="*/ 425073 w 1443488"/>
                <a:gd name="connsiteY7" fmla="*/ 1583 h 1893243"/>
                <a:gd name="connsiteX8" fmla="*/ 1026698 w 1443488"/>
                <a:gd name="connsiteY8" fmla="*/ 431899 h 1893243"/>
                <a:gd name="connsiteX9" fmla="*/ 1242159 w 1443488"/>
                <a:gd name="connsiteY9" fmla="*/ 715100 h 1893243"/>
                <a:gd name="connsiteX10" fmla="*/ 1436334 w 1443488"/>
                <a:gd name="connsiteY10" fmla="*/ 1177295 h 1893243"/>
                <a:gd name="connsiteX11" fmla="*/ 1354600 w 1443488"/>
                <a:gd name="connsiteY11" fmla="*/ 1612956 h 1893243"/>
                <a:gd name="connsiteX0" fmla="*/ 1354600 w 1443488"/>
                <a:gd name="connsiteY0" fmla="*/ 1611374 h 1891661"/>
                <a:gd name="connsiteX1" fmla="*/ 968848 w 1443488"/>
                <a:gd name="connsiteY1" fmla="*/ 1891661 h 1891661"/>
                <a:gd name="connsiteX2" fmla="*/ 828297 w 1443488"/>
                <a:gd name="connsiteY2" fmla="*/ 1689801 h 1891661"/>
                <a:gd name="connsiteX3" fmla="*/ 573380 w 1443488"/>
                <a:gd name="connsiteY3" fmla="*/ 1409590 h 1891661"/>
                <a:gd name="connsiteX4" fmla="*/ 3419 w 1443488"/>
                <a:gd name="connsiteY4" fmla="*/ 1054718 h 1891661"/>
                <a:gd name="connsiteX5" fmla="*/ 57841 w 1443488"/>
                <a:gd name="connsiteY5" fmla="*/ 652379 h 1891661"/>
                <a:gd name="connsiteX6" fmla="*/ 162594 w 1443488"/>
                <a:gd name="connsiteY6" fmla="*/ 298568 h 1891661"/>
                <a:gd name="connsiteX7" fmla="*/ 425073 w 1443488"/>
                <a:gd name="connsiteY7" fmla="*/ 1 h 1891661"/>
                <a:gd name="connsiteX8" fmla="*/ 1088825 w 1443488"/>
                <a:gd name="connsiteY8" fmla="*/ 297420 h 1891661"/>
                <a:gd name="connsiteX9" fmla="*/ 1242159 w 1443488"/>
                <a:gd name="connsiteY9" fmla="*/ 713518 h 1891661"/>
                <a:gd name="connsiteX10" fmla="*/ 1436334 w 1443488"/>
                <a:gd name="connsiteY10" fmla="*/ 1175713 h 1891661"/>
                <a:gd name="connsiteX11" fmla="*/ 1354600 w 1443488"/>
                <a:gd name="connsiteY11" fmla="*/ 1611374 h 1891661"/>
                <a:gd name="connsiteX0" fmla="*/ 1354600 w 1443488"/>
                <a:gd name="connsiteY0" fmla="*/ 1612088 h 1892375"/>
                <a:gd name="connsiteX1" fmla="*/ 968848 w 1443488"/>
                <a:gd name="connsiteY1" fmla="*/ 1892375 h 1892375"/>
                <a:gd name="connsiteX2" fmla="*/ 828297 w 1443488"/>
                <a:gd name="connsiteY2" fmla="*/ 1690515 h 1892375"/>
                <a:gd name="connsiteX3" fmla="*/ 573380 w 1443488"/>
                <a:gd name="connsiteY3" fmla="*/ 1410304 h 1892375"/>
                <a:gd name="connsiteX4" fmla="*/ 3419 w 1443488"/>
                <a:gd name="connsiteY4" fmla="*/ 1055432 h 1892375"/>
                <a:gd name="connsiteX5" fmla="*/ 57841 w 1443488"/>
                <a:gd name="connsiteY5" fmla="*/ 653093 h 1892375"/>
                <a:gd name="connsiteX6" fmla="*/ 162594 w 1443488"/>
                <a:gd name="connsiteY6" fmla="*/ 299282 h 1892375"/>
                <a:gd name="connsiteX7" fmla="*/ 425073 w 1443488"/>
                <a:gd name="connsiteY7" fmla="*/ 715 h 1892375"/>
                <a:gd name="connsiteX8" fmla="*/ 1076782 w 1443488"/>
                <a:gd name="connsiteY8" fmla="*/ 385215 h 1892375"/>
                <a:gd name="connsiteX9" fmla="*/ 1242159 w 1443488"/>
                <a:gd name="connsiteY9" fmla="*/ 714232 h 1892375"/>
                <a:gd name="connsiteX10" fmla="*/ 1436334 w 1443488"/>
                <a:gd name="connsiteY10" fmla="*/ 1176427 h 1892375"/>
                <a:gd name="connsiteX11" fmla="*/ 1354600 w 1443488"/>
                <a:gd name="connsiteY11" fmla="*/ 1612088 h 1892375"/>
                <a:gd name="connsiteX0" fmla="*/ 1354600 w 1443488"/>
                <a:gd name="connsiteY0" fmla="*/ 1612866 h 1893153"/>
                <a:gd name="connsiteX1" fmla="*/ 968848 w 1443488"/>
                <a:gd name="connsiteY1" fmla="*/ 1893153 h 1893153"/>
                <a:gd name="connsiteX2" fmla="*/ 828297 w 1443488"/>
                <a:gd name="connsiteY2" fmla="*/ 1691293 h 1893153"/>
                <a:gd name="connsiteX3" fmla="*/ 573380 w 1443488"/>
                <a:gd name="connsiteY3" fmla="*/ 1411082 h 1893153"/>
                <a:gd name="connsiteX4" fmla="*/ 3419 w 1443488"/>
                <a:gd name="connsiteY4" fmla="*/ 1056210 h 1893153"/>
                <a:gd name="connsiteX5" fmla="*/ 57841 w 1443488"/>
                <a:gd name="connsiteY5" fmla="*/ 653871 h 1893153"/>
                <a:gd name="connsiteX6" fmla="*/ 162594 w 1443488"/>
                <a:gd name="connsiteY6" fmla="*/ 300060 h 1893153"/>
                <a:gd name="connsiteX7" fmla="*/ 425073 w 1443488"/>
                <a:gd name="connsiteY7" fmla="*/ 1493 h 1893153"/>
                <a:gd name="connsiteX8" fmla="*/ 1027075 w 1443488"/>
                <a:gd name="connsiteY8" fmla="*/ 427645 h 1893153"/>
                <a:gd name="connsiteX9" fmla="*/ 1242159 w 1443488"/>
                <a:gd name="connsiteY9" fmla="*/ 715010 h 1893153"/>
                <a:gd name="connsiteX10" fmla="*/ 1436334 w 1443488"/>
                <a:gd name="connsiteY10" fmla="*/ 1177205 h 1893153"/>
                <a:gd name="connsiteX11" fmla="*/ 1354600 w 1443488"/>
                <a:gd name="connsiteY11" fmla="*/ 1612866 h 1893153"/>
                <a:gd name="connsiteX0" fmla="*/ 1193033 w 1436692"/>
                <a:gd name="connsiteY0" fmla="*/ 1551925 h 1893153"/>
                <a:gd name="connsiteX1" fmla="*/ 968848 w 1436692"/>
                <a:gd name="connsiteY1" fmla="*/ 1893153 h 1893153"/>
                <a:gd name="connsiteX2" fmla="*/ 828297 w 1436692"/>
                <a:gd name="connsiteY2" fmla="*/ 1691293 h 1893153"/>
                <a:gd name="connsiteX3" fmla="*/ 573380 w 1436692"/>
                <a:gd name="connsiteY3" fmla="*/ 1411082 h 1893153"/>
                <a:gd name="connsiteX4" fmla="*/ 3419 w 1436692"/>
                <a:gd name="connsiteY4" fmla="*/ 1056210 h 1893153"/>
                <a:gd name="connsiteX5" fmla="*/ 57841 w 1436692"/>
                <a:gd name="connsiteY5" fmla="*/ 653871 h 1893153"/>
                <a:gd name="connsiteX6" fmla="*/ 162594 w 1436692"/>
                <a:gd name="connsiteY6" fmla="*/ 300060 h 1893153"/>
                <a:gd name="connsiteX7" fmla="*/ 425073 w 1436692"/>
                <a:gd name="connsiteY7" fmla="*/ 1493 h 1893153"/>
                <a:gd name="connsiteX8" fmla="*/ 1027075 w 1436692"/>
                <a:gd name="connsiteY8" fmla="*/ 427645 h 1893153"/>
                <a:gd name="connsiteX9" fmla="*/ 1242159 w 1436692"/>
                <a:gd name="connsiteY9" fmla="*/ 715010 h 1893153"/>
                <a:gd name="connsiteX10" fmla="*/ 1436334 w 1436692"/>
                <a:gd name="connsiteY10" fmla="*/ 1177205 h 1893153"/>
                <a:gd name="connsiteX11" fmla="*/ 1193033 w 1436692"/>
                <a:gd name="connsiteY11" fmla="*/ 1551925 h 1893153"/>
                <a:gd name="connsiteX0" fmla="*/ 1193033 w 1262522"/>
                <a:gd name="connsiteY0" fmla="*/ 1551925 h 1893153"/>
                <a:gd name="connsiteX1" fmla="*/ 968848 w 1262522"/>
                <a:gd name="connsiteY1" fmla="*/ 1893153 h 1893153"/>
                <a:gd name="connsiteX2" fmla="*/ 828297 w 1262522"/>
                <a:gd name="connsiteY2" fmla="*/ 1691293 h 1893153"/>
                <a:gd name="connsiteX3" fmla="*/ 573380 w 1262522"/>
                <a:gd name="connsiteY3" fmla="*/ 1411082 h 1893153"/>
                <a:gd name="connsiteX4" fmla="*/ 3419 w 1262522"/>
                <a:gd name="connsiteY4" fmla="*/ 1056210 h 1893153"/>
                <a:gd name="connsiteX5" fmla="*/ 57841 w 1262522"/>
                <a:gd name="connsiteY5" fmla="*/ 653871 h 1893153"/>
                <a:gd name="connsiteX6" fmla="*/ 162594 w 1262522"/>
                <a:gd name="connsiteY6" fmla="*/ 300060 h 1893153"/>
                <a:gd name="connsiteX7" fmla="*/ 425073 w 1262522"/>
                <a:gd name="connsiteY7" fmla="*/ 1493 h 1893153"/>
                <a:gd name="connsiteX8" fmla="*/ 1027075 w 1262522"/>
                <a:gd name="connsiteY8" fmla="*/ 427645 h 1893153"/>
                <a:gd name="connsiteX9" fmla="*/ 1242159 w 1262522"/>
                <a:gd name="connsiteY9" fmla="*/ 715010 h 1893153"/>
                <a:gd name="connsiteX10" fmla="*/ 1248039 w 1262522"/>
                <a:gd name="connsiteY10" fmla="*/ 1227199 h 1893153"/>
                <a:gd name="connsiteX11" fmla="*/ 1193033 w 1262522"/>
                <a:gd name="connsiteY11" fmla="*/ 1551925 h 1893153"/>
                <a:gd name="connsiteX0" fmla="*/ 1130889 w 1265934"/>
                <a:gd name="connsiteY0" fmla="*/ 1500062 h 1893153"/>
                <a:gd name="connsiteX1" fmla="*/ 968848 w 1265934"/>
                <a:gd name="connsiteY1" fmla="*/ 1893153 h 1893153"/>
                <a:gd name="connsiteX2" fmla="*/ 828297 w 1265934"/>
                <a:gd name="connsiteY2" fmla="*/ 1691293 h 1893153"/>
                <a:gd name="connsiteX3" fmla="*/ 573380 w 1265934"/>
                <a:gd name="connsiteY3" fmla="*/ 1411082 h 1893153"/>
                <a:gd name="connsiteX4" fmla="*/ 3419 w 1265934"/>
                <a:gd name="connsiteY4" fmla="*/ 1056210 h 1893153"/>
                <a:gd name="connsiteX5" fmla="*/ 57841 w 1265934"/>
                <a:gd name="connsiteY5" fmla="*/ 653871 h 1893153"/>
                <a:gd name="connsiteX6" fmla="*/ 162594 w 1265934"/>
                <a:gd name="connsiteY6" fmla="*/ 300060 h 1893153"/>
                <a:gd name="connsiteX7" fmla="*/ 425073 w 1265934"/>
                <a:gd name="connsiteY7" fmla="*/ 1493 h 1893153"/>
                <a:gd name="connsiteX8" fmla="*/ 1027075 w 1265934"/>
                <a:gd name="connsiteY8" fmla="*/ 427645 h 1893153"/>
                <a:gd name="connsiteX9" fmla="*/ 1242159 w 1265934"/>
                <a:gd name="connsiteY9" fmla="*/ 715010 h 1893153"/>
                <a:gd name="connsiteX10" fmla="*/ 1248039 w 1265934"/>
                <a:gd name="connsiteY10" fmla="*/ 1227199 h 1893153"/>
                <a:gd name="connsiteX11" fmla="*/ 1130889 w 1265934"/>
                <a:gd name="connsiteY11" fmla="*/ 1500062 h 1893153"/>
                <a:gd name="connsiteX0" fmla="*/ 1058955 w 1270401"/>
                <a:gd name="connsiteY0" fmla="*/ 1464100 h 1893153"/>
                <a:gd name="connsiteX1" fmla="*/ 968848 w 1270401"/>
                <a:gd name="connsiteY1" fmla="*/ 1893153 h 1893153"/>
                <a:gd name="connsiteX2" fmla="*/ 828297 w 1270401"/>
                <a:gd name="connsiteY2" fmla="*/ 1691293 h 1893153"/>
                <a:gd name="connsiteX3" fmla="*/ 573380 w 1270401"/>
                <a:gd name="connsiteY3" fmla="*/ 1411082 h 1893153"/>
                <a:gd name="connsiteX4" fmla="*/ 3419 w 1270401"/>
                <a:gd name="connsiteY4" fmla="*/ 1056210 h 1893153"/>
                <a:gd name="connsiteX5" fmla="*/ 57841 w 1270401"/>
                <a:gd name="connsiteY5" fmla="*/ 653871 h 1893153"/>
                <a:gd name="connsiteX6" fmla="*/ 162594 w 1270401"/>
                <a:gd name="connsiteY6" fmla="*/ 300060 h 1893153"/>
                <a:gd name="connsiteX7" fmla="*/ 425073 w 1270401"/>
                <a:gd name="connsiteY7" fmla="*/ 1493 h 1893153"/>
                <a:gd name="connsiteX8" fmla="*/ 1027075 w 1270401"/>
                <a:gd name="connsiteY8" fmla="*/ 427645 h 1893153"/>
                <a:gd name="connsiteX9" fmla="*/ 1242159 w 1270401"/>
                <a:gd name="connsiteY9" fmla="*/ 715010 h 1893153"/>
                <a:gd name="connsiteX10" fmla="*/ 1248039 w 1270401"/>
                <a:gd name="connsiteY10" fmla="*/ 1227199 h 1893153"/>
                <a:gd name="connsiteX11" fmla="*/ 1058955 w 1270401"/>
                <a:gd name="connsiteY11" fmla="*/ 1464100 h 1893153"/>
                <a:gd name="connsiteX0" fmla="*/ 1058955 w 1244481"/>
                <a:gd name="connsiteY0" fmla="*/ 1464100 h 1893153"/>
                <a:gd name="connsiteX1" fmla="*/ 968848 w 1244481"/>
                <a:gd name="connsiteY1" fmla="*/ 1893153 h 1893153"/>
                <a:gd name="connsiteX2" fmla="*/ 828297 w 1244481"/>
                <a:gd name="connsiteY2" fmla="*/ 1691293 h 1893153"/>
                <a:gd name="connsiteX3" fmla="*/ 573380 w 1244481"/>
                <a:gd name="connsiteY3" fmla="*/ 1411082 h 1893153"/>
                <a:gd name="connsiteX4" fmla="*/ 3419 w 1244481"/>
                <a:gd name="connsiteY4" fmla="*/ 1056210 h 1893153"/>
                <a:gd name="connsiteX5" fmla="*/ 57841 w 1244481"/>
                <a:gd name="connsiteY5" fmla="*/ 653871 h 1893153"/>
                <a:gd name="connsiteX6" fmla="*/ 162594 w 1244481"/>
                <a:gd name="connsiteY6" fmla="*/ 300060 h 1893153"/>
                <a:gd name="connsiteX7" fmla="*/ 425073 w 1244481"/>
                <a:gd name="connsiteY7" fmla="*/ 1493 h 1893153"/>
                <a:gd name="connsiteX8" fmla="*/ 1027075 w 1244481"/>
                <a:gd name="connsiteY8" fmla="*/ 427645 h 1893153"/>
                <a:gd name="connsiteX9" fmla="*/ 1242159 w 1244481"/>
                <a:gd name="connsiteY9" fmla="*/ 715010 h 1893153"/>
                <a:gd name="connsiteX10" fmla="*/ 1136188 w 1244481"/>
                <a:gd name="connsiteY10" fmla="*/ 1216988 h 1893153"/>
                <a:gd name="connsiteX11" fmla="*/ 1058955 w 1244481"/>
                <a:gd name="connsiteY11" fmla="*/ 1464100 h 1893153"/>
                <a:gd name="connsiteX0" fmla="*/ 1058955 w 1155449"/>
                <a:gd name="connsiteY0" fmla="*/ 1464100 h 1893153"/>
                <a:gd name="connsiteX1" fmla="*/ 968848 w 1155449"/>
                <a:gd name="connsiteY1" fmla="*/ 1893153 h 1893153"/>
                <a:gd name="connsiteX2" fmla="*/ 828297 w 1155449"/>
                <a:gd name="connsiteY2" fmla="*/ 1691293 h 1893153"/>
                <a:gd name="connsiteX3" fmla="*/ 573380 w 1155449"/>
                <a:gd name="connsiteY3" fmla="*/ 1411082 h 1893153"/>
                <a:gd name="connsiteX4" fmla="*/ 3419 w 1155449"/>
                <a:gd name="connsiteY4" fmla="*/ 1056210 h 1893153"/>
                <a:gd name="connsiteX5" fmla="*/ 57841 w 1155449"/>
                <a:gd name="connsiteY5" fmla="*/ 653871 h 1893153"/>
                <a:gd name="connsiteX6" fmla="*/ 162594 w 1155449"/>
                <a:gd name="connsiteY6" fmla="*/ 300060 h 1893153"/>
                <a:gd name="connsiteX7" fmla="*/ 425073 w 1155449"/>
                <a:gd name="connsiteY7" fmla="*/ 1493 h 1893153"/>
                <a:gd name="connsiteX8" fmla="*/ 1027075 w 1155449"/>
                <a:gd name="connsiteY8" fmla="*/ 427645 h 1893153"/>
                <a:gd name="connsiteX9" fmla="*/ 1146883 w 1155449"/>
                <a:gd name="connsiteY9" fmla="*/ 752501 h 1893153"/>
                <a:gd name="connsiteX10" fmla="*/ 1136188 w 1155449"/>
                <a:gd name="connsiteY10" fmla="*/ 1216988 h 1893153"/>
                <a:gd name="connsiteX11" fmla="*/ 1058955 w 1155449"/>
                <a:gd name="connsiteY11" fmla="*/ 1464100 h 1893153"/>
                <a:gd name="connsiteX0" fmla="*/ 1058955 w 1160861"/>
                <a:gd name="connsiteY0" fmla="*/ 1465862 h 1894915"/>
                <a:gd name="connsiteX1" fmla="*/ 968848 w 1160861"/>
                <a:gd name="connsiteY1" fmla="*/ 1894915 h 1894915"/>
                <a:gd name="connsiteX2" fmla="*/ 828297 w 1160861"/>
                <a:gd name="connsiteY2" fmla="*/ 1693055 h 1894915"/>
                <a:gd name="connsiteX3" fmla="*/ 573380 w 1160861"/>
                <a:gd name="connsiteY3" fmla="*/ 1412844 h 1894915"/>
                <a:gd name="connsiteX4" fmla="*/ 3419 w 1160861"/>
                <a:gd name="connsiteY4" fmla="*/ 1057972 h 1894915"/>
                <a:gd name="connsiteX5" fmla="*/ 57841 w 1160861"/>
                <a:gd name="connsiteY5" fmla="*/ 655633 h 1894915"/>
                <a:gd name="connsiteX6" fmla="*/ 162594 w 1160861"/>
                <a:gd name="connsiteY6" fmla="*/ 301822 h 1894915"/>
                <a:gd name="connsiteX7" fmla="*/ 425073 w 1160861"/>
                <a:gd name="connsiteY7" fmla="*/ 3255 h 1894915"/>
                <a:gd name="connsiteX8" fmla="*/ 954021 w 1160861"/>
                <a:gd name="connsiteY8" fmla="*/ 498321 h 1894915"/>
                <a:gd name="connsiteX9" fmla="*/ 1146883 w 1160861"/>
                <a:gd name="connsiteY9" fmla="*/ 754263 h 1894915"/>
                <a:gd name="connsiteX10" fmla="*/ 1136188 w 1160861"/>
                <a:gd name="connsiteY10" fmla="*/ 1218750 h 1894915"/>
                <a:gd name="connsiteX11" fmla="*/ 1058955 w 1160861"/>
                <a:gd name="connsiteY11" fmla="*/ 1465862 h 1894915"/>
                <a:gd name="connsiteX0" fmla="*/ 1058955 w 1136701"/>
                <a:gd name="connsiteY0" fmla="*/ 1465862 h 1894915"/>
                <a:gd name="connsiteX1" fmla="*/ 968848 w 1136701"/>
                <a:gd name="connsiteY1" fmla="*/ 1894915 h 1894915"/>
                <a:gd name="connsiteX2" fmla="*/ 828297 w 1136701"/>
                <a:gd name="connsiteY2" fmla="*/ 1693055 h 1894915"/>
                <a:gd name="connsiteX3" fmla="*/ 573380 w 1136701"/>
                <a:gd name="connsiteY3" fmla="*/ 1412844 h 1894915"/>
                <a:gd name="connsiteX4" fmla="*/ 3419 w 1136701"/>
                <a:gd name="connsiteY4" fmla="*/ 1057972 h 1894915"/>
                <a:gd name="connsiteX5" fmla="*/ 57841 w 1136701"/>
                <a:gd name="connsiteY5" fmla="*/ 655633 h 1894915"/>
                <a:gd name="connsiteX6" fmla="*/ 162594 w 1136701"/>
                <a:gd name="connsiteY6" fmla="*/ 301822 h 1894915"/>
                <a:gd name="connsiteX7" fmla="*/ 425073 w 1136701"/>
                <a:gd name="connsiteY7" fmla="*/ 3255 h 1894915"/>
                <a:gd name="connsiteX8" fmla="*/ 954021 w 1136701"/>
                <a:gd name="connsiteY8" fmla="*/ 498321 h 1894915"/>
                <a:gd name="connsiteX9" fmla="*/ 1085500 w 1136701"/>
                <a:gd name="connsiteY9" fmla="*/ 786450 h 1894915"/>
                <a:gd name="connsiteX10" fmla="*/ 1136188 w 1136701"/>
                <a:gd name="connsiteY10" fmla="*/ 1218750 h 1894915"/>
                <a:gd name="connsiteX11" fmla="*/ 1058955 w 1136701"/>
                <a:gd name="connsiteY11" fmla="*/ 1465862 h 1894915"/>
                <a:gd name="connsiteX0" fmla="*/ 1058955 w 1136701"/>
                <a:gd name="connsiteY0" fmla="*/ 1464863 h 1893916"/>
                <a:gd name="connsiteX1" fmla="*/ 968848 w 1136701"/>
                <a:gd name="connsiteY1" fmla="*/ 1893916 h 1893916"/>
                <a:gd name="connsiteX2" fmla="*/ 828297 w 1136701"/>
                <a:gd name="connsiteY2" fmla="*/ 1692056 h 1893916"/>
                <a:gd name="connsiteX3" fmla="*/ 573380 w 1136701"/>
                <a:gd name="connsiteY3" fmla="*/ 1411845 h 1893916"/>
                <a:gd name="connsiteX4" fmla="*/ 3419 w 1136701"/>
                <a:gd name="connsiteY4" fmla="*/ 1056973 h 1893916"/>
                <a:gd name="connsiteX5" fmla="*/ 57841 w 1136701"/>
                <a:gd name="connsiteY5" fmla="*/ 654634 h 1893916"/>
                <a:gd name="connsiteX6" fmla="*/ 162594 w 1136701"/>
                <a:gd name="connsiteY6" fmla="*/ 300823 h 1893916"/>
                <a:gd name="connsiteX7" fmla="*/ 425073 w 1136701"/>
                <a:gd name="connsiteY7" fmla="*/ 2256 h 1893916"/>
                <a:gd name="connsiteX8" fmla="*/ 954021 w 1136701"/>
                <a:gd name="connsiteY8" fmla="*/ 497322 h 1893916"/>
                <a:gd name="connsiteX9" fmla="*/ 1085500 w 1136701"/>
                <a:gd name="connsiteY9" fmla="*/ 785451 h 1893916"/>
                <a:gd name="connsiteX10" fmla="*/ 1136188 w 1136701"/>
                <a:gd name="connsiteY10" fmla="*/ 1217751 h 1893916"/>
                <a:gd name="connsiteX11" fmla="*/ 1058955 w 1136701"/>
                <a:gd name="connsiteY11" fmla="*/ 1464863 h 1893916"/>
                <a:gd name="connsiteX0" fmla="*/ 1058955 w 1136701"/>
                <a:gd name="connsiteY0" fmla="*/ 1418376 h 1847429"/>
                <a:gd name="connsiteX1" fmla="*/ 968848 w 1136701"/>
                <a:gd name="connsiteY1" fmla="*/ 1847429 h 1847429"/>
                <a:gd name="connsiteX2" fmla="*/ 828297 w 1136701"/>
                <a:gd name="connsiteY2" fmla="*/ 1645569 h 1847429"/>
                <a:gd name="connsiteX3" fmla="*/ 573380 w 1136701"/>
                <a:gd name="connsiteY3" fmla="*/ 1365358 h 1847429"/>
                <a:gd name="connsiteX4" fmla="*/ 3419 w 1136701"/>
                <a:gd name="connsiteY4" fmla="*/ 1010486 h 1847429"/>
                <a:gd name="connsiteX5" fmla="*/ 57841 w 1136701"/>
                <a:gd name="connsiteY5" fmla="*/ 608147 h 1847429"/>
                <a:gd name="connsiteX6" fmla="*/ 162594 w 1136701"/>
                <a:gd name="connsiteY6" fmla="*/ 254336 h 1847429"/>
                <a:gd name="connsiteX7" fmla="*/ 617143 w 1136701"/>
                <a:gd name="connsiteY7" fmla="*/ 2699 h 1847429"/>
                <a:gd name="connsiteX8" fmla="*/ 954021 w 1136701"/>
                <a:gd name="connsiteY8" fmla="*/ 450835 h 1847429"/>
                <a:gd name="connsiteX9" fmla="*/ 1085500 w 1136701"/>
                <a:gd name="connsiteY9" fmla="*/ 738964 h 1847429"/>
                <a:gd name="connsiteX10" fmla="*/ 1136188 w 1136701"/>
                <a:gd name="connsiteY10" fmla="*/ 1171264 h 1847429"/>
                <a:gd name="connsiteX11" fmla="*/ 1058955 w 1136701"/>
                <a:gd name="connsiteY11" fmla="*/ 1418376 h 1847429"/>
                <a:gd name="connsiteX0" fmla="*/ 1059118 w 1136864"/>
                <a:gd name="connsiteY0" fmla="*/ 1419678 h 1848731"/>
                <a:gd name="connsiteX1" fmla="*/ 969011 w 1136864"/>
                <a:gd name="connsiteY1" fmla="*/ 1848731 h 1848731"/>
                <a:gd name="connsiteX2" fmla="*/ 828460 w 1136864"/>
                <a:gd name="connsiteY2" fmla="*/ 1646871 h 1848731"/>
                <a:gd name="connsiteX3" fmla="*/ 573543 w 1136864"/>
                <a:gd name="connsiteY3" fmla="*/ 1366660 h 1848731"/>
                <a:gd name="connsiteX4" fmla="*/ 3582 w 1136864"/>
                <a:gd name="connsiteY4" fmla="*/ 1011788 h 1848731"/>
                <a:gd name="connsiteX5" fmla="*/ 58004 w 1136864"/>
                <a:gd name="connsiteY5" fmla="*/ 609449 h 1848731"/>
                <a:gd name="connsiteX6" fmla="*/ 179704 w 1136864"/>
                <a:gd name="connsiteY6" fmla="*/ 252986 h 1848731"/>
                <a:gd name="connsiteX7" fmla="*/ 617306 w 1136864"/>
                <a:gd name="connsiteY7" fmla="*/ 4001 h 1848731"/>
                <a:gd name="connsiteX8" fmla="*/ 954184 w 1136864"/>
                <a:gd name="connsiteY8" fmla="*/ 452137 h 1848731"/>
                <a:gd name="connsiteX9" fmla="*/ 1085663 w 1136864"/>
                <a:gd name="connsiteY9" fmla="*/ 740266 h 1848731"/>
                <a:gd name="connsiteX10" fmla="*/ 1136351 w 1136864"/>
                <a:gd name="connsiteY10" fmla="*/ 1172566 h 1848731"/>
                <a:gd name="connsiteX11" fmla="*/ 1059118 w 1136864"/>
                <a:gd name="connsiteY11" fmla="*/ 1419678 h 1848731"/>
                <a:gd name="connsiteX0" fmla="*/ 1059118 w 1136864"/>
                <a:gd name="connsiteY0" fmla="*/ 1420189 h 1849242"/>
                <a:gd name="connsiteX1" fmla="*/ 969011 w 1136864"/>
                <a:gd name="connsiteY1" fmla="*/ 1849242 h 1849242"/>
                <a:gd name="connsiteX2" fmla="*/ 828460 w 1136864"/>
                <a:gd name="connsiteY2" fmla="*/ 1647382 h 1849242"/>
                <a:gd name="connsiteX3" fmla="*/ 573543 w 1136864"/>
                <a:gd name="connsiteY3" fmla="*/ 1367171 h 1849242"/>
                <a:gd name="connsiteX4" fmla="*/ 3582 w 1136864"/>
                <a:gd name="connsiteY4" fmla="*/ 1012299 h 1849242"/>
                <a:gd name="connsiteX5" fmla="*/ 58004 w 1136864"/>
                <a:gd name="connsiteY5" fmla="*/ 609960 h 1849242"/>
                <a:gd name="connsiteX6" fmla="*/ 179704 w 1136864"/>
                <a:gd name="connsiteY6" fmla="*/ 253497 h 1849242"/>
                <a:gd name="connsiteX7" fmla="*/ 617306 w 1136864"/>
                <a:gd name="connsiteY7" fmla="*/ 4512 h 1849242"/>
                <a:gd name="connsiteX8" fmla="*/ 954184 w 1136864"/>
                <a:gd name="connsiteY8" fmla="*/ 452648 h 1849242"/>
                <a:gd name="connsiteX9" fmla="*/ 1085663 w 1136864"/>
                <a:gd name="connsiteY9" fmla="*/ 740777 h 1849242"/>
                <a:gd name="connsiteX10" fmla="*/ 1136351 w 1136864"/>
                <a:gd name="connsiteY10" fmla="*/ 1173077 h 1849242"/>
                <a:gd name="connsiteX11" fmla="*/ 1059118 w 1136864"/>
                <a:gd name="connsiteY11" fmla="*/ 1420189 h 1849242"/>
                <a:gd name="connsiteX0" fmla="*/ 1059118 w 1136864"/>
                <a:gd name="connsiteY0" fmla="*/ 1420429 h 1849482"/>
                <a:gd name="connsiteX1" fmla="*/ 969011 w 1136864"/>
                <a:gd name="connsiteY1" fmla="*/ 1849482 h 1849482"/>
                <a:gd name="connsiteX2" fmla="*/ 828460 w 1136864"/>
                <a:gd name="connsiteY2" fmla="*/ 1647622 h 1849482"/>
                <a:gd name="connsiteX3" fmla="*/ 573543 w 1136864"/>
                <a:gd name="connsiteY3" fmla="*/ 1367411 h 1849482"/>
                <a:gd name="connsiteX4" fmla="*/ 3582 w 1136864"/>
                <a:gd name="connsiteY4" fmla="*/ 1012539 h 1849482"/>
                <a:gd name="connsiteX5" fmla="*/ 58004 w 1136864"/>
                <a:gd name="connsiteY5" fmla="*/ 610200 h 1849482"/>
                <a:gd name="connsiteX6" fmla="*/ 179704 w 1136864"/>
                <a:gd name="connsiteY6" fmla="*/ 253737 h 1849482"/>
                <a:gd name="connsiteX7" fmla="*/ 617306 w 1136864"/>
                <a:gd name="connsiteY7" fmla="*/ 4752 h 1849482"/>
                <a:gd name="connsiteX8" fmla="*/ 954184 w 1136864"/>
                <a:gd name="connsiteY8" fmla="*/ 452888 h 1849482"/>
                <a:gd name="connsiteX9" fmla="*/ 1085663 w 1136864"/>
                <a:gd name="connsiteY9" fmla="*/ 741017 h 1849482"/>
                <a:gd name="connsiteX10" fmla="*/ 1136351 w 1136864"/>
                <a:gd name="connsiteY10" fmla="*/ 1173317 h 1849482"/>
                <a:gd name="connsiteX11" fmla="*/ 1059118 w 1136864"/>
                <a:gd name="connsiteY11" fmla="*/ 1420429 h 1849482"/>
                <a:gd name="connsiteX0" fmla="*/ 1059118 w 1136864"/>
                <a:gd name="connsiteY0" fmla="*/ 1425502 h 1854555"/>
                <a:gd name="connsiteX1" fmla="*/ 969011 w 1136864"/>
                <a:gd name="connsiteY1" fmla="*/ 1854555 h 1854555"/>
                <a:gd name="connsiteX2" fmla="*/ 828460 w 1136864"/>
                <a:gd name="connsiteY2" fmla="*/ 1652695 h 1854555"/>
                <a:gd name="connsiteX3" fmla="*/ 573543 w 1136864"/>
                <a:gd name="connsiteY3" fmla="*/ 1372484 h 1854555"/>
                <a:gd name="connsiteX4" fmla="*/ 3582 w 1136864"/>
                <a:gd name="connsiteY4" fmla="*/ 1017612 h 1854555"/>
                <a:gd name="connsiteX5" fmla="*/ 58004 w 1136864"/>
                <a:gd name="connsiteY5" fmla="*/ 615273 h 1854555"/>
                <a:gd name="connsiteX6" fmla="*/ 179704 w 1136864"/>
                <a:gd name="connsiteY6" fmla="*/ 258810 h 1854555"/>
                <a:gd name="connsiteX7" fmla="*/ 617306 w 1136864"/>
                <a:gd name="connsiteY7" fmla="*/ 9825 h 1854555"/>
                <a:gd name="connsiteX8" fmla="*/ 954184 w 1136864"/>
                <a:gd name="connsiteY8" fmla="*/ 457961 h 1854555"/>
                <a:gd name="connsiteX9" fmla="*/ 1085663 w 1136864"/>
                <a:gd name="connsiteY9" fmla="*/ 746090 h 1854555"/>
                <a:gd name="connsiteX10" fmla="*/ 1136351 w 1136864"/>
                <a:gd name="connsiteY10" fmla="*/ 1178390 h 1854555"/>
                <a:gd name="connsiteX11" fmla="*/ 1059118 w 1136864"/>
                <a:gd name="connsiteY11" fmla="*/ 1425502 h 1854555"/>
                <a:gd name="connsiteX0" fmla="*/ 1059118 w 1136864"/>
                <a:gd name="connsiteY0" fmla="*/ 1440384 h 1869437"/>
                <a:gd name="connsiteX1" fmla="*/ 969011 w 1136864"/>
                <a:gd name="connsiteY1" fmla="*/ 1869437 h 1869437"/>
                <a:gd name="connsiteX2" fmla="*/ 828460 w 1136864"/>
                <a:gd name="connsiteY2" fmla="*/ 1667577 h 1869437"/>
                <a:gd name="connsiteX3" fmla="*/ 573543 w 1136864"/>
                <a:gd name="connsiteY3" fmla="*/ 1387366 h 1869437"/>
                <a:gd name="connsiteX4" fmla="*/ 3582 w 1136864"/>
                <a:gd name="connsiteY4" fmla="*/ 1032494 h 1869437"/>
                <a:gd name="connsiteX5" fmla="*/ 58004 w 1136864"/>
                <a:gd name="connsiteY5" fmla="*/ 630155 h 1869437"/>
                <a:gd name="connsiteX6" fmla="*/ 179704 w 1136864"/>
                <a:gd name="connsiteY6" fmla="*/ 273692 h 1869437"/>
                <a:gd name="connsiteX7" fmla="*/ 618811 w 1136864"/>
                <a:gd name="connsiteY7" fmla="*/ 8048 h 1869437"/>
                <a:gd name="connsiteX8" fmla="*/ 954184 w 1136864"/>
                <a:gd name="connsiteY8" fmla="*/ 472843 h 1869437"/>
                <a:gd name="connsiteX9" fmla="*/ 1085663 w 1136864"/>
                <a:gd name="connsiteY9" fmla="*/ 760972 h 1869437"/>
                <a:gd name="connsiteX10" fmla="*/ 1136351 w 1136864"/>
                <a:gd name="connsiteY10" fmla="*/ 1193272 h 1869437"/>
                <a:gd name="connsiteX11" fmla="*/ 1059118 w 1136864"/>
                <a:gd name="connsiteY11" fmla="*/ 1440384 h 1869437"/>
                <a:gd name="connsiteX0" fmla="*/ 1059118 w 1136864"/>
                <a:gd name="connsiteY0" fmla="*/ 1440852 h 1869905"/>
                <a:gd name="connsiteX1" fmla="*/ 969011 w 1136864"/>
                <a:gd name="connsiteY1" fmla="*/ 1869905 h 1869905"/>
                <a:gd name="connsiteX2" fmla="*/ 828460 w 1136864"/>
                <a:gd name="connsiteY2" fmla="*/ 1668045 h 1869905"/>
                <a:gd name="connsiteX3" fmla="*/ 573543 w 1136864"/>
                <a:gd name="connsiteY3" fmla="*/ 1387834 h 1869905"/>
                <a:gd name="connsiteX4" fmla="*/ 3582 w 1136864"/>
                <a:gd name="connsiteY4" fmla="*/ 1032962 h 1869905"/>
                <a:gd name="connsiteX5" fmla="*/ 58004 w 1136864"/>
                <a:gd name="connsiteY5" fmla="*/ 630623 h 1869905"/>
                <a:gd name="connsiteX6" fmla="*/ 179704 w 1136864"/>
                <a:gd name="connsiteY6" fmla="*/ 274160 h 1869905"/>
                <a:gd name="connsiteX7" fmla="*/ 618811 w 1136864"/>
                <a:gd name="connsiteY7" fmla="*/ 8516 h 1869905"/>
                <a:gd name="connsiteX8" fmla="*/ 954184 w 1136864"/>
                <a:gd name="connsiteY8" fmla="*/ 473311 h 1869905"/>
                <a:gd name="connsiteX9" fmla="*/ 1085663 w 1136864"/>
                <a:gd name="connsiteY9" fmla="*/ 761440 h 1869905"/>
                <a:gd name="connsiteX10" fmla="*/ 1136351 w 1136864"/>
                <a:gd name="connsiteY10" fmla="*/ 1193740 h 1869905"/>
                <a:gd name="connsiteX11" fmla="*/ 1059118 w 1136864"/>
                <a:gd name="connsiteY11" fmla="*/ 1440852 h 1869905"/>
                <a:gd name="connsiteX0" fmla="*/ 1059118 w 1136701"/>
                <a:gd name="connsiteY0" fmla="*/ 1436463 h 1865516"/>
                <a:gd name="connsiteX1" fmla="*/ 969011 w 1136701"/>
                <a:gd name="connsiteY1" fmla="*/ 1865516 h 1865516"/>
                <a:gd name="connsiteX2" fmla="*/ 828460 w 1136701"/>
                <a:gd name="connsiteY2" fmla="*/ 1663656 h 1865516"/>
                <a:gd name="connsiteX3" fmla="*/ 573543 w 1136701"/>
                <a:gd name="connsiteY3" fmla="*/ 1383445 h 1865516"/>
                <a:gd name="connsiteX4" fmla="*/ 3582 w 1136701"/>
                <a:gd name="connsiteY4" fmla="*/ 1028573 h 1865516"/>
                <a:gd name="connsiteX5" fmla="*/ 58004 w 1136701"/>
                <a:gd name="connsiteY5" fmla="*/ 626234 h 1865516"/>
                <a:gd name="connsiteX6" fmla="*/ 179704 w 1136701"/>
                <a:gd name="connsiteY6" fmla="*/ 269771 h 1865516"/>
                <a:gd name="connsiteX7" fmla="*/ 618811 w 1136701"/>
                <a:gd name="connsiteY7" fmla="*/ 4127 h 1865516"/>
                <a:gd name="connsiteX8" fmla="*/ 1037413 w 1136701"/>
                <a:gd name="connsiteY8" fmla="*/ 472322 h 1865516"/>
                <a:gd name="connsiteX9" fmla="*/ 1085663 w 1136701"/>
                <a:gd name="connsiteY9" fmla="*/ 757051 h 1865516"/>
                <a:gd name="connsiteX10" fmla="*/ 1136351 w 1136701"/>
                <a:gd name="connsiteY10" fmla="*/ 1189351 h 1865516"/>
                <a:gd name="connsiteX11" fmla="*/ 1059118 w 1136701"/>
                <a:gd name="connsiteY11" fmla="*/ 1436463 h 1865516"/>
                <a:gd name="connsiteX0" fmla="*/ 1059118 w 1158467"/>
                <a:gd name="connsiteY0" fmla="*/ 1436463 h 1865516"/>
                <a:gd name="connsiteX1" fmla="*/ 969011 w 1158467"/>
                <a:gd name="connsiteY1" fmla="*/ 1865516 h 1865516"/>
                <a:gd name="connsiteX2" fmla="*/ 828460 w 1158467"/>
                <a:gd name="connsiteY2" fmla="*/ 1663656 h 1865516"/>
                <a:gd name="connsiteX3" fmla="*/ 573543 w 1158467"/>
                <a:gd name="connsiteY3" fmla="*/ 1383445 h 1865516"/>
                <a:gd name="connsiteX4" fmla="*/ 3582 w 1158467"/>
                <a:gd name="connsiteY4" fmla="*/ 1028573 h 1865516"/>
                <a:gd name="connsiteX5" fmla="*/ 58004 w 1158467"/>
                <a:gd name="connsiteY5" fmla="*/ 626234 h 1865516"/>
                <a:gd name="connsiteX6" fmla="*/ 179704 w 1158467"/>
                <a:gd name="connsiteY6" fmla="*/ 269771 h 1865516"/>
                <a:gd name="connsiteX7" fmla="*/ 618811 w 1158467"/>
                <a:gd name="connsiteY7" fmla="*/ 4127 h 1865516"/>
                <a:gd name="connsiteX8" fmla="*/ 1037413 w 1158467"/>
                <a:gd name="connsiteY8" fmla="*/ 472322 h 1865516"/>
                <a:gd name="connsiteX9" fmla="*/ 1151569 w 1158467"/>
                <a:gd name="connsiteY9" fmla="*/ 767268 h 1865516"/>
                <a:gd name="connsiteX10" fmla="*/ 1136351 w 1158467"/>
                <a:gd name="connsiteY10" fmla="*/ 1189351 h 1865516"/>
                <a:gd name="connsiteX11" fmla="*/ 1059118 w 1158467"/>
                <a:gd name="connsiteY11" fmla="*/ 1436463 h 1865516"/>
                <a:gd name="connsiteX0" fmla="*/ 1102430 w 1157299"/>
                <a:gd name="connsiteY0" fmla="*/ 1465612 h 1865516"/>
                <a:gd name="connsiteX1" fmla="*/ 969011 w 1157299"/>
                <a:gd name="connsiteY1" fmla="*/ 1865516 h 1865516"/>
                <a:gd name="connsiteX2" fmla="*/ 828460 w 1157299"/>
                <a:gd name="connsiteY2" fmla="*/ 1663656 h 1865516"/>
                <a:gd name="connsiteX3" fmla="*/ 573543 w 1157299"/>
                <a:gd name="connsiteY3" fmla="*/ 1383445 h 1865516"/>
                <a:gd name="connsiteX4" fmla="*/ 3582 w 1157299"/>
                <a:gd name="connsiteY4" fmla="*/ 1028573 h 1865516"/>
                <a:gd name="connsiteX5" fmla="*/ 58004 w 1157299"/>
                <a:gd name="connsiteY5" fmla="*/ 626234 h 1865516"/>
                <a:gd name="connsiteX6" fmla="*/ 179704 w 1157299"/>
                <a:gd name="connsiteY6" fmla="*/ 269771 h 1865516"/>
                <a:gd name="connsiteX7" fmla="*/ 618811 w 1157299"/>
                <a:gd name="connsiteY7" fmla="*/ 4127 h 1865516"/>
                <a:gd name="connsiteX8" fmla="*/ 1037413 w 1157299"/>
                <a:gd name="connsiteY8" fmla="*/ 472322 h 1865516"/>
                <a:gd name="connsiteX9" fmla="*/ 1151569 w 1157299"/>
                <a:gd name="connsiteY9" fmla="*/ 767268 h 1865516"/>
                <a:gd name="connsiteX10" fmla="*/ 1136351 w 1157299"/>
                <a:gd name="connsiteY10" fmla="*/ 1189351 h 1865516"/>
                <a:gd name="connsiteX11" fmla="*/ 1102430 w 1157299"/>
                <a:gd name="connsiteY11" fmla="*/ 1465612 h 1865516"/>
                <a:gd name="connsiteX0" fmla="*/ 1102430 w 1157299"/>
                <a:gd name="connsiteY0" fmla="*/ 1465612 h 1865516"/>
                <a:gd name="connsiteX1" fmla="*/ 969011 w 1157299"/>
                <a:gd name="connsiteY1" fmla="*/ 1865516 h 1865516"/>
                <a:gd name="connsiteX2" fmla="*/ 828460 w 1157299"/>
                <a:gd name="connsiteY2" fmla="*/ 1663656 h 1865516"/>
                <a:gd name="connsiteX3" fmla="*/ 573543 w 1157299"/>
                <a:gd name="connsiteY3" fmla="*/ 1383445 h 1865516"/>
                <a:gd name="connsiteX4" fmla="*/ 3582 w 1157299"/>
                <a:gd name="connsiteY4" fmla="*/ 1028573 h 1865516"/>
                <a:gd name="connsiteX5" fmla="*/ 58004 w 1157299"/>
                <a:gd name="connsiteY5" fmla="*/ 626234 h 1865516"/>
                <a:gd name="connsiteX6" fmla="*/ 179704 w 1157299"/>
                <a:gd name="connsiteY6" fmla="*/ 269771 h 1865516"/>
                <a:gd name="connsiteX7" fmla="*/ 618811 w 1157299"/>
                <a:gd name="connsiteY7" fmla="*/ 4127 h 1865516"/>
                <a:gd name="connsiteX8" fmla="*/ 1037413 w 1157299"/>
                <a:gd name="connsiteY8" fmla="*/ 472322 h 1865516"/>
                <a:gd name="connsiteX9" fmla="*/ 1151569 w 1157299"/>
                <a:gd name="connsiteY9" fmla="*/ 767268 h 1865516"/>
                <a:gd name="connsiteX10" fmla="*/ 1136351 w 1157299"/>
                <a:gd name="connsiteY10" fmla="*/ 1189351 h 1865516"/>
                <a:gd name="connsiteX11" fmla="*/ 1102430 w 1157299"/>
                <a:gd name="connsiteY11" fmla="*/ 1465612 h 1865516"/>
                <a:gd name="connsiteX0" fmla="*/ 1102430 w 1157299"/>
                <a:gd name="connsiteY0" fmla="*/ 1465612 h 1865516"/>
                <a:gd name="connsiteX1" fmla="*/ 969011 w 1157299"/>
                <a:gd name="connsiteY1" fmla="*/ 1865516 h 1865516"/>
                <a:gd name="connsiteX2" fmla="*/ 828460 w 1157299"/>
                <a:gd name="connsiteY2" fmla="*/ 1663656 h 1865516"/>
                <a:gd name="connsiteX3" fmla="*/ 573543 w 1157299"/>
                <a:gd name="connsiteY3" fmla="*/ 1383445 h 1865516"/>
                <a:gd name="connsiteX4" fmla="*/ 3582 w 1157299"/>
                <a:gd name="connsiteY4" fmla="*/ 1028573 h 1865516"/>
                <a:gd name="connsiteX5" fmla="*/ 58004 w 1157299"/>
                <a:gd name="connsiteY5" fmla="*/ 626234 h 1865516"/>
                <a:gd name="connsiteX6" fmla="*/ 179704 w 1157299"/>
                <a:gd name="connsiteY6" fmla="*/ 269771 h 1865516"/>
                <a:gd name="connsiteX7" fmla="*/ 618811 w 1157299"/>
                <a:gd name="connsiteY7" fmla="*/ 4127 h 1865516"/>
                <a:gd name="connsiteX8" fmla="*/ 1037413 w 1157299"/>
                <a:gd name="connsiteY8" fmla="*/ 472322 h 1865516"/>
                <a:gd name="connsiteX9" fmla="*/ 1151569 w 1157299"/>
                <a:gd name="connsiteY9" fmla="*/ 767268 h 1865516"/>
                <a:gd name="connsiteX10" fmla="*/ 1136351 w 1157299"/>
                <a:gd name="connsiteY10" fmla="*/ 1189351 h 1865516"/>
                <a:gd name="connsiteX11" fmla="*/ 1102430 w 1157299"/>
                <a:gd name="connsiteY11" fmla="*/ 1465612 h 1865516"/>
                <a:gd name="connsiteX0" fmla="*/ 1191310 w 1222094"/>
                <a:gd name="connsiteY0" fmla="*/ 1498922 h 1865516"/>
                <a:gd name="connsiteX1" fmla="*/ 969011 w 1222094"/>
                <a:gd name="connsiteY1" fmla="*/ 1865516 h 1865516"/>
                <a:gd name="connsiteX2" fmla="*/ 828460 w 1222094"/>
                <a:gd name="connsiteY2" fmla="*/ 1663656 h 1865516"/>
                <a:gd name="connsiteX3" fmla="*/ 573543 w 1222094"/>
                <a:gd name="connsiteY3" fmla="*/ 1383445 h 1865516"/>
                <a:gd name="connsiteX4" fmla="*/ 3582 w 1222094"/>
                <a:gd name="connsiteY4" fmla="*/ 1028573 h 1865516"/>
                <a:gd name="connsiteX5" fmla="*/ 58004 w 1222094"/>
                <a:gd name="connsiteY5" fmla="*/ 626234 h 1865516"/>
                <a:gd name="connsiteX6" fmla="*/ 179704 w 1222094"/>
                <a:gd name="connsiteY6" fmla="*/ 269771 h 1865516"/>
                <a:gd name="connsiteX7" fmla="*/ 618811 w 1222094"/>
                <a:gd name="connsiteY7" fmla="*/ 4127 h 1865516"/>
                <a:gd name="connsiteX8" fmla="*/ 1037413 w 1222094"/>
                <a:gd name="connsiteY8" fmla="*/ 472322 h 1865516"/>
                <a:gd name="connsiteX9" fmla="*/ 1151569 w 1222094"/>
                <a:gd name="connsiteY9" fmla="*/ 767268 h 1865516"/>
                <a:gd name="connsiteX10" fmla="*/ 1136351 w 1222094"/>
                <a:gd name="connsiteY10" fmla="*/ 1189351 h 1865516"/>
                <a:gd name="connsiteX11" fmla="*/ 1191310 w 1222094"/>
                <a:gd name="connsiteY11" fmla="*/ 1498922 h 1865516"/>
                <a:gd name="connsiteX0" fmla="*/ 1191310 w 1276779"/>
                <a:gd name="connsiteY0" fmla="*/ 1498922 h 1865516"/>
                <a:gd name="connsiteX1" fmla="*/ 969011 w 1276779"/>
                <a:gd name="connsiteY1" fmla="*/ 1865516 h 1865516"/>
                <a:gd name="connsiteX2" fmla="*/ 828460 w 1276779"/>
                <a:gd name="connsiteY2" fmla="*/ 1663656 h 1865516"/>
                <a:gd name="connsiteX3" fmla="*/ 573543 w 1276779"/>
                <a:gd name="connsiteY3" fmla="*/ 1383445 h 1865516"/>
                <a:gd name="connsiteX4" fmla="*/ 3582 w 1276779"/>
                <a:gd name="connsiteY4" fmla="*/ 1028573 h 1865516"/>
                <a:gd name="connsiteX5" fmla="*/ 58004 w 1276779"/>
                <a:gd name="connsiteY5" fmla="*/ 626234 h 1865516"/>
                <a:gd name="connsiteX6" fmla="*/ 179704 w 1276779"/>
                <a:gd name="connsiteY6" fmla="*/ 269771 h 1865516"/>
                <a:gd name="connsiteX7" fmla="*/ 618811 w 1276779"/>
                <a:gd name="connsiteY7" fmla="*/ 4127 h 1865516"/>
                <a:gd name="connsiteX8" fmla="*/ 1037413 w 1276779"/>
                <a:gd name="connsiteY8" fmla="*/ 472322 h 1865516"/>
                <a:gd name="connsiteX9" fmla="*/ 1151569 w 1276779"/>
                <a:gd name="connsiteY9" fmla="*/ 767268 h 1865516"/>
                <a:gd name="connsiteX10" fmla="*/ 1276064 w 1276779"/>
                <a:gd name="connsiteY10" fmla="*/ 1122324 h 1865516"/>
                <a:gd name="connsiteX11" fmla="*/ 1191310 w 1276779"/>
                <a:gd name="connsiteY11" fmla="*/ 1498922 h 1865516"/>
                <a:gd name="connsiteX0" fmla="*/ 1191310 w 1276451"/>
                <a:gd name="connsiteY0" fmla="*/ 1498922 h 1865516"/>
                <a:gd name="connsiteX1" fmla="*/ 969011 w 1276451"/>
                <a:gd name="connsiteY1" fmla="*/ 1865516 h 1865516"/>
                <a:gd name="connsiteX2" fmla="*/ 828460 w 1276451"/>
                <a:gd name="connsiteY2" fmla="*/ 1663656 h 1865516"/>
                <a:gd name="connsiteX3" fmla="*/ 573543 w 1276451"/>
                <a:gd name="connsiteY3" fmla="*/ 1383445 h 1865516"/>
                <a:gd name="connsiteX4" fmla="*/ 3582 w 1276451"/>
                <a:gd name="connsiteY4" fmla="*/ 1028573 h 1865516"/>
                <a:gd name="connsiteX5" fmla="*/ 58004 w 1276451"/>
                <a:gd name="connsiteY5" fmla="*/ 626234 h 1865516"/>
                <a:gd name="connsiteX6" fmla="*/ 179704 w 1276451"/>
                <a:gd name="connsiteY6" fmla="*/ 269771 h 1865516"/>
                <a:gd name="connsiteX7" fmla="*/ 618811 w 1276451"/>
                <a:gd name="connsiteY7" fmla="*/ 4127 h 1865516"/>
                <a:gd name="connsiteX8" fmla="*/ 1037413 w 1276451"/>
                <a:gd name="connsiteY8" fmla="*/ 472322 h 1865516"/>
                <a:gd name="connsiteX9" fmla="*/ 1163241 w 1276451"/>
                <a:gd name="connsiteY9" fmla="*/ 730541 h 1865516"/>
                <a:gd name="connsiteX10" fmla="*/ 1276064 w 1276451"/>
                <a:gd name="connsiteY10" fmla="*/ 1122324 h 1865516"/>
                <a:gd name="connsiteX11" fmla="*/ 1191310 w 1276451"/>
                <a:gd name="connsiteY11" fmla="*/ 1498922 h 1865516"/>
                <a:gd name="connsiteX0" fmla="*/ 1191310 w 1276451"/>
                <a:gd name="connsiteY0" fmla="*/ 1232280 h 1598874"/>
                <a:gd name="connsiteX1" fmla="*/ 969011 w 1276451"/>
                <a:gd name="connsiteY1" fmla="*/ 1598874 h 1598874"/>
                <a:gd name="connsiteX2" fmla="*/ 828460 w 1276451"/>
                <a:gd name="connsiteY2" fmla="*/ 1397014 h 1598874"/>
                <a:gd name="connsiteX3" fmla="*/ 573543 w 1276451"/>
                <a:gd name="connsiteY3" fmla="*/ 1116803 h 1598874"/>
                <a:gd name="connsiteX4" fmla="*/ 3582 w 1276451"/>
                <a:gd name="connsiteY4" fmla="*/ 761931 h 1598874"/>
                <a:gd name="connsiteX5" fmla="*/ 58004 w 1276451"/>
                <a:gd name="connsiteY5" fmla="*/ 359592 h 1598874"/>
                <a:gd name="connsiteX6" fmla="*/ 179704 w 1276451"/>
                <a:gd name="connsiteY6" fmla="*/ 3129 h 1598874"/>
                <a:gd name="connsiteX7" fmla="*/ 710489 w 1276451"/>
                <a:gd name="connsiteY7" fmla="*/ 186761 h 1598874"/>
                <a:gd name="connsiteX8" fmla="*/ 1037413 w 1276451"/>
                <a:gd name="connsiteY8" fmla="*/ 205680 h 1598874"/>
                <a:gd name="connsiteX9" fmla="*/ 1163241 w 1276451"/>
                <a:gd name="connsiteY9" fmla="*/ 463899 h 1598874"/>
                <a:gd name="connsiteX10" fmla="*/ 1276064 w 1276451"/>
                <a:gd name="connsiteY10" fmla="*/ 855682 h 1598874"/>
                <a:gd name="connsiteX11" fmla="*/ 1191310 w 1276451"/>
                <a:gd name="connsiteY11" fmla="*/ 1232280 h 1598874"/>
                <a:gd name="connsiteX0" fmla="*/ 1192232 w 1277373"/>
                <a:gd name="connsiteY0" fmla="*/ 1066035 h 1432629"/>
                <a:gd name="connsiteX1" fmla="*/ 969933 w 1277373"/>
                <a:gd name="connsiteY1" fmla="*/ 1432629 h 1432629"/>
                <a:gd name="connsiteX2" fmla="*/ 829382 w 1277373"/>
                <a:gd name="connsiteY2" fmla="*/ 1230769 h 1432629"/>
                <a:gd name="connsiteX3" fmla="*/ 574465 w 1277373"/>
                <a:gd name="connsiteY3" fmla="*/ 950558 h 1432629"/>
                <a:gd name="connsiteX4" fmla="*/ 4504 w 1277373"/>
                <a:gd name="connsiteY4" fmla="*/ 595686 h 1432629"/>
                <a:gd name="connsiteX5" fmla="*/ 58926 w 1277373"/>
                <a:gd name="connsiteY5" fmla="*/ 193347 h 1432629"/>
                <a:gd name="connsiteX6" fmla="*/ 255334 w 1277373"/>
                <a:gd name="connsiteY6" fmla="*/ 11668 h 1432629"/>
                <a:gd name="connsiteX7" fmla="*/ 711411 w 1277373"/>
                <a:gd name="connsiteY7" fmla="*/ 20516 h 1432629"/>
                <a:gd name="connsiteX8" fmla="*/ 1038335 w 1277373"/>
                <a:gd name="connsiteY8" fmla="*/ 39435 h 1432629"/>
                <a:gd name="connsiteX9" fmla="*/ 1164163 w 1277373"/>
                <a:gd name="connsiteY9" fmla="*/ 297654 h 1432629"/>
                <a:gd name="connsiteX10" fmla="*/ 1276986 w 1277373"/>
                <a:gd name="connsiteY10" fmla="*/ 689437 h 1432629"/>
                <a:gd name="connsiteX11" fmla="*/ 1192232 w 1277373"/>
                <a:gd name="connsiteY11" fmla="*/ 1066035 h 1432629"/>
                <a:gd name="connsiteX0" fmla="*/ 1192232 w 1277373"/>
                <a:gd name="connsiteY0" fmla="*/ 1073024 h 1439618"/>
                <a:gd name="connsiteX1" fmla="*/ 969933 w 1277373"/>
                <a:gd name="connsiteY1" fmla="*/ 1439618 h 1439618"/>
                <a:gd name="connsiteX2" fmla="*/ 829382 w 1277373"/>
                <a:gd name="connsiteY2" fmla="*/ 1237758 h 1439618"/>
                <a:gd name="connsiteX3" fmla="*/ 574465 w 1277373"/>
                <a:gd name="connsiteY3" fmla="*/ 957547 h 1439618"/>
                <a:gd name="connsiteX4" fmla="*/ 4504 w 1277373"/>
                <a:gd name="connsiteY4" fmla="*/ 602675 h 1439618"/>
                <a:gd name="connsiteX5" fmla="*/ 58926 w 1277373"/>
                <a:gd name="connsiteY5" fmla="*/ 200336 h 1439618"/>
                <a:gd name="connsiteX6" fmla="*/ 255334 w 1277373"/>
                <a:gd name="connsiteY6" fmla="*/ 18657 h 1439618"/>
                <a:gd name="connsiteX7" fmla="*/ 711411 w 1277373"/>
                <a:gd name="connsiteY7" fmla="*/ 27505 h 1439618"/>
                <a:gd name="connsiteX8" fmla="*/ 912189 w 1277373"/>
                <a:gd name="connsiteY8" fmla="*/ 209868 h 1439618"/>
                <a:gd name="connsiteX9" fmla="*/ 1164163 w 1277373"/>
                <a:gd name="connsiteY9" fmla="*/ 304643 h 1439618"/>
                <a:gd name="connsiteX10" fmla="*/ 1276986 w 1277373"/>
                <a:gd name="connsiteY10" fmla="*/ 696426 h 1439618"/>
                <a:gd name="connsiteX11" fmla="*/ 1192232 w 1277373"/>
                <a:gd name="connsiteY11" fmla="*/ 1073024 h 1439618"/>
                <a:gd name="connsiteX0" fmla="*/ 1192232 w 1280506"/>
                <a:gd name="connsiteY0" fmla="*/ 1073024 h 1439618"/>
                <a:gd name="connsiteX1" fmla="*/ 969933 w 1280506"/>
                <a:gd name="connsiteY1" fmla="*/ 1439618 h 1439618"/>
                <a:gd name="connsiteX2" fmla="*/ 829382 w 1280506"/>
                <a:gd name="connsiteY2" fmla="*/ 1237758 h 1439618"/>
                <a:gd name="connsiteX3" fmla="*/ 574465 w 1280506"/>
                <a:gd name="connsiteY3" fmla="*/ 957547 h 1439618"/>
                <a:gd name="connsiteX4" fmla="*/ 4504 w 1280506"/>
                <a:gd name="connsiteY4" fmla="*/ 602675 h 1439618"/>
                <a:gd name="connsiteX5" fmla="*/ 58926 w 1280506"/>
                <a:gd name="connsiteY5" fmla="*/ 200336 h 1439618"/>
                <a:gd name="connsiteX6" fmla="*/ 255334 w 1280506"/>
                <a:gd name="connsiteY6" fmla="*/ 18657 h 1439618"/>
                <a:gd name="connsiteX7" fmla="*/ 711411 w 1280506"/>
                <a:gd name="connsiteY7" fmla="*/ 27505 h 1439618"/>
                <a:gd name="connsiteX8" fmla="*/ 912189 w 1280506"/>
                <a:gd name="connsiteY8" fmla="*/ 209868 h 1439618"/>
                <a:gd name="connsiteX9" fmla="*/ 1086968 w 1280506"/>
                <a:gd name="connsiteY9" fmla="*/ 388574 h 1439618"/>
                <a:gd name="connsiteX10" fmla="*/ 1276986 w 1280506"/>
                <a:gd name="connsiteY10" fmla="*/ 696426 h 1439618"/>
                <a:gd name="connsiteX11" fmla="*/ 1192232 w 1280506"/>
                <a:gd name="connsiteY11" fmla="*/ 1073024 h 1439618"/>
                <a:gd name="connsiteX0" fmla="*/ 1192232 w 1224514"/>
                <a:gd name="connsiteY0" fmla="*/ 1073024 h 1439618"/>
                <a:gd name="connsiteX1" fmla="*/ 969933 w 1224514"/>
                <a:gd name="connsiteY1" fmla="*/ 1439618 h 1439618"/>
                <a:gd name="connsiteX2" fmla="*/ 829382 w 1224514"/>
                <a:gd name="connsiteY2" fmla="*/ 1237758 h 1439618"/>
                <a:gd name="connsiteX3" fmla="*/ 574465 w 1224514"/>
                <a:gd name="connsiteY3" fmla="*/ 957547 h 1439618"/>
                <a:gd name="connsiteX4" fmla="*/ 4504 w 1224514"/>
                <a:gd name="connsiteY4" fmla="*/ 602675 h 1439618"/>
                <a:gd name="connsiteX5" fmla="*/ 58926 w 1224514"/>
                <a:gd name="connsiteY5" fmla="*/ 200336 h 1439618"/>
                <a:gd name="connsiteX6" fmla="*/ 255334 w 1224514"/>
                <a:gd name="connsiteY6" fmla="*/ 18657 h 1439618"/>
                <a:gd name="connsiteX7" fmla="*/ 711411 w 1224514"/>
                <a:gd name="connsiteY7" fmla="*/ 27505 h 1439618"/>
                <a:gd name="connsiteX8" fmla="*/ 912189 w 1224514"/>
                <a:gd name="connsiteY8" fmla="*/ 209868 h 1439618"/>
                <a:gd name="connsiteX9" fmla="*/ 1086968 w 1224514"/>
                <a:gd name="connsiteY9" fmla="*/ 388574 h 1439618"/>
                <a:gd name="connsiteX10" fmla="*/ 1212338 w 1224514"/>
                <a:gd name="connsiteY10" fmla="*/ 718517 h 1439618"/>
                <a:gd name="connsiteX11" fmla="*/ 1192232 w 1224514"/>
                <a:gd name="connsiteY11" fmla="*/ 1073024 h 1439618"/>
                <a:gd name="connsiteX0" fmla="*/ 1192232 w 1225714"/>
                <a:gd name="connsiteY0" fmla="*/ 1073024 h 1381567"/>
                <a:gd name="connsiteX1" fmla="*/ 947332 w 1225714"/>
                <a:gd name="connsiteY1" fmla="*/ 1381567 h 1381567"/>
                <a:gd name="connsiteX2" fmla="*/ 829382 w 1225714"/>
                <a:gd name="connsiteY2" fmla="*/ 1237758 h 1381567"/>
                <a:gd name="connsiteX3" fmla="*/ 574465 w 1225714"/>
                <a:gd name="connsiteY3" fmla="*/ 957547 h 1381567"/>
                <a:gd name="connsiteX4" fmla="*/ 4504 w 1225714"/>
                <a:gd name="connsiteY4" fmla="*/ 602675 h 1381567"/>
                <a:gd name="connsiteX5" fmla="*/ 58926 w 1225714"/>
                <a:gd name="connsiteY5" fmla="*/ 200336 h 1381567"/>
                <a:gd name="connsiteX6" fmla="*/ 255334 w 1225714"/>
                <a:gd name="connsiteY6" fmla="*/ 18657 h 1381567"/>
                <a:gd name="connsiteX7" fmla="*/ 711411 w 1225714"/>
                <a:gd name="connsiteY7" fmla="*/ 27505 h 1381567"/>
                <a:gd name="connsiteX8" fmla="*/ 912189 w 1225714"/>
                <a:gd name="connsiteY8" fmla="*/ 209868 h 1381567"/>
                <a:gd name="connsiteX9" fmla="*/ 1086968 w 1225714"/>
                <a:gd name="connsiteY9" fmla="*/ 388574 h 1381567"/>
                <a:gd name="connsiteX10" fmla="*/ 1212338 w 1225714"/>
                <a:gd name="connsiteY10" fmla="*/ 718517 h 1381567"/>
                <a:gd name="connsiteX11" fmla="*/ 1192232 w 1225714"/>
                <a:gd name="connsiteY11" fmla="*/ 1073024 h 1381567"/>
                <a:gd name="connsiteX0" fmla="*/ 1192232 w 1225714"/>
                <a:gd name="connsiteY0" fmla="*/ 1060784 h 1369327"/>
                <a:gd name="connsiteX1" fmla="*/ 947332 w 1225714"/>
                <a:gd name="connsiteY1" fmla="*/ 1369327 h 1369327"/>
                <a:gd name="connsiteX2" fmla="*/ 829382 w 1225714"/>
                <a:gd name="connsiteY2" fmla="*/ 1225518 h 1369327"/>
                <a:gd name="connsiteX3" fmla="*/ 574465 w 1225714"/>
                <a:gd name="connsiteY3" fmla="*/ 945307 h 1369327"/>
                <a:gd name="connsiteX4" fmla="*/ 4504 w 1225714"/>
                <a:gd name="connsiteY4" fmla="*/ 590435 h 1369327"/>
                <a:gd name="connsiteX5" fmla="*/ 58926 w 1225714"/>
                <a:gd name="connsiteY5" fmla="*/ 188096 h 1369327"/>
                <a:gd name="connsiteX6" fmla="*/ 255334 w 1225714"/>
                <a:gd name="connsiteY6" fmla="*/ 6417 h 1369327"/>
                <a:gd name="connsiteX7" fmla="*/ 693839 w 1225714"/>
                <a:gd name="connsiteY7" fmla="*/ 55651 h 1369327"/>
                <a:gd name="connsiteX8" fmla="*/ 912189 w 1225714"/>
                <a:gd name="connsiteY8" fmla="*/ 197628 h 1369327"/>
                <a:gd name="connsiteX9" fmla="*/ 1086968 w 1225714"/>
                <a:gd name="connsiteY9" fmla="*/ 376334 h 1369327"/>
                <a:gd name="connsiteX10" fmla="*/ 1212338 w 1225714"/>
                <a:gd name="connsiteY10" fmla="*/ 706277 h 1369327"/>
                <a:gd name="connsiteX11" fmla="*/ 1192232 w 1225714"/>
                <a:gd name="connsiteY11" fmla="*/ 1060784 h 1369327"/>
                <a:gd name="connsiteX0" fmla="*/ 1192232 w 1225714"/>
                <a:gd name="connsiteY0" fmla="*/ 1060784 h 1369327"/>
                <a:gd name="connsiteX1" fmla="*/ 947332 w 1225714"/>
                <a:gd name="connsiteY1" fmla="*/ 1369327 h 1369327"/>
                <a:gd name="connsiteX2" fmla="*/ 829382 w 1225714"/>
                <a:gd name="connsiteY2" fmla="*/ 1225518 h 1369327"/>
                <a:gd name="connsiteX3" fmla="*/ 574465 w 1225714"/>
                <a:gd name="connsiteY3" fmla="*/ 945307 h 1369327"/>
                <a:gd name="connsiteX4" fmla="*/ 4504 w 1225714"/>
                <a:gd name="connsiteY4" fmla="*/ 590435 h 1369327"/>
                <a:gd name="connsiteX5" fmla="*/ 58926 w 1225714"/>
                <a:gd name="connsiteY5" fmla="*/ 188096 h 1369327"/>
                <a:gd name="connsiteX6" fmla="*/ 255334 w 1225714"/>
                <a:gd name="connsiteY6" fmla="*/ 6417 h 1369327"/>
                <a:gd name="connsiteX7" fmla="*/ 693839 w 1225714"/>
                <a:gd name="connsiteY7" fmla="*/ 55651 h 1369327"/>
                <a:gd name="connsiteX8" fmla="*/ 912189 w 1225714"/>
                <a:gd name="connsiteY8" fmla="*/ 197628 h 1369327"/>
                <a:gd name="connsiteX9" fmla="*/ 1086968 w 1225714"/>
                <a:gd name="connsiteY9" fmla="*/ 376334 h 1369327"/>
                <a:gd name="connsiteX10" fmla="*/ 1212338 w 1225714"/>
                <a:gd name="connsiteY10" fmla="*/ 706277 h 1369327"/>
                <a:gd name="connsiteX11" fmla="*/ 1192232 w 1225714"/>
                <a:gd name="connsiteY11" fmla="*/ 1060784 h 1369327"/>
                <a:gd name="connsiteX0" fmla="*/ 1192232 w 1225714"/>
                <a:gd name="connsiteY0" fmla="*/ 1060784 h 1369327"/>
                <a:gd name="connsiteX1" fmla="*/ 947332 w 1225714"/>
                <a:gd name="connsiteY1" fmla="*/ 1369327 h 1369327"/>
                <a:gd name="connsiteX2" fmla="*/ 829382 w 1225714"/>
                <a:gd name="connsiteY2" fmla="*/ 1225518 h 1369327"/>
                <a:gd name="connsiteX3" fmla="*/ 574465 w 1225714"/>
                <a:gd name="connsiteY3" fmla="*/ 945307 h 1369327"/>
                <a:gd name="connsiteX4" fmla="*/ 4504 w 1225714"/>
                <a:gd name="connsiteY4" fmla="*/ 590435 h 1369327"/>
                <a:gd name="connsiteX5" fmla="*/ 58926 w 1225714"/>
                <a:gd name="connsiteY5" fmla="*/ 188096 h 1369327"/>
                <a:gd name="connsiteX6" fmla="*/ 255334 w 1225714"/>
                <a:gd name="connsiteY6" fmla="*/ 6417 h 1369327"/>
                <a:gd name="connsiteX7" fmla="*/ 693839 w 1225714"/>
                <a:gd name="connsiteY7" fmla="*/ 55651 h 1369327"/>
                <a:gd name="connsiteX8" fmla="*/ 912189 w 1225714"/>
                <a:gd name="connsiteY8" fmla="*/ 197628 h 1369327"/>
                <a:gd name="connsiteX9" fmla="*/ 1086968 w 1225714"/>
                <a:gd name="connsiteY9" fmla="*/ 376334 h 1369327"/>
                <a:gd name="connsiteX10" fmla="*/ 1212338 w 1225714"/>
                <a:gd name="connsiteY10" fmla="*/ 706277 h 1369327"/>
                <a:gd name="connsiteX11" fmla="*/ 1192232 w 1225714"/>
                <a:gd name="connsiteY11" fmla="*/ 1060784 h 1369327"/>
                <a:gd name="connsiteX0" fmla="*/ 1192232 w 1224264"/>
                <a:gd name="connsiteY0" fmla="*/ 1060784 h 1342443"/>
                <a:gd name="connsiteX1" fmla="*/ 974821 w 1224264"/>
                <a:gd name="connsiteY1" fmla="*/ 1342443 h 1342443"/>
                <a:gd name="connsiteX2" fmla="*/ 829382 w 1224264"/>
                <a:gd name="connsiteY2" fmla="*/ 1225518 h 1342443"/>
                <a:gd name="connsiteX3" fmla="*/ 574465 w 1224264"/>
                <a:gd name="connsiteY3" fmla="*/ 945307 h 1342443"/>
                <a:gd name="connsiteX4" fmla="*/ 4504 w 1224264"/>
                <a:gd name="connsiteY4" fmla="*/ 590435 h 1342443"/>
                <a:gd name="connsiteX5" fmla="*/ 58926 w 1224264"/>
                <a:gd name="connsiteY5" fmla="*/ 188096 h 1342443"/>
                <a:gd name="connsiteX6" fmla="*/ 255334 w 1224264"/>
                <a:gd name="connsiteY6" fmla="*/ 6417 h 1342443"/>
                <a:gd name="connsiteX7" fmla="*/ 693839 w 1224264"/>
                <a:gd name="connsiteY7" fmla="*/ 55651 h 1342443"/>
                <a:gd name="connsiteX8" fmla="*/ 912189 w 1224264"/>
                <a:gd name="connsiteY8" fmla="*/ 197628 h 1342443"/>
                <a:gd name="connsiteX9" fmla="*/ 1086968 w 1224264"/>
                <a:gd name="connsiteY9" fmla="*/ 376334 h 1342443"/>
                <a:gd name="connsiteX10" fmla="*/ 1212338 w 1224264"/>
                <a:gd name="connsiteY10" fmla="*/ 706277 h 1342443"/>
                <a:gd name="connsiteX11" fmla="*/ 1192232 w 1224264"/>
                <a:gd name="connsiteY11" fmla="*/ 1060784 h 1342443"/>
                <a:gd name="connsiteX0" fmla="*/ 1192232 w 1224264"/>
                <a:gd name="connsiteY0" fmla="*/ 1060784 h 1342443"/>
                <a:gd name="connsiteX1" fmla="*/ 974821 w 1224264"/>
                <a:gd name="connsiteY1" fmla="*/ 1342443 h 1342443"/>
                <a:gd name="connsiteX2" fmla="*/ 574465 w 1224264"/>
                <a:gd name="connsiteY2" fmla="*/ 945307 h 1342443"/>
                <a:gd name="connsiteX3" fmla="*/ 4504 w 1224264"/>
                <a:gd name="connsiteY3" fmla="*/ 590435 h 1342443"/>
                <a:gd name="connsiteX4" fmla="*/ 58926 w 1224264"/>
                <a:gd name="connsiteY4" fmla="*/ 188096 h 1342443"/>
                <a:gd name="connsiteX5" fmla="*/ 255334 w 1224264"/>
                <a:gd name="connsiteY5" fmla="*/ 6417 h 1342443"/>
                <a:gd name="connsiteX6" fmla="*/ 693839 w 1224264"/>
                <a:gd name="connsiteY6" fmla="*/ 55651 h 1342443"/>
                <a:gd name="connsiteX7" fmla="*/ 912189 w 1224264"/>
                <a:gd name="connsiteY7" fmla="*/ 197628 h 1342443"/>
                <a:gd name="connsiteX8" fmla="*/ 1086968 w 1224264"/>
                <a:gd name="connsiteY8" fmla="*/ 376334 h 1342443"/>
                <a:gd name="connsiteX9" fmla="*/ 1212338 w 1224264"/>
                <a:gd name="connsiteY9" fmla="*/ 706277 h 1342443"/>
                <a:gd name="connsiteX10" fmla="*/ 1192232 w 1224264"/>
                <a:gd name="connsiteY10" fmla="*/ 1060784 h 1342443"/>
                <a:gd name="connsiteX0" fmla="*/ 1192232 w 1224264"/>
                <a:gd name="connsiteY0" fmla="*/ 1060784 h 1342443"/>
                <a:gd name="connsiteX1" fmla="*/ 974821 w 1224264"/>
                <a:gd name="connsiteY1" fmla="*/ 1342443 h 1342443"/>
                <a:gd name="connsiteX2" fmla="*/ 574465 w 1224264"/>
                <a:gd name="connsiteY2" fmla="*/ 945307 h 1342443"/>
                <a:gd name="connsiteX3" fmla="*/ 4504 w 1224264"/>
                <a:gd name="connsiteY3" fmla="*/ 590435 h 1342443"/>
                <a:gd name="connsiteX4" fmla="*/ 58926 w 1224264"/>
                <a:gd name="connsiteY4" fmla="*/ 188096 h 1342443"/>
                <a:gd name="connsiteX5" fmla="*/ 255334 w 1224264"/>
                <a:gd name="connsiteY5" fmla="*/ 6417 h 1342443"/>
                <a:gd name="connsiteX6" fmla="*/ 693839 w 1224264"/>
                <a:gd name="connsiteY6" fmla="*/ 55651 h 1342443"/>
                <a:gd name="connsiteX7" fmla="*/ 912189 w 1224264"/>
                <a:gd name="connsiteY7" fmla="*/ 197628 h 1342443"/>
                <a:gd name="connsiteX8" fmla="*/ 1086968 w 1224264"/>
                <a:gd name="connsiteY8" fmla="*/ 376334 h 1342443"/>
                <a:gd name="connsiteX9" fmla="*/ 1212338 w 1224264"/>
                <a:gd name="connsiteY9" fmla="*/ 706277 h 1342443"/>
                <a:gd name="connsiteX10" fmla="*/ 1192232 w 1224264"/>
                <a:gd name="connsiteY10" fmla="*/ 1060784 h 1342443"/>
                <a:gd name="connsiteX0" fmla="*/ 1192232 w 1224264"/>
                <a:gd name="connsiteY0" fmla="*/ 1060784 h 1342443"/>
                <a:gd name="connsiteX1" fmla="*/ 974821 w 1224264"/>
                <a:gd name="connsiteY1" fmla="*/ 1342443 h 1342443"/>
                <a:gd name="connsiteX2" fmla="*/ 574465 w 1224264"/>
                <a:gd name="connsiteY2" fmla="*/ 945307 h 1342443"/>
                <a:gd name="connsiteX3" fmla="*/ 4504 w 1224264"/>
                <a:gd name="connsiteY3" fmla="*/ 590435 h 1342443"/>
                <a:gd name="connsiteX4" fmla="*/ 58926 w 1224264"/>
                <a:gd name="connsiteY4" fmla="*/ 188096 h 1342443"/>
                <a:gd name="connsiteX5" fmla="*/ 255334 w 1224264"/>
                <a:gd name="connsiteY5" fmla="*/ 6417 h 1342443"/>
                <a:gd name="connsiteX6" fmla="*/ 693839 w 1224264"/>
                <a:gd name="connsiteY6" fmla="*/ 55651 h 1342443"/>
                <a:gd name="connsiteX7" fmla="*/ 912189 w 1224264"/>
                <a:gd name="connsiteY7" fmla="*/ 197628 h 1342443"/>
                <a:gd name="connsiteX8" fmla="*/ 1086968 w 1224264"/>
                <a:gd name="connsiteY8" fmla="*/ 376334 h 1342443"/>
                <a:gd name="connsiteX9" fmla="*/ 1212338 w 1224264"/>
                <a:gd name="connsiteY9" fmla="*/ 706277 h 1342443"/>
                <a:gd name="connsiteX10" fmla="*/ 1192232 w 1224264"/>
                <a:gd name="connsiteY10" fmla="*/ 1060784 h 1342443"/>
                <a:gd name="connsiteX0" fmla="*/ 1192232 w 1221774"/>
                <a:gd name="connsiteY0" fmla="*/ 1060784 h 1439740"/>
                <a:gd name="connsiteX1" fmla="*/ 1028684 w 1221774"/>
                <a:gd name="connsiteY1" fmla="*/ 1439740 h 1439740"/>
                <a:gd name="connsiteX2" fmla="*/ 574465 w 1221774"/>
                <a:gd name="connsiteY2" fmla="*/ 945307 h 1439740"/>
                <a:gd name="connsiteX3" fmla="*/ 4504 w 1221774"/>
                <a:gd name="connsiteY3" fmla="*/ 590435 h 1439740"/>
                <a:gd name="connsiteX4" fmla="*/ 58926 w 1221774"/>
                <a:gd name="connsiteY4" fmla="*/ 188096 h 1439740"/>
                <a:gd name="connsiteX5" fmla="*/ 255334 w 1221774"/>
                <a:gd name="connsiteY5" fmla="*/ 6417 h 1439740"/>
                <a:gd name="connsiteX6" fmla="*/ 693839 w 1221774"/>
                <a:gd name="connsiteY6" fmla="*/ 55651 h 1439740"/>
                <a:gd name="connsiteX7" fmla="*/ 912189 w 1221774"/>
                <a:gd name="connsiteY7" fmla="*/ 197628 h 1439740"/>
                <a:gd name="connsiteX8" fmla="*/ 1086968 w 1221774"/>
                <a:gd name="connsiteY8" fmla="*/ 376334 h 1439740"/>
                <a:gd name="connsiteX9" fmla="*/ 1212338 w 1221774"/>
                <a:gd name="connsiteY9" fmla="*/ 706277 h 1439740"/>
                <a:gd name="connsiteX10" fmla="*/ 1192232 w 1221774"/>
                <a:gd name="connsiteY10" fmla="*/ 1060784 h 1439740"/>
                <a:gd name="connsiteX0" fmla="*/ 1192232 w 1222654"/>
                <a:gd name="connsiteY0" fmla="*/ 1060784 h 1433685"/>
                <a:gd name="connsiteX1" fmla="*/ 1008347 w 1222654"/>
                <a:gd name="connsiteY1" fmla="*/ 1433685 h 1433685"/>
                <a:gd name="connsiteX2" fmla="*/ 574465 w 1222654"/>
                <a:gd name="connsiteY2" fmla="*/ 945307 h 1433685"/>
                <a:gd name="connsiteX3" fmla="*/ 4504 w 1222654"/>
                <a:gd name="connsiteY3" fmla="*/ 590435 h 1433685"/>
                <a:gd name="connsiteX4" fmla="*/ 58926 w 1222654"/>
                <a:gd name="connsiteY4" fmla="*/ 188096 h 1433685"/>
                <a:gd name="connsiteX5" fmla="*/ 255334 w 1222654"/>
                <a:gd name="connsiteY5" fmla="*/ 6417 h 1433685"/>
                <a:gd name="connsiteX6" fmla="*/ 693839 w 1222654"/>
                <a:gd name="connsiteY6" fmla="*/ 55651 h 1433685"/>
                <a:gd name="connsiteX7" fmla="*/ 912189 w 1222654"/>
                <a:gd name="connsiteY7" fmla="*/ 197628 h 1433685"/>
                <a:gd name="connsiteX8" fmla="*/ 1086968 w 1222654"/>
                <a:gd name="connsiteY8" fmla="*/ 376334 h 1433685"/>
                <a:gd name="connsiteX9" fmla="*/ 1212338 w 1222654"/>
                <a:gd name="connsiteY9" fmla="*/ 706277 h 1433685"/>
                <a:gd name="connsiteX10" fmla="*/ 1192232 w 1222654"/>
                <a:gd name="connsiteY10" fmla="*/ 1060784 h 1433685"/>
                <a:gd name="connsiteX0" fmla="*/ 1192232 w 1222654"/>
                <a:gd name="connsiteY0" fmla="*/ 1060784 h 1433685"/>
                <a:gd name="connsiteX1" fmla="*/ 1008347 w 1222654"/>
                <a:gd name="connsiteY1" fmla="*/ 1433685 h 1433685"/>
                <a:gd name="connsiteX2" fmla="*/ 574465 w 1222654"/>
                <a:gd name="connsiteY2" fmla="*/ 945307 h 1433685"/>
                <a:gd name="connsiteX3" fmla="*/ 4504 w 1222654"/>
                <a:gd name="connsiteY3" fmla="*/ 590435 h 1433685"/>
                <a:gd name="connsiteX4" fmla="*/ 58926 w 1222654"/>
                <a:gd name="connsiteY4" fmla="*/ 188096 h 1433685"/>
                <a:gd name="connsiteX5" fmla="*/ 255334 w 1222654"/>
                <a:gd name="connsiteY5" fmla="*/ 6417 h 1433685"/>
                <a:gd name="connsiteX6" fmla="*/ 693839 w 1222654"/>
                <a:gd name="connsiteY6" fmla="*/ 55651 h 1433685"/>
                <a:gd name="connsiteX7" fmla="*/ 912189 w 1222654"/>
                <a:gd name="connsiteY7" fmla="*/ 197628 h 1433685"/>
                <a:gd name="connsiteX8" fmla="*/ 1086968 w 1222654"/>
                <a:gd name="connsiteY8" fmla="*/ 376334 h 1433685"/>
                <a:gd name="connsiteX9" fmla="*/ 1212338 w 1222654"/>
                <a:gd name="connsiteY9" fmla="*/ 706277 h 1433685"/>
                <a:gd name="connsiteX10" fmla="*/ 1192232 w 1222654"/>
                <a:gd name="connsiteY10" fmla="*/ 1060784 h 1433685"/>
                <a:gd name="connsiteX0" fmla="*/ 1192232 w 1222654"/>
                <a:gd name="connsiteY0" fmla="*/ 1060784 h 1433685"/>
                <a:gd name="connsiteX1" fmla="*/ 1008347 w 1222654"/>
                <a:gd name="connsiteY1" fmla="*/ 1433685 h 1433685"/>
                <a:gd name="connsiteX2" fmla="*/ 574465 w 1222654"/>
                <a:gd name="connsiteY2" fmla="*/ 945307 h 1433685"/>
                <a:gd name="connsiteX3" fmla="*/ 4504 w 1222654"/>
                <a:gd name="connsiteY3" fmla="*/ 590435 h 1433685"/>
                <a:gd name="connsiteX4" fmla="*/ 58926 w 1222654"/>
                <a:gd name="connsiteY4" fmla="*/ 188096 h 1433685"/>
                <a:gd name="connsiteX5" fmla="*/ 255334 w 1222654"/>
                <a:gd name="connsiteY5" fmla="*/ 6417 h 1433685"/>
                <a:gd name="connsiteX6" fmla="*/ 693839 w 1222654"/>
                <a:gd name="connsiteY6" fmla="*/ 55651 h 1433685"/>
                <a:gd name="connsiteX7" fmla="*/ 912189 w 1222654"/>
                <a:gd name="connsiteY7" fmla="*/ 197628 h 1433685"/>
                <a:gd name="connsiteX8" fmla="*/ 1086968 w 1222654"/>
                <a:gd name="connsiteY8" fmla="*/ 376334 h 1433685"/>
                <a:gd name="connsiteX9" fmla="*/ 1212338 w 1222654"/>
                <a:gd name="connsiteY9" fmla="*/ 706277 h 1433685"/>
                <a:gd name="connsiteX10" fmla="*/ 1192232 w 1222654"/>
                <a:gd name="connsiteY10" fmla="*/ 1060784 h 1433685"/>
                <a:gd name="connsiteX0" fmla="*/ 1192232 w 1222654"/>
                <a:gd name="connsiteY0" fmla="*/ 1060784 h 1433685"/>
                <a:gd name="connsiteX1" fmla="*/ 1008347 w 1222654"/>
                <a:gd name="connsiteY1" fmla="*/ 1433685 h 1433685"/>
                <a:gd name="connsiteX2" fmla="*/ 574465 w 1222654"/>
                <a:gd name="connsiteY2" fmla="*/ 945307 h 1433685"/>
                <a:gd name="connsiteX3" fmla="*/ 4504 w 1222654"/>
                <a:gd name="connsiteY3" fmla="*/ 590435 h 1433685"/>
                <a:gd name="connsiteX4" fmla="*/ 58926 w 1222654"/>
                <a:gd name="connsiteY4" fmla="*/ 188096 h 1433685"/>
                <a:gd name="connsiteX5" fmla="*/ 255334 w 1222654"/>
                <a:gd name="connsiteY5" fmla="*/ 6417 h 1433685"/>
                <a:gd name="connsiteX6" fmla="*/ 693839 w 1222654"/>
                <a:gd name="connsiteY6" fmla="*/ 55651 h 1433685"/>
                <a:gd name="connsiteX7" fmla="*/ 912189 w 1222654"/>
                <a:gd name="connsiteY7" fmla="*/ 197628 h 1433685"/>
                <a:gd name="connsiteX8" fmla="*/ 1086968 w 1222654"/>
                <a:gd name="connsiteY8" fmla="*/ 376334 h 1433685"/>
                <a:gd name="connsiteX9" fmla="*/ 1212338 w 1222654"/>
                <a:gd name="connsiteY9" fmla="*/ 706277 h 1433685"/>
                <a:gd name="connsiteX10" fmla="*/ 1192232 w 1222654"/>
                <a:gd name="connsiteY10" fmla="*/ 1060784 h 1433685"/>
                <a:gd name="connsiteX0" fmla="*/ 1192232 w 1222654"/>
                <a:gd name="connsiteY0" fmla="*/ 1060784 h 1433685"/>
                <a:gd name="connsiteX1" fmla="*/ 1008347 w 1222654"/>
                <a:gd name="connsiteY1" fmla="*/ 1433685 h 1433685"/>
                <a:gd name="connsiteX2" fmla="*/ 574465 w 1222654"/>
                <a:gd name="connsiteY2" fmla="*/ 945307 h 1433685"/>
                <a:gd name="connsiteX3" fmla="*/ 4504 w 1222654"/>
                <a:gd name="connsiteY3" fmla="*/ 590435 h 1433685"/>
                <a:gd name="connsiteX4" fmla="*/ 58926 w 1222654"/>
                <a:gd name="connsiteY4" fmla="*/ 188096 h 1433685"/>
                <a:gd name="connsiteX5" fmla="*/ 255334 w 1222654"/>
                <a:gd name="connsiteY5" fmla="*/ 6417 h 1433685"/>
                <a:gd name="connsiteX6" fmla="*/ 693839 w 1222654"/>
                <a:gd name="connsiteY6" fmla="*/ 55651 h 1433685"/>
                <a:gd name="connsiteX7" fmla="*/ 912189 w 1222654"/>
                <a:gd name="connsiteY7" fmla="*/ 197628 h 1433685"/>
                <a:gd name="connsiteX8" fmla="*/ 1086968 w 1222654"/>
                <a:gd name="connsiteY8" fmla="*/ 376334 h 1433685"/>
                <a:gd name="connsiteX9" fmla="*/ 1212338 w 1222654"/>
                <a:gd name="connsiteY9" fmla="*/ 706277 h 1433685"/>
                <a:gd name="connsiteX10" fmla="*/ 1192232 w 1222654"/>
                <a:gd name="connsiteY10" fmla="*/ 1060784 h 1433685"/>
                <a:gd name="connsiteX0" fmla="*/ 1192232 w 1222654"/>
                <a:gd name="connsiteY0" fmla="*/ 1060784 h 1433685"/>
                <a:gd name="connsiteX1" fmla="*/ 1008347 w 1222654"/>
                <a:gd name="connsiteY1" fmla="*/ 1433685 h 1433685"/>
                <a:gd name="connsiteX2" fmla="*/ 574465 w 1222654"/>
                <a:gd name="connsiteY2" fmla="*/ 945307 h 1433685"/>
                <a:gd name="connsiteX3" fmla="*/ 4504 w 1222654"/>
                <a:gd name="connsiteY3" fmla="*/ 590435 h 1433685"/>
                <a:gd name="connsiteX4" fmla="*/ 58926 w 1222654"/>
                <a:gd name="connsiteY4" fmla="*/ 188096 h 1433685"/>
                <a:gd name="connsiteX5" fmla="*/ 255334 w 1222654"/>
                <a:gd name="connsiteY5" fmla="*/ 6417 h 1433685"/>
                <a:gd name="connsiteX6" fmla="*/ 693839 w 1222654"/>
                <a:gd name="connsiteY6" fmla="*/ 55651 h 1433685"/>
                <a:gd name="connsiteX7" fmla="*/ 912189 w 1222654"/>
                <a:gd name="connsiteY7" fmla="*/ 197628 h 1433685"/>
                <a:gd name="connsiteX8" fmla="*/ 1086968 w 1222654"/>
                <a:gd name="connsiteY8" fmla="*/ 376334 h 1433685"/>
                <a:gd name="connsiteX9" fmla="*/ 1212338 w 1222654"/>
                <a:gd name="connsiteY9" fmla="*/ 706277 h 1433685"/>
                <a:gd name="connsiteX10" fmla="*/ 1192232 w 1222654"/>
                <a:gd name="connsiteY10" fmla="*/ 1060784 h 1433685"/>
                <a:gd name="connsiteX0" fmla="*/ 1192232 w 1222654"/>
                <a:gd name="connsiteY0" fmla="*/ 1060784 h 1433685"/>
                <a:gd name="connsiteX1" fmla="*/ 1008347 w 1222654"/>
                <a:gd name="connsiteY1" fmla="*/ 1433685 h 1433685"/>
                <a:gd name="connsiteX2" fmla="*/ 574465 w 1222654"/>
                <a:gd name="connsiteY2" fmla="*/ 945307 h 1433685"/>
                <a:gd name="connsiteX3" fmla="*/ 4504 w 1222654"/>
                <a:gd name="connsiteY3" fmla="*/ 590435 h 1433685"/>
                <a:gd name="connsiteX4" fmla="*/ 58926 w 1222654"/>
                <a:gd name="connsiteY4" fmla="*/ 188096 h 1433685"/>
                <a:gd name="connsiteX5" fmla="*/ 255334 w 1222654"/>
                <a:gd name="connsiteY5" fmla="*/ 6417 h 1433685"/>
                <a:gd name="connsiteX6" fmla="*/ 693839 w 1222654"/>
                <a:gd name="connsiteY6" fmla="*/ 55651 h 1433685"/>
                <a:gd name="connsiteX7" fmla="*/ 912189 w 1222654"/>
                <a:gd name="connsiteY7" fmla="*/ 197628 h 1433685"/>
                <a:gd name="connsiteX8" fmla="*/ 1086968 w 1222654"/>
                <a:gd name="connsiteY8" fmla="*/ 376334 h 1433685"/>
                <a:gd name="connsiteX9" fmla="*/ 1212338 w 1222654"/>
                <a:gd name="connsiteY9" fmla="*/ 706277 h 1433685"/>
                <a:gd name="connsiteX10" fmla="*/ 1192232 w 1222654"/>
                <a:gd name="connsiteY10" fmla="*/ 1060784 h 1433685"/>
                <a:gd name="connsiteX0" fmla="*/ 1192232 w 1222654"/>
                <a:gd name="connsiteY0" fmla="*/ 1065148 h 1438049"/>
                <a:gd name="connsiteX1" fmla="*/ 1008347 w 1222654"/>
                <a:gd name="connsiteY1" fmla="*/ 1438049 h 1438049"/>
                <a:gd name="connsiteX2" fmla="*/ 574465 w 1222654"/>
                <a:gd name="connsiteY2" fmla="*/ 949671 h 1438049"/>
                <a:gd name="connsiteX3" fmla="*/ 4504 w 1222654"/>
                <a:gd name="connsiteY3" fmla="*/ 594799 h 1438049"/>
                <a:gd name="connsiteX4" fmla="*/ 58926 w 1222654"/>
                <a:gd name="connsiteY4" fmla="*/ 192460 h 1438049"/>
                <a:gd name="connsiteX5" fmla="*/ 255334 w 1222654"/>
                <a:gd name="connsiteY5" fmla="*/ 10781 h 1438049"/>
                <a:gd name="connsiteX6" fmla="*/ 693839 w 1222654"/>
                <a:gd name="connsiteY6" fmla="*/ 60015 h 1438049"/>
                <a:gd name="connsiteX7" fmla="*/ 1086968 w 1222654"/>
                <a:gd name="connsiteY7" fmla="*/ 380698 h 1438049"/>
                <a:gd name="connsiteX8" fmla="*/ 1212338 w 1222654"/>
                <a:gd name="connsiteY8" fmla="*/ 710641 h 1438049"/>
                <a:gd name="connsiteX9" fmla="*/ 1192232 w 1222654"/>
                <a:gd name="connsiteY9" fmla="*/ 1065148 h 1438049"/>
                <a:gd name="connsiteX0" fmla="*/ 1205036 w 1228815"/>
                <a:gd name="connsiteY0" fmla="*/ 1062118 h 1438049"/>
                <a:gd name="connsiteX1" fmla="*/ 1008347 w 1228815"/>
                <a:gd name="connsiteY1" fmla="*/ 1438049 h 1438049"/>
                <a:gd name="connsiteX2" fmla="*/ 574465 w 1228815"/>
                <a:gd name="connsiteY2" fmla="*/ 949671 h 1438049"/>
                <a:gd name="connsiteX3" fmla="*/ 4504 w 1228815"/>
                <a:gd name="connsiteY3" fmla="*/ 594799 h 1438049"/>
                <a:gd name="connsiteX4" fmla="*/ 58926 w 1228815"/>
                <a:gd name="connsiteY4" fmla="*/ 192460 h 1438049"/>
                <a:gd name="connsiteX5" fmla="*/ 255334 w 1228815"/>
                <a:gd name="connsiteY5" fmla="*/ 10781 h 1438049"/>
                <a:gd name="connsiteX6" fmla="*/ 693839 w 1228815"/>
                <a:gd name="connsiteY6" fmla="*/ 60015 h 1438049"/>
                <a:gd name="connsiteX7" fmla="*/ 1086968 w 1228815"/>
                <a:gd name="connsiteY7" fmla="*/ 380698 h 1438049"/>
                <a:gd name="connsiteX8" fmla="*/ 1212338 w 1228815"/>
                <a:gd name="connsiteY8" fmla="*/ 710641 h 1438049"/>
                <a:gd name="connsiteX9" fmla="*/ 1205036 w 1228815"/>
                <a:gd name="connsiteY9" fmla="*/ 1062118 h 1438049"/>
                <a:gd name="connsiteX0" fmla="*/ 1205036 w 1230841"/>
                <a:gd name="connsiteY0" fmla="*/ 1063065 h 1438996"/>
                <a:gd name="connsiteX1" fmla="*/ 1008347 w 1230841"/>
                <a:gd name="connsiteY1" fmla="*/ 1438996 h 1438996"/>
                <a:gd name="connsiteX2" fmla="*/ 574465 w 1230841"/>
                <a:gd name="connsiteY2" fmla="*/ 950618 h 1438996"/>
                <a:gd name="connsiteX3" fmla="*/ 4504 w 1230841"/>
                <a:gd name="connsiteY3" fmla="*/ 595746 h 1438996"/>
                <a:gd name="connsiteX4" fmla="*/ 58926 w 1230841"/>
                <a:gd name="connsiteY4" fmla="*/ 193407 h 1438996"/>
                <a:gd name="connsiteX5" fmla="*/ 255334 w 1230841"/>
                <a:gd name="connsiteY5" fmla="*/ 11728 h 1438996"/>
                <a:gd name="connsiteX6" fmla="*/ 693839 w 1230841"/>
                <a:gd name="connsiteY6" fmla="*/ 60962 h 1438996"/>
                <a:gd name="connsiteX7" fmla="*/ 1055336 w 1230841"/>
                <a:gd name="connsiteY7" fmla="*/ 408151 h 1438996"/>
                <a:gd name="connsiteX8" fmla="*/ 1212338 w 1230841"/>
                <a:gd name="connsiteY8" fmla="*/ 711588 h 1438996"/>
                <a:gd name="connsiteX9" fmla="*/ 1205036 w 1230841"/>
                <a:gd name="connsiteY9" fmla="*/ 1063065 h 1438996"/>
                <a:gd name="connsiteX0" fmla="*/ 1205036 w 1230841"/>
                <a:gd name="connsiteY0" fmla="*/ 1063065 h 1470362"/>
                <a:gd name="connsiteX1" fmla="*/ 1008347 w 1230841"/>
                <a:gd name="connsiteY1" fmla="*/ 1438996 h 1470362"/>
                <a:gd name="connsiteX2" fmla="*/ 574465 w 1230841"/>
                <a:gd name="connsiteY2" fmla="*/ 950618 h 1470362"/>
                <a:gd name="connsiteX3" fmla="*/ 4504 w 1230841"/>
                <a:gd name="connsiteY3" fmla="*/ 595746 h 1470362"/>
                <a:gd name="connsiteX4" fmla="*/ 58926 w 1230841"/>
                <a:gd name="connsiteY4" fmla="*/ 193407 h 1470362"/>
                <a:gd name="connsiteX5" fmla="*/ 255334 w 1230841"/>
                <a:gd name="connsiteY5" fmla="*/ 11728 h 1470362"/>
                <a:gd name="connsiteX6" fmla="*/ 693839 w 1230841"/>
                <a:gd name="connsiteY6" fmla="*/ 60962 h 1470362"/>
                <a:gd name="connsiteX7" fmla="*/ 1055336 w 1230841"/>
                <a:gd name="connsiteY7" fmla="*/ 408151 h 1470362"/>
                <a:gd name="connsiteX8" fmla="*/ 1212338 w 1230841"/>
                <a:gd name="connsiteY8" fmla="*/ 711588 h 1470362"/>
                <a:gd name="connsiteX9" fmla="*/ 1205036 w 1230841"/>
                <a:gd name="connsiteY9" fmla="*/ 1063065 h 1470362"/>
                <a:gd name="connsiteX0" fmla="*/ 1205036 w 1230841"/>
                <a:gd name="connsiteY0" fmla="*/ 1063065 h 1455565"/>
                <a:gd name="connsiteX1" fmla="*/ 1008347 w 1230841"/>
                <a:gd name="connsiteY1" fmla="*/ 1438996 h 1455565"/>
                <a:gd name="connsiteX2" fmla="*/ 574465 w 1230841"/>
                <a:gd name="connsiteY2" fmla="*/ 950618 h 1455565"/>
                <a:gd name="connsiteX3" fmla="*/ 4504 w 1230841"/>
                <a:gd name="connsiteY3" fmla="*/ 595746 h 1455565"/>
                <a:gd name="connsiteX4" fmla="*/ 58926 w 1230841"/>
                <a:gd name="connsiteY4" fmla="*/ 193407 h 1455565"/>
                <a:gd name="connsiteX5" fmla="*/ 255334 w 1230841"/>
                <a:gd name="connsiteY5" fmla="*/ 11728 h 1455565"/>
                <a:gd name="connsiteX6" fmla="*/ 693839 w 1230841"/>
                <a:gd name="connsiteY6" fmla="*/ 60962 h 1455565"/>
                <a:gd name="connsiteX7" fmla="*/ 1055336 w 1230841"/>
                <a:gd name="connsiteY7" fmla="*/ 408151 h 1455565"/>
                <a:gd name="connsiteX8" fmla="*/ 1212338 w 1230841"/>
                <a:gd name="connsiteY8" fmla="*/ 711588 h 1455565"/>
                <a:gd name="connsiteX9" fmla="*/ 1205036 w 1230841"/>
                <a:gd name="connsiteY9" fmla="*/ 1063065 h 1455565"/>
                <a:gd name="connsiteX0" fmla="*/ 1205036 w 1230841"/>
                <a:gd name="connsiteY0" fmla="*/ 1063065 h 1439154"/>
                <a:gd name="connsiteX1" fmla="*/ 1008347 w 1230841"/>
                <a:gd name="connsiteY1" fmla="*/ 1438996 h 1439154"/>
                <a:gd name="connsiteX2" fmla="*/ 574465 w 1230841"/>
                <a:gd name="connsiteY2" fmla="*/ 950618 h 1439154"/>
                <a:gd name="connsiteX3" fmla="*/ 4504 w 1230841"/>
                <a:gd name="connsiteY3" fmla="*/ 595746 h 1439154"/>
                <a:gd name="connsiteX4" fmla="*/ 58926 w 1230841"/>
                <a:gd name="connsiteY4" fmla="*/ 193407 h 1439154"/>
                <a:gd name="connsiteX5" fmla="*/ 255334 w 1230841"/>
                <a:gd name="connsiteY5" fmla="*/ 11728 h 1439154"/>
                <a:gd name="connsiteX6" fmla="*/ 693839 w 1230841"/>
                <a:gd name="connsiteY6" fmla="*/ 60962 h 1439154"/>
                <a:gd name="connsiteX7" fmla="*/ 1055336 w 1230841"/>
                <a:gd name="connsiteY7" fmla="*/ 408151 h 1439154"/>
                <a:gd name="connsiteX8" fmla="*/ 1212338 w 1230841"/>
                <a:gd name="connsiteY8" fmla="*/ 711588 h 1439154"/>
                <a:gd name="connsiteX9" fmla="*/ 1205036 w 1230841"/>
                <a:gd name="connsiteY9" fmla="*/ 1063065 h 1439154"/>
                <a:gd name="connsiteX0" fmla="*/ 1205036 w 1229125"/>
                <a:gd name="connsiteY0" fmla="*/ 1063065 h 1387312"/>
                <a:gd name="connsiteX1" fmla="*/ 1038093 w 1229125"/>
                <a:gd name="connsiteY1" fmla="*/ 1387124 h 1387312"/>
                <a:gd name="connsiteX2" fmla="*/ 574465 w 1229125"/>
                <a:gd name="connsiteY2" fmla="*/ 950618 h 1387312"/>
                <a:gd name="connsiteX3" fmla="*/ 4504 w 1229125"/>
                <a:gd name="connsiteY3" fmla="*/ 595746 h 1387312"/>
                <a:gd name="connsiteX4" fmla="*/ 58926 w 1229125"/>
                <a:gd name="connsiteY4" fmla="*/ 193407 h 1387312"/>
                <a:gd name="connsiteX5" fmla="*/ 255334 w 1229125"/>
                <a:gd name="connsiteY5" fmla="*/ 11728 h 1387312"/>
                <a:gd name="connsiteX6" fmla="*/ 693839 w 1229125"/>
                <a:gd name="connsiteY6" fmla="*/ 60962 h 1387312"/>
                <a:gd name="connsiteX7" fmla="*/ 1055336 w 1229125"/>
                <a:gd name="connsiteY7" fmla="*/ 408151 h 1387312"/>
                <a:gd name="connsiteX8" fmla="*/ 1212338 w 1229125"/>
                <a:gd name="connsiteY8" fmla="*/ 711588 h 1387312"/>
                <a:gd name="connsiteX9" fmla="*/ 1205036 w 1229125"/>
                <a:gd name="connsiteY9" fmla="*/ 1063065 h 1387312"/>
                <a:gd name="connsiteX0" fmla="*/ 1205036 w 1226181"/>
                <a:gd name="connsiteY0" fmla="*/ 1063065 h 1358934"/>
                <a:gd name="connsiteX1" fmla="*/ 1094957 w 1226181"/>
                <a:gd name="connsiteY1" fmla="*/ 1358724 h 1358934"/>
                <a:gd name="connsiteX2" fmla="*/ 574465 w 1226181"/>
                <a:gd name="connsiteY2" fmla="*/ 950618 h 1358934"/>
                <a:gd name="connsiteX3" fmla="*/ 4504 w 1226181"/>
                <a:gd name="connsiteY3" fmla="*/ 595746 h 1358934"/>
                <a:gd name="connsiteX4" fmla="*/ 58926 w 1226181"/>
                <a:gd name="connsiteY4" fmla="*/ 193407 h 1358934"/>
                <a:gd name="connsiteX5" fmla="*/ 255334 w 1226181"/>
                <a:gd name="connsiteY5" fmla="*/ 11728 h 1358934"/>
                <a:gd name="connsiteX6" fmla="*/ 693839 w 1226181"/>
                <a:gd name="connsiteY6" fmla="*/ 60962 h 1358934"/>
                <a:gd name="connsiteX7" fmla="*/ 1055336 w 1226181"/>
                <a:gd name="connsiteY7" fmla="*/ 408151 h 1358934"/>
                <a:gd name="connsiteX8" fmla="*/ 1212338 w 1226181"/>
                <a:gd name="connsiteY8" fmla="*/ 711588 h 1358934"/>
                <a:gd name="connsiteX9" fmla="*/ 1205036 w 1226181"/>
                <a:gd name="connsiteY9" fmla="*/ 1063065 h 1358934"/>
                <a:gd name="connsiteX0" fmla="*/ 1205036 w 1224418"/>
                <a:gd name="connsiteY0" fmla="*/ 1063065 h 1375197"/>
                <a:gd name="connsiteX1" fmla="*/ 1135254 w 1224418"/>
                <a:gd name="connsiteY1" fmla="*/ 1375000 h 1375197"/>
                <a:gd name="connsiteX2" fmla="*/ 574465 w 1224418"/>
                <a:gd name="connsiteY2" fmla="*/ 950618 h 1375197"/>
                <a:gd name="connsiteX3" fmla="*/ 4504 w 1224418"/>
                <a:gd name="connsiteY3" fmla="*/ 595746 h 1375197"/>
                <a:gd name="connsiteX4" fmla="*/ 58926 w 1224418"/>
                <a:gd name="connsiteY4" fmla="*/ 193407 h 1375197"/>
                <a:gd name="connsiteX5" fmla="*/ 255334 w 1224418"/>
                <a:gd name="connsiteY5" fmla="*/ 11728 h 1375197"/>
                <a:gd name="connsiteX6" fmla="*/ 693839 w 1224418"/>
                <a:gd name="connsiteY6" fmla="*/ 60962 h 1375197"/>
                <a:gd name="connsiteX7" fmla="*/ 1055336 w 1224418"/>
                <a:gd name="connsiteY7" fmla="*/ 408151 h 1375197"/>
                <a:gd name="connsiteX8" fmla="*/ 1212338 w 1224418"/>
                <a:gd name="connsiteY8" fmla="*/ 711588 h 1375197"/>
                <a:gd name="connsiteX9" fmla="*/ 1205036 w 1224418"/>
                <a:gd name="connsiteY9" fmla="*/ 1063065 h 1375197"/>
                <a:gd name="connsiteX0" fmla="*/ 1205036 w 1224418"/>
                <a:gd name="connsiteY0" fmla="*/ 1063065 h 1375197"/>
                <a:gd name="connsiteX1" fmla="*/ 1135254 w 1224418"/>
                <a:gd name="connsiteY1" fmla="*/ 1375000 h 1375197"/>
                <a:gd name="connsiteX2" fmla="*/ 574465 w 1224418"/>
                <a:gd name="connsiteY2" fmla="*/ 950618 h 1375197"/>
                <a:gd name="connsiteX3" fmla="*/ 4504 w 1224418"/>
                <a:gd name="connsiteY3" fmla="*/ 595746 h 1375197"/>
                <a:gd name="connsiteX4" fmla="*/ 58926 w 1224418"/>
                <a:gd name="connsiteY4" fmla="*/ 193407 h 1375197"/>
                <a:gd name="connsiteX5" fmla="*/ 255334 w 1224418"/>
                <a:gd name="connsiteY5" fmla="*/ 11728 h 1375197"/>
                <a:gd name="connsiteX6" fmla="*/ 693839 w 1224418"/>
                <a:gd name="connsiteY6" fmla="*/ 60962 h 1375197"/>
                <a:gd name="connsiteX7" fmla="*/ 1055336 w 1224418"/>
                <a:gd name="connsiteY7" fmla="*/ 408151 h 1375197"/>
                <a:gd name="connsiteX8" fmla="*/ 1212338 w 1224418"/>
                <a:gd name="connsiteY8" fmla="*/ 711588 h 1375197"/>
                <a:gd name="connsiteX9" fmla="*/ 1205036 w 1224418"/>
                <a:gd name="connsiteY9" fmla="*/ 1063065 h 1375197"/>
                <a:gd name="connsiteX0" fmla="*/ 1205036 w 1224418"/>
                <a:gd name="connsiteY0" fmla="*/ 1063065 h 1375197"/>
                <a:gd name="connsiteX1" fmla="*/ 1135254 w 1224418"/>
                <a:gd name="connsiteY1" fmla="*/ 1375000 h 1375197"/>
                <a:gd name="connsiteX2" fmla="*/ 574465 w 1224418"/>
                <a:gd name="connsiteY2" fmla="*/ 950618 h 1375197"/>
                <a:gd name="connsiteX3" fmla="*/ 4504 w 1224418"/>
                <a:gd name="connsiteY3" fmla="*/ 595746 h 1375197"/>
                <a:gd name="connsiteX4" fmla="*/ 58926 w 1224418"/>
                <a:gd name="connsiteY4" fmla="*/ 193407 h 1375197"/>
                <a:gd name="connsiteX5" fmla="*/ 255334 w 1224418"/>
                <a:gd name="connsiteY5" fmla="*/ 11728 h 1375197"/>
                <a:gd name="connsiteX6" fmla="*/ 693839 w 1224418"/>
                <a:gd name="connsiteY6" fmla="*/ 60962 h 1375197"/>
                <a:gd name="connsiteX7" fmla="*/ 1055336 w 1224418"/>
                <a:gd name="connsiteY7" fmla="*/ 408151 h 1375197"/>
                <a:gd name="connsiteX8" fmla="*/ 1212338 w 1224418"/>
                <a:gd name="connsiteY8" fmla="*/ 711588 h 1375197"/>
                <a:gd name="connsiteX9" fmla="*/ 1205036 w 1224418"/>
                <a:gd name="connsiteY9" fmla="*/ 1063065 h 1375197"/>
                <a:gd name="connsiteX0" fmla="*/ 1205036 w 1224418"/>
                <a:gd name="connsiteY0" fmla="*/ 1063065 h 1375197"/>
                <a:gd name="connsiteX1" fmla="*/ 1135254 w 1224418"/>
                <a:gd name="connsiteY1" fmla="*/ 1375000 h 1375197"/>
                <a:gd name="connsiteX2" fmla="*/ 574465 w 1224418"/>
                <a:gd name="connsiteY2" fmla="*/ 950618 h 1375197"/>
                <a:gd name="connsiteX3" fmla="*/ 4504 w 1224418"/>
                <a:gd name="connsiteY3" fmla="*/ 595746 h 1375197"/>
                <a:gd name="connsiteX4" fmla="*/ 58926 w 1224418"/>
                <a:gd name="connsiteY4" fmla="*/ 193407 h 1375197"/>
                <a:gd name="connsiteX5" fmla="*/ 255334 w 1224418"/>
                <a:gd name="connsiteY5" fmla="*/ 11728 h 1375197"/>
                <a:gd name="connsiteX6" fmla="*/ 693839 w 1224418"/>
                <a:gd name="connsiteY6" fmla="*/ 60962 h 1375197"/>
                <a:gd name="connsiteX7" fmla="*/ 1055336 w 1224418"/>
                <a:gd name="connsiteY7" fmla="*/ 408151 h 1375197"/>
                <a:gd name="connsiteX8" fmla="*/ 1212338 w 1224418"/>
                <a:gd name="connsiteY8" fmla="*/ 711588 h 1375197"/>
                <a:gd name="connsiteX9" fmla="*/ 1205036 w 1224418"/>
                <a:gd name="connsiteY9" fmla="*/ 1063065 h 1375197"/>
                <a:gd name="connsiteX0" fmla="*/ 1205036 w 1224418"/>
                <a:gd name="connsiteY0" fmla="*/ 1063065 h 1375197"/>
                <a:gd name="connsiteX1" fmla="*/ 1135254 w 1224418"/>
                <a:gd name="connsiteY1" fmla="*/ 1375000 h 1375197"/>
                <a:gd name="connsiteX2" fmla="*/ 574465 w 1224418"/>
                <a:gd name="connsiteY2" fmla="*/ 950618 h 1375197"/>
                <a:gd name="connsiteX3" fmla="*/ 4504 w 1224418"/>
                <a:gd name="connsiteY3" fmla="*/ 595746 h 1375197"/>
                <a:gd name="connsiteX4" fmla="*/ 58926 w 1224418"/>
                <a:gd name="connsiteY4" fmla="*/ 193407 h 1375197"/>
                <a:gd name="connsiteX5" fmla="*/ 255334 w 1224418"/>
                <a:gd name="connsiteY5" fmla="*/ 11728 h 1375197"/>
                <a:gd name="connsiteX6" fmla="*/ 693839 w 1224418"/>
                <a:gd name="connsiteY6" fmla="*/ 60962 h 1375197"/>
                <a:gd name="connsiteX7" fmla="*/ 1055336 w 1224418"/>
                <a:gd name="connsiteY7" fmla="*/ 408151 h 1375197"/>
                <a:gd name="connsiteX8" fmla="*/ 1212338 w 1224418"/>
                <a:gd name="connsiteY8" fmla="*/ 711588 h 1375197"/>
                <a:gd name="connsiteX9" fmla="*/ 1205036 w 1224418"/>
                <a:gd name="connsiteY9" fmla="*/ 1063065 h 1375197"/>
                <a:gd name="connsiteX0" fmla="*/ 1205036 w 1224418"/>
                <a:gd name="connsiteY0" fmla="*/ 1066489 h 1378621"/>
                <a:gd name="connsiteX1" fmla="*/ 1135254 w 1224418"/>
                <a:gd name="connsiteY1" fmla="*/ 1378424 h 1378621"/>
                <a:gd name="connsiteX2" fmla="*/ 574465 w 1224418"/>
                <a:gd name="connsiteY2" fmla="*/ 954042 h 1378621"/>
                <a:gd name="connsiteX3" fmla="*/ 4504 w 1224418"/>
                <a:gd name="connsiteY3" fmla="*/ 599170 h 1378621"/>
                <a:gd name="connsiteX4" fmla="*/ 58926 w 1224418"/>
                <a:gd name="connsiteY4" fmla="*/ 196831 h 1378621"/>
                <a:gd name="connsiteX5" fmla="*/ 255334 w 1224418"/>
                <a:gd name="connsiteY5" fmla="*/ 15152 h 1378621"/>
                <a:gd name="connsiteX6" fmla="*/ 693839 w 1224418"/>
                <a:gd name="connsiteY6" fmla="*/ 64386 h 1378621"/>
                <a:gd name="connsiteX7" fmla="*/ 1055336 w 1224418"/>
                <a:gd name="connsiteY7" fmla="*/ 411575 h 1378621"/>
                <a:gd name="connsiteX8" fmla="*/ 1212338 w 1224418"/>
                <a:gd name="connsiteY8" fmla="*/ 715012 h 1378621"/>
                <a:gd name="connsiteX9" fmla="*/ 1205036 w 1224418"/>
                <a:gd name="connsiteY9" fmla="*/ 1066489 h 1378621"/>
                <a:gd name="connsiteX0" fmla="*/ 1159004 w 1178386"/>
                <a:gd name="connsiteY0" fmla="*/ 1066489 h 1378621"/>
                <a:gd name="connsiteX1" fmla="*/ 1089222 w 1178386"/>
                <a:gd name="connsiteY1" fmla="*/ 1378424 h 1378621"/>
                <a:gd name="connsiteX2" fmla="*/ 528433 w 1178386"/>
                <a:gd name="connsiteY2" fmla="*/ 954042 h 1378621"/>
                <a:gd name="connsiteX3" fmla="*/ 28705 w 1178386"/>
                <a:gd name="connsiteY3" fmla="*/ 565707 h 1378621"/>
                <a:gd name="connsiteX4" fmla="*/ 12894 w 1178386"/>
                <a:gd name="connsiteY4" fmla="*/ 196831 h 1378621"/>
                <a:gd name="connsiteX5" fmla="*/ 209302 w 1178386"/>
                <a:gd name="connsiteY5" fmla="*/ 15152 h 1378621"/>
                <a:gd name="connsiteX6" fmla="*/ 647807 w 1178386"/>
                <a:gd name="connsiteY6" fmla="*/ 64386 h 1378621"/>
                <a:gd name="connsiteX7" fmla="*/ 1009304 w 1178386"/>
                <a:gd name="connsiteY7" fmla="*/ 411575 h 1378621"/>
                <a:gd name="connsiteX8" fmla="*/ 1166306 w 1178386"/>
                <a:gd name="connsiteY8" fmla="*/ 715012 h 1378621"/>
                <a:gd name="connsiteX9" fmla="*/ 1159004 w 1178386"/>
                <a:gd name="connsiteY9" fmla="*/ 1066489 h 1378621"/>
                <a:gd name="connsiteX0" fmla="*/ 1159004 w 1178386"/>
                <a:gd name="connsiteY0" fmla="*/ 1066489 h 1378621"/>
                <a:gd name="connsiteX1" fmla="*/ 1089222 w 1178386"/>
                <a:gd name="connsiteY1" fmla="*/ 1378424 h 1378621"/>
                <a:gd name="connsiteX2" fmla="*/ 528433 w 1178386"/>
                <a:gd name="connsiteY2" fmla="*/ 954042 h 1378621"/>
                <a:gd name="connsiteX3" fmla="*/ 28705 w 1178386"/>
                <a:gd name="connsiteY3" fmla="*/ 565707 h 1378621"/>
                <a:gd name="connsiteX4" fmla="*/ 12894 w 1178386"/>
                <a:gd name="connsiteY4" fmla="*/ 196831 h 1378621"/>
                <a:gd name="connsiteX5" fmla="*/ 209302 w 1178386"/>
                <a:gd name="connsiteY5" fmla="*/ 15152 h 1378621"/>
                <a:gd name="connsiteX6" fmla="*/ 647807 w 1178386"/>
                <a:gd name="connsiteY6" fmla="*/ 64386 h 1378621"/>
                <a:gd name="connsiteX7" fmla="*/ 1009304 w 1178386"/>
                <a:gd name="connsiteY7" fmla="*/ 411575 h 1378621"/>
                <a:gd name="connsiteX8" fmla="*/ 1166306 w 1178386"/>
                <a:gd name="connsiteY8" fmla="*/ 715012 h 1378621"/>
                <a:gd name="connsiteX9" fmla="*/ 1159004 w 1178386"/>
                <a:gd name="connsiteY9" fmla="*/ 1066489 h 1378621"/>
                <a:gd name="connsiteX0" fmla="*/ 1217724 w 1237106"/>
                <a:gd name="connsiteY0" fmla="*/ 1066489 h 1378621"/>
                <a:gd name="connsiteX1" fmla="*/ 1147942 w 1237106"/>
                <a:gd name="connsiteY1" fmla="*/ 1378424 h 1378621"/>
                <a:gd name="connsiteX2" fmla="*/ 587153 w 1237106"/>
                <a:gd name="connsiteY2" fmla="*/ 954042 h 1378621"/>
                <a:gd name="connsiteX3" fmla="*/ 3600 w 1237106"/>
                <a:gd name="connsiteY3" fmla="*/ 418299 h 1378621"/>
                <a:gd name="connsiteX4" fmla="*/ 71614 w 1237106"/>
                <a:gd name="connsiteY4" fmla="*/ 196831 h 1378621"/>
                <a:gd name="connsiteX5" fmla="*/ 268022 w 1237106"/>
                <a:gd name="connsiteY5" fmla="*/ 15152 h 1378621"/>
                <a:gd name="connsiteX6" fmla="*/ 706527 w 1237106"/>
                <a:gd name="connsiteY6" fmla="*/ 64386 h 1378621"/>
                <a:gd name="connsiteX7" fmla="*/ 1068024 w 1237106"/>
                <a:gd name="connsiteY7" fmla="*/ 411575 h 1378621"/>
                <a:gd name="connsiteX8" fmla="*/ 1225026 w 1237106"/>
                <a:gd name="connsiteY8" fmla="*/ 715012 h 1378621"/>
                <a:gd name="connsiteX9" fmla="*/ 1217724 w 1237106"/>
                <a:gd name="connsiteY9" fmla="*/ 1066489 h 1378621"/>
                <a:gd name="connsiteX0" fmla="*/ 1217724 w 1237106"/>
                <a:gd name="connsiteY0" fmla="*/ 1066489 h 1378621"/>
                <a:gd name="connsiteX1" fmla="*/ 1147942 w 1237106"/>
                <a:gd name="connsiteY1" fmla="*/ 1378424 h 1378621"/>
                <a:gd name="connsiteX2" fmla="*/ 587153 w 1237106"/>
                <a:gd name="connsiteY2" fmla="*/ 954042 h 1378621"/>
                <a:gd name="connsiteX3" fmla="*/ 220651 w 1237106"/>
                <a:gd name="connsiteY3" fmla="*/ 647034 h 1378621"/>
                <a:gd name="connsiteX4" fmla="*/ 3600 w 1237106"/>
                <a:gd name="connsiteY4" fmla="*/ 418299 h 1378621"/>
                <a:gd name="connsiteX5" fmla="*/ 71614 w 1237106"/>
                <a:gd name="connsiteY5" fmla="*/ 196831 h 1378621"/>
                <a:gd name="connsiteX6" fmla="*/ 268022 w 1237106"/>
                <a:gd name="connsiteY6" fmla="*/ 15152 h 1378621"/>
                <a:gd name="connsiteX7" fmla="*/ 706527 w 1237106"/>
                <a:gd name="connsiteY7" fmla="*/ 64386 h 1378621"/>
                <a:gd name="connsiteX8" fmla="*/ 1068024 w 1237106"/>
                <a:gd name="connsiteY8" fmla="*/ 411575 h 1378621"/>
                <a:gd name="connsiteX9" fmla="*/ 1225026 w 1237106"/>
                <a:gd name="connsiteY9" fmla="*/ 715012 h 1378621"/>
                <a:gd name="connsiteX10" fmla="*/ 1217724 w 1237106"/>
                <a:gd name="connsiteY10" fmla="*/ 1066489 h 1378621"/>
                <a:gd name="connsiteX0" fmla="*/ 1217724 w 1237106"/>
                <a:gd name="connsiteY0" fmla="*/ 1066489 h 1378621"/>
                <a:gd name="connsiteX1" fmla="*/ 1147942 w 1237106"/>
                <a:gd name="connsiteY1" fmla="*/ 1378424 h 1378621"/>
                <a:gd name="connsiteX2" fmla="*/ 587153 w 1237106"/>
                <a:gd name="connsiteY2" fmla="*/ 954042 h 1378621"/>
                <a:gd name="connsiteX3" fmla="*/ 220651 w 1237106"/>
                <a:gd name="connsiteY3" fmla="*/ 647034 h 1378621"/>
                <a:gd name="connsiteX4" fmla="*/ 3600 w 1237106"/>
                <a:gd name="connsiteY4" fmla="*/ 418299 h 1378621"/>
                <a:gd name="connsiteX5" fmla="*/ 71614 w 1237106"/>
                <a:gd name="connsiteY5" fmla="*/ 196831 h 1378621"/>
                <a:gd name="connsiteX6" fmla="*/ 268022 w 1237106"/>
                <a:gd name="connsiteY6" fmla="*/ 15152 h 1378621"/>
                <a:gd name="connsiteX7" fmla="*/ 706527 w 1237106"/>
                <a:gd name="connsiteY7" fmla="*/ 64386 h 1378621"/>
                <a:gd name="connsiteX8" fmla="*/ 1068024 w 1237106"/>
                <a:gd name="connsiteY8" fmla="*/ 411575 h 1378621"/>
                <a:gd name="connsiteX9" fmla="*/ 1225026 w 1237106"/>
                <a:gd name="connsiteY9" fmla="*/ 715012 h 1378621"/>
                <a:gd name="connsiteX10" fmla="*/ 1217724 w 1237106"/>
                <a:gd name="connsiteY10" fmla="*/ 1066489 h 1378621"/>
                <a:gd name="connsiteX0" fmla="*/ 1217724 w 1237106"/>
                <a:gd name="connsiteY0" fmla="*/ 1066489 h 1378621"/>
                <a:gd name="connsiteX1" fmla="*/ 1147942 w 1237106"/>
                <a:gd name="connsiteY1" fmla="*/ 1378424 h 1378621"/>
                <a:gd name="connsiteX2" fmla="*/ 587153 w 1237106"/>
                <a:gd name="connsiteY2" fmla="*/ 954042 h 1378621"/>
                <a:gd name="connsiteX3" fmla="*/ 220651 w 1237106"/>
                <a:gd name="connsiteY3" fmla="*/ 647034 h 1378621"/>
                <a:gd name="connsiteX4" fmla="*/ 3600 w 1237106"/>
                <a:gd name="connsiteY4" fmla="*/ 418299 h 1378621"/>
                <a:gd name="connsiteX5" fmla="*/ 71614 w 1237106"/>
                <a:gd name="connsiteY5" fmla="*/ 196831 h 1378621"/>
                <a:gd name="connsiteX6" fmla="*/ 268022 w 1237106"/>
                <a:gd name="connsiteY6" fmla="*/ 15152 h 1378621"/>
                <a:gd name="connsiteX7" fmla="*/ 706527 w 1237106"/>
                <a:gd name="connsiteY7" fmla="*/ 64386 h 1378621"/>
                <a:gd name="connsiteX8" fmla="*/ 1068024 w 1237106"/>
                <a:gd name="connsiteY8" fmla="*/ 411575 h 1378621"/>
                <a:gd name="connsiteX9" fmla="*/ 1225026 w 1237106"/>
                <a:gd name="connsiteY9" fmla="*/ 715012 h 1378621"/>
                <a:gd name="connsiteX10" fmla="*/ 1217724 w 1237106"/>
                <a:gd name="connsiteY10" fmla="*/ 1066489 h 1378621"/>
                <a:gd name="connsiteX0" fmla="*/ 1217724 w 1237106"/>
                <a:gd name="connsiteY0" fmla="*/ 1066489 h 1378621"/>
                <a:gd name="connsiteX1" fmla="*/ 1147942 w 1237106"/>
                <a:gd name="connsiteY1" fmla="*/ 1378424 h 1378621"/>
                <a:gd name="connsiteX2" fmla="*/ 587153 w 1237106"/>
                <a:gd name="connsiteY2" fmla="*/ 954042 h 1378621"/>
                <a:gd name="connsiteX3" fmla="*/ 220651 w 1237106"/>
                <a:gd name="connsiteY3" fmla="*/ 647034 h 1378621"/>
                <a:gd name="connsiteX4" fmla="*/ 3600 w 1237106"/>
                <a:gd name="connsiteY4" fmla="*/ 418299 h 1378621"/>
                <a:gd name="connsiteX5" fmla="*/ 71614 w 1237106"/>
                <a:gd name="connsiteY5" fmla="*/ 196831 h 1378621"/>
                <a:gd name="connsiteX6" fmla="*/ 268022 w 1237106"/>
                <a:gd name="connsiteY6" fmla="*/ 15152 h 1378621"/>
                <a:gd name="connsiteX7" fmla="*/ 706527 w 1237106"/>
                <a:gd name="connsiteY7" fmla="*/ 64386 h 1378621"/>
                <a:gd name="connsiteX8" fmla="*/ 1068024 w 1237106"/>
                <a:gd name="connsiteY8" fmla="*/ 411575 h 1378621"/>
                <a:gd name="connsiteX9" fmla="*/ 1225026 w 1237106"/>
                <a:gd name="connsiteY9" fmla="*/ 715012 h 1378621"/>
                <a:gd name="connsiteX10" fmla="*/ 1217724 w 1237106"/>
                <a:gd name="connsiteY10" fmla="*/ 1066489 h 1378621"/>
                <a:gd name="connsiteX0" fmla="*/ 1255564 w 1274946"/>
                <a:gd name="connsiteY0" fmla="*/ 1066489 h 1378621"/>
                <a:gd name="connsiteX1" fmla="*/ 1185782 w 1274946"/>
                <a:gd name="connsiteY1" fmla="*/ 1378424 h 1378621"/>
                <a:gd name="connsiteX2" fmla="*/ 624993 w 1274946"/>
                <a:gd name="connsiteY2" fmla="*/ 954042 h 1378621"/>
                <a:gd name="connsiteX3" fmla="*/ 258491 w 1274946"/>
                <a:gd name="connsiteY3" fmla="*/ 647034 h 1378621"/>
                <a:gd name="connsiteX4" fmla="*/ 2256 w 1274946"/>
                <a:gd name="connsiteY4" fmla="*/ 388918 h 1378621"/>
                <a:gd name="connsiteX5" fmla="*/ 109454 w 1274946"/>
                <a:gd name="connsiteY5" fmla="*/ 196831 h 1378621"/>
                <a:gd name="connsiteX6" fmla="*/ 305862 w 1274946"/>
                <a:gd name="connsiteY6" fmla="*/ 15152 h 1378621"/>
                <a:gd name="connsiteX7" fmla="*/ 744367 w 1274946"/>
                <a:gd name="connsiteY7" fmla="*/ 64386 h 1378621"/>
                <a:gd name="connsiteX8" fmla="*/ 1105864 w 1274946"/>
                <a:gd name="connsiteY8" fmla="*/ 411575 h 1378621"/>
                <a:gd name="connsiteX9" fmla="*/ 1262866 w 1274946"/>
                <a:gd name="connsiteY9" fmla="*/ 715012 h 1378621"/>
                <a:gd name="connsiteX10" fmla="*/ 1255564 w 1274946"/>
                <a:gd name="connsiteY10" fmla="*/ 1066489 h 1378621"/>
                <a:gd name="connsiteX0" fmla="*/ 1256593 w 1275975"/>
                <a:gd name="connsiteY0" fmla="*/ 1064484 h 1376616"/>
                <a:gd name="connsiteX1" fmla="*/ 1186811 w 1275975"/>
                <a:gd name="connsiteY1" fmla="*/ 1376419 h 1376616"/>
                <a:gd name="connsiteX2" fmla="*/ 626022 w 1275975"/>
                <a:gd name="connsiteY2" fmla="*/ 952037 h 1376616"/>
                <a:gd name="connsiteX3" fmla="*/ 259520 w 1275975"/>
                <a:gd name="connsiteY3" fmla="*/ 645029 h 1376616"/>
                <a:gd name="connsiteX4" fmla="*/ 3285 w 1275975"/>
                <a:gd name="connsiteY4" fmla="*/ 386913 h 1376616"/>
                <a:gd name="connsiteX5" fmla="*/ 82886 w 1275975"/>
                <a:gd name="connsiteY5" fmla="*/ 167104 h 1376616"/>
                <a:gd name="connsiteX6" fmla="*/ 306891 w 1275975"/>
                <a:gd name="connsiteY6" fmla="*/ 13147 h 1376616"/>
                <a:gd name="connsiteX7" fmla="*/ 745396 w 1275975"/>
                <a:gd name="connsiteY7" fmla="*/ 62381 h 1376616"/>
                <a:gd name="connsiteX8" fmla="*/ 1106893 w 1275975"/>
                <a:gd name="connsiteY8" fmla="*/ 409570 h 1376616"/>
                <a:gd name="connsiteX9" fmla="*/ 1263895 w 1275975"/>
                <a:gd name="connsiteY9" fmla="*/ 713007 h 1376616"/>
                <a:gd name="connsiteX10" fmla="*/ 1256593 w 1275975"/>
                <a:gd name="connsiteY10" fmla="*/ 1064484 h 1376616"/>
                <a:gd name="connsiteX0" fmla="*/ 1277363 w 1296745"/>
                <a:gd name="connsiteY0" fmla="*/ 1064484 h 1376616"/>
                <a:gd name="connsiteX1" fmla="*/ 1207581 w 1296745"/>
                <a:gd name="connsiteY1" fmla="*/ 1376419 h 1376616"/>
                <a:gd name="connsiteX2" fmla="*/ 646792 w 1296745"/>
                <a:gd name="connsiteY2" fmla="*/ 952037 h 1376616"/>
                <a:gd name="connsiteX3" fmla="*/ 280290 w 1296745"/>
                <a:gd name="connsiteY3" fmla="*/ 645029 h 1376616"/>
                <a:gd name="connsiteX4" fmla="*/ 2532 w 1296745"/>
                <a:gd name="connsiteY4" fmla="*/ 371946 h 1376616"/>
                <a:gd name="connsiteX5" fmla="*/ 103656 w 1296745"/>
                <a:gd name="connsiteY5" fmla="*/ 167104 h 1376616"/>
                <a:gd name="connsiteX6" fmla="*/ 327661 w 1296745"/>
                <a:gd name="connsiteY6" fmla="*/ 13147 h 1376616"/>
                <a:gd name="connsiteX7" fmla="*/ 766166 w 1296745"/>
                <a:gd name="connsiteY7" fmla="*/ 62381 h 1376616"/>
                <a:gd name="connsiteX8" fmla="*/ 1127663 w 1296745"/>
                <a:gd name="connsiteY8" fmla="*/ 409570 h 1376616"/>
                <a:gd name="connsiteX9" fmla="*/ 1284665 w 1296745"/>
                <a:gd name="connsiteY9" fmla="*/ 713007 h 1376616"/>
                <a:gd name="connsiteX10" fmla="*/ 1277363 w 1296745"/>
                <a:gd name="connsiteY10" fmla="*/ 1064484 h 1376616"/>
                <a:gd name="connsiteX0" fmla="*/ 1278784 w 1298166"/>
                <a:gd name="connsiteY0" fmla="*/ 1063046 h 1375178"/>
                <a:gd name="connsiteX1" fmla="*/ 1209002 w 1298166"/>
                <a:gd name="connsiteY1" fmla="*/ 1374981 h 1375178"/>
                <a:gd name="connsiteX2" fmla="*/ 648213 w 1298166"/>
                <a:gd name="connsiteY2" fmla="*/ 950599 h 1375178"/>
                <a:gd name="connsiteX3" fmla="*/ 281711 w 1298166"/>
                <a:gd name="connsiteY3" fmla="*/ 643591 h 1375178"/>
                <a:gd name="connsiteX4" fmla="*/ 3953 w 1298166"/>
                <a:gd name="connsiteY4" fmla="*/ 370508 h 1375178"/>
                <a:gd name="connsiteX5" fmla="*/ 76379 w 1298166"/>
                <a:gd name="connsiteY5" fmla="*/ 145710 h 1375178"/>
                <a:gd name="connsiteX6" fmla="*/ 329082 w 1298166"/>
                <a:gd name="connsiteY6" fmla="*/ 11709 h 1375178"/>
                <a:gd name="connsiteX7" fmla="*/ 767587 w 1298166"/>
                <a:gd name="connsiteY7" fmla="*/ 60943 h 1375178"/>
                <a:gd name="connsiteX8" fmla="*/ 1129084 w 1298166"/>
                <a:gd name="connsiteY8" fmla="*/ 408132 h 1375178"/>
                <a:gd name="connsiteX9" fmla="*/ 1286086 w 1298166"/>
                <a:gd name="connsiteY9" fmla="*/ 711569 h 1375178"/>
                <a:gd name="connsiteX10" fmla="*/ 1278784 w 1298166"/>
                <a:gd name="connsiteY10" fmla="*/ 1063046 h 1375178"/>
                <a:gd name="connsiteX0" fmla="*/ 1278690 w 1298072"/>
                <a:gd name="connsiteY0" fmla="*/ 1106778 h 1418910"/>
                <a:gd name="connsiteX1" fmla="*/ 1208908 w 1298072"/>
                <a:gd name="connsiteY1" fmla="*/ 1418713 h 1418910"/>
                <a:gd name="connsiteX2" fmla="*/ 648119 w 1298072"/>
                <a:gd name="connsiteY2" fmla="*/ 994331 h 1418910"/>
                <a:gd name="connsiteX3" fmla="*/ 281617 w 1298072"/>
                <a:gd name="connsiteY3" fmla="*/ 687323 h 1418910"/>
                <a:gd name="connsiteX4" fmla="*/ 3859 w 1298072"/>
                <a:gd name="connsiteY4" fmla="*/ 414240 h 1418910"/>
                <a:gd name="connsiteX5" fmla="*/ 76285 w 1298072"/>
                <a:gd name="connsiteY5" fmla="*/ 189442 h 1418910"/>
                <a:gd name="connsiteX6" fmla="*/ 320691 w 1298072"/>
                <a:gd name="connsiteY6" fmla="*/ 2752 h 1418910"/>
                <a:gd name="connsiteX7" fmla="*/ 767493 w 1298072"/>
                <a:gd name="connsiteY7" fmla="*/ 104675 h 1418910"/>
                <a:gd name="connsiteX8" fmla="*/ 1128990 w 1298072"/>
                <a:gd name="connsiteY8" fmla="*/ 451864 h 1418910"/>
                <a:gd name="connsiteX9" fmla="*/ 1285992 w 1298072"/>
                <a:gd name="connsiteY9" fmla="*/ 755301 h 1418910"/>
                <a:gd name="connsiteX10" fmla="*/ 1278690 w 1298072"/>
                <a:gd name="connsiteY10" fmla="*/ 1106778 h 1418910"/>
                <a:gd name="connsiteX0" fmla="*/ 1278690 w 1298072"/>
                <a:gd name="connsiteY0" fmla="*/ 1118684 h 1430816"/>
                <a:gd name="connsiteX1" fmla="*/ 1208908 w 1298072"/>
                <a:gd name="connsiteY1" fmla="*/ 1430619 h 1430816"/>
                <a:gd name="connsiteX2" fmla="*/ 648119 w 1298072"/>
                <a:gd name="connsiteY2" fmla="*/ 1006237 h 1430816"/>
                <a:gd name="connsiteX3" fmla="*/ 281617 w 1298072"/>
                <a:gd name="connsiteY3" fmla="*/ 699229 h 1430816"/>
                <a:gd name="connsiteX4" fmla="*/ 3859 w 1298072"/>
                <a:gd name="connsiteY4" fmla="*/ 426146 h 1430816"/>
                <a:gd name="connsiteX5" fmla="*/ 76285 w 1298072"/>
                <a:gd name="connsiteY5" fmla="*/ 201348 h 1430816"/>
                <a:gd name="connsiteX6" fmla="*/ 320691 w 1298072"/>
                <a:gd name="connsiteY6" fmla="*/ 14658 h 1430816"/>
                <a:gd name="connsiteX7" fmla="*/ 751472 w 1298072"/>
                <a:gd name="connsiteY7" fmla="*/ 62785 h 1430816"/>
                <a:gd name="connsiteX8" fmla="*/ 1128990 w 1298072"/>
                <a:gd name="connsiteY8" fmla="*/ 463770 h 1430816"/>
                <a:gd name="connsiteX9" fmla="*/ 1285992 w 1298072"/>
                <a:gd name="connsiteY9" fmla="*/ 767207 h 1430816"/>
                <a:gd name="connsiteX10" fmla="*/ 1278690 w 1298072"/>
                <a:gd name="connsiteY10" fmla="*/ 1118684 h 1430816"/>
                <a:gd name="connsiteX0" fmla="*/ 1278438 w 1297820"/>
                <a:gd name="connsiteY0" fmla="*/ 1140348 h 1452480"/>
                <a:gd name="connsiteX1" fmla="*/ 1208656 w 1297820"/>
                <a:gd name="connsiteY1" fmla="*/ 1452283 h 1452480"/>
                <a:gd name="connsiteX2" fmla="*/ 647867 w 1297820"/>
                <a:gd name="connsiteY2" fmla="*/ 1027901 h 1452480"/>
                <a:gd name="connsiteX3" fmla="*/ 281365 w 1297820"/>
                <a:gd name="connsiteY3" fmla="*/ 720893 h 1452480"/>
                <a:gd name="connsiteX4" fmla="*/ 3607 w 1297820"/>
                <a:gd name="connsiteY4" fmla="*/ 447810 h 1452480"/>
                <a:gd name="connsiteX5" fmla="*/ 76033 w 1297820"/>
                <a:gd name="connsiteY5" fmla="*/ 223012 h 1452480"/>
                <a:gd name="connsiteX6" fmla="*/ 296704 w 1297820"/>
                <a:gd name="connsiteY6" fmla="*/ 9153 h 1452480"/>
                <a:gd name="connsiteX7" fmla="*/ 751220 w 1297820"/>
                <a:gd name="connsiteY7" fmla="*/ 84449 h 1452480"/>
                <a:gd name="connsiteX8" fmla="*/ 1128738 w 1297820"/>
                <a:gd name="connsiteY8" fmla="*/ 485434 h 1452480"/>
                <a:gd name="connsiteX9" fmla="*/ 1285740 w 1297820"/>
                <a:gd name="connsiteY9" fmla="*/ 788871 h 1452480"/>
                <a:gd name="connsiteX10" fmla="*/ 1278438 w 1297820"/>
                <a:gd name="connsiteY10" fmla="*/ 1140348 h 1452480"/>
                <a:gd name="connsiteX0" fmla="*/ 1278438 w 1297820"/>
                <a:gd name="connsiteY0" fmla="*/ 1140348 h 1452480"/>
                <a:gd name="connsiteX1" fmla="*/ 1208656 w 1297820"/>
                <a:gd name="connsiteY1" fmla="*/ 1452283 h 1452480"/>
                <a:gd name="connsiteX2" fmla="*/ 647867 w 1297820"/>
                <a:gd name="connsiteY2" fmla="*/ 1027901 h 1452480"/>
                <a:gd name="connsiteX3" fmla="*/ 281365 w 1297820"/>
                <a:gd name="connsiteY3" fmla="*/ 720893 h 1452480"/>
                <a:gd name="connsiteX4" fmla="*/ 3607 w 1297820"/>
                <a:gd name="connsiteY4" fmla="*/ 447810 h 1452480"/>
                <a:gd name="connsiteX5" fmla="*/ 76033 w 1297820"/>
                <a:gd name="connsiteY5" fmla="*/ 223012 h 1452480"/>
                <a:gd name="connsiteX6" fmla="*/ 296704 w 1297820"/>
                <a:gd name="connsiteY6" fmla="*/ 9153 h 1452480"/>
                <a:gd name="connsiteX7" fmla="*/ 751220 w 1297820"/>
                <a:gd name="connsiteY7" fmla="*/ 84449 h 1452480"/>
                <a:gd name="connsiteX8" fmla="*/ 1128738 w 1297820"/>
                <a:gd name="connsiteY8" fmla="*/ 485434 h 1452480"/>
                <a:gd name="connsiteX9" fmla="*/ 1285740 w 1297820"/>
                <a:gd name="connsiteY9" fmla="*/ 788871 h 1452480"/>
                <a:gd name="connsiteX10" fmla="*/ 1278438 w 1297820"/>
                <a:gd name="connsiteY10" fmla="*/ 1140348 h 1452480"/>
                <a:gd name="connsiteX0" fmla="*/ 1278076 w 1297458"/>
                <a:gd name="connsiteY0" fmla="*/ 1139452 h 1451584"/>
                <a:gd name="connsiteX1" fmla="*/ 1208294 w 1297458"/>
                <a:gd name="connsiteY1" fmla="*/ 1451387 h 1451584"/>
                <a:gd name="connsiteX2" fmla="*/ 647505 w 1297458"/>
                <a:gd name="connsiteY2" fmla="*/ 1027005 h 1451584"/>
                <a:gd name="connsiteX3" fmla="*/ 281003 w 1297458"/>
                <a:gd name="connsiteY3" fmla="*/ 719997 h 1451584"/>
                <a:gd name="connsiteX4" fmla="*/ 3245 w 1297458"/>
                <a:gd name="connsiteY4" fmla="*/ 446914 h 1451584"/>
                <a:gd name="connsiteX5" fmla="*/ 81949 w 1297458"/>
                <a:gd name="connsiteY5" fmla="*/ 209479 h 1451584"/>
                <a:gd name="connsiteX6" fmla="*/ 296342 w 1297458"/>
                <a:gd name="connsiteY6" fmla="*/ 8257 h 1451584"/>
                <a:gd name="connsiteX7" fmla="*/ 750858 w 1297458"/>
                <a:gd name="connsiteY7" fmla="*/ 83553 h 1451584"/>
                <a:gd name="connsiteX8" fmla="*/ 1128376 w 1297458"/>
                <a:gd name="connsiteY8" fmla="*/ 484538 h 1451584"/>
                <a:gd name="connsiteX9" fmla="*/ 1285378 w 1297458"/>
                <a:gd name="connsiteY9" fmla="*/ 787975 h 1451584"/>
                <a:gd name="connsiteX10" fmla="*/ 1278076 w 1297458"/>
                <a:gd name="connsiteY10" fmla="*/ 1139452 h 145158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</a:cxnLst>
              <a:rect l="l" t="t" r="r" b="b"/>
              <a:pathLst>
                <a:path w="1297458" h="1451584">
                  <a:moveTo>
                    <a:pt x="1278076" y="1139452"/>
                  </a:moveTo>
                  <a:cubicBezTo>
                    <a:pt x="1265229" y="1250021"/>
                    <a:pt x="1228778" y="1458905"/>
                    <a:pt x="1208294" y="1451387"/>
                  </a:cubicBezTo>
                  <a:cubicBezTo>
                    <a:pt x="1187810" y="1443869"/>
                    <a:pt x="802053" y="1148903"/>
                    <a:pt x="647505" y="1027005"/>
                  </a:cubicBezTo>
                  <a:cubicBezTo>
                    <a:pt x="492957" y="905107"/>
                    <a:pt x="378262" y="809287"/>
                    <a:pt x="281003" y="719997"/>
                  </a:cubicBezTo>
                  <a:cubicBezTo>
                    <a:pt x="183744" y="630707"/>
                    <a:pt x="54891" y="514121"/>
                    <a:pt x="3245" y="446914"/>
                  </a:cubicBezTo>
                  <a:cubicBezTo>
                    <a:pt x="-12755" y="332696"/>
                    <a:pt x="33100" y="282588"/>
                    <a:pt x="81949" y="209479"/>
                  </a:cubicBezTo>
                  <a:cubicBezTo>
                    <a:pt x="130798" y="136370"/>
                    <a:pt x="184857" y="29245"/>
                    <a:pt x="296342" y="8257"/>
                  </a:cubicBezTo>
                  <a:cubicBezTo>
                    <a:pt x="407827" y="-12731"/>
                    <a:pt x="612186" y="4173"/>
                    <a:pt x="750858" y="83553"/>
                  </a:cubicBezTo>
                  <a:cubicBezTo>
                    <a:pt x="889530" y="162933"/>
                    <a:pt x="1041960" y="376100"/>
                    <a:pt x="1128376" y="484538"/>
                  </a:cubicBezTo>
                  <a:cubicBezTo>
                    <a:pt x="1214793" y="592976"/>
                    <a:pt x="1260428" y="678823"/>
                    <a:pt x="1285378" y="787975"/>
                  </a:cubicBezTo>
                  <a:cubicBezTo>
                    <a:pt x="1310328" y="897127"/>
                    <a:pt x="1290923" y="1028883"/>
                    <a:pt x="1278076" y="1139452"/>
                  </a:cubicBezTo>
                  <a:close/>
                </a:path>
              </a:pathLst>
            </a:custGeom>
            <a:noFill/>
            <a:ln w="76200" cmpd="thickThin">
              <a:solidFill>
                <a:srgbClr val="00B0F0"/>
              </a:solidFill>
            </a:ln>
            <a:effectLst>
              <a:outerShdw blurRad="50800" dist="38100" algn="l" rotWithShape="0">
                <a:prstClr val="black">
                  <a:alpha val="40000"/>
                </a:prstClr>
              </a:outerShdw>
              <a:reflection stA="85000" endPos="0" dist="50800" dir="5400000" sy="-100000" algn="bl" rotWithShape="0"/>
              <a:softEdge rad="0"/>
            </a:effectLst>
            <a:scene3d>
              <a:camera prst="orthographicFront"/>
              <a:lightRig rig="threePt" dir="t"/>
            </a:scene3d>
            <a:sp3d>
              <a:bevelT w="44450" h="6350" prst="hardEdge"/>
            </a:sp3d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400"/>
            </a:p>
          </p:txBody>
        </p:sp>
        <p:sp>
          <p:nvSpPr>
            <p:cNvPr id="11" name="椭圆 10">
              <a:extLst>
                <a:ext uri="{FF2B5EF4-FFF2-40B4-BE49-F238E27FC236}">
                  <a16:creationId xmlns:a16="http://schemas.microsoft.com/office/drawing/2014/main" id="{6D47C798-6663-2F84-4F63-935DC6764813}"/>
                </a:ext>
              </a:extLst>
            </p:cNvPr>
            <p:cNvSpPr/>
            <p:nvPr/>
          </p:nvSpPr>
          <p:spPr>
            <a:xfrm>
              <a:off x="1882217" y="533500"/>
              <a:ext cx="1804865" cy="1634247"/>
            </a:xfrm>
            <a:prstGeom prst="ellipse">
              <a:avLst/>
            </a:prstGeom>
            <a:noFill/>
            <a:ln w="19050">
              <a:solidFill>
                <a:schemeClr val="bg1"/>
              </a:solidFill>
              <a:prstDash val="dash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400"/>
            </a:p>
          </p:txBody>
        </p:sp>
        <p:sp>
          <p:nvSpPr>
            <p:cNvPr id="15" name="椭圆 14">
              <a:extLst>
                <a:ext uri="{FF2B5EF4-FFF2-40B4-BE49-F238E27FC236}">
                  <a16:creationId xmlns:a16="http://schemas.microsoft.com/office/drawing/2014/main" id="{FFAD022F-4F56-3DD2-5AF3-4E7D659FA9A2}"/>
                </a:ext>
              </a:extLst>
            </p:cNvPr>
            <p:cNvSpPr/>
            <p:nvPr/>
          </p:nvSpPr>
          <p:spPr>
            <a:xfrm>
              <a:off x="7597210" y="203829"/>
              <a:ext cx="1804865" cy="1634247"/>
            </a:xfrm>
            <a:prstGeom prst="ellipse">
              <a:avLst/>
            </a:prstGeom>
            <a:noFill/>
            <a:ln w="19050">
              <a:solidFill>
                <a:schemeClr val="bg1"/>
              </a:solidFill>
              <a:prstDash val="dash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400"/>
            </a:p>
          </p:txBody>
        </p:sp>
        <p:grpSp>
          <p:nvGrpSpPr>
            <p:cNvPr id="4" name="组合 3">
              <a:extLst>
                <a:ext uri="{FF2B5EF4-FFF2-40B4-BE49-F238E27FC236}">
                  <a16:creationId xmlns:a16="http://schemas.microsoft.com/office/drawing/2014/main" id="{0FFF6B0E-5BED-E1E6-4A20-07DA5BB20223}"/>
                </a:ext>
              </a:extLst>
            </p:cNvPr>
            <p:cNvGrpSpPr/>
            <p:nvPr/>
          </p:nvGrpSpPr>
          <p:grpSpPr>
            <a:xfrm>
              <a:off x="4826149" y="5180386"/>
              <a:ext cx="306882" cy="344579"/>
              <a:chOff x="4824798" y="5173559"/>
              <a:chExt cx="306882" cy="344579"/>
            </a:xfrm>
          </p:grpSpPr>
          <p:grpSp>
            <p:nvGrpSpPr>
              <p:cNvPr id="5" name="组合 4">
                <a:extLst>
                  <a:ext uri="{FF2B5EF4-FFF2-40B4-BE49-F238E27FC236}">
                    <a16:creationId xmlns:a16="http://schemas.microsoft.com/office/drawing/2014/main" id="{F51DCB21-B5C4-9335-4A66-E2DBF50658FD}"/>
                  </a:ext>
                </a:extLst>
              </p:cNvPr>
              <p:cNvGrpSpPr/>
              <p:nvPr/>
            </p:nvGrpSpPr>
            <p:grpSpPr>
              <a:xfrm rot="670795">
                <a:off x="4824798" y="5265000"/>
                <a:ext cx="176326" cy="253138"/>
                <a:chOff x="6726859" y="1927660"/>
                <a:chExt cx="246834" cy="354361"/>
              </a:xfrm>
            </p:grpSpPr>
            <p:sp>
              <p:nvSpPr>
                <p:cNvPr id="23" name="任意多边形: 形状 22">
                  <a:extLst>
                    <a:ext uri="{FF2B5EF4-FFF2-40B4-BE49-F238E27FC236}">
                      <a16:creationId xmlns:a16="http://schemas.microsoft.com/office/drawing/2014/main" id="{A4F53744-C9A5-9579-1E80-510433F10453}"/>
                    </a:ext>
                  </a:extLst>
                </p:cNvPr>
                <p:cNvSpPr/>
                <p:nvPr/>
              </p:nvSpPr>
              <p:spPr>
                <a:xfrm>
                  <a:off x="6726858" y="1995512"/>
                  <a:ext cx="244229" cy="286509"/>
                </a:xfrm>
                <a:custGeom>
                  <a:avLst/>
                  <a:gdLst>
                    <a:gd name="connsiteX0" fmla="*/ 97804 w 244229"/>
                    <a:gd name="connsiteY0" fmla="*/ 625 h 285611"/>
                    <a:gd name="connsiteX1" fmla="*/ 37479 w 244229"/>
                    <a:gd name="connsiteY1" fmla="*/ 59363 h 285611"/>
                    <a:gd name="connsiteX2" fmla="*/ 20017 w 244229"/>
                    <a:gd name="connsiteY2" fmla="*/ 105400 h 285611"/>
                    <a:gd name="connsiteX3" fmla="*/ 4142 w 244229"/>
                    <a:gd name="connsiteY3" fmla="*/ 145088 h 285611"/>
                    <a:gd name="connsiteX4" fmla="*/ 967 w 244229"/>
                    <a:gd name="connsiteY4" fmla="*/ 178425 h 285611"/>
                    <a:gd name="connsiteX5" fmla="*/ 18429 w 244229"/>
                    <a:gd name="connsiteY5" fmla="*/ 221288 h 285611"/>
                    <a:gd name="connsiteX6" fmla="*/ 62879 w 244229"/>
                    <a:gd name="connsiteY6" fmla="*/ 259388 h 285611"/>
                    <a:gd name="connsiteX7" fmla="*/ 105742 w 244229"/>
                    <a:gd name="connsiteY7" fmla="*/ 281613 h 285611"/>
                    <a:gd name="connsiteX8" fmla="*/ 161304 w 244229"/>
                    <a:gd name="connsiteY8" fmla="*/ 284788 h 285611"/>
                    <a:gd name="connsiteX9" fmla="*/ 208929 w 244229"/>
                    <a:gd name="connsiteY9" fmla="*/ 272088 h 285611"/>
                    <a:gd name="connsiteX10" fmla="*/ 243854 w 244229"/>
                    <a:gd name="connsiteY10" fmla="*/ 218113 h 285611"/>
                    <a:gd name="connsiteX11" fmla="*/ 226392 w 244229"/>
                    <a:gd name="connsiteY11" fmla="*/ 146675 h 285611"/>
                    <a:gd name="connsiteX12" fmla="*/ 210517 w 244229"/>
                    <a:gd name="connsiteY12" fmla="*/ 110163 h 285611"/>
                    <a:gd name="connsiteX13" fmla="*/ 199404 w 244229"/>
                    <a:gd name="connsiteY13" fmla="*/ 60950 h 285611"/>
                    <a:gd name="connsiteX14" fmla="*/ 181942 w 244229"/>
                    <a:gd name="connsiteY14" fmla="*/ 41900 h 285611"/>
                    <a:gd name="connsiteX15" fmla="*/ 162892 w 244229"/>
                    <a:gd name="connsiteY15" fmla="*/ 29200 h 285611"/>
                    <a:gd name="connsiteX16" fmla="*/ 97804 w 244229"/>
                    <a:gd name="connsiteY16" fmla="*/ 625 h 285611"/>
                    <a:gd name="connsiteX0" fmla="*/ 97804 w 244229"/>
                    <a:gd name="connsiteY0" fmla="*/ 2876 h 287862"/>
                    <a:gd name="connsiteX1" fmla="*/ 37479 w 244229"/>
                    <a:gd name="connsiteY1" fmla="*/ 61614 h 287862"/>
                    <a:gd name="connsiteX2" fmla="*/ 20017 w 244229"/>
                    <a:gd name="connsiteY2" fmla="*/ 107651 h 287862"/>
                    <a:gd name="connsiteX3" fmla="*/ 4142 w 244229"/>
                    <a:gd name="connsiteY3" fmla="*/ 147339 h 287862"/>
                    <a:gd name="connsiteX4" fmla="*/ 967 w 244229"/>
                    <a:gd name="connsiteY4" fmla="*/ 180676 h 287862"/>
                    <a:gd name="connsiteX5" fmla="*/ 18429 w 244229"/>
                    <a:gd name="connsiteY5" fmla="*/ 223539 h 287862"/>
                    <a:gd name="connsiteX6" fmla="*/ 62879 w 244229"/>
                    <a:gd name="connsiteY6" fmla="*/ 261639 h 287862"/>
                    <a:gd name="connsiteX7" fmla="*/ 105742 w 244229"/>
                    <a:gd name="connsiteY7" fmla="*/ 283864 h 287862"/>
                    <a:gd name="connsiteX8" fmla="*/ 161304 w 244229"/>
                    <a:gd name="connsiteY8" fmla="*/ 287039 h 287862"/>
                    <a:gd name="connsiteX9" fmla="*/ 208929 w 244229"/>
                    <a:gd name="connsiteY9" fmla="*/ 274339 h 287862"/>
                    <a:gd name="connsiteX10" fmla="*/ 243854 w 244229"/>
                    <a:gd name="connsiteY10" fmla="*/ 220364 h 287862"/>
                    <a:gd name="connsiteX11" fmla="*/ 226392 w 244229"/>
                    <a:gd name="connsiteY11" fmla="*/ 148926 h 287862"/>
                    <a:gd name="connsiteX12" fmla="*/ 210517 w 244229"/>
                    <a:gd name="connsiteY12" fmla="*/ 112414 h 287862"/>
                    <a:gd name="connsiteX13" fmla="*/ 199404 w 244229"/>
                    <a:gd name="connsiteY13" fmla="*/ 63201 h 287862"/>
                    <a:gd name="connsiteX14" fmla="*/ 181942 w 244229"/>
                    <a:gd name="connsiteY14" fmla="*/ 44151 h 287862"/>
                    <a:gd name="connsiteX15" fmla="*/ 162892 w 244229"/>
                    <a:gd name="connsiteY15" fmla="*/ 31451 h 287862"/>
                    <a:gd name="connsiteX16" fmla="*/ 97804 w 244229"/>
                    <a:gd name="connsiteY16" fmla="*/ 2876 h 287862"/>
                    <a:gd name="connsiteX0" fmla="*/ 97804 w 244229"/>
                    <a:gd name="connsiteY0" fmla="*/ 176 h 285162"/>
                    <a:gd name="connsiteX1" fmla="*/ 37479 w 244229"/>
                    <a:gd name="connsiteY1" fmla="*/ 58914 h 285162"/>
                    <a:gd name="connsiteX2" fmla="*/ 20017 w 244229"/>
                    <a:gd name="connsiteY2" fmla="*/ 104951 h 285162"/>
                    <a:gd name="connsiteX3" fmla="*/ 4142 w 244229"/>
                    <a:gd name="connsiteY3" fmla="*/ 144639 h 285162"/>
                    <a:gd name="connsiteX4" fmla="*/ 967 w 244229"/>
                    <a:gd name="connsiteY4" fmla="*/ 177976 h 285162"/>
                    <a:gd name="connsiteX5" fmla="*/ 18429 w 244229"/>
                    <a:gd name="connsiteY5" fmla="*/ 220839 h 285162"/>
                    <a:gd name="connsiteX6" fmla="*/ 62879 w 244229"/>
                    <a:gd name="connsiteY6" fmla="*/ 258939 h 285162"/>
                    <a:gd name="connsiteX7" fmla="*/ 105742 w 244229"/>
                    <a:gd name="connsiteY7" fmla="*/ 281164 h 285162"/>
                    <a:gd name="connsiteX8" fmla="*/ 161304 w 244229"/>
                    <a:gd name="connsiteY8" fmla="*/ 284339 h 285162"/>
                    <a:gd name="connsiteX9" fmla="*/ 208929 w 244229"/>
                    <a:gd name="connsiteY9" fmla="*/ 271639 h 285162"/>
                    <a:gd name="connsiteX10" fmla="*/ 243854 w 244229"/>
                    <a:gd name="connsiteY10" fmla="*/ 217664 h 285162"/>
                    <a:gd name="connsiteX11" fmla="*/ 226392 w 244229"/>
                    <a:gd name="connsiteY11" fmla="*/ 146226 h 285162"/>
                    <a:gd name="connsiteX12" fmla="*/ 210517 w 244229"/>
                    <a:gd name="connsiteY12" fmla="*/ 109714 h 285162"/>
                    <a:gd name="connsiteX13" fmla="*/ 199404 w 244229"/>
                    <a:gd name="connsiteY13" fmla="*/ 60501 h 285162"/>
                    <a:gd name="connsiteX14" fmla="*/ 181942 w 244229"/>
                    <a:gd name="connsiteY14" fmla="*/ 41451 h 285162"/>
                    <a:gd name="connsiteX15" fmla="*/ 97804 w 244229"/>
                    <a:gd name="connsiteY15" fmla="*/ 176 h 285162"/>
                    <a:gd name="connsiteX0" fmla="*/ 97804 w 244229"/>
                    <a:gd name="connsiteY0" fmla="*/ 313 h 285299"/>
                    <a:gd name="connsiteX1" fmla="*/ 37479 w 244229"/>
                    <a:gd name="connsiteY1" fmla="*/ 59051 h 285299"/>
                    <a:gd name="connsiteX2" fmla="*/ 20017 w 244229"/>
                    <a:gd name="connsiteY2" fmla="*/ 105088 h 285299"/>
                    <a:gd name="connsiteX3" fmla="*/ 4142 w 244229"/>
                    <a:gd name="connsiteY3" fmla="*/ 144776 h 285299"/>
                    <a:gd name="connsiteX4" fmla="*/ 967 w 244229"/>
                    <a:gd name="connsiteY4" fmla="*/ 178113 h 285299"/>
                    <a:gd name="connsiteX5" fmla="*/ 18429 w 244229"/>
                    <a:gd name="connsiteY5" fmla="*/ 220976 h 285299"/>
                    <a:gd name="connsiteX6" fmla="*/ 62879 w 244229"/>
                    <a:gd name="connsiteY6" fmla="*/ 259076 h 285299"/>
                    <a:gd name="connsiteX7" fmla="*/ 105742 w 244229"/>
                    <a:gd name="connsiteY7" fmla="*/ 281301 h 285299"/>
                    <a:gd name="connsiteX8" fmla="*/ 161304 w 244229"/>
                    <a:gd name="connsiteY8" fmla="*/ 284476 h 285299"/>
                    <a:gd name="connsiteX9" fmla="*/ 208929 w 244229"/>
                    <a:gd name="connsiteY9" fmla="*/ 271776 h 285299"/>
                    <a:gd name="connsiteX10" fmla="*/ 243854 w 244229"/>
                    <a:gd name="connsiteY10" fmla="*/ 217801 h 285299"/>
                    <a:gd name="connsiteX11" fmla="*/ 226392 w 244229"/>
                    <a:gd name="connsiteY11" fmla="*/ 146363 h 285299"/>
                    <a:gd name="connsiteX12" fmla="*/ 210517 w 244229"/>
                    <a:gd name="connsiteY12" fmla="*/ 109851 h 285299"/>
                    <a:gd name="connsiteX13" fmla="*/ 199404 w 244229"/>
                    <a:gd name="connsiteY13" fmla="*/ 60638 h 285299"/>
                    <a:gd name="connsiteX14" fmla="*/ 181942 w 244229"/>
                    <a:gd name="connsiteY14" fmla="*/ 36826 h 285299"/>
                    <a:gd name="connsiteX15" fmla="*/ 97804 w 244229"/>
                    <a:gd name="connsiteY15" fmla="*/ 313 h 285299"/>
                    <a:gd name="connsiteX0" fmla="*/ 97804 w 244229"/>
                    <a:gd name="connsiteY0" fmla="*/ 1523 h 286509"/>
                    <a:gd name="connsiteX1" fmla="*/ 37479 w 244229"/>
                    <a:gd name="connsiteY1" fmla="*/ 60261 h 286509"/>
                    <a:gd name="connsiteX2" fmla="*/ 20017 w 244229"/>
                    <a:gd name="connsiteY2" fmla="*/ 106298 h 286509"/>
                    <a:gd name="connsiteX3" fmla="*/ 4142 w 244229"/>
                    <a:gd name="connsiteY3" fmla="*/ 145986 h 286509"/>
                    <a:gd name="connsiteX4" fmla="*/ 967 w 244229"/>
                    <a:gd name="connsiteY4" fmla="*/ 179323 h 286509"/>
                    <a:gd name="connsiteX5" fmla="*/ 18429 w 244229"/>
                    <a:gd name="connsiteY5" fmla="*/ 222186 h 286509"/>
                    <a:gd name="connsiteX6" fmla="*/ 62879 w 244229"/>
                    <a:gd name="connsiteY6" fmla="*/ 260286 h 286509"/>
                    <a:gd name="connsiteX7" fmla="*/ 105742 w 244229"/>
                    <a:gd name="connsiteY7" fmla="*/ 282511 h 286509"/>
                    <a:gd name="connsiteX8" fmla="*/ 161304 w 244229"/>
                    <a:gd name="connsiteY8" fmla="*/ 285686 h 286509"/>
                    <a:gd name="connsiteX9" fmla="*/ 208929 w 244229"/>
                    <a:gd name="connsiteY9" fmla="*/ 272986 h 286509"/>
                    <a:gd name="connsiteX10" fmla="*/ 243854 w 244229"/>
                    <a:gd name="connsiteY10" fmla="*/ 219011 h 286509"/>
                    <a:gd name="connsiteX11" fmla="*/ 226392 w 244229"/>
                    <a:gd name="connsiteY11" fmla="*/ 147573 h 286509"/>
                    <a:gd name="connsiteX12" fmla="*/ 210517 w 244229"/>
                    <a:gd name="connsiteY12" fmla="*/ 111061 h 286509"/>
                    <a:gd name="connsiteX13" fmla="*/ 199404 w 244229"/>
                    <a:gd name="connsiteY13" fmla="*/ 61848 h 286509"/>
                    <a:gd name="connsiteX14" fmla="*/ 181942 w 244229"/>
                    <a:gd name="connsiteY14" fmla="*/ 38036 h 286509"/>
                    <a:gd name="connsiteX15" fmla="*/ 97804 w 244229"/>
                    <a:gd name="connsiteY15" fmla="*/ 1523 h 286509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</a:cxnLst>
                  <a:rect l="l" t="t" r="r" b="b"/>
                  <a:pathLst>
                    <a:path w="244229" h="286509">
                      <a:moveTo>
                        <a:pt x="97804" y="1523"/>
                      </a:moveTo>
                      <a:cubicBezTo>
                        <a:pt x="73727" y="5227"/>
                        <a:pt x="50443" y="42799"/>
                        <a:pt x="37479" y="60261"/>
                      </a:cubicBezTo>
                      <a:cubicBezTo>
                        <a:pt x="24515" y="77723"/>
                        <a:pt x="25573" y="92011"/>
                        <a:pt x="20017" y="106298"/>
                      </a:cubicBezTo>
                      <a:cubicBezTo>
                        <a:pt x="14461" y="120586"/>
                        <a:pt x="7317" y="133815"/>
                        <a:pt x="4142" y="145986"/>
                      </a:cubicBezTo>
                      <a:cubicBezTo>
                        <a:pt x="967" y="158157"/>
                        <a:pt x="-1414" y="166623"/>
                        <a:pt x="967" y="179323"/>
                      </a:cubicBezTo>
                      <a:cubicBezTo>
                        <a:pt x="3348" y="192023"/>
                        <a:pt x="8110" y="208692"/>
                        <a:pt x="18429" y="222186"/>
                      </a:cubicBezTo>
                      <a:cubicBezTo>
                        <a:pt x="28748" y="235680"/>
                        <a:pt x="48327" y="250232"/>
                        <a:pt x="62879" y="260286"/>
                      </a:cubicBezTo>
                      <a:cubicBezTo>
                        <a:pt x="77431" y="270340"/>
                        <a:pt x="89338" y="278278"/>
                        <a:pt x="105742" y="282511"/>
                      </a:cubicBezTo>
                      <a:cubicBezTo>
                        <a:pt x="122146" y="286744"/>
                        <a:pt x="144106" y="287274"/>
                        <a:pt x="161304" y="285686"/>
                      </a:cubicBezTo>
                      <a:cubicBezTo>
                        <a:pt x="178502" y="284099"/>
                        <a:pt x="195171" y="284099"/>
                        <a:pt x="208929" y="272986"/>
                      </a:cubicBezTo>
                      <a:cubicBezTo>
                        <a:pt x="222687" y="261873"/>
                        <a:pt x="240943" y="239913"/>
                        <a:pt x="243854" y="219011"/>
                      </a:cubicBezTo>
                      <a:cubicBezTo>
                        <a:pt x="246765" y="198109"/>
                        <a:pt x="231948" y="165565"/>
                        <a:pt x="226392" y="147573"/>
                      </a:cubicBezTo>
                      <a:cubicBezTo>
                        <a:pt x="220836" y="129581"/>
                        <a:pt x="215015" y="125348"/>
                        <a:pt x="210517" y="111061"/>
                      </a:cubicBezTo>
                      <a:cubicBezTo>
                        <a:pt x="206019" y="96774"/>
                        <a:pt x="204166" y="74019"/>
                        <a:pt x="199404" y="61848"/>
                      </a:cubicBezTo>
                      <a:cubicBezTo>
                        <a:pt x="194642" y="49677"/>
                        <a:pt x="188027" y="43328"/>
                        <a:pt x="181942" y="38036"/>
                      </a:cubicBezTo>
                      <a:cubicBezTo>
                        <a:pt x="152309" y="-2181"/>
                        <a:pt x="121881" y="-2181"/>
                        <a:pt x="97804" y="1523"/>
                      </a:cubicBezTo>
                      <a:close/>
                    </a:path>
                  </a:pathLst>
                </a:custGeom>
                <a:gradFill>
                  <a:gsLst>
                    <a:gs pos="68000">
                      <a:srgbClr val="952634"/>
                    </a:gs>
                    <a:gs pos="0">
                      <a:schemeClr val="accent6">
                        <a:lumMod val="75000"/>
                      </a:schemeClr>
                    </a:gs>
                    <a:gs pos="100000">
                      <a:srgbClr val="79111D"/>
                    </a:gs>
                  </a:gsLst>
                  <a:lin ang="8400000" scaled="0"/>
                </a:gradFill>
                <a:ln w="25400">
                  <a:noFill/>
                </a:ln>
                <a:effectLst>
                  <a:outerShdw blurRad="63500" sx="102000" sy="102000" algn="ctr" rotWithShape="0">
                    <a:srgbClr val="93494E">
                      <a:alpha val="40000"/>
                    </a:srgbClr>
                  </a:outerShdw>
                </a:effectLst>
                <a:scene3d>
                  <a:camera prst="orthographicFront"/>
                  <a:lightRig rig="threePt" dir="t"/>
                </a:scene3d>
                <a:sp3d prstMaterial="matte"/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400"/>
                </a:p>
              </p:txBody>
            </p:sp>
            <p:sp>
              <p:nvSpPr>
                <p:cNvPr id="24" name="椭圆 10">
                  <a:extLst>
                    <a:ext uri="{FF2B5EF4-FFF2-40B4-BE49-F238E27FC236}">
                      <a16:creationId xmlns:a16="http://schemas.microsoft.com/office/drawing/2014/main" id="{DEC64F04-7F2F-0BB1-856E-6FB26063A75D}"/>
                    </a:ext>
                  </a:extLst>
                </p:cNvPr>
                <p:cNvSpPr/>
                <p:nvPr/>
              </p:nvSpPr>
              <p:spPr>
                <a:xfrm>
                  <a:off x="6744914" y="1927659"/>
                  <a:ext cx="228769" cy="183395"/>
                </a:xfrm>
                <a:custGeom>
                  <a:avLst/>
                  <a:gdLst>
                    <a:gd name="connsiteX0" fmla="*/ 0 w 144463"/>
                    <a:gd name="connsiteY0" fmla="*/ 56357 h 112713"/>
                    <a:gd name="connsiteX1" fmla="*/ 72232 w 144463"/>
                    <a:gd name="connsiteY1" fmla="*/ 0 h 112713"/>
                    <a:gd name="connsiteX2" fmla="*/ 144464 w 144463"/>
                    <a:gd name="connsiteY2" fmla="*/ 56357 h 112713"/>
                    <a:gd name="connsiteX3" fmla="*/ 72232 w 144463"/>
                    <a:gd name="connsiteY3" fmla="*/ 112714 h 112713"/>
                    <a:gd name="connsiteX4" fmla="*/ 0 w 144463"/>
                    <a:gd name="connsiteY4" fmla="*/ 56357 h 112713"/>
                    <a:gd name="connsiteX0" fmla="*/ 13 w 144477"/>
                    <a:gd name="connsiteY0" fmla="*/ 56357 h 66426"/>
                    <a:gd name="connsiteX1" fmla="*/ 72245 w 144477"/>
                    <a:gd name="connsiteY1" fmla="*/ 0 h 66426"/>
                    <a:gd name="connsiteX2" fmla="*/ 144477 w 144477"/>
                    <a:gd name="connsiteY2" fmla="*/ 56357 h 66426"/>
                    <a:gd name="connsiteX3" fmla="*/ 77007 w 144477"/>
                    <a:gd name="connsiteY3" fmla="*/ 36514 h 66426"/>
                    <a:gd name="connsiteX4" fmla="*/ 13 w 144477"/>
                    <a:gd name="connsiteY4" fmla="*/ 56357 h 66426"/>
                    <a:gd name="connsiteX0" fmla="*/ 16 w 144480"/>
                    <a:gd name="connsiteY0" fmla="*/ 56357 h 74825"/>
                    <a:gd name="connsiteX1" fmla="*/ 72248 w 144480"/>
                    <a:gd name="connsiteY1" fmla="*/ 0 h 74825"/>
                    <a:gd name="connsiteX2" fmla="*/ 144480 w 144480"/>
                    <a:gd name="connsiteY2" fmla="*/ 56357 h 74825"/>
                    <a:gd name="connsiteX3" fmla="*/ 67485 w 144480"/>
                    <a:gd name="connsiteY3" fmla="*/ 69852 h 74825"/>
                    <a:gd name="connsiteX4" fmla="*/ 16 w 144480"/>
                    <a:gd name="connsiteY4" fmla="*/ 56357 h 74825"/>
                    <a:gd name="connsiteX0" fmla="*/ 29 w 144493"/>
                    <a:gd name="connsiteY0" fmla="*/ 56357 h 80327"/>
                    <a:gd name="connsiteX1" fmla="*/ 72261 w 144493"/>
                    <a:gd name="connsiteY1" fmla="*/ 0 h 80327"/>
                    <a:gd name="connsiteX2" fmla="*/ 144493 w 144493"/>
                    <a:gd name="connsiteY2" fmla="*/ 56357 h 80327"/>
                    <a:gd name="connsiteX3" fmla="*/ 65911 w 144493"/>
                    <a:gd name="connsiteY3" fmla="*/ 79377 h 80327"/>
                    <a:gd name="connsiteX4" fmla="*/ 29 w 144493"/>
                    <a:gd name="connsiteY4" fmla="*/ 56357 h 80327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44493" h="80327">
                      <a:moveTo>
                        <a:pt x="29" y="56357"/>
                      </a:moveTo>
                      <a:cubicBezTo>
                        <a:pt x="1087" y="43128"/>
                        <a:pt x="32368" y="0"/>
                        <a:pt x="72261" y="0"/>
                      </a:cubicBezTo>
                      <a:cubicBezTo>
                        <a:pt x="112154" y="0"/>
                        <a:pt x="144493" y="25232"/>
                        <a:pt x="144493" y="56357"/>
                      </a:cubicBezTo>
                      <a:cubicBezTo>
                        <a:pt x="144493" y="87482"/>
                        <a:pt x="105804" y="79377"/>
                        <a:pt x="65911" y="79377"/>
                      </a:cubicBezTo>
                      <a:cubicBezTo>
                        <a:pt x="26018" y="79377"/>
                        <a:pt x="-1029" y="69586"/>
                        <a:pt x="29" y="56357"/>
                      </a:cubicBezTo>
                      <a:close/>
                    </a:path>
                  </a:pathLst>
                </a:custGeom>
                <a:gradFill>
                  <a:gsLst>
                    <a:gs pos="100000">
                      <a:schemeClr val="bg1">
                        <a:alpha val="0"/>
                        <a:lumMod val="0"/>
                        <a:lumOff val="100000"/>
                      </a:schemeClr>
                    </a:gs>
                    <a:gs pos="0">
                      <a:schemeClr val="bg1">
                        <a:lumMod val="96000"/>
                        <a:lumOff val="4000"/>
                        <a:alpha val="90000"/>
                      </a:schemeClr>
                    </a:gs>
                  </a:gsLst>
                  <a:lin ang="21594000" scaled="0"/>
                </a:gradFill>
                <a:ln>
                  <a:noFill/>
                </a:ln>
                <a:effectLst>
                  <a:softEdge rad="31750"/>
                </a:effectLst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400"/>
                </a:p>
              </p:txBody>
            </p:sp>
          </p:grpSp>
          <p:grpSp>
            <p:nvGrpSpPr>
              <p:cNvPr id="8" name="组合 7">
                <a:extLst>
                  <a:ext uri="{FF2B5EF4-FFF2-40B4-BE49-F238E27FC236}">
                    <a16:creationId xmlns:a16="http://schemas.microsoft.com/office/drawing/2014/main" id="{E698BFE3-BFBA-97F4-58D2-43FE141B8793}"/>
                  </a:ext>
                </a:extLst>
              </p:cNvPr>
              <p:cNvGrpSpPr/>
              <p:nvPr/>
            </p:nvGrpSpPr>
            <p:grpSpPr>
              <a:xfrm rot="380349">
                <a:off x="4924843" y="5173559"/>
                <a:ext cx="206837" cy="197666"/>
                <a:chOff x="5402144" y="3034832"/>
                <a:chExt cx="420806" cy="402147"/>
              </a:xfrm>
            </p:grpSpPr>
            <p:sp>
              <p:nvSpPr>
                <p:cNvPr id="9" name="任意多边形: 形状 8">
                  <a:extLst>
                    <a:ext uri="{FF2B5EF4-FFF2-40B4-BE49-F238E27FC236}">
                      <a16:creationId xmlns:a16="http://schemas.microsoft.com/office/drawing/2014/main" id="{8A3E0445-8518-CC88-A189-F6389FD4D486}"/>
                    </a:ext>
                  </a:extLst>
                </p:cNvPr>
                <p:cNvSpPr/>
                <p:nvPr/>
              </p:nvSpPr>
              <p:spPr>
                <a:xfrm>
                  <a:off x="5402144" y="3034832"/>
                  <a:ext cx="113111" cy="339040"/>
                </a:xfrm>
                <a:custGeom>
                  <a:avLst/>
                  <a:gdLst>
                    <a:gd name="connsiteX0" fmla="*/ 107950 w 107950"/>
                    <a:gd name="connsiteY0" fmla="*/ 0 h 381000"/>
                    <a:gd name="connsiteX1" fmla="*/ 103187 w 107950"/>
                    <a:gd name="connsiteY1" fmla="*/ 115888 h 381000"/>
                    <a:gd name="connsiteX2" fmla="*/ 79375 w 107950"/>
                    <a:gd name="connsiteY2" fmla="*/ 206375 h 381000"/>
                    <a:gd name="connsiteX3" fmla="*/ 61912 w 107950"/>
                    <a:gd name="connsiteY3" fmla="*/ 276225 h 381000"/>
                    <a:gd name="connsiteX4" fmla="*/ 33337 w 107950"/>
                    <a:gd name="connsiteY4" fmla="*/ 328613 h 381000"/>
                    <a:gd name="connsiteX5" fmla="*/ 0 w 107950"/>
                    <a:gd name="connsiteY5" fmla="*/ 381000 h 381000"/>
                    <a:gd name="connsiteX6" fmla="*/ 0 w 107950"/>
                    <a:gd name="connsiteY6" fmla="*/ 381000 h 381000"/>
                    <a:gd name="connsiteX0" fmla="*/ 157384 w 157384"/>
                    <a:gd name="connsiteY0" fmla="*/ 0 h 370974"/>
                    <a:gd name="connsiteX1" fmla="*/ 103187 w 157384"/>
                    <a:gd name="connsiteY1" fmla="*/ 105862 h 370974"/>
                    <a:gd name="connsiteX2" fmla="*/ 79375 w 157384"/>
                    <a:gd name="connsiteY2" fmla="*/ 196349 h 370974"/>
                    <a:gd name="connsiteX3" fmla="*/ 61912 w 157384"/>
                    <a:gd name="connsiteY3" fmla="*/ 266199 h 370974"/>
                    <a:gd name="connsiteX4" fmla="*/ 33337 w 157384"/>
                    <a:gd name="connsiteY4" fmla="*/ 318587 h 370974"/>
                    <a:gd name="connsiteX5" fmla="*/ 0 w 157384"/>
                    <a:gd name="connsiteY5" fmla="*/ 370974 h 370974"/>
                    <a:gd name="connsiteX6" fmla="*/ 0 w 157384"/>
                    <a:gd name="connsiteY6" fmla="*/ 370974 h 370974"/>
                    <a:gd name="connsiteX0" fmla="*/ 157384 w 157384"/>
                    <a:gd name="connsiteY0" fmla="*/ 0 h 370974"/>
                    <a:gd name="connsiteX1" fmla="*/ 103187 w 157384"/>
                    <a:gd name="connsiteY1" fmla="*/ 105862 h 370974"/>
                    <a:gd name="connsiteX2" fmla="*/ 79375 w 157384"/>
                    <a:gd name="connsiteY2" fmla="*/ 196349 h 370974"/>
                    <a:gd name="connsiteX3" fmla="*/ 61912 w 157384"/>
                    <a:gd name="connsiteY3" fmla="*/ 266199 h 370974"/>
                    <a:gd name="connsiteX4" fmla="*/ 33337 w 157384"/>
                    <a:gd name="connsiteY4" fmla="*/ 318587 h 370974"/>
                    <a:gd name="connsiteX5" fmla="*/ 0 w 157384"/>
                    <a:gd name="connsiteY5" fmla="*/ 370974 h 370974"/>
                    <a:gd name="connsiteX0" fmla="*/ 124047 w 124047"/>
                    <a:gd name="connsiteY0" fmla="*/ 0 h 318586"/>
                    <a:gd name="connsiteX1" fmla="*/ 69850 w 124047"/>
                    <a:gd name="connsiteY1" fmla="*/ 105862 h 318586"/>
                    <a:gd name="connsiteX2" fmla="*/ 46038 w 124047"/>
                    <a:gd name="connsiteY2" fmla="*/ 196349 h 318586"/>
                    <a:gd name="connsiteX3" fmla="*/ 28575 w 124047"/>
                    <a:gd name="connsiteY3" fmla="*/ 266199 h 318586"/>
                    <a:gd name="connsiteX4" fmla="*/ 0 w 124047"/>
                    <a:gd name="connsiteY4" fmla="*/ 318587 h 318586"/>
                    <a:gd name="connsiteX0" fmla="*/ 113110 w 113110"/>
                    <a:gd name="connsiteY0" fmla="*/ 0 h 339036"/>
                    <a:gd name="connsiteX1" fmla="*/ 58913 w 113110"/>
                    <a:gd name="connsiteY1" fmla="*/ 105862 h 339036"/>
                    <a:gd name="connsiteX2" fmla="*/ 35101 w 113110"/>
                    <a:gd name="connsiteY2" fmla="*/ 196349 h 339036"/>
                    <a:gd name="connsiteX3" fmla="*/ 17638 w 113110"/>
                    <a:gd name="connsiteY3" fmla="*/ 266199 h 339036"/>
                    <a:gd name="connsiteX4" fmla="*/ 1 w 113110"/>
                    <a:gd name="connsiteY4" fmla="*/ 339036 h 339036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13110" h="339036">
                      <a:moveTo>
                        <a:pt x="113110" y="0"/>
                      </a:moveTo>
                      <a:cubicBezTo>
                        <a:pt x="113109" y="40746"/>
                        <a:pt x="71915" y="73137"/>
                        <a:pt x="58913" y="105862"/>
                      </a:cubicBezTo>
                      <a:cubicBezTo>
                        <a:pt x="45912" y="138587"/>
                        <a:pt x="41980" y="169626"/>
                        <a:pt x="35101" y="196349"/>
                      </a:cubicBezTo>
                      <a:cubicBezTo>
                        <a:pt x="28222" y="223072"/>
                        <a:pt x="23488" y="242418"/>
                        <a:pt x="17638" y="266199"/>
                      </a:cubicBezTo>
                      <a:cubicBezTo>
                        <a:pt x="11788" y="289980"/>
                        <a:pt x="10320" y="321574"/>
                        <a:pt x="1" y="339036"/>
                      </a:cubicBezTo>
                    </a:path>
                  </a:pathLst>
                </a:custGeom>
                <a:noFill/>
                <a:ln w="6350"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400" dirty="0"/>
                </a:p>
              </p:txBody>
            </p:sp>
            <p:sp>
              <p:nvSpPr>
                <p:cNvPr id="10" name="任意多边形: 形状 9">
                  <a:extLst>
                    <a:ext uri="{FF2B5EF4-FFF2-40B4-BE49-F238E27FC236}">
                      <a16:creationId xmlns:a16="http://schemas.microsoft.com/office/drawing/2014/main" id="{F977BB33-132B-7504-834E-43D19E49339B}"/>
                    </a:ext>
                  </a:extLst>
                </p:cNvPr>
                <p:cNvSpPr/>
                <p:nvPr/>
              </p:nvSpPr>
              <p:spPr>
                <a:xfrm>
                  <a:off x="5428900" y="3114565"/>
                  <a:ext cx="104775" cy="147638"/>
                </a:xfrm>
                <a:custGeom>
                  <a:avLst/>
                  <a:gdLst>
                    <a:gd name="connsiteX0" fmla="*/ 104775 w 104775"/>
                    <a:gd name="connsiteY0" fmla="*/ 0 h 147638"/>
                    <a:gd name="connsiteX1" fmla="*/ 73025 w 104775"/>
                    <a:gd name="connsiteY1" fmla="*/ 50800 h 147638"/>
                    <a:gd name="connsiteX2" fmla="*/ 34925 w 104775"/>
                    <a:gd name="connsiteY2" fmla="*/ 123825 h 147638"/>
                    <a:gd name="connsiteX3" fmla="*/ 0 w 104775"/>
                    <a:gd name="connsiteY3" fmla="*/ 147638 h 147638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104775" h="147638">
                      <a:moveTo>
                        <a:pt x="104775" y="0"/>
                      </a:moveTo>
                      <a:cubicBezTo>
                        <a:pt x="94721" y="15081"/>
                        <a:pt x="84667" y="30163"/>
                        <a:pt x="73025" y="50800"/>
                      </a:cubicBezTo>
                      <a:cubicBezTo>
                        <a:pt x="61383" y="71437"/>
                        <a:pt x="47096" y="107685"/>
                        <a:pt x="34925" y="123825"/>
                      </a:cubicBezTo>
                      <a:cubicBezTo>
                        <a:pt x="22754" y="139965"/>
                        <a:pt x="11377" y="143801"/>
                        <a:pt x="0" y="147638"/>
                      </a:cubicBezTo>
                    </a:path>
                  </a:pathLst>
                </a:custGeom>
                <a:noFill/>
                <a:ln w="6350"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400"/>
                </a:p>
              </p:txBody>
            </p:sp>
            <p:sp>
              <p:nvSpPr>
                <p:cNvPr id="17" name="任意多边形: 形状 16">
                  <a:extLst>
                    <a:ext uri="{FF2B5EF4-FFF2-40B4-BE49-F238E27FC236}">
                      <a16:creationId xmlns:a16="http://schemas.microsoft.com/office/drawing/2014/main" id="{97990ACC-BE72-23C9-64B0-1B15B8B5D459}"/>
                    </a:ext>
                  </a:extLst>
                </p:cNvPr>
                <p:cNvSpPr/>
                <p:nvPr/>
              </p:nvSpPr>
              <p:spPr>
                <a:xfrm>
                  <a:off x="5407025" y="3297238"/>
                  <a:ext cx="268288" cy="82550"/>
                </a:xfrm>
                <a:custGeom>
                  <a:avLst/>
                  <a:gdLst>
                    <a:gd name="connsiteX0" fmla="*/ 0 w 268288"/>
                    <a:gd name="connsiteY0" fmla="*/ 82550 h 82550"/>
                    <a:gd name="connsiteX1" fmla="*/ 61913 w 268288"/>
                    <a:gd name="connsiteY1" fmla="*/ 30162 h 82550"/>
                    <a:gd name="connsiteX2" fmla="*/ 117475 w 268288"/>
                    <a:gd name="connsiteY2" fmla="*/ 19050 h 82550"/>
                    <a:gd name="connsiteX3" fmla="*/ 207963 w 268288"/>
                    <a:gd name="connsiteY3" fmla="*/ 19050 h 82550"/>
                    <a:gd name="connsiteX4" fmla="*/ 268288 w 268288"/>
                    <a:gd name="connsiteY4" fmla="*/ 0 h 8255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268288" h="82550">
                      <a:moveTo>
                        <a:pt x="0" y="82550"/>
                      </a:moveTo>
                      <a:cubicBezTo>
                        <a:pt x="21167" y="61647"/>
                        <a:pt x="42334" y="40745"/>
                        <a:pt x="61913" y="30162"/>
                      </a:cubicBezTo>
                      <a:cubicBezTo>
                        <a:pt x="81492" y="19579"/>
                        <a:pt x="93133" y="20902"/>
                        <a:pt x="117475" y="19050"/>
                      </a:cubicBezTo>
                      <a:cubicBezTo>
                        <a:pt x="141817" y="17198"/>
                        <a:pt x="182828" y="22225"/>
                        <a:pt x="207963" y="19050"/>
                      </a:cubicBezTo>
                      <a:cubicBezTo>
                        <a:pt x="233098" y="15875"/>
                        <a:pt x="250693" y="7937"/>
                        <a:pt x="268288" y="0"/>
                      </a:cubicBezTo>
                    </a:path>
                  </a:pathLst>
                </a:custGeom>
                <a:noFill/>
                <a:ln w="6350"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400"/>
                </a:p>
              </p:txBody>
            </p:sp>
            <p:sp>
              <p:nvSpPr>
                <p:cNvPr id="18" name="任意多边形: 形状 17">
                  <a:extLst>
                    <a:ext uri="{FF2B5EF4-FFF2-40B4-BE49-F238E27FC236}">
                      <a16:creationId xmlns:a16="http://schemas.microsoft.com/office/drawing/2014/main" id="{66FBB309-7249-A221-6BB3-9B7906B04B6A}"/>
                    </a:ext>
                  </a:extLst>
                </p:cNvPr>
                <p:cNvSpPr/>
                <p:nvPr/>
              </p:nvSpPr>
              <p:spPr>
                <a:xfrm>
                  <a:off x="5518150" y="3246438"/>
                  <a:ext cx="107950" cy="71437"/>
                </a:xfrm>
                <a:custGeom>
                  <a:avLst/>
                  <a:gdLst>
                    <a:gd name="connsiteX0" fmla="*/ 0 w 107950"/>
                    <a:gd name="connsiteY0" fmla="*/ 71437 h 71437"/>
                    <a:gd name="connsiteX1" fmla="*/ 66675 w 107950"/>
                    <a:gd name="connsiteY1" fmla="*/ 22225 h 71437"/>
                    <a:gd name="connsiteX2" fmla="*/ 107950 w 107950"/>
                    <a:gd name="connsiteY2" fmla="*/ 0 h 71437"/>
                    <a:gd name="connsiteX3" fmla="*/ 107950 w 107950"/>
                    <a:gd name="connsiteY3" fmla="*/ 0 h 71437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107950" h="71437">
                      <a:moveTo>
                        <a:pt x="0" y="71437"/>
                      </a:moveTo>
                      <a:cubicBezTo>
                        <a:pt x="24341" y="52784"/>
                        <a:pt x="48683" y="34131"/>
                        <a:pt x="66675" y="22225"/>
                      </a:cubicBezTo>
                      <a:cubicBezTo>
                        <a:pt x="84667" y="10319"/>
                        <a:pt x="107950" y="0"/>
                        <a:pt x="107950" y="0"/>
                      </a:cubicBezTo>
                      <a:lnTo>
                        <a:pt x="107950" y="0"/>
                      </a:lnTo>
                    </a:path>
                  </a:pathLst>
                </a:custGeom>
                <a:noFill/>
                <a:ln w="6350"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400"/>
                </a:p>
              </p:txBody>
            </p:sp>
            <p:sp>
              <p:nvSpPr>
                <p:cNvPr id="19" name="任意多边形: 形状 18">
                  <a:extLst>
                    <a:ext uri="{FF2B5EF4-FFF2-40B4-BE49-F238E27FC236}">
                      <a16:creationId xmlns:a16="http://schemas.microsoft.com/office/drawing/2014/main" id="{1B5BEB06-D74C-7F32-F2C2-F77BC1C1A4C7}"/>
                    </a:ext>
                  </a:extLst>
                </p:cNvPr>
                <p:cNvSpPr/>
                <p:nvPr/>
              </p:nvSpPr>
              <p:spPr>
                <a:xfrm>
                  <a:off x="5562286" y="3189827"/>
                  <a:ext cx="18719" cy="80963"/>
                </a:xfrm>
                <a:custGeom>
                  <a:avLst/>
                  <a:gdLst>
                    <a:gd name="connsiteX0" fmla="*/ 0 w 11112"/>
                    <a:gd name="connsiteY0" fmla="*/ 80963 h 80963"/>
                    <a:gd name="connsiteX1" fmla="*/ 11112 w 11112"/>
                    <a:gd name="connsiteY1" fmla="*/ 0 h 80963"/>
                    <a:gd name="connsiteX0" fmla="*/ 10877 w 21989"/>
                    <a:gd name="connsiteY0" fmla="*/ 80963 h 80963"/>
                    <a:gd name="connsiteX1" fmla="*/ 21989 w 21989"/>
                    <a:gd name="connsiteY1" fmla="*/ 0 h 80963"/>
                    <a:gd name="connsiteX0" fmla="*/ 7606 w 18718"/>
                    <a:gd name="connsiteY0" fmla="*/ 80963 h 80963"/>
                    <a:gd name="connsiteX1" fmla="*/ 18718 w 18718"/>
                    <a:gd name="connsiteY1" fmla="*/ 0 h 8096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18718" h="80963">
                      <a:moveTo>
                        <a:pt x="7606" y="80963"/>
                      </a:moveTo>
                      <a:cubicBezTo>
                        <a:pt x="-13256" y="20616"/>
                        <a:pt x="15014" y="26988"/>
                        <a:pt x="18718" y="0"/>
                      </a:cubicBezTo>
                    </a:path>
                  </a:pathLst>
                </a:custGeom>
                <a:noFill/>
                <a:ln w="6350"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400" dirty="0"/>
                </a:p>
              </p:txBody>
            </p:sp>
            <p:sp>
              <p:nvSpPr>
                <p:cNvPr id="20" name="任意多边形: 形状 19">
                  <a:extLst>
                    <a:ext uri="{FF2B5EF4-FFF2-40B4-BE49-F238E27FC236}">
                      <a16:creationId xmlns:a16="http://schemas.microsoft.com/office/drawing/2014/main" id="{976D41AE-9992-B5C7-8485-D67C0B2293FC}"/>
                    </a:ext>
                  </a:extLst>
                </p:cNvPr>
                <p:cNvSpPr/>
                <p:nvPr/>
              </p:nvSpPr>
              <p:spPr>
                <a:xfrm>
                  <a:off x="5411375" y="3367628"/>
                  <a:ext cx="411575" cy="69351"/>
                </a:xfrm>
                <a:custGeom>
                  <a:avLst/>
                  <a:gdLst>
                    <a:gd name="connsiteX0" fmla="*/ 0 w 404812"/>
                    <a:gd name="connsiteY0" fmla="*/ 18046 h 67301"/>
                    <a:gd name="connsiteX1" fmla="*/ 84137 w 404812"/>
                    <a:gd name="connsiteY1" fmla="*/ 584 h 67301"/>
                    <a:gd name="connsiteX2" fmla="*/ 180975 w 404812"/>
                    <a:gd name="connsiteY2" fmla="*/ 37096 h 67301"/>
                    <a:gd name="connsiteX3" fmla="*/ 247650 w 404812"/>
                    <a:gd name="connsiteY3" fmla="*/ 62496 h 67301"/>
                    <a:gd name="connsiteX4" fmla="*/ 404812 w 404812"/>
                    <a:gd name="connsiteY4" fmla="*/ 67259 h 67301"/>
                    <a:gd name="connsiteX0" fmla="*/ 0 w 411575"/>
                    <a:gd name="connsiteY0" fmla="*/ 9746 h 69352"/>
                    <a:gd name="connsiteX1" fmla="*/ 90900 w 411575"/>
                    <a:gd name="connsiteY1" fmla="*/ 2635 h 69352"/>
                    <a:gd name="connsiteX2" fmla="*/ 187738 w 411575"/>
                    <a:gd name="connsiteY2" fmla="*/ 39147 h 69352"/>
                    <a:gd name="connsiteX3" fmla="*/ 254413 w 411575"/>
                    <a:gd name="connsiteY3" fmla="*/ 64547 h 69352"/>
                    <a:gd name="connsiteX4" fmla="*/ 411575 w 411575"/>
                    <a:gd name="connsiteY4" fmla="*/ 69310 h 69352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411575" h="69352">
                      <a:moveTo>
                        <a:pt x="0" y="9746"/>
                      </a:moveTo>
                      <a:cubicBezTo>
                        <a:pt x="26987" y="-573"/>
                        <a:pt x="59610" y="-2265"/>
                        <a:pt x="90900" y="2635"/>
                      </a:cubicBezTo>
                      <a:cubicBezTo>
                        <a:pt x="122190" y="7535"/>
                        <a:pt x="187738" y="39147"/>
                        <a:pt x="187738" y="39147"/>
                      </a:cubicBezTo>
                      <a:cubicBezTo>
                        <a:pt x="214990" y="49466"/>
                        <a:pt x="217107" y="59520"/>
                        <a:pt x="254413" y="64547"/>
                      </a:cubicBezTo>
                      <a:cubicBezTo>
                        <a:pt x="291719" y="69574"/>
                        <a:pt x="351647" y="69442"/>
                        <a:pt x="411575" y="69310"/>
                      </a:cubicBezTo>
                    </a:path>
                  </a:pathLst>
                </a:custGeom>
                <a:noFill/>
                <a:ln w="6350"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400"/>
                </a:p>
              </p:txBody>
            </p:sp>
            <p:sp>
              <p:nvSpPr>
                <p:cNvPr id="22" name="任意多边形: 形状 21">
                  <a:extLst>
                    <a:ext uri="{FF2B5EF4-FFF2-40B4-BE49-F238E27FC236}">
                      <a16:creationId xmlns:a16="http://schemas.microsoft.com/office/drawing/2014/main" id="{ECC5ACBD-B2C8-9B17-6B7C-F907DFA6ED5D}"/>
                    </a:ext>
                  </a:extLst>
                </p:cNvPr>
                <p:cNvSpPr/>
                <p:nvPr/>
              </p:nvSpPr>
              <p:spPr>
                <a:xfrm>
                  <a:off x="5585793" y="3373494"/>
                  <a:ext cx="155575" cy="37109"/>
                </a:xfrm>
                <a:custGeom>
                  <a:avLst/>
                  <a:gdLst>
                    <a:gd name="connsiteX0" fmla="*/ 0 w 155575"/>
                    <a:gd name="connsiteY0" fmla="*/ 28575 h 37109"/>
                    <a:gd name="connsiteX1" fmla="*/ 52388 w 155575"/>
                    <a:gd name="connsiteY1" fmla="*/ 36512 h 37109"/>
                    <a:gd name="connsiteX2" fmla="*/ 117475 w 155575"/>
                    <a:gd name="connsiteY2" fmla="*/ 14287 h 37109"/>
                    <a:gd name="connsiteX3" fmla="*/ 155575 w 155575"/>
                    <a:gd name="connsiteY3" fmla="*/ 0 h 37109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155575" h="37109">
                      <a:moveTo>
                        <a:pt x="0" y="28575"/>
                      </a:moveTo>
                      <a:cubicBezTo>
                        <a:pt x="16404" y="33734"/>
                        <a:pt x="32809" y="38893"/>
                        <a:pt x="52388" y="36512"/>
                      </a:cubicBezTo>
                      <a:cubicBezTo>
                        <a:pt x="71967" y="34131"/>
                        <a:pt x="100277" y="20372"/>
                        <a:pt x="117475" y="14287"/>
                      </a:cubicBezTo>
                      <a:cubicBezTo>
                        <a:pt x="134673" y="8202"/>
                        <a:pt x="145124" y="4101"/>
                        <a:pt x="155575" y="0"/>
                      </a:cubicBezTo>
                    </a:path>
                  </a:pathLst>
                </a:custGeom>
                <a:noFill/>
                <a:ln w="6350"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400" dirty="0"/>
                </a:p>
              </p:txBody>
            </p:sp>
          </p:grpSp>
        </p:grpSp>
        <p:grpSp>
          <p:nvGrpSpPr>
            <p:cNvPr id="25" name="组合 24">
              <a:extLst>
                <a:ext uri="{FF2B5EF4-FFF2-40B4-BE49-F238E27FC236}">
                  <a16:creationId xmlns:a16="http://schemas.microsoft.com/office/drawing/2014/main" id="{AC624BD8-4B46-66A3-681E-524A1A7D7FEA}"/>
                </a:ext>
              </a:extLst>
            </p:cNvPr>
            <p:cNvGrpSpPr/>
            <p:nvPr/>
          </p:nvGrpSpPr>
          <p:grpSpPr>
            <a:xfrm>
              <a:off x="5166273" y="6019827"/>
              <a:ext cx="366950" cy="469022"/>
              <a:chOff x="5189465" y="6017600"/>
              <a:chExt cx="366950" cy="469022"/>
            </a:xfrm>
          </p:grpSpPr>
          <p:grpSp>
            <p:nvGrpSpPr>
              <p:cNvPr id="26" name="组合 25">
                <a:extLst>
                  <a:ext uri="{FF2B5EF4-FFF2-40B4-BE49-F238E27FC236}">
                    <a16:creationId xmlns:a16="http://schemas.microsoft.com/office/drawing/2014/main" id="{0FA9C87B-A2D5-1E5A-F324-3A2DDCE8E596}"/>
                  </a:ext>
                </a:extLst>
              </p:cNvPr>
              <p:cNvGrpSpPr/>
              <p:nvPr/>
            </p:nvGrpSpPr>
            <p:grpSpPr>
              <a:xfrm rot="17858672">
                <a:off x="5316697" y="5984359"/>
                <a:ext cx="206478" cy="272959"/>
                <a:chOff x="5000928" y="3589541"/>
                <a:chExt cx="639756" cy="845743"/>
              </a:xfrm>
            </p:grpSpPr>
            <p:sp>
              <p:nvSpPr>
                <p:cNvPr id="35" name="任意多边形: 形状 34">
                  <a:extLst>
                    <a:ext uri="{FF2B5EF4-FFF2-40B4-BE49-F238E27FC236}">
                      <a16:creationId xmlns:a16="http://schemas.microsoft.com/office/drawing/2014/main" id="{7187406E-D7BB-86BD-65DD-92F001D62A39}"/>
                    </a:ext>
                  </a:extLst>
                </p:cNvPr>
                <p:cNvSpPr/>
                <p:nvPr/>
              </p:nvSpPr>
              <p:spPr>
                <a:xfrm>
                  <a:off x="5079156" y="3664894"/>
                  <a:ext cx="561528" cy="770390"/>
                </a:xfrm>
                <a:custGeom>
                  <a:avLst/>
                  <a:gdLst>
                    <a:gd name="connsiteX0" fmla="*/ 520717 w 561528"/>
                    <a:gd name="connsiteY0" fmla="*/ 348114 h 770390"/>
                    <a:gd name="connsiteX1" fmla="*/ 558817 w 561528"/>
                    <a:gd name="connsiteY1" fmla="*/ 211589 h 770390"/>
                    <a:gd name="connsiteX2" fmla="*/ 550880 w 561528"/>
                    <a:gd name="connsiteY2" fmla="*/ 71889 h 770390"/>
                    <a:gd name="connsiteX3" fmla="*/ 490555 w 561528"/>
                    <a:gd name="connsiteY3" fmla="*/ 21089 h 770390"/>
                    <a:gd name="connsiteX4" fmla="*/ 369905 w 561528"/>
                    <a:gd name="connsiteY4" fmla="*/ 452 h 770390"/>
                    <a:gd name="connsiteX5" fmla="*/ 225442 w 561528"/>
                    <a:gd name="connsiteY5" fmla="*/ 9977 h 770390"/>
                    <a:gd name="connsiteX6" fmla="*/ 154005 w 561528"/>
                    <a:gd name="connsiteY6" fmla="*/ 44902 h 770390"/>
                    <a:gd name="connsiteX7" fmla="*/ 52405 w 561528"/>
                    <a:gd name="connsiteY7" fmla="*/ 132214 h 770390"/>
                    <a:gd name="connsiteX8" fmla="*/ 12717 w 561528"/>
                    <a:gd name="connsiteY8" fmla="*/ 214764 h 770390"/>
                    <a:gd name="connsiteX9" fmla="*/ 17 w 561528"/>
                    <a:gd name="connsiteY9" fmla="*/ 295727 h 770390"/>
                    <a:gd name="connsiteX10" fmla="*/ 11130 w 561528"/>
                    <a:gd name="connsiteY10" fmla="*/ 417964 h 770390"/>
                    <a:gd name="connsiteX11" fmla="*/ 52405 w 561528"/>
                    <a:gd name="connsiteY11" fmla="*/ 557664 h 770390"/>
                    <a:gd name="connsiteX12" fmla="*/ 168292 w 561528"/>
                    <a:gd name="connsiteY12" fmla="*/ 705302 h 770390"/>
                    <a:gd name="connsiteX13" fmla="*/ 306405 w 561528"/>
                    <a:gd name="connsiteY13" fmla="*/ 768802 h 770390"/>
                    <a:gd name="connsiteX14" fmla="*/ 434992 w 561528"/>
                    <a:gd name="connsiteY14" fmla="*/ 740227 h 770390"/>
                    <a:gd name="connsiteX15" fmla="*/ 490555 w 561528"/>
                    <a:gd name="connsiteY15" fmla="*/ 624339 h 770390"/>
                    <a:gd name="connsiteX16" fmla="*/ 498492 w 561528"/>
                    <a:gd name="connsiteY16" fmla="*/ 560839 h 770390"/>
                    <a:gd name="connsiteX17" fmla="*/ 500080 w 561528"/>
                    <a:gd name="connsiteY17" fmla="*/ 454477 h 770390"/>
                    <a:gd name="connsiteX18" fmla="*/ 503255 w 561528"/>
                    <a:gd name="connsiteY18" fmla="*/ 411614 h 770390"/>
                    <a:gd name="connsiteX19" fmla="*/ 520717 w 561528"/>
                    <a:gd name="connsiteY19" fmla="*/ 348114 h 77039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</a:cxnLst>
                  <a:rect l="l" t="t" r="r" b="b"/>
                  <a:pathLst>
                    <a:path w="561528" h="770390">
                      <a:moveTo>
                        <a:pt x="520717" y="348114"/>
                      </a:moveTo>
                      <a:cubicBezTo>
                        <a:pt x="529977" y="314776"/>
                        <a:pt x="553790" y="257626"/>
                        <a:pt x="558817" y="211589"/>
                      </a:cubicBezTo>
                      <a:cubicBezTo>
                        <a:pt x="563844" y="165552"/>
                        <a:pt x="562257" y="103639"/>
                        <a:pt x="550880" y="71889"/>
                      </a:cubicBezTo>
                      <a:cubicBezTo>
                        <a:pt x="539503" y="40139"/>
                        <a:pt x="520717" y="32995"/>
                        <a:pt x="490555" y="21089"/>
                      </a:cubicBezTo>
                      <a:cubicBezTo>
                        <a:pt x="460393" y="9183"/>
                        <a:pt x="414090" y="2304"/>
                        <a:pt x="369905" y="452"/>
                      </a:cubicBezTo>
                      <a:cubicBezTo>
                        <a:pt x="325720" y="-1400"/>
                        <a:pt x="261425" y="2569"/>
                        <a:pt x="225442" y="9977"/>
                      </a:cubicBezTo>
                      <a:cubicBezTo>
                        <a:pt x="189459" y="17385"/>
                        <a:pt x="182844" y="24529"/>
                        <a:pt x="154005" y="44902"/>
                      </a:cubicBezTo>
                      <a:cubicBezTo>
                        <a:pt x="125165" y="65275"/>
                        <a:pt x="75953" y="103904"/>
                        <a:pt x="52405" y="132214"/>
                      </a:cubicBezTo>
                      <a:cubicBezTo>
                        <a:pt x="28857" y="160524"/>
                        <a:pt x="21448" y="187512"/>
                        <a:pt x="12717" y="214764"/>
                      </a:cubicBezTo>
                      <a:cubicBezTo>
                        <a:pt x="3986" y="242016"/>
                        <a:pt x="281" y="261860"/>
                        <a:pt x="17" y="295727"/>
                      </a:cubicBezTo>
                      <a:cubicBezTo>
                        <a:pt x="-248" y="329594"/>
                        <a:pt x="2399" y="374308"/>
                        <a:pt x="11130" y="417964"/>
                      </a:cubicBezTo>
                      <a:cubicBezTo>
                        <a:pt x="19861" y="461620"/>
                        <a:pt x="26211" y="509774"/>
                        <a:pt x="52405" y="557664"/>
                      </a:cubicBezTo>
                      <a:cubicBezTo>
                        <a:pt x="78599" y="605554"/>
                        <a:pt x="125959" y="670112"/>
                        <a:pt x="168292" y="705302"/>
                      </a:cubicBezTo>
                      <a:cubicBezTo>
                        <a:pt x="210625" y="740492"/>
                        <a:pt x="261955" y="762981"/>
                        <a:pt x="306405" y="768802"/>
                      </a:cubicBezTo>
                      <a:cubicBezTo>
                        <a:pt x="350855" y="774623"/>
                        <a:pt x="404300" y="764304"/>
                        <a:pt x="434992" y="740227"/>
                      </a:cubicBezTo>
                      <a:cubicBezTo>
                        <a:pt x="465684" y="716150"/>
                        <a:pt x="479972" y="654237"/>
                        <a:pt x="490555" y="624339"/>
                      </a:cubicBezTo>
                      <a:cubicBezTo>
                        <a:pt x="501138" y="594441"/>
                        <a:pt x="496905" y="589149"/>
                        <a:pt x="498492" y="560839"/>
                      </a:cubicBezTo>
                      <a:cubicBezTo>
                        <a:pt x="500079" y="532529"/>
                        <a:pt x="499286" y="479348"/>
                        <a:pt x="500080" y="454477"/>
                      </a:cubicBezTo>
                      <a:cubicBezTo>
                        <a:pt x="500874" y="429606"/>
                        <a:pt x="501668" y="423256"/>
                        <a:pt x="503255" y="411614"/>
                      </a:cubicBezTo>
                      <a:cubicBezTo>
                        <a:pt x="504842" y="399972"/>
                        <a:pt x="511457" y="381452"/>
                        <a:pt x="520717" y="348114"/>
                      </a:cubicBezTo>
                      <a:close/>
                    </a:path>
                  </a:pathLst>
                </a:custGeom>
                <a:gradFill>
                  <a:gsLst>
                    <a:gs pos="68000">
                      <a:srgbClr val="952634"/>
                    </a:gs>
                    <a:gs pos="0">
                      <a:schemeClr val="accent6">
                        <a:lumMod val="75000"/>
                      </a:schemeClr>
                    </a:gs>
                    <a:gs pos="100000">
                      <a:srgbClr val="79111D"/>
                    </a:gs>
                  </a:gsLst>
                  <a:lin ang="21594000" scaled="0"/>
                </a:gradFill>
                <a:ln w="25400">
                  <a:noFill/>
                </a:ln>
                <a:effectLst>
                  <a:outerShdw blurRad="63500" sx="102000" sy="102000" algn="ctr" rotWithShape="0">
                    <a:srgbClr val="93494E">
                      <a:alpha val="40000"/>
                    </a:srgbClr>
                  </a:outerShdw>
                </a:effectLst>
                <a:scene3d>
                  <a:camera prst="orthographicFront"/>
                  <a:lightRig rig="threePt" dir="t"/>
                </a:scene3d>
                <a:sp3d prstMaterial="matte"/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400"/>
                </a:p>
              </p:txBody>
            </p:sp>
            <p:sp>
              <p:nvSpPr>
                <p:cNvPr id="36" name="任意多边形: 形状 35">
                  <a:extLst>
                    <a:ext uri="{FF2B5EF4-FFF2-40B4-BE49-F238E27FC236}">
                      <a16:creationId xmlns:a16="http://schemas.microsoft.com/office/drawing/2014/main" id="{130F675B-D498-E26E-1AC4-DD0DEE9CF977}"/>
                    </a:ext>
                  </a:extLst>
                </p:cNvPr>
                <p:cNvSpPr/>
                <p:nvPr/>
              </p:nvSpPr>
              <p:spPr>
                <a:xfrm>
                  <a:off x="5000928" y="3589541"/>
                  <a:ext cx="627294" cy="845678"/>
                </a:xfrm>
                <a:custGeom>
                  <a:avLst/>
                  <a:gdLst>
                    <a:gd name="connsiteX0" fmla="*/ 208442 w 279647"/>
                    <a:gd name="connsiteY0" fmla="*/ 12619 h 655160"/>
                    <a:gd name="connsiteX1" fmla="*/ 61122 w 279647"/>
                    <a:gd name="connsiteY1" fmla="*/ 83739 h 655160"/>
                    <a:gd name="connsiteX2" fmla="*/ 20482 w 279647"/>
                    <a:gd name="connsiteY2" fmla="*/ 195499 h 655160"/>
                    <a:gd name="connsiteX3" fmla="*/ 162 w 279647"/>
                    <a:gd name="connsiteY3" fmla="*/ 352979 h 655160"/>
                    <a:gd name="connsiteX4" fmla="*/ 30642 w 279647"/>
                    <a:gd name="connsiteY4" fmla="*/ 510459 h 655160"/>
                    <a:gd name="connsiteX5" fmla="*/ 106842 w 279647"/>
                    <a:gd name="connsiteY5" fmla="*/ 637459 h 655160"/>
                    <a:gd name="connsiteX6" fmla="*/ 198282 w 279647"/>
                    <a:gd name="connsiteY6" fmla="*/ 647619 h 655160"/>
                    <a:gd name="connsiteX7" fmla="*/ 264322 w 279647"/>
                    <a:gd name="connsiteY7" fmla="*/ 647619 h 655160"/>
                    <a:gd name="connsiteX8" fmla="*/ 238922 w 279647"/>
                    <a:gd name="connsiteY8" fmla="*/ 551099 h 655160"/>
                    <a:gd name="connsiteX9" fmla="*/ 238922 w 279647"/>
                    <a:gd name="connsiteY9" fmla="*/ 419019 h 655160"/>
                    <a:gd name="connsiteX10" fmla="*/ 238922 w 279647"/>
                    <a:gd name="connsiteY10" fmla="*/ 312339 h 655160"/>
                    <a:gd name="connsiteX11" fmla="*/ 167802 w 279647"/>
                    <a:gd name="connsiteY11" fmla="*/ 251379 h 655160"/>
                    <a:gd name="connsiteX12" fmla="*/ 208442 w 279647"/>
                    <a:gd name="connsiteY12" fmla="*/ 149779 h 655160"/>
                    <a:gd name="connsiteX13" fmla="*/ 279562 w 279647"/>
                    <a:gd name="connsiteY13" fmla="*/ 12619 h 655160"/>
                    <a:gd name="connsiteX14" fmla="*/ 208442 w 279647"/>
                    <a:gd name="connsiteY14" fmla="*/ 12619 h 655160"/>
                    <a:gd name="connsiteX0" fmla="*/ 208494 w 279699"/>
                    <a:gd name="connsiteY0" fmla="*/ 12892 h 655433"/>
                    <a:gd name="connsiteX1" fmla="*/ 81494 w 279699"/>
                    <a:gd name="connsiteY1" fmla="*/ 89092 h 655433"/>
                    <a:gd name="connsiteX2" fmla="*/ 20534 w 279699"/>
                    <a:gd name="connsiteY2" fmla="*/ 195772 h 655433"/>
                    <a:gd name="connsiteX3" fmla="*/ 214 w 279699"/>
                    <a:gd name="connsiteY3" fmla="*/ 353252 h 655433"/>
                    <a:gd name="connsiteX4" fmla="*/ 30694 w 279699"/>
                    <a:gd name="connsiteY4" fmla="*/ 510732 h 655433"/>
                    <a:gd name="connsiteX5" fmla="*/ 106894 w 279699"/>
                    <a:gd name="connsiteY5" fmla="*/ 637732 h 655433"/>
                    <a:gd name="connsiteX6" fmla="*/ 198334 w 279699"/>
                    <a:gd name="connsiteY6" fmla="*/ 647892 h 655433"/>
                    <a:gd name="connsiteX7" fmla="*/ 264374 w 279699"/>
                    <a:gd name="connsiteY7" fmla="*/ 647892 h 655433"/>
                    <a:gd name="connsiteX8" fmla="*/ 238974 w 279699"/>
                    <a:gd name="connsiteY8" fmla="*/ 551372 h 655433"/>
                    <a:gd name="connsiteX9" fmla="*/ 238974 w 279699"/>
                    <a:gd name="connsiteY9" fmla="*/ 419292 h 655433"/>
                    <a:gd name="connsiteX10" fmla="*/ 238974 w 279699"/>
                    <a:gd name="connsiteY10" fmla="*/ 312612 h 655433"/>
                    <a:gd name="connsiteX11" fmla="*/ 167854 w 279699"/>
                    <a:gd name="connsiteY11" fmla="*/ 251652 h 655433"/>
                    <a:gd name="connsiteX12" fmla="*/ 208494 w 279699"/>
                    <a:gd name="connsiteY12" fmla="*/ 150052 h 655433"/>
                    <a:gd name="connsiteX13" fmla="*/ 279614 w 279699"/>
                    <a:gd name="connsiteY13" fmla="*/ 12892 h 655433"/>
                    <a:gd name="connsiteX14" fmla="*/ 208494 w 279699"/>
                    <a:gd name="connsiteY14" fmla="*/ 12892 h 655433"/>
                    <a:gd name="connsiteX0" fmla="*/ 208494 w 279699"/>
                    <a:gd name="connsiteY0" fmla="*/ 12892 h 655433"/>
                    <a:gd name="connsiteX1" fmla="*/ 81494 w 279699"/>
                    <a:gd name="connsiteY1" fmla="*/ 89092 h 655433"/>
                    <a:gd name="connsiteX2" fmla="*/ 20534 w 279699"/>
                    <a:gd name="connsiteY2" fmla="*/ 195772 h 655433"/>
                    <a:gd name="connsiteX3" fmla="*/ 214 w 279699"/>
                    <a:gd name="connsiteY3" fmla="*/ 353252 h 655433"/>
                    <a:gd name="connsiteX4" fmla="*/ 30694 w 279699"/>
                    <a:gd name="connsiteY4" fmla="*/ 510732 h 655433"/>
                    <a:gd name="connsiteX5" fmla="*/ 106894 w 279699"/>
                    <a:gd name="connsiteY5" fmla="*/ 637732 h 655433"/>
                    <a:gd name="connsiteX6" fmla="*/ 198334 w 279699"/>
                    <a:gd name="connsiteY6" fmla="*/ 647892 h 655433"/>
                    <a:gd name="connsiteX7" fmla="*/ 264374 w 279699"/>
                    <a:gd name="connsiteY7" fmla="*/ 647892 h 655433"/>
                    <a:gd name="connsiteX8" fmla="*/ 238974 w 279699"/>
                    <a:gd name="connsiteY8" fmla="*/ 551372 h 655433"/>
                    <a:gd name="connsiteX9" fmla="*/ 238974 w 279699"/>
                    <a:gd name="connsiteY9" fmla="*/ 419292 h 655433"/>
                    <a:gd name="connsiteX10" fmla="*/ 167854 w 279699"/>
                    <a:gd name="connsiteY10" fmla="*/ 251652 h 655433"/>
                    <a:gd name="connsiteX11" fmla="*/ 208494 w 279699"/>
                    <a:gd name="connsiteY11" fmla="*/ 150052 h 655433"/>
                    <a:gd name="connsiteX12" fmla="*/ 279614 w 279699"/>
                    <a:gd name="connsiteY12" fmla="*/ 12892 h 655433"/>
                    <a:gd name="connsiteX13" fmla="*/ 208494 w 279699"/>
                    <a:gd name="connsiteY13" fmla="*/ 12892 h 655433"/>
                    <a:gd name="connsiteX0" fmla="*/ 208494 w 279699"/>
                    <a:gd name="connsiteY0" fmla="*/ 12892 h 655433"/>
                    <a:gd name="connsiteX1" fmla="*/ 81494 w 279699"/>
                    <a:gd name="connsiteY1" fmla="*/ 89092 h 655433"/>
                    <a:gd name="connsiteX2" fmla="*/ 20534 w 279699"/>
                    <a:gd name="connsiteY2" fmla="*/ 195772 h 655433"/>
                    <a:gd name="connsiteX3" fmla="*/ 214 w 279699"/>
                    <a:gd name="connsiteY3" fmla="*/ 353252 h 655433"/>
                    <a:gd name="connsiteX4" fmla="*/ 30694 w 279699"/>
                    <a:gd name="connsiteY4" fmla="*/ 510732 h 655433"/>
                    <a:gd name="connsiteX5" fmla="*/ 106894 w 279699"/>
                    <a:gd name="connsiteY5" fmla="*/ 637732 h 655433"/>
                    <a:gd name="connsiteX6" fmla="*/ 198334 w 279699"/>
                    <a:gd name="connsiteY6" fmla="*/ 647892 h 655433"/>
                    <a:gd name="connsiteX7" fmla="*/ 264374 w 279699"/>
                    <a:gd name="connsiteY7" fmla="*/ 647892 h 655433"/>
                    <a:gd name="connsiteX8" fmla="*/ 238974 w 279699"/>
                    <a:gd name="connsiteY8" fmla="*/ 551372 h 655433"/>
                    <a:gd name="connsiteX9" fmla="*/ 167854 w 279699"/>
                    <a:gd name="connsiteY9" fmla="*/ 251652 h 655433"/>
                    <a:gd name="connsiteX10" fmla="*/ 208494 w 279699"/>
                    <a:gd name="connsiteY10" fmla="*/ 150052 h 655433"/>
                    <a:gd name="connsiteX11" fmla="*/ 279614 w 279699"/>
                    <a:gd name="connsiteY11" fmla="*/ 12892 h 655433"/>
                    <a:gd name="connsiteX12" fmla="*/ 208494 w 279699"/>
                    <a:gd name="connsiteY12" fmla="*/ 12892 h 655433"/>
                    <a:gd name="connsiteX0" fmla="*/ 208494 w 279699"/>
                    <a:gd name="connsiteY0" fmla="*/ 12892 h 657138"/>
                    <a:gd name="connsiteX1" fmla="*/ 81494 w 279699"/>
                    <a:gd name="connsiteY1" fmla="*/ 89092 h 657138"/>
                    <a:gd name="connsiteX2" fmla="*/ 20534 w 279699"/>
                    <a:gd name="connsiteY2" fmla="*/ 195772 h 657138"/>
                    <a:gd name="connsiteX3" fmla="*/ 214 w 279699"/>
                    <a:gd name="connsiteY3" fmla="*/ 353252 h 657138"/>
                    <a:gd name="connsiteX4" fmla="*/ 30694 w 279699"/>
                    <a:gd name="connsiteY4" fmla="*/ 510732 h 657138"/>
                    <a:gd name="connsiteX5" fmla="*/ 106894 w 279699"/>
                    <a:gd name="connsiteY5" fmla="*/ 637732 h 657138"/>
                    <a:gd name="connsiteX6" fmla="*/ 264374 w 279699"/>
                    <a:gd name="connsiteY6" fmla="*/ 647892 h 657138"/>
                    <a:gd name="connsiteX7" fmla="*/ 238974 w 279699"/>
                    <a:gd name="connsiteY7" fmla="*/ 551372 h 657138"/>
                    <a:gd name="connsiteX8" fmla="*/ 167854 w 279699"/>
                    <a:gd name="connsiteY8" fmla="*/ 251652 h 657138"/>
                    <a:gd name="connsiteX9" fmla="*/ 208494 w 279699"/>
                    <a:gd name="connsiteY9" fmla="*/ 150052 h 657138"/>
                    <a:gd name="connsiteX10" fmla="*/ 279614 w 279699"/>
                    <a:gd name="connsiteY10" fmla="*/ 12892 h 657138"/>
                    <a:gd name="connsiteX11" fmla="*/ 208494 w 279699"/>
                    <a:gd name="connsiteY11" fmla="*/ 12892 h 657138"/>
                    <a:gd name="connsiteX0" fmla="*/ 208494 w 279699"/>
                    <a:gd name="connsiteY0" fmla="*/ 12892 h 679045"/>
                    <a:gd name="connsiteX1" fmla="*/ 81494 w 279699"/>
                    <a:gd name="connsiteY1" fmla="*/ 89092 h 679045"/>
                    <a:gd name="connsiteX2" fmla="*/ 20534 w 279699"/>
                    <a:gd name="connsiteY2" fmla="*/ 195772 h 679045"/>
                    <a:gd name="connsiteX3" fmla="*/ 214 w 279699"/>
                    <a:gd name="connsiteY3" fmla="*/ 353252 h 679045"/>
                    <a:gd name="connsiteX4" fmla="*/ 30694 w 279699"/>
                    <a:gd name="connsiteY4" fmla="*/ 510732 h 679045"/>
                    <a:gd name="connsiteX5" fmla="*/ 106894 w 279699"/>
                    <a:gd name="connsiteY5" fmla="*/ 637732 h 679045"/>
                    <a:gd name="connsiteX6" fmla="*/ 264374 w 279699"/>
                    <a:gd name="connsiteY6" fmla="*/ 647892 h 679045"/>
                    <a:gd name="connsiteX7" fmla="*/ 167854 w 279699"/>
                    <a:gd name="connsiteY7" fmla="*/ 251652 h 679045"/>
                    <a:gd name="connsiteX8" fmla="*/ 208494 w 279699"/>
                    <a:gd name="connsiteY8" fmla="*/ 150052 h 679045"/>
                    <a:gd name="connsiteX9" fmla="*/ 279614 w 279699"/>
                    <a:gd name="connsiteY9" fmla="*/ 12892 h 679045"/>
                    <a:gd name="connsiteX10" fmla="*/ 208494 w 279699"/>
                    <a:gd name="connsiteY10" fmla="*/ 12892 h 679045"/>
                    <a:gd name="connsiteX0" fmla="*/ 208494 w 279699"/>
                    <a:gd name="connsiteY0" fmla="*/ 12892 h 679045"/>
                    <a:gd name="connsiteX1" fmla="*/ 81494 w 279699"/>
                    <a:gd name="connsiteY1" fmla="*/ 89092 h 679045"/>
                    <a:gd name="connsiteX2" fmla="*/ 20534 w 279699"/>
                    <a:gd name="connsiteY2" fmla="*/ 195772 h 679045"/>
                    <a:gd name="connsiteX3" fmla="*/ 214 w 279699"/>
                    <a:gd name="connsiteY3" fmla="*/ 353252 h 679045"/>
                    <a:gd name="connsiteX4" fmla="*/ 30694 w 279699"/>
                    <a:gd name="connsiteY4" fmla="*/ 510732 h 679045"/>
                    <a:gd name="connsiteX5" fmla="*/ 106894 w 279699"/>
                    <a:gd name="connsiteY5" fmla="*/ 637732 h 679045"/>
                    <a:gd name="connsiteX6" fmla="*/ 264374 w 279699"/>
                    <a:gd name="connsiteY6" fmla="*/ 647892 h 679045"/>
                    <a:gd name="connsiteX7" fmla="*/ 167854 w 279699"/>
                    <a:gd name="connsiteY7" fmla="*/ 251652 h 679045"/>
                    <a:gd name="connsiteX8" fmla="*/ 208494 w 279699"/>
                    <a:gd name="connsiteY8" fmla="*/ 150052 h 679045"/>
                    <a:gd name="connsiteX9" fmla="*/ 279614 w 279699"/>
                    <a:gd name="connsiteY9" fmla="*/ 12892 h 679045"/>
                    <a:gd name="connsiteX10" fmla="*/ 208494 w 279699"/>
                    <a:gd name="connsiteY10" fmla="*/ 12892 h 679045"/>
                    <a:gd name="connsiteX0" fmla="*/ 208494 w 279699"/>
                    <a:gd name="connsiteY0" fmla="*/ 12892 h 679045"/>
                    <a:gd name="connsiteX1" fmla="*/ 81494 w 279699"/>
                    <a:gd name="connsiteY1" fmla="*/ 89092 h 679045"/>
                    <a:gd name="connsiteX2" fmla="*/ 20534 w 279699"/>
                    <a:gd name="connsiteY2" fmla="*/ 195772 h 679045"/>
                    <a:gd name="connsiteX3" fmla="*/ 214 w 279699"/>
                    <a:gd name="connsiteY3" fmla="*/ 353252 h 679045"/>
                    <a:gd name="connsiteX4" fmla="*/ 30694 w 279699"/>
                    <a:gd name="connsiteY4" fmla="*/ 510732 h 679045"/>
                    <a:gd name="connsiteX5" fmla="*/ 106894 w 279699"/>
                    <a:gd name="connsiteY5" fmla="*/ 637732 h 679045"/>
                    <a:gd name="connsiteX6" fmla="*/ 264374 w 279699"/>
                    <a:gd name="connsiteY6" fmla="*/ 647892 h 679045"/>
                    <a:gd name="connsiteX7" fmla="*/ 167854 w 279699"/>
                    <a:gd name="connsiteY7" fmla="*/ 251652 h 679045"/>
                    <a:gd name="connsiteX8" fmla="*/ 208494 w 279699"/>
                    <a:gd name="connsiteY8" fmla="*/ 150052 h 679045"/>
                    <a:gd name="connsiteX9" fmla="*/ 279614 w 279699"/>
                    <a:gd name="connsiteY9" fmla="*/ 12892 h 679045"/>
                    <a:gd name="connsiteX10" fmla="*/ 208494 w 279699"/>
                    <a:gd name="connsiteY10" fmla="*/ 12892 h 679045"/>
                    <a:gd name="connsiteX0" fmla="*/ 208494 w 279699"/>
                    <a:gd name="connsiteY0" fmla="*/ 12892 h 679045"/>
                    <a:gd name="connsiteX1" fmla="*/ 81494 w 279699"/>
                    <a:gd name="connsiteY1" fmla="*/ 89092 h 679045"/>
                    <a:gd name="connsiteX2" fmla="*/ 20534 w 279699"/>
                    <a:gd name="connsiteY2" fmla="*/ 195772 h 679045"/>
                    <a:gd name="connsiteX3" fmla="*/ 214 w 279699"/>
                    <a:gd name="connsiteY3" fmla="*/ 353252 h 679045"/>
                    <a:gd name="connsiteX4" fmla="*/ 30694 w 279699"/>
                    <a:gd name="connsiteY4" fmla="*/ 510732 h 679045"/>
                    <a:gd name="connsiteX5" fmla="*/ 106894 w 279699"/>
                    <a:gd name="connsiteY5" fmla="*/ 637732 h 679045"/>
                    <a:gd name="connsiteX6" fmla="*/ 264374 w 279699"/>
                    <a:gd name="connsiteY6" fmla="*/ 647892 h 679045"/>
                    <a:gd name="connsiteX7" fmla="*/ 167854 w 279699"/>
                    <a:gd name="connsiteY7" fmla="*/ 251652 h 679045"/>
                    <a:gd name="connsiteX8" fmla="*/ 208494 w 279699"/>
                    <a:gd name="connsiteY8" fmla="*/ 150052 h 679045"/>
                    <a:gd name="connsiteX9" fmla="*/ 279614 w 279699"/>
                    <a:gd name="connsiteY9" fmla="*/ 12892 h 679045"/>
                    <a:gd name="connsiteX10" fmla="*/ 208494 w 279699"/>
                    <a:gd name="connsiteY10" fmla="*/ 12892 h 679045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</a:cxnLst>
                  <a:rect l="l" t="t" r="r" b="b"/>
                  <a:pathLst>
                    <a:path w="279699" h="679045">
                      <a:moveTo>
                        <a:pt x="208494" y="12892"/>
                      </a:moveTo>
                      <a:cubicBezTo>
                        <a:pt x="175474" y="25592"/>
                        <a:pt x="112821" y="58612"/>
                        <a:pt x="81494" y="89092"/>
                      </a:cubicBezTo>
                      <a:cubicBezTo>
                        <a:pt x="50167" y="119572"/>
                        <a:pt x="34081" y="151745"/>
                        <a:pt x="20534" y="195772"/>
                      </a:cubicBezTo>
                      <a:cubicBezTo>
                        <a:pt x="6987" y="239799"/>
                        <a:pt x="-1479" y="300759"/>
                        <a:pt x="214" y="353252"/>
                      </a:cubicBezTo>
                      <a:cubicBezTo>
                        <a:pt x="1907" y="405745"/>
                        <a:pt x="12914" y="463319"/>
                        <a:pt x="30694" y="510732"/>
                      </a:cubicBezTo>
                      <a:cubicBezTo>
                        <a:pt x="48474" y="558145"/>
                        <a:pt x="67947" y="614872"/>
                        <a:pt x="106894" y="637732"/>
                      </a:cubicBezTo>
                      <a:cubicBezTo>
                        <a:pt x="145841" y="660592"/>
                        <a:pt x="254214" y="712239"/>
                        <a:pt x="264374" y="647892"/>
                      </a:cubicBezTo>
                      <a:cubicBezTo>
                        <a:pt x="130601" y="465012"/>
                        <a:pt x="177167" y="334625"/>
                        <a:pt x="167854" y="251652"/>
                      </a:cubicBezTo>
                      <a:cubicBezTo>
                        <a:pt x="162774" y="224559"/>
                        <a:pt x="189867" y="189845"/>
                        <a:pt x="208494" y="150052"/>
                      </a:cubicBezTo>
                      <a:cubicBezTo>
                        <a:pt x="227121" y="110259"/>
                        <a:pt x="282154" y="34059"/>
                        <a:pt x="279614" y="12892"/>
                      </a:cubicBezTo>
                      <a:cubicBezTo>
                        <a:pt x="277074" y="-8275"/>
                        <a:pt x="241514" y="192"/>
                        <a:pt x="208494" y="12892"/>
                      </a:cubicBezTo>
                      <a:close/>
                    </a:path>
                  </a:pathLst>
                </a:custGeom>
                <a:gradFill>
                  <a:gsLst>
                    <a:gs pos="85000">
                      <a:schemeClr val="bg1">
                        <a:alpha val="0"/>
                      </a:schemeClr>
                    </a:gs>
                    <a:gs pos="0">
                      <a:schemeClr val="bg1">
                        <a:alpha val="82000"/>
                        <a:lumMod val="39000"/>
                        <a:lumOff val="61000"/>
                      </a:schemeClr>
                    </a:gs>
                  </a:gsLst>
                  <a:lin ang="21594000" scaled="0"/>
                </a:gradFill>
                <a:ln>
                  <a:noFill/>
                </a:ln>
                <a:effectLst>
                  <a:softEdge rad="31750"/>
                </a:effectLst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400" dirty="0"/>
                </a:p>
              </p:txBody>
            </p:sp>
          </p:grpSp>
          <p:grpSp>
            <p:nvGrpSpPr>
              <p:cNvPr id="27" name="组合 26">
                <a:extLst>
                  <a:ext uri="{FF2B5EF4-FFF2-40B4-BE49-F238E27FC236}">
                    <a16:creationId xmlns:a16="http://schemas.microsoft.com/office/drawing/2014/main" id="{DEA92925-1AB8-9C67-67FF-5B3739490587}"/>
                  </a:ext>
                </a:extLst>
              </p:cNvPr>
              <p:cNvGrpSpPr/>
              <p:nvPr/>
            </p:nvGrpSpPr>
            <p:grpSpPr>
              <a:xfrm rot="16263625">
                <a:off x="5169575" y="6191531"/>
                <a:ext cx="314981" cy="275202"/>
                <a:chOff x="3020060" y="3104143"/>
                <a:chExt cx="665026" cy="623589"/>
              </a:xfrm>
            </p:grpSpPr>
            <p:sp>
              <p:nvSpPr>
                <p:cNvPr id="28" name="任意多边形: 形状 27">
                  <a:extLst>
                    <a:ext uri="{FF2B5EF4-FFF2-40B4-BE49-F238E27FC236}">
                      <a16:creationId xmlns:a16="http://schemas.microsoft.com/office/drawing/2014/main" id="{A29BF3D4-DCD2-390F-DD35-F0E609A88DED}"/>
                    </a:ext>
                  </a:extLst>
                </p:cNvPr>
                <p:cNvSpPr/>
                <p:nvPr/>
              </p:nvSpPr>
              <p:spPr>
                <a:xfrm>
                  <a:off x="3020060" y="3556000"/>
                  <a:ext cx="664633" cy="169333"/>
                </a:xfrm>
                <a:custGeom>
                  <a:avLst/>
                  <a:gdLst>
                    <a:gd name="connsiteX0" fmla="*/ 0 w 664633"/>
                    <a:gd name="connsiteY0" fmla="*/ 169333 h 169333"/>
                    <a:gd name="connsiteX1" fmla="*/ 194733 w 664633"/>
                    <a:gd name="connsiteY1" fmla="*/ 148167 h 169333"/>
                    <a:gd name="connsiteX2" fmla="*/ 364067 w 664633"/>
                    <a:gd name="connsiteY2" fmla="*/ 59267 h 169333"/>
                    <a:gd name="connsiteX3" fmla="*/ 541867 w 664633"/>
                    <a:gd name="connsiteY3" fmla="*/ 55033 h 169333"/>
                    <a:gd name="connsiteX4" fmla="*/ 664633 w 664633"/>
                    <a:gd name="connsiteY4" fmla="*/ 0 h 16933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664633" h="169333">
                      <a:moveTo>
                        <a:pt x="0" y="169333"/>
                      </a:moveTo>
                      <a:cubicBezTo>
                        <a:pt x="67027" y="167922"/>
                        <a:pt x="134055" y="166511"/>
                        <a:pt x="194733" y="148167"/>
                      </a:cubicBezTo>
                      <a:cubicBezTo>
                        <a:pt x="255411" y="129823"/>
                        <a:pt x="306211" y="74789"/>
                        <a:pt x="364067" y="59267"/>
                      </a:cubicBezTo>
                      <a:cubicBezTo>
                        <a:pt x="421923" y="43745"/>
                        <a:pt x="491773" y="64911"/>
                        <a:pt x="541867" y="55033"/>
                      </a:cubicBezTo>
                      <a:cubicBezTo>
                        <a:pt x="591961" y="45155"/>
                        <a:pt x="628297" y="22577"/>
                        <a:pt x="664633" y="0"/>
                      </a:cubicBezTo>
                    </a:path>
                  </a:pathLst>
                </a:custGeom>
                <a:noFill/>
                <a:ln w="6350"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400" dirty="0"/>
                </a:p>
              </p:txBody>
            </p:sp>
            <p:sp>
              <p:nvSpPr>
                <p:cNvPr id="29" name="任意多边形: 形状 28">
                  <a:extLst>
                    <a:ext uri="{FF2B5EF4-FFF2-40B4-BE49-F238E27FC236}">
                      <a16:creationId xmlns:a16="http://schemas.microsoft.com/office/drawing/2014/main" id="{B9427C54-54D2-5D8F-D292-D1F261DBD86D}"/>
                    </a:ext>
                  </a:extLst>
                </p:cNvPr>
                <p:cNvSpPr/>
                <p:nvPr/>
              </p:nvSpPr>
              <p:spPr>
                <a:xfrm>
                  <a:off x="3187700" y="3619500"/>
                  <a:ext cx="351367" cy="108232"/>
                </a:xfrm>
                <a:custGeom>
                  <a:avLst/>
                  <a:gdLst>
                    <a:gd name="connsiteX0" fmla="*/ 0 w 351367"/>
                    <a:gd name="connsiteY0" fmla="*/ 101600 h 108232"/>
                    <a:gd name="connsiteX1" fmla="*/ 177800 w 351367"/>
                    <a:gd name="connsiteY1" fmla="*/ 97367 h 108232"/>
                    <a:gd name="connsiteX2" fmla="*/ 351367 w 351367"/>
                    <a:gd name="connsiteY2" fmla="*/ 0 h 108232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351367" h="108232">
                      <a:moveTo>
                        <a:pt x="0" y="101600"/>
                      </a:moveTo>
                      <a:cubicBezTo>
                        <a:pt x="59619" y="107950"/>
                        <a:pt x="119239" y="114300"/>
                        <a:pt x="177800" y="97367"/>
                      </a:cubicBezTo>
                      <a:cubicBezTo>
                        <a:pt x="236361" y="80434"/>
                        <a:pt x="293864" y="40217"/>
                        <a:pt x="351367" y="0"/>
                      </a:cubicBezTo>
                    </a:path>
                  </a:pathLst>
                </a:custGeom>
                <a:noFill/>
                <a:ln w="6350"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400"/>
                </a:p>
              </p:txBody>
            </p:sp>
            <p:sp>
              <p:nvSpPr>
                <p:cNvPr id="30" name="任意多边形: 形状 29">
                  <a:extLst>
                    <a:ext uri="{FF2B5EF4-FFF2-40B4-BE49-F238E27FC236}">
                      <a16:creationId xmlns:a16="http://schemas.microsoft.com/office/drawing/2014/main" id="{154A9F4B-B76B-5F5D-8665-75A005C206AA}"/>
                    </a:ext>
                  </a:extLst>
                </p:cNvPr>
                <p:cNvSpPr/>
                <p:nvPr/>
              </p:nvSpPr>
              <p:spPr>
                <a:xfrm>
                  <a:off x="3164700" y="3498358"/>
                  <a:ext cx="514125" cy="71186"/>
                </a:xfrm>
                <a:custGeom>
                  <a:avLst/>
                  <a:gdLst>
                    <a:gd name="connsiteX0" fmla="*/ 0 w 482600"/>
                    <a:gd name="connsiteY0" fmla="*/ 15088 h 57421"/>
                    <a:gd name="connsiteX1" fmla="*/ 177800 w 482600"/>
                    <a:gd name="connsiteY1" fmla="*/ 2388 h 57421"/>
                    <a:gd name="connsiteX2" fmla="*/ 482600 w 482600"/>
                    <a:gd name="connsiteY2" fmla="*/ 57421 h 57421"/>
                    <a:gd name="connsiteX3" fmla="*/ 482600 w 482600"/>
                    <a:gd name="connsiteY3" fmla="*/ 57421 h 57421"/>
                    <a:gd name="connsiteX0" fmla="*/ 0 w 514126"/>
                    <a:gd name="connsiteY0" fmla="*/ 15088 h 71187"/>
                    <a:gd name="connsiteX1" fmla="*/ 177800 w 514126"/>
                    <a:gd name="connsiteY1" fmla="*/ 2388 h 71187"/>
                    <a:gd name="connsiteX2" fmla="*/ 482600 w 514126"/>
                    <a:gd name="connsiteY2" fmla="*/ 57421 h 71187"/>
                    <a:gd name="connsiteX3" fmla="*/ 514126 w 514126"/>
                    <a:gd name="connsiteY3" fmla="*/ 71186 h 71187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514126" h="71187">
                      <a:moveTo>
                        <a:pt x="0" y="15088"/>
                      </a:moveTo>
                      <a:cubicBezTo>
                        <a:pt x="48683" y="5210"/>
                        <a:pt x="97367" y="-4667"/>
                        <a:pt x="177800" y="2388"/>
                      </a:cubicBezTo>
                      <a:cubicBezTo>
                        <a:pt x="258233" y="9443"/>
                        <a:pt x="482600" y="57421"/>
                        <a:pt x="482600" y="57421"/>
                      </a:cubicBezTo>
                      <a:lnTo>
                        <a:pt x="514126" y="71186"/>
                      </a:lnTo>
                    </a:path>
                  </a:pathLst>
                </a:custGeom>
                <a:noFill/>
                <a:ln w="6350"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400"/>
                </a:p>
              </p:txBody>
            </p:sp>
            <p:sp>
              <p:nvSpPr>
                <p:cNvPr id="31" name="任意多边形: 形状 30">
                  <a:extLst>
                    <a:ext uri="{FF2B5EF4-FFF2-40B4-BE49-F238E27FC236}">
                      <a16:creationId xmlns:a16="http://schemas.microsoft.com/office/drawing/2014/main" id="{AF43E24D-64A1-9216-D37E-60C335CB7EDD}"/>
                    </a:ext>
                  </a:extLst>
                </p:cNvPr>
                <p:cNvSpPr/>
                <p:nvPr/>
              </p:nvSpPr>
              <p:spPr>
                <a:xfrm>
                  <a:off x="3215640" y="3401060"/>
                  <a:ext cx="127000" cy="105833"/>
                </a:xfrm>
                <a:custGeom>
                  <a:avLst/>
                  <a:gdLst>
                    <a:gd name="connsiteX0" fmla="*/ 0 w 127000"/>
                    <a:gd name="connsiteY0" fmla="*/ 0 h 105833"/>
                    <a:gd name="connsiteX1" fmla="*/ 127000 w 127000"/>
                    <a:gd name="connsiteY1" fmla="*/ 105833 h 10583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127000" h="105833">
                      <a:moveTo>
                        <a:pt x="0" y="0"/>
                      </a:moveTo>
                      <a:lnTo>
                        <a:pt x="127000" y="105833"/>
                      </a:lnTo>
                    </a:path>
                  </a:pathLst>
                </a:custGeom>
                <a:noFill/>
                <a:ln w="6350"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400"/>
                </a:p>
              </p:txBody>
            </p:sp>
            <p:sp>
              <p:nvSpPr>
                <p:cNvPr id="32" name="任意多边形: 形状 31">
                  <a:extLst>
                    <a:ext uri="{FF2B5EF4-FFF2-40B4-BE49-F238E27FC236}">
                      <a16:creationId xmlns:a16="http://schemas.microsoft.com/office/drawing/2014/main" id="{88FB941A-B961-74F2-A673-A3C437C2C450}"/>
                    </a:ext>
                  </a:extLst>
                </p:cNvPr>
                <p:cNvSpPr/>
                <p:nvPr/>
              </p:nvSpPr>
              <p:spPr>
                <a:xfrm>
                  <a:off x="3255432" y="3301999"/>
                  <a:ext cx="428393" cy="238453"/>
                </a:xfrm>
                <a:custGeom>
                  <a:avLst/>
                  <a:gdLst>
                    <a:gd name="connsiteX0" fmla="*/ 0 w 427567"/>
                    <a:gd name="connsiteY0" fmla="*/ 0 h 190500"/>
                    <a:gd name="connsiteX1" fmla="*/ 194734 w 427567"/>
                    <a:gd name="connsiteY1" fmla="*/ 76200 h 190500"/>
                    <a:gd name="connsiteX2" fmla="*/ 317500 w 427567"/>
                    <a:gd name="connsiteY2" fmla="*/ 169333 h 190500"/>
                    <a:gd name="connsiteX3" fmla="*/ 427567 w 427567"/>
                    <a:gd name="connsiteY3" fmla="*/ 190500 h 190500"/>
                    <a:gd name="connsiteX0" fmla="*/ 0 w 428393"/>
                    <a:gd name="connsiteY0" fmla="*/ 0 h 238451"/>
                    <a:gd name="connsiteX1" fmla="*/ 194734 w 428393"/>
                    <a:gd name="connsiteY1" fmla="*/ 76200 h 238451"/>
                    <a:gd name="connsiteX2" fmla="*/ 317500 w 428393"/>
                    <a:gd name="connsiteY2" fmla="*/ 169333 h 238451"/>
                    <a:gd name="connsiteX3" fmla="*/ 428393 w 428393"/>
                    <a:gd name="connsiteY3" fmla="*/ 238451 h 238451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428393" h="238451">
                      <a:moveTo>
                        <a:pt x="0" y="0"/>
                      </a:moveTo>
                      <a:cubicBezTo>
                        <a:pt x="70908" y="23989"/>
                        <a:pt x="141817" y="47978"/>
                        <a:pt x="194734" y="76200"/>
                      </a:cubicBezTo>
                      <a:cubicBezTo>
                        <a:pt x="247651" y="104422"/>
                        <a:pt x="278695" y="150283"/>
                        <a:pt x="317500" y="169333"/>
                      </a:cubicBezTo>
                      <a:cubicBezTo>
                        <a:pt x="356305" y="188383"/>
                        <a:pt x="392762" y="237392"/>
                        <a:pt x="428393" y="238451"/>
                      </a:cubicBezTo>
                    </a:path>
                  </a:pathLst>
                </a:custGeom>
                <a:noFill/>
                <a:ln w="6350"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400"/>
                </a:p>
              </p:txBody>
            </p:sp>
            <p:sp>
              <p:nvSpPr>
                <p:cNvPr id="33" name="任意多边形: 形状 32">
                  <a:extLst>
                    <a:ext uri="{FF2B5EF4-FFF2-40B4-BE49-F238E27FC236}">
                      <a16:creationId xmlns:a16="http://schemas.microsoft.com/office/drawing/2014/main" id="{5C9D787C-E866-CF22-1B8D-A1836DD17E33}"/>
                    </a:ext>
                  </a:extLst>
                </p:cNvPr>
                <p:cNvSpPr/>
                <p:nvPr/>
              </p:nvSpPr>
              <p:spPr>
                <a:xfrm>
                  <a:off x="3283373" y="3213947"/>
                  <a:ext cx="232856" cy="215198"/>
                </a:xfrm>
                <a:custGeom>
                  <a:avLst/>
                  <a:gdLst>
                    <a:gd name="connsiteX0" fmla="*/ 0 w 232856"/>
                    <a:gd name="connsiteY0" fmla="*/ 0 h 215198"/>
                    <a:gd name="connsiteX1" fmla="*/ 122767 w 232856"/>
                    <a:gd name="connsiteY1" fmla="*/ 101600 h 215198"/>
                    <a:gd name="connsiteX2" fmla="*/ 224367 w 232856"/>
                    <a:gd name="connsiteY2" fmla="*/ 207433 h 215198"/>
                    <a:gd name="connsiteX3" fmla="*/ 220134 w 232856"/>
                    <a:gd name="connsiteY3" fmla="*/ 198966 h 215198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232856" h="215198">
                      <a:moveTo>
                        <a:pt x="0" y="0"/>
                      </a:moveTo>
                      <a:cubicBezTo>
                        <a:pt x="42686" y="33514"/>
                        <a:pt x="85373" y="67028"/>
                        <a:pt x="122767" y="101600"/>
                      </a:cubicBezTo>
                      <a:cubicBezTo>
                        <a:pt x="160161" y="136172"/>
                        <a:pt x="208139" y="191205"/>
                        <a:pt x="224367" y="207433"/>
                      </a:cubicBezTo>
                      <a:cubicBezTo>
                        <a:pt x="240595" y="223661"/>
                        <a:pt x="230364" y="211313"/>
                        <a:pt x="220134" y="198966"/>
                      </a:cubicBezTo>
                    </a:path>
                  </a:pathLst>
                </a:custGeom>
                <a:noFill/>
                <a:ln w="6350"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400"/>
                </a:p>
              </p:txBody>
            </p:sp>
            <p:sp>
              <p:nvSpPr>
                <p:cNvPr id="34" name="任意多边形: 形状 33">
                  <a:extLst>
                    <a:ext uri="{FF2B5EF4-FFF2-40B4-BE49-F238E27FC236}">
                      <a16:creationId xmlns:a16="http://schemas.microsoft.com/office/drawing/2014/main" id="{77E5D3F4-6FB7-7478-CA66-126C9394EB36}"/>
                    </a:ext>
                  </a:extLst>
                </p:cNvPr>
                <p:cNvSpPr/>
                <p:nvPr/>
              </p:nvSpPr>
              <p:spPr>
                <a:xfrm>
                  <a:off x="3309328" y="3104143"/>
                  <a:ext cx="375758" cy="439805"/>
                </a:xfrm>
                <a:custGeom>
                  <a:avLst/>
                  <a:gdLst>
                    <a:gd name="connsiteX0" fmla="*/ 0 w 368300"/>
                    <a:gd name="connsiteY0" fmla="*/ 0 h 431800"/>
                    <a:gd name="connsiteX1" fmla="*/ 93133 w 368300"/>
                    <a:gd name="connsiteY1" fmla="*/ 110067 h 431800"/>
                    <a:gd name="connsiteX2" fmla="*/ 160866 w 368300"/>
                    <a:gd name="connsiteY2" fmla="*/ 198967 h 431800"/>
                    <a:gd name="connsiteX3" fmla="*/ 241300 w 368300"/>
                    <a:gd name="connsiteY3" fmla="*/ 270933 h 431800"/>
                    <a:gd name="connsiteX4" fmla="*/ 287866 w 368300"/>
                    <a:gd name="connsiteY4" fmla="*/ 372533 h 431800"/>
                    <a:gd name="connsiteX5" fmla="*/ 368300 w 368300"/>
                    <a:gd name="connsiteY5" fmla="*/ 431800 h 431800"/>
                    <a:gd name="connsiteX0" fmla="*/ 37180 w 405480"/>
                    <a:gd name="connsiteY0" fmla="*/ 0 h 431800"/>
                    <a:gd name="connsiteX1" fmla="*/ 3313 w 405480"/>
                    <a:gd name="connsiteY1" fmla="*/ 12700 h 431800"/>
                    <a:gd name="connsiteX2" fmla="*/ 130313 w 405480"/>
                    <a:gd name="connsiteY2" fmla="*/ 110067 h 431800"/>
                    <a:gd name="connsiteX3" fmla="*/ 198046 w 405480"/>
                    <a:gd name="connsiteY3" fmla="*/ 198967 h 431800"/>
                    <a:gd name="connsiteX4" fmla="*/ 278480 w 405480"/>
                    <a:gd name="connsiteY4" fmla="*/ 270933 h 431800"/>
                    <a:gd name="connsiteX5" fmla="*/ 325046 w 405480"/>
                    <a:gd name="connsiteY5" fmla="*/ 372533 h 431800"/>
                    <a:gd name="connsiteX6" fmla="*/ 405480 w 405480"/>
                    <a:gd name="connsiteY6" fmla="*/ 431800 h 431800"/>
                    <a:gd name="connsiteX0" fmla="*/ 0 w 368300"/>
                    <a:gd name="connsiteY0" fmla="*/ 0 h 431800"/>
                    <a:gd name="connsiteX1" fmla="*/ 93133 w 368300"/>
                    <a:gd name="connsiteY1" fmla="*/ 110067 h 431800"/>
                    <a:gd name="connsiteX2" fmla="*/ 160866 w 368300"/>
                    <a:gd name="connsiteY2" fmla="*/ 198967 h 431800"/>
                    <a:gd name="connsiteX3" fmla="*/ 241300 w 368300"/>
                    <a:gd name="connsiteY3" fmla="*/ 270933 h 431800"/>
                    <a:gd name="connsiteX4" fmla="*/ 287866 w 368300"/>
                    <a:gd name="connsiteY4" fmla="*/ 372533 h 431800"/>
                    <a:gd name="connsiteX5" fmla="*/ 368300 w 368300"/>
                    <a:gd name="connsiteY5" fmla="*/ 431800 h 431800"/>
                    <a:gd name="connsiteX0" fmla="*/ 0 w 275167"/>
                    <a:gd name="connsiteY0" fmla="*/ 0 h 321733"/>
                    <a:gd name="connsiteX1" fmla="*/ 67733 w 275167"/>
                    <a:gd name="connsiteY1" fmla="*/ 88900 h 321733"/>
                    <a:gd name="connsiteX2" fmla="*/ 148167 w 275167"/>
                    <a:gd name="connsiteY2" fmla="*/ 160866 h 321733"/>
                    <a:gd name="connsiteX3" fmla="*/ 194733 w 275167"/>
                    <a:gd name="connsiteY3" fmla="*/ 262466 h 321733"/>
                    <a:gd name="connsiteX4" fmla="*/ 275167 w 275167"/>
                    <a:gd name="connsiteY4" fmla="*/ 321733 h 321733"/>
                    <a:gd name="connsiteX0" fmla="*/ 0 w 334434"/>
                    <a:gd name="connsiteY0" fmla="*/ 0 h 389466"/>
                    <a:gd name="connsiteX1" fmla="*/ 127000 w 334434"/>
                    <a:gd name="connsiteY1" fmla="*/ 156633 h 389466"/>
                    <a:gd name="connsiteX2" fmla="*/ 207434 w 334434"/>
                    <a:gd name="connsiteY2" fmla="*/ 228599 h 389466"/>
                    <a:gd name="connsiteX3" fmla="*/ 254000 w 334434"/>
                    <a:gd name="connsiteY3" fmla="*/ 330199 h 389466"/>
                    <a:gd name="connsiteX4" fmla="*/ 334434 w 334434"/>
                    <a:gd name="connsiteY4" fmla="*/ 389466 h 389466"/>
                    <a:gd name="connsiteX0" fmla="*/ 0 w 379067"/>
                    <a:gd name="connsiteY0" fmla="*/ 0 h 372582"/>
                    <a:gd name="connsiteX1" fmla="*/ 171633 w 379067"/>
                    <a:gd name="connsiteY1" fmla="*/ 139749 h 372582"/>
                    <a:gd name="connsiteX2" fmla="*/ 252067 w 379067"/>
                    <a:gd name="connsiteY2" fmla="*/ 211715 h 372582"/>
                    <a:gd name="connsiteX3" fmla="*/ 298633 w 379067"/>
                    <a:gd name="connsiteY3" fmla="*/ 313315 h 372582"/>
                    <a:gd name="connsiteX4" fmla="*/ 379067 w 379067"/>
                    <a:gd name="connsiteY4" fmla="*/ 372582 h 372582"/>
                    <a:gd name="connsiteX0" fmla="*/ 0 w 379067"/>
                    <a:gd name="connsiteY0" fmla="*/ 0 h 372582"/>
                    <a:gd name="connsiteX1" fmla="*/ 107925 w 379067"/>
                    <a:gd name="connsiteY1" fmla="*/ 119898 h 372582"/>
                    <a:gd name="connsiteX2" fmla="*/ 252067 w 379067"/>
                    <a:gd name="connsiteY2" fmla="*/ 211715 h 372582"/>
                    <a:gd name="connsiteX3" fmla="*/ 298633 w 379067"/>
                    <a:gd name="connsiteY3" fmla="*/ 313315 h 372582"/>
                    <a:gd name="connsiteX4" fmla="*/ 379067 w 379067"/>
                    <a:gd name="connsiteY4" fmla="*/ 372582 h 372582"/>
                    <a:gd name="connsiteX0" fmla="*/ 0 w 375756"/>
                    <a:gd name="connsiteY0" fmla="*/ 0 h 439805"/>
                    <a:gd name="connsiteX1" fmla="*/ 107925 w 375756"/>
                    <a:gd name="connsiteY1" fmla="*/ 119898 h 439805"/>
                    <a:gd name="connsiteX2" fmla="*/ 252067 w 375756"/>
                    <a:gd name="connsiteY2" fmla="*/ 211715 h 439805"/>
                    <a:gd name="connsiteX3" fmla="*/ 298633 w 375756"/>
                    <a:gd name="connsiteY3" fmla="*/ 313315 h 439805"/>
                    <a:gd name="connsiteX4" fmla="*/ 375757 w 375756"/>
                    <a:gd name="connsiteY4" fmla="*/ 439806 h 439805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375756" h="439805">
                      <a:moveTo>
                        <a:pt x="0" y="0"/>
                      </a:moveTo>
                      <a:cubicBezTo>
                        <a:pt x="26811" y="33161"/>
                        <a:pt x="65914" y="84612"/>
                        <a:pt x="107925" y="119898"/>
                      </a:cubicBezTo>
                      <a:cubicBezTo>
                        <a:pt x="149936" y="155184"/>
                        <a:pt x="220282" y="179479"/>
                        <a:pt x="252067" y="211715"/>
                      </a:cubicBezTo>
                      <a:cubicBezTo>
                        <a:pt x="283852" y="243951"/>
                        <a:pt x="277466" y="286504"/>
                        <a:pt x="298633" y="313315"/>
                      </a:cubicBezTo>
                      <a:cubicBezTo>
                        <a:pt x="319800" y="340126"/>
                        <a:pt x="346123" y="423578"/>
                        <a:pt x="375757" y="439806"/>
                      </a:cubicBezTo>
                    </a:path>
                  </a:pathLst>
                </a:custGeom>
                <a:noFill/>
                <a:ln w="6350"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400" dirty="0"/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2531846481"/>
      </p:ext>
    </p:extLst>
  </p:cSld>
  <p:clrMapOvr>
    <a:masterClrMapping/>
  </p:clrMapOvr>
</p:sld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16</TotalTime>
  <Words>26</Words>
  <Application>Microsoft Office PowerPoint</Application>
  <PresentationFormat>宽屏</PresentationFormat>
  <Paragraphs>16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2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4" baseType="lpstr">
      <vt:lpstr>等线</vt:lpstr>
      <vt:lpstr>Arial</vt:lpstr>
      <vt:lpstr>WPS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huajie zheng</dc:creator>
  <cp:lastModifiedBy>huajie zheng</cp:lastModifiedBy>
  <cp:revision>282</cp:revision>
  <dcterms:created xsi:type="dcterms:W3CDTF">2023-08-09T12:44:55Z</dcterms:created>
  <dcterms:modified xsi:type="dcterms:W3CDTF">2026-01-20T07:02:2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15259</vt:lpwstr>
  </property>
</Properties>
</file>